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drawings/drawing10.xml" ContentType="application/vnd.openxmlformats-officedocument.drawingml.chartshapes+xml"/>
  <Override PartName="/ppt/charts/chart11.xml" ContentType="application/vnd.openxmlformats-officedocument.drawingml.chart+xml"/>
  <Override PartName="/ppt/drawings/drawing11.xml" ContentType="application/vnd.openxmlformats-officedocument.drawingml.chartshapes+xml"/>
  <Override PartName="/ppt/charts/chart12.xml" ContentType="application/vnd.openxmlformats-officedocument.drawingml.chart+xml"/>
  <Override PartName="/ppt/drawings/drawing12.xml" ContentType="application/vnd.openxmlformats-officedocument.drawingml.chartshapes+xml"/>
  <Override PartName="/ppt/charts/chart13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drawings/drawing13.xml" ContentType="application/vnd.openxmlformats-officedocument.drawingml.chartshapes+xml"/>
  <Override PartName="/ppt/charts/chart14.xml" ContentType="application/vnd.openxmlformats-officedocument.drawingml.chart+xml"/>
  <Override PartName="/ppt/drawings/drawing14.xml" ContentType="application/vnd.openxmlformats-officedocument.drawingml.chartshapes+xml"/>
  <Override PartName="/ppt/charts/chart15.xml" ContentType="application/vnd.openxmlformats-officedocument.drawingml.chart+xml"/>
  <Override PartName="/ppt/drawings/drawing15.xml" ContentType="application/vnd.openxmlformats-officedocument.drawingml.chartshapes+xml"/>
  <Override PartName="/ppt/charts/chart16.xml" ContentType="application/vnd.openxmlformats-officedocument.drawingml.chart+xml"/>
  <Override PartName="/ppt/drawings/drawing16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17.xml" ContentType="application/vnd.openxmlformats-officedocument.drawingml.chart+xml"/>
  <Override PartName="/ppt/drawings/drawing17.xml" ContentType="application/vnd.openxmlformats-officedocument.drawingml.chartshapes+xml"/>
  <Override PartName="/ppt/charts/chart18.xml" ContentType="application/vnd.openxmlformats-officedocument.drawingml.chart+xml"/>
  <Override PartName="/ppt/drawings/drawing18.xml" ContentType="application/vnd.openxmlformats-officedocument.drawingml.chartshapes+xml"/>
  <Override PartName="/ppt/charts/chart19.xml" ContentType="application/vnd.openxmlformats-officedocument.drawingml.chart+xml"/>
  <Override PartName="/ppt/drawings/drawing19.xml" ContentType="application/vnd.openxmlformats-officedocument.drawingml.chartshapes+xml"/>
  <Override PartName="/ppt/charts/chart20.xml" ContentType="application/vnd.openxmlformats-officedocument.drawingml.chart+xml"/>
  <Override PartName="/ppt/drawings/drawing20.xml" ContentType="application/vnd.openxmlformats-officedocument.drawingml.chartshapes+xml"/>
  <Override PartName="/ppt/charts/chart21.xml" ContentType="application/vnd.openxmlformats-officedocument.drawingml.chart+xml"/>
  <Override PartName="/ppt/drawings/drawing21.xml" ContentType="application/vnd.openxmlformats-officedocument.drawingml.chartshapes+xml"/>
  <Override PartName="/ppt/charts/chart22.xml" ContentType="application/vnd.openxmlformats-officedocument.drawingml.chart+xml"/>
  <Override PartName="/ppt/drawings/drawing22.xml" ContentType="application/vnd.openxmlformats-officedocument.drawingml.chartshapes+xml"/>
  <Override PartName="/ppt/charts/chart23.xml" ContentType="application/vnd.openxmlformats-officedocument.drawingml.chart+xml"/>
  <Override PartName="/ppt/drawings/drawing23.xml" ContentType="application/vnd.openxmlformats-officedocument.drawingml.chartshapes+xml"/>
  <Override PartName="/ppt/charts/chart24.xml" ContentType="application/vnd.openxmlformats-officedocument.drawingml.chart+xml"/>
  <Override PartName="/ppt/drawings/drawing24.xml" ContentType="application/vnd.openxmlformats-officedocument.drawingml.chartshapes+xml"/>
  <Override PartName="/ppt/charts/chart25.xml" ContentType="application/vnd.openxmlformats-officedocument.drawingml.chart+xml"/>
  <Override PartName="/ppt/drawings/drawing25.xml" ContentType="application/vnd.openxmlformats-officedocument.drawingml.chartshapes+xml"/>
  <Override PartName="/ppt/charts/chart26.xml" ContentType="application/vnd.openxmlformats-officedocument.drawingml.chart+xml"/>
  <Override PartName="/ppt/drawings/drawing26.xml" ContentType="application/vnd.openxmlformats-officedocument.drawingml.chartshapes+xml"/>
  <Override PartName="/ppt/charts/chart27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28.xml" ContentType="application/vnd.openxmlformats-officedocument.drawingml.chart+xml"/>
  <Override PartName="/ppt/drawings/drawing27.xml" ContentType="application/vnd.openxmlformats-officedocument.drawingml.chartshapes+xml"/>
  <Override PartName="/ppt/charts/chart29.xml" ContentType="application/vnd.openxmlformats-officedocument.drawingml.chart+xml"/>
  <Override PartName="/ppt/drawings/drawing28.xml" ContentType="application/vnd.openxmlformats-officedocument.drawingml.chartshapes+xml"/>
  <Override PartName="/ppt/charts/chart30.xml" ContentType="application/vnd.openxmlformats-officedocument.drawingml.chart+xml"/>
  <Override PartName="/ppt/drawings/drawing29.xml" ContentType="application/vnd.openxmlformats-officedocument.drawingml.chartshapes+xml"/>
  <Override PartName="/ppt/charts/chart31.xml" ContentType="application/vnd.openxmlformats-officedocument.drawingml.chart+xml"/>
  <Override PartName="/ppt/drawings/drawing30.xml" ContentType="application/vnd.openxmlformats-officedocument.drawingml.chartshapes+xml"/>
  <Override PartName="/ppt/charts/chart32.xml" ContentType="application/vnd.openxmlformats-officedocument.drawingml.chart+xml"/>
  <Override PartName="/ppt/drawings/drawing31.xml" ContentType="application/vnd.openxmlformats-officedocument.drawingml.chartshapes+xml"/>
  <Override PartName="/ppt/charts/chart33.xml" ContentType="application/vnd.openxmlformats-officedocument.drawingml.chart+xml"/>
  <Override PartName="/ppt/drawings/drawing32.xml" ContentType="application/vnd.openxmlformats-officedocument.drawingml.chartshapes+xml"/>
  <Override PartName="/ppt/charts/chart34.xml" ContentType="application/vnd.openxmlformats-officedocument.drawingml.chart+xml"/>
  <Override PartName="/ppt/drawings/drawing33.xml" ContentType="application/vnd.openxmlformats-officedocument.drawingml.chartshapes+xml"/>
  <Override PartName="/ppt/charts/chart35.xml" ContentType="application/vnd.openxmlformats-officedocument.drawingml.chart+xml"/>
  <Override PartName="/ppt/drawings/drawing34.xml" ContentType="application/vnd.openxmlformats-officedocument.drawingml.chartshapes+xml"/>
  <Override PartName="/ppt/charts/chart36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drawings/drawing35.xml" ContentType="application/vnd.openxmlformats-officedocument.drawingml.chartshapes+xml"/>
  <Override PartName="/ppt/charts/chart37.xml" ContentType="application/vnd.openxmlformats-officedocument.drawingml.chart+xml"/>
  <Override PartName="/ppt/drawings/drawing36.xml" ContentType="application/vnd.openxmlformats-officedocument.drawingml.chartshapes+xml"/>
  <Override PartName="/ppt/charts/chart38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drawings/drawing37.xml" ContentType="application/vnd.openxmlformats-officedocument.drawingml.chartshapes+xml"/>
  <Override PartName="/ppt/charts/chart39.xml" ContentType="application/vnd.openxmlformats-officedocument.drawingml.chart+xml"/>
  <Override PartName="/ppt/drawings/drawing38.xml" ContentType="application/vnd.openxmlformats-officedocument.drawingml.chartshapes+xml"/>
  <Override PartName="/ppt/charts/chart40.xml" ContentType="application/vnd.openxmlformats-officedocument.drawingml.chart+xml"/>
  <Override PartName="/ppt/drawings/drawing39.xml" ContentType="application/vnd.openxmlformats-officedocument.drawingml.chartshapes+xml"/>
  <Override PartName="/ppt/charts/chart41.xml" ContentType="application/vnd.openxmlformats-officedocument.drawingml.chart+xml"/>
  <Override PartName="/ppt/drawings/drawing40.xml" ContentType="application/vnd.openxmlformats-officedocument.drawingml.chartshapes+xml"/>
  <Override PartName="/ppt/charts/chart42.xml" ContentType="application/vnd.openxmlformats-officedocument.drawingml.chart+xml"/>
  <Override PartName="/ppt/drawings/drawing41.xml" ContentType="application/vnd.openxmlformats-officedocument.drawingml.chartshapes+xml"/>
  <Override PartName="/ppt/charts/chart43.xml" ContentType="application/vnd.openxmlformats-officedocument.drawingml.chart+xml"/>
  <Override PartName="/ppt/charts/chart44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drawings/drawing42.xml" ContentType="application/vnd.openxmlformats-officedocument.drawingml.chartshapes+xml"/>
  <Override PartName="/ppt/charts/chart45.xml" ContentType="application/vnd.openxmlformats-officedocument.drawingml.chart+xml"/>
  <Override PartName="/ppt/drawings/drawing43.xml" ContentType="application/vnd.openxmlformats-officedocument.drawingml.chartshapes+xml"/>
  <Override PartName="/ppt/charts/chart46.xml" ContentType="application/vnd.openxmlformats-officedocument.drawingml.chart+xml"/>
  <Override PartName="/ppt/drawings/drawing44.xml" ContentType="application/vnd.openxmlformats-officedocument.drawingml.chartshapes+xml"/>
  <Override PartName="/ppt/charts/chart47.xml" ContentType="application/vnd.openxmlformats-officedocument.drawingml.chart+xml"/>
  <Override PartName="/ppt/drawings/drawing45.xml" ContentType="application/vnd.openxmlformats-officedocument.drawingml.chartshapes+xml"/>
  <Override PartName="/ppt/charts/chart48.xml" ContentType="application/vnd.openxmlformats-officedocument.drawingml.chart+xml"/>
  <Override PartName="/ppt/drawings/drawing46.xml" ContentType="application/vnd.openxmlformats-officedocument.drawingml.chartshapes+xml"/>
  <Override PartName="/ppt/charts/chart49.xml" ContentType="application/vnd.openxmlformats-officedocument.drawingml.chart+xml"/>
  <Override PartName="/ppt/drawings/drawing47.xml" ContentType="application/vnd.openxmlformats-officedocument.drawingml.chartshapes+xml"/>
  <Override PartName="/ppt/charts/chart50.xml" ContentType="application/vnd.openxmlformats-officedocument.drawingml.chart+xml"/>
  <Override PartName="/ppt/drawings/drawing48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2"/>
  </p:notesMasterIdLst>
  <p:sldIdLst>
    <p:sldId id="262" r:id="rId2"/>
    <p:sldId id="283" r:id="rId3"/>
    <p:sldId id="284" r:id="rId4"/>
    <p:sldId id="264" r:id="rId5"/>
    <p:sldId id="285" r:id="rId6"/>
    <p:sldId id="277" r:id="rId7"/>
    <p:sldId id="287" r:id="rId8"/>
    <p:sldId id="282" r:id="rId9"/>
    <p:sldId id="286" r:id="rId10"/>
    <p:sldId id="288" r:id="rId11"/>
  </p:sldIdLst>
  <p:sldSz cx="9601200" cy="12801600" type="A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183083" initials="E" lastIdx="1" clrIdx="0">
    <p:extLst>
      <p:ext uri="{19B8F6BF-5375-455C-9EA6-DF929625EA0E}">
        <p15:presenceInfo xmlns:p15="http://schemas.microsoft.com/office/powerpoint/2012/main" userId="E183083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93" autoAdjust="0"/>
    <p:restoredTop sz="96445" autoAdjust="0"/>
  </p:normalViewPr>
  <p:slideViewPr>
    <p:cSldViewPr snapToGrid="0">
      <p:cViewPr>
        <p:scale>
          <a:sx n="66" d="100"/>
          <a:sy n="66" d="100"/>
        </p:scale>
        <p:origin x="1388" y="-1564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192.168.1.37\fukuoka\&#23455;&#39443;&#12487;&#12540;&#12479;\_220410_ER%20stres_supplimental_5100\5001-5012%20CHO-T%20WT%20TG,TM,MG\WB%20band%20intensity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210614_CHO-Tcad_ERstress(Tunic&amp;MG)_2800\XBP1_JMP.xlsx" TargetMode="Externa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chartUserShapes" Target="../drawings/drawing10.xm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1.xml"/><Relationship Id="rId1" Type="http://schemas.openxmlformats.org/officeDocument/2006/relationships/oleObject" Target="file:///\\192.168.1.37\fukuoka\&#23455;&#39443;&#12487;&#12540;&#12479;\210614_CHO-Tcad_ERstress(Tunic&amp;MG)_2800\XBP1_JMP.xlsx" TargetMode="Externa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2.xml"/><Relationship Id="rId1" Type="http://schemas.openxmlformats.org/officeDocument/2006/relationships/oleObject" Target="file:///\\192.168.1.37\fukuoka\&#23455;&#39443;&#12487;&#12540;&#12479;\220315_ER%20stres_supplimental_5000\5001-5024%20(293TT,%20TM,%202-24h)\RNA\2022-03-18%20112321.xls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_220315_ER%20stres_supplimental_5000\5001-5024%20(293TT,%20TM,%202-24h)\RNA\XBP1\5001-5024%20XBP1.xlsx" TargetMode="Externa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chartUserShapes" Target="../drawings/drawing13.xml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4.xml"/><Relationship Id="rId1" Type="http://schemas.openxmlformats.org/officeDocument/2006/relationships/oleObject" Target="file:///\\192.168.1.37\fukuoka\&#23455;&#39443;&#12487;&#12540;&#12479;\220315_ER%20stres_supplimental_5000\5001-5024%20(293TT,%20TM,%202-24h)\exosome\exosome%20band%20intensity.xlsx" TargetMode="External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5.xml"/><Relationship Id="rId1" Type="http://schemas.openxmlformats.org/officeDocument/2006/relationships/oleObject" Target="file:///\\192.168.1.37\fukuoka\&#23455;&#39443;&#12487;&#12540;&#12479;\220315_ER%20stres_supplimental_5000\5001-5024%20(293TT,%20TM,%202-24h)\exosome\exosome%20band%20intensity.xlsx" TargetMode="External"/></Relationships>
</file>

<file path=ppt/charts/_rels/chart1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6.xml"/><Relationship Id="rId1" Type="http://schemas.openxmlformats.org/officeDocument/2006/relationships/oleObject" Target="file:///\\192.168.1.37\fukuoka\&#23455;&#39443;&#12487;&#12540;&#12479;\220315_ER%20stres_supplimental_5000\5001-5024%20(293TT,%20TM,%202-24h)\exosome\exosome%20band%20intensity.xlsx" TargetMode="External"/></Relationships>
</file>

<file path=ppt/charts/_rels/chart1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7.xml"/><Relationship Id="rId1" Type="http://schemas.openxmlformats.org/officeDocument/2006/relationships/oleObject" Target="file:///\\192.168.1.37\fukuoka\&#23455;&#39443;&#12487;&#12540;&#12479;\210614_CHO-Tcad_ERstress(Tunic&amp;MG)_2800\WB&#12496;&#12531;&#12489;&#23450;&#37327;_2800.xlsx" TargetMode="External"/></Relationships>
</file>

<file path=ppt/charts/_rels/chart1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8.xml"/><Relationship Id="rId1" Type="http://schemas.openxmlformats.org/officeDocument/2006/relationships/oleObject" Target="file:///\\192.168.1.37\fukuoka\&#23455;&#39443;&#12487;&#12540;&#12479;\210614_CHO-Tcad_ERstress(Tunic&amp;MG)_2800\WB&#12496;&#12531;&#12489;&#23450;&#37327;_2800.xlsx" TargetMode="External"/></Relationships>
</file>

<file path=ppt/charts/_rels/chart1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9.xml"/><Relationship Id="rId1" Type="http://schemas.openxmlformats.org/officeDocument/2006/relationships/oleObject" Target="file:///\\192.168.1.37\fukuoka\&#23455;&#39443;&#12487;&#12540;&#12479;\210614_CHO-Tcad_ERstress(Tunic&amp;MG)_2800\WB&#12496;&#12531;&#12489;&#23450;&#37327;_2800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\\192.168.1.37\fukuoka\&#23455;&#39443;&#12487;&#12540;&#12479;\220410_ER%20stres_supplimental_5100\5101-5112%20CHO-T%20WT%20TG,TM,MG\WB%20band%20intensity.xlsx" TargetMode="External"/></Relationships>
</file>

<file path=ppt/charts/_rels/chart2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0.xml"/><Relationship Id="rId1" Type="http://schemas.openxmlformats.org/officeDocument/2006/relationships/oleObject" Target="file:///\\192.168.1.37\fukuoka\&#23455;&#39443;&#12487;&#12540;&#12479;\210614_CHO-Tcad_ERstress(Tunic&amp;MG)_2800\WB&#12496;&#12531;&#12489;&#23450;&#37327;_2800.xlsx" TargetMode="External"/></Relationships>
</file>

<file path=ppt/charts/_rels/chart2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1.xml"/><Relationship Id="rId1" Type="http://schemas.openxmlformats.org/officeDocument/2006/relationships/oleObject" Target="file:///\\192.168.1.37\fukuoka\&#23455;&#39443;&#12487;&#12540;&#12479;\210512_CHO-Tcad_ERstress_2100\Thaps%200.1-1%20&#956;M\ChemiDoc%20Images%202021-05-31_15.46.05\WB&#12496;&#12531;&#12489;&#23450;&#37327;.xlsx" TargetMode="External"/></Relationships>
</file>

<file path=ppt/charts/_rels/chart2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2.xml"/><Relationship Id="rId1" Type="http://schemas.openxmlformats.org/officeDocument/2006/relationships/oleObject" Target="file:///\\192.168.1.37\fukuoka\&#23455;&#39443;&#12487;&#12540;&#12479;\210512_CHO-Tcad_ERstress_2100\Thaps%200.1-1%20&#956;M\ChemiDoc%20Images%202021-05-31_15.46.05\WB&#12496;&#12531;&#12489;&#23450;&#37327;.xlsx" TargetMode="External"/></Relationships>
</file>

<file path=ppt/charts/_rels/chart2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3.xml"/><Relationship Id="rId1" Type="http://schemas.openxmlformats.org/officeDocument/2006/relationships/oleObject" Target="file:///\\192.168.1.37\fukuoka\&#23455;&#39443;&#12487;&#12540;&#12479;\_220222_ER%20stress_supplimental_4800\4873-4896%20(F2%204u8c)&#9734;\exosome\WB&#23450;&#37327;.xlsx" TargetMode="External"/></Relationships>
</file>

<file path=ppt/charts/_rels/chart2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4.xml"/><Relationship Id="rId1" Type="http://schemas.openxmlformats.org/officeDocument/2006/relationships/oleObject" Target="file:///\\192.168.1.37\fukuoka\&#23455;&#39443;&#12487;&#12540;&#12479;\_221114_ER%20stress_supplimental_6100\6113-6136%20(F2T%20TM+APN)\Cell%20lysate\611336%20CL%20band%20intensity.xlsx" TargetMode="External"/></Relationships>
</file>

<file path=ppt/charts/_rels/chart2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5.xml"/><Relationship Id="rId1" Type="http://schemas.openxmlformats.org/officeDocument/2006/relationships/oleObject" Target="file:///\\192.168.1.37\fukuoka\&#23455;&#39443;&#12487;&#12540;&#12479;\_221114_ER%20stress_supplimental_6100\6113-6136%20(F2T%20TM+APN)\RNA\2022-11-28%20181308.xls" TargetMode="External"/></Relationships>
</file>

<file path=ppt/charts/_rels/chart2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6.xml"/><Relationship Id="rId1" Type="http://schemas.openxmlformats.org/officeDocument/2006/relationships/oleObject" Target="file:///\\192.168.1.37\fukuoka\&#23455;&#39443;&#12487;&#12540;&#12479;\_221114_ER%20stress_supplimental_6100\6113-6136%20(F2T%20TM+APN)\Cell%20lysate\Export1.xls" TargetMode="Externa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210719_CHO-Tcad,%20XBP1_knockdown_3300\3361-3372(RNAseq)\211122_protocol&amp;result_3300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7.xml"/><Relationship Id="rId1" Type="http://schemas.openxmlformats.org/officeDocument/2006/relationships/oleObject" Target="file:///\\192.168.1.37\fukuoka\&#23455;&#39443;&#12487;&#12540;&#12479;\220314_F2_poly(IC)_4900\4901-4924_F2%20poly(IC)\2022-03-17%20133612.xls" TargetMode="External"/></Relationships>
</file>

<file path=ppt/charts/_rels/chart2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8.xml"/><Relationship Id="rId1" Type="http://schemas.openxmlformats.org/officeDocument/2006/relationships/oleObject" Target="file:///\\192.168.1.37\fukuoka\&#23455;&#39443;&#12487;&#12540;&#12479;\220315_ER%20stres_supplimental_5000\5001-5024%20(293TT,%20TM,%202-24h)\RNA\2022-03-18%20112321.xls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Chinese%20hamster%2036B4&#26908;&#35342;&#65288;2100,2500,2700&#65289;\2100,2500,2700&#12487;&#12540;&#12479;&#25774;&#12426;&#30452;&#12375;\210702_protocol&amp;result_T-cadherin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3.xml"/></Relationships>
</file>

<file path=ppt/charts/_rels/chart3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9.xml"/><Relationship Id="rId1" Type="http://schemas.openxmlformats.org/officeDocument/2006/relationships/oleObject" Target="file:///\\192.168.1.37\fukuoka\&#23455;&#39443;&#12487;&#12540;&#12479;\220315_ER%20stres_supplimental_5000\5001-5024%20(293TT,%20TM,%202-24h)\RNA\2022-03-18%20112321.xls" TargetMode="External"/></Relationships>
</file>

<file path=ppt/charts/_rels/chart3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0.xml"/><Relationship Id="rId1" Type="http://schemas.openxmlformats.org/officeDocument/2006/relationships/oleObject" Target="file:///\\192.168.1.37\fukuoka\&#23455;&#39443;&#12487;&#12540;&#12479;\220314_F2_poly(IC)_4900\4901-4924_F2%20poly(IC)\ChemiDoc%20Images%202022-03-22_18.36.36\4901-4924%20XBP1.xlsx" TargetMode="External"/></Relationships>
</file>

<file path=ppt/charts/_rels/chart3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1.xml"/><Relationship Id="rId1" Type="http://schemas.openxmlformats.org/officeDocument/2006/relationships/oleObject" Target="file:///\\192.168.1.37\fukuoka\&#23455;&#39443;&#12487;&#12540;&#12479;\220314_F2_poly(IC)_4900\4901-4924_F2%20poly(IC)\2022-03-17%20133612.xls" TargetMode="External"/></Relationships>
</file>

<file path=ppt/charts/_rels/chart3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2.xml"/><Relationship Id="rId1" Type="http://schemas.openxmlformats.org/officeDocument/2006/relationships/oleObject" Target="file:///\\192.168.1.37\fukuoka\&#23455;&#39443;&#12487;&#12540;&#12479;\220314_F2_poly(IC)_4900\4937-4948_F2%20poly(IC)\exosome\493748%20band%20intensity.xlsx" TargetMode="External"/></Relationships>
</file>

<file path=ppt/charts/_rels/chart3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3.xml"/><Relationship Id="rId1" Type="http://schemas.openxmlformats.org/officeDocument/2006/relationships/oleObject" Target="file:///\\192.168.1.37\fukuoka\&#23455;&#39443;&#12487;&#12540;&#12479;\220314_F2_poly(IC)_4900\4937-4948_F2%20poly(IC)\exosome\493748%20band%20intensity.xlsx" TargetMode="External"/></Relationships>
</file>

<file path=ppt/charts/_rels/chart3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4.xml"/><Relationship Id="rId1" Type="http://schemas.openxmlformats.org/officeDocument/2006/relationships/oleObject" Target="file:///\\192.168.1.37\fukuoka\&#23455;&#39443;&#12487;&#12540;&#12479;\220314_F2_poly(IC)_4900\4937-4948_F2%20poly(IC)\exosome\493748%20band%20intensity.xlsx" TargetMode="External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211201_C57B6_TM_4400\Tunicamycin&#25237;&#19982;&#20108;&#22238;&#30446;&#65288;2&#26085;&#36899;&#25237;&#65289;\211201_TMip&#12414;&#12392;&#12417;.xlsx" TargetMode="Externa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chartUserShapes" Target="../drawings/drawing35.xml"/></Relationships>
</file>

<file path=ppt/charts/_rels/chart3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6.xml"/><Relationship Id="rId1" Type="http://schemas.openxmlformats.org/officeDocument/2006/relationships/oleObject" Target="file:///\\192.168.1.37\fukuoka\&#23455;&#39443;&#12487;&#12540;&#12479;\_211201_C57B6_TM_4400\Tunicamycin&#25237;&#19982;&#20108;&#22238;&#30446;&#65288;2&#26085;&#36899;&#25237;&#65289;\&#12479;&#12531;&#12497;&#12463;&#36074;\WB&#12496;&#12531;&#12489;&#23450;&#37327;.xlsx" TargetMode="External"/></Relationships>
</file>

<file path=ppt/charts/_rels/chart38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_211201_C57B6_TM_4400\Tunicamycin&#25237;&#19982;&#20108;&#22238;&#30446;&#65288;2&#26085;&#36899;&#25237;&#65289;\&#12479;&#12531;&#12497;&#12463;&#36074;\WB&#12496;&#12531;&#12489;&#23450;&#37327;.xlsx" TargetMode="Externa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chartUserShapes" Target="../drawings/drawing37.xml"/></Relationships>
</file>

<file path=ppt/charts/_rels/chart3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8.xml"/><Relationship Id="rId1" Type="http://schemas.openxmlformats.org/officeDocument/2006/relationships/oleObject" Target="file:///\\192.168.1.37\fukuoka\&#23455;&#39443;&#12487;&#12540;&#12479;\_211201_C57B6_TM_4400\Tunicamycin&#25237;&#19982;&#20108;&#22238;&#30446;&#65288;2&#26085;&#36899;&#25237;&#65289;\&#12479;&#12531;&#12497;&#12463;&#36074;\WB&#12496;&#12531;&#12489;&#23450;&#37327;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210614_CHO-Tcad_ERstress(Tunic&amp;MG)_2800\210614_protocol&amp;result_2800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4.xml"/></Relationships>
</file>

<file path=ppt/charts/_rels/chart4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9.xml"/><Relationship Id="rId1" Type="http://schemas.openxmlformats.org/officeDocument/2006/relationships/oleObject" Target="file:///\\192.168.1.37\fukuoka\&#23455;&#39443;&#12487;&#12540;&#12479;\_211201_C57B6_TM_4400\Tunicamycin&#25237;&#19982;&#20108;&#22238;&#30446;&#65288;2&#26085;&#36899;&#25237;&#65289;\&#12479;&#12531;&#12497;&#12463;&#36074;\WB&#12496;&#12531;&#12489;&#23450;&#37327;.xlsx" TargetMode="External"/></Relationships>
</file>

<file path=ppt/charts/_rels/chart4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0.xml"/><Relationship Id="rId1" Type="http://schemas.openxmlformats.org/officeDocument/2006/relationships/oleObject" Target="file:///\\192.168.1.37\fukuoka\&#23455;&#39443;&#12487;&#12540;&#12479;\211201_C57B6_TM_4400\Tunicamycin&#25237;&#19982;&#20108;&#22238;&#30446;&#65288;2&#26085;&#36899;&#25237;&#65289;\&#12479;&#12531;&#12497;&#12463;&#36074;\WB&#12496;&#12531;&#12489;&#23450;&#37327;.xlsx" TargetMode="External"/></Relationships>
</file>

<file path=ppt/charts/_rels/chart4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1.xml"/><Relationship Id="rId1" Type="http://schemas.openxmlformats.org/officeDocument/2006/relationships/oleObject" Target="file:///\\192.168.1.37\fukuoka\&#23455;&#39443;&#12487;&#12540;&#12479;\211201_C57B6_TM_4400\Tunicamycin&#25237;&#19982;&#20108;&#22238;&#30446;&#65288;2&#26085;&#36899;&#25237;&#65289;\&#12479;&#12531;&#12497;&#12463;&#36074;\WB&#12496;&#12531;&#12489;&#23450;&#37327;.xlsx" TargetMode="External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oleObject" Target="file:///\\192.168.1.37\fukuoka\&#23455;&#39443;&#12487;&#12540;&#12479;\211201_C57B6_TM_4400\Tunicamycin&#25237;&#19982;&#20108;&#22238;&#30446;&#65288;2&#26085;&#36899;&#25237;&#65289;\&#34880;&#20013;&#12456;&#12463;&#12477;&#12477;&#12540;&#12512;\Nanocyte\NS300\&#12487;&#12540;&#12479;&#12414;&#12392;&#12417;%20(&#33258;&#21205;&#20445;&#23384;&#28168;&#12415;).xlsx" TargetMode="External"/></Relationships>
</file>

<file path=ppt/charts/_rels/chart44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_230301_revise_6400\TM%20vivo%20model\230410_pre2\230410%20TMip%20body%20weight.xlsx" TargetMode="External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chartUserShapes" Target="../drawings/drawing42.xml"/></Relationships>
</file>

<file path=ppt/charts/_rels/chart4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3.xml"/><Relationship Id="rId1" Type="http://schemas.openxmlformats.org/officeDocument/2006/relationships/oleObject" Target="file:///\\192.168.1.37\fukuoka\&#23455;&#39443;&#12487;&#12540;&#12479;\_230301_revise_6400\TM%20vivo%20model\230410_pre2\230410%20TMip%20body%20weight.xlsx" TargetMode="External"/></Relationships>
</file>

<file path=ppt/charts/_rels/chart4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4.xml"/><Relationship Id="rId1" Type="http://schemas.openxmlformats.org/officeDocument/2006/relationships/oleObject" Target="file:///\\192.168.1.37\fukuoka\&#23455;&#39443;&#12487;&#12540;&#12479;\_230301_revise_6400\TM%20vivo%20model\230410_pre2\230410%20TMip%20body%20weight.xlsx" TargetMode="External"/></Relationships>
</file>

<file path=ppt/charts/_rels/chart4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5.xml"/><Relationship Id="rId1" Type="http://schemas.openxmlformats.org/officeDocument/2006/relationships/oleObject" Target="file:///\\192.168.1.37\fukuoka\&#23455;&#39443;&#12487;&#12540;&#12479;\_230301_revise_6400\TM%20vivo%20model\230410_pre2\RNA\2023-04-21%20165019.xls" TargetMode="External"/></Relationships>
</file>

<file path=ppt/charts/_rels/chart4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6.xml"/><Relationship Id="rId1" Type="http://schemas.openxmlformats.org/officeDocument/2006/relationships/oleObject" Target="file:///\\192.168.1.37\fukuoka\&#23455;&#39443;&#12487;&#12540;&#12479;\_230301_revise_6400\TM%20vivo%20model\230410_pre2\exosome\band%20intensity.xlsx" TargetMode="External"/></Relationships>
</file>

<file path=ppt/charts/_rels/chart4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7.xml"/><Relationship Id="rId1" Type="http://schemas.openxmlformats.org/officeDocument/2006/relationships/oleObject" Target="file:///\\192.168.1.37\fukuoka\&#23455;&#39443;&#12487;&#12540;&#12479;\_230301_revise_6400\TM%20vivo%20model\230410_pre2\exosome\band%20intensity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210614_CHO-Tcad_ERstress(Tunic&amp;MG)_2800\210614_protocol&amp;result_2800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5.xml"/></Relationships>
</file>

<file path=ppt/charts/_rels/chart5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8.xml"/><Relationship Id="rId1" Type="http://schemas.openxmlformats.org/officeDocument/2006/relationships/oleObject" Target="file:///\\192.168.1.37\fukuoka\&#23455;&#39443;&#12487;&#12540;&#12479;\_230301_revise_6400\TM%20vivo%20model\230410_pre2\exosome\band%20intensity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210614_CHO-Tcad_ERstress(Tunic&amp;MG)_2800\210614_protocol&amp;result_2800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210614_CHO-Tcad_ERstress(Tunic&amp;MG)_2800\210614_protocol&amp;result_2800.xlsx" TargetMode="Externa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Chinese%20hamster%2036B4&#26908;&#35342;&#65288;2100,2500,2700&#65289;\2100,2500,2700&#12487;&#12540;&#12479;&#25774;&#12426;&#30452;&#12375;\210702_protocol&amp;result_GRP78.xlsx" TargetMode="Externa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chartUserShapes" Target="../drawings/drawing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2.168.1.37\fukuoka\&#23455;&#39443;&#12487;&#12540;&#12479;\210512_CHO-Tcad_ERstress_2100\Thaps%200.1-1%20&#956;M\XBP1&#23450;&#37327;.xlsx" TargetMode="Externa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chartUserShapes" Target="../drawings/drawing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sz="1200"/>
            </a:pPr>
            <a:r>
              <a:rPr lang="en-US" altLang="ja-JP" sz="1200" dirty="0"/>
              <a:t>T-cadherin/tubulin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646-4CBC-B056-1345EDEA61A4}"/>
              </c:ext>
            </c:extLst>
          </c:dPt>
          <c:dPt>
            <c:idx val="1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646-4CBC-B056-1345EDEA61A4}"/>
              </c:ext>
            </c:extLst>
          </c:dPt>
          <c:dPt>
            <c:idx val="2"/>
            <c:invertIfNegative val="0"/>
            <c:bubble3D val="0"/>
            <c:spPr>
              <a:pattFill prst="smGrid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646-4CBC-B056-1345EDEA61A4}"/>
              </c:ext>
            </c:extLst>
          </c:dPt>
          <c:errBars>
            <c:errBarType val="plus"/>
            <c:errValType val="cust"/>
            <c:noEndCap val="0"/>
            <c:plus>
              <c:numRef>
                <c:f>'[WB band intensity.xlsx]T-cadherin'!$L$22:$L$25</c:f>
                <c:numCache>
                  <c:formatCode>General</c:formatCode>
                  <c:ptCount val="4"/>
                  <c:pt idx="0">
                    <c:v>0.11989942972790525</c:v>
                  </c:pt>
                  <c:pt idx="1">
                    <c:v>6.1204127314740835E-2</c:v>
                  </c:pt>
                  <c:pt idx="2">
                    <c:v>7.3864500769097757E-2</c:v>
                  </c:pt>
                  <c:pt idx="3">
                    <c:v>0.163747879890919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'[WB band intensity.xlsx]T-cadherin'!$G$22:$G$25</c:f>
              <c:strCache>
                <c:ptCount val="4"/>
                <c:pt idx="0">
                  <c:v>DMSO</c:v>
                </c:pt>
                <c:pt idx="1">
                  <c:v>TG</c:v>
                </c:pt>
                <c:pt idx="2">
                  <c:v>TM</c:v>
                </c:pt>
                <c:pt idx="3">
                  <c:v>MG</c:v>
                </c:pt>
              </c:strCache>
            </c:strRef>
          </c:cat>
          <c:val>
            <c:numRef>
              <c:f>'[WB band intensity.xlsx]T-cadherin'!$H$22:$H$25</c:f>
              <c:numCache>
                <c:formatCode>General</c:formatCode>
                <c:ptCount val="4"/>
                <c:pt idx="0">
                  <c:v>1</c:v>
                </c:pt>
                <c:pt idx="1">
                  <c:v>0.33695938376549539</c:v>
                </c:pt>
                <c:pt idx="2">
                  <c:v>0.42955200416523615</c:v>
                </c:pt>
                <c:pt idx="3">
                  <c:v>0.894226929009717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646-4CBC-B056-1345EDEA61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813443392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WB band intensity.xlsx]T-cadherin'!$G$22:$G$25</c:f>
              <c:strCache>
                <c:ptCount val="4"/>
                <c:pt idx="0">
                  <c:v>DMSO</c:v>
                </c:pt>
                <c:pt idx="1">
                  <c:v>TG</c:v>
                </c:pt>
                <c:pt idx="2">
                  <c:v>TM</c:v>
                </c:pt>
                <c:pt idx="3">
                  <c:v>MG</c:v>
                </c:pt>
              </c:strCache>
            </c:strRef>
          </c:xVal>
          <c:yVal>
            <c:numRef>
              <c:f>'[WB band intensity.xlsx]T-cadherin'!$I$22:$I$25</c:f>
              <c:numCache>
                <c:formatCode>General</c:formatCode>
                <c:ptCount val="4"/>
                <c:pt idx="0">
                  <c:v>0.74403772667977142</c:v>
                </c:pt>
                <c:pt idx="1">
                  <c:v>0.18861237958307558</c:v>
                </c:pt>
                <c:pt idx="2">
                  <c:v>0.25248670647658378</c:v>
                </c:pt>
                <c:pt idx="3">
                  <c:v>0.662839916216616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1646-4CBC-B056-1345EDEA61A4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WB band intensity.xlsx]T-cadherin'!$G$22:$G$25</c:f>
              <c:strCache>
                <c:ptCount val="4"/>
                <c:pt idx="0">
                  <c:v>DMSO</c:v>
                </c:pt>
                <c:pt idx="1">
                  <c:v>TG</c:v>
                </c:pt>
                <c:pt idx="2">
                  <c:v>TM</c:v>
                </c:pt>
                <c:pt idx="3">
                  <c:v>MG</c:v>
                </c:pt>
              </c:strCache>
            </c:strRef>
          </c:xVal>
          <c:yVal>
            <c:numRef>
              <c:f>'[WB band intensity.xlsx]T-cadherin'!$J$22:$J$25</c:f>
              <c:numCache>
                <c:formatCode>General</c:formatCode>
                <c:ptCount val="4"/>
                <c:pt idx="0">
                  <c:v>1.0032657983957238</c:v>
                </c:pt>
                <c:pt idx="1">
                  <c:v>0.39238113489335863</c:v>
                </c:pt>
                <c:pt idx="2">
                  <c:v>0.48587051949292315</c:v>
                </c:pt>
                <c:pt idx="3">
                  <c:v>1.29365480853099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1646-4CBC-B056-1345EDEA61A4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WB band intensity.xlsx]T-cadherin'!$G$22:$G$25</c:f>
              <c:strCache>
                <c:ptCount val="4"/>
                <c:pt idx="0">
                  <c:v>DMSO</c:v>
                </c:pt>
                <c:pt idx="1">
                  <c:v>TG</c:v>
                </c:pt>
                <c:pt idx="2">
                  <c:v>TM</c:v>
                </c:pt>
                <c:pt idx="3">
                  <c:v>MG</c:v>
                </c:pt>
              </c:strCache>
            </c:strRef>
          </c:xVal>
          <c:yVal>
            <c:numRef>
              <c:f>'[WB band intensity.xlsx]T-cadherin'!$K$22:$K$25</c:f>
              <c:numCache>
                <c:formatCode>General</c:formatCode>
                <c:ptCount val="4"/>
                <c:pt idx="0">
                  <c:v>1.2526964749245046</c:v>
                </c:pt>
                <c:pt idx="1">
                  <c:v>0.42988463682005196</c:v>
                </c:pt>
                <c:pt idx="2">
                  <c:v>0.55029878652620168</c:v>
                </c:pt>
                <c:pt idx="3">
                  <c:v>0.726186062281539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1646-4CBC-B056-1345EDEA61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3443392"/>
        <c:axId val="1"/>
      </c:scatterChart>
      <c:catAx>
        <c:axId val="813443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0" dirty="0"/>
                  <a:t>Arbitrary units</a:t>
                </a:r>
                <a:endParaRPr lang="ja-JP" dirty="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81344339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i="1" dirty="0" smtClean="0"/>
              <a:t>Xbp1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splicing</a:t>
            </a:r>
            <a:endParaRPr lang="ja-JP" alt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smGrid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EC7-4A85-9388-CA16BEE3CE4B}"/>
              </c:ext>
            </c:extLst>
          </c:dPt>
          <c:errBars>
            <c:errBarType val="plus"/>
            <c:errValType val="cust"/>
            <c:noEndCap val="0"/>
            <c:plus>
              <c:numRef>
                <c:f>[XBP1_JMP.xlsx]Sheet2!$M$38:$M$41</c:f>
                <c:numCache>
                  <c:formatCode>General</c:formatCode>
                  <c:ptCount val="4"/>
                  <c:pt idx="0">
                    <c:v>0.81613695034824874</c:v>
                  </c:pt>
                  <c:pt idx="1">
                    <c:v>0.52887772500543295</c:v>
                  </c:pt>
                  <c:pt idx="2">
                    <c:v>1.2904217677860741</c:v>
                  </c:pt>
                  <c:pt idx="3">
                    <c:v>1.26849942841433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XBP1_JMP.xlsx]Sheet2!$H$38:$H$41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[XBP1_JMP.xlsx]Sheet2!$I$38:$I$41</c:f>
              <c:numCache>
                <c:formatCode>General</c:formatCode>
                <c:ptCount val="4"/>
                <c:pt idx="0">
                  <c:v>40.062127581201274</c:v>
                </c:pt>
                <c:pt idx="1">
                  <c:v>71.341354052599641</c:v>
                </c:pt>
                <c:pt idx="2">
                  <c:v>75.367899664482479</c:v>
                </c:pt>
                <c:pt idx="3">
                  <c:v>81.814347056704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EC7-4A85-9388-CA16BEE3CE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862257216"/>
        <c:axId val="86225754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[XBP1_JMP.xlsx]Sheet2!$H$38:$H$41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[XBP1_JMP.xlsx]Sheet2!$J$38:$J$41</c:f>
              <c:numCache>
                <c:formatCode>General</c:formatCode>
                <c:ptCount val="4"/>
                <c:pt idx="0">
                  <c:v>38.990345028526249</c:v>
                </c:pt>
                <c:pt idx="1">
                  <c:v>72.146321070377056</c:v>
                </c:pt>
                <c:pt idx="2">
                  <c:v>77.849643637622762</c:v>
                </c:pt>
                <c:pt idx="3">
                  <c:v>84.6325556790832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EC7-4A85-9388-CA16BEE3CE4B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[XBP1_JMP.xlsx]Sheet2!$H$38:$H$41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[XBP1_JMP.xlsx]Sheet2!$K$38:$K$41</c:f>
              <c:numCache>
                <c:formatCode>General</c:formatCode>
                <c:ptCount val="4"/>
                <c:pt idx="0">
                  <c:v>42.059463166293959</c:v>
                </c:pt>
                <c:pt idx="1">
                  <c:v>70.059823621613447</c:v>
                </c:pt>
                <c:pt idx="2">
                  <c:v>72.43172308482913</c:v>
                </c:pt>
                <c:pt idx="3">
                  <c:v>81.5384610475447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6EC7-4A85-9388-CA16BEE3CE4B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[XBP1_JMP.xlsx]Sheet2!$H$38:$H$41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[XBP1_JMP.xlsx]Sheet2!$L$38:$L$41</c:f>
              <c:numCache>
                <c:formatCode>General</c:formatCode>
                <c:ptCount val="4"/>
                <c:pt idx="0">
                  <c:v>39.136574548783614</c:v>
                </c:pt>
                <c:pt idx="1">
                  <c:v>71.817917465808392</c:v>
                </c:pt>
                <c:pt idx="2">
                  <c:v>75.82233227099556</c:v>
                </c:pt>
                <c:pt idx="3">
                  <c:v>79.272024443484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6EC7-4A85-9388-CA16BEE3CE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2257216"/>
        <c:axId val="862257544"/>
      </c:scatterChart>
      <c:catAx>
        <c:axId val="8622572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dirty="0" err="1"/>
                  <a:t>Tunicamycin</a:t>
                </a:r>
                <a:r>
                  <a:rPr lang="en-US" altLang="ja-JP" dirty="0"/>
                  <a:t> (</a:t>
                </a:r>
                <a:r>
                  <a:rPr lang="en-US" altLang="ja-JP" baseline="0" dirty="0" err="1"/>
                  <a:t>μmol</a:t>
                </a:r>
                <a:r>
                  <a:rPr lang="en-US" altLang="ja-JP" baseline="0" dirty="0"/>
                  <a:t>/L)</a:t>
                </a:r>
                <a:endParaRPr lang="ja-JP" altLang="en-US" dirty="0"/>
              </a:p>
            </c:rich>
          </c:tx>
          <c:layout>
            <c:manualLayout>
              <c:xMode val="edge"/>
              <c:yMode val="edge"/>
              <c:x val="0.25649861111111111"/>
              <c:y val="0.8265901234567901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2257544"/>
        <c:crosses val="autoZero"/>
        <c:auto val="1"/>
        <c:lblAlgn val="ctr"/>
        <c:lblOffset val="100"/>
        <c:noMultiLvlLbl val="0"/>
      </c:catAx>
      <c:valAx>
        <c:axId val="86225754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dirty="0"/>
                  <a:t>% spliced </a:t>
                </a:r>
                <a:r>
                  <a:rPr lang="en-US" altLang="ja-JP" i="1" dirty="0" smtClean="0"/>
                  <a:t>Xbp1 </a:t>
                </a:r>
                <a:r>
                  <a:rPr lang="en-US" altLang="ja-JP" dirty="0"/>
                  <a:t>amplicons</a:t>
                </a:r>
                <a:endParaRPr lang="ja-JP" alt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225721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altLang="ja-JP" sz="1200" i="1" dirty="0" smtClean="0"/>
              <a:t>Xbp1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splicing</a:t>
            </a:r>
            <a:endParaRPr lang="ja-JP" altLang="en-US" sz="1200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FF1-4368-B0E2-3DFBE99759E2}"/>
              </c:ext>
            </c:extLst>
          </c:dPt>
          <c:errBars>
            <c:errBarType val="plus"/>
            <c:errValType val="cust"/>
            <c:noEndCap val="0"/>
            <c:plus>
              <c:numRef>
                <c:f>[XBP1_JMP.xlsx]Sheet2!$M$42:$M$45</c:f>
                <c:numCache>
                  <c:formatCode>General</c:formatCode>
                  <c:ptCount val="4"/>
                  <c:pt idx="0">
                    <c:v>2.4598231791655025</c:v>
                  </c:pt>
                  <c:pt idx="1">
                    <c:v>1.2016622812597089</c:v>
                  </c:pt>
                  <c:pt idx="2">
                    <c:v>2.810978363594951</c:v>
                  </c:pt>
                  <c:pt idx="3">
                    <c:v>3.19842338196648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XBP1_JMP.xlsx]Sheet2!$H$42:$H$4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[XBP1_JMP.xlsx]Sheet2!$I$42:$I$45</c:f>
              <c:numCache>
                <c:formatCode>General</c:formatCode>
                <c:ptCount val="4"/>
                <c:pt idx="0">
                  <c:v>40.5739792396867</c:v>
                </c:pt>
                <c:pt idx="1">
                  <c:v>75.450966301812571</c:v>
                </c:pt>
                <c:pt idx="2">
                  <c:v>61.210796967714913</c:v>
                </c:pt>
                <c:pt idx="3">
                  <c:v>35.4128676681501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FF1-4368-B0E2-3DFBE99759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862257216"/>
        <c:axId val="86225754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[XBP1_JMP.xlsx]Sheet2!$H$42:$H$4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[XBP1_JMP.xlsx]Sheet2!$J$42:$J$45</c:f>
              <c:numCache>
                <c:formatCode>General</c:formatCode>
                <c:ptCount val="4"/>
                <c:pt idx="0">
                  <c:v>35.440173499357016</c:v>
                </c:pt>
                <c:pt idx="1">
                  <c:v>72.557586032533578</c:v>
                </c:pt>
                <c:pt idx="2">
                  <c:v>54.950599430837684</c:v>
                </c:pt>
                <c:pt idx="3">
                  <c:v>32.2630937218697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FF1-4368-B0E2-3DFBE99759E2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[XBP1_JMP.xlsx]Sheet2!$H$42:$H$4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[XBP1_JMP.xlsx]Sheet2!$K$42:$K$45</c:f>
              <c:numCache>
                <c:formatCode>General</c:formatCode>
                <c:ptCount val="4"/>
                <c:pt idx="0">
                  <c:v>45.872422754403239</c:v>
                </c:pt>
                <c:pt idx="1">
                  <c:v>77.365874371734961</c:v>
                </c:pt>
                <c:pt idx="2">
                  <c:v>61.858025980779217</c:v>
                </c:pt>
                <c:pt idx="3">
                  <c:v>43.200145296416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6FF1-4368-B0E2-3DFBE99759E2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[XBP1_JMP.xlsx]Sheet2!$H$42:$H$4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[XBP1_JMP.xlsx]Sheet2!$L$42:$L$45</c:f>
              <c:numCache>
                <c:formatCode>General</c:formatCode>
                <c:ptCount val="4"/>
                <c:pt idx="0">
                  <c:v>40.409341465299839</c:v>
                </c:pt>
                <c:pt idx="1">
                  <c:v>76.429438501169159</c:v>
                </c:pt>
                <c:pt idx="2">
                  <c:v>66.823765491527837</c:v>
                </c:pt>
                <c:pt idx="3">
                  <c:v>30.7753639861646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6FF1-4368-B0E2-3DFBE99759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2257216"/>
        <c:axId val="862257544"/>
      </c:scatterChart>
      <c:catAx>
        <c:axId val="8622572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dirty="0"/>
                  <a:t>MG132 (</a:t>
                </a:r>
                <a:r>
                  <a:rPr lang="en-US" altLang="ja-JP" baseline="0" dirty="0" err="1"/>
                  <a:t>μmol</a:t>
                </a:r>
                <a:r>
                  <a:rPr lang="en-US" altLang="ja-JP" baseline="0" dirty="0"/>
                  <a:t>/L)</a:t>
                </a:r>
                <a:endParaRPr lang="ja-JP" alt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2257544"/>
        <c:crosses val="autoZero"/>
        <c:auto val="1"/>
        <c:lblAlgn val="ctr"/>
        <c:lblOffset val="100"/>
        <c:noMultiLvlLbl val="0"/>
      </c:catAx>
      <c:valAx>
        <c:axId val="86225754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dirty="0"/>
                  <a:t>% spliced </a:t>
                </a:r>
                <a:r>
                  <a:rPr lang="en-US" altLang="ja-JP" i="1" dirty="0" smtClean="0"/>
                  <a:t>Xbp1 </a:t>
                </a:r>
                <a:r>
                  <a:rPr lang="en-US" altLang="ja-JP" dirty="0"/>
                  <a:t>amplicons</a:t>
                </a:r>
                <a:endParaRPr lang="ja-JP" alt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62257216"/>
        <c:crosses val="autoZero"/>
        <c:crossBetween val="between"/>
        <c:majorUnit val="20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sz="1200"/>
            </a:pPr>
            <a:r>
              <a:rPr lang="en-US" sz="1200" dirty="0"/>
              <a:t>T-cadherin mRNA</a:t>
            </a:r>
            <a:endParaRPr lang="ja-JP" sz="1200" dirty="0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DMSO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285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2022-03-18 112321.xls]calculate'!$G$31:$G$34</c:f>
                <c:numCache>
                  <c:formatCode>General</c:formatCode>
                  <c:ptCount val="4"/>
                  <c:pt idx="0">
                    <c:v>2.4383459090860867E-2</c:v>
                  </c:pt>
                  <c:pt idx="1">
                    <c:v>3.2995503318918762E-2</c:v>
                  </c:pt>
                  <c:pt idx="2">
                    <c:v>4.1465644399610389E-2</c:v>
                  </c:pt>
                  <c:pt idx="3">
                    <c:v>3.4714764011849038E-2</c:v>
                  </c:pt>
                </c:numCache>
              </c:numRef>
            </c:plus>
            <c:minus>
              <c:numRef>
                <c:f>'[2022-03-18 112321.xls]calculate'!$G$31:$G$34</c:f>
                <c:numCache>
                  <c:formatCode>General</c:formatCode>
                  <c:ptCount val="4"/>
                  <c:pt idx="0">
                    <c:v>2.4383459090860867E-2</c:v>
                  </c:pt>
                  <c:pt idx="1">
                    <c:v>3.2995503318918762E-2</c:v>
                  </c:pt>
                  <c:pt idx="2">
                    <c:v>4.1465644399610389E-2</c:v>
                  </c:pt>
                  <c:pt idx="3">
                    <c:v>3.4714764011849038E-2</c:v>
                  </c:pt>
                </c:numCache>
              </c:numRef>
            </c:minus>
          </c:errBars>
          <c:xVal>
            <c:numRef>
              <c:f>'[2022-03-18 112321.xls]calculate'!$B$41:$B$44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2022-03-18 112321.xls]calculate'!$C$41:$C$44</c:f>
              <c:numCache>
                <c:formatCode>#,##0.00_ </c:formatCode>
                <c:ptCount val="4"/>
                <c:pt idx="0">
                  <c:v>1</c:v>
                </c:pt>
                <c:pt idx="1">
                  <c:v>0.90625403709339103</c:v>
                </c:pt>
                <c:pt idx="2">
                  <c:v>0.88724061407213217</c:v>
                </c:pt>
                <c:pt idx="3">
                  <c:v>0.903612097010126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F9C-476A-B16F-D0A31F2EFBB9}"/>
            </c:ext>
          </c:extLst>
        </c:ser>
        <c:ser>
          <c:idx val="1"/>
          <c:order val="1"/>
          <c:tx>
            <c:v>TM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2857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2022-03-18 112321.xls]calculate'!$G$35:$G$38</c:f>
                <c:numCache>
                  <c:formatCode>General</c:formatCode>
                  <c:ptCount val="4"/>
                  <c:pt idx="0">
                    <c:v>2.2734345989763493E-2</c:v>
                  </c:pt>
                  <c:pt idx="1">
                    <c:v>5.6430101668895068E-2</c:v>
                  </c:pt>
                  <c:pt idx="2">
                    <c:v>4.4383503261166295E-2</c:v>
                  </c:pt>
                  <c:pt idx="3">
                    <c:v>3.8687538195900067E-2</c:v>
                  </c:pt>
                </c:numCache>
              </c:numRef>
            </c:plus>
            <c:minus>
              <c:numRef>
                <c:f>'[2022-03-18 112321.xls]calculate'!$G$35:$G$38</c:f>
                <c:numCache>
                  <c:formatCode>General</c:formatCode>
                  <c:ptCount val="4"/>
                  <c:pt idx="0">
                    <c:v>2.2734345989763493E-2</c:v>
                  </c:pt>
                  <c:pt idx="1">
                    <c:v>5.6430101668895068E-2</c:v>
                  </c:pt>
                  <c:pt idx="2">
                    <c:v>4.4383503261166295E-2</c:v>
                  </c:pt>
                  <c:pt idx="3">
                    <c:v>3.8687538195900067E-2</c:v>
                  </c:pt>
                </c:numCache>
              </c:numRef>
            </c:minus>
          </c:errBars>
          <c:xVal>
            <c:numRef>
              <c:f>'[2022-03-18 112321.xls]calculate'!$B$41:$B$44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2022-03-18 112321.xls]calculate'!$D$41:$D$44</c:f>
              <c:numCache>
                <c:formatCode>#,##0.00_ </c:formatCode>
                <c:ptCount val="4"/>
                <c:pt idx="0">
                  <c:v>0.9050477798759774</c:v>
                </c:pt>
                <c:pt idx="1">
                  <c:v>0.952704489508854</c:v>
                </c:pt>
                <c:pt idx="2">
                  <c:v>0.35838254855814183</c:v>
                </c:pt>
                <c:pt idx="3">
                  <c:v>0.54830019433455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F9C-476A-B16F-D0A31F2EFB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07876416"/>
        <c:axId val="1"/>
      </c:scatterChart>
      <c:valAx>
        <c:axId val="507876416"/>
        <c:scaling>
          <c:orientation val="minMax"/>
          <c:max val="25"/>
          <c:min val="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hour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ja-JP"/>
          </a:p>
        </c:txPr>
        <c:crossAx val="1"/>
        <c:crosses val="autoZero"/>
        <c:crossBetween val="midCat"/>
      </c:val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DH13/18S (AU)</a:t>
                </a:r>
                <a:endParaRPr lang="ja-JP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#,##0.00_ 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07876416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58894227543190836"/>
          <c:y val="0.17769586524870537"/>
          <c:w val="0.36915603313884265"/>
          <c:h val="0.15625121859767532"/>
        </c:manualLayout>
      </c:layout>
      <c:overlay val="1"/>
      <c:spPr>
        <a:noFill/>
        <a:ln w="25400">
          <a:noFill/>
        </a:ln>
      </c:spPr>
      <c:txPr>
        <a:bodyPr rot="0" vert="horz"/>
        <a:lstStyle/>
        <a:p>
          <a:pPr>
            <a:defRPr/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i="1" dirty="0"/>
              <a:t>XBP1</a:t>
            </a:r>
            <a:r>
              <a:rPr lang="en-US" sz="1200" dirty="0"/>
              <a:t> splicing</a:t>
            </a:r>
            <a:endParaRPr lang="ja-JP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2655039878655284"/>
          <c:y val="0.16997278053871914"/>
          <c:w val="0.72540982711186774"/>
          <c:h val="0.62241770833333332"/>
        </c:manualLayout>
      </c:layout>
      <c:scatterChart>
        <c:scatterStyle val="lineMarker"/>
        <c:varyColors val="0"/>
        <c:ser>
          <c:idx val="0"/>
          <c:order val="0"/>
          <c:tx>
            <c:v>DMSO</c:v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2857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5001-5024 XBP1.xlsx]Sheet1'!$N$47:$N$50</c:f>
                <c:numCache>
                  <c:formatCode>General</c:formatCode>
                  <c:ptCount val="4"/>
                  <c:pt idx="0">
                    <c:v>1.0113268559782167</c:v>
                  </c:pt>
                  <c:pt idx="1">
                    <c:v>1.3949714173516337</c:v>
                  </c:pt>
                  <c:pt idx="2">
                    <c:v>1.3909041880309727</c:v>
                  </c:pt>
                  <c:pt idx="3">
                    <c:v>1.89337902436481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5001-5024 XBP1.xlsx]Sheet1'!$J$47:$J$50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5001-5024 XBP1.xlsx]Sheet1'!$K$47:$K$50</c:f>
              <c:numCache>
                <c:formatCode>General</c:formatCode>
                <c:ptCount val="4"/>
                <c:pt idx="0">
                  <c:v>10.488084990625936</c:v>
                </c:pt>
                <c:pt idx="1">
                  <c:v>11.330618993958415</c:v>
                </c:pt>
                <c:pt idx="2">
                  <c:v>13.184755609758836</c:v>
                </c:pt>
                <c:pt idx="3">
                  <c:v>15.4700654049491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D94-408D-A21D-F71A0301057F}"/>
            </c:ext>
          </c:extLst>
        </c:ser>
        <c:ser>
          <c:idx val="1"/>
          <c:order val="1"/>
          <c:tx>
            <c:v>TM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2857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5001-5024 XBP1.xlsx]Sheet1'!$O$47:$O$50</c:f>
                <c:numCache>
                  <c:formatCode>General</c:formatCode>
                  <c:ptCount val="4"/>
                  <c:pt idx="0">
                    <c:v>3.5091057994926373</c:v>
                  </c:pt>
                  <c:pt idx="1">
                    <c:v>3.5387043584835647</c:v>
                  </c:pt>
                  <c:pt idx="2">
                    <c:v>1.5558331160143637</c:v>
                  </c:pt>
                  <c:pt idx="3">
                    <c:v>1.75463131420095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5001-5024 XBP1.xlsx]Sheet1'!$J$47:$J$50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5001-5024 XBP1.xlsx]Sheet1'!$L$47:$L$50</c:f>
              <c:numCache>
                <c:formatCode>General</c:formatCode>
                <c:ptCount val="4"/>
                <c:pt idx="0">
                  <c:v>53.827015848472229</c:v>
                </c:pt>
                <c:pt idx="1">
                  <c:v>59.709057267585251</c:v>
                </c:pt>
                <c:pt idx="2">
                  <c:v>33.922235320678546</c:v>
                </c:pt>
                <c:pt idx="3">
                  <c:v>37.7120319475812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D94-408D-A21D-F71A030105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36015888"/>
        <c:axId val="836016216"/>
      </c:scatterChart>
      <c:valAx>
        <c:axId val="836015888"/>
        <c:scaling>
          <c:orientation val="minMax"/>
          <c:max val="25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hour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36016216"/>
        <c:crosses val="autoZero"/>
        <c:crossBetween val="midCat"/>
      </c:valAx>
      <c:valAx>
        <c:axId val="8360162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% spliced XBP1 amplicons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1.628205128205128E-2"/>
              <c:y val="0.1699725694444444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3601588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64723205772612857"/>
          <c:y val="0.18553255456698134"/>
          <c:w val="0.32898587588695094"/>
          <c:h val="0.1760577273702409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sz="1600"/>
            </a:pPr>
            <a:r>
              <a:rPr lang="en-US" sz="1600"/>
              <a:t>exosomal Alix</a:t>
            </a:r>
            <a:endParaRPr lang="ja-JP" sz="1600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[exosome band intensity.xlsx]ALIX'!$C$57</c:f>
              <c:strCache>
                <c:ptCount val="1"/>
                <c:pt idx="0">
                  <c:v>DMSO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exosome band intensity.xlsx]ALIX'!$C$63:$C$66</c:f>
                <c:numCache>
                  <c:formatCode>General</c:formatCode>
                  <c:ptCount val="4"/>
                  <c:pt idx="0">
                    <c:v>0.40007481452011001</c:v>
                  </c:pt>
                  <c:pt idx="1">
                    <c:v>0.36818602838169423</c:v>
                  </c:pt>
                  <c:pt idx="2">
                    <c:v>2.5981183827620433</c:v>
                  </c:pt>
                  <c:pt idx="3">
                    <c:v>6.2783720127549545</c:v>
                  </c:pt>
                </c:numCache>
              </c:numRef>
            </c:plus>
            <c:minus>
              <c:numRef>
                <c:f>'[exosome band intensity.xlsx]ALIX'!$C$63:$C$66</c:f>
                <c:numCache>
                  <c:formatCode>General</c:formatCode>
                  <c:ptCount val="4"/>
                  <c:pt idx="0">
                    <c:v>0.40007481452011001</c:v>
                  </c:pt>
                  <c:pt idx="1">
                    <c:v>0.36818602838169423</c:v>
                  </c:pt>
                  <c:pt idx="2">
                    <c:v>2.5981183827620433</c:v>
                  </c:pt>
                  <c:pt idx="3">
                    <c:v>6.2783720127549545</c:v>
                  </c:pt>
                </c:numCache>
              </c:numRef>
            </c:minus>
          </c:errBars>
          <c:xVal>
            <c:numRef>
              <c:f>'[exosome band intensity.xlsx]ALIX'!$B$58:$B$61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exosome band intensity.xlsx]ALIX'!$C$58:$C$61</c:f>
              <c:numCache>
                <c:formatCode>#,##0.00_ </c:formatCode>
                <c:ptCount val="4"/>
                <c:pt idx="0">
                  <c:v>1</c:v>
                </c:pt>
                <c:pt idx="1">
                  <c:v>3.1999457038143069</c:v>
                </c:pt>
                <c:pt idx="2">
                  <c:v>16.250830672623508</c:v>
                </c:pt>
                <c:pt idx="3">
                  <c:v>44.3371616078753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1CE-4DBB-BB17-670ACFECB738}"/>
            </c:ext>
          </c:extLst>
        </c:ser>
        <c:ser>
          <c:idx val="1"/>
          <c:order val="1"/>
          <c:tx>
            <c:strRef>
              <c:f>'[exosome band intensity.xlsx]ALIX'!$D$57</c:f>
              <c:strCache>
                <c:ptCount val="1"/>
                <c:pt idx="0">
                  <c:v>TM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exosome band intensity.xlsx]ALIX'!$D$63:$D$66</c:f>
                <c:numCache>
                  <c:formatCode>General</c:formatCode>
                  <c:ptCount val="4"/>
                  <c:pt idx="0">
                    <c:v>0.56063943468509336</c:v>
                  </c:pt>
                  <c:pt idx="1">
                    <c:v>0.85368243808260436</c:v>
                  </c:pt>
                  <c:pt idx="2">
                    <c:v>0.47388688698363218</c:v>
                  </c:pt>
                  <c:pt idx="3">
                    <c:v>3.4694435840894262</c:v>
                  </c:pt>
                </c:numCache>
              </c:numRef>
            </c:plus>
            <c:minus>
              <c:numRef>
                <c:f>'[exosome band intensity.xlsx]ALIX'!$D$63:$D$66</c:f>
                <c:numCache>
                  <c:formatCode>General</c:formatCode>
                  <c:ptCount val="4"/>
                  <c:pt idx="0">
                    <c:v>0.56063943468509336</c:v>
                  </c:pt>
                  <c:pt idx="1">
                    <c:v>0.85368243808260436</c:v>
                  </c:pt>
                  <c:pt idx="2">
                    <c:v>0.47388688698363218</c:v>
                  </c:pt>
                  <c:pt idx="3">
                    <c:v>3.4694435840894262</c:v>
                  </c:pt>
                </c:numCache>
              </c:numRef>
            </c:minus>
          </c:errBars>
          <c:xVal>
            <c:numRef>
              <c:f>'[exosome band intensity.xlsx]ALIX'!$B$58:$B$61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exosome band intensity.xlsx]ALIX'!$D$58:$D$61</c:f>
              <c:numCache>
                <c:formatCode>#,##0_ </c:formatCode>
                <c:ptCount val="4"/>
                <c:pt idx="0">
                  <c:v>1.4962199231590936</c:v>
                </c:pt>
                <c:pt idx="1">
                  <c:v>2.1060192043248094</c:v>
                </c:pt>
                <c:pt idx="2">
                  <c:v>7.2229861721779267</c:v>
                </c:pt>
                <c:pt idx="3">
                  <c:v>25.0174278952555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1CE-4DBB-BB17-670ACFECB7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4911960"/>
        <c:axId val="1"/>
      </c:scatterChart>
      <c:valAx>
        <c:axId val="524911960"/>
        <c:scaling>
          <c:orientation val="minMax"/>
          <c:max val="25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hour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ja-JP"/>
          </a:p>
        </c:txPr>
        <c:crossAx val="1"/>
        <c:crosses val="autoZero"/>
        <c:crossBetween val="midCat"/>
      </c:val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band intensity</a:t>
                </a:r>
                <a:endParaRPr lang="ja-JP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#,##0_ 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24911960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5677777777777777"/>
          <c:y val="0.6257863079615047"/>
          <c:w val="0.22744488188976378"/>
          <c:h val="0.15625121859767532"/>
        </c:manualLayout>
      </c:layout>
      <c:overlay val="1"/>
      <c:spPr>
        <a:noFill/>
        <a:ln w="25400">
          <a:noFill/>
        </a:ln>
      </c:spPr>
      <c:txPr>
        <a:bodyPr rot="0" vert="horz"/>
        <a:lstStyle/>
        <a:p>
          <a:pPr>
            <a:defRPr/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sz="1600"/>
            </a:pPr>
            <a:r>
              <a:rPr lang="en-US" sz="1600"/>
              <a:t>exosomal Tsg101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[exosome band intensity.xlsx]TSG101'!$C$57</c:f>
              <c:strCache>
                <c:ptCount val="1"/>
                <c:pt idx="0">
                  <c:v>DMSO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exosome band intensity.xlsx]TSG101'!$C$63:$C$66</c:f>
                <c:numCache>
                  <c:formatCode>General</c:formatCode>
                  <c:ptCount val="4"/>
                  <c:pt idx="0">
                    <c:v>7.2954581792852552E-2</c:v>
                  </c:pt>
                  <c:pt idx="1">
                    <c:v>0.22961506920965347</c:v>
                  </c:pt>
                  <c:pt idx="2">
                    <c:v>1.352289014025106</c:v>
                  </c:pt>
                  <c:pt idx="3">
                    <c:v>1.8824371514645211</c:v>
                  </c:pt>
                </c:numCache>
              </c:numRef>
            </c:plus>
            <c:minus>
              <c:numRef>
                <c:f>'[exosome band intensity.xlsx]TSG101'!$C$63:$C$66</c:f>
                <c:numCache>
                  <c:formatCode>General</c:formatCode>
                  <c:ptCount val="4"/>
                  <c:pt idx="0">
                    <c:v>7.2954581792852552E-2</c:v>
                  </c:pt>
                  <c:pt idx="1">
                    <c:v>0.22961506920965347</c:v>
                  </c:pt>
                  <c:pt idx="2">
                    <c:v>1.352289014025106</c:v>
                  </c:pt>
                  <c:pt idx="3">
                    <c:v>1.8824371514645211</c:v>
                  </c:pt>
                </c:numCache>
              </c:numRef>
            </c:minus>
          </c:errBars>
          <c:xVal>
            <c:numRef>
              <c:f>'[exosome band intensity.xlsx]TSG101'!$B$58:$B$61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exosome band intensity.xlsx]TSG101'!$C$58:$C$61</c:f>
              <c:numCache>
                <c:formatCode>#,##0.00_ </c:formatCode>
                <c:ptCount val="4"/>
                <c:pt idx="0">
                  <c:v>1</c:v>
                </c:pt>
                <c:pt idx="1">
                  <c:v>1.656335972152041</c:v>
                </c:pt>
                <c:pt idx="2">
                  <c:v>5.4767996057367787</c:v>
                </c:pt>
                <c:pt idx="3">
                  <c:v>13.0144324044441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90A-43F6-94F6-453753274E78}"/>
            </c:ext>
          </c:extLst>
        </c:ser>
        <c:ser>
          <c:idx val="1"/>
          <c:order val="1"/>
          <c:tx>
            <c:strRef>
              <c:f>'[exosome band intensity.xlsx]TSG101'!$D$57</c:f>
              <c:strCache>
                <c:ptCount val="1"/>
                <c:pt idx="0">
                  <c:v>TM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exosome band intensity.xlsx]TSG101'!$D$63:$D$66</c:f>
                <c:numCache>
                  <c:formatCode>General</c:formatCode>
                  <c:ptCount val="4"/>
                  <c:pt idx="0">
                    <c:v>0.37031849542732354</c:v>
                  </c:pt>
                  <c:pt idx="1">
                    <c:v>0.20412994708640592</c:v>
                  </c:pt>
                  <c:pt idx="2">
                    <c:v>9.1785957135902652E-2</c:v>
                  </c:pt>
                  <c:pt idx="3">
                    <c:v>1.035324954741502</c:v>
                  </c:pt>
                </c:numCache>
              </c:numRef>
            </c:plus>
            <c:minus>
              <c:numRef>
                <c:f>'[exosome band intensity.xlsx]TSG101'!$D$63:$D$66</c:f>
                <c:numCache>
                  <c:formatCode>General</c:formatCode>
                  <c:ptCount val="4"/>
                  <c:pt idx="0">
                    <c:v>0.37031849542732354</c:v>
                  </c:pt>
                  <c:pt idx="1">
                    <c:v>0.20412994708640592</c:v>
                  </c:pt>
                  <c:pt idx="2">
                    <c:v>9.1785957135902652E-2</c:v>
                  </c:pt>
                  <c:pt idx="3">
                    <c:v>1.035324954741502</c:v>
                  </c:pt>
                </c:numCache>
              </c:numRef>
            </c:minus>
          </c:errBars>
          <c:xVal>
            <c:numRef>
              <c:f>'[exosome band intensity.xlsx]TSG101'!$B$58:$B$61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exosome band intensity.xlsx]TSG101'!$D$58:$D$61</c:f>
              <c:numCache>
                <c:formatCode>#,##0.00_ </c:formatCode>
                <c:ptCount val="4"/>
                <c:pt idx="0">
                  <c:v>1.6262047798177157</c:v>
                </c:pt>
                <c:pt idx="1">
                  <c:v>1.5880947479397876</c:v>
                </c:pt>
                <c:pt idx="2">
                  <c:v>2.7053911752412678</c:v>
                </c:pt>
                <c:pt idx="3">
                  <c:v>6.46241086968727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90A-43F6-94F6-453753274E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4911960"/>
        <c:axId val="1"/>
      </c:scatterChart>
      <c:valAx>
        <c:axId val="524911960"/>
        <c:scaling>
          <c:orientation val="minMax"/>
          <c:max val="25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hour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ja-JP"/>
          </a:p>
        </c:txPr>
        <c:crossAx val="1"/>
        <c:crosses val="autoZero"/>
        <c:crossBetween val="midCat"/>
      </c:val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band intensity</a:t>
                </a:r>
                <a:endParaRPr lang="ja-JP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#,##0_ 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24911960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3733333333333329"/>
          <c:y val="0.6257863079615047"/>
          <c:w val="0.24688932633420824"/>
          <c:h val="0.15625121859767532"/>
        </c:manualLayout>
      </c:layout>
      <c:overlay val="1"/>
      <c:spPr>
        <a:noFill/>
        <a:ln w="25400">
          <a:noFill/>
        </a:ln>
      </c:spPr>
      <c:txPr>
        <a:bodyPr rot="0" vert="horz"/>
        <a:lstStyle/>
        <a:p>
          <a:pPr>
            <a:defRPr/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sz="1600"/>
            </a:pPr>
            <a:r>
              <a:rPr lang="en-US" sz="1600"/>
              <a:t>exosomal Syntenin</a:t>
            </a:r>
            <a:endParaRPr lang="ja-JP" sz="1600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[exosome band intensity.xlsx]syntenin'!$H$79</c:f>
              <c:strCache>
                <c:ptCount val="1"/>
                <c:pt idx="0">
                  <c:v>DMSO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exosome band intensity.xlsx]syntenin'!$H$85:$H$8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713236835726936E-2</c:v>
                  </c:pt>
                  <c:pt idx="2">
                    <c:v>4.694513809008314E-2</c:v>
                  </c:pt>
                  <c:pt idx="3">
                    <c:v>0.13131903806103531</c:v>
                  </c:pt>
                </c:numCache>
              </c:numRef>
            </c:plus>
            <c:minus>
              <c:numRef>
                <c:f>'[exosome band intensity.xlsx]syntenin'!$H$85:$H$8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713236835726936E-2</c:v>
                  </c:pt>
                  <c:pt idx="2">
                    <c:v>4.694513809008314E-2</c:v>
                  </c:pt>
                  <c:pt idx="3">
                    <c:v>0.13131903806103531</c:v>
                  </c:pt>
                </c:numCache>
              </c:numRef>
            </c:minus>
          </c:errBars>
          <c:xVal>
            <c:numRef>
              <c:f>'[exosome band intensity.xlsx]syntenin'!$G$80:$G$83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exosome band intensity.xlsx]syntenin'!$H$80:$H$83</c:f>
              <c:numCache>
                <c:formatCode>0.000</c:formatCode>
                <c:ptCount val="4"/>
                <c:pt idx="0">
                  <c:v>0</c:v>
                </c:pt>
                <c:pt idx="1">
                  <c:v>1.4345726741951611E-2</c:v>
                </c:pt>
                <c:pt idx="2">
                  <c:v>0.23141703357330751</c:v>
                </c:pt>
                <c:pt idx="3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821-40A1-BAE0-F6025AA56695}"/>
            </c:ext>
          </c:extLst>
        </c:ser>
        <c:ser>
          <c:idx val="1"/>
          <c:order val="1"/>
          <c:tx>
            <c:strRef>
              <c:f>'[exosome band intensity.xlsx]syntenin'!$I$79</c:f>
              <c:strCache>
                <c:ptCount val="1"/>
                <c:pt idx="0">
                  <c:v>TM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exosome band intensity.xlsx]syntenin'!$I$85:$I$88</c:f>
                <c:numCache>
                  <c:formatCode>General</c:formatCode>
                  <c:ptCount val="4"/>
                  <c:pt idx="0">
                    <c:v>9.8366133732118236E-3</c:v>
                  </c:pt>
                  <c:pt idx="1">
                    <c:v>0</c:v>
                  </c:pt>
                  <c:pt idx="2">
                    <c:v>2.5234574615054996E-2</c:v>
                  </c:pt>
                  <c:pt idx="3">
                    <c:v>0.15600821821142549</c:v>
                  </c:pt>
                </c:numCache>
              </c:numRef>
            </c:plus>
            <c:minus>
              <c:numRef>
                <c:f>'[exosome band intensity.xlsx]syntenin'!$I$85:$I$88</c:f>
                <c:numCache>
                  <c:formatCode>General</c:formatCode>
                  <c:ptCount val="4"/>
                  <c:pt idx="0">
                    <c:v>9.8366133732118236E-3</c:v>
                  </c:pt>
                  <c:pt idx="1">
                    <c:v>0</c:v>
                  </c:pt>
                  <c:pt idx="2">
                    <c:v>2.5234574615054996E-2</c:v>
                  </c:pt>
                  <c:pt idx="3">
                    <c:v>0.15600821821142549</c:v>
                  </c:pt>
                </c:numCache>
              </c:numRef>
            </c:minus>
          </c:errBars>
          <c:xVal>
            <c:numRef>
              <c:f>'[exosome band intensity.xlsx]syntenin'!$G$80:$G$83</c:f>
              <c:numCache>
                <c:formatCode>General</c:formatCode>
                <c:ptCount val="4"/>
                <c:pt idx="0">
                  <c:v>2</c:v>
                </c:pt>
                <c:pt idx="1">
                  <c:v>4</c:v>
                </c:pt>
                <c:pt idx="2">
                  <c:v>10</c:v>
                </c:pt>
                <c:pt idx="3">
                  <c:v>24</c:v>
                </c:pt>
              </c:numCache>
            </c:numRef>
          </c:xVal>
          <c:yVal>
            <c:numRef>
              <c:f>'[exosome band intensity.xlsx]syntenin'!$I$80:$I$83</c:f>
              <c:numCache>
                <c:formatCode>0.000</c:formatCode>
                <c:ptCount val="4"/>
                <c:pt idx="0">
                  <c:v>1.5009874875889104E-2</c:v>
                </c:pt>
                <c:pt idx="1">
                  <c:v>0</c:v>
                </c:pt>
                <c:pt idx="2">
                  <c:v>3.0905915841536985E-2</c:v>
                </c:pt>
                <c:pt idx="3">
                  <c:v>0.511967688923305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821-40A1-BAE0-F6025AA566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4911960"/>
        <c:axId val="1"/>
      </c:scatterChart>
      <c:valAx>
        <c:axId val="524911960"/>
        <c:scaling>
          <c:orientation val="minMax"/>
          <c:max val="25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hour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ja-JP"/>
          </a:p>
        </c:txPr>
        <c:crossAx val="1"/>
        <c:crosses val="autoZero"/>
        <c:crossBetween val="midCat"/>
      </c:valAx>
      <c:valAx>
        <c:axId val="1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band intensity</a:t>
                </a:r>
                <a:endParaRPr lang="ja-JP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#,##0.0_ 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24911960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77874475152397793"/>
          <c:y val="0.6257863079615047"/>
          <c:w val="0.20547812465736179"/>
          <c:h val="0.15625121859767532"/>
        </c:manualLayout>
      </c:layout>
      <c:overlay val="1"/>
      <c:spPr>
        <a:noFill/>
        <a:ln w="25400">
          <a:noFill/>
        </a:ln>
      </c:spPr>
      <c:txPr>
        <a:bodyPr rot="0" vert="horz"/>
        <a:lstStyle/>
        <a:p>
          <a:pPr>
            <a:defRPr/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ALIX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3AB-45CB-A326-A5271F0CB860}"/>
              </c:ext>
            </c:extLst>
          </c:dPt>
          <c:errBars>
            <c:errBarType val="plus"/>
            <c:errValType val="cust"/>
            <c:noEndCap val="0"/>
            <c:plus>
              <c:numRef>
                <c:f>[WBバンド定量_2800.xlsx]ALIX!$M$30:$M$33</c:f>
                <c:numCache>
                  <c:formatCode>General</c:formatCode>
                  <c:ptCount val="4"/>
                  <c:pt idx="0">
                    <c:v>0.12348203948885764</c:v>
                  </c:pt>
                  <c:pt idx="1">
                    <c:v>0.15021300847976743</c:v>
                  </c:pt>
                  <c:pt idx="2">
                    <c:v>6.0289181506470425E-2</c:v>
                  </c:pt>
                  <c:pt idx="3">
                    <c:v>5.82539679213202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WBバンド定量_2800.xlsx]ALIX!$H$30:$H$33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[WBバンド定量_2800.xlsx]ALIX!$I$30:$I$33</c:f>
              <c:numCache>
                <c:formatCode>General</c:formatCode>
                <c:ptCount val="4"/>
                <c:pt idx="0">
                  <c:v>1</c:v>
                </c:pt>
                <c:pt idx="1">
                  <c:v>0.76234897836060111</c:v>
                </c:pt>
                <c:pt idx="2">
                  <c:v>0.49207817529482745</c:v>
                </c:pt>
                <c:pt idx="3">
                  <c:v>0.395365185778654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3AB-45CB-A326-A5271F0CB8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796005552"/>
        <c:axId val="796002272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[WBバンド定量_2800.xlsx]ALIX!$J$30:$J$33</c:f>
              <c:numCache>
                <c:formatCode>General</c:formatCode>
                <c:ptCount val="4"/>
                <c:pt idx="0">
                  <c:v>1.1939712600454822</c:v>
                </c:pt>
                <c:pt idx="1">
                  <c:v>0.83365507144817863</c:v>
                </c:pt>
                <c:pt idx="2">
                  <c:v>0.35209233921091215</c:v>
                </c:pt>
                <c:pt idx="3">
                  <c:v>0.431989769843802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3AB-45CB-A326-A5271F0CB860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[WBバンド定量_2800.xlsx]ALIX!$K$30:$K$33</c:f>
              <c:numCache>
                <c:formatCode>General</c:formatCode>
                <c:ptCount val="4"/>
                <c:pt idx="0">
                  <c:v>0.70202549951237148</c:v>
                </c:pt>
                <c:pt idx="1">
                  <c:v>0.41408699649844782</c:v>
                </c:pt>
                <c:pt idx="2">
                  <c:v>0.6028081600224956</c:v>
                </c:pt>
                <c:pt idx="3">
                  <c:v>0.257617382338697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3AB-45CB-A326-A5271F0CB860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[WBバンド定量_2800.xlsx]ALIX!$L$30:$L$33</c:f>
              <c:numCache>
                <c:formatCode>General</c:formatCode>
                <c:ptCount val="4"/>
                <c:pt idx="0">
                  <c:v>1.1040032404421463</c:v>
                </c:pt>
                <c:pt idx="1">
                  <c:v>1.0393048671351768</c:v>
                </c:pt>
                <c:pt idx="2">
                  <c:v>0.52133402665107442</c:v>
                </c:pt>
                <c:pt idx="3">
                  <c:v>0.496488405153463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3AB-45CB-A326-A5271F0CB8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6005552"/>
        <c:axId val="796002272"/>
      </c:scatterChart>
      <c:catAx>
        <c:axId val="7960055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unicamycin </a:t>
                </a:r>
                <a:r>
                  <a:rPr lang="en-US" dirty="0"/>
                  <a:t>(</a:t>
                </a:r>
                <a:r>
                  <a:rPr lang="en-US" dirty="0" err="1"/>
                  <a:t>μmol</a:t>
                </a:r>
                <a:r>
                  <a:rPr lang="en-US" dirty="0"/>
                  <a:t>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96002272"/>
        <c:crosses val="autoZero"/>
        <c:auto val="1"/>
        <c:lblAlgn val="ctr"/>
        <c:lblOffset val="100"/>
        <c:noMultiLvlLbl val="0"/>
      </c:catAx>
      <c:valAx>
        <c:axId val="7960022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altLang="ja-JP" b="0"/>
                  <a:t>relative band intensity</a:t>
                </a:r>
                <a:endParaRPr lang="en-US" altLang="ja-JP" b="0" dirty="0"/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960055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  <c:userShapes r:id="rId2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ALIX</a:t>
            </a:r>
            <a:endParaRPr lang="ja-JP" altLang="en-US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3F7-454C-AE43-7BD28E72A8BA}"/>
              </c:ext>
            </c:extLst>
          </c:dPt>
          <c:errBars>
            <c:errBarType val="plus"/>
            <c:errValType val="cust"/>
            <c:noEndCap val="0"/>
            <c:plus>
              <c:numRef>
                <c:f>[WBバンド定量_2800.xlsx]ALIX!$M$38:$M$41</c:f>
                <c:numCache>
                  <c:formatCode>General</c:formatCode>
                  <c:ptCount val="4"/>
                  <c:pt idx="0">
                    <c:v>0.17522464806904775</c:v>
                  </c:pt>
                  <c:pt idx="1">
                    <c:v>7.4966722606138306E-2</c:v>
                  </c:pt>
                  <c:pt idx="2">
                    <c:v>0.12616380375196495</c:v>
                  </c:pt>
                  <c:pt idx="3">
                    <c:v>3.948004079514584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WBバンド定量_2800.xlsx]ALIX!$H$38:$H$41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[WBバンド定量_2800.xlsx]ALIX!$I$38:$I$41</c:f>
              <c:numCache>
                <c:formatCode>General</c:formatCode>
                <c:ptCount val="4"/>
                <c:pt idx="0">
                  <c:v>1</c:v>
                </c:pt>
                <c:pt idx="1">
                  <c:v>1.120481202537335</c:v>
                </c:pt>
                <c:pt idx="2">
                  <c:v>0.56134667922566728</c:v>
                </c:pt>
                <c:pt idx="3">
                  <c:v>0.257296792373924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3F7-454C-AE43-7BD28E72A8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796005552"/>
        <c:axId val="796002272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[WBバンド定量_2800.xlsx]ALIX!$J$38:$J$41</c:f>
              <c:numCache>
                <c:formatCode>General</c:formatCode>
                <c:ptCount val="4"/>
                <c:pt idx="0">
                  <c:v>0.81854263481057921</c:v>
                </c:pt>
                <c:pt idx="1">
                  <c:v>1.0668520552335465</c:v>
                </c:pt>
                <c:pt idx="2">
                  <c:v>0.3849186465983217</c:v>
                </c:pt>
                <c:pt idx="3">
                  <c:v>0.174004432128633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3F7-454C-AE43-7BD28E72A8BA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[WBバンド定量_2800.xlsx]ALIX!$K$38:$K$41</c:f>
              <c:numCache>
                <c:formatCode>General</c:formatCode>
                <c:ptCount val="4"/>
                <c:pt idx="0">
                  <c:v>0.75387342247097033</c:v>
                </c:pt>
                <c:pt idx="1">
                  <c:v>0.99520048151520946</c:v>
                </c:pt>
                <c:pt idx="2">
                  <c:v>0.42982736585384917</c:v>
                </c:pt>
                <c:pt idx="3">
                  <c:v>0.341496683720330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3F7-454C-AE43-7BD28E72A8BA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[WBバンド定量_2800.xlsx]ALIX!$L$38:$L$41</c:f>
              <c:numCache>
                <c:formatCode>General</c:formatCode>
                <c:ptCount val="4"/>
                <c:pt idx="0">
                  <c:v>1.4275839427184502</c:v>
                </c:pt>
                <c:pt idx="1">
                  <c:v>1.2993910708632488</c:v>
                </c:pt>
                <c:pt idx="2">
                  <c:v>0.86929402522483079</c:v>
                </c:pt>
                <c:pt idx="3">
                  <c:v>0.256389261272810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3F7-454C-AE43-7BD28E72A8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6005552"/>
        <c:axId val="796002272"/>
      </c:scatterChart>
      <c:catAx>
        <c:axId val="7960055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MG132 (μmol/L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96002272"/>
        <c:crosses val="autoZero"/>
        <c:auto val="1"/>
        <c:lblAlgn val="ctr"/>
        <c:lblOffset val="100"/>
        <c:noMultiLvlLbl val="0"/>
      </c:catAx>
      <c:valAx>
        <c:axId val="7960022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altLang="ja-JP" b="0"/>
                  <a:t>relative band intensity</a:t>
                </a:r>
                <a:endParaRPr lang="en-US" altLang="ja-JP" b="0" dirty="0"/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960055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  <c:userShapes r:id="rId2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altLang="ja-JP" sz="1600" dirty="0" err="1"/>
              <a:t>exsomal</a:t>
            </a:r>
            <a:r>
              <a:rPr lang="en-US" altLang="ja-JP" sz="1600" dirty="0"/>
              <a:t> Tsg101</a:t>
            </a:r>
            <a:endParaRPr lang="ja-JP" altLang="en-US" sz="1600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smGrid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089-476A-A7E2-C15B4E3115E6}"/>
              </c:ext>
            </c:extLst>
          </c:dPt>
          <c:errBars>
            <c:errBarType val="plus"/>
            <c:errValType val="cust"/>
            <c:noEndCap val="0"/>
            <c:plus>
              <c:numRef>
                <c:f>'[WBバンド定量_2800.xlsx]TSG101'!$M$30:$M$33</c:f>
                <c:numCache>
                  <c:formatCode>General</c:formatCode>
                  <c:ptCount val="4"/>
                  <c:pt idx="0">
                    <c:v>1.8976006708391526E-2</c:v>
                  </c:pt>
                  <c:pt idx="1">
                    <c:v>9.5380761984299525E-2</c:v>
                  </c:pt>
                  <c:pt idx="2">
                    <c:v>0.14723203940899424</c:v>
                  </c:pt>
                  <c:pt idx="3">
                    <c:v>7.099932498723711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WBバンド定量_2800.xlsx]TSG101'!$H$30:$H$33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'[WBバンド定量_2800.xlsx]TSG101'!$I$30:$I$33</c:f>
              <c:numCache>
                <c:formatCode>General</c:formatCode>
                <c:ptCount val="4"/>
                <c:pt idx="0">
                  <c:v>1</c:v>
                </c:pt>
                <c:pt idx="1">
                  <c:v>0.79988802924730018</c:v>
                </c:pt>
                <c:pt idx="2">
                  <c:v>0.62787397219617813</c:v>
                </c:pt>
                <c:pt idx="3">
                  <c:v>0.40020404308850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089-476A-A7E2-C15B4E3115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96005552"/>
        <c:axId val="796002272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yVal>
            <c:numRef>
              <c:f>'[WBバンド定量_2800.xlsx]TSG101'!$J$30:$J$33</c:f>
              <c:numCache>
                <c:formatCode>General</c:formatCode>
                <c:ptCount val="4"/>
                <c:pt idx="0">
                  <c:v>1.0446385570612398</c:v>
                </c:pt>
                <c:pt idx="1">
                  <c:v>0.65951717671817767</c:v>
                </c:pt>
                <c:pt idx="2">
                  <c:v>0.27517385820185764</c:v>
                </c:pt>
                <c:pt idx="3">
                  <c:v>0.262187611717806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089-476A-A7E2-C15B4E3115E6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yVal>
            <c:numRef>
              <c:f>'[WBバンド定量_2800.xlsx]TSG101'!$K$30:$K$33</c:f>
              <c:numCache>
                <c:formatCode>General</c:formatCode>
                <c:ptCount val="4"/>
                <c:pt idx="0">
                  <c:v>0.98890342859840941</c:v>
                </c:pt>
                <c:pt idx="1">
                  <c:v>0.708330691453124</c:v>
                </c:pt>
                <c:pt idx="2">
                  <c:v>0.869413772402582</c:v>
                </c:pt>
                <c:pt idx="3">
                  <c:v>0.377573472374926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089-476A-A7E2-C15B4E3115E6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yVal>
            <c:numRef>
              <c:f>'[WBバンド定量_2800.xlsx]TSG101'!$L$30:$L$33</c:f>
              <c:numCache>
                <c:formatCode>General</c:formatCode>
                <c:ptCount val="4"/>
                <c:pt idx="0">
                  <c:v>0.96645801434035061</c:v>
                </c:pt>
                <c:pt idx="1">
                  <c:v>1.0318162195705989</c:v>
                </c:pt>
                <c:pt idx="2">
                  <c:v>0.73903428598409471</c:v>
                </c:pt>
                <c:pt idx="3">
                  <c:v>0.560851045172778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089-476A-A7E2-C15B4E3115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6005552"/>
        <c:axId val="796002272"/>
      </c:scatterChart>
      <c:catAx>
        <c:axId val="796005552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Tunicamycin </a:t>
                </a:r>
                <a:r>
                  <a:rPr lang="en-US" dirty="0"/>
                  <a:t>(</a:t>
                </a:r>
                <a:r>
                  <a:rPr lang="en-US" dirty="0" err="1"/>
                  <a:t>μmol</a:t>
                </a:r>
                <a:r>
                  <a:rPr lang="en-US" dirty="0"/>
                  <a:t>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96002272"/>
        <c:crosses val="autoZero"/>
        <c:auto val="1"/>
        <c:lblAlgn val="ctr"/>
        <c:lblOffset val="100"/>
        <c:noMultiLvlLbl val="0"/>
      </c:catAx>
      <c:valAx>
        <c:axId val="7960022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relative band intensity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960055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sz="1200"/>
            </a:pPr>
            <a:r>
              <a:rPr lang="en-US" altLang="ja-JP" sz="1200" dirty="0" err="1"/>
              <a:t>BiP</a:t>
            </a:r>
            <a:r>
              <a:rPr lang="en-US" altLang="ja-JP" sz="1200" dirty="0"/>
              <a:t>/tubulin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030-4FC8-9E95-C59B3E6DBE84}"/>
              </c:ext>
            </c:extLst>
          </c:dPt>
          <c:dPt>
            <c:idx val="1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030-4FC8-9E95-C59B3E6DBE84}"/>
              </c:ext>
            </c:extLst>
          </c:dPt>
          <c:dPt>
            <c:idx val="2"/>
            <c:invertIfNegative val="0"/>
            <c:bubble3D val="0"/>
            <c:spPr>
              <a:pattFill prst="smGrid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030-4FC8-9E95-C59B3E6DBE84}"/>
              </c:ext>
            </c:extLst>
          </c:dPt>
          <c:errBars>
            <c:errBarType val="plus"/>
            <c:errValType val="cust"/>
            <c:noEndCap val="0"/>
            <c:plus>
              <c:numRef>
                <c:f>'[WB band intensity.xlsx]Bip'!$L$22:$L$25</c:f>
                <c:numCache>
                  <c:formatCode>General</c:formatCode>
                  <c:ptCount val="4"/>
                  <c:pt idx="0">
                    <c:v>0.20736923916465325</c:v>
                  </c:pt>
                  <c:pt idx="1">
                    <c:v>0.42817778195715095</c:v>
                  </c:pt>
                  <c:pt idx="2">
                    <c:v>0.94805894101712496</c:v>
                  </c:pt>
                  <c:pt idx="3">
                    <c:v>0.205981461591608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'[WB band intensity.xlsx]Bip'!$G$22:$G$25</c:f>
              <c:strCache>
                <c:ptCount val="4"/>
                <c:pt idx="0">
                  <c:v>DMSO</c:v>
                </c:pt>
                <c:pt idx="1">
                  <c:v>TG</c:v>
                </c:pt>
                <c:pt idx="2">
                  <c:v>TM</c:v>
                </c:pt>
                <c:pt idx="3">
                  <c:v>MG</c:v>
                </c:pt>
              </c:strCache>
            </c:strRef>
          </c:cat>
          <c:val>
            <c:numRef>
              <c:f>'[WB band intensity.xlsx]Bip'!$H$22:$H$25</c:f>
              <c:numCache>
                <c:formatCode>0.0000</c:formatCode>
                <c:ptCount val="4"/>
                <c:pt idx="0">
                  <c:v>1</c:v>
                </c:pt>
                <c:pt idx="1">
                  <c:v>2.6293329881257126</c:v>
                </c:pt>
                <c:pt idx="2">
                  <c:v>4.3379443969905953</c:v>
                </c:pt>
                <c:pt idx="3">
                  <c:v>1.36810327358572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030-4FC8-9E95-C59B3E6DBE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813443392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WB band intensity.xlsx]Bip'!$G$22:$G$25</c:f>
              <c:strCache>
                <c:ptCount val="4"/>
                <c:pt idx="0">
                  <c:v>DMSO</c:v>
                </c:pt>
                <c:pt idx="1">
                  <c:v>TG</c:v>
                </c:pt>
                <c:pt idx="2">
                  <c:v>TM</c:v>
                </c:pt>
                <c:pt idx="3">
                  <c:v>MG</c:v>
                </c:pt>
              </c:strCache>
            </c:strRef>
          </c:xVal>
          <c:yVal>
            <c:numRef>
              <c:f>'[WB band intensity.xlsx]Bip'!$I$22:$I$25</c:f>
              <c:numCache>
                <c:formatCode>0.0000</c:formatCode>
                <c:ptCount val="4"/>
                <c:pt idx="0">
                  <c:v>0.4974608909153091</c:v>
                </c:pt>
                <c:pt idx="1">
                  <c:v>1.6802670945824143</c:v>
                </c:pt>
                <c:pt idx="2">
                  <c:v>2.4562597622185232</c:v>
                </c:pt>
                <c:pt idx="3">
                  <c:v>1.18748361194627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0030-4FC8-9E95-C59B3E6DBE84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WB band intensity.xlsx]Bip'!$G$22:$G$25</c:f>
              <c:strCache>
                <c:ptCount val="4"/>
                <c:pt idx="0">
                  <c:v>DMSO</c:v>
                </c:pt>
                <c:pt idx="1">
                  <c:v>TG</c:v>
                </c:pt>
                <c:pt idx="2">
                  <c:v>TM</c:v>
                </c:pt>
                <c:pt idx="3">
                  <c:v>MG</c:v>
                </c:pt>
              </c:strCache>
            </c:strRef>
          </c:xVal>
          <c:yVal>
            <c:numRef>
              <c:f>'[WB band intensity.xlsx]Bip'!$J$22:$J$25</c:f>
              <c:numCache>
                <c:formatCode>0.0000</c:formatCode>
                <c:ptCount val="4"/>
                <c:pt idx="0">
                  <c:v>1.3152995394169817</c:v>
                </c:pt>
                <c:pt idx="1">
                  <c:v>3.490477374992583</c:v>
                </c:pt>
                <c:pt idx="2">
                  <c:v>6.4573952591608306</c:v>
                </c:pt>
                <c:pt idx="3">
                  <c:v>1.86640824495164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0030-4FC8-9E95-C59B3E6DBE84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WB band intensity.xlsx]Bip'!$G$22:$G$25</c:f>
              <c:strCache>
                <c:ptCount val="4"/>
                <c:pt idx="0">
                  <c:v>DMSO</c:v>
                </c:pt>
                <c:pt idx="1">
                  <c:v>TG</c:v>
                </c:pt>
                <c:pt idx="2">
                  <c:v>TM</c:v>
                </c:pt>
                <c:pt idx="3">
                  <c:v>MG</c:v>
                </c:pt>
              </c:strCache>
            </c:strRef>
          </c:xVal>
          <c:yVal>
            <c:numRef>
              <c:f>'[WB band intensity.xlsx]Bip'!$K$22:$K$25</c:f>
              <c:numCache>
                <c:formatCode>0.0000</c:formatCode>
                <c:ptCount val="4"/>
                <c:pt idx="0">
                  <c:v>1.1872395696677089</c:v>
                </c:pt>
                <c:pt idx="1">
                  <c:v>2.7172544948021393</c:v>
                </c:pt>
                <c:pt idx="2">
                  <c:v>4.1001781695924322</c:v>
                </c:pt>
                <c:pt idx="3">
                  <c:v>1.05041796385925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0030-4FC8-9E95-C59B3E6DBE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3443392"/>
        <c:axId val="1"/>
      </c:scatterChart>
      <c:catAx>
        <c:axId val="813443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0" dirty="0"/>
                  <a:t>Arbitrary units</a:t>
                </a:r>
                <a:endParaRPr lang="ja-JP" dirty="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81344339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altLang="ja-JP" sz="1600" dirty="0" err="1"/>
              <a:t>exosomal</a:t>
            </a:r>
            <a:r>
              <a:rPr lang="en-US" altLang="ja-JP" sz="1600" dirty="0"/>
              <a:t> Tsg101</a:t>
            </a:r>
            <a:endParaRPr lang="ja-JP" altLang="en-US" sz="1600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BFA-4DB4-A6B1-88F96CF43DA3}"/>
              </c:ext>
            </c:extLst>
          </c:dPt>
          <c:errBars>
            <c:errBarType val="plus"/>
            <c:errValType val="cust"/>
            <c:noEndCap val="0"/>
            <c:plus>
              <c:numRef>
                <c:f>'[WBバンド定量_2800.xlsx]TSG101'!$M$38:$M$41</c:f>
                <c:numCache>
                  <c:formatCode>General</c:formatCode>
                  <c:ptCount val="4"/>
                  <c:pt idx="0">
                    <c:v>0.14676963900200138</c:v>
                  </c:pt>
                  <c:pt idx="1">
                    <c:v>7.274644547630317E-2</c:v>
                  </c:pt>
                  <c:pt idx="2">
                    <c:v>4.7645349091514737E-2</c:v>
                  </c:pt>
                  <c:pt idx="3">
                    <c:v>7.400316579577953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WBバンド定量_2800.xlsx]TSG101'!$H$38:$H$41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'[WBバンド定量_2800.xlsx]TSG101'!$I$38:$I$41</c:f>
              <c:numCache>
                <c:formatCode>General</c:formatCode>
                <c:ptCount val="4"/>
                <c:pt idx="0">
                  <c:v>1</c:v>
                </c:pt>
                <c:pt idx="1">
                  <c:v>1.0307764419824601</c:v>
                </c:pt>
                <c:pt idx="2">
                  <c:v>0.51698548992425319</c:v>
                </c:pt>
                <c:pt idx="3">
                  <c:v>0.33832829871942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BFA-4DB4-A6B1-88F96CF43D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96005552"/>
        <c:axId val="796002272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_2800.xlsx]TSG101'!$H$38:$H$41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WBバンド定量_2800.xlsx]TSG101'!$J$38:$J$41</c:f>
              <c:numCache>
                <c:formatCode>General</c:formatCode>
                <c:ptCount val="4"/>
                <c:pt idx="0">
                  <c:v>0.6440151788639833</c:v>
                </c:pt>
                <c:pt idx="1">
                  <c:v>1.0078962538240517</c:v>
                </c:pt>
                <c:pt idx="2">
                  <c:v>0.54750095701480628</c:v>
                </c:pt>
                <c:pt idx="3">
                  <c:v>0.3251965166584697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BFA-4DB4-A6B1-88F96CF43DA3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_2800.xlsx]TSG101'!$H$38:$H$41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WBバンド定量_2800.xlsx]TSG101'!$K$38:$K$41</c:f>
              <c:numCache>
                <c:formatCode>General</c:formatCode>
                <c:ptCount val="4"/>
                <c:pt idx="0">
                  <c:v>1.1344944044290068</c:v>
                </c:pt>
                <c:pt idx="1">
                  <c:v>1.1952576309507243</c:v>
                </c:pt>
                <c:pt idx="2">
                  <c:v>0.59928267171602856</c:v>
                </c:pt>
                <c:pt idx="3">
                  <c:v>0.501466140271118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BFA-4DB4-A6B1-88F96CF43DA3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_2800.xlsx]TSG101'!$H$38:$H$41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WBバンド定量_2800.xlsx]TSG101'!$L$38:$L$41</c:f>
              <c:numCache>
                <c:formatCode>General</c:formatCode>
                <c:ptCount val="4"/>
                <c:pt idx="0">
                  <c:v>1.2214904167070098</c:v>
                </c:pt>
                <c:pt idx="1">
                  <c:v>0.88917544117260439</c:v>
                </c:pt>
                <c:pt idx="2">
                  <c:v>0.40417284104192458</c:v>
                </c:pt>
                <c:pt idx="3">
                  <c:v>0.188322239228694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BFA-4DB4-A6B1-88F96CF43D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6005552"/>
        <c:axId val="796002272"/>
      </c:scatterChart>
      <c:catAx>
        <c:axId val="796005552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MG132 (μmol/L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96002272"/>
        <c:crosses val="autoZero"/>
        <c:auto val="1"/>
        <c:lblAlgn val="ctr"/>
        <c:lblOffset val="100"/>
        <c:noMultiLvlLbl val="0"/>
      </c:catAx>
      <c:valAx>
        <c:axId val="7960022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relative band intensity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960055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altLang="ja-JP" sz="1600" dirty="0" err="1"/>
              <a:t>exosomal</a:t>
            </a:r>
            <a:r>
              <a:rPr lang="en-US" altLang="ja-JP" sz="1600" dirty="0"/>
              <a:t> Tsg101</a:t>
            </a:r>
            <a:endParaRPr lang="ja-JP" altLang="en-US" sz="1600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trellis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4ED-4862-A370-8855A969190F}"/>
              </c:ext>
            </c:extLst>
          </c:dPt>
          <c:errBars>
            <c:errBarType val="plus"/>
            <c:errValType val="cust"/>
            <c:noEndCap val="0"/>
            <c:plus>
              <c:numRef>
                <c:f>'[WBバンド定量.xlsx]TSG101'!$G$22:$G$25</c:f>
                <c:numCache>
                  <c:formatCode>General</c:formatCode>
                  <c:ptCount val="4"/>
                  <c:pt idx="0">
                    <c:v>0.18375799975348209</c:v>
                  </c:pt>
                  <c:pt idx="1">
                    <c:v>7.668608947837742E-2</c:v>
                  </c:pt>
                  <c:pt idx="2">
                    <c:v>7.4452393573664094E-2</c:v>
                  </c:pt>
                  <c:pt idx="3">
                    <c:v>8.835725969933917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[WBバンド定量.xlsx]TSG101'!$B$22:$B$25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numCache>
            </c:numRef>
          </c:cat>
          <c:val>
            <c:numRef>
              <c:f>'[WBバンド定量.xlsx]TSG101'!$C$22:$C$25</c:f>
              <c:numCache>
                <c:formatCode>#,##0.00_ </c:formatCode>
                <c:ptCount val="4"/>
                <c:pt idx="0">
                  <c:v>1</c:v>
                </c:pt>
                <c:pt idx="1">
                  <c:v>0.7294736169758661</c:v>
                </c:pt>
                <c:pt idx="2">
                  <c:v>0.33134353586503806</c:v>
                </c:pt>
                <c:pt idx="3">
                  <c:v>0.165933685880733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4ED-4862-A370-8855A96919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96005552"/>
        <c:axId val="796002272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yVal>
            <c:numRef>
              <c:f>'[WBバンド定量.xlsx]TSG101'!$D$22:$D$25</c:f>
              <c:numCache>
                <c:formatCode>#,##0.00_ </c:formatCode>
                <c:ptCount val="4"/>
                <c:pt idx="0">
                  <c:v>0.48967303292805181</c:v>
                </c:pt>
                <c:pt idx="1">
                  <c:v>0.49915290477714969</c:v>
                </c:pt>
                <c:pt idx="2">
                  <c:v>0.53690472573977699</c:v>
                </c:pt>
                <c:pt idx="3">
                  <c:v>0.12968268397155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4ED-4862-A370-8855A969190F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yVal>
            <c:numRef>
              <c:f>'[WBバンド定量.xlsx]TSG101'!$E$22:$E$25</c:f>
              <c:numCache>
                <c:formatCode>#,##0.00_ </c:formatCode>
                <c:ptCount val="4"/>
                <c:pt idx="0">
                  <c:v>1.2552572482140896</c:v>
                </c:pt>
                <c:pt idx="1">
                  <c:v>0.41530449860141655</c:v>
                </c:pt>
                <c:pt idx="2">
                  <c:v>0.22641979001385731</c:v>
                </c:pt>
                <c:pt idx="3">
                  <c:v>0.156075250097562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4ED-4862-A370-8855A969190F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yVal>
            <c:numRef>
              <c:f>'[WBバンド定量.xlsx]TSG101'!$F$22:$F$25</c:f>
              <c:numCache>
                <c:formatCode>#,##0.00_ </c:formatCode>
                <c:ptCount val="4"/>
                <c:pt idx="0">
                  <c:v>1.2550697188578586</c:v>
                </c:pt>
                <c:pt idx="1">
                  <c:v>1.2739634475490322</c:v>
                </c:pt>
                <c:pt idx="2">
                  <c:v>0.23070609184147986</c:v>
                </c:pt>
                <c:pt idx="3">
                  <c:v>0.212043123573082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4ED-4862-A370-8855A96919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6005552"/>
        <c:axId val="796002272"/>
      </c:scatterChart>
      <c:catAx>
        <c:axId val="796005552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Thapsigargin </a:t>
                </a:r>
                <a:r>
                  <a:rPr lang="en-US" dirty="0"/>
                  <a:t>(</a:t>
                </a:r>
                <a:r>
                  <a:rPr lang="en-US" dirty="0" err="1"/>
                  <a:t>μmol</a:t>
                </a:r>
                <a:r>
                  <a:rPr lang="en-US" dirty="0"/>
                  <a:t>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96002272"/>
        <c:crosses val="autoZero"/>
        <c:auto val="1"/>
        <c:lblAlgn val="ctr"/>
        <c:lblOffset val="100"/>
        <c:noMultiLvlLbl val="0"/>
      </c:catAx>
      <c:valAx>
        <c:axId val="7960022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relative band intensity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960055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ALIX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4765101010101009"/>
          <c:y val="0.16708333333333336"/>
          <c:w val="0.79141464646464643"/>
          <c:h val="0.622716170895304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761-4278-AD8E-6C0D16AF7F4E}"/>
              </c:ext>
            </c:extLst>
          </c:dPt>
          <c:errBars>
            <c:errBarType val="plus"/>
            <c:errValType val="cust"/>
            <c:noEndCap val="0"/>
            <c:plus>
              <c:numRef>
                <c:f>[WBバンド定量.xlsx]ALIX!$G$22:$G$25</c:f>
                <c:numCache>
                  <c:formatCode>General</c:formatCode>
                  <c:ptCount val="4"/>
                  <c:pt idx="0">
                    <c:v>0.25597373489681402</c:v>
                  </c:pt>
                  <c:pt idx="1">
                    <c:v>0.35181950076594731</c:v>
                  </c:pt>
                  <c:pt idx="2">
                    <c:v>7.0411521909733446E-2</c:v>
                  </c:pt>
                  <c:pt idx="3">
                    <c:v>6.038718966674640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[WBバンド定量.xlsx]ALIX!$B$22:$B$25</c:f>
              <c:numCache>
                <c:formatCode>General</c:formatCod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numCache>
            </c:numRef>
          </c:cat>
          <c:val>
            <c:numRef>
              <c:f>[WBバンド定量.xlsx]ALIX!$C$22:$C$25</c:f>
              <c:numCache>
                <c:formatCode>#,##0.00_ </c:formatCode>
                <c:ptCount val="4"/>
                <c:pt idx="0">
                  <c:v>1</c:v>
                </c:pt>
                <c:pt idx="1">
                  <c:v>0.89559978324106271</c:v>
                </c:pt>
                <c:pt idx="2">
                  <c:v>0.36525921445032034</c:v>
                </c:pt>
                <c:pt idx="3">
                  <c:v>0.213961114603797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761-4278-AD8E-6C0D16AF7F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796005552"/>
        <c:axId val="796002272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[WBバンド定量.xlsx]ALIX!$D$22:$D$25</c:f>
              <c:numCache>
                <c:formatCode>#,##0.00_ </c:formatCode>
                <c:ptCount val="4"/>
                <c:pt idx="0">
                  <c:v>0.45214462718340981</c:v>
                </c:pt>
                <c:pt idx="1">
                  <c:v>0.54968769872367418</c:v>
                </c:pt>
                <c:pt idx="2">
                  <c:v>0.53006161305636823</c:v>
                </c:pt>
                <c:pt idx="3">
                  <c:v>6.865100622949482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761-4278-AD8E-6C0D16AF7F4E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[WBバンド定量.xlsx]ALIX!$E$22:$E$25</c:f>
              <c:numCache>
                <c:formatCode>#,##0.00_ </c:formatCode>
                <c:ptCount val="4"/>
                <c:pt idx="0">
                  <c:v>1.0098399052377038</c:v>
                </c:pt>
                <c:pt idx="1">
                  <c:v>0.38499533265729619</c:v>
                </c:pt>
                <c:pt idx="2">
                  <c:v>0.23881090468960753</c:v>
                </c:pt>
                <c:pt idx="3">
                  <c:v>0.262668593871962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761-4278-AD8E-6C0D16AF7F4E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[WBバンド定量.xlsx]ALIX!$F$22:$F$25</c:f>
              <c:numCache>
                <c:formatCode>#,##0.00_ </c:formatCode>
                <c:ptCount val="4"/>
                <c:pt idx="0">
                  <c:v>1.5380154675788864</c:v>
                </c:pt>
                <c:pt idx="1">
                  <c:v>1.7521163183422179</c:v>
                </c:pt>
                <c:pt idx="2">
                  <c:v>0.32690512560498525</c:v>
                </c:pt>
                <c:pt idx="3">
                  <c:v>0.310563743709935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761-4278-AD8E-6C0D16AF7F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6005552"/>
        <c:axId val="796002272"/>
      </c:scatterChart>
      <c:catAx>
        <c:axId val="7960055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hapsigargin </a:t>
                </a:r>
                <a:r>
                  <a:rPr lang="en-US" dirty="0"/>
                  <a:t>(</a:t>
                </a:r>
                <a:r>
                  <a:rPr lang="en-US" dirty="0" err="1"/>
                  <a:t>μmol</a:t>
                </a:r>
                <a:r>
                  <a:rPr lang="en-US" dirty="0"/>
                  <a:t>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96002272"/>
        <c:crosses val="autoZero"/>
        <c:auto val="1"/>
        <c:lblAlgn val="ctr"/>
        <c:lblOffset val="100"/>
        <c:noMultiLvlLbl val="0"/>
      </c:catAx>
      <c:valAx>
        <c:axId val="7960022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altLang="ja-JP" b="0"/>
                  <a:t>relative band intensity</a:t>
                </a:r>
                <a:endParaRPr lang="en-US" altLang="ja-JP" b="0" dirty="0"/>
              </a:p>
            </c:rich>
          </c:tx>
          <c:overlay val="0"/>
        </c:title>
        <c:numFmt formatCode="#,##0.0_ 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960055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  <c:userShapes r:id="rId2"/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altLang="ja-JP" sz="1600" dirty="0" err="1"/>
              <a:t>exosomal</a:t>
            </a:r>
            <a:r>
              <a:rPr lang="en-US" altLang="ja-JP" sz="1600" dirty="0"/>
              <a:t> </a:t>
            </a:r>
            <a:r>
              <a:rPr lang="en-US" altLang="ja-JP" sz="1600" dirty="0" err="1"/>
              <a:t>Alix</a:t>
            </a:r>
            <a:endParaRPr lang="ja-JP" altLang="en-US" sz="160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3216447944006998"/>
          <c:y val="0.125"/>
          <c:w val="0.8372799650043744"/>
          <c:h val="0.767600612423447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WB定量.xlsx]Alix!$E$27</c:f>
              <c:strCache>
                <c:ptCount val="1"/>
                <c:pt idx="0">
                  <c:v>DMSO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WB定量.xlsx]Alix!$H$28:$H$29</c:f>
                <c:numCache>
                  <c:formatCode>General</c:formatCode>
                  <c:ptCount val="2"/>
                  <c:pt idx="0">
                    <c:v>8.2079853124991858E-2</c:v>
                  </c:pt>
                  <c:pt idx="1">
                    <c:v>7.2053119711498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WB定量.xlsx]Alix!$D$28:$D$29</c:f>
              <c:strCache>
                <c:ptCount val="2"/>
                <c:pt idx="0">
                  <c:v>DMSO</c:v>
                </c:pt>
                <c:pt idx="1">
                  <c:v>4μ8c</c:v>
                </c:pt>
              </c:strCache>
            </c:strRef>
          </c:cat>
          <c:val>
            <c:numRef>
              <c:f>[WB定量.xlsx]Alix!$E$28:$E$29</c:f>
              <c:numCache>
                <c:formatCode>General</c:formatCode>
                <c:ptCount val="2"/>
                <c:pt idx="0">
                  <c:v>1</c:v>
                </c:pt>
                <c:pt idx="1">
                  <c:v>0.699552040216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EA-405A-949A-C4FBD860CA24}"/>
            </c:ext>
          </c:extLst>
        </c:ser>
        <c:ser>
          <c:idx val="1"/>
          <c:order val="1"/>
          <c:tx>
            <c:strRef>
              <c:f>[WB定量.xlsx]Alix!$F$27</c:f>
              <c:strCache>
                <c:ptCount val="1"/>
                <c:pt idx="0">
                  <c:v>TG</c:v>
                </c:pt>
              </c:strCache>
            </c:strRef>
          </c:tx>
          <c:spPr>
            <a:pattFill prst="trellis">
              <a:fgClr>
                <a:schemeClr val="tx1">
                  <a:lumMod val="75000"/>
                  <a:lumOff val="25000"/>
                </a:schemeClr>
              </a:fgClr>
              <a:bgClr>
                <a:schemeClr val="bg1"/>
              </a:bgClr>
            </a:patt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[WB定量.xlsx]Alix!$I$28:$I$29</c:f>
                <c:numCache>
                  <c:formatCode>General</c:formatCode>
                  <c:ptCount val="2"/>
                  <c:pt idx="0">
                    <c:v>1.9795381821837807E-2</c:v>
                  </c:pt>
                  <c:pt idx="1">
                    <c:v>4.27082580302620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[WB定量.xlsx]Alix!$D$28:$D$29</c:f>
              <c:strCache>
                <c:ptCount val="2"/>
                <c:pt idx="0">
                  <c:v>DMSO</c:v>
                </c:pt>
                <c:pt idx="1">
                  <c:v>4μ8c</c:v>
                </c:pt>
              </c:strCache>
            </c:strRef>
          </c:cat>
          <c:val>
            <c:numRef>
              <c:f>[WB定量.xlsx]Alix!$F$28:$F$29</c:f>
              <c:numCache>
                <c:formatCode>General</c:formatCode>
                <c:ptCount val="2"/>
                <c:pt idx="0">
                  <c:v>0.6850620268055585</c:v>
                </c:pt>
                <c:pt idx="1">
                  <c:v>0.41141215923467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6EA-405A-949A-C4FBD860CA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51337184"/>
        <c:axId val="1"/>
      </c:barChart>
      <c:scatterChart>
        <c:scatterStyle val="lineMarker"/>
        <c:varyColors val="0"/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[WB定量.xlsx]Alix!$I$22:$I$25</c:f>
              <c:numCache>
                <c:formatCode>General</c:formatCode>
                <c:ptCount val="4"/>
                <c:pt idx="0">
                  <c:v>0.78</c:v>
                </c:pt>
                <c:pt idx="1">
                  <c:v>1.18</c:v>
                </c:pt>
                <c:pt idx="2">
                  <c:v>1.78</c:v>
                </c:pt>
                <c:pt idx="3">
                  <c:v>2.1800000000000002</c:v>
                </c:pt>
              </c:numCache>
            </c:numRef>
          </c:xVal>
          <c:yVal>
            <c:numRef>
              <c:f>[WB定量.xlsx]Alix!$D$22:$D$25</c:f>
              <c:numCache>
                <c:formatCode>#,##0.000_ </c:formatCode>
                <c:ptCount val="4"/>
                <c:pt idx="0">
                  <c:v>1.2009692216778365</c:v>
                </c:pt>
                <c:pt idx="1">
                  <c:v>0.73003039029091799</c:v>
                </c:pt>
                <c:pt idx="2">
                  <c:v>0.81534521934306114</c:v>
                </c:pt>
                <c:pt idx="3">
                  <c:v>0.474995701351653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6EA-405A-949A-C4FBD860CA24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[WB定量.xlsx]Alix!$I$22:$I$25</c:f>
              <c:numCache>
                <c:formatCode>General</c:formatCode>
                <c:ptCount val="4"/>
                <c:pt idx="0">
                  <c:v>0.78</c:v>
                </c:pt>
                <c:pt idx="1">
                  <c:v>1.18</c:v>
                </c:pt>
                <c:pt idx="2">
                  <c:v>1.78</c:v>
                </c:pt>
                <c:pt idx="3">
                  <c:v>2.1800000000000002</c:v>
                </c:pt>
              </c:numCache>
            </c:numRef>
          </c:xVal>
          <c:yVal>
            <c:numRef>
              <c:f>[WB定量.xlsx]Alix!$E$22:$E$25</c:f>
              <c:numCache>
                <c:formatCode>#,##0.000_ </c:formatCode>
                <c:ptCount val="4"/>
                <c:pt idx="0">
                  <c:v>0.89446670079233481</c:v>
                </c:pt>
                <c:pt idx="1">
                  <c:v>0.67828586373844713</c:v>
                </c:pt>
                <c:pt idx="2">
                  <c:v>0.75700877319540771</c:v>
                </c:pt>
                <c:pt idx="3">
                  <c:v>0.451563620983728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6EA-405A-949A-C4FBD860CA24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[WB定量.xlsx]Alix!$I$22:$I$25</c:f>
              <c:numCache>
                <c:formatCode>General</c:formatCode>
                <c:ptCount val="4"/>
                <c:pt idx="0">
                  <c:v>0.78</c:v>
                </c:pt>
                <c:pt idx="1">
                  <c:v>1.18</c:v>
                </c:pt>
                <c:pt idx="2">
                  <c:v>1.78</c:v>
                </c:pt>
                <c:pt idx="3">
                  <c:v>2.1800000000000002</c:v>
                </c:pt>
              </c:numCache>
            </c:numRef>
          </c:xVal>
          <c:yVal>
            <c:numRef>
              <c:f>[WB定量.xlsx]Alix!$F$22:$F$25</c:f>
              <c:numCache>
                <c:formatCode>#,##0.000_ </c:formatCode>
                <c:ptCount val="4"/>
                <c:pt idx="0">
                  <c:v>0.9045640775298287</c:v>
                </c:pt>
                <c:pt idx="1">
                  <c:v>0.6468698263873105</c:v>
                </c:pt>
                <c:pt idx="2">
                  <c:v>0.52630212811092025</c:v>
                </c:pt>
                <c:pt idx="3">
                  <c:v>0.307677155368632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06EA-405A-949A-C4FBD860CA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1337184"/>
        <c:axId val="1"/>
      </c:scatterChart>
      <c:catAx>
        <c:axId val="1151337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elative band intensit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151337184"/>
        <c:crosses val="autoZero"/>
        <c:crossBetween val="between"/>
      </c:valAx>
      <c:spPr>
        <a:noFill/>
        <a:ln w="25400">
          <a:noFill/>
        </a:ln>
      </c:spPr>
    </c:plotArea>
    <c:legend>
      <c:legendPos val="tr"/>
      <c:legendEntry>
        <c:idx val="2"/>
        <c:delete val="1"/>
      </c:legendEntry>
      <c:legendEntry>
        <c:idx val="3"/>
        <c:delete val="1"/>
      </c:legendEntry>
      <c:legendEntry>
        <c:idx val="4"/>
        <c:delete val="1"/>
      </c:legendEntry>
      <c:overlay val="1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dirty="0" smtClean="0"/>
              <a:t>T-cadherin/tubulin</a:t>
            </a:r>
            <a:endParaRPr lang="ja-JP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3185348011747533"/>
          <c:y val="0.2472311670964884"/>
          <c:w val="0.83745052275480869"/>
          <c:h val="0.652322602722720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AA9-437F-9CC8-DDCDB407DEBA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AA9-437F-9CC8-DDCDB407DEBA}"/>
              </c:ext>
            </c:extLst>
          </c:dPt>
          <c:errBars>
            <c:errBarType val="plus"/>
            <c:errValType val="cust"/>
            <c:noEndCap val="0"/>
            <c:plus>
              <c:numRef>
                <c:f>'[611336 CL band intensity.xlsx]CL T-cad'!$K$22:$K$25</c:f>
                <c:numCache>
                  <c:formatCode>General</c:formatCode>
                  <c:ptCount val="4"/>
                  <c:pt idx="0">
                    <c:v>0.11617096876870547</c:v>
                  </c:pt>
                  <c:pt idx="1">
                    <c:v>3.8326023438382394E-2</c:v>
                  </c:pt>
                  <c:pt idx="2">
                    <c:v>4.2219748226373886E-2</c:v>
                  </c:pt>
                  <c:pt idx="3">
                    <c:v>0.105363433662291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611336 CL band intensity.xlsx]CL T-cad'!$F$22:$F$25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cat>
          <c:val>
            <c:numRef>
              <c:f>'[611336 CL band intensity.xlsx]CL T-cad'!$G$22:$G$25</c:f>
              <c:numCache>
                <c:formatCode>0.000</c:formatCode>
                <c:ptCount val="4"/>
                <c:pt idx="0">
                  <c:v>1</c:v>
                </c:pt>
                <c:pt idx="1">
                  <c:v>1.0956281558296561</c:v>
                </c:pt>
                <c:pt idx="2">
                  <c:v>1.0204119955047315</c:v>
                </c:pt>
                <c:pt idx="3">
                  <c:v>1.1984291449702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AA9-437F-9CC8-DDCDB407DE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08485960"/>
        <c:axId val="408491536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611336 CL band intensity.xlsx]CL T-cad'!$F$22:$F$25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xVal>
          <c:yVal>
            <c:numRef>
              <c:f>'[611336 CL band intensity.xlsx]CL T-cad'!$H$22:$H$25</c:f>
              <c:numCache>
                <c:formatCode>0.000</c:formatCode>
                <c:ptCount val="4"/>
                <c:pt idx="0">
                  <c:v>0.75628024212288203</c:v>
                </c:pt>
                <c:pt idx="1">
                  <c:v>1.0018572372228611</c:v>
                </c:pt>
                <c:pt idx="2">
                  <c:v>0.92575451624597749</c:v>
                </c:pt>
                <c:pt idx="3">
                  <c:v>0.952370830999190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AA9-437F-9CC8-DDCDB407DEBA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611336 CL band intensity.xlsx]CL T-cad'!$F$22:$F$25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xVal>
          <c:yVal>
            <c:numRef>
              <c:f>'[611336 CL band intensity.xlsx]CL T-cad'!$I$22:$I$25</c:f>
              <c:numCache>
                <c:formatCode>0.000</c:formatCode>
                <c:ptCount val="4"/>
                <c:pt idx="0">
                  <c:v>0.99465479788356492</c:v>
                </c:pt>
                <c:pt idx="1">
                  <c:v>1.1464173882342796</c:v>
                </c:pt>
                <c:pt idx="2">
                  <c:v>1.0316678457762167</c:v>
                </c:pt>
                <c:pt idx="3">
                  <c:v>1.25401930149398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CAA9-437F-9CC8-DDCDB407DEBA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611336 CL band intensity.xlsx]CL T-cad'!$F$22:$F$25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xVal>
          <c:yVal>
            <c:numRef>
              <c:f>'[611336 CL band intensity.xlsx]CL T-cad'!$J$22:$J$25</c:f>
              <c:numCache>
                <c:formatCode>0.000</c:formatCode>
                <c:ptCount val="4"/>
                <c:pt idx="0">
                  <c:v>1.2490649599935528</c:v>
                </c:pt>
                <c:pt idx="1">
                  <c:v>1.1386098420318271</c:v>
                </c:pt>
                <c:pt idx="2">
                  <c:v>1.1038136244920005</c:v>
                </c:pt>
                <c:pt idx="3">
                  <c:v>1.38889730241752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CAA9-437F-9CC8-DDCDB407DE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8485960"/>
        <c:axId val="408491536"/>
      </c:scatterChart>
      <c:catAx>
        <c:axId val="408485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08491536"/>
        <c:crosses val="autoZero"/>
        <c:auto val="1"/>
        <c:lblAlgn val="ctr"/>
        <c:lblOffset val="100"/>
        <c:noMultiLvlLbl val="0"/>
      </c:catAx>
      <c:valAx>
        <c:axId val="4084915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Arbitrary units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#,##0.0_ 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084859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T-cadherin mRNA</a:t>
            </a:r>
            <a:endParaRPr lang="ja-JP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3185348011747533"/>
          <c:y val="0.2472311670964884"/>
          <c:w val="0.83745052275480869"/>
          <c:h val="0.652322602722720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BF7-4F99-843D-96EA9BE2C17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BF7-4F99-843D-96EA9BE2C175}"/>
              </c:ext>
            </c:extLst>
          </c:dPt>
          <c:errBars>
            <c:errBarType val="plus"/>
            <c:errValType val="cust"/>
            <c:noEndCap val="0"/>
            <c:plus>
              <c:numRef>
                <c:f>'[2022-11-28 181308.xls]calc'!$L$17:$L$20</c:f>
                <c:numCache>
                  <c:formatCode>General</c:formatCode>
                  <c:ptCount val="4"/>
                  <c:pt idx="0">
                    <c:v>1.6495664975414361E-2</c:v>
                  </c:pt>
                  <c:pt idx="1">
                    <c:v>4.9704687966105054E-2</c:v>
                  </c:pt>
                  <c:pt idx="2">
                    <c:v>4.3617444192856729E-2</c:v>
                  </c:pt>
                  <c:pt idx="3">
                    <c:v>9.5484444559984782E-2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'[2022-11-28 181308.xls]calc'!$G$17:$G$20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cat>
          <c:val>
            <c:numRef>
              <c:f>'[2022-11-28 181308.xls]calc'!$H$17:$H$20</c:f>
              <c:numCache>
                <c:formatCode>#,##0.000_ </c:formatCode>
                <c:ptCount val="4"/>
                <c:pt idx="0">
                  <c:v>1</c:v>
                </c:pt>
                <c:pt idx="1">
                  <c:v>1.0415008709422018</c:v>
                </c:pt>
                <c:pt idx="2">
                  <c:v>0.93784949625653669</c:v>
                </c:pt>
                <c:pt idx="3">
                  <c:v>1.21477962305187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BF7-4F99-843D-96EA9BE2C1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626444072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11-28 181308.xls]calc'!$G$17:$G$20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xVal>
          <c:yVal>
            <c:numRef>
              <c:f>'[2022-11-28 181308.xls]calc'!$I$17:$I$20</c:f>
              <c:numCache>
                <c:formatCode>#,##0.000_ </c:formatCode>
                <c:ptCount val="4"/>
                <c:pt idx="0">
                  <c:v>1.0388105813661102</c:v>
                </c:pt>
                <c:pt idx="1">
                  <c:v>0.96474547239422337</c:v>
                </c:pt>
                <c:pt idx="2">
                  <c:v>1.016338690015735</c:v>
                </c:pt>
                <c:pt idx="3">
                  <c:v>1.13704729535056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BF7-4F99-843D-96EA9BE2C175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11-28 181308.xls]calc'!$G$17:$G$20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xVal>
          <c:yVal>
            <c:numRef>
              <c:f>'[2022-11-28 181308.xls]calc'!$J$17:$J$20</c:f>
              <c:numCache>
                <c:formatCode>#,##0.000_ </c:formatCode>
                <c:ptCount val="4"/>
                <c:pt idx="0">
                  <c:v>0.97085892922835348</c:v>
                </c:pt>
                <c:pt idx="1">
                  <c:v>1.1617257364557203</c:v>
                </c:pt>
                <c:pt idx="2">
                  <c:v>0.83582949561161202</c:v>
                </c:pt>
                <c:pt idx="3">
                  <c:v>1.44468510251788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4BF7-4F99-843D-96EA9BE2C175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11-28 181308.xls]calc'!$G$17:$G$20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xVal>
          <c:yVal>
            <c:numRef>
              <c:f>'[2022-11-28 181308.xls]calc'!$K$17:$K$20</c:f>
              <c:numCache>
                <c:formatCode>#,##0.000_ </c:formatCode>
                <c:ptCount val="4"/>
                <c:pt idx="0">
                  <c:v>0.99033048940553658</c:v>
                </c:pt>
                <c:pt idx="1">
                  <c:v>0.99803140397666157</c:v>
                </c:pt>
                <c:pt idx="2">
                  <c:v>0.96138030314226286</c:v>
                </c:pt>
                <c:pt idx="3">
                  <c:v>1.06260647128718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4BF7-4F99-843D-96EA9BE2C1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26444072"/>
        <c:axId val="1"/>
      </c:scatterChart>
      <c:catAx>
        <c:axId val="626444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 dirty="0"/>
                  <a:t>Cdh13/Rplp0</a:t>
                </a:r>
                <a:r>
                  <a:rPr lang="en-US" dirty="0"/>
                  <a:t> (AU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#,##0.0_ 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6264440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Cell lysate protein concentration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4296456692913387"/>
          <c:y val="0.2472311670964884"/>
          <c:w val="0.82633945756780403"/>
          <c:h val="0.652322602722720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E21-4779-9575-1F62D72EE85D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E21-4779-9575-1F62D72EE85D}"/>
              </c:ext>
            </c:extLst>
          </c:dPt>
          <c:errBars>
            <c:errBarType val="plus"/>
            <c:errValType val="cust"/>
            <c:noEndCap val="0"/>
            <c:plus>
              <c:numRef>
                <c:f>'[Export1.xls]560.0'!$S$14:$S$17</c:f>
                <c:numCache>
                  <c:formatCode>General</c:formatCode>
                  <c:ptCount val="4"/>
                  <c:pt idx="0">
                    <c:v>41.588189043881506</c:v>
                  </c:pt>
                  <c:pt idx="1">
                    <c:v>24.628012474867333</c:v>
                  </c:pt>
                  <c:pt idx="2">
                    <c:v>23.78259743039661</c:v>
                  </c:pt>
                  <c:pt idx="3">
                    <c:v>5.93272869903014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'[Export1.xls]560.0'!$N$14:$N$17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cat>
          <c:val>
            <c:numRef>
              <c:f>'[Export1.xls]560.0'!$O$14:$O$17</c:f>
              <c:numCache>
                <c:formatCode>General</c:formatCode>
                <c:ptCount val="4"/>
                <c:pt idx="0">
                  <c:v>249.79066666666668</c:v>
                </c:pt>
                <c:pt idx="1">
                  <c:v>268.62780000000004</c:v>
                </c:pt>
                <c:pt idx="2">
                  <c:v>309.62626666666665</c:v>
                </c:pt>
                <c:pt idx="3">
                  <c:v>269.7358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E21-4779-9575-1F62D72EE8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626444072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Export1.xls]560.0'!$N$14:$N$17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xVal>
          <c:yVal>
            <c:numRef>
              <c:f>'[Export1.xls]560.0'!$P$14:$P$17</c:f>
              <c:numCache>
                <c:formatCode>General</c:formatCode>
                <c:ptCount val="4"/>
                <c:pt idx="0">
                  <c:v>158.92919999999998</c:v>
                </c:pt>
                <c:pt idx="1">
                  <c:v>232.06160000000003</c:v>
                </c:pt>
                <c:pt idx="2">
                  <c:v>255.33100000000005</c:v>
                </c:pt>
                <c:pt idx="3">
                  <c:v>255.3310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E21-4779-9575-1F62D72EE85D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Export1.xls]560.0'!$N$14:$N$17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xVal>
          <c:yVal>
            <c:numRef>
              <c:f>'[Export1.xls]560.0'!$Q$14:$Q$17</c:f>
              <c:numCache>
                <c:formatCode>General</c:formatCode>
                <c:ptCount val="4"/>
                <c:pt idx="0">
                  <c:v>255.33100000000005</c:v>
                </c:pt>
                <c:pt idx="1">
                  <c:v>328.46339999999998</c:v>
                </c:pt>
                <c:pt idx="2">
                  <c:v>355.05700000000002</c:v>
                </c:pt>
                <c:pt idx="3">
                  <c:v>278.600399999999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EE21-4779-9575-1F62D72EE85D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Export1.xls]560.0'!$N$14:$N$17</c:f>
              <c:strCache>
                <c:ptCount val="4"/>
                <c:pt idx="0">
                  <c:v>DMSO</c:v>
                </c:pt>
                <c:pt idx="1">
                  <c:v>TM</c:v>
                </c:pt>
                <c:pt idx="2">
                  <c:v>APN</c:v>
                </c:pt>
                <c:pt idx="3">
                  <c:v>APN+TM</c:v>
                </c:pt>
              </c:strCache>
            </c:strRef>
          </c:xVal>
          <c:yVal>
            <c:numRef>
              <c:f>'[Export1.xls]560.0'!$R$14:$R$17</c:f>
              <c:numCache>
                <c:formatCode>General</c:formatCode>
                <c:ptCount val="4"/>
                <c:pt idx="0">
                  <c:v>335.11180000000002</c:v>
                </c:pt>
                <c:pt idx="1">
                  <c:v>245.35840000000005</c:v>
                </c:pt>
                <c:pt idx="2">
                  <c:v>318.49079999999998</c:v>
                </c:pt>
                <c:pt idx="3">
                  <c:v>275.2761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EE21-4779-9575-1F62D72EE8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26444072"/>
        <c:axId val="1"/>
      </c:scatterChart>
      <c:catAx>
        <c:axId val="626444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rotein concentration (μg/mL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#,##0_ 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6264440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i="1" dirty="0" smtClean="0"/>
              <a:t>Xbp1</a:t>
            </a:r>
            <a:r>
              <a:rPr lang="en-US" dirty="0" smtClean="0"/>
              <a:t> </a:t>
            </a:r>
            <a:r>
              <a:rPr lang="en-US" dirty="0"/>
              <a:t>calibration curve</a:t>
            </a:r>
            <a:endParaRPr lang="ja-JP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/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'[211122_protocol&amp;result_3300.xlsx]XBP1'!$C$47:$C$51</c:f>
              <c:numCache>
                <c:formatCode>General</c:formatCode>
                <c:ptCount val="5"/>
                <c:pt idx="0">
                  <c:v>2</c:v>
                </c:pt>
                <c:pt idx="1">
                  <c:v>1</c:v>
                </c:pt>
                <c:pt idx="2">
                  <c:v>0.5</c:v>
                </c:pt>
                <c:pt idx="3">
                  <c:v>0.25</c:v>
                </c:pt>
                <c:pt idx="4">
                  <c:v>0.125</c:v>
                </c:pt>
              </c:numCache>
            </c:numRef>
          </c:xVal>
          <c:yVal>
            <c:numRef>
              <c:f>'[211122_protocol&amp;result_3300.xlsx]XBP1'!$D$47:$D$51</c:f>
              <c:numCache>
                <c:formatCode>#,##0_ </c:formatCode>
                <c:ptCount val="5"/>
                <c:pt idx="0">
                  <c:v>28576937</c:v>
                </c:pt>
                <c:pt idx="1">
                  <c:v>13978680</c:v>
                </c:pt>
                <c:pt idx="2">
                  <c:v>10396299</c:v>
                </c:pt>
                <c:pt idx="3">
                  <c:v>6418180</c:v>
                </c:pt>
                <c:pt idx="4">
                  <c:v>286366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964-4086-B346-2300164056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2239248"/>
        <c:axId val="172283848"/>
      </c:scatterChart>
      <c:valAx>
        <c:axId val="5322392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Si Ctrl PCR products (AU)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2283848"/>
        <c:crosses val="autoZero"/>
        <c:crossBetween val="midCat"/>
      </c:valAx>
      <c:valAx>
        <c:axId val="1722838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Band intensity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#,##0_ 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322392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TLR3 mRNA</a:t>
            </a:r>
            <a:endParaRPr lang="ja-JP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60A-4747-8AB3-B4DE0B9868B8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60A-4747-8AB3-B4DE0B9868B8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60A-4747-8AB3-B4DE0B9868B8}"/>
              </c:ext>
            </c:extLst>
          </c:dPt>
          <c:errBars>
            <c:errBarType val="plus"/>
            <c:errValType val="cust"/>
            <c:noEndCap val="0"/>
            <c:plus>
              <c:numRef>
                <c:f>'[2022-03-17 133612.xls]calculate'!$V$20:$V$21</c:f>
                <c:numCache>
                  <c:formatCode>General</c:formatCode>
                  <c:ptCount val="2"/>
                  <c:pt idx="0">
                    <c:v>6.1250194381670224E-2</c:v>
                  </c:pt>
                  <c:pt idx="1">
                    <c:v>0.10225140962787442</c:v>
                  </c:pt>
                </c:numCache>
              </c:numRef>
            </c:plus>
            <c:spPr>
              <a:solidFill>
                <a:schemeClr val="bg2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[2022-03-17 133612.xls]calculate'!$Y$20:$Y$21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[2022-03-17 133612.xls]calculate'!$Z$20:$Z$21</c:f>
              <c:numCache>
                <c:formatCode>General</c:formatCode>
                <c:ptCount val="2"/>
                <c:pt idx="0">
                  <c:v>1</c:v>
                </c:pt>
                <c:pt idx="1">
                  <c:v>2.7171710598693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60A-4747-8AB3-B4DE0B9868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10715216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7 133612.xls]calculate'!$Y$20:$Y$21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7 133612.xls]calculate'!$AA$20:$AA$21</c:f>
              <c:numCache>
                <c:formatCode>General</c:formatCode>
                <c:ptCount val="2"/>
                <c:pt idx="0">
                  <c:v>0.91440957812962309</c:v>
                </c:pt>
                <c:pt idx="1">
                  <c:v>3.23231048799726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60A-4747-8AB3-B4DE0B9868B8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7 133612.xls]calculate'!$Y$20:$Y$21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7 133612.xls]calculate'!$AB$20:$AB$21</c:f>
              <c:numCache>
                <c:formatCode>General</c:formatCode>
                <c:ptCount val="2"/>
                <c:pt idx="0">
                  <c:v>1.1902860380704794</c:v>
                </c:pt>
                <c:pt idx="1">
                  <c:v>2.88874540553990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960A-4747-8AB3-B4DE0B9868B8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7 133612.xls]calculate'!$Y$20:$Y$21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7 133612.xls]calculate'!$AC$20:$AC$21</c:f>
              <c:numCache>
                <c:formatCode>General</c:formatCode>
                <c:ptCount val="2"/>
                <c:pt idx="0">
                  <c:v>0.89530438379989774</c:v>
                </c:pt>
                <c:pt idx="1">
                  <c:v>2.03045728607097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960A-4747-8AB3-B4DE0B9868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0715216"/>
        <c:axId val="1"/>
      </c:scatterChart>
      <c:catAx>
        <c:axId val="510715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 dirty="0"/>
                  <a:t>Tlr3/Rplp0 </a:t>
                </a:r>
                <a:r>
                  <a:rPr lang="en-US" dirty="0"/>
                  <a:t>(AU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107152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T-cad mRNA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128-48EA-910A-77BDE52268C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128-48EA-910A-77BDE52268CD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128-48EA-910A-77BDE52268CD}"/>
              </c:ext>
            </c:extLst>
          </c:dPt>
          <c:errBars>
            <c:errBarType val="plus"/>
            <c:errValType val="cust"/>
            <c:noEndCap val="0"/>
            <c:plus>
              <c:numRef>
                <c:f>'\\192.168.1.37\fukuoka\実験データ\220314_F2_poly(IC)_4900\4901-4924_F2 poly(IC)\[2022-03-17 133612.xls]calculate'!$V$20:$V$21</c:f>
                <c:numCache>
                  <c:formatCode>General</c:formatCode>
                  <c:ptCount val="2"/>
                  <c:pt idx="0">
                    <c:v>6.1250194381670224E-2</c:v>
                  </c:pt>
                  <c:pt idx="1">
                    <c:v>0.10225140962787442</c:v>
                  </c:pt>
                </c:numCache>
              </c:numRef>
            </c:plus>
            <c:spPr>
              <a:solidFill>
                <a:schemeClr val="bg2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[2022-03-18 112321.xls]calculate'!$I$75:$I$76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[2022-03-18 112321.xls]calculate'!$J$75:$J$76</c:f>
              <c:numCache>
                <c:formatCode>#,##0.00_ </c:formatCode>
                <c:ptCount val="2"/>
                <c:pt idx="0">
                  <c:v>1</c:v>
                </c:pt>
                <c:pt idx="1">
                  <c:v>0.671380694210568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128-48EA-910A-77BDE52268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76750632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8 112321.xls]calculate'!$I$75:$I$76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8 112321.xls]calculate'!$K$75:$K$76</c:f>
              <c:numCache>
                <c:formatCode>#,##0.00_ </c:formatCode>
                <c:ptCount val="2"/>
                <c:pt idx="0">
                  <c:v>1.1011733910998025</c:v>
                </c:pt>
                <c:pt idx="1">
                  <c:v>0.655028288067690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1128-48EA-910A-77BDE52268CD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8 112321.xls]calculate'!$I$75:$I$76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8 112321.xls]calculate'!$L$75:$L$76</c:f>
              <c:numCache>
                <c:formatCode>#,##0.00_ </c:formatCode>
                <c:ptCount val="2"/>
                <c:pt idx="0">
                  <c:v>0.88031238866295225</c:v>
                </c:pt>
                <c:pt idx="1">
                  <c:v>0.645452646252395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1128-48EA-910A-77BDE52268CD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8 112321.xls]calculate'!$I$75:$I$76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8 112321.xls]calculate'!$M$75:$M$76</c:f>
              <c:numCache>
                <c:formatCode>#,##0.00_ </c:formatCode>
                <c:ptCount val="2"/>
                <c:pt idx="0">
                  <c:v>1.0185142202372455</c:v>
                </c:pt>
                <c:pt idx="1">
                  <c:v>0.713661148311618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1128-48EA-910A-77BDE52268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6750632"/>
        <c:axId val="1"/>
      </c:scatterChart>
      <c:catAx>
        <c:axId val="476750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 dirty="0"/>
                  <a:t>Cdh13/Rplp0 </a:t>
                </a:r>
                <a:r>
                  <a:rPr lang="en-US" dirty="0"/>
                  <a:t>(AU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767506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/>
              <a:t>T-cadherin mRNA</a:t>
            </a:r>
            <a:endParaRPr lang="ja-JP" alt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trellis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5E6-40A3-A9CD-07E25531A17D}"/>
              </c:ext>
            </c:extLst>
          </c:dPt>
          <c:dPt>
            <c:idx val="1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5E6-40A3-A9CD-07E25531A17D}"/>
              </c:ext>
            </c:extLst>
          </c:dPt>
          <c:dPt>
            <c:idx val="2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5E6-40A3-A9CD-07E25531A17D}"/>
              </c:ext>
            </c:extLst>
          </c:dPt>
          <c:dPt>
            <c:idx val="3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5E6-40A3-A9CD-07E25531A17D}"/>
              </c:ext>
            </c:extLst>
          </c:dPt>
          <c:errBars>
            <c:errBarType val="plus"/>
            <c:errValType val="cust"/>
            <c:noEndCap val="0"/>
            <c:plus>
              <c:numRef>
                <c:f>'2100'!$F$17:$F$20</c:f>
                <c:numCache>
                  <c:formatCode>General</c:formatCode>
                  <c:ptCount val="4"/>
                  <c:pt idx="0">
                    <c:v>0.11114992086964882</c:v>
                  </c:pt>
                  <c:pt idx="1">
                    <c:v>0.13650182056122936</c:v>
                  </c:pt>
                  <c:pt idx="2">
                    <c:v>1.7867121661393221E-2</c:v>
                  </c:pt>
                  <c:pt idx="3">
                    <c:v>1.398594593024238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100'!$A$17:$A$20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cat>
          <c:val>
            <c:numRef>
              <c:f>'2100'!$B$17:$B$20</c:f>
              <c:numCache>
                <c:formatCode>General</c:formatCode>
                <c:ptCount val="4"/>
                <c:pt idx="0">
                  <c:v>1</c:v>
                </c:pt>
                <c:pt idx="1">
                  <c:v>0.75990547026426825</c:v>
                </c:pt>
                <c:pt idx="2">
                  <c:v>0.33479704732647048</c:v>
                </c:pt>
                <c:pt idx="3">
                  <c:v>0.11103972671408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5E6-40A3-A9CD-07E25531A1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74071768"/>
        <c:axId val="77407242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2100'!$A$17:$A$20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xVal>
          <c:yVal>
            <c:numRef>
              <c:f>'2100'!$C$17:$C$20</c:f>
              <c:numCache>
                <c:formatCode>General</c:formatCode>
                <c:ptCount val="4"/>
                <c:pt idx="0">
                  <c:v>0.74999126056704857</c:v>
                </c:pt>
                <c:pt idx="1">
                  <c:v>1.0316443421493142</c:v>
                </c:pt>
                <c:pt idx="2">
                  <c:v>0.2921833126443858</c:v>
                </c:pt>
                <c:pt idx="3">
                  <c:v>0.137256434585055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65E6-40A3-A9CD-07E25531A17D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2100'!$A$17:$A$20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xVal>
          <c:yVal>
            <c:numRef>
              <c:f>'2100'!$D$17:$D$20</c:f>
              <c:numCache>
                <c:formatCode>General</c:formatCode>
                <c:ptCount val="4"/>
                <c:pt idx="0">
                  <c:v>1.2183643972836369</c:v>
                </c:pt>
                <c:pt idx="1">
                  <c:v>0.79275429268274022</c:v>
                </c:pt>
                <c:pt idx="2">
                  <c:v>0.34746647428176808</c:v>
                </c:pt>
                <c:pt idx="3">
                  <c:v>0.117029625246884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65E6-40A3-A9CD-07E25531A17D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2100'!$A$17:$A$20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xVal>
          <c:yVal>
            <c:numRef>
              <c:f>'2100'!$E$17:$E$20</c:f>
              <c:numCache>
                <c:formatCode>General</c:formatCode>
                <c:ptCount val="4"/>
                <c:pt idx="0">
                  <c:v>1.0316443421493142</c:v>
                </c:pt>
                <c:pt idx="1">
                  <c:v>0.45531777596075063</c:v>
                </c:pt>
                <c:pt idx="2">
                  <c:v>0.36474135505325744</c:v>
                </c:pt>
                <c:pt idx="3">
                  <c:v>7.88331203103056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65E6-40A3-A9CD-07E25531A1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74071768"/>
        <c:axId val="774072424"/>
      </c:scatterChart>
      <c:catAx>
        <c:axId val="7740717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hapsigargin </a:t>
                </a:r>
                <a:r>
                  <a:rPr lang="en-US" dirty="0"/>
                  <a:t>(</a:t>
                </a:r>
                <a:r>
                  <a:rPr lang="en-US" dirty="0" err="1"/>
                  <a:t>μmol</a:t>
                </a:r>
                <a:r>
                  <a:rPr lang="en-US" dirty="0"/>
                  <a:t>/L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25817453703703702"/>
              <c:y val="0.83286172839506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4072424"/>
        <c:crosses val="autoZero"/>
        <c:auto val="1"/>
        <c:lblAlgn val="ctr"/>
        <c:lblOffset val="100"/>
        <c:noMultiLvlLbl val="0"/>
      </c:catAx>
      <c:valAx>
        <c:axId val="774072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i="1" dirty="0"/>
                  <a:t>Cdh13/Rplp0</a:t>
                </a:r>
                <a:r>
                  <a:rPr lang="en-US" dirty="0"/>
                  <a:t> (AU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4071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BiP mRNA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08A-4694-83E4-9669F60D117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08A-4694-83E4-9669F60D1179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08A-4694-83E4-9669F60D1179}"/>
              </c:ext>
            </c:extLst>
          </c:dPt>
          <c:errBars>
            <c:errBarType val="plus"/>
            <c:errValType val="cust"/>
            <c:noEndCap val="0"/>
            <c:plus>
              <c:numRef>
                <c:f>'\\192.168.1.37\fukuoka\実験データ\220314_F2_poly(IC)_4900\4901-4924_F2 poly(IC)\[2022-03-17 133612.xls]calculate'!$V$20:$V$21</c:f>
                <c:numCache>
                  <c:formatCode>General</c:formatCode>
                  <c:ptCount val="2"/>
                  <c:pt idx="0">
                    <c:v>6.1250194381670224E-2</c:v>
                  </c:pt>
                  <c:pt idx="1">
                    <c:v>0.10225140962787442</c:v>
                  </c:pt>
                </c:numCache>
              </c:numRef>
            </c:plus>
            <c:spPr>
              <a:solidFill>
                <a:schemeClr val="bg2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[2022-03-18 112321.xls]calculate'!$R$75:$R$76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[2022-03-18 112321.xls]calculate'!$S$75:$S$76</c:f>
              <c:numCache>
                <c:formatCode>#,##0.00_ </c:formatCode>
                <c:ptCount val="2"/>
                <c:pt idx="0">
                  <c:v>1</c:v>
                </c:pt>
                <c:pt idx="1">
                  <c:v>1.19164079939166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08A-4694-83E4-9669F60D11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76748008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8 112321.xls]calculate'!$R$75:$R$76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8 112321.xls]calculate'!$T$75:$T$76</c:f>
              <c:numCache>
                <c:formatCode>#,##0.00_ </c:formatCode>
                <c:ptCount val="2"/>
                <c:pt idx="0">
                  <c:v>1.1795637120370726</c:v>
                </c:pt>
                <c:pt idx="1">
                  <c:v>1.27311493936358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208A-4694-83E4-9669F60D1179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8 112321.xls]calculate'!$R$75:$R$76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8 112321.xls]calculate'!$U$75:$U$76</c:f>
              <c:numCache>
                <c:formatCode>#,##0.00_ </c:formatCode>
                <c:ptCount val="2"/>
                <c:pt idx="0">
                  <c:v>0.93877689261256003</c:v>
                </c:pt>
                <c:pt idx="1">
                  <c:v>1.23117040723021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208A-4694-83E4-9669F60D1179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8 112321.xls]calculate'!$R$75:$R$76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8 112321.xls]calculate'!$V$75:$V$76</c:f>
              <c:numCache>
                <c:formatCode>#,##0.00_ </c:formatCode>
                <c:ptCount val="2"/>
                <c:pt idx="0">
                  <c:v>0.88165939535036753</c:v>
                </c:pt>
                <c:pt idx="1">
                  <c:v>1.07063705158118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208A-4694-83E4-9669F60D11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6748008"/>
        <c:axId val="1"/>
      </c:scatterChart>
      <c:catAx>
        <c:axId val="476748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 dirty="0"/>
                  <a:t>Hspa5/Rplp0 </a:t>
                </a:r>
                <a:r>
                  <a:rPr lang="en-US" dirty="0"/>
                  <a:t>(AU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7674800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i="1" dirty="0" smtClean="0"/>
              <a:t>Xbp1</a:t>
            </a:r>
            <a:r>
              <a:rPr lang="en-US" dirty="0" smtClean="0"/>
              <a:t> </a:t>
            </a:r>
            <a:r>
              <a:rPr lang="en-US" dirty="0"/>
              <a:t>splicing</a:t>
            </a:r>
            <a:endParaRPr lang="ja-JP" dirty="0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7BE-4FF3-8ED0-EC2C983180E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7BE-4FF3-8ED0-EC2C983180EC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7BE-4FF3-8ED0-EC2C983180EC}"/>
              </c:ext>
            </c:extLst>
          </c:dPt>
          <c:errBars>
            <c:errBarType val="plus"/>
            <c:errValType val="cust"/>
            <c:noEndCap val="0"/>
            <c:plus>
              <c:numRef>
                <c:f>'[4901-4924 XBP1.xlsx]Sheet1'!$U$38:$U$39</c:f>
                <c:numCache>
                  <c:formatCode>General</c:formatCode>
                  <c:ptCount val="2"/>
                  <c:pt idx="0">
                    <c:v>1.5938454808971441</c:v>
                  </c:pt>
                  <c:pt idx="1">
                    <c:v>2.61089424355091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bg2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[4901-4924 XBP1.xlsx]Sheet1'!$P$38:$P$39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[4901-4924 XBP1.xlsx]Sheet1'!$Q$38:$Q$39</c:f>
              <c:numCache>
                <c:formatCode>General</c:formatCode>
                <c:ptCount val="2"/>
                <c:pt idx="0">
                  <c:v>29.975096310164172</c:v>
                </c:pt>
                <c:pt idx="1">
                  <c:v>33.5808014452761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7BE-4FF3-8ED0-EC2C983180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495066752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01-4924 XBP1.xlsx]Sheet1'!$P$38:$P$39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01-4924 XBP1.xlsx]Sheet1'!$R$38:$R$39</c:f>
              <c:numCache>
                <c:formatCode>General</c:formatCode>
                <c:ptCount val="2"/>
                <c:pt idx="0">
                  <c:v>29.124265662977773</c:v>
                </c:pt>
                <c:pt idx="1">
                  <c:v>27.4912800031611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17BE-4FF3-8ED0-EC2C983180EC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01-4924 XBP1.xlsx]Sheet1'!$P$38:$P$39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01-4924 XBP1.xlsx]Sheet1'!$S$38:$S$39</c:f>
              <c:numCache>
                <c:formatCode>General</c:formatCode>
                <c:ptCount val="2"/>
                <c:pt idx="0">
                  <c:v>27.100722127781356</c:v>
                </c:pt>
                <c:pt idx="1">
                  <c:v>34.9332986425142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17BE-4FF3-8ED0-EC2C983180EC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01-4924 XBP1.xlsx]Sheet1'!$P$38:$P$39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01-4924 XBP1.xlsx]Sheet1'!$T$38:$T$39</c:f>
              <c:numCache>
                <c:formatCode>General</c:formatCode>
                <c:ptCount val="2"/>
                <c:pt idx="0">
                  <c:v>33.700301139733376</c:v>
                </c:pt>
                <c:pt idx="1">
                  <c:v>38.3178256901528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17BE-4FF3-8ED0-EC2C983180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5066752"/>
        <c:axId val="1"/>
      </c:scatterChart>
      <c:catAx>
        <c:axId val="495066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%  spliced</a:t>
                </a:r>
                <a:r>
                  <a:rPr lang="en-US" altLang="ja-JP" sz="1100" b="1" i="0" u="none" strike="noStrike" baseline="0" dirty="0" smtClean="0">
                    <a:effectLst/>
                  </a:rPr>
                  <a:t> </a:t>
                </a:r>
                <a:r>
                  <a:rPr lang="en-US" altLang="ja-JP" sz="1100" b="1" i="1" u="none" strike="noStrike" baseline="0" dirty="0" smtClean="0">
                    <a:effectLst/>
                  </a:rPr>
                  <a:t>Xbp1</a:t>
                </a:r>
                <a:r>
                  <a:rPr lang="en-US" altLang="ja-JP" sz="1100" b="1" i="0" u="none" strike="noStrike" baseline="0" dirty="0" smtClean="0">
                    <a:effectLst/>
                  </a:rPr>
                  <a:t> </a:t>
                </a:r>
                <a:r>
                  <a:rPr lang="en-US" dirty="0" smtClean="0"/>
                  <a:t>amplicons</a:t>
                </a:r>
                <a:endParaRPr lang="en-US" dirty="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9506675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PKR mRNA</a:t>
            </a:r>
            <a:endParaRPr lang="ja-JP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C31-46ED-8641-2B9D23B1E58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C31-46ED-8641-2B9D23B1E587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C31-46ED-8641-2B9D23B1E587}"/>
              </c:ext>
            </c:extLst>
          </c:dPt>
          <c:errBars>
            <c:errBarType val="plus"/>
            <c:errValType val="cust"/>
            <c:noEndCap val="0"/>
            <c:plus>
              <c:numRef>
                <c:f>'[2022-03-17 133612.xls]calculate'!$V$20:$V$21</c:f>
                <c:numCache>
                  <c:formatCode>General</c:formatCode>
                  <c:ptCount val="2"/>
                  <c:pt idx="0">
                    <c:v>6.1250194381670224E-2</c:v>
                  </c:pt>
                  <c:pt idx="1">
                    <c:v>0.10225140962787442</c:v>
                  </c:pt>
                </c:numCache>
              </c:numRef>
            </c:plus>
            <c:spPr>
              <a:solidFill>
                <a:schemeClr val="bg2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[2022-03-17 133612.xls]calculate'!$Q$20:$Q$21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[2022-03-17 133612.xls]calculate'!$R$20:$R$21</c:f>
              <c:numCache>
                <c:formatCode>0.000</c:formatCode>
                <c:ptCount val="2"/>
                <c:pt idx="0">
                  <c:v>1</c:v>
                </c:pt>
                <c:pt idx="1">
                  <c:v>3.15080840151726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C31-46ED-8641-2B9D23B1E5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10716528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7 133612.xls]calculate'!$Q$20:$Q$21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7 133612.xls]calculate'!$S$20:$S$21</c:f>
              <c:numCache>
                <c:formatCode>0.000</c:formatCode>
                <c:ptCount val="2"/>
                <c:pt idx="0">
                  <c:v>0.93710314232441239</c:v>
                </c:pt>
                <c:pt idx="1">
                  <c:v>3.07721883115078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7C31-46ED-8641-2B9D23B1E587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7 133612.xls]calculate'!$Q$20:$Q$21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7 133612.xls]calculate'!$T$20:$T$21</c:f>
              <c:numCache>
                <c:formatCode>0.000</c:formatCode>
                <c:ptCount val="2"/>
                <c:pt idx="0">
                  <c:v>0.91348603070191203</c:v>
                </c:pt>
                <c:pt idx="1">
                  <c:v>2.98026889185532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7C31-46ED-8641-2B9D23B1E587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2022-03-17 133612.xls]calculate'!$Q$20:$Q$21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2022-03-17 133612.xls]calculate'!$U$20:$U$21</c:f>
              <c:numCache>
                <c:formatCode>0.000</c:formatCode>
                <c:ptCount val="2"/>
                <c:pt idx="0">
                  <c:v>1.1494108269736758</c:v>
                </c:pt>
                <c:pt idx="1">
                  <c:v>3.39493748154569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7C31-46ED-8641-2B9D23B1E5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0716528"/>
        <c:axId val="1"/>
      </c:scatterChart>
      <c:catAx>
        <c:axId val="510716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 dirty="0"/>
                  <a:t>Eif2ak2/Rplp0</a:t>
                </a:r>
                <a:r>
                  <a:rPr lang="en-US" dirty="0"/>
                  <a:t> (AU)</a:t>
                </a:r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1071652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exosomal Syntenin</a:t>
            </a:r>
            <a:endParaRPr lang="ja-JP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8D1-4899-A14B-4D0C235147E3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98D1-4899-A14B-4D0C235147E3}"/>
              </c:ext>
            </c:extLst>
          </c:dPt>
          <c:errBars>
            <c:errBarType val="plus"/>
            <c:errValType val="cust"/>
            <c:noEndCap val="0"/>
            <c:plus>
              <c:numRef>
                <c:f>'[493748 band intensity.xlsx]Tsg101'!$G$42:$G$43</c:f>
                <c:numCache>
                  <c:formatCode>General</c:formatCode>
                  <c:ptCount val="2"/>
                  <c:pt idx="0">
                    <c:v>0.12630865776944422</c:v>
                  </c:pt>
                  <c:pt idx="1">
                    <c:v>5.380370448368911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bg2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[493748 band intensity.xlsx]syntenin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[493748 band intensity.xlsx]syntenin'!$C$42:$C$43</c:f>
              <c:numCache>
                <c:formatCode>#,##0.000_ </c:formatCode>
                <c:ptCount val="2"/>
                <c:pt idx="0">
                  <c:v>1</c:v>
                </c:pt>
                <c:pt idx="1">
                  <c:v>0.213524316406514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8D1-4899-A14B-4D0C235147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45554160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3748 band intensity.xlsx]syntenin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3748 band intensity.xlsx]syntenin'!$D$42:$D$43</c:f>
              <c:numCache>
                <c:formatCode>#,##0.000_ </c:formatCode>
                <c:ptCount val="2"/>
                <c:pt idx="0">
                  <c:v>1.2881362043484479</c:v>
                </c:pt>
                <c:pt idx="1">
                  <c:v>0.237495436353075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8D1-4899-A14B-4D0C235147E3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3748 band intensity.xlsx]syntenin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3748 band intensity.xlsx]syntenin'!$E$42:$E$43</c:f>
              <c:numCache>
                <c:formatCode>#,##0.000_ </c:formatCode>
                <c:ptCount val="2"/>
                <c:pt idx="0">
                  <c:v>1.1892386497945702</c:v>
                </c:pt>
                <c:pt idx="1">
                  <c:v>0.312776668161480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8D1-4899-A14B-4D0C235147E3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3748 band intensity.xlsx]syntenin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3748 band intensity.xlsx]syntenin'!$F$42:$F$43</c:f>
              <c:numCache>
                <c:formatCode>#,##0.000_ </c:formatCode>
                <c:ptCount val="2"/>
                <c:pt idx="0">
                  <c:v>0.52262514585698205</c:v>
                </c:pt>
                <c:pt idx="1">
                  <c:v>9.030084470498707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98D1-4899-A14B-4D0C235147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5554160"/>
        <c:axId val="1"/>
      </c:scatterChart>
      <c:catAx>
        <c:axId val="54555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band intensity (/cell)</a:t>
                </a:r>
              </a:p>
            </c:rich>
          </c:tx>
          <c:layout>
            <c:manualLayout>
              <c:xMode val="edge"/>
              <c:yMode val="edge"/>
              <c:x val="5.6444444444444443E-2"/>
              <c:y val="0.13352619047619046"/>
            </c:manualLayout>
          </c:layout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455541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exosomal Tsg101</a:t>
            </a:r>
            <a:endParaRPr lang="ja-JP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839-42BB-BFB0-76ECB1064741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5839-42BB-BFB0-76ECB1064741}"/>
              </c:ext>
            </c:extLst>
          </c:dPt>
          <c:errBars>
            <c:errBarType val="plus"/>
            <c:errValType val="cust"/>
            <c:noEndCap val="0"/>
            <c:plus>
              <c:numRef>
                <c:f>'[493748 band intensity.xlsx]Tsg101'!$G$42:$G$43</c:f>
                <c:numCache>
                  <c:formatCode>General</c:formatCode>
                  <c:ptCount val="2"/>
                  <c:pt idx="0">
                    <c:v>0.12630865776944422</c:v>
                  </c:pt>
                  <c:pt idx="1">
                    <c:v>5.380370448368911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bg2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[493748 band intensity.xlsx]Tsg101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[493748 band intensity.xlsx]Tsg101'!$C$42:$C$43</c:f>
              <c:numCache>
                <c:formatCode>#,##0.000_ </c:formatCode>
                <c:ptCount val="2"/>
                <c:pt idx="0">
                  <c:v>1</c:v>
                </c:pt>
                <c:pt idx="1">
                  <c:v>0.33080190932389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839-42BB-BFB0-76ECB10647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45554160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3748 band intensity.xlsx]Tsg101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3748 band intensity.xlsx]Tsg101'!$D$42:$D$43</c:f>
              <c:numCache>
                <c:formatCode>#,##0.000_ </c:formatCode>
                <c:ptCount val="2"/>
                <c:pt idx="0">
                  <c:v>1.3041559224037613</c:v>
                </c:pt>
                <c:pt idx="1">
                  <c:v>0.24825731525740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839-42BB-BFB0-76ECB1064741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3748 band intensity.xlsx]Tsg101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3748 band intensity.xlsx]Tsg101'!$E$42:$E$43</c:f>
              <c:numCache>
                <c:formatCode>#,##0.000_ </c:formatCode>
                <c:ptCount val="2"/>
                <c:pt idx="0">
                  <c:v>0.79883713507129661</c:v>
                </c:pt>
                <c:pt idx="1">
                  <c:v>0.461049294250072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839-42BB-BFB0-76ECB1064741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3748 band intensity.xlsx]Tsg101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3748 band intensity.xlsx]Tsg101'!$F$42:$F$43</c:f>
              <c:numCache>
                <c:formatCode>#,##0.000_ </c:formatCode>
                <c:ptCount val="2"/>
                <c:pt idx="0">
                  <c:v>0.89700694252494206</c:v>
                </c:pt>
                <c:pt idx="1">
                  <c:v>0.283099118464192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5839-42BB-BFB0-76ECB10647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5554160"/>
        <c:axId val="1"/>
      </c:scatterChart>
      <c:catAx>
        <c:axId val="54555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band intensity (/cell)</a:t>
                </a:r>
              </a:p>
            </c:rich>
          </c:tx>
          <c:layout>
            <c:manualLayout>
              <c:xMode val="edge"/>
              <c:yMode val="edge"/>
              <c:x val="6.3500000000000001E-2"/>
              <c:y val="0.10328809523809522"/>
            </c:manualLayout>
          </c:layout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455541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exosomal Alix</a:t>
            </a:r>
            <a:endParaRPr lang="ja-JP"/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37330944444444447"/>
          <c:y val="0.20319999999999999"/>
          <c:w val="0.54907944444444445"/>
          <c:h val="0.6938392857142857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827-495D-B975-288A647AE488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2827-495D-B975-288A647AE488}"/>
              </c:ext>
            </c:extLst>
          </c:dPt>
          <c:errBars>
            <c:errBarType val="plus"/>
            <c:errValType val="cust"/>
            <c:noEndCap val="0"/>
            <c:plus>
              <c:numRef>
                <c:f>'[493748 band intensity.xlsx]Alix'!$G$42:$G$43</c:f>
                <c:numCache>
                  <c:formatCode>General</c:formatCode>
                  <c:ptCount val="2"/>
                  <c:pt idx="0">
                    <c:v>0.15619788945628654</c:v>
                  </c:pt>
                  <c:pt idx="1">
                    <c:v>9.122927280189552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bg2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[493748 band intensity.xlsx]Alix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[493748 band intensity.xlsx]Alix'!$C$42:$C$43</c:f>
              <c:numCache>
                <c:formatCode>#,##0.000_ </c:formatCode>
                <c:ptCount val="2"/>
                <c:pt idx="0">
                  <c:v>1</c:v>
                </c:pt>
                <c:pt idx="1">
                  <c:v>0.335808027237618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827-495D-B975-288A647AE4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545554160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3748 band intensity.xlsx]Alix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3748 band intensity.xlsx]Alix'!$D$42:$D$43</c:f>
              <c:numCache>
                <c:formatCode>#,##0.000_ </c:formatCode>
                <c:ptCount val="2"/>
                <c:pt idx="0">
                  <c:v>1.3528150752252315</c:v>
                </c:pt>
                <c:pt idx="1">
                  <c:v>0.219553804400464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827-495D-B975-288A647AE488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3748 band intensity.xlsx]Alix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3748 band intensity.xlsx]Alix'!$E$42:$E$43</c:f>
              <c:numCache>
                <c:formatCode>#,##0.000_ </c:formatCode>
                <c:ptCount val="2"/>
                <c:pt idx="0">
                  <c:v>0.95177652940841773</c:v>
                </c:pt>
                <c:pt idx="1">
                  <c:v>0.559211355112856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2827-495D-B975-288A647AE488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[493748 band intensity.xlsx]Alix'!$B$42:$B$43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493748 band intensity.xlsx]Alix'!$F$42:$F$43</c:f>
              <c:numCache>
                <c:formatCode>#,##0.000_ </c:formatCode>
                <c:ptCount val="2"/>
                <c:pt idx="0">
                  <c:v>0.69540839536635102</c:v>
                </c:pt>
                <c:pt idx="1">
                  <c:v>0.228658922199534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2827-495D-B975-288A647AE4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5554160"/>
        <c:axId val="1"/>
      </c:scatterChart>
      <c:catAx>
        <c:axId val="54555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band intensity (/cell)</a:t>
                </a:r>
              </a:p>
            </c:rich>
          </c:tx>
          <c:layout>
            <c:manualLayout>
              <c:xMode val="edge"/>
              <c:yMode val="edge"/>
              <c:x val="5.6444444444444443E-2"/>
              <c:y val="0.12760476190476192"/>
            </c:manualLayout>
          </c:layout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455541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Tunicamycin i.p. mouse bw</a:t>
            </a:r>
            <a:endParaRPr lang="ja-JP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[211201_TMipまとめ.xlsx]body weight'!$A$2</c:f>
              <c:strCache>
                <c:ptCount val="1"/>
                <c:pt idx="0">
                  <c:v>Ctrl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2:$F$2</c:f>
              <c:numCache>
                <c:formatCode>General</c:formatCode>
                <c:ptCount val="2"/>
                <c:pt idx="0">
                  <c:v>22.3</c:v>
                </c:pt>
                <c:pt idx="1">
                  <c:v>21.8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0-A1C6-4037-B71E-1D842A70F1A5}"/>
            </c:ext>
          </c:extLst>
        </c:ser>
        <c:ser>
          <c:idx val="1"/>
          <c:order val="1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3:$F$3</c:f>
              <c:numCache>
                <c:formatCode>General</c:formatCode>
                <c:ptCount val="2"/>
                <c:pt idx="0">
                  <c:v>22.1</c:v>
                </c:pt>
                <c:pt idx="1">
                  <c:v>21.6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1-A1C6-4037-B71E-1D842A70F1A5}"/>
            </c:ext>
          </c:extLst>
        </c:ser>
        <c:ser>
          <c:idx val="2"/>
          <c:order val="2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4:$F$4</c:f>
              <c:numCache>
                <c:formatCode>General</c:formatCode>
                <c:ptCount val="2"/>
                <c:pt idx="0">
                  <c:v>23.3</c:v>
                </c:pt>
                <c:pt idx="1">
                  <c:v>22.1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2-A1C6-4037-B71E-1D842A70F1A5}"/>
            </c:ext>
          </c:extLst>
        </c:ser>
        <c:ser>
          <c:idx val="3"/>
          <c:order val="3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5:$F$5</c:f>
              <c:numCache>
                <c:formatCode>General</c:formatCode>
                <c:ptCount val="2"/>
                <c:pt idx="0">
                  <c:v>22.1</c:v>
                </c:pt>
                <c:pt idx="1">
                  <c:v>21.7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3-A1C6-4037-B71E-1D842A70F1A5}"/>
            </c:ext>
          </c:extLst>
        </c:ser>
        <c:ser>
          <c:idx val="4"/>
          <c:order val="4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6:$F$6</c:f>
              <c:numCache>
                <c:formatCode>General</c:formatCode>
                <c:ptCount val="2"/>
                <c:pt idx="0">
                  <c:v>24</c:v>
                </c:pt>
                <c:pt idx="1">
                  <c:v>23.2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4-A1C6-4037-B71E-1D842A70F1A5}"/>
            </c:ext>
          </c:extLst>
        </c:ser>
        <c:ser>
          <c:idx val="5"/>
          <c:order val="5"/>
          <c:tx>
            <c:strRef>
              <c:f>'[211201_TMipまとめ.xlsx]body weight'!$A$8</c:f>
              <c:strCache>
                <c:ptCount val="1"/>
                <c:pt idx="0">
                  <c:v>TM
1mg/kg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8:$F$8</c:f>
              <c:numCache>
                <c:formatCode>General</c:formatCode>
                <c:ptCount val="2"/>
                <c:pt idx="0">
                  <c:v>22.6</c:v>
                </c:pt>
                <c:pt idx="1">
                  <c:v>20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5-A1C6-4037-B71E-1D842A70F1A5}"/>
            </c:ext>
          </c:extLst>
        </c:ser>
        <c:ser>
          <c:idx val="6"/>
          <c:order val="6"/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9:$F$9</c:f>
              <c:numCache>
                <c:formatCode>General</c:formatCode>
                <c:ptCount val="2"/>
                <c:pt idx="0">
                  <c:v>21.6</c:v>
                </c:pt>
                <c:pt idx="1">
                  <c:v>19.399999999999999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6-A1C6-4037-B71E-1D842A70F1A5}"/>
            </c:ext>
          </c:extLst>
        </c:ser>
        <c:ser>
          <c:idx val="7"/>
          <c:order val="7"/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10:$F$10</c:f>
              <c:numCache>
                <c:formatCode>General</c:formatCode>
                <c:ptCount val="2"/>
                <c:pt idx="0">
                  <c:v>24.1</c:v>
                </c:pt>
                <c:pt idx="1">
                  <c:v>20.8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7-A1C6-4037-B71E-1D842A70F1A5}"/>
            </c:ext>
          </c:extLst>
        </c:ser>
        <c:ser>
          <c:idx val="8"/>
          <c:order val="8"/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11:$F$11</c:f>
              <c:numCache>
                <c:formatCode>General</c:formatCode>
                <c:ptCount val="2"/>
                <c:pt idx="0">
                  <c:v>22.2</c:v>
                </c:pt>
                <c:pt idx="1">
                  <c:v>21.4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8-A1C6-4037-B71E-1D842A70F1A5}"/>
            </c:ext>
          </c:extLst>
        </c:ser>
        <c:ser>
          <c:idx val="9"/>
          <c:order val="9"/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strRef>
              <c:f>'[211201_TMipまとめ.xlsx]body weight'!$C$1:$F$1</c:f>
              <c:strCache>
                <c:ptCount val="2"/>
                <c:pt idx="0">
                  <c:v>Day1</c:v>
                </c:pt>
                <c:pt idx="1">
                  <c:v>Day2</c:v>
                </c:pt>
              </c:strCache>
              <c:extLst/>
            </c:strRef>
          </c:cat>
          <c:val>
            <c:numRef>
              <c:f>'[211201_TMipまとめ.xlsx]body weight'!$C$12:$F$12</c:f>
              <c:numCache>
                <c:formatCode>General</c:formatCode>
                <c:ptCount val="2"/>
                <c:pt idx="0">
                  <c:v>22.6</c:v>
                </c:pt>
                <c:pt idx="1">
                  <c:v>22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9-A1C6-4037-B71E-1D842A70F1A5}"/>
            </c:ext>
          </c:extLst>
        </c:ser>
        <c:ser>
          <c:idx val="10"/>
          <c:order val="10"/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strLit>
              <c:ptCount val="4"/>
              <c:pt idx="0">
                <c:v>Day1</c:v>
              </c:pt>
              <c:pt idx="1">
                <c:v>Day2</c:v>
              </c:pt>
              <c:pt idx="3">
                <c:v>Day1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'[211201_TMipまとめ.xlsx]body weight'!$C$13:$D$13</c:f>
              <c:numCache>
                <c:formatCode>General</c:formatCode>
                <c:ptCount val="2"/>
                <c:pt idx="0">
                  <c:v>23.5</c:v>
                </c:pt>
                <c:pt idx="1">
                  <c:v>22.2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A-A1C6-4037-B71E-1D842A70F1A5}"/>
            </c:ext>
          </c:extLst>
        </c:ser>
        <c:ser>
          <c:idx val="11"/>
          <c:order val="11"/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strLit>
              <c:ptCount val="4"/>
              <c:pt idx="0">
                <c:v>Day1</c:v>
              </c:pt>
              <c:pt idx="1">
                <c:v>Day2</c:v>
              </c:pt>
              <c:pt idx="3">
                <c:v>Day1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'[211201_TMipまとめ.xlsx]body weight'!$C$14:$D$14</c:f>
              <c:numCache>
                <c:formatCode>General</c:formatCode>
                <c:ptCount val="2"/>
                <c:pt idx="0">
                  <c:v>22.2</c:v>
                </c:pt>
                <c:pt idx="1">
                  <c:v>21.6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B-A1C6-4037-B71E-1D842A70F1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74232992"/>
        <c:axId val="774233976"/>
      </c:lineChart>
      <c:catAx>
        <c:axId val="774232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4233976"/>
        <c:crosses val="autoZero"/>
        <c:auto val="1"/>
        <c:lblAlgn val="ctr"/>
        <c:lblOffset val="100"/>
        <c:noMultiLvlLbl val="0"/>
      </c:catAx>
      <c:valAx>
        <c:axId val="774233976"/>
        <c:scaling>
          <c:orientation val="minMax"/>
          <c:max val="2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Body weight (g)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42329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1"/>
        <c:delete val="1"/>
      </c:legendEntry>
      <c:legendEntry>
        <c:idx val="2"/>
        <c:delete val="1"/>
      </c:legendEntry>
      <c:legendEntry>
        <c:idx val="3"/>
        <c:delete val="1"/>
      </c:legendEntry>
      <c:legendEntry>
        <c:idx val="4"/>
        <c:delete val="1"/>
      </c:legendEntry>
      <c:legendEntry>
        <c:idx val="6"/>
        <c:delete val="1"/>
      </c:legendEntry>
      <c:legendEntry>
        <c:idx val="7"/>
        <c:delete val="1"/>
      </c:legendEntry>
      <c:legendEntry>
        <c:idx val="8"/>
        <c:delete val="1"/>
      </c:legendEntry>
      <c:legendEntry>
        <c:idx val="9"/>
        <c:delete val="1"/>
      </c:legendEntry>
      <c:legendEntry>
        <c:idx val="10"/>
        <c:delete val="1"/>
      </c:legendEntry>
      <c:legendEntry>
        <c:idx val="11"/>
        <c:delete val="1"/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T-cadherin/actin</a:t>
            </a:r>
            <a:endParaRPr lang="ja-JP"/>
          </a:p>
        </c:rich>
      </c:tx>
      <c:layout>
        <c:manualLayout>
          <c:xMode val="edge"/>
          <c:yMode val="edge"/>
          <c:x val="0.26801527777777773"/>
          <c:y val="1.8814814814814815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53F-433B-B908-87A3804A493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53F-433B-B908-87A3804A493B}"/>
              </c:ext>
            </c:extLst>
          </c:dPt>
          <c:errBars>
            <c:errBarType val="plus"/>
            <c:errValType val="cust"/>
            <c:noEndCap val="0"/>
            <c:plus>
              <c:numRef>
                <c:f>'血管T-cad'!$K$24:$K$25</c:f>
                <c:numCache>
                  <c:formatCode>General</c:formatCode>
                  <c:ptCount val="2"/>
                  <c:pt idx="0">
                    <c:v>0.24009836314248761</c:v>
                  </c:pt>
                  <c:pt idx="1">
                    <c:v>0.203443442728847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血管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血管T-cad'!$C$24:$C$25</c:f>
              <c:numCache>
                <c:formatCode>General</c:formatCode>
                <c:ptCount val="2"/>
                <c:pt idx="0">
                  <c:v>1</c:v>
                </c:pt>
                <c:pt idx="1">
                  <c:v>1.09588648962460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53F-433B-B908-87A3804A49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67963976"/>
        <c:axId val="76796430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血管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血管T-cad'!$D$24:$D$25</c:f>
              <c:numCache>
                <c:formatCode>General</c:formatCode>
                <c:ptCount val="2"/>
                <c:pt idx="0">
                  <c:v>0.61254134731644228</c:v>
                </c:pt>
                <c:pt idx="1">
                  <c:v>0.71384598597753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53F-433B-B908-87A3804A493B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血管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血管T-cad'!$E$24:$E$25</c:f>
              <c:numCache>
                <c:formatCode>General</c:formatCode>
                <c:ptCount val="2"/>
                <c:pt idx="0">
                  <c:v>2.3304154406097037</c:v>
                </c:pt>
                <c:pt idx="1">
                  <c:v>1.24898382393144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E53F-433B-B908-87A3804A493B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血管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血管T-cad'!$F$24:$F$25</c:f>
              <c:numCache>
                <c:formatCode>General</c:formatCode>
                <c:ptCount val="2"/>
                <c:pt idx="0">
                  <c:v>0.7602928119790523</c:v>
                </c:pt>
                <c:pt idx="1">
                  <c:v>2.12259385662886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E53F-433B-B908-87A3804A493B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血管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血管T-cad'!$G$24:$G$25</c:f>
              <c:numCache>
                <c:formatCode>General</c:formatCode>
                <c:ptCount val="2"/>
                <c:pt idx="0">
                  <c:v>1.1052683165839388</c:v>
                </c:pt>
                <c:pt idx="1">
                  <c:v>0.666695847019261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E53F-433B-B908-87A3804A493B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血管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血管T-cad'!$H$24:$H$25</c:f>
              <c:numCache>
                <c:formatCode>General</c:formatCode>
                <c:ptCount val="2"/>
                <c:pt idx="0">
                  <c:v>1.5383879116002461</c:v>
                </c:pt>
                <c:pt idx="1">
                  <c:v>1.52169159288738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E53F-433B-B908-87A3804A493B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血管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血管T-cad'!$I$24:$I$25</c:f>
              <c:numCache>
                <c:formatCode>General</c:formatCode>
                <c:ptCount val="2"/>
                <c:pt idx="0">
                  <c:v>0.83175231549006345</c:v>
                </c:pt>
                <c:pt idx="1">
                  <c:v>1.17184154514624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E53F-433B-B908-87A3804A493B}"/>
            </c:ext>
          </c:extLst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血管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血管T-cad'!$J$24:$J$25</c:f>
              <c:numCache>
                <c:formatCode>General</c:formatCode>
                <c:ptCount val="2"/>
                <c:pt idx="1">
                  <c:v>0.433002722248297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E53F-433B-B908-87A3804A49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7963976"/>
        <c:axId val="767964304"/>
      </c:scatterChart>
      <c:catAx>
        <c:axId val="767963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4304"/>
        <c:crosses val="autoZero"/>
        <c:auto val="1"/>
        <c:lblAlgn val="ctr"/>
        <c:lblOffset val="100"/>
        <c:noMultiLvlLbl val="0"/>
      </c:catAx>
      <c:valAx>
        <c:axId val="767964304"/>
        <c:scaling>
          <c:orientation val="minMax"/>
          <c:max val="3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rbitrary unit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39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BiP/actin</a:t>
            </a:r>
            <a:endParaRPr lang="ja-JP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DFD-4798-9594-978C8C42E82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DFD-4798-9594-978C8C42E82B}"/>
              </c:ext>
            </c:extLst>
          </c:dPt>
          <c:errBars>
            <c:errBarType val="plus"/>
            <c:errValType val="cust"/>
            <c:noEndCap val="0"/>
            <c:plus>
              <c:numRef>
                <c:f>血管Bip!$K$24:$K$25</c:f>
                <c:numCache>
                  <c:formatCode>General</c:formatCode>
                  <c:ptCount val="2"/>
                  <c:pt idx="0">
                    <c:v>0.20232827126943412</c:v>
                  </c:pt>
                  <c:pt idx="1">
                    <c:v>0.134090218868396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血管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血管Bip!$C$24:$C$25</c:f>
              <c:numCache>
                <c:formatCode>General</c:formatCode>
                <c:ptCount val="2"/>
                <c:pt idx="0">
                  <c:v>1</c:v>
                </c:pt>
                <c:pt idx="1">
                  <c:v>1.0904921625410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DFD-4798-9594-978C8C42E8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67963976"/>
        <c:axId val="76796430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血管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血管Bip!$D$24:$D$25</c:f>
              <c:numCache>
                <c:formatCode>General</c:formatCode>
                <c:ptCount val="2"/>
                <c:pt idx="0">
                  <c:v>1.1406849223992563</c:v>
                </c:pt>
                <c:pt idx="1">
                  <c:v>1.05660677263645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6DFD-4798-9594-978C8C42E82B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血管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血管Bip!$E$24:$E$25</c:f>
              <c:numCache>
                <c:formatCode>General</c:formatCode>
                <c:ptCount val="2"/>
                <c:pt idx="0">
                  <c:v>1.9137972956920095</c:v>
                </c:pt>
                <c:pt idx="1">
                  <c:v>0.944225443647984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6DFD-4798-9594-978C8C42E82B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血管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血管Bip!$F$24:$F$25</c:f>
              <c:numCache>
                <c:formatCode>General</c:formatCode>
                <c:ptCount val="2"/>
                <c:pt idx="0">
                  <c:v>0.63556912554275569</c:v>
                </c:pt>
                <c:pt idx="1">
                  <c:v>1.14982822516387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6DFD-4798-9594-978C8C42E82B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血管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血管Bip!$G$24:$G$25</c:f>
              <c:numCache>
                <c:formatCode>General</c:formatCode>
                <c:ptCount val="2"/>
                <c:pt idx="0">
                  <c:v>1.2808907671511702</c:v>
                </c:pt>
                <c:pt idx="1">
                  <c:v>1.53541679207844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6DFD-4798-9594-978C8C42E82B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血管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血管Bip!$H$24:$H$25</c:f>
              <c:numCache>
                <c:formatCode>General</c:formatCode>
                <c:ptCount val="2"/>
                <c:pt idx="0">
                  <c:v>1.6860711806657598</c:v>
                </c:pt>
                <c:pt idx="1">
                  <c:v>0.678705031614758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6DFD-4798-9594-978C8C42E82B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血管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血管Bip!$I$24:$I$25</c:f>
              <c:numCache>
                <c:formatCode>General</c:formatCode>
                <c:ptCount val="2"/>
                <c:pt idx="0">
                  <c:v>0.56801025242420278</c:v>
                </c:pt>
                <c:pt idx="1">
                  <c:v>1.15172141397427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6DFD-4798-9594-978C8C42E82B}"/>
            </c:ext>
          </c:extLst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血管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血管Bip!$J$24:$J$25</c:f>
              <c:numCache>
                <c:formatCode>General</c:formatCode>
                <c:ptCount val="2"/>
                <c:pt idx="1">
                  <c:v>0.334790559024279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6DFD-4798-9594-978C8C42E8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7963976"/>
        <c:axId val="767964304"/>
      </c:scatterChart>
      <c:catAx>
        <c:axId val="767963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67964304"/>
        <c:crosses val="autoZero"/>
        <c:auto val="1"/>
        <c:lblAlgn val="ctr"/>
        <c:lblOffset val="100"/>
        <c:noMultiLvlLbl val="0"/>
      </c:catAx>
      <c:valAx>
        <c:axId val="7679643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Arbitrary unit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679639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BiP/actin</a:t>
            </a:r>
            <a:endParaRPr lang="ja-JP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D1D-4CC9-AFF7-432D365C55E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D1D-4CC9-AFF7-432D365C55EA}"/>
              </c:ext>
            </c:extLst>
          </c:dPt>
          <c:errBars>
            <c:errBarType val="plus"/>
            <c:errValType val="cust"/>
            <c:noEndCap val="0"/>
            <c:plus>
              <c:numRef>
                <c:f>心Bip!$K$24:$K$25</c:f>
                <c:numCache>
                  <c:formatCode>General</c:formatCode>
                  <c:ptCount val="2"/>
                  <c:pt idx="0">
                    <c:v>0.14632135182871267</c:v>
                  </c:pt>
                  <c:pt idx="1">
                    <c:v>0.554530135325968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心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心Bip!$C$24:$C$25</c:f>
              <c:numCache>
                <c:formatCode>General</c:formatCode>
                <c:ptCount val="2"/>
                <c:pt idx="0">
                  <c:v>1</c:v>
                </c:pt>
                <c:pt idx="1">
                  <c:v>1.85230948801557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D1D-4CC9-AFF7-432D365C55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67963976"/>
        <c:axId val="76796430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心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心Bip!$D$24:$D$25</c:f>
              <c:numCache>
                <c:formatCode>General</c:formatCode>
                <c:ptCount val="2"/>
                <c:pt idx="0">
                  <c:v>0.86662907372265796</c:v>
                </c:pt>
                <c:pt idx="1">
                  <c:v>1.44874730525492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D1D-4CC9-AFF7-432D365C55EA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心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心Bip!$E$24:$E$25</c:f>
              <c:numCache>
                <c:formatCode>General</c:formatCode>
                <c:ptCount val="2"/>
                <c:pt idx="0">
                  <c:v>1.4042116956696733</c:v>
                </c:pt>
                <c:pt idx="1">
                  <c:v>1.24656090316771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5D1D-4CC9-AFF7-432D365C55EA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心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心Bip!$F$24:$F$25</c:f>
              <c:numCache>
                <c:formatCode>General</c:formatCode>
                <c:ptCount val="2"/>
                <c:pt idx="0">
                  <c:v>0.40491010907113867</c:v>
                </c:pt>
                <c:pt idx="1">
                  <c:v>1.110091053794555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5D1D-4CC9-AFF7-432D365C55EA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心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心Bip!$G$24:$G$25</c:f>
              <c:numCache>
                <c:formatCode>General</c:formatCode>
                <c:ptCount val="2"/>
                <c:pt idx="0">
                  <c:v>1.2265563742592884</c:v>
                </c:pt>
                <c:pt idx="1">
                  <c:v>1.73712500115505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5D1D-4CC9-AFF7-432D365C55EA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心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心Bip!$H$24:$H$25</c:f>
              <c:numCache>
                <c:formatCode>General</c:formatCode>
                <c:ptCount val="2"/>
                <c:pt idx="0">
                  <c:v>1.348305188590353</c:v>
                </c:pt>
                <c:pt idx="1">
                  <c:v>0.870183092627265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5D1D-4CC9-AFF7-432D365C55EA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心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心Bip!$I$24:$I$25</c:f>
              <c:numCache>
                <c:formatCode>General</c:formatCode>
                <c:ptCount val="2"/>
                <c:pt idx="0">
                  <c:v>0.74938755868688867</c:v>
                </c:pt>
                <c:pt idx="1">
                  <c:v>1.1611665723656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5D1D-4CC9-AFF7-432D365C55EA}"/>
            </c:ext>
          </c:extLst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心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心Bip!$J$24:$J$25</c:f>
              <c:numCache>
                <c:formatCode>General</c:formatCode>
                <c:ptCount val="2"/>
                <c:pt idx="1">
                  <c:v>5.39229248774384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5D1D-4CC9-AFF7-432D365C55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7963976"/>
        <c:axId val="767964304"/>
      </c:scatterChart>
      <c:catAx>
        <c:axId val="767963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4304"/>
        <c:crosses val="autoZero"/>
        <c:auto val="1"/>
        <c:lblAlgn val="ctr"/>
        <c:lblOffset val="100"/>
        <c:noMultiLvlLbl val="0"/>
      </c:catAx>
      <c:valAx>
        <c:axId val="767964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rbitrary unit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39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/>
              <a:t>T-cadherin mRNA</a:t>
            </a:r>
            <a:endParaRPr lang="ja-JP" alt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smGrid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D12-44A8-A691-4D0E4BED0CF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BD12-44A8-A691-4D0E4BED0CF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BD12-44A8-A691-4D0E4BED0CF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BD12-44A8-A691-4D0E4BED0CF7}"/>
              </c:ext>
            </c:extLst>
          </c:dPt>
          <c:errBars>
            <c:errBarType val="plus"/>
            <c:errValType val="cust"/>
            <c:noEndCap val="0"/>
            <c:plus>
              <c:numRef>
                <c:f>'[210614_protocol&amp;result_2800.xlsx]解析2'!$H$3:$H$6</c:f>
                <c:numCache>
                  <c:formatCode>General</c:formatCode>
                  <c:ptCount val="4"/>
                  <c:pt idx="0">
                    <c:v>0.12431854619379544</c:v>
                  </c:pt>
                  <c:pt idx="1">
                    <c:v>9.0029538450699872E-2</c:v>
                  </c:pt>
                  <c:pt idx="2">
                    <c:v>4.8395529345475544E-2</c:v>
                  </c:pt>
                  <c:pt idx="3">
                    <c:v>5.701228722751669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10614_protocol&amp;result_2800.xlsx]解析2'!$B$3:$B$6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'[210614_protocol&amp;result_2800.xlsx]解析2'!$D$3:$D$6</c:f>
              <c:numCache>
                <c:formatCode>General</c:formatCode>
                <c:ptCount val="4"/>
                <c:pt idx="0">
                  <c:v>1</c:v>
                </c:pt>
                <c:pt idx="1">
                  <c:v>0.66020996201226512</c:v>
                </c:pt>
                <c:pt idx="2">
                  <c:v>0.53595210752442002</c:v>
                </c:pt>
                <c:pt idx="3">
                  <c:v>0.581849058157501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D12-44A8-A691-4D0E4BED0C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577137512"/>
        <c:axId val="57713784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yVal>
            <c:numRef>
              <c:f>'[210614_protocol&amp;result_2800.xlsx]解析2'!$E$3:$E$6</c:f>
              <c:numCache>
                <c:formatCode>General</c:formatCode>
                <c:ptCount val="4"/>
                <c:pt idx="0">
                  <c:v>1.3033040074264872</c:v>
                </c:pt>
                <c:pt idx="1">
                  <c:v>0.87186317189952933</c:v>
                </c:pt>
                <c:pt idx="2">
                  <c:v>0.53669473664264211</c:v>
                </c:pt>
                <c:pt idx="3">
                  <c:v>0.487060754061097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BD12-44A8-A691-4D0E4BED0CF7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yVal>
            <c:numRef>
              <c:f>'[210614_protocol&amp;result_2800.xlsx]解析2'!$F$3:$F$6</c:f>
              <c:numCache>
                <c:formatCode>General</c:formatCode>
                <c:ptCount val="4"/>
                <c:pt idx="0">
                  <c:v>0.87186317189952933</c:v>
                </c:pt>
                <c:pt idx="1">
                  <c:v>0.60801281846552313</c:v>
                </c:pt>
                <c:pt idx="2">
                  <c:v>0.4329203865306761</c:v>
                </c:pt>
                <c:pt idx="3">
                  <c:v>0.718058676662867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BD12-44A8-A691-4D0E4BED0CF7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yVal>
            <c:numRef>
              <c:f>'[210614_protocol&amp;result_2800.xlsx]解析2'!$G$3:$G$6</c:f>
              <c:numCache>
                <c:formatCode>General</c:formatCode>
                <c:ptCount val="4"/>
                <c:pt idx="0">
                  <c:v>0.82483282067398367</c:v>
                </c:pt>
                <c:pt idx="1">
                  <c:v>0.500753895671743</c:v>
                </c:pt>
                <c:pt idx="2">
                  <c:v>0.63824119939994195</c:v>
                </c:pt>
                <c:pt idx="3">
                  <c:v>0.540427743748538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BD12-44A8-A691-4D0E4BED0C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7137512"/>
        <c:axId val="577137840"/>
      </c:scatterChart>
      <c:catAx>
        <c:axId val="577137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unicamycin </a:t>
                </a:r>
                <a:r>
                  <a:rPr lang="en-US" dirty="0"/>
                  <a:t>(</a:t>
                </a:r>
                <a:r>
                  <a:rPr lang="en-US" dirty="0" err="1"/>
                  <a:t>μmol</a:t>
                </a:r>
                <a:r>
                  <a:rPr lang="en-US" dirty="0"/>
                  <a:t>/L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137840"/>
        <c:crosses val="autoZero"/>
        <c:auto val="1"/>
        <c:lblAlgn val="ctr"/>
        <c:lblOffset val="100"/>
        <c:noMultiLvlLbl val="0"/>
      </c:catAx>
      <c:valAx>
        <c:axId val="5771378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i="1" dirty="0"/>
                  <a:t>Cdh13/Rplp0</a:t>
                </a:r>
                <a:r>
                  <a:rPr lang="en-US" dirty="0"/>
                  <a:t> (AU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137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T-cadherin/actin</a:t>
            </a:r>
            <a:endParaRPr lang="ja-JP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8ED-46BD-92A5-D54F981CF12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8ED-46BD-92A5-D54F981CF12B}"/>
              </c:ext>
            </c:extLst>
          </c:dPt>
          <c:errBars>
            <c:errBarType val="plus"/>
            <c:errValType val="cust"/>
            <c:noEndCap val="0"/>
            <c:plus>
              <c:numRef>
                <c:f>'心T-cad'!$K$24:$K$25</c:f>
                <c:numCache>
                  <c:formatCode>General</c:formatCode>
                  <c:ptCount val="2"/>
                  <c:pt idx="0">
                    <c:v>8.1431897411089763E-2</c:v>
                  </c:pt>
                  <c:pt idx="1">
                    <c:v>6.151773289028088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心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心T-cad'!$C$24:$C$25</c:f>
              <c:numCache>
                <c:formatCode>General</c:formatCode>
                <c:ptCount val="2"/>
                <c:pt idx="0">
                  <c:v>1</c:v>
                </c:pt>
                <c:pt idx="1">
                  <c:v>1.21736097230706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8ED-46BD-92A5-D54F981CF1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67963976"/>
        <c:axId val="76796430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心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心T-cad'!$D$24:$D$25</c:f>
              <c:numCache>
                <c:formatCode>General</c:formatCode>
                <c:ptCount val="2"/>
                <c:pt idx="0">
                  <c:v>1.0753724267071798</c:v>
                </c:pt>
                <c:pt idx="1">
                  <c:v>1.2813477169867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8ED-46BD-92A5-D54F981CF12B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心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心T-cad'!$E$24:$E$25</c:f>
              <c:numCache>
                <c:formatCode>General</c:formatCode>
                <c:ptCount val="2"/>
                <c:pt idx="0">
                  <c:v>0.79323677303111484</c:v>
                </c:pt>
                <c:pt idx="1">
                  <c:v>1.30373391201624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A8ED-46BD-92A5-D54F981CF12B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心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心T-cad'!$F$24:$F$25</c:f>
              <c:numCache>
                <c:formatCode>General</c:formatCode>
                <c:ptCount val="2"/>
                <c:pt idx="0">
                  <c:v>1.0929579126194657</c:v>
                </c:pt>
                <c:pt idx="1">
                  <c:v>1.36687200739192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A8ED-46BD-92A5-D54F981CF12B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心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心T-cad'!$G$24:$G$25</c:f>
              <c:numCache>
                <c:formatCode>General</c:formatCode>
                <c:ptCount val="2"/>
                <c:pt idx="0">
                  <c:v>1.3004798629596721</c:v>
                </c:pt>
                <c:pt idx="1">
                  <c:v>1.10403296394014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A8ED-46BD-92A5-D54F981CF12B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心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心T-cad'!$H$24:$H$25</c:f>
              <c:numCache>
                <c:formatCode>General</c:formatCode>
                <c:ptCount val="2"/>
                <c:pt idx="0">
                  <c:v>0.70011876741782431</c:v>
                </c:pt>
                <c:pt idx="1">
                  <c:v>1.41251213682854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A8ED-46BD-92A5-D54F981CF12B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'心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心T-cad'!$I$24:$I$25</c:f>
              <c:numCache>
                <c:formatCode>General</c:formatCode>
                <c:ptCount val="2"/>
                <c:pt idx="0">
                  <c:v>1.0378342572647437</c:v>
                </c:pt>
                <c:pt idx="1">
                  <c:v>0.908707663959309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A8ED-46BD-92A5-D54F981CF1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7963976"/>
        <c:axId val="767964304"/>
      </c:scatterChart>
      <c:catAx>
        <c:axId val="767963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4304"/>
        <c:crosses val="autoZero"/>
        <c:auto val="1"/>
        <c:lblAlgn val="ctr"/>
        <c:lblOffset val="100"/>
        <c:noMultiLvlLbl val="0"/>
      </c:catAx>
      <c:valAx>
        <c:axId val="767964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rbitrary unit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39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T-cadherin/actin</a:t>
            </a:r>
            <a:endParaRPr lang="ja-JP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356-4A63-AA8A-53101592160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356-4A63-AA8A-53101592160F}"/>
              </c:ext>
            </c:extLst>
          </c:dPt>
          <c:errBars>
            <c:errBarType val="plus"/>
            <c:errValType val="cust"/>
            <c:noEndCap val="0"/>
            <c:plus>
              <c:numRef>
                <c:f>'[WBバンド定量.xlsx]筋T-cad'!$K$24:$K$25</c:f>
                <c:numCache>
                  <c:formatCode>General</c:formatCode>
                  <c:ptCount val="2"/>
                  <c:pt idx="0">
                    <c:v>0.2364209346177357</c:v>
                  </c:pt>
                  <c:pt idx="1">
                    <c:v>0.104101843649897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WBバンド定量.xlsx]筋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'[WBバンド定量.xlsx]筋T-cad'!$C$24:$C$25</c:f>
              <c:numCache>
                <c:formatCode>General</c:formatCode>
                <c:ptCount val="2"/>
                <c:pt idx="0">
                  <c:v>1</c:v>
                </c:pt>
                <c:pt idx="1">
                  <c:v>0.889944019103962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356-4A63-AA8A-5310159216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67963976"/>
        <c:axId val="76796430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.xlsx]筋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WBバンド定量.xlsx]筋T-cad'!$D$24:$D$25</c:f>
              <c:numCache>
                <c:formatCode>General</c:formatCode>
                <c:ptCount val="2"/>
                <c:pt idx="0">
                  <c:v>1.6919026089609135</c:v>
                </c:pt>
                <c:pt idx="1">
                  <c:v>0.882073284328589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6356-4A63-AA8A-53101592160F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.xlsx]筋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WBバンド定量.xlsx]筋T-cad'!$E$24:$E$25</c:f>
              <c:numCache>
                <c:formatCode>General</c:formatCode>
                <c:ptCount val="2"/>
                <c:pt idx="0">
                  <c:v>1.7480685561364486</c:v>
                </c:pt>
                <c:pt idx="1">
                  <c:v>0.791844523350617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6356-4A63-AA8A-53101592160F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.xlsx]筋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WBバンド定量.xlsx]筋T-cad'!$F$24:$F$25</c:f>
              <c:numCache>
                <c:formatCode>General</c:formatCode>
                <c:ptCount val="2"/>
                <c:pt idx="0">
                  <c:v>0.27166011463252143</c:v>
                </c:pt>
                <c:pt idx="1">
                  <c:v>1.18964979205104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6356-4A63-AA8A-53101592160F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.xlsx]筋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WBバンド定量.xlsx]筋T-cad'!$G$24:$G$25</c:f>
              <c:numCache>
                <c:formatCode>General</c:formatCode>
                <c:ptCount val="2"/>
                <c:pt idx="0">
                  <c:v>0.87835933015811563</c:v>
                </c:pt>
                <c:pt idx="1">
                  <c:v>0.843618282125499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6356-4A63-AA8A-53101592160F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.xlsx]筋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WBバンド定量.xlsx]筋T-cad'!$H$24:$H$25</c:f>
              <c:numCache>
                <c:formatCode>General</c:formatCode>
                <c:ptCount val="2"/>
                <c:pt idx="0">
                  <c:v>0.34824201924954623</c:v>
                </c:pt>
                <c:pt idx="1">
                  <c:v>0.513848909578267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6356-4A63-AA8A-53101592160F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.xlsx]筋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WBバンド定量.xlsx]筋T-cad'!$I$24:$I$25</c:f>
              <c:numCache>
                <c:formatCode>General</c:formatCode>
                <c:ptCount val="2"/>
                <c:pt idx="0">
                  <c:v>1.0617673708624542</c:v>
                </c:pt>
                <c:pt idx="1">
                  <c:v>1.36606795823559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6356-4A63-AA8A-53101592160F}"/>
            </c:ext>
          </c:extLst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WBバンド定量.xlsx]筋T-cad'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'[WBバンド定量.xlsx]筋T-cad'!$J$24:$J$25</c:f>
              <c:numCache>
                <c:formatCode>General</c:formatCode>
                <c:ptCount val="2"/>
                <c:pt idx="1">
                  <c:v>0.642505384058126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6356-4A63-AA8A-5310159216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7963976"/>
        <c:axId val="767964304"/>
      </c:scatterChart>
      <c:catAx>
        <c:axId val="767963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4304"/>
        <c:crosses val="autoZero"/>
        <c:auto val="1"/>
        <c:lblAlgn val="ctr"/>
        <c:lblOffset val="100"/>
        <c:noMultiLvlLbl val="0"/>
      </c:catAx>
      <c:valAx>
        <c:axId val="767964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rbitrary unit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39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dirty="0" err="1"/>
              <a:t>BiP</a:t>
            </a:r>
            <a:r>
              <a:rPr lang="en-US" dirty="0"/>
              <a:t>/actin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415-4871-94E1-35A6CD6D35A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415-4871-94E1-35A6CD6D35A9}"/>
              </c:ext>
            </c:extLst>
          </c:dPt>
          <c:errBars>
            <c:errBarType val="plus"/>
            <c:errValType val="cust"/>
            <c:noEndCap val="0"/>
            <c:plus>
              <c:numRef>
                <c:f>[WBバンド定量.xlsx]筋Bip!$K$24:$K$25</c:f>
                <c:numCache>
                  <c:formatCode>General</c:formatCode>
                  <c:ptCount val="2"/>
                  <c:pt idx="0">
                    <c:v>0.28145621299077961</c:v>
                  </c:pt>
                  <c:pt idx="1">
                    <c:v>8.74066180726838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WBバンド定量.xlsx]筋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cat>
          <c:val>
            <c:numRef>
              <c:f>[WBバンド定量.xlsx]筋Bip!$C$24:$C$25</c:f>
              <c:numCache>
                <c:formatCode>General</c:formatCode>
                <c:ptCount val="2"/>
                <c:pt idx="0">
                  <c:v>1</c:v>
                </c:pt>
                <c:pt idx="1">
                  <c:v>0.756040110260305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415-4871-94E1-35A6CD6D35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67963976"/>
        <c:axId val="76796430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[WBバンド定量.xlsx]筋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[WBバンド定量.xlsx]筋Bip!$D$24:$D$25</c:f>
              <c:numCache>
                <c:formatCode>General</c:formatCode>
                <c:ptCount val="2"/>
                <c:pt idx="0">
                  <c:v>1.3950479460094898</c:v>
                </c:pt>
                <c:pt idx="1">
                  <c:v>1.15673833424462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415-4871-94E1-35A6CD6D35A9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[WBバンド定量.xlsx]筋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[WBバンド定量.xlsx]筋Bip!$E$24:$E$25</c:f>
              <c:numCache>
                <c:formatCode>General</c:formatCode>
                <c:ptCount val="2"/>
                <c:pt idx="0">
                  <c:v>2.2735677704864266</c:v>
                </c:pt>
                <c:pt idx="1">
                  <c:v>0.644278229484711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8415-4871-94E1-35A6CD6D35A9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[WBバンド定量.xlsx]筋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[WBバンド定量.xlsx]筋Bip!$F$24:$F$25</c:f>
              <c:numCache>
                <c:formatCode>General</c:formatCode>
                <c:ptCount val="2"/>
                <c:pt idx="0">
                  <c:v>0.3413082116687684</c:v>
                </c:pt>
                <c:pt idx="1">
                  <c:v>0.98882461588028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8415-4871-94E1-35A6CD6D35A9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[WBバンド定量.xlsx]筋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[WBバンド定量.xlsx]筋Bip!$G$24:$G$25</c:f>
              <c:numCache>
                <c:formatCode>General</c:formatCode>
                <c:ptCount val="2"/>
                <c:pt idx="0">
                  <c:v>0.68703439601604166</c:v>
                </c:pt>
                <c:pt idx="1">
                  <c:v>0.461445725611332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8415-4871-94E1-35A6CD6D35A9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[WBバンド定量.xlsx]筋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[WBバンド定量.xlsx]筋Bip!$H$24:$H$25</c:f>
              <c:numCache>
                <c:formatCode>General</c:formatCode>
                <c:ptCount val="2"/>
                <c:pt idx="0">
                  <c:v>0.2648051450954762</c:v>
                </c:pt>
                <c:pt idx="1">
                  <c:v>0.705116359748004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8415-4871-94E1-35A6CD6D35A9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[WBバンド定量.xlsx]筋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[WBバンド定量.xlsx]筋Bip!$I$24:$I$25</c:f>
              <c:numCache>
                <c:formatCode>General</c:formatCode>
                <c:ptCount val="2"/>
                <c:pt idx="0">
                  <c:v>1.0382365307237973</c:v>
                </c:pt>
                <c:pt idx="1">
                  <c:v>0.813222507718060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8415-4871-94E1-35A6CD6D35A9}"/>
            </c:ext>
          </c:extLst>
        </c:ser>
        <c:ser>
          <c:idx val="7"/>
          <c:order val="7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[WBバンド定量.xlsx]筋Bip!$B$24:$B$25</c:f>
              <c:strCache>
                <c:ptCount val="2"/>
                <c:pt idx="0">
                  <c:v>-</c:v>
                </c:pt>
                <c:pt idx="1">
                  <c:v>+</c:v>
                </c:pt>
              </c:strCache>
            </c:strRef>
          </c:xVal>
          <c:yVal>
            <c:numRef>
              <c:f>[WBバンド定量.xlsx]筋Bip!$J$24:$J$25</c:f>
              <c:numCache>
                <c:formatCode>General</c:formatCode>
                <c:ptCount val="2"/>
                <c:pt idx="1">
                  <c:v>0.522654999135124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8415-4871-94E1-35A6CD6D35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7963976"/>
        <c:axId val="767964304"/>
      </c:scatterChart>
      <c:catAx>
        <c:axId val="767963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4304"/>
        <c:crosses val="autoZero"/>
        <c:auto val="1"/>
        <c:lblAlgn val="ctr"/>
        <c:lblOffset val="100"/>
        <c:noMultiLvlLbl val="0"/>
      </c:catAx>
      <c:valAx>
        <c:axId val="767964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rbitrary units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7679639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ouse serum exosome</a:t>
            </a:r>
            <a:endParaRPr lang="en-US" altLang="ja-JP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[データまとめ (自動保存済み).xlsx]Ctrl粒子数'!$D$1</c:f>
              <c:strCache>
                <c:ptCount val="1"/>
                <c:pt idx="0">
                  <c:v>Ctrl (n=6)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x"/>
            <c:size val="2"/>
            <c:spPr>
              <a:noFill/>
              <a:ln w="12700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1"/>
            <c:plus>
              <c:numRef>
                <c:f>'[データまとめ (自動保存済み).xlsx]Ctrl粒子数'!$G$3:$G$1002</c:f>
                <c:numCache>
                  <c:formatCode>General</c:formatCode>
                  <c:ptCount val="100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3.2773069341672503E-12</c:v>
                  </c:pt>
                  <c:pt idx="10">
                    <c:v>2.3061913447323745E-11</c:v>
                  </c:pt>
                  <c:pt idx="11">
                    <c:v>1.4892827008204194E-10</c:v>
                  </c:pt>
                  <c:pt idx="12">
                    <c:v>2.0567090757377964E-9</c:v>
                  </c:pt>
                  <c:pt idx="13">
                    <c:v>2.1465104058033874E-8</c:v>
                  </c:pt>
                  <c:pt idx="14">
                    <c:v>1.4953901448191444E-7</c:v>
                  </c:pt>
                  <c:pt idx="15">
                    <c:v>7.3358480118651028E-7</c:v>
                  </c:pt>
                  <c:pt idx="16">
                    <c:v>2.6618419696021E-6</c:v>
                  </c:pt>
                  <c:pt idx="17">
                    <c:v>8.7952869184560058E-6</c:v>
                  </c:pt>
                  <c:pt idx="18">
                    <c:v>9.1762611720395468E-5</c:v>
                  </c:pt>
                  <c:pt idx="19">
                    <c:v>5.4523071314005066E-4</c:v>
                  </c:pt>
                  <c:pt idx="20">
                    <c:v>1.0967405960819103E-3</c:v>
                  </c:pt>
                  <c:pt idx="21">
                    <c:v>8.1337197550574738E-4</c:v>
                  </c:pt>
                  <c:pt idx="22">
                    <c:v>2.6407053080123726E-4</c:v>
                  </c:pt>
                  <c:pt idx="23">
                    <c:v>8.6792538108156455E-5</c:v>
                  </c:pt>
                  <c:pt idx="24">
                    <c:v>7.3748254809896855E-5</c:v>
                  </c:pt>
                  <c:pt idx="25">
                    <c:v>6.4192219198759768E-5</c:v>
                  </c:pt>
                  <c:pt idx="26">
                    <c:v>5.1972251021479505E-5</c:v>
                  </c:pt>
                  <c:pt idx="27">
                    <c:v>3.9794852685156809E-5</c:v>
                  </c:pt>
                  <c:pt idx="28">
                    <c:v>3.0011161374421453E-5</c:v>
                  </c:pt>
                  <c:pt idx="29">
                    <c:v>2.7076520823784802E-5</c:v>
                  </c:pt>
                  <c:pt idx="30">
                    <c:v>3.8173570822467482E-5</c:v>
                  </c:pt>
                  <c:pt idx="31">
                    <c:v>5.7265090793625197E-5</c:v>
                  </c:pt>
                  <c:pt idx="32">
                    <c:v>7.4700239279356731E-5</c:v>
                  </c:pt>
                  <c:pt idx="33">
                    <c:v>1.177666666556296E-4</c:v>
                  </c:pt>
                  <c:pt idx="34">
                    <c:v>5.3256852304895894E-4</c:v>
                  </c:pt>
                  <c:pt idx="35">
                    <c:v>1.8894495400290261E-3</c:v>
                  </c:pt>
                  <c:pt idx="36">
                    <c:v>3.688362807508362E-3</c:v>
                  </c:pt>
                  <c:pt idx="37">
                    <c:v>4.2200484318222755E-3</c:v>
                  </c:pt>
                  <c:pt idx="38">
                    <c:v>3.236408812361936E-3</c:v>
                  </c:pt>
                  <c:pt idx="39">
                    <c:v>2.0328402757137831E-3</c:v>
                  </c:pt>
                  <c:pt idx="40">
                    <c:v>1.5227693318833621E-3</c:v>
                  </c:pt>
                  <c:pt idx="41">
                    <c:v>1.6599626650607329E-3</c:v>
                  </c:pt>
                  <c:pt idx="42">
                    <c:v>1.8265532671234443E-3</c:v>
                  </c:pt>
                  <c:pt idx="43">
                    <c:v>1.7203741145622104E-3</c:v>
                  </c:pt>
                  <c:pt idx="44">
                    <c:v>1.4687575518930616E-3</c:v>
                  </c:pt>
                  <c:pt idx="45">
                    <c:v>1.3650805611767048E-3</c:v>
                  </c:pt>
                  <c:pt idx="46">
                    <c:v>1.5065176290396318E-3</c:v>
                  </c:pt>
                  <c:pt idx="47">
                    <c:v>1.8770303769290663E-3</c:v>
                  </c:pt>
                  <c:pt idx="48">
                    <c:v>2.7884934340398964E-3</c:v>
                  </c:pt>
                  <c:pt idx="49">
                    <c:v>4.6763244394893424E-3</c:v>
                  </c:pt>
                  <c:pt idx="50">
                    <c:v>7.1677092671331676E-3</c:v>
                  </c:pt>
                  <c:pt idx="51">
                    <c:v>9.0798317346020424E-3</c:v>
                  </c:pt>
                  <c:pt idx="52">
                    <c:v>9.4583727934086058E-3</c:v>
                  </c:pt>
                  <c:pt idx="53">
                    <c:v>8.5422863395661301E-3</c:v>
                  </c:pt>
                  <c:pt idx="54">
                    <c:v>7.6158310511878881E-3</c:v>
                  </c:pt>
                  <c:pt idx="55">
                    <c:v>7.8302101850017854E-3</c:v>
                  </c:pt>
                  <c:pt idx="56">
                    <c:v>9.2811445603806064E-3</c:v>
                  </c:pt>
                  <c:pt idx="57">
                    <c:v>1.159486781685856E-2</c:v>
                  </c:pt>
                  <c:pt idx="58">
                    <c:v>1.4536245362712702E-2</c:v>
                  </c:pt>
                  <c:pt idx="59">
                    <c:v>1.7952087858184702E-2</c:v>
                  </c:pt>
                  <c:pt idx="60">
                    <c:v>2.1666326436988875E-2</c:v>
                  </c:pt>
                  <c:pt idx="61">
                    <c:v>2.5500786207815616E-2</c:v>
                  </c:pt>
                  <c:pt idx="62">
                    <c:v>2.9390038776653356E-2</c:v>
                  </c:pt>
                  <c:pt idx="63">
                    <c:v>3.3480681972252783E-2</c:v>
                  </c:pt>
                  <c:pt idx="64">
                    <c:v>3.8089963419360856E-2</c:v>
                  </c:pt>
                  <c:pt idx="65">
                    <c:v>4.3486216399921201E-2</c:v>
                  </c:pt>
                  <c:pt idx="66">
                    <c:v>4.9639860134270367E-2</c:v>
                  </c:pt>
                  <c:pt idx="67">
                    <c:v>5.6194027901963248E-2</c:v>
                  </c:pt>
                  <c:pt idx="68">
                    <c:v>6.273768541449154E-2</c:v>
                  </c:pt>
                  <c:pt idx="69">
                    <c:v>6.9219432909118042E-2</c:v>
                  </c:pt>
                  <c:pt idx="70">
                    <c:v>7.6213731948293353E-2</c:v>
                  </c:pt>
                  <c:pt idx="71">
                    <c:v>8.4681337323789449E-2</c:v>
                  </c:pt>
                  <c:pt idx="72">
                    <c:v>9.5061655987429661E-2</c:v>
                  </c:pt>
                  <c:pt idx="73">
                    <c:v>0.10642728396454083</c:v>
                  </c:pt>
                  <c:pt idx="74">
                    <c:v>0.11683938501025379</c:v>
                  </c:pt>
                  <c:pt idx="75">
                    <c:v>0.12464606643781791</c:v>
                  </c:pt>
                  <c:pt idx="76">
                    <c:v>0.12939019780435299</c:v>
                  </c:pt>
                  <c:pt idx="77">
                    <c:v>0.13174764508689321</c:v>
                  </c:pt>
                  <c:pt idx="78">
                    <c:v>0.13296700359873617</c:v>
                  </c:pt>
                  <c:pt idx="79">
                    <c:v>0.13433141994696685</c:v>
                  </c:pt>
                  <c:pt idx="80">
                    <c:v>0.13667995812886663</c:v>
                  </c:pt>
                  <c:pt idx="81">
                    <c:v>0.1400281930864756</c:v>
                  </c:pt>
                  <c:pt idx="82">
                    <c:v>0.14360084545971505</c:v>
                  </c:pt>
                  <c:pt idx="83">
                    <c:v>0.14633140273969339</c:v>
                  </c:pt>
                  <c:pt idx="84">
                    <c:v>0.14742210987227758</c:v>
                  </c:pt>
                  <c:pt idx="85">
                    <c:v>0.1465924622314442</c:v>
                  </c:pt>
                  <c:pt idx="86">
                    <c:v>0.144002025939236</c:v>
                  </c:pt>
                  <c:pt idx="87">
                    <c:v>0.14004881645044928</c:v>
                  </c:pt>
                  <c:pt idx="88">
                    <c:v>0.1352115985817032</c:v>
                  </c:pt>
                  <c:pt idx="89">
                    <c:v>0.12997022420356963</c:v>
                  </c:pt>
                  <c:pt idx="90">
                    <c:v>0.12475502228720879</c:v>
                  </c:pt>
                  <c:pt idx="91">
                    <c:v>0.11988400587854374</c:v>
                  </c:pt>
                  <c:pt idx="92">
                    <c:v>0.11549824004055433</c:v>
                  </c:pt>
                  <c:pt idx="93">
                    <c:v>0.11154181546918018</c:v>
                  </c:pt>
                  <c:pt idx="94">
                    <c:v>0.10781856616663038</c:v>
                  </c:pt>
                  <c:pt idx="95">
                    <c:v>0.10410464962761896</c:v>
                  </c:pt>
                  <c:pt idx="96">
                    <c:v>0.1002580559271789</c:v>
                  </c:pt>
                  <c:pt idx="97">
                    <c:v>9.6275736100019799E-2</c:v>
                  </c:pt>
                  <c:pt idx="98">
                    <c:v>9.2284311771903951E-2</c:v>
                  </c:pt>
                  <c:pt idx="99">
                    <c:v>8.8479595135708036E-2</c:v>
                  </c:pt>
                  <c:pt idx="100">
                    <c:v>8.5047806991081568E-2</c:v>
                  </c:pt>
                  <c:pt idx="101">
                    <c:v>8.2109294223243159E-2</c:v>
                  </c:pt>
                  <c:pt idx="102">
                    <c:v>7.9711096597566158E-2</c:v>
                  </c:pt>
                  <c:pt idx="103">
                    <c:v>7.7851892273242698E-2</c:v>
                  </c:pt>
                  <c:pt idx="104">
                    <c:v>7.6494802229568643E-2</c:v>
                  </c:pt>
                  <c:pt idx="105">
                    <c:v>7.5561634985020443E-2</c:v>
                  </c:pt>
                  <c:pt idx="106">
                    <c:v>7.4945073234896548E-2</c:v>
                  </c:pt>
                  <c:pt idx="107">
                    <c:v>7.4529521499581156E-2</c:v>
                  </c:pt>
                  <c:pt idx="108">
                    <c:v>7.417446066840469E-2</c:v>
                  </c:pt>
                  <c:pt idx="109">
                    <c:v>7.3689511438872451E-2</c:v>
                  </c:pt>
                  <c:pt idx="110">
                    <c:v>7.2875602896780675E-2</c:v>
                  </c:pt>
                  <c:pt idx="111">
                    <c:v>7.162876189401321E-2</c:v>
                  </c:pt>
                  <c:pt idx="112">
                    <c:v>7.0029315863863795E-2</c:v>
                  </c:pt>
                  <c:pt idx="113">
                    <c:v>6.8348929386816359E-2</c:v>
                  </c:pt>
                  <c:pt idx="114">
                    <c:v>6.695719432762022E-2</c:v>
                  </c:pt>
                  <c:pt idx="115">
                    <c:v>6.616519292355838E-2</c:v>
                  </c:pt>
                  <c:pt idx="116">
                    <c:v>6.609063431515054E-2</c:v>
                  </c:pt>
                  <c:pt idx="117">
                    <c:v>6.662528887858056E-2</c:v>
                  </c:pt>
                  <c:pt idx="118">
                    <c:v>6.7512154794688917E-2</c:v>
                  </c:pt>
                  <c:pt idx="119">
                    <c:v>6.846590783850573E-2</c:v>
                  </c:pt>
                  <c:pt idx="120">
                    <c:v>6.9267118679097336E-2</c:v>
                  </c:pt>
                  <c:pt idx="121">
                    <c:v>6.980487822599224E-2</c:v>
                  </c:pt>
                  <c:pt idx="122">
                    <c:v>7.0075944589222394E-2</c:v>
                  </c:pt>
                  <c:pt idx="123">
                    <c:v>7.0156281662057438E-2</c:v>
                  </c:pt>
                  <c:pt idx="124">
                    <c:v>7.0157242322046204E-2</c:v>
                  </c:pt>
                  <c:pt idx="125">
                    <c:v>7.0175053232291409E-2</c:v>
                  </c:pt>
                  <c:pt idx="126">
                    <c:v>7.024122750584226E-2</c:v>
                  </c:pt>
                  <c:pt idx="127">
                    <c:v>7.0282854257980948E-2</c:v>
                  </c:pt>
                  <c:pt idx="128">
                    <c:v>7.0105262623887499E-2</c:v>
                  </c:pt>
                  <c:pt idx="129">
                    <c:v>6.9412471143986271E-2</c:v>
                  </c:pt>
                  <c:pt idx="130">
                    <c:v>6.7875753967467214E-2</c:v>
                  </c:pt>
                  <c:pt idx="131">
                    <c:v>6.5242399165639633E-2</c:v>
                  </c:pt>
                  <c:pt idx="132">
                    <c:v>6.1451781414324808E-2</c:v>
                  </c:pt>
                  <c:pt idx="133">
                    <c:v>5.6710621192136774E-2</c:v>
                  </c:pt>
                  <c:pt idx="134">
                    <c:v>5.1486413175766167E-2</c:v>
                  </c:pt>
                  <c:pt idx="135">
                    <c:v>4.6405602202614561E-2</c:v>
                  </c:pt>
                  <c:pt idx="136">
                    <c:v>4.2079222678342715E-2</c:v>
                  </c:pt>
                  <c:pt idx="137">
                    <c:v>3.8916625224826314E-2</c:v>
                  </c:pt>
                  <c:pt idx="138">
                    <c:v>3.7019029171865003E-2</c:v>
                  </c:pt>
                  <c:pt idx="139">
                    <c:v>3.6219881239272889E-2</c:v>
                  </c:pt>
                  <c:pt idx="140">
                    <c:v>3.6228285456684384E-2</c:v>
                  </c:pt>
                  <c:pt idx="141">
                    <c:v>3.6754696391616479E-2</c:v>
                  </c:pt>
                  <c:pt idx="142">
                    <c:v>3.7556372529603213E-2</c:v>
                  </c:pt>
                  <c:pt idx="143">
                    <c:v>3.8430137071325157E-2</c:v>
                  </c:pt>
                  <c:pt idx="144">
                    <c:v>3.9199690172818775E-2</c:v>
                  </c:pt>
                  <c:pt idx="145">
                    <c:v>3.9718467971634169E-2</c:v>
                  </c:pt>
                  <c:pt idx="146">
                    <c:v>3.9884607976426262E-2</c:v>
                  </c:pt>
                  <c:pt idx="147">
                    <c:v>3.9656341191434255E-2</c:v>
                  </c:pt>
                  <c:pt idx="148">
                    <c:v>3.9058819947630379E-2</c:v>
                  </c:pt>
                  <c:pt idx="149">
                    <c:v>3.8178396449463928E-2</c:v>
                  </c:pt>
                  <c:pt idx="150">
                    <c:v>3.714308442157925E-2</c:v>
                  </c:pt>
                  <c:pt idx="151">
                    <c:v>3.6089923044752129E-2</c:v>
                  </c:pt>
                  <c:pt idx="152">
                    <c:v>3.5125265203124527E-2</c:v>
                  </c:pt>
                  <c:pt idx="153">
                    <c:v>3.4291928607751612E-2</c:v>
                  </c:pt>
                  <c:pt idx="154">
                    <c:v>3.3559496396302145E-2</c:v>
                  </c:pt>
                  <c:pt idx="155">
                    <c:v>3.2843790317538563E-2</c:v>
                  </c:pt>
                  <c:pt idx="156">
                    <c:v>3.2044815508934177E-2</c:v>
                  </c:pt>
                  <c:pt idx="157">
                    <c:v>3.1084038434535759E-2</c:v>
                  </c:pt>
                  <c:pt idx="158">
                    <c:v>2.9926961630384524E-2</c:v>
                  </c:pt>
                  <c:pt idx="159">
                    <c:v>2.8587575896885757E-2</c:v>
                  </c:pt>
                  <c:pt idx="160">
                    <c:v>2.7118748645324642E-2</c:v>
                  </c:pt>
                  <c:pt idx="161">
                    <c:v>2.5595100857628415E-2</c:v>
                  </c:pt>
                  <c:pt idx="162">
                    <c:v>2.4094508291289358E-2</c:v>
                  </c:pt>
                  <c:pt idx="163">
                    <c:v>2.2682932487062053E-2</c:v>
                  </c:pt>
                  <c:pt idx="164">
                    <c:v>2.1405520683263009E-2</c:v>
                  </c:pt>
                  <c:pt idx="165">
                    <c:v>2.0284899197660754E-2</c:v>
                  </c:pt>
                  <c:pt idx="166">
                    <c:v>1.9325535803189988E-2</c:v>
                  </c:pt>
                  <c:pt idx="167">
                    <c:v>1.8521523632867319E-2</c:v>
                  </c:pt>
                  <c:pt idx="168">
                    <c:v>1.7864687666522102E-2</c:v>
                  </c:pt>
                  <c:pt idx="169">
                    <c:v>1.7350541779705259E-2</c:v>
                  </c:pt>
                  <c:pt idx="170">
                    <c:v>1.6980787807746669E-2</c:v>
                  </c:pt>
                  <c:pt idx="171">
                    <c:v>1.6762191882922144E-2</c:v>
                  </c:pt>
                  <c:pt idx="172">
                    <c:v>1.6702618412609248E-2</c:v>
                  </c:pt>
                  <c:pt idx="173">
                    <c:v>1.6805775307721756E-2</c:v>
                  </c:pt>
                  <c:pt idx="174">
                    <c:v>1.7066659116274013E-2</c:v>
                  </c:pt>
                  <c:pt idx="175">
                    <c:v>1.7469414461358451E-2</c:v>
                  </c:pt>
                  <c:pt idx="176">
                    <c:v>1.7988259487640362E-2</c:v>
                  </c:pt>
                  <c:pt idx="177">
                    <c:v>1.8590832857566825E-2</c:v>
                  </c:pt>
                  <c:pt idx="178">
                    <c:v>1.924255292324982E-2</c:v>
                  </c:pt>
                  <c:pt idx="179">
                    <c:v>1.9910617118579478E-2</c:v>
                  </c:pt>
                  <c:pt idx="180">
                    <c:v>2.0566787005548891E-2</c:v>
                  </c:pt>
                  <c:pt idx="181">
                    <c:v>2.1188653778562758E-2</c:v>
                  </c:pt>
                  <c:pt idx="182">
                    <c:v>2.1759451797186961E-2</c:v>
                  </c:pt>
                  <c:pt idx="183">
                    <c:v>2.2266711952325255E-2</c:v>
                  </c:pt>
                  <c:pt idx="184">
                    <c:v>2.2700221533798422E-2</c:v>
                  </c:pt>
                  <c:pt idx="185">
                    <c:v>2.3049926719912975E-2</c:v>
                  </c:pt>
                  <c:pt idx="186">
                    <c:v>2.3304531168627952E-2</c:v>
                  </c:pt>
                  <c:pt idx="187">
                    <c:v>2.3451506713122617E-2</c:v>
                  </c:pt>
                  <c:pt idx="188">
                    <c:v>2.3478952384680948E-2</c:v>
                  </c:pt>
                  <c:pt idx="189">
                    <c:v>2.3379211473163897E-2</c:v>
                  </c:pt>
                  <c:pt idx="190">
                    <c:v>2.3153481092861177E-2</c:v>
                  </c:pt>
                  <c:pt idx="191">
                    <c:v>2.2815992104493761E-2</c:v>
                  </c:pt>
                  <c:pt idx="192">
                    <c:v>2.2395896800307312E-2</c:v>
                  </c:pt>
                  <c:pt idx="193">
                    <c:v>2.1935019363444917E-2</c:v>
                  </c:pt>
                  <c:pt idx="194">
                    <c:v>2.14804212679282E-2</c:v>
                  </c:pt>
                  <c:pt idx="195">
                    <c:v>2.1072582156728293E-2</c:v>
                  </c:pt>
                  <c:pt idx="196">
                    <c:v>2.0732598894999291E-2</c:v>
                  </c:pt>
                  <c:pt idx="197">
                    <c:v>2.0453705482108467E-2</c:v>
                  </c:pt>
                  <c:pt idx="198">
                    <c:v>2.0201590662370851E-2</c:v>
                  </c:pt>
                  <c:pt idx="199">
                    <c:v>1.992409467755293E-2</c:v>
                  </c:pt>
                  <c:pt idx="200">
                    <c:v>1.9566474507849346E-2</c:v>
                  </c:pt>
                  <c:pt idx="201">
                    <c:v>1.9086635766927471E-2</c:v>
                  </c:pt>
                  <c:pt idx="202">
                    <c:v>1.8466006133117913E-2</c:v>
                  </c:pt>
                  <c:pt idx="203">
                    <c:v>1.7714194930696366E-2</c:v>
                  </c:pt>
                  <c:pt idx="204">
                    <c:v>1.6867469459579253E-2</c:v>
                  </c:pt>
                  <c:pt idx="205">
                    <c:v>1.5981902995090509E-2</c:v>
                  </c:pt>
                  <c:pt idx="206">
                    <c:v>1.5122264849668937E-2</c:v>
                  </c:pt>
                  <c:pt idx="207">
                    <c:v>1.4348106912342597E-2</c:v>
                  </c:pt>
                  <c:pt idx="208">
                    <c:v>1.3699661933999034E-2</c:v>
                  </c:pt>
                  <c:pt idx="209">
                    <c:v>1.318773355788724E-2</c:v>
                  </c:pt>
                  <c:pt idx="210">
                    <c:v>1.2791831878145907E-2</c:v>
                  </c:pt>
                  <c:pt idx="211">
                    <c:v>1.246769626888899E-2</c:v>
                  </c:pt>
                  <c:pt idx="212">
                    <c:v>1.2160675024437552E-2</c:v>
                  </c:pt>
                  <c:pt idx="213">
                    <c:v>1.1819207921431379E-2</c:v>
                  </c:pt>
                  <c:pt idx="214">
                    <c:v>1.1404286121048865E-2</c:v>
                  </c:pt>
                  <c:pt idx="215">
                    <c:v>1.0893856857881107E-2</c:v>
                  </c:pt>
                  <c:pt idx="216">
                    <c:v>1.0283200152746171E-2</c:v>
                  </c:pt>
                  <c:pt idx="217">
                    <c:v>9.582897496853272E-3</c:v>
                  </c:pt>
                  <c:pt idx="218">
                    <c:v>8.8158522630345845E-3</c:v>
                  </c:pt>
                  <c:pt idx="219">
                    <c:v>8.0145300904790225E-3</c:v>
                  </c:pt>
                  <c:pt idx="220">
                    <c:v>7.2193554582004492E-3</c:v>
                  </c:pt>
                  <c:pt idx="221">
                    <c:v>6.4788447405357804E-3</c:v>
                  </c:pt>
                  <c:pt idx="222">
                    <c:v>5.8509380696911799E-3</c:v>
                  </c:pt>
                  <c:pt idx="223">
                    <c:v>5.4020251573025637E-3</c:v>
                  </c:pt>
                  <c:pt idx="224">
                    <c:v>5.1960525022350136E-3</c:v>
                  </c:pt>
                  <c:pt idx="225">
                    <c:v>5.2696971955318644E-3</c:v>
                  </c:pt>
                  <c:pt idx="226">
                    <c:v>5.6097793620542343E-3</c:v>
                  </c:pt>
                  <c:pt idx="227">
                    <c:v>6.1575816337230641E-3</c:v>
                  </c:pt>
                  <c:pt idx="228">
                    <c:v>6.8342039826959806E-3</c:v>
                  </c:pt>
                  <c:pt idx="229">
                    <c:v>7.5621087002765717E-3</c:v>
                  </c:pt>
                  <c:pt idx="230">
                    <c:v>8.2749015166066267E-3</c:v>
                  </c:pt>
                  <c:pt idx="231">
                    <c:v>8.9209762324996503E-3</c:v>
                  </c:pt>
                  <c:pt idx="232">
                    <c:v>9.465643294540348E-3</c:v>
                  </c:pt>
                  <c:pt idx="233">
                    <c:v>9.8924232473407113E-3</c:v>
                  </c:pt>
                  <c:pt idx="234">
                    <c:v>1.0202384698907531E-2</c:v>
                  </c:pt>
                  <c:pt idx="235">
                    <c:v>1.0410522529400246E-2</c:v>
                  </c:pt>
                  <c:pt idx="236">
                    <c:v>1.0539418710034462E-2</c:v>
                  </c:pt>
                  <c:pt idx="237">
                    <c:v>1.0612092701586574E-2</c:v>
                  </c:pt>
                  <c:pt idx="238">
                    <c:v>1.0647005387812707E-2</c:v>
                  </c:pt>
                  <c:pt idx="239">
                    <c:v>1.0657485568579499E-2</c:v>
                  </c:pt>
                  <c:pt idx="240">
                    <c:v>1.0655099901436696E-2</c:v>
                  </c:pt>
                  <c:pt idx="241">
                    <c:v>1.0653085834358537E-2</c:v>
                  </c:pt>
                  <c:pt idx="242">
                    <c:v>1.0664822835709296E-2</c:v>
                  </c:pt>
                  <c:pt idx="243">
                    <c:v>1.0695966727343433E-2</c:v>
                  </c:pt>
                  <c:pt idx="244">
                    <c:v>1.073543457353505E-2</c:v>
                  </c:pt>
                  <c:pt idx="245">
                    <c:v>1.0752582445666332E-2</c:v>
                  </c:pt>
                  <c:pt idx="246">
                    <c:v>1.070250858080268E-2</c:v>
                  </c:pt>
                  <c:pt idx="247">
                    <c:v>1.0536233581578814E-2</c:v>
                  </c:pt>
                  <c:pt idx="248">
                    <c:v>1.0213045182676994E-2</c:v>
                  </c:pt>
                  <c:pt idx="249">
                    <c:v>9.7131099927251149E-3</c:v>
                  </c:pt>
                  <c:pt idx="250">
                    <c:v>9.0466193869288992E-3</c:v>
                  </c:pt>
                  <c:pt idx="251">
                    <c:v>8.2558574548342954E-3</c:v>
                  </c:pt>
                  <c:pt idx="252">
                    <c:v>7.4098853234417852E-3</c:v>
                  </c:pt>
                  <c:pt idx="253">
                    <c:v>6.593854987135649E-3</c:v>
                  </c:pt>
                  <c:pt idx="254">
                    <c:v>5.8939495365134056E-3</c:v>
                  </c:pt>
                  <c:pt idx="255">
                    <c:v>5.377180117187878E-3</c:v>
                  </c:pt>
                  <c:pt idx="256">
                    <c:v>5.0692160331193168E-3</c:v>
                  </c:pt>
                  <c:pt idx="257">
                    <c:v>4.9443902744648292E-3</c:v>
                  </c:pt>
                  <c:pt idx="258">
                    <c:v>4.9409529682683858E-3</c:v>
                  </c:pt>
                  <c:pt idx="259">
                    <c:v>4.9910041361244601E-3</c:v>
                  </c:pt>
                  <c:pt idx="260">
                    <c:v>5.0427855846328605E-3</c:v>
                  </c:pt>
                  <c:pt idx="261">
                    <c:v>5.0679778288559027E-3</c:v>
                  </c:pt>
                  <c:pt idx="262">
                    <c:v>5.0597586836061467E-3</c:v>
                  </c:pt>
                  <c:pt idx="263">
                    <c:v>5.0275215922129524E-3</c:v>
                  </c:pt>
                  <c:pt idx="264">
                    <c:v>4.9904540398727293E-3</c:v>
                  </c:pt>
                  <c:pt idx="265">
                    <c:v>4.9703389649484652E-3</c:v>
                  </c:pt>
                  <c:pt idx="266">
                    <c:v>4.984333045307124E-3</c:v>
                  </c:pt>
                  <c:pt idx="267">
                    <c:v>5.0397864102950463E-3</c:v>
                  </c:pt>
                  <c:pt idx="268">
                    <c:v>5.1334357691839843E-3</c:v>
                  </c:pt>
                  <c:pt idx="269">
                    <c:v>5.2553822243492521E-3</c:v>
                  </c:pt>
                  <c:pt idx="270">
                    <c:v>5.3955423408790495E-3</c:v>
                  </c:pt>
                  <c:pt idx="271">
                    <c:v>5.5491413875679418E-3</c:v>
                  </c:pt>
                  <c:pt idx="272">
                    <c:v>5.7187636704857546E-3</c:v>
                  </c:pt>
                  <c:pt idx="273">
                    <c:v>5.9122713709916863E-3</c:v>
                  </c:pt>
                  <c:pt idx="274">
                    <c:v>6.1376327399157169E-3</c:v>
                  </c:pt>
                  <c:pt idx="275">
                    <c:v>6.3969960083947886E-3</c:v>
                  </c:pt>
                  <c:pt idx="276">
                    <c:v>6.6826643415707522E-3</c:v>
                  </c:pt>
                  <c:pt idx="277">
                    <c:v>6.9765676155311125E-3</c:v>
                  </c:pt>
                  <c:pt idx="278">
                    <c:v>7.2530355457427961E-3</c:v>
                  </c:pt>
                  <c:pt idx="279">
                    <c:v>7.4834472849032831E-3</c:v>
                  </c:pt>
                  <c:pt idx="280">
                    <c:v>7.6411995356667562E-3</c:v>
                  </c:pt>
                  <c:pt idx="281">
                    <c:v>7.7058918022013274E-3</c:v>
                  </c:pt>
                  <c:pt idx="282">
                    <c:v>7.6660695851180393E-3</c:v>
                  </c:pt>
                  <c:pt idx="283">
                    <c:v>7.5201837037413089E-3</c:v>
                  </c:pt>
                  <c:pt idx="284">
                    <c:v>7.275779111787492E-3</c:v>
                  </c:pt>
                  <c:pt idx="285">
                    <c:v>6.9473632903282317E-3</c:v>
                  </c:pt>
                  <c:pt idx="286">
                    <c:v>6.5537412592602436E-3</c:v>
                  </c:pt>
                  <c:pt idx="287">
                    <c:v>6.1156168502455891E-3</c:v>
                  </c:pt>
                  <c:pt idx="288">
                    <c:v>5.6539172427049703E-3</c:v>
                  </c:pt>
                  <c:pt idx="289">
                    <c:v>5.1888197746135269E-3</c:v>
                  </c:pt>
                  <c:pt idx="290">
                    <c:v>4.7391377894893125E-3</c:v>
                  </c:pt>
                  <c:pt idx="291">
                    <c:v>4.3216837587721508E-3</c:v>
                  </c:pt>
                  <c:pt idx="292">
                    <c:v>3.9503907465533051E-3</c:v>
                  </c:pt>
                  <c:pt idx="293">
                    <c:v>3.6351984010716126E-3</c:v>
                  </c:pt>
                  <c:pt idx="294">
                    <c:v>3.3809429537311583E-3</c:v>
                  </c:pt>
                  <c:pt idx="295">
                    <c:v>3.1867084498155424E-3</c:v>
                  </c:pt>
                  <c:pt idx="296">
                    <c:v>3.0461471214236545E-3</c:v>
                  </c:pt>
                  <c:pt idx="297">
                    <c:v>2.948953400881298E-3</c:v>
                  </c:pt>
                  <c:pt idx="298">
                    <c:v>2.8830849377089441E-3</c:v>
                  </c:pt>
                  <c:pt idx="299">
                    <c:v>2.8369484021930303E-3</c:v>
                  </c:pt>
                  <c:pt idx="300">
                    <c:v>2.8009128203039303E-3</c:v>
                  </c:pt>
                  <c:pt idx="301">
                    <c:v>2.7679545604225148E-3</c:v>
                  </c:pt>
                  <c:pt idx="302">
                    <c:v>2.73359129905878E-3</c:v>
                  </c:pt>
                  <c:pt idx="303">
                    <c:v>2.6953892099870771E-3</c:v>
                  </c:pt>
                  <c:pt idx="304">
                    <c:v>2.6523061941054827E-3</c:v>
                  </c:pt>
                  <c:pt idx="305">
                    <c:v>2.6040652502308365E-3</c:v>
                  </c:pt>
                  <c:pt idx="306">
                    <c:v>2.5506792721072631E-3</c:v>
                  </c:pt>
                  <c:pt idx="307">
                    <c:v>2.4921786604605576E-3</c:v>
                  </c:pt>
                  <c:pt idx="308">
                    <c:v>2.4285299098618911E-3</c:v>
                  </c:pt>
                  <c:pt idx="309">
                    <c:v>2.3596872141758716E-3</c:v>
                  </c:pt>
                  <c:pt idx="310">
                    <c:v>2.2857009025435736E-3</c:v>
                  </c:pt>
                  <c:pt idx="311">
                    <c:v>2.2068169844110049E-3</c:v>
                  </c:pt>
                  <c:pt idx="312">
                    <c:v>2.1235302945050837E-3</c:v>
                  </c:pt>
                  <c:pt idx="313">
                    <c:v>2.0365851715169669E-3</c:v>
                  </c:pt>
                  <c:pt idx="314">
                    <c:v>1.9469422792289227E-3</c:v>
                  </c:pt>
                  <c:pt idx="315">
                    <c:v>1.8557464702509093E-3</c:v>
                  </c:pt>
                  <c:pt idx="316">
                    <c:v>1.7643448664085818E-3</c:v>
                  </c:pt>
                  <c:pt idx="317">
                    <c:v>1.6744254452911345E-3</c:v>
                  </c:pt>
                  <c:pt idx="318">
                    <c:v>1.588379334403352E-3</c:v>
                  </c:pt>
                  <c:pt idx="319">
                    <c:v>1.5100189672628062E-3</c:v>
                  </c:pt>
                  <c:pt idx="320">
                    <c:v>1.445738516651984E-3</c:v>
                  </c:pt>
                  <c:pt idx="321">
                    <c:v>1.4058972269147603E-3</c:v>
                  </c:pt>
                  <c:pt idx="322">
                    <c:v>1.4053929046877829E-3</c:v>
                  </c:pt>
                  <c:pt idx="323">
                    <c:v>1.4614254648648818E-3</c:v>
                  </c:pt>
                  <c:pt idx="324">
                    <c:v>1.587424026933926E-3</c:v>
                  </c:pt>
                  <c:pt idx="325">
                    <c:v>1.78634054866E-3</c:v>
                  </c:pt>
                  <c:pt idx="326">
                    <c:v>2.0484195422014826E-3</c:v>
                  </c:pt>
                  <c:pt idx="327">
                    <c:v>2.353745357503447E-3</c:v>
                  </c:pt>
                  <c:pt idx="328">
                    <c:v>2.6760871984176397E-3</c:v>
                  </c:pt>
                  <c:pt idx="329">
                    <c:v>2.9861819236531354E-3</c:v>
                  </c:pt>
                  <c:pt idx="330">
                    <c:v>3.2546975721919982E-3</c:v>
                  </c:pt>
                  <c:pt idx="331">
                    <c:v>3.4553215117340079E-3</c:v>
                  </c:pt>
                  <c:pt idx="332">
                    <c:v>3.5678646111954181E-3</c:v>
                  </c:pt>
                  <c:pt idx="333">
                    <c:v>3.5808801483120964E-3</c:v>
                  </c:pt>
                  <c:pt idx="334">
                    <c:v>3.4932316199293187E-3</c:v>
                  </c:pt>
                  <c:pt idx="335">
                    <c:v>3.3142334389297608E-3</c:v>
                  </c:pt>
                  <c:pt idx="336">
                    <c:v>3.0623169450118893E-3</c:v>
                  </c:pt>
                  <c:pt idx="337">
                    <c:v>2.7625130806341754E-3</c:v>
                  </c:pt>
                  <c:pt idx="338">
                    <c:v>2.4432675265815182E-3</c:v>
                  </c:pt>
                  <c:pt idx="339">
                    <c:v>2.1331136721164084E-3</c:v>
                  </c:pt>
                  <c:pt idx="340">
                    <c:v>1.8574838787449967E-3</c:v>
                  </c:pt>
                  <c:pt idx="341">
                    <c:v>1.6355801669780531E-3</c:v>
                  </c:pt>
                  <c:pt idx="342">
                    <c:v>1.4773026313813079E-3</c:v>
                  </c:pt>
                  <c:pt idx="343">
                    <c:v>1.3813983099258441E-3</c:v>
                  </c:pt>
                  <c:pt idx="344">
                    <c:v>1.33705266181422E-3</c:v>
                  </c:pt>
                  <c:pt idx="345">
                    <c:v>1.3291062168818506E-3</c:v>
                  </c:pt>
                  <c:pt idx="346">
                    <c:v>1.3435404506668329E-3</c:v>
                  </c:pt>
                  <c:pt idx="347">
                    <c:v>1.3702094342531201E-3</c:v>
                  </c:pt>
                  <c:pt idx="348">
                    <c:v>1.4028925555061699E-3</c:v>
                  </c:pt>
                  <c:pt idx="349">
                    <c:v>1.438202645466829E-3</c:v>
                  </c:pt>
                  <c:pt idx="350">
                    <c:v>1.4744464402176249E-3</c:v>
                  </c:pt>
                  <c:pt idx="351">
                    <c:v>1.5108124796565571E-3</c:v>
                  </c:pt>
                  <c:pt idx="352">
                    <c:v>1.5468882822786498E-3</c:v>
                  </c:pt>
                  <c:pt idx="353">
                    <c:v>1.5824057385591744E-3</c:v>
                  </c:pt>
                  <c:pt idx="354">
                    <c:v>1.6171200117063396E-3</c:v>
                  </c:pt>
                  <c:pt idx="355">
                    <c:v>1.6507585741753264E-3</c:v>
                  </c:pt>
                  <c:pt idx="356">
                    <c:v>1.6830044994463459E-3</c:v>
                  </c:pt>
                  <c:pt idx="357">
                    <c:v>1.7134958738854308E-3</c:v>
                  </c:pt>
                  <c:pt idx="358">
                    <c:v>1.7418329990104581E-3</c:v>
                  </c:pt>
                  <c:pt idx="359">
                    <c:v>1.7675898314205628E-3</c:v>
                  </c:pt>
                  <c:pt idx="360">
                    <c:v>1.7903282480962962E-3</c:v>
                  </c:pt>
                  <c:pt idx="361">
                    <c:v>1.8096142872174551E-3</c:v>
                  </c:pt>
                  <c:pt idx="362">
                    <c:v>1.825035757115288E-3</c:v>
                  </c:pt>
                  <c:pt idx="363">
                    <c:v>1.836220414104626E-3</c:v>
                  </c:pt>
                  <c:pt idx="364">
                    <c:v>1.8428538223632216E-3</c:v>
                  </c:pt>
                  <c:pt idx="365">
                    <c:v>1.8446959028657335E-3</c:v>
                  </c:pt>
                  <c:pt idx="366">
                    <c:v>1.8415952562491529E-3</c:v>
                  </c:pt>
                  <c:pt idx="367">
                    <c:v>1.8335002751599559E-3</c:v>
                  </c:pt>
                  <c:pt idx="368">
                    <c:v>1.8204664268853586E-3</c:v>
                  </c:pt>
                  <c:pt idx="369">
                    <c:v>1.8026590610453748E-3</c:v>
                  </c:pt>
                  <c:pt idx="370">
                    <c:v>1.780351527234507E-3</c:v>
                  </c:pt>
                  <c:pt idx="371">
                    <c:v>1.7539185300514315E-3</c:v>
                  </c:pt>
                  <c:pt idx="372">
                    <c:v>1.72382500296286E-3</c:v>
                  </c:pt>
                  <c:pt idx="373">
                    <c:v>1.6906110311311041E-3</c:v>
                  </c:pt>
                  <c:pt idx="374">
                    <c:v>1.6548736575774277E-3</c:v>
                  </c:pt>
                  <c:pt idx="375">
                    <c:v>1.6172466763272671E-3</c:v>
                  </c:pt>
                  <c:pt idx="376">
                    <c:v>1.5783798294360719E-3</c:v>
                  </c:pt>
                  <c:pt idx="377">
                    <c:v>1.5389189712926301E-3</c:v>
                  </c:pt>
                  <c:pt idx="378">
                    <c:v>1.4994888666205065E-3</c:v>
                  </c:pt>
                  <c:pt idx="379">
                    <c:v>1.46068037434923E-3</c:v>
                  </c:pt>
                  <c:pt idx="380">
                    <c:v>1.4230433949994202E-3</c:v>
                  </c:pt>
                  <c:pt idx="381">
                    <c:v>1.3870867831678173E-3</c:v>
                  </c:pt>
                  <c:pt idx="382">
                    <c:v>1.3532857254542365E-3</c:v>
                  </c:pt>
                  <c:pt idx="383">
                    <c:v>1.3220966560255761E-3</c:v>
                  </c:pt>
                  <c:pt idx="384">
                    <c:v>1.2939791881816014E-3</c:v>
                  </c:pt>
                  <c:pt idx="385">
                    <c:v>1.2694242498632485E-3</c:v>
                  </c:pt>
                  <c:pt idx="386">
                    <c:v>1.2489875393146685E-3</c:v>
                  </c:pt>
                  <c:pt idx="387">
                    <c:v>1.2333274183232465E-3</c:v>
                  </c:pt>
                  <c:pt idx="388">
                    <c:v>1.2232459941802574E-3</c:v>
                  </c:pt>
                  <c:pt idx="389">
                    <c:v>1.2197308555069381E-3</c:v>
                  </c:pt>
                  <c:pt idx="390">
                    <c:v>1.2239914570808051E-3</c:v>
                  </c:pt>
                  <c:pt idx="391">
                    <c:v>1.2374789301408315E-3</c:v>
                  </c:pt>
                  <c:pt idx="392">
                    <c:v>1.2618717689361718E-3</c:v>
                  </c:pt>
                  <c:pt idx="393">
                    <c:v>1.2990069353932883E-3</c:v>
                  </c:pt>
                  <c:pt idx="394">
                    <c:v>1.3507417270474714E-3</c:v>
                  </c:pt>
                  <c:pt idx="395">
                    <c:v>1.4187495535283379E-3</c:v>
                  </c:pt>
                  <c:pt idx="396">
                    <c:v>1.5042789204778432E-3</c:v>
                  </c:pt>
                  <c:pt idx="397">
                    <c:v>1.6079260093853978E-3</c:v>
                  </c:pt>
                  <c:pt idx="398">
                    <c:v>1.7294748245688185E-3</c:v>
                  </c:pt>
                  <c:pt idx="399">
                    <c:v>1.8678418928383927E-3</c:v>
                  </c:pt>
                  <c:pt idx="400">
                    <c:v>2.0211367051246316E-3</c:v>
                  </c:pt>
                  <c:pt idx="401">
                    <c:v>2.1868269827283733E-3</c:v>
                  </c:pt>
                  <c:pt idx="402">
                    <c:v>2.3619825862635437E-3</c:v>
                  </c:pt>
                  <c:pt idx="403">
                    <c:v>2.5435557935614911E-3</c:v>
                  </c:pt>
                  <c:pt idx="404">
                    <c:v>2.7286329050448662E-3</c:v>
                  </c:pt>
                  <c:pt idx="405">
                    <c:v>2.9145723659362408E-3</c:v>
                  </c:pt>
                  <c:pt idx="406">
                    <c:v>3.0989576611190799E-3</c:v>
                  </c:pt>
                  <c:pt idx="407">
                    <c:v>3.279367179867064E-3</c:v>
                  </c:pt>
                  <c:pt idx="408">
                    <c:v>3.4530838296787142E-3</c:v>
                  </c:pt>
                  <c:pt idx="409">
                    <c:v>3.6169528583281851E-3</c:v>
                  </c:pt>
                  <c:pt idx="410">
                    <c:v>3.7675470139016962E-3</c:v>
                  </c:pt>
                  <c:pt idx="411">
                    <c:v>3.9016027545727911E-3</c:v>
                  </c:pt>
                  <c:pt idx="412">
                    <c:v>4.0164801439046523E-3</c:v>
                  </c:pt>
                  <c:pt idx="413">
                    <c:v>4.1103535433141582E-3</c:v>
                  </c:pt>
                  <c:pt idx="414">
                    <c:v>4.1820202611551963E-3</c:v>
                  </c:pt>
                  <c:pt idx="415">
                    <c:v>4.2304870633031941E-3</c:v>
                  </c:pt>
                  <c:pt idx="416">
                    <c:v>4.2546430588418028E-3</c:v>
                  </c:pt>
                  <c:pt idx="417">
                    <c:v>4.2532442115262139E-3</c:v>
                  </c:pt>
                  <c:pt idx="418">
                    <c:v>4.2252089656365397E-3</c:v>
                  </c:pt>
                  <c:pt idx="419">
                    <c:v>4.1700433410252766E-3</c:v>
                  </c:pt>
                  <c:pt idx="420">
                    <c:v>4.088187895280742E-3</c:v>
                  </c:pt>
                  <c:pt idx="421">
                    <c:v>3.981174681697632E-3</c:v>
                  </c:pt>
                  <c:pt idx="422">
                    <c:v>3.8515974305817803E-3</c:v>
                  </c:pt>
                  <c:pt idx="423">
                    <c:v>3.7029605233233594E-3</c:v>
                  </c:pt>
                  <c:pt idx="424">
                    <c:v>3.5394761182150737E-3</c:v>
                  </c:pt>
                  <c:pt idx="425">
                    <c:v>3.3658532555496268E-3</c:v>
                  </c:pt>
                  <c:pt idx="426">
                    <c:v>3.1870967824243462E-3</c:v>
                  </c:pt>
                  <c:pt idx="427">
                    <c:v>3.0083188117059493E-3</c:v>
                  </c:pt>
                  <c:pt idx="428">
                    <c:v>2.8345596066235595E-3</c:v>
                  </c:pt>
                  <c:pt idx="429">
                    <c:v>2.6706137116528977E-3</c:v>
                  </c:pt>
                  <c:pt idx="430">
                    <c:v>2.5208571906248029E-3</c:v>
                  </c:pt>
                  <c:pt idx="431">
                    <c:v>2.3890738379373213E-3</c:v>
                  </c:pt>
                  <c:pt idx="432">
                    <c:v>2.2782839893903256E-3</c:v>
                  </c:pt>
                  <c:pt idx="433">
                    <c:v>2.1905908911693962E-3</c:v>
                  </c:pt>
                  <c:pt idx="434">
                    <c:v>2.1270725053407252E-3</c:v>
                  </c:pt>
                  <c:pt idx="435">
                    <c:v>2.0877521730651642E-3</c:v>
                  </c:pt>
                  <c:pt idx="436">
                    <c:v>2.0716697243564654E-3</c:v>
                  </c:pt>
                  <c:pt idx="437">
                    <c:v>2.0770454041474508E-3</c:v>
                  </c:pt>
                  <c:pt idx="438">
                    <c:v>2.1014976814713385E-3</c:v>
                  </c:pt>
                  <c:pt idx="439">
                    <c:v>2.1422628177435359E-3</c:v>
                  </c:pt>
                  <c:pt idx="440">
                    <c:v>2.196376060922657E-3</c:v>
                  </c:pt>
                  <c:pt idx="441">
                    <c:v>2.2608011947622764E-3</c:v>
                  </c:pt>
                  <c:pt idx="442">
                    <c:v>2.3325189322971986E-3</c:v>
                  </c:pt>
                  <c:pt idx="443">
                    <c:v>2.4085946480088176E-3</c:v>
                  </c:pt>
                  <c:pt idx="444">
                    <c:v>2.4862418486445216E-3</c:v>
                  </c:pt>
                  <c:pt idx="445">
                    <c:v>2.5628861432135629E-3</c:v>
                  </c:pt>
                  <c:pt idx="446">
                    <c:v>2.6362233198878801E-3</c:v>
                  </c:pt>
                  <c:pt idx="447">
                    <c:v>2.7042598794917621E-3</c:v>
                  </c:pt>
                  <c:pt idx="448">
                    <c:v>2.7653267303589637E-3</c:v>
                  </c:pt>
                  <c:pt idx="449">
                    <c:v>2.8180648851532132E-3</c:v>
                  </c:pt>
                  <c:pt idx="450">
                    <c:v>2.8613912810069404E-3</c:v>
                  </c:pt>
                  <c:pt idx="451">
                    <c:v>2.8944578457793342E-3</c:v>
                  </c:pt>
                  <c:pt idx="452">
                    <c:v>2.9166149663025082E-3</c:v>
                  </c:pt>
                  <c:pt idx="453">
                    <c:v>2.9273818768438225E-3</c:v>
                  </c:pt>
                  <c:pt idx="454">
                    <c:v>2.9264162293833247E-3</c:v>
                  </c:pt>
                  <c:pt idx="455">
                    <c:v>2.9134698796240478E-3</c:v>
                  </c:pt>
                  <c:pt idx="456">
                    <c:v>2.8883229562230127E-3</c:v>
                  </c:pt>
                  <c:pt idx="457">
                    <c:v>2.8507035692586754E-3</c:v>
                  </c:pt>
                  <c:pt idx="458">
                    <c:v>2.8002197127039328E-3</c:v>
                  </c:pt>
                  <c:pt idx="459">
                    <c:v>2.7363421543263227E-3</c:v>
                  </c:pt>
                  <c:pt idx="460">
                    <c:v>2.6584727267123087E-3</c:v>
                  </c:pt>
                  <c:pt idx="461">
                    <c:v>2.5661088909850506E-3</c:v>
                  </c:pt>
                  <c:pt idx="462">
                    <c:v>2.4590800515834213E-3</c:v>
                  </c:pt>
                  <c:pt idx="463">
                    <c:v>2.3377993378739673E-3</c:v>
                  </c:pt>
                  <c:pt idx="464">
                    <c:v>2.2034600764355467E-3</c:v>
                  </c:pt>
                  <c:pt idx="465">
                    <c:v>2.0581159050929872E-3</c:v>
                  </c:pt>
                  <c:pt idx="466">
                    <c:v>1.9046131235927E-3</c:v>
                  </c:pt>
                  <c:pt idx="467">
                    <c:v>1.7463823241104248E-3</c:v>
                  </c:pt>
                  <c:pt idx="468">
                    <c:v>1.5871308357737609E-3</c:v>
                  </c:pt>
                  <c:pt idx="469">
                    <c:v>1.4304985248852346E-3</c:v>
                  </c:pt>
                  <c:pt idx="470">
                    <c:v>1.2797429425241858E-3</c:v>
                  </c:pt>
                  <c:pt idx="471">
                    <c:v>1.1375067887669898E-3</c:v>
                  </c:pt>
                  <c:pt idx="472">
                    <c:v>1.005696846253921E-3</c:v>
                  </c:pt>
                  <c:pt idx="473">
                    <c:v>8.8547602167895383E-4</c:v>
                  </c:pt>
                  <c:pt idx="474">
                    <c:v>7.773466911314195E-4</c:v>
                  </c:pt>
                  <c:pt idx="475">
                    <c:v>6.812896163834011E-4</c:v>
                  </c:pt>
                  <c:pt idx="476">
                    <c:v>5.9692059093091935E-4</c:v>
                  </c:pt>
                  <c:pt idx="477">
                    <c:v>5.2363441556923965E-4</c:v>
                  </c:pt>
                  <c:pt idx="478">
                    <c:v>4.6071846035373651E-4</c:v>
                  </c:pt>
                  <c:pt idx="479">
                    <c:v>4.0743019360892384E-4</c:v>
                  </c:pt>
                  <c:pt idx="480">
                    <c:v>3.6304120791332131E-4</c:v>
                  </c:pt>
                  <c:pt idx="481">
                    <c:v>3.268540994178243E-4</c:v>
                  </c:pt>
                  <c:pt idx="482">
                    <c:v>2.9819933559618856E-4</c:v>
                  </c:pt>
                  <c:pt idx="483">
                    <c:v>2.7642039851778554E-4</c:v>
                  </c:pt>
                  <c:pt idx="484">
                    <c:v>2.6085708390678536E-4</c:v>
                  </c:pt>
                  <c:pt idx="485">
                    <c:v>2.5083781555759467E-4</c:v>
                  </c:pt>
                  <c:pt idx="486">
                    <c:v>2.4568818223505494E-4</c:v>
                  </c:pt>
                  <c:pt idx="487">
                    <c:v>2.4475458818755814E-4</c:v>
                  </c:pt>
                  <c:pt idx="488">
                    <c:v>2.47433839134808E-4</c:v>
                  </c:pt>
                  <c:pt idx="489">
                    <c:v>2.5319717688481239E-4</c:v>
                  </c:pt>
                  <c:pt idx="490">
                    <c:v>2.6160179770569266E-4</c:v>
                  </c:pt>
                  <c:pt idx="491">
                    <c:v>2.7228934312037472E-4</c:v>
                  </c:pt>
                  <c:pt idx="492">
                    <c:v>2.8497521143648396E-4</c:v>
                  </c:pt>
                  <c:pt idx="493">
                    <c:v>2.9943352874638233E-4</c:v>
                  </c:pt>
                  <c:pt idx="494">
                    <c:v>3.1548168238682006E-4</c:v>
                  </c:pt>
                  <c:pt idx="495">
                    <c:v>3.3296658660476061E-4</c:v>
                  </c:pt>
                  <c:pt idx="496">
                    <c:v>3.517536314548107E-4</c:v>
                  </c:pt>
                  <c:pt idx="497">
                    <c:v>3.7171840599814363E-4</c:v>
                  </c:pt>
                  <c:pt idx="498">
                    <c:v>3.9274080537172838E-4</c:v>
                  </c:pt>
                  <c:pt idx="499">
                    <c:v>4.1470107931527241E-4</c:v>
                  </c:pt>
                  <c:pt idx="500">
                    <c:v>4.3747730030286452E-4</c:v>
                  </c:pt>
                  <c:pt idx="501">
                    <c:v>4.6094390435541841E-4</c:v>
                  </c:pt>
                  <c:pt idx="502">
                    <c:v>4.8497093288082108E-4</c:v>
                  </c:pt>
                  <c:pt idx="503">
                    <c:v>5.0942380492782877E-4</c:v>
                  </c:pt>
                  <c:pt idx="504">
                    <c:v>5.3416342199934133E-4</c:v>
                  </c:pt>
                  <c:pt idx="505">
                    <c:v>5.5904658125540926E-4</c:v>
                  </c:pt>
                  <c:pt idx="506">
                    <c:v>5.8392651799687577E-4</c:v>
                  </c:pt>
                  <c:pt idx="507">
                    <c:v>6.0865367553776116E-4</c:v>
                  </c:pt>
                  <c:pt idx="508">
                    <c:v>6.3307656882817726E-4</c:v>
                  </c:pt>
                  <c:pt idx="509">
                    <c:v>6.5704277016156662E-4</c:v>
                  </c:pt>
                  <c:pt idx="510">
                    <c:v>6.8039999372092601E-4</c:v>
                  </c:pt>
                  <c:pt idx="511">
                    <c:v>7.0299722022259853E-4</c:v>
                  </c:pt>
                  <c:pt idx="512">
                    <c:v>7.2468584483627253E-4</c:v>
                  </c:pt>
                  <c:pt idx="513">
                    <c:v>7.4532079578594544E-4</c:v>
                  </c:pt>
                  <c:pt idx="514">
                    <c:v>7.6476159084039677E-4</c:v>
                  </c:pt>
                  <c:pt idx="515">
                    <c:v>7.8287327612308567E-4</c:v>
                  </c:pt>
                  <c:pt idx="516">
                    <c:v>7.9952735174339316E-4</c:v>
                  </c:pt>
                  <c:pt idx="517">
                    <c:v>8.1460283113483044E-4</c:v>
                  </c:pt>
                  <c:pt idx="518">
                    <c:v>8.2798802063202895E-4</c:v>
                  </c:pt>
                  <c:pt idx="519">
                    <c:v>8.3958407796037827E-4</c:v>
                  </c:pt>
                  <c:pt idx="520">
                    <c:v>8.4931227529214787E-4</c:v>
                  </c:pt>
                  <c:pt idx="521">
                    <c:v>8.5712796319045888E-4</c:v>
                  </c:pt>
                  <c:pt idx="522">
                    <c:v>8.6304500646532307E-4</c:v>
                  </c:pt>
                  <c:pt idx="523">
                    <c:v>8.6717437020648555E-4</c:v>
                  </c:pt>
                  <c:pt idx="524">
                    <c:v>8.6977774583765364E-4</c:v>
                  </c:pt>
                  <c:pt idx="525">
                    <c:v>8.7133025188551008E-4</c:v>
                  </c:pt>
                  <c:pt idx="526">
                    <c:v>8.7257412776357564E-4</c:v>
                  </c:pt>
                  <c:pt idx="527">
                    <c:v>8.7452957842368143E-4</c:v>
                  </c:pt>
                  <c:pt idx="528">
                    <c:v>8.7841726768588522E-4</c:v>
                  </c:pt>
                  <c:pt idx="529">
                    <c:v>8.8545310842817857E-4</c:v>
                  </c:pt>
                  <c:pt idx="530">
                    <c:v>8.9651586953101898E-4</c:v>
                  </c:pt>
                  <c:pt idx="531">
                    <c:v>9.1175972176364554E-4</c:v>
                  </c:pt>
                  <c:pt idx="532">
                    <c:v>9.3031129004706185E-4</c:v>
                  </c:pt>
                  <c:pt idx="533">
                    <c:v>9.5019645470345267E-4</c:v>
                  </c:pt>
                  <c:pt idx="534">
                    <c:v>9.6856292009714763E-4</c:v>
                  </c:pt>
                  <c:pt idx="535">
                    <c:v>9.8214746287716395E-4</c:v>
                  </c:pt>
                  <c:pt idx="536">
                    <c:v>9.8785617903089109E-4</c:v>
                  </c:pt>
                  <c:pt idx="537">
                    <c:v>9.8331408505199528E-4</c:v>
                  </c:pt>
                  <c:pt idx="538">
                    <c:v>9.6727641400698688E-4</c:v>
                  </c:pt>
                  <c:pt idx="539">
                    <c:v>9.3984292476411671E-4</c:v>
                  </c:pt>
                  <c:pt idx="540">
                    <c:v>9.0245921743172723E-4</c:v>
                  </c:pt>
                  <c:pt idx="541">
                    <c:v>8.577207488594139E-4</c:v>
                  </c:pt>
                  <c:pt idx="542">
                    <c:v>8.0901693458416285E-4</c:v>
                  </c:pt>
                  <c:pt idx="543">
                    <c:v>7.6006652497097012E-4</c:v>
                  </c:pt>
                  <c:pt idx="544">
                    <c:v>7.1440646331462538E-4</c:v>
                  </c:pt>
                  <c:pt idx="545">
                    <c:v>6.749110992216302E-4</c:v>
                  </c:pt>
                  <c:pt idx="546">
                    <c:v>6.4343651653358625E-4</c:v>
                  </c:pt>
                  <c:pt idx="547">
                    <c:v>6.2068390133816222E-4</c:v>
                  </c:pt>
                  <c:pt idx="548">
                    <c:v>6.0632276410159543E-4</c:v>
                  </c:pt>
                  <c:pt idx="549">
                    <c:v>5.9931336309012825E-4</c:v>
                  </c:pt>
                  <c:pt idx="550">
                    <c:v>5.9828587498948955E-4</c:v>
                  </c:pt>
                  <c:pt idx="551">
                    <c:v>6.0183961088287375E-4</c:v>
                  </c:pt>
                  <c:pt idx="552">
                    <c:v>6.0870316490532371E-4</c:v>
                  </c:pt>
                  <c:pt idx="553">
                    <c:v>6.1777540511274835E-4</c:v>
                  </c:pt>
                  <c:pt idx="554">
                    <c:v>6.2810139938413551E-4</c:v>
                  </c:pt>
                  <c:pt idx="555">
                    <c:v>6.3883170561496736E-4</c:v>
                  </c:pt>
                  <c:pt idx="556">
                    <c:v>6.4919222992516608E-4</c:v>
                  </c:pt>
                  <c:pt idx="557">
                    <c:v>6.5847321492352269E-4</c:v>
                  </c:pt>
                  <c:pt idx="558">
                    <c:v>6.6603511656364875E-4</c:v>
                  </c:pt>
                  <c:pt idx="559">
                    <c:v>6.7132560498707342E-4</c:v>
                  </c:pt>
                  <c:pt idx="560">
                    <c:v>6.7390189587132566E-4</c:v>
                  </c:pt>
                  <c:pt idx="561">
                    <c:v>6.7345402990099485E-4</c:v>
                  </c:pt>
                  <c:pt idx="562">
                    <c:v>6.698261569094339E-4</c:v>
                  </c:pt>
                  <c:pt idx="563">
                    <c:v>6.6303375477397655E-4</c:v>
                  </c:pt>
                  <c:pt idx="564">
                    <c:v>6.5327508756011675E-4</c:v>
                  </c:pt>
                  <c:pt idx="565">
                    <c:v>6.4093530616847548E-4</c:v>
                  </c:pt>
                  <c:pt idx="566">
                    <c:v>6.2658124129618721E-4</c:v>
                  </c:pt>
                  <c:pt idx="567">
                    <c:v>6.1094457867704127E-4</c:v>
                  </c:pt>
                  <c:pt idx="568">
                    <c:v>5.9489051235263758E-4</c:v>
                  </c:pt>
                  <c:pt idx="569">
                    <c:v>5.7936910260461517E-4</c:v>
                  </c:pt>
                  <c:pt idx="570">
                    <c:v>5.653478433969301E-4</c:v>
                  </c:pt>
                  <c:pt idx="571">
                    <c:v>5.5372752765645472E-4</c:v>
                  </c:pt>
                  <c:pt idx="572">
                    <c:v>5.4524992145252359E-4</c:v>
                  </c:pt>
                  <c:pt idx="573">
                    <c:v>5.404130407499491E-4</c:v>
                  </c:pt>
                  <c:pt idx="574">
                    <c:v>5.394140232852703E-4</c:v>
                  </c:pt>
                  <c:pt idx="575">
                    <c:v>5.421359436179801E-4</c:v>
                  </c:pt>
                  <c:pt idx="576">
                    <c:v>5.4818251451935131E-4</c:v>
                  </c:pt>
                  <c:pt idx="577">
                    <c:v>5.5694941238091863E-4</c:v>
                  </c:pt>
                  <c:pt idx="578">
                    <c:v>5.6771135469158105E-4</c:v>
                  </c:pt>
                  <c:pt idx="579">
                    <c:v>5.7970408903249763E-4</c:v>
                  </c:pt>
                  <c:pt idx="580">
                    <c:v>5.9218802828230554E-4</c:v>
                  </c:pt>
                  <c:pt idx="581">
                    <c:v>6.0448932441086519E-4</c:v>
                  </c:pt>
                  <c:pt idx="582">
                    <c:v>6.1602079405560805E-4</c:v>
                  </c:pt>
                  <c:pt idx="583">
                    <c:v>6.2628819010906859E-4</c:v>
                  </c:pt>
                  <c:pt idx="584">
                    <c:v>6.3488774883657564E-4</c:v>
                  </c:pt>
                  <c:pt idx="585">
                    <c:v>6.4149998023759099E-4</c:v>
                  </c:pt>
                  <c:pt idx="586">
                    <c:v>6.4588342688330646E-4</c:v>
                  </c:pt>
                  <c:pt idx="587">
                    <c:v>6.4787093833567374E-4</c:v>
                  </c:pt>
                  <c:pt idx="588">
                    <c:v>6.4737010769203593E-4</c:v>
                  </c:pt>
                  <c:pt idx="589">
                    <c:v>6.44368735376192E-4</c:v>
                  </c:pt>
                  <c:pt idx="590">
                    <c:v>6.3894538600412897E-4</c:v>
                  </c:pt>
                  <c:pt idx="591">
                    <c:v>6.3128401521148352E-4</c:v>
                  </c:pt>
                  <c:pt idx="592">
                    <c:v>6.2169027218481759E-4</c:v>
                  </c:pt>
                  <c:pt idx="593">
                    <c:v>6.1060495535706293E-4</c:v>
                  </c:pt>
                  <c:pt idx="594">
                    <c:v>5.9860755238162863E-4</c:v>
                  </c:pt>
                  <c:pt idx="595">
                    <c:v>5.8640050590354914E-4</c:v>
                  </c:pt>
                  <c:pt idx="596">
                    <c:v>5.7476383918729707E-4</c:v>
                  </c:pt>
                  <c:pt idx="597">
                    <c:v>5.6447282851140141E-4</c:v>
                  </c:pt>
                  <c:pt idx="598">
                    <c:v>5.5618067373075758E-4</c:v>
                  </c:pt>
                  <c:pt idx="599">
                    <c:v>5.5028389632816093E-4</c:v>
                  </c:pt>
                  <c:pt idx="600">
                    <c:v>5.4680463364164655E-4</c:v>
                  </c:pt>
                  <c:pt idx="601">
                    <c:v>5.4533064477907595E-4</c:v>
                  </c:pt>
                  <c:pt idx="602">
                    <c:v>5.4504128138199183E-4</c:v>
                  </c:pt>
                  <c:pt idx="603">
                    <c:v>5.4481996158335167E-4</c:v>
                  </c:pt>
                  <c:pt idx="604">
                    <c:v>5.4342595082044283E-4</c:v>
                  </c:pt>
                  <c:pt idx="605">
                    <c:v>5.3968536468155029E-4</c:v>
                  </c:pt>
                  <c:pt idx="606">
                    <c:v>5.3266560948056106E-4</c:v>
                  </c:pt>
                  <c:pt idx="607">
                    <c:v>5.2181060725001291E-4</c:v>
                  </c:pt>
                  <c:pt idx="608">
                    <c:v>5.0702722376229999E-4</c:v>
                  </c:pt>
                  <c:pt idx="609">
                    <c:v>4.8872172503260081E-4</c:v>
                  </c:pt>
                  <c:pt idx="610">
                    <c:v>4.677883530405173E-4</c:v>
                  </c:pt>
                  <c:pt idx="611">
                    <c:v>4.4555113513306666E-4</c:v>
                  </c:pt>
                  <c:pt idx="612">
                    <c:v>4.2365558438625612E-4</c:v>
                  </c:pt>
                  <c:pt idx="613">
                    <c:v>4.0390214298260306E-4</c:v>
                  </c:pt>
                  <c:pt idx="614">
                    <c:v>3.8801636544081171E-4</c:v>
                  </c:pt>
                  <c:pt idx="615">
                    <c:v>3.773750174224141E-4</c:v>
                  </c:pt>
                  <c:pt idx="616">
                    <c:v>3.7275528480734026E-4</c:v>
                  </c:pt>
                  <c:pt idx="617">
                    <c:v>3.7421028175980492E-4</c:v>
                  </c:pt>
                  <c:pt idx="618">
                    <c:v>3.8113967917341614E-4</c:v>
                  </c:pt>
                  <c:pt idx="619">
                    <c:v>3.9252054190566318E-4</c:v>
                  </c:pt>
                  <c:pt idx="620">
                    <c:v>4.0718162522102648E-4</c:v>
                  </c:pt>
                  <c:pt idx="621">
                    <c:v>4.2401477020013892E-4</c:v>
                  </c:pt>
                  <c:pt idx="622">
                    <c:v>4.4208517960560387E-4</c:v>
                  </c:pt>
                  <c:pt idx="623">
                    <c:v>4.6065806880441195E-4</c:v>
                  </c:pt>
                  <c:pt idx="624">
                    <c:v>4.7917765174448397E-4</c:v>
                  </c:pt>
                  <c:pt idx="625">
                    <c:v>4.9722862222025064E-4</c:v>
                  </c:pt>
                  <c:pt idx="626">
                    <c:v>5.1449825691167223E-4</c:v>
                  </c:pt>
                  <c:pt idx="627">
                    <c:v>5.307472587451872E-4</c:v>
                  </c:pt>
                  <c:pt idx="628">
                    <c:v>5.4579167031611176E-4</c:v>
                  </c:pt>
                  <c:pt idx="629">
                    <c:v>5.5949496591067784E-4</c:v>
                  </c:pt>
                  <c:pt idx="630">
                    <c:v>5.7176812104486733E-4</c:v>
                  </c:pt>
                  <c:pt idx="631">
                    <c:v>5.8257463983506707E-4</c:v>
                  </c:pt>
                  <c:pt idx="632">
                    <c:v>5.9193700519904135E-4</c:v>
                  </c:pt>
                  <c:pt idx="633">
                    <c:v>5.9994027325832274E-4</c:v>
                  </c:pt>
                  <c:pt idx="634">
                    <c:v>6.0672818303954246E-4</c:v>
                  </c:pt>
                  <c:pt idx="635">
                    <c:v>6.1248723207878056E-4</c:v>
                  </c:pt>
                  <c:pt idx="636">
                    <c:v>6.1741577189501943E-4</c:v>
                  </c:pt>
                  <c:pt idx="637">
                    <c:v>6.2167843779089465E-4</c:v>
                  </c:pt>
                  <c:pt idx="638">
                    <c:v>6.2535125243066438E-4</c:v>
                  </c:pt>
                  <c:pt idx="639">
                    <c:v>6.2836804897674911E-4</c:v>
                  </c:pt>
                  <c:pt idx="640">
                    <c:v>6.3048241693151842E-4</c:v>
                  </c:pt>
                  <c:pt idx="641">
                    <c:v>6.3125877454853435E-4</c:v>
                  </c:pt>
                  <c:pt idx="642">
                    <c:v>6.3010062226842361E-4</c:v>
                  </c:pt>
                  <c:pt idx="643">
                    <c:v>6.2631500293804663E-4</c:v>
                  </c:pt>
                  <c:pt idx="644">
                    <c:v>6.1920308060133575E-4</c:v>
                  </c:pt>
                  <c:pt idx="645">
                    <c:v>6.081605125732144E-4</c:v>
                  </c:pt>
                  <c:pt idx="646">
                    <c:v>5.9276972772811024E-4</c:v>
                  </c:pt>
                  <c:pt idx="647">
                    <c:v>5.7286885777387106E-4</c:v>
                  </c:pt>
                  <c:pt idx="648">
                    <c:v>5.4858725743823762E-4</c:v>
                  </c:pt>
                  <c:pt idx="649">
                    <c:v>5.2034387338805333E-4</c:v>
                  </c:pt>
                  <c:pt idx="650">
                    <c:v>4.8881055603887684E-4</c:v>
                  </c:pt>
                  <c:pt idx="651">
                    <c:v>4.5484732463527068E-4</c:v>
                  </c:pt>
                  <c:pt idx="652">
                    <c:v>4.1941996876027662E-4</c:v>
                  </c:pt>
                  <c:pt idx="653">
                    <c:v>3.8351209690097669E-4</c:v>
                  </c:pt>
                  <c:pt idx="654">
                    <c:v>3.4804405480958302E-4</c:v>
                  </c:pt>
                  <c:pt idx="655">
                    <c:v>3.1381019791720864E-4</c:v>
                  </c:pt>
                  <c:pt idx="656">
                    <c:v>2.81444162955216E-4</c:v>
                  </c:pt>
                  <c:pt idx="657">
                    <c:v>2.5141952756825434E-4</c:v>
                  </c:pt>
                  <c:pt idx="658">
                    <c:v>2.2409108473618789E-4</c:v>
                  </c:pt>
                  <c:pt idx="659">
                    <c:v>1.9977948398505638E-4</c:v>
                  </c:pt>
                  <c:pt idx="660">
                    <c:v>1.7889710345018623E-4</c:v>
                  </c:pt>
                  <c:pt idx="661">
                    <c:v>1.6209691944708401E-4</c:v>
                  </c:pt>
                  <c:pt idx="662">
                    <c:v>1.5037983551429579E-4</c:v>
                  </c:pt>
                  <c:pt idx="663">
                    <c:v>1.4501605597070396E-4</c:v>
                  </c:pt>
                  <c:pt idx="664">
                    <c:v>1.4713612847155229E-4</c:v>
                  </c:pt>
                  <c:pt idx="665">
                    <c:v>1.5714987930492895E-4</c:v>
                  </c:pt>
                  <c:pt idx="666">
                    <c:v>1.7450688555178067E-4</c:v>
                  </c:pt>
                  <c:pt idx="667">
                    <c:v>1.9799211688701406E-4</c:v>
                  </c:pt>
                  <c:pt idx="668">
                    <c:v>2.2615992367131104E-4</c:v>
                  </c:pt>
                  <c:pt idx="669">
                    <c:v>2.5756957145235741E-4</c:v>
                  </c:pt>
                  <c:pt idx="670">
                    <c:v>2.9083254895474221E-4</c:v>
                  </c:pt>
                  <c:pt idx="671">
                    <c:v>3.2459146087421607E-4</c:v>
                  </c:pt>
                  <c:pt idx="672">
                    <c:v>3.5750308666518133E-4</c:v>
                  </c:pt>
                  <c:pt idx="673">
                    <c:v>3.8824774060035457E-4</c:v>
                  </c:pt>
                  <c:pt idx="674">
                    <c:v>4.1556400323157174E-4</c:v>
                  </c:pt>
                  <c:pt idx="675">
                    <c:v>4.3830060948695009E-4</c:v>
                  </c:pt>
                  <c:pt idx="676">
                    <c:v>4.554757515632011E-4</c:v>
                  </c:pt>
                  <c:pt idx="677">
                    <c:v>4.6633450503633718E-4</c:v>
                  </c:pt>
                  <c:pt idx="678">
                    <c:v>4.7039626464820031E-4</c:v>
                  </c:pt>
                  <c:pt idx="679">
                    <c:v>4.6748591648133685E-4</c:v>
                  </c:pt>
                  <c:pt idx="680">
                    <c:v>4.5774461621048032E-4</c:v>
                  </c:pt>
                  <c:pt idx="681">
                    <c:v>4.4161858599197008E-4</c:v>
                  </c:pt>
                  <c:pt idx="682">
                    <c:v>4.1982696263761756E-4</c:v>
                  </c:pt>
                  <c:pt idx="683">
                    <c:v>3.9331192187629311E-4</c:v>
                  </c:pt>
                  <c:pt idx="684">
                    <c:v>3.6317635881565882E-4</c:v>
                  </c:pt>
                  <c:pt idx="685">
                    <c:v>3.3061534788091757E-4</c:v>
                  </c:pt>
                  <c:pt idx="686">
                    <c:v>2.9684816415004713E-4</c:v>
                  </c:pt>
                  <c:pt idx="687">
                    <c:v>2.6305694830461312E-4</c:v>
                  </c:pt>
                  <c:pt idx="688">
                    <c:v>2.3033690783616539E-4</c:v>
                  </c:pt>
                  <c:pt idx="689">
                    <c:v>1.9966046621843308E-4</c:v>
                  </c:pt>
                  <c:pt idx="690">
                    <c:v>1.7185431376617497E-4</c:v>
                  </c:pt>
                  <c:pt idx="691">
                    <c:v>1.4758294604511231E-4</c:v>
                  </c:pt>
                  <c:pt idx="692">
                    <c:v>1.2732571336836882E-4</c:v>
                  </c:pt>
                  <c:pt idx="693">
                    <c:v>1.1133141737473098E-4</c:v>
                  </c:pt>
                  <c:pt idx="694">
                    <c:v>9.9548426885060615E-5</c:v>
                  </c:pt>
                  <c:pt idx="695">
                    <c:v>9.1569773014282783E-5</c:v>
                  </c:pt>
                  <c:pt idx="696">
                    <c:v>8.6667988088627807E-5</c:v>
                  </c:pt>
                  <c:pt idx="697">
                    <c:v>8.3949085952096046E-5</c:v>
                  </c:pt>
                  <c:pt idx="698">
                    <c:v>8.254988301978503E-5</c:v>
                  </c:pt>
                  <c:pt idx="699">
                    <c:v>8.1772914519376313E-5</c:v>
                  </c:pt>
                  <c:pt idx="700">
                    <c:v>8.1125440227365121E-5</c:v>
                  </c:pt>
                  <c:pt idx="701">
                    <c:v>8.0295294588747401E-5</c:v>
                  </c:pt>
                  <c:pt idx="702">
                    <c:v>7.9105761074592192E-5</c:v>
                  </c:pt>
                  <c:pt idx="703">
                    <c:v>7.7473308302998875E-5</c:v>
                  </c:pt>
                  <c:pt idx="704">
                    <c:v>7.5375673948824485E-5</c:v>
                  </c:pt>
                  <c:pt idx="705">
                    <c:v>7.2830054170561678E-5</c:v>
                  </c:pt>
                  <c:pt idx="706">
                    <c:v>6.9878778793008975E-5</c:v>
                  </c:pt>
                  <c:pt idx="707">
                    <c:v>6.658002881890347E-5</c:v>
                  </c:pt>
                  <c:pt idx="708">
                    <c:v>6.3001663170832582E-5</c:v>
                  </c:pt>
                  <c:pt idx="709">
                    <c:v>5.9216934303254416E-5</c:v>
                  </c:pt>
                  <c:pt idx="710">
                    <c:v>5.5301404111430691E-5</c:v>
                  </c:pt>
                  <c:pt idx="711">
                    <c:v>5.1330587632441362E-5</c:v>
                  </c:pt>
                  <c:pt idx="712">
                    <c:v>4.737820730625128E-5</c:v>
                  </c:pt>
                  <c:pt idx="713">
                    <c:v>4.3514843464593489E-5</c:v>
                  </c:pt>
                  <c:pt idx="714">
                    <c:v>3.9806986912245995E-5</c:v>
                  </c:pt>
                  <c:pt idx="715">
                    <c:v>3.6316349796812117E-5</c:v>
                  </c:pt>
                  <c:pt idx="716">
                    <c:v>3.3099265822584765E-5</c:v>
                  </c:pt>
                  <c:pt idx="717">
                    <c:v>3.0205918847098092E-5</c:v>
                  </c:pt>
                  <c:pt idx="718">
                    <c:v>2.7679019858367934E-5</c:v>
                  </c:pt>
                  <c:pt idx="719">
                    <c:v>2.5551609582730867E-5</c:v>
                  </c:pt>
                  <c:pt idx="720">
                    <c:v>2.3843914945111342E-5</c:v>
                  </c:pt>
                  <c:pt idx="721">
                    <c:v>2.2559886915864988E-5</c:v>
                  </c:pt>
                  <c:pt idx="722">
                    <c:v>2.1684880092233443E-5</c:v>
                  </c:pt>
                  <c:pt idx="723">
                    <c:v>2.118617041656967E-5</c:v>
                  </c:pt>
                  <c:pt idx="724">
                    <c:v>2.1017120642163606E-5</c:v>
                  </c:pt>
                  <c:pt idx="725">
                    <c:v>2.1123935620595052E-5</c:v>
                  </c:pt>
                  <c:pt idx="726">
                    <c:v>2.1452737773609705E-5</c:v>
                  </c:pt>
                  <c:pt idx="727">
                    <c:v>2.1954955087901799E-5</c:v>
                  </c:pt>
                  <c:pt idx="728">
                    <c:v>2.2590164169200074E-5</c:v>
                  </c:pt>
                  <c:pt idx="729">
                    <c:v>2.3326738429035055E-5</c:v>
                  </c:pt>
                  <c:pt idx="730">
                    <c:v>2.4141108245166629E-5</c:v>
                  </c:pt>
                  <c:pt idx="731">
                    <c:v>2.5016355572335511E-5</c:v>
                  </c:pt>
                  <c:pt idx="732">
                    <c:v>2.5940726169012792E-5</c:v>
                  </c:pt>
                  <c:pt idx="733">
                    <c:v>2.6906252594409849E-5</c:v>
                  </c:pt>
                  <c:pt idx="734">
                    <c:v>2.7907652452392317E-5</c:v>
                  </c:pt>
                  <c:pt idx="735">
                    <c:v>2.8941479262773595E-5</c:v>
                  </c:pt>
                  <c:pt idx="736">
                    <c:v>3.0005491338022926E-5</c:v>
                  </c:pt>
                  <c:pt idx="737">
                    <c:v>3.1098214755842578E-5</c:v>
                  </c:pt>
                  <c:pt idx="738">
                    <c:v>3.2218637117827248E-5</c:v>
                  </c:pt>
                  <c:pt idx="739">
                    <c:v>3.3365994638185789E-5</c:v>
                  </c:pt>
                  <c:pt idx="740">
                    <c:v>3.4539642686332879E-5</c:v>
                  </c:pt>
                  <c:pt idx="741">
                    <c:v>3.5738971339947809E-5</c:v>
                  </c:pt>
                  <c:pt idx="742">
                    <c:v>3.6963345822934733E-5</c:v>
                  </c:pt>
                  <c:pt idx="743">
                    <c:v>3.8212079338660532E-5</c:v>
                  </c:pt>
                  <c:pt idx="744">
                    <c:v>3.9484404629980668E-5</c:v>
                  </c:pt>
                  <c:pt idx="745">
                    <c:v>4.0779470912767443E-5</c:v>
                  </c:pt>
                  <c:pt idx="746">
                    <c:v>4.209633608559805E-5</c:v>
                  </c:pt>
                  <c:pt idx="747">
                    <c:v>4.3433967559174832E-5</c:v>
                  </c:pt>
                  <c:pt idx="748">
                    <c:v>4.4791232990272798E-5</c:v>
                  </c:pt>
                  <c:pt idx="749">
                    <c:v>4.6166906994440095E-5</c:v>
                  </c:pt>
                  <c:pt idx="750">
                    <c:v>4.7559678442764089E-5</c:v>
                  </c:pt>
                  <c:pt idx="751">
                    <c:v>4.8968142369030467E-5</c:v>
                  </c:pt>
                  <c:pt idx="752">
                    <c:v>5.039081061633056E-5</c:v>
                  </c:pt>
                  <c:pt idx="753">
                    <c:v>5.1826099839544457E-5</c:v>
                  </c:pt>
                  <c:pt idx="754">
                    <c:v>5.3272362142201271E-5</c:v>
                  </c:pt>
                  <c:pt idx="755">
                    <c:v>5.4727860082500344E-5</c:v>
                  </c:pt>
                  <c:pt idx="756">
                    <c:v>5.6190790429991915E-5</c:v>
                  </c:pt>
                  <c:pt idx="757">
                    <c:v>5.7659275512331995E-5</c:v>
                  </c:pt>
                  <c:pt idx="758">
                    <c:v>5.9131380562691935E-5</c:v>
                  </c:pt>
                  <c:pt idx="759">
                    <c:v>6.0605105125037473E-5</c:v>
                  </c:pt>
                  <c:pt idx="760">
                    <c:v>6.2078400460018022E-5</c:v>
                  </c:pt>
                  <c:pt idx="761">
                    <c:v>6.3549171138855174E-5</c:v>
                  </c:pt>
                  <c:pt idx="762">
                    <c:v>6.5015282657560118E-5</c:v>
                  </c:pt>
                  <c:pt idx="763">
                    <c:v>6.647455953244898E-5</c:v>
                  </c:pt>
                  <c:pt idx="764">
                    <c:v>6.7924813650249873E-5</c:v>
                  </c:pt>
                  <c:pt idx="765">
                    <c:v>6.9363825767248234E-5</c:v>
                  </c:pt>
                  <c:pt idx="766">
                    <c:v>7.0789380661159213E-5</c:v>
                  </c:pt>
                  <c:pt idx="767">
                    <c:v>7.2199245852379299E-5</c:v>
                  </c:pt>
                  <c:pt idx="768">
                    <c:v>7.3591216452775673E-5</c:v>
                  </c:pt>
                  <c:pt idx="769">
                    <c:v>7.4963088384067664E-5</c:v>
                  </c:pt>
                  <c:pt idx="770">
                    <c:v>7.6312693064368683E-5</c:v>
                  </c:pt>
                  <c:pt idx="771">
                    <c:v>7.7637900289229358E-5</c:v>
                  </c:pt>
                  <c:pt idx="772">
                    <c:v>7.8936621232165053E-5</c:v>
                  </c:pt>
                  <c:pt idx="773">
                    <c:v>8.0206830532589395E-5</c:v>
                  </c:pt>
                  <c:pt idx="774">
                    <c:v>8.1446563150820768E-5</c:v>
                  </c:pt>
                  <c:pt idx="775">
                    <c:v>8.2653939903688675E-5</c:v>
                  </c:pt>
                  <c:pt idx="776">
                    <c:v>8.3827164529641656E-5</c:v>
                  </c:pt>
                  <c:pt idx="777">
                    <c:v>8.496454921780613E-5</c:v>
                  </c:pt>
                  <c:pt idx="778">
                    <c:v>8.6064498448249494E-5</c:v>
                  </c:pt>
                  <c:pt idx="779">
                    <c:v>8.7125554035389103E-5</c:v>
                  </c:pt>
                  <c:pt idx="780">
                    <c:v>8.8146372835757892E-5</c:v>
                  </c:pt>
                  <c:pt idx="781">
                    <c:v>8.9125760844784932E-5</c:v>
                  </c:pt>
                  <c:pt idx="782">
                    <c:v>9.0062656836189517E-5</c:v>
                  </c:pt>
                  <c:pt idx="783">
                    <c:v>9.0956167141567555E-5</c:v>
                  </c:pt>
                  <c:pt idx="784">
                    <c:v>9.1805553335678919E-5</c:v>
                  </c:pt>
                  <c:pt idx="785">
                    <c:v>9.2610244726691016E-5</c:v>
                  </c:pt>
                  <c:pt idx="786">
                    <c:v>9.3369846229591981E-5</c:v>
                  </c:pt>
                  <c:pt idx="787">
                    <c:v>9.4084140781256934E-5</c:v>
                  </c:pt>
                  <c:pt idx="788">
                    <c:v>9.475308996046378E-5</c:v>
                  </c:pt>
                  <c:pt idx="789">
                    <c:v>9.5376837889164697E-5</c:v>
                  </c:pt>
                  <c:pt idx="790">
                    <c:v>9.5955715728476756E-5</c:v>
                  </c:pt>
                  <c:pt idx="791">
                    <c:v>9.649022387709028E-5</c:v>
                  </c:pt>
                  <c:pt idx="792">
                    <c:v>9.6981051965605157E-5</c:v>
                  </c:pt>
                  <c:pt idx="793">
                    <c:v>9.7429055019729338E-5</c:v>
                  </c:pt>
                  <c:pt idx="794">
                    <c:v>9.7835252253368422E-5</c:v>
                  </c:pt>
                  <c:pt idx="795">
                    <c:v>9.8200817759278833E-5</c:v>
                  </c:pt>
                  <c:pt idx="796">
                    <c:v>9.8527069570368848E-5</c:v>
                  </c:pt>
                  <c:pt idx="797">
                    <c:v>9.8815443163688602E-5</c:v>
                  </c:pt>
                  <c:pt idx="798">
                    <c:v>9.9067496285173932E-5</c:v>
                  </c:pt>
                  <c:pt idx="799">
                    <c:v>9.9284866231525535E-5</c:v>
                  </c:pt>
                  <c:pt idx="800">
                    <c:v>9.9469254147541614E-5</c:v>
                  </c:pt>
                  <c:pt idx="801">
                    <c:v>9.9622400193334677E-5</c:v>
                  </c:pt>
                  <c:pt idx="802">
                    <c:v>9.9746049199882656E-5</c:v>
                  </c:pt>
                  <c:pt idx="803">
                    <c:v>9.9841911891147847E-5</c:v>
                  </c:pt>
                  <c:pt idx="804">
                    <c:v>9.9911631330181072E-5</c:v>
                  </c:pt>
                  <c:pt idx="805">
                    <c:v>9.9956748256087383E-5</c:v>
                  </c:pt>
                  <c:pt idx="806">
                    <c:v>9.997864536988573E-5</c:v>
                  </c:pt>
                  <c:pt idx="807">
                    <c:v>9.9978544265260448E-5</c:v>
                  </c:pt>
                  <c:pt idx="808">
                    <c:v>9.9957460063941728E-5</c:v>
                  </c:pt>
                  <c:pt idx="809">
                    <c:v>9.9916266997357217E-5</c:v>
                  </c:pt>
                  <c:pt idx="810">
                    <c:v>9.9855786588888139E-5</c:v>
                  </c:pt>
                  <c:pt idx="811">
                    <c:v>9.9777030869752532E-5</c:v>
                  </c:pt>
                  <c:pt idx="812">
                    <c:v>9.9681686383627869E-5</c:v>
                  </c:pt>
                  <c:pt idx="813">
                    <c:v>9.9572932551201978E-5</c:v>
                  </c:pt>
                  <c:pt idx="814">
                    <c:v>9.9456824645458938E-5</c:v>
                  </c:pt>
                  <c:pt idx="815">
                    <c:v>9.9344500656468543E-5</c:v>
                  </c:pt>
                  <c:pt idx="816">
                    <c:v>9.9255492149657871E-5</c:v>
                  </c:pt>
                  <c:pt idx="817">
                    <c:v>9.9222547304511817E-5</c:v>
                  </c:pt>
                  <c:pt idx="818">
                    <c:v>9.929827278893609E-5</c:v>
                  </c:pt>
                  <c:pt idx="819">
                    <c:v>9.9563636352089087E-5</c:v>
                  </c:pt>
                  <c:pt idx="820">
                    <c:v>1.0013799943385751E-4</c:v>
                  </c:pt>
                  <c:pt idx="821">
                    <c:v>1.011891770505088E-4</c:v>
                  </c:pt>
                  <c:pt idx="822">
                    <c:v>1.0294069019706768E-4</c:v>
                  </c:pt>
                  <c:pt idx="823">
                    <c:v>1.0567168326098579E-4</c:v>
                  </c:pt>
                  <c:pt idx="824">
                    <c:v>1.0970444582392291E-4</c:v>
                  </c:pt>
                  <c:pt idx="825">
                    <c:v>1.1537661702991275E-4</c:v>
                  </c:pt>
                  <c:pt idx="826">
                    <c:v>1.2300084020772285E-4</c:v>
                  </c:pt>
                  <c:pt idx="827">
                    <c:v>1.3282152174087208E-4</c:v>
                  </c:pt>
                  <c:pt idx="828">
                    <c:v>1.4498084067384319E-4</c:v>
                  </c:pt>
                  <c:pt idx="829">
                    <c:v>1.5950191836525208E-4</c:v>
                  </c:pt>
                  <c:pt idx="830">
                    <c:v>1.7628848870615964E-4</c:v>
                  </c:pt>
                  <c:pt idx="831">
                    <c:v>1.9513494640536943E-4</c:v>
                  </c:pt>
                  <c:pt idx="832">
                    <c:v>2.1574009218263668E-4</c:v>
                  </c:pt>
                  <c:pt idx="833">
                    <c:v>2.3772089124962631E-4</c:v>
                  </c:pt>
                  <c:pt idx="834">
                    <c:v>2.6062541839239121E-4</c:v>
                  </c:pt>
                  <c:pt idx="835">
                    <c:v>2.8394588431131007E-4</c:v>
                  </c:pt>
                  <c:pt idx="836">
                    <c:v>3.0713278585986167E-4</c:v>
                  </c:pt>
                  <c:pt idx="837">
                    <c:v>3.2961103893338288E-4</c:v>
                  </c:pt>
                  <c:pt idx="838">
                    <c:v>3.507982113409997E-4</c:v>
                  </c:pt>
                  <c:pt idx="839">
                    <c:v>3.7012450826042934E-4</c:v>
                  </c:pt>
                  <c:pt idx="840">
                    <c:v>3.8705370073518938E-4</c:v>
                  </c:pt>
                  <c:pt idx="841">
                    <c:v>4.0110392219372935E-4</c:v>
                  </c:pt>
                  <c:pt idx="842">
                    <c:v>4.1186714215924938E-4</c:v>
                  </c:pt>
                  <c:pt idx="843">
                    <c:v>4.1902605668312355E-4</c:v>
                  </c:pt>
                  <c:pt idx="844">
                    <c:v>4.2236734541068447E-4</c:v>
                  </c:pt>
                  <c:pt idx="845">
                    <c:v>4.2179037825592898E-4</c:v>
                  </c:pt>
                  <c:pt idx="846">
                    <c:v>4.1731082757183382E-4</c:v>
                  </c:pt>
                  <c:pt idx="847">
                    <c:v>4.0905889255912786E-4</c:v>
                  </c:pt>
                  <c:pt idx="848">
                    <c:v>3.9727230633390204E-4</c:v>
                  </c:pt>
                  <c:pt idx="849">
                    <c:v>3.822845484802226E-4</c:v>
                  </c:pt>
                  <c:pt idx="850">
                    <c:v>3.6450910541644137E-4</c:v>
                  </c:pt>
                  <c:pt idx="851">
                    <c:v>3.4442069095529017E-4</c:v>
                  </c:pt>
                  <c:pt idx="852">
                    <c:v>3.2253471688751048E-4</c:v>
                  </c:pt>
                  <c:pt idx="853">
                    <c:v>2.9938611283055589E-4</c:v>
                  </c:pt>
                  <c:pt idx="854">
                    <c:v>2.7550880441896801E-4</c:v>
                  </c:pt>
                  <c:pt idx="855">
                    <c:v>2.5141679654160423E-4</c:v>
                  </c:pt>
                  <c:pt idx="856">
                    <c:v>2.2758784430406109E-4</c:v>
                  </c:pt>
                  <c:pt idx="857">
                    <c:v>2.044502117996489E-4</c:v>
                  </c:pt>
                  <c:pt idx="858">
                    <c:v>1.8237294717583623E-4</c:v>
                  </c:pt>
                  <c:pt idx="859">
                    <c:v>1.6165963262954262E-4</c:v>
                  </c:pt>
                  <c:pt idx="860">
                    <c:v>1.4254538285820811E-4</c:v>
                  </c:pt>
                  <c:pt idx="861">
                    <c:v>1.2519656024098858E-4</c:v>
                  </c:pt>
                  <c:pt idx="862">
                    <c:v>1.0971247403441933E-4</c:v>
                  </c:pt>
                  <c:pt idx="863">
                    <c:v>9.6128327556536987E-5</c:v>
                  </c:pt>
                  <c:pt idx="864">
                    <c:v>8.4418804181823147E-5</c:v>
                  </c:pt>
                  <c:pt idx="865">
                    <c:v>7.4502210010830692E-5</c:v>
                  </c:pt>
                  <c:pt idx="866">
                    <c:v>6.6245853448576852E-5</c:v>
                  </c:pt>
                  <c:pt idx="867">
                    <c:v>5.9474133793225827E-5</c:v>
                  </c:pt>
                  <c:pt idx="868">
                    <c:v>5.3980735182655417E-5</c:v>
                  </c:pt>
                  <c:pt idx="869">
                    <c:v>4.9545004383835974E-5</c:v>
                  </c:pt>
                  <c:pt idx="870">
                    <c:v>4.5950465981003674E-5</c:v>
                  </c:pt>
                  <c:pt idx="871">
                    <c:v>4.3001963225610632E-5</c:v>
                  </c:pt>
                  <c:pt idx="872">
                    <c:v>4.0538502001906763E-5</c:v>
                  </c:pt>
                  <c:pt idx="873">
                    <c:v>3.8441091979785828E-5</c:v>
                  </c:pt>
                  <c:pt idx="874">
                    <c:v>3.6637313923724352E-5</c:v>
                  </c:pt>
                  <c:pt idx="875">
                    <c:v>3.5105668225334953E-5</c:v>
                  </c:pt>
                  <c:pt idx="876">
                    <c:v>3.3882368209693237E-5</c:v>
                  </c:pt>
                  <c:pt idx="877">
                    <c:v>3.3071179401474473E-5</c:v>
                  </c:pt>
                  <c:pt idx="878">
                    <c:v>3.2851985556568296E-5</c:v>
                  </c:pt>
                  <c:pt idx="879">
                    <c:v>3.3476800427231422E-5</c:v>
                  </c:pt>
                  <c:pt idx="880">
                    <c:v>3.5238761384688733E-5</c:v>
                  </c:pt>
                  <c:pt idx="881">
                    <c:v>3.8413673068768607E-5</c:v>
                  </c:pt>
                  <c:pt idx="882">
                    <c:v>4.3201889350728622E-5</c:v>
                  </c:pt>
                  <c:pt idx="883">
                    <c:v>4.9705450589798823E-5</c:v>
                  </c:pt>
                  <c:pt idx="884">
                    <c:v>5.7943260071767911E-5</c:v>
                  </c:pt>
                  <c:pt idx="885">
                    <c:v>6.7878066218426917E-5</c:v>
                  </c:pt>
                  <c:pt idx="886">
                    <c:v>7.9433805629085846E-5</c:v>
                  </c:pt>
                  <c:pt idx="887">
                    <c:v>9.2499662929017775E-5</c:v>
                  </c:pt>
                  <c:pt idx="888">
                    <c:v>1.0692616641001894E-4</c:v>
                  </c:pt>
                  <c:pt idx="889">
                    <c:v>1.2251913610980715E-4</c:v>
                  </c:pt>
                  <c:pt idx="890">
                    <c:v>1.3903503249379016E-4</c:v>
                  </c:pt>
                  <c:pt idx="891">
                    <c:v>1.5617952722192188E-4</c:v>
                  </c:pt>
                  <c:pt idx="892">
                    <c:v>1.7361012068417176E-4</c:v>
                  </c:pt>
                  <c:pt idx="893">
                    <c:v>1.9094292689442532E-4</c:v>
                  </c:pt>
                  <c:pt idx="894">
                    <c:v>2.0776340601069557E-4</c:v>
                  </c:pt>
                  <c:pt idx="895">
                    <c:v>2.2364055879028262E-4</c:v>
                  </c:pt>
                  <c:pt idx="896">
                    <c:v>2.3814371442161262E-4</c:v>
                  </c:pt>
                  <c:pt idx="897">
                    <c:v>2.5086090920063323E-4</c:v>
                  </c:pt>
                  <c:pt idx="898">
                    <c:v>2.6141764380332809E-4</c:v>
                  </c:pt>
                  <c:pt idx="899">
                    <c:v>2.694947400461711E-4</c:v>
                  </c:pt>
                  <c:pt idx="900">
                    <c:v>2.7484404585813202E-4</c:v>
                  </c:pt>
                  <c:pt idx="901">
                    <c:v>2.7730086854721431E-4</c:v>
                  </c:pt>
                  <c:pt idx="902">
                    <c:v>2.767921947216123E-4</c:v>
                  </c:pt>
                  <c:pt idx="903">
                    <c:v>2.7334014075237276E-4</c:v>
                  </c:pt>
                  <c:pt idx="904">
                    <c:v>2.6706038076382261E-4</c:v>
                  </c:pt>
                  <c:pt idx="905">
                    <c:v>2.5815565761332088E-4</c:v>
                  </c:pt>
                  <c:pt idx="906">
                    <c:v>2.469048916445878E-4</c:v>
                  </c:pt>
                  <c:pt idx="907">
                    <c:v>2.3364871750022019E-4</c:v>
                  </c:pt>
                  <c:pt idx="908">
                    <c:v>2.1877242019804828E-4</c:v>
                  </c:pt>
                  <c:pt idx="909">
                    <c:v>2.0268752515564958E-4</c:v>
                  </c:pt>
                  <c:pt idx="910">
                    <c:v>1.8581320673742902E-4</c:v>
                  </c:pt>
                  <c:pt idx="911">
                    <c:v>1.6855865669326985E-4</c:v>
                  </c:pt>
                  <c:pt idx="912">
                    <c:v>1.5130745606751629E-4</c:v>
                  </c:pt>
                  <c:pt idx="913">
                    <c:v>1.344046327307313E-4</c:v>
                  </c:pt>
                  <c:pt idx="914">
                    <c:v>1.1814701392609334E-4</c:v>
                  </c:pt>
                  <c:pt idx="915">
                    <c:v>1.0277700063462047E-4</c:v>
                  </c:pt>
                  <c:pt idx="916">
                    <c:v>8.8479793912194454E-5</c:v>
                  </c:pt>
                  <c:pt idx="917">
                    <c:v>7.5383785084965713E-5</c:v>
                  </c:pt>
                  <c:pt idx="918">
                    <c:v>6.3563642786365721E-5</c:v>
                  </c:pt>
                  <c:pt idx="919">
                    <c:v>5.3045554718561204E-5</c:v>
                  </c:pt>
                  <c:pt idx="920">
                    <c:v>4.3813987301294927E-5</c:v>
                  </c:pt>
                  <c:pt idx="921">
                    <c:v>3.5819304851974546E-5</c:v>
                  </c:pt>
                  <c:pt idx="922">
                    <c:v>2.8985697997671551E-5</c:v>
                  </c:pt>
                  <c:pt idx="923">
                    <c:v>2.3218929976509517E-5</c:v>
                  </c:pt>
                  <c:pt idx="924">
                    <c:v>1.8413435389728246E-5</c:v>
                  </c:pt>
                  <c:pt idx="925">
                    <c:v>1.4458578939011131E-5</c:v>
                  </c:pt>
                  <c:pt idx="926">
                    <c:v>1.1243837797016672E-5</c:v>
                  </c:pt>
                  <c:pt idx="927">
                    <c:v>8.6628914016910198E-6</c:v>
                  </c:pt>
                  <c:pt idx="928">
                    <c:v>6.6166013246239334E-6</c:v>
                  </c:pt>
                  <c:pt idx="929">
                    <c:v>5.0149733067677394E-6</c:v>
                  </c:pt>
                  <c:pt idx="930">
                    <c:v>3.7782685464374446E-6</c:v>
                  </c:pt>
                  <c:pt idx="931">
                    <c:v>2.837296834589023E-6</c:v>
                  </c:pt>
                  <c:pt idx="932">
                    <c:v>2.1331359460502868E-6</c:v>
                  </c:pt>
                  <c:pt idx="933">
                    <c:v>1.6162610982094401E-6</c:v>
                  </c:pt>
                  <c:pt idx="934">
                    <c:v>1.2452852849018025E-6</c:v>
                  </c:pt>
                  <c:pt idx="935">
                    <c:v>9.8542295303402411E-7</c:v>
                  </c:pt>
                  <c:pt idx="936">
                    <c:v>8.07229808754745E-7</c:v>
                  </c:pt>
                  <c:pt idx="937">
                    <c:v>6.8608455113027394E-7</c:v>
                  </c:pt>
                  <c:pt idx="938">
                    <c:v>6.0247367600830734E-7</c:v>
                  </c:pt>
                  <c:pt idx="939">
                    <c:v>5.4223430433169217E-7</c:v>
                  </c:pt>
                  <c:pt idx="940">
                    <c:v>4.9604576547562243E-7</c:v>
                  </c:pt>
                  <c:pt idx="941">
                    <c:v>4.582747606731141E-7</c:v>
                  </c:pt>
                  <c:pt idx="942">
                    <c:v>4.2572817254284063E-7</c:v>
                  </c:pt>
                  <c:pt idx="943">
                    <c:v>3.966723629656353E-7</c:v>
                  </c:pt>
                  <c:pt idx="944">
                    <c:v>3.7017245079477131E-7</c:v>
                  </c:pt>
                  <c:pt idx="945">
                    <c:v>3.457177131948357E-7</c:v>
                  </c:pt>
                  <c:pt idx="946">
                    <c:v>3.2301772328167084E-7</c:v>
                  </c:pt>
                  <c:pt idx="947">
                    <c:v>3.018834271677041E-7</c:v>
                  </c:pt>
                  <c:pt idx="948">
                    <c:v>2.8217506879988916E-7</c:v>
                  </c:pt>
                  <c:pt idx="949">
                    <c:v>2.6378764064215661E-7</c:v>
                  </c:pt>
                  <c:pt idx="950">
                    <c:v>2.4662372372142593E-7</c:v>
                  </c:pt>
                  <c:pt idx="951">
                    <c:v>2.3059762712874436E-7</c:v>
                  </c:pt>
                  <c:pt idx="952">
                    <c:v>2.1562958014373389E-7</c:v>
                  </c:pt>
                  <c:pt idx="953">
                    <c:v>2.0164355957701424E-7</c:v>
                  </c:pt>
                  <c:pt idx="954">
                    <c:v>1.8857799494187093E-7</c:v>
                  </c:pt>
                  <c:pt idx="955">
                    <c:v>1.7636861845661855E-7</c:v>
                  </c:pt>
                  <c:pt idx="956">
                    <c:v>1.6495135957025049E-7</c:v>
                  </c:pt>
                  <c:pt idx="957">
                    <c:v>1.5427599014968813E-7</c:v>
                  </c:pt>
                  <c:pt idx="958">
                    <c:v>1.4429515740956748E-7</c:v>
                  </c:pt>
                  <c:pt idx="959">
                    <c:v>1.3495775356123965E-7</c:v>
                  </c:pt>
                  <c:pt idx="960">
                    <c:v>1.2622038140872085E-7</c:v>
                  </c:pt>
                  <c:pt idx="961">
                    <c:v>1.1804715197279809E-7</c:v>
                  </c:pt>
                  <c:pt idx="962">
                    <c:v>1.1039984590703147E-7</c:v>
                  </c:pt>
                  <c:pt idx="963">
                    <c:v>1.0324446984741639E-7</c:v>
                  </c:pt>
                  <c:pt idx="964">
                    <c:v>9.6544827784049896E-8</c:v>
                  </c:pt>
                  <c:pt idx="965">
                    <c:v>9.0277765861195805E-8</c:v>
                  </c:pt>
                  <c:pt idx="966">
                    <c:v>8.4408159911406847E-8</c:v>
                  </c:pt>
                  <c:pt idx="967">
                    <c:v>7.8917497803906762E-8</c:v>
                  </c:pt>
                  <c:pt idx="968">
                    <c:v>7.3777773600234146E-8</c:v>
                  </c:pt>
                  <c:pt idx="969">
                    <c:v>6.8967919447834323E-8</c:v>
                  </c:pt>
                  <c:pt idx="970">
                    <c:v>6.4463913617534018E-8</c:v>
                  </c:pt>
                  <c:pt idx="971">
                    <c:v>6.0251603786861055E-8</c:v>
                  </c:pt>
                  <c:pt idx="972">
                    <c:v>5.6307302693937194E-8</c:v>
                  </c:pt>
                  <c:pt idx="973">
                    <c:v>5.2617331903724138E-8</c:v>
                  </c:pt>
                  <c:pt idx="974">
                    <c:v>4.9164777022067632E-8</c:v>
                  </c:pt>
                  <c:pt idx="975">
                    <c:v>4.5932920353731295E-8</c:v>
                  </c:pt>
                  <c:pt idx="976">
                    <c:v>4.2911599036296138E-8</c:v>
                  </c:pt>
                  <c:pt idx="977">
                    <c:v>4.0084164879339501E-8</c:v>
                  </c:pt>
                  <c:pt idx="978">
                    <c:v>3.7440643537718723E-8</c:v>
                  </c:pt>
                  <c:pt idx="979">
                    <c:v>3.4964485373124075E-8</c:v>
                  </c:pt>
                  <c:pt idx="980">
                    <c:v>3.2652316099576566E-8</c:v>
                  </c:pt>
                  <c:pt idx="981">
                    <c:v>3.0490940731087099E-8</c:v>
                  </c:pt>
                  <c:pt idx="982">
                    <c:v>2.8467187895306175E-8</c:v>
                  </c:pt>
                  <c:pt idx="983">
                    <c:v>2.6574499779271831E-8</c:v>
                  </c:pt>
                  <c:pt idx="984">
                    <c:v>2.4806244949982221E-8</c:v>
                  </c:pt>
                  <c:pt idx="985">
                    <c:v>2.3155906605890878E-8</c:v>
                  </c:pt>
                  <c:pt idx="986">
                    <c:v>2.1610301290168348E-8</c:v>
                  </c:pt>
                  <c:pt idx="987">
                    <c:v>2.0166225523182366E-8</c:v>
                  </c:pt>
                  <c:pt idx="988">
                    <c:v>1.8820328095695613E-8</c:v>
                  </c:pt>
                  <c:pt idx="989">
                    <c:v>1.7559540869725369E-8</c:v>
                  </c:pt>
                  <c:pt idx="990">
                    <c:v>1.6380572560426802E-8</c:v>
                  </c:pt>
                  <c:pt idx="991">
                    <c:v>1.5283408929899064E-8</c:v>
                  </c:pt>
                  <c:pt idx="992">
                    <c:v>1.4255004956024962E-8</c:v>
                  </c:pt>
                  <c:pt idx="993">
                    <c:v>1.3295356318265022E-8</c:v>
                  </c:pt>
                  <c:pt idx="994">
                    <c:v>1.2401264406861458E-8</c:v>
                  </c:pt>
                  <c:pt idx="995">
                    <c:v>1.1562729012747044E-8</c:v>
                  </c:pt>
                  <c:pt idx="996">
                    <c:v>1.0783102762432768E-8</c:v>
                  </c:pt>
                  <c:pt idx="997">
                    <c:v>1.0052639767558385E-8</c:v>
                  </c:pt>
                  <c:pt idx="998">
                    <c:v>9.3745263386516775E-9</c:v>
                  </c:pt>
                  <c:pt idx="999">
                    <c:v>8.7390205400834251E-9</c:v>
                  </c:pt>
                </c:numCache>
              </c:numRef>
            </c:plus>
            <c:minus>
              <c:numRef>
                <c:f>'[データまとめ (自動保存済み).xlsx]Ctrl粒子数'!$G$3:$G$1002,'[データまとめ (自動保存済み).xlsx]Ctrl粒子数'!$G$3:$G$1002</c:f>
                <c:numCache>
                  <c:formatCode>General</c:formatCode>
                  <c:ptCount val="200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3.2773069341672503E-12</c:v>
                  </c:pt>
                  <c:pt idx="10">
                    <c:v>2.3061913447323745E-11</c:v>
                  </c:pt>
                  <c:pt idx="11">
                    <c:v>1.4892827008204194E-10</c:v>
                  </c:pt>
                  <c:pt idx="12">
                    <c:v>2.0567090757377964E-9</c:v>
                  </c:pt>
                  <c:pt idx="13">
                    <c:v>2.1465104058033874E-8</c:v>
                  </c:pt>
                  <c:pt idx="14">
                    <c:v>1.4953901448191444E-7</c:v>
                  </c:pt>
                  <c:pt idx="15">
                    <c:v>7.3358480118651028E-7</c:v>
                  </c:pt>
                  <c:pt idx="16">
                    <c:v>2.6618419696021E-6</c:v>
                  </c:pt>
                  <c:pt idx="17">
                    <c:v>8.7952869184560058E-6</c:v>
                  </c:pt>
                  <c:pt idx="18">
                    <c:v>9.1762611720395468E-5</c:v>
                  </c:pt>
                  <c:pt idx="19">
                    <c:v>5.4523071314005066E-4</c:v>
                  </c:pt>
                  <c:pt idx="20">
                    <c:v>1.0967405960819103E-3</c:v>
                  </c:pt>
                  <c:pt idx="21">
                    <c:v>8.1337197550574738E-4</c:v>
                  </c:pt>
                  <c:pt idx="22">
                    <c:v>2.6407053080123726E-4</c:v>
                  </c:pt>
                  <c:pt idx="23">
                    <c:v>8.6792538108156455E-5</c:v>
                  </c:pt>
                  <c:pt idx="24">
                    <c:v>7.3748254809896855E-5</c:v>
                  </c:pt>
                  <c:pt idx="25">
                    <c:v>6.4192219198759768E-5</c:v>
                  </c:pt>
                  <c:pt idx="26">
                    <c:v>5.1972251021479505E-5</c:v>
                  </c:pt>
                  <c:pt idx="27">
                    <c:v>3.9794852685156809E-5</c:v>
                  </c:pt>
                  <c:pt idx="28">
                    <c:v>3.0011161374421453E-5</c:v>
                  </c:pt>
                  <c:pt idx="29">
                    <c:v>2.7076520823784802E-5</c:v>
                  </c:pt>
                  <c:pt idx="30">
                    <c:v>3.8173570822467482E-5</c:v>
                  </c:pt>
                  <c:pt idx="31">
                    <c:v>5.7265090793625197E-5</c:v>
                  </c:pt>
                  <c:pt idx="32">
                    <c:v>7.4700239279356731E-5</c:v>
                  </c:pt>
                  <c:pt idx="33">
                    <c:v>1.177666666556296E-4</c:v>
                  </c:pt>
                  <c:pt idx="34">
                    <c:v>5.3256852304895894E-4</c:v>
                  </c:pt>
                  <c:pt idx="35">
                    <c:v>1.8894495400290261E-3</c:v>
                  </c:pt>
                  <c:pt idx="36">
                    <c:v>3.688362807508362E-3</c:v>
                  </c:pt>
                  <c:pt idx="37">
                    <c:v>4.2200484318222755E-3</c:v>
                  </c:pt>
                  <c:pt idx="38">
                    <c:v>3.236408812361936E-3</c:v>
                  </c:pt>
                  <c:pt idx="39">
                    <c:v>2.0328402757137831E-3</c:v>
                  </c:pt>
                  <c:pt idx="40">
                    <c:v>1.5227693318833621E-3</c:v>
                  </c:pt>
                  <c:pt idx="41">
                    <c:v>1.6599626650607329E-3</c:v>
                  </c:pt>
                  <c:pt idx="42">
                    <c:v>1.8265532671234443E-3</c:v>
                  </c:pt>
                  <c:pt idx="43">
                    <c:v>1.7203741145622104E-3</c:v>
                  </c:pt>
                  <c:pt idx="44">
                    <c:v>1.4687575518930616E-3</c:v>
                  </c:pt>
                  <c:pt idx="45">
                    <c:v>1.3650805611767048E-3</c:v>
                  </c:pt>
                  <c:pt idx="46">
                    <c:v>1.5065176290396318E-3</c:v>
                  </c:pt>
                  <c:pt idx="47">
                    <c:v>1.8770303769290663E-3</c:v>
                  </c:pt>
                  <c:pt idx="48">
                    <c:v>2.7884934340398964E-3</c:v>
                  </c:pt>
                  <c:pt idx="49">
                    <c:v>4.6763244394893424E-3</c:v>
                  </c:pt>
                  <c:pt idx="50">
                    <c:v>7.1677092671331676E-3</c:v>
                  </c:pt>
                  <c:pt idx="51">
                    <c:v>9.0798317346020424E-3</c:v>
                  </c:pt>
                  <c:pt idx="52">
                    <c:v>9.4583727934086058E-3</c:v>
                  </c:pt>
                  <c:pt idx="53">
                    <c:v>8.5422863395661301E-3</c:v>
                  </c:pt>
                  <c:pt idx="54">
                    <c:v>7.6158310511878881E-3</c:v>
                  </c:pt>
                  <c:pt idx="55">
                    <c:v>7.8302101850017854E-3</c:v>
                  </c:pt>
                  <c:pt idx="56">
                    <c:v>9.2811445603806064E-3</c:v>
                  </c:pt>
                  <c:pt idx="57">
                    <c:v>1.159486781685856E-2</c:v>
                  </c:pt>
                  <c:pt idx="58">
                    <c:v>1.4536245362712702E-2</c:v>
                  </c:pt>
                  <c:pt idx="59">
                    <c:v>1.7952087858184702E-2</c:v>
                  </c:pt>
                  <c:pt idx="60">
                    <c:v>2.1666326436988875E-2</c:v>
                  </c:pt>
                  <c:pt idx="61">
                    <c:v>2.5500786207815616E-2</c:v>
                  </c:pt>
                  <c:pt idx="62">
                    <c:v>2.9390038776653356E-2</c:v>
                  </c:pt>
                  <c:pt idx="63">
                    <c:v>3.3480681972252783E-2</c:v>
                  </c:pt>
                  <c:pt idx="64">
                    <c:v>3.8089963419360856E-2</c:v>
                  </c:pt>
                  <c:pt idx="65">
                    <c:v>4.3486216399921201E-2</c:v>
                  </c:pt>
                  <c:pt idx="66">
                    <c:v>4.9639860134270367E-2</c:v>
                  </c:pt>
                  <c:pt idx="67">
                    <c:v>5.6194027901963248E-2</c:v>
                  </c:pt>
                  <c:pt idx="68">
                    <c:v>6.273768541449154E-2</c:v>
                  </c:pt>
                  <c:pt idx="69">
                    <c:v>6.9219432909118042E-2</c:v>
                  </c:pt>
                  <c:pt idx="70">
                    <c:v>7.6213731948293353E-2</c:v>
                  </c:pt>
                  <c:pt idx="71">
                    <c:v>8.4681337323789449E-2</c:v>
                  </c:pt>
                  <c:pt idx="72">
                    <c:v>9.5061655987429661E-2</c:v>
                  </c:pt>
                  <c:pt idx="73">
                    <c:v>0.10642728396454083</c:v>
                  </c:pt>
                  <c:pt idx="74">
                    <c:v>0.11683938501025379</c:v>
                  </c:pt>
                  <c:pt idx="75">
                    <c:v>0.12464606643781791</c:v>
                  </c:pt>
                  <c:pt idx="76">
                    <c:v>0.12939019780435299</c:v>
                  </c:pt>
                  <c:pt idx="77">
                    <c:v>0.13174764508689321</c:v>
                  </c:pt>
                  <c:pt idx="78">
                    <c:v>0.13296700359873617</c:v>
                  </c:pt>
                  <c:pt idx="79">
                    <c:v>0.13433141994696685</c:v>
                  </c:pt>
                  <c:pt idx="80">
                    <c:v>0.13667995812886663</c:v>
                  </c:pt>
                  <c:pt idx="81">
                    <c:v>0.1400281930864756</c:v>
                  </c:pt>
                  <c:pt idx="82">
                    <c:v>0.14360084545971505</c:v>
                  </c:pt>
                  <c:pt idx="83">
                    <c:v>0.14633140273969339</c:v>
                  </c:pt>
                  <c:pt idx="84">
                    <c:v>0.14742210987227758</c:v>
                  </c:pt>
                  <c:pt idx="85">
                    <c:v>0.1465924622314442</c:v>
                  </c:pt>
                  <c:pt idx="86">
                    <c:v>0.144002025939236</c:v>
                  </c:pt>
                  <c:pt idx="87">
                    <c:v>0.14004881645044928</c:v>
                  </c:pt>
                  <c:pt idx="88">
                    <c:v>0.1352115985817032</c:v>
                  </c:pt>
                  <c:pt idx="89">
                    <c:v>0.12997022420356963</c:v>
                  </c:pt>
                  <c:pt idx="90">
                    <c:v>0.12475502228720879</c:v>
                  </c:pt>
                  <c:pt idx="91">
                    <c:v>0.11988400587854374</c:v>
                  </c:pt>
                  <c:pt idx="92">
                    <c:v>0.11549824004055433</c:v>
                  </c:pt>
                  <c:pt idx="93">
                    <c:v>0.11154181546918018</c:v>
                  </c:pt>
                  <c:pt idx="94">
                    <c:v>0.10781856616663038</c:v>
                  </c:pt>
                  <c:pt idx="95">
                    <c:v>0.10410464962761896</c:v>
                  </c:pt>
                  <c:pt idx="96">
                    <c:v>0.1002580559271789</c:v>
                  </c:pt>
                  <c:pt idx="97">
                    <c:v>9.6275736100019799E-2</c:v>
                  </c:pt>
                  <c:pt idx="98">
                    <c:v>9.2284311771903951E-2</c:v>
                  </c:pt>
                  <c:pt idx="99">
                    <c:v>8.8479595135708036E-2</c:v>
                  </c:pt>
                  <c:pt idx="100">
                    <c:v>8.5047806991081568E-2</c:v>
                  </c:pt>
                  <c:pt idx="101">
                    <c:v>8.2109294223243159E-2</c:v>
                  </c:pt>
                  <c:pt idx="102">
                    <c:v>7.9711096597566158E-2</c:v>
                  </c:pt>
                  <c:pt idx="103">
                    <c:v>7.7851892273242698E-2</c:v>
                  </c:pt>
                  <c:pt idx="104">
                    <c:v>7.6494802229568643E-2</c:v>
                  </c:pt>
                  <c:pt idx="105">
                    <c:v>7.5561634985020443E-2</c:v>
                  </c:pt>
                  <c:pt idx="106">
                    <c:v>7.4945073234896548E-2</c:v>
                  </c:pt>
                  <c:pt idx="107">
                    <c:v>7.4529521499581156E-2</c:v>
                  </c:pt>
                  <c:pt idx="108">
                    <c:v>7.417446066840469E-2</c:v>
                  </c:pt>
                  <c:pt idx="109">
                    <c:v>7.3689511438872451E-2</c:v>
                  </c:pt>
                  <c:pt idx="110">
                    <c:v>7.2875602896780675E-2</c:v>
                  </c:pt>
                  <c:pt idx="111">
                    <c:v>7.162876189401321E-2</c:v>
                  </c:pt>
                  <c:pt idx="112">
                    <c:v>7.0029315863863795E-2</c:v>
                  </c:pt>
                  <c:pt idx="113">
                    <c:v>6.8348929386816359E-2</c:v>
                  </c:pt>
                  <c:pt idx="114">
                    <c:v>6.695719432762022E-2</c:v>
                  </c:pt>
                  <c:pt idx="115">
                    <c:v>6.616519292355838E-2</c:v>
                  </c:pt>
                  <c:pt idx="116">
                    <c:v>6.609063431515054E-2</c:v>
                  </c:pt>
                  <c:pt idx="117">
                    <c:v>6.662528887858056E-2</c:v>
                  </c:pt>
                  <c:pt idx="118">
                    <c:v>6.7512154794688917E-2</c:v>
                  </c:pt>
                  <c:pt idx="119">
                    <c:v>6.846590783850573E-2</c:v>
                  </c:pt>
                  <c:pt idx="120">
                    <c:v>6.9267118679097336E-2</c:v>
                  </c:pt>
                  <c:pt idx="121">
                    <c:v>6.980487822599224E-2</c:v>
                  </c:pt>
                  <c:pt idx="122">
                    <c:v>7.0075944589222394E-2</c:v>
                  </c:pt>
                  <c:pt idx="123">
                    <c:v>7.0156281662057438E-2</c:v>
                  </c:pt>
                  <c:pt idx="124">
                    <c:v>7.0157242322046204E-2</c:v>
                  </c:pt>
                  <c:pt idx="125">
                    <c:v>7.0175053232291409E-2</c:v>
                  </c:pt>
                  <c:pt idx="126">
                    <c:v>7.024122750584226E-2</c:v>
                  </c:pt>
                  <c:pt idx="127">
                    <c:v>7.0282854257980948E-2</c:v>
                  </c:pt>
                  <c:pt idx="128">
                    <c:v>7.0105262623887499E-2</c:v>
                  </c:pt>
                  <c:pt idx="129">
                    <c:v>6.9412471143986271E-2</c:v>
                  </c:pt>
                  <c:pt idx="130">
                    <c:v>6.7875753967467214E-2</c:v>
                  </c:pt>
                  <c:pt idx="131">
                    <c:v>6.5242399165639633E-2</c:v>
                  </c:pt>
                  <c:pt idx="132">
                    <c:v>6.1451781414324808E-2</c:v>
                  </c:pt>
                  <c:pt idx="133">
                    <c:v>5.6710621192136774E-2</c:v>
                  </c:pt>
                  <c:pt idx="134">
                    <c:v>5.1486413175766167E-2</c:v>
                  </c:pt>
                  <c:pt idx="135">
                    <c:v>4.6405602202614561E-2</c:v>
                  </c:pt>
                  <c:pt idx="136">
                    <c:v>4.2079222678342715E-2</c:v>
                  </c:pt>
                  <c:pt idx="137">
                    <c:v>3.8916625224826314E-2</c:v>
                  </c:pt>
                  <c:pt idx="138">
                    <c:v>3.7019029171865003E-2</c:v>
                  </c:pt>
                  <c:pt idx="139">
                    <c:v>3.6219881239272889E-2</c:v>
                  </c:pt>
                  <c:pt idx="140">
                    <c:v>3.6228285456684384E-2</c:v>
                  </c:pt>
                  <c:pt idx="141">
                    <c:v>3.6754696391616479E-2</c:v>
                  </c:pt>
                  <c:pt idx="142">
                    <c:v>3.7556372529603213E-2</c:v>
                  </c:pt>
                  <c:pt idx="143">
                    <c:v>3.8430137071325157E-2</c:v>
                  </c:pt>
                  <c:pt idx="144">
                    <c:v>3.9199690172818775E-2</c:v>
                  </c:pt>
                  <c:pt idx="145">
                    <c:v>3.9718467971634169E-2</c:v>
                  </c:pt>
                  <c:pt idx="146">
                    <c:v>3.9884607976426262E-2</c:v>
                  </c:pt>
                  <c:pt idx="147">
                    <c:v>3.9656341191434255E-2</c:v>
                  </c:pt>
                  <c:pt idx="148">
                    <c:v>3.9058819947630379E-2</c:v>
                  </c:pt>
                  <c:pt idx="149">
                    <c:v>3.8178396449463928E-2</c:v>
                  </c:pt>
                  <c:pt idx="150">
                    <c:v>3.714308442157925E-2</c:v>
                  </c:pt>
                  <c:pt idx="151">
                    <c:v>3.6089923044752129E-2</c:v>
                  </c:pt>
                  <c:pt idx="152">
                    <c:v>3.5125265203124527E-2</c:v>
                  </c:pt>
                  <c:pt idx="153">
                    <c:v>3.4291928607751612E-2</c:v>
                  </c:pt>
                  <c:pt idx="154">
                    <c:v>3.3559496396302145E-2</c:v>
                  </c:pt>
                  <c:pt idx="155">
                    <c:v>3.2843790317538563E-2</c:v>
                  </c:pt>
                  <c:pt idx="156">
                    <c:v>3.2044815508934177E-2</c:v>
                  </c:pt>
                  <c:pt idx="157">
                    <c:v>3.1084038434535759E-2</c:v>
                  </c:pt>
                  <c:pt idx="158">
                    <c:v>2.9926961630384524E-2</c:v>
                  </c:pt>
                  <c:pt idx="159">
                    <c:v>2.8587575896885757E-2</c:v>
                  </c:pt>
                  <c:pt idx="160">
                    <c:v>2.7118748645324642E-2</c:v>
                  </c:pt>
                  <c:pt idx="161">
                    <c:v>2.5595100857628415E-2</c:v>
                  </c:pt>
                  <c:pt idx="162">
                    <c:v>2.4094508291289358E-2</c:v>
                  </c:pt>
                  <c:pt idx="163">
                    <c:v>2.2682932487062053E-2</c:v>
                  </c:pt>
                  <c:pt idx="164">
                    <c:v>2.1405520683263009E-2</c:v>
                  </c:pt>
                  <c:pt idx="165">
                    <c:v>2.0284899197660754E-2</c:v>
                  </c:pt>
                  <c:pt idx="166">
                    <c:v>1.9325535803189988E-2</c:v>
                  </c:pt>
                  <c:pt idx="167">
                    <c:v>1.8521523632867319E-2</c:v>
                  </c:pt>
                  <c:pt idx="168">
                    <c:v>1.7864687666522102E-2</c:v>
                  </c:pt>
                  <c:pt idx="169">
                    <c:v>1.7350541779705259E-2</c:v>
                  </c:pt>
                  <c:pt idx="170">
                    <c:v>1.6980787807746669E-2</c:v>
                  </c:pt>
                  <c:pt idx="171">
                    <c:v>1.6762191882922144E-2</c:v>
                  </c:pt>
                  <c:pt idx="172">
                    <c:v>1.6702618412609248E-2</c:v>
                  </c:pt>
                  <c:pt idx="173">
                    <c:v>1.6805775307721756E-2</c:v>
                  </c:pt>
                  <c:pt idx="174">
                    <c:v>1.7066659116274013E-2</c:v>
                  </c:pt>
                  <c:pt idx="175">
                    <c:v>1.7469414461358451E-2</c:v>
                  </c:pt>
                  <c:pt idx="176">
                    <c:v>1.7988259487640362E-2</c:v>
                  </c:pt>
                  <c:pt idx="177">
                    <c:v>1.8590832857566825E-2</c:v>
                  </c:pt>
                  <c:pt idx="178">
                    <c:v>1.924255292324982E-2</c:v>
                  </c:pt>
                  <c:pt idx="179">
                    <c:v>1.9910617118579478E-2</c:v>
                  </c:pt>
                  <c:pt idx="180">
                    <c:v>2.0566787005548891E-2</c:v>
                  </c:pt>
                  <c:pt idx="181">
                    <c:v>2.1188653778562758E-2</c:v>
                  </c:pt>
                  <c:pt idx="182">
                    <c:v>2.1759451797186961E-2</c:v>
                  </c:pt>
                  <c:pt idx="183">
                    <c:v>2.2266711952325255E-2</c:v>
                  </c:pt>
                  <c:pt idx="184">
                    <c:v>2.2700221533798422E-2</c:v>
                  </c:pt>
                  <c:pt idx="185">
                    <c:v>2.3049926719912975E-2</c:v>
                  </c:pt>
                  <c:pt idx="186">
                    <c:v>2.3304531168627952E-2</c:v>
                  </c:pt>
                  <c:pt idx="187">
                    <c:v>2.3451506713122617E-2</c:v>
                  </c:pt>
                  <c:pt idx="188">
                    <c:v>2.3478952384680948E-2</c:v>
                  </c:pt>
                  <c:pt idx="189">
                    <c:v>2.3379211473163897E-2</c:v>
                  </c:pt>
                  <c:pt idx="190">
                    <c:v>2.3153481092861177E-2</c:v>
                  </c:pt>
                  <c:pt idx="191">
                    <c:v>2.2815992104493761E-2</c:v>
                  </c:pt>
                  <c:pt idx="192">
                    <c:v>2.2395896800307312E-2</c:v>
                  </c:pt>
                  <c:pt idx="193">
                    <c:v>2.1935019363444917E-2</c:v>
                  </c:pt>
                  <c:pt idx="194">
                    <c:v>2.14804212679282E-2</c:v>
                  </c:pt>
                  <c:pt idx="195">
                    <c:v>2.1072582156728293E-2</c:v>
                  </c:pt>
                  <c:pt idx="196">
                    <c:v>2.0732598894999291E-2</c:v>
                  </c:pt>
                  <c:pt idx="197">
                    <c:v>2.0453705482108467E-2</c:v>
                  </c:pt>
                  <c:pt idx="198">
                    <c:v>2.0201590662370851E-2</c:v>
                  </c:pt>
                  <c:pt idx="199">
                    <c:v>1.992409467755293E-2</c:v>
                  </c:pt>
                  <c:pt idx="200">
                    <c:v>1.9566474507849346E-2</c:v>
                  </c:pt>
                  <c:pt idx="201">
                    <c:v>1.9086635766927471E-2</c:v>
                  </c:pt>
                  <c:pt idx="202">
                    <c:v>1.8466006133117913E-2</c:v>
                  </c:pt>
                  <c:pt idx="203">
                    <c:v>1.7714194930696366E-2</c:v>
                  </c:pt>
                  <c:pt idx="204">
                    <c:v>1.6867469459579253E-2</c:v>
                  </c:pt>
                  <c:pt idx="205">
                    <c:v>1.5981902995090509E-2</c:v>
                  </c:pt>
                  <c:pt idx="206">
                    <c:v>1.5122264849668937E-2</c:v>
                  </c:pt>
                  <c:pt idx="207">
                    <c:v>1.4348106912342597E-2</c:v>
                  </c:pt>
                  <c:pt idx="208">
                    <c:v>1.3699661933999034E-2</c:v>
                  </c:pt>
                  <c:pt idx="209">
                    <c:v>1.318773355788724E-2</c:v>
                  </c:pt>
                  <c:pt idx="210">
                    <c:v>1.2791831878145907E-2</c:v>
                  </c:pt>
                  <c:pt idx="211">
                    <c:v>1.246769626888899E-2</c:v>
                  </c:pt>
                  <c:pt idx="212">
                    <c:v>1.2160675024437552E-2</c:v>
                  </c:pt>
                  <c:pt idx="213">
                    <c:v>1.1819207921431379E-2</c:v>
                  </c:pt>
                  <c:pt idx="214">
                    <c:v>1.1404286121048865E-2</c:v>
                  </c:pt>
                  <c:pt idx="215">
                    <c:v>1.0893856857881107E-2</c:v>
                  </c:pt>
                  <c:pt idx="216">
                    <c:v>1.0283200152746171E-2</c:v>
                  </c:pt>
                  <c:pt idx="217">
                    <c:v>9.582897496853272E-3</c:v>
                  </c:pt>
                  <c:pt idx="218">
                    <c:v>8.8158522630345845E-3</c:v>
                  </c:pt>
                  <c:pt idx="219">
                    <c:v>8.0145300904790225E-3</c:v>
                  </c:pt>
                  <c:pt idx="220">
                    <c:v>7.2193554582004492E-3</c:v>
                  </c:pt>
                  <c:pt idx="221">
                    <c:v>6.4788447405357804E-3</c:v>
                  </c:pt>
                  <c:pt idx="222">
                    <c:v>5.8509380696911799E-3</c:v>
                  </c:pt>
                  <c:pt idx="223">
                    <c:v>5.4020251573025637E-3</c:v>
                  </c:pt>
                  <c:pt idx="224">
                    <c:v>5.1960525022350136E-3</c:v>
                  </c:pt>
                  <c:pt idx="225">
                    <c:v>5.2696971955318644E-3</c:v>
                  </c:pt>
                  <c:pt idx="226">
                    <c:v>5.6097793620542343E-3</c:v>
                  </c:pt>
                  <c:pt idx="227">
                    <c:v>6.1575816337230641E-3</c:v>
                  </c:pt>
                  <c:pt idx="228">
                    <c:v>6.8342039826959806E-3</c:v>
                  </c:pt>
                  <c:pt idx="229">
                    <c:v>7.5621087002765717E-3</c:v>
                  </c:pt>
                  <c:pt idx="230">
                    <c:v>8.2749015166066267E-3</c:v>
                  </c:pt>
                  <c:pt idx="231">
                    <c:v>8.9209762324996503E-3</c:v>
                  </c:pt>
                  <c:pt idx="232">
                    <c:v>9.465643294540348E-3</c:v>
                  </c:pt>
                  <c:pt idx="233">
                    <c:v>9.8924232473407113E-3</c:v>
                  </c:pt>
                  <c:pt idx="234">
                    <c:v>1.0202384698907531E-2</c:v>
                  </c:pt>
                  <c:pt idx="235">
                    <c:v>1.0410522529400246E-2</c:v>
                  </c:pt>
                  <c:pt idx="236">
                    <c:v>1.0539418710034462E-2</c:v>
                  </c:pt>
                  <c:pt idx="237">
                    <c:v>1.0612092701586574E-2</c:v>
                  </c:pt>
                  <c:pt idx="238">
                    <c:v>1.0647005387812707E-2</c:v>
                  </c:pt>
                  <c:pt idx="239">
                    <c:v>1.0657485568579499E-2</c:v>
                  </c:pt>
                  <c:pt idx="240">
                    <c:v>1.0655099901436696E-2</c:v>
                  </c:pt>
                  <c:pt idx="241">
                    <c:v>1.0653085834358537E-2</c:v>
                  </c:pt>
                  <c:pt idx="242">
                    <c:v>1.0664822835709296E-2</c:v>
                  </c:pt>
                  <c:pt idx="243">
                    <c:v>1.0695966727343433E-2</c:v>
                  </c:pt>
                  <c:pt idx="244">
                    <c:v>1.073543457353505E-2</c:v>
                  </c:pt>
                  <c:pt idx="245">
                    <c:v>1.0752582445666332E-2</c:v>
                  </c:pt>
                  <c:pt idx="246">
                    <c:v>1.070250858080268E-2</c:v>
                  </c:pt>
                  <c:pt idx="247">
                    <c:v>1.0536233581578814E-2</c:v>
                  </c:pt>
                  <c:pt idx="248">
                    <c:v>1.0213045182676994E-2</c:v>
                  </c:pt>
                  <c:pt idx="249">
                    <c:v>9.7131099927251149E-3</c:v>
                  </c:pt>
                  <c:pt idx="250">
                    <c:v>9.0466193869288992E-3</c:v>
                  </c:pt>
                  <c:pt idx="251">
                    <c:v>8.2558574548342954E-3</c:v>
                  </c:pt>
                  <c:pt idx="252">
                    <c:v>7.4098853234417852E-3</c:v>
                  </c:pt>
                  <c:pt idx="253">
                    <c:v>6.593854987135649E-3</c:v>
                  </c:pt>
                  <c:pt idx="254">
                    <c:v>5.8939495365134056E-3</c:v>
                  </c:pt>
                  <c:pt idx="255">
                    <c:v>5.377180117187878E-3</c:v>
                  </c:pt>
                  <c:pt idx="256">
                    <c:v>5.0692160331193168E-3</c:v>
                  </c:pt>
                  <c:pt idx="257">
                    <c:v>4.9443902744648292E-3</c:v>
                  </c:pt>
                  <c:pt idx="258">
                    <c:v>4.9409529682683858E-3</c:v>
                  </c:pt>
                  <c:pt idx="259">
                    <c:v>4.9910041361244601E-3</c:v>
                  </c:pt>
                  <c:pt idx="260">
                    <c:v>5.0427855846328605E-3</c:v>
                  </c:pt>
                  <c:pt idx="261">
                    <c:v>5.0679778288559027E-3</c:v>
                  </c:pt>
                  <c:pt idx="262">
                    <c:v>5.0597586836061467E-3</c:v>
                  </c:pt>
                  <c:pt idx="263">
                    <c:v>5.0275215922129524E-3</c:v>
                  </c:pt>
                  <c:pt idx="264">
                    <c:v>4.9904540398727293E-3</c:v>
                  </c:pt>
                  <c:pt idx="265">
                    <c:v>4.9703389649484652E-3</c:v>
                  </c:pt>
                  <c:pt idx="266">
                    <c:v>4.984333045307124E-3</c:v>
                  </c:pt>
                  <c:pt idx="267">
                    <c:v>5.0397864102950463E-3</c:v>
                  </c:pt>
                  <c:pt idx="268">
                    <c:v>5.1334357691839843E-3</c:v>
                  </c:pt>
                  <c:pt idx="269">
                    <c:v>5.2553822243492521E-3</c:v>
                  </c:pt>
                  <c:pt idx="270">
                    <c:v>5.3955423408790495E-3</c:v>
                  </c:pt>
                  <c:pt idx="271">
                    <c:v>5.5491413875679418E-3</c:v>
                  </c:pt>
                  <c:pt idx="272">
                    <c:v>5.7187636704857546E-3</c:v>
                  </c:pt>
                  <c:pt idx="273">
                    <c:v>5.9122713709916863E-3</c:v>
                  </c:pt>
                  <c:pt idx="274">
                    <c:v>6.1376327399157169E-3</c:v>
                  </c:pt>
                  <c:pt idx="275">
                    <c:v>6.3969960083947886E-3</c:v>
                  </c:pt>
                  <c:pt idx="276">
                    <c:v>6.6826643415707522E-3</c:v>
                  </c:pt>
                  <c:pt idx="277">
                    <c:v>6.9765676155311125E-3</c:v>
                  </c:pt>
                  <c:pt idx="278">
                    <c:v>7.2530355457427961E-3</c:v>
                  </c:pt>
                  <c:pt idx="279">
                    <c:v>7.4834472849032831E-3</c:v>
                  </c:pt>
                  <c:pt idx="280">
                    <c:v>7.6411995356667562E-3</c:v>
                  </c:pt>
                  <c:pt idx="281">
                    <c:v>7.7058918022013274E-3</c:v>
                  </c:pt>
                  <c:pt idx="282">
                    <c:v>7.6660695851180393E-3</c:v>
                  </c:pt>
                  <c:pt idx="283">
                    <c:v>7.5201837037413089E-3</c:v>
                  </c:pt>
                  <c:pt idx="284">
                    <c:v>7.275779111787492E-3</c:v>
                  </c:pt>
                  <c:pt idx="285">
                    <c:v>6.9473632903282317E-3</c:v>
                  </c:pt>
                  <c:pt idx="286">
                    <c:v>6.5537412592602436E-3</c:v>
                  </c:pt>
                  <c:pt idx="287">
                    <c:v>6.1156168502455891E-3</c:v>
                  </c:pt>
                  <c:pt idx="288">
                    <c:v>5.6539172427049703E-3</c:v>
                  </c:pt>
                  <c:pt idx="289">
                    <c:v>5.1888197746135269E-3</c:v>
                  </c:pt>
                  <c:pt idx="290">
                    <c:v>4.7391377894893125E-3</c:v>
                  </c:pt>
                  <c:pt idx="291">
                    <c:v>4.3216837587721508E-3</c:v>
                  </c:pt>
                  <c:pt idx="292">
                    <c:v>3.9503907465533051E-3</c:v>
                  </c:pt>
                  <c:pt idx="293">
                    <c:v>3.6351984010716126E-3</c:v>
                  </c:pt>
                  <c:pt idx="294">
                    <c:v>3.3809429537311583E-3</c:v>
                  </c:pt>
                  <c:pt idx="295">
                    <c:v>3.1867084498155424E-3</c:v>
                  </c:pt>
                  <c:pt idx="296">
                    <c:v>3.0461471214236545E-3</c:v>
                  </c:pt>
                  <c:pt idx="297">
                    <c:v>2.948953400881298E-3</c:v>
                  </c:pt>
                  <c:pt idx="298">
                    <c:v>2.8830849377089441E-3</c:v>
                  </c:pt>
                  <c:pt idx="299">
                    <c:v>2.8369484021930303E-3</c:v>
                  </c:pt>
                  <c:pt idx="300">
                    <c:v>2.8009128203039303E-3</c:v>
                  </c:pt>
                  <c:pt idx="301">
                    <c:v>2.7679545604225148E-3</c:v>
                  </c:pt>
                  <c:pt idx="302">
                    <c:v>2.73359129905878E-3</c:v>
                  </c:pt>
                  <c:pt idx="303">
                    <c:v>2.6953892099870771E-3</c:v>
                  </c:pt>
                  <c:pt idx="304">
                    <c:v>2.6523061941054827E-3</c:v>
                  </c:pt>
                  <c:pt idx="305">
                    <c:v>2.6040652502308365E-3</c:v>
                  </c:pt>
                  <c:pt idx="306">
                    <c:v>2.5506792721072631E-3</c:v>
                  </c:pt>
                  <c:pt idx="307">
                    <c:v>2.4921786604605576E-3</c:v>
                  </c:pt>
                  <c:pt idx="308">
                    <c:v>2.4285299098618911E-3</c:v>
                  </c:pt>
                  <c:pt idx="309">
                    <c:v>2.3596872141758716E-3</c:v>
                  </c:pt>
                  <c:pt idx="310">
                    <c:v>2.2857009025435736E-3</c:v>
                  </c:pt>
                  <c:pt idx="311">
                    <c:v>2.2068169844110049E-3</c:v>
                  </c:pt>
                  <c:pt idx="312">
                    <c:v>2.1235302945050837E-3</c:v>
                  </c:pt>
                  <c:pt idx="313">
                    <c:v>2.0365851715169669E-3</c:v>
                  </c:pt>
                  <c:pt idx="314">
                    <c:v>1.9469422792289227E-3</c:v>
                  </c:pt>
                  <c:pt idx="315">
                    <c:v>1.8557464702509093E-3</c:v>
                  </c:pt>
                  <c:pt idx="316">
                    <c:v>1.7643448664085818E-3</c:v>
                  </c:pt>
                  <c:pt idx="317">
                    <c:v>1.6744254452911345E-3</c:v>
                  </c:pt>
                  <c:pt idx="318">
                    <c:v>1.588379334403352E-3</c:v>
                  </c:pt>
                  <c:pt idx="319">
                    <c:v>1.5100189672628062E-3</c:v>
                  </c:pt>
                  <c:pt idx="320">
                    <c:v>1.445738516651984E-3</c:v>
                  </c:pt>
                  <c:pt idx="321">
                    <c:v>1.4058972269147603E-3</c:v>
                  </c:pt>
                  <c:pt idx="322">
                    <c:v>1.4053929046877829E-3</c:v>
                  </c:pt>
                  <c:pt idx="323">
                    <c:v>1.4614254648648818E-3</c:v>
                  </c:pt>
                  <c:pt idx="324">
                    <c:v>1.587424026933926E-3</c:v>
                  </c:pt>
                  <c:pt idx="325">
                    <c:v>1.78634054866E-3</c:v>
                  </c:pt>
                  <c:pt idx="326">
                    <c:v>2.0484195422014826E-3</c:v>
                  </c:pt>
                  <c:pt idx="327">
                    <c:v>2.353745357503447E-3</c:v>
                  </c:pt>
                  <c:pt idx="328">
                    <c:v>2.6760871984176397E-3</c:v>
                  </c:pt>
                  <c:pt idx="329">
                    <c:v>2.9861819236531354E-3</c:v>
                  </c:pt>
                  <c:pt idx="330">
                    <c:v>3.2546975721919982E-3</c:v>
                  </c:pt>
                  <c:pt idx="331">
                    <c:v>3.4553215117340079E-3</c:v>
                  </c:pt>
                  <c:pt idx="332">
                    <c:v>3.5678646111954181E-3</c:v>
                  </c:pt>
                  <c:pt idx="333">
                    <c:v>3.5808801483120964E-3</c:v>
                  </c:pt>
                  <c:pt idx="334">
                    <c:v>3.4932316199293187E-3</c:v>
                  </c:pt>
                  <c:pt idx="335">
                    <c:v>3.3142334389297608E-3</c:v>
                  </c:pt>
                  <c:pt idx="336">
                    <c:v>3.0623169450118893E-3</c:v>
                  </c:pt>
                  <c:pt idx="337">
                    <c:v>2.7625130806341754E-3</c:v>
                  </c:pt>
                  <c:pt idx="338">
                    <c:v>2.4432675265815182E-3</c:v>
                  </c:pt>
                  <c:pt idx="339">
                    <c:v>2.1331136721164084E-3</c:v>
                  </c:pt>
                  <c:pt idx="340">
                    <c:v>1.8574838787449967E-3</c:v>
                  </c:pt>
                  <c:pt idx="341">
                    <c:v>1.6355801669780531E-3</c:v>
                  </c:pt>
                  <c:pt idx="342">
                    <c:v>1.4773026313813079E-3</c:v>
                  </c:pt>
                  <c:pt idx="343">
                    <c:v>1.3813983099258441E-3</c:v>
                  </c:pt>
                  <c:pt idx="344">
                    <c:v>1.33705266181422E-3</c:v>
                  </c:pt>
                  <c:pt idx="345">
                    <c:v>1.3291062168818506E-3</c:v>
                  </c:pt>
                  <c:pt idx="346">
                    <c:v>1.3435404506668329E-3</c:v>
                  </c:pt>
                  <c:pt idx="347">
                    <c:v>1.3702094342531201E-3</c:v>
                  </c:pt>
                  <c:pt idx="348">
                    <c:v>1.4028925555061699E-3</c:v>
                  </c:pt>
                  <c:pt idx="349">
                    <c:v>1.438202645466829E-3</c:v>
                  </c:pt>
                  <c:pt idx="350">
                    <c:v>1.4744464402176249E-3</c:v>
                  </c:pt>
                  <c:pt idx="351">
                    <c:v>1.5108124796565571E-3</c:v>
                  </c:pt>
                  <c:pt idx="352">
                    <c:v>1.5468882822786498E-3</c:v>
                  </c:pt>
                  <c:pt idx="353">
                    <c:v>1.5824057385591744E-3</c:v>
                  </c:pt>
                  <c:pt idx="354">
                    <c:v>1.6171200117063396E-3</c:v>
                  </c:pt>
                  <c:pt idx="355">
                    <c:v>1.6507585741753264E-3</c:v>
                  </c:pt>
                  <c:pt idx="356">
                    <c:v>1.6830044994463459E-3</c:v>
                  </c:pt>
                  <c:pt idx="357">
                    <c:v>1.7134958738854308E-3</c:v>
                  </c:pt>
                  <c:pt idx="358">
                    <c:v>1.7418329990104581E-3</c:v>
                  </c:pt>
                  <c:pt idx="359">
                    <c:v>1.7675898314205628E-3</c:v>
                  </c:pt>
                  <c:pt idx="360">
                    <c:v>1.7903282480962962E-3</c:v>
                  </c:pt>
                  <c:pt idx="361">
                    <c:v>1.8096142872174551E-3</c:v>
                  </c:pt>
                  <c:pt idx="362">
                    <c:v>1.825035757115288E-3</c:v>
                  </c:pt>
                  <c:pt idx="363">
                    <c:v>1.836220414104626E-3</c:v>
                  </c:pt>
                  <c:pt idx="364">
                    <c:v>1.8428538223632216E-3</c:v>
                  </c:pt>
                  <c:pt idx="365">
                    <c:v>1.8446959028657335E-3</c:v>
                  </c:pt>
                  <c:pt idx="366">
                    <c:v>1.8415952562491529E-3</c:v>
                  </c:pt>
                  <c:pt idx="367">
                    <c:v>1.8335002751599559E-3</c:v>
                  </c:pt>
                  <c:pt idx="368">
                    <c:v>1.8204664268853586E-3</c:v>
                  </c:pt>
                  <c:pt idx="369">
                    <c:v>1.8026590610453748E-3</c:v>
                  </c:pt>
                  <c:pt idx="370">
                    <c:v>1.780351527234507E-3</c:v>
                  </c:pt>
                  <c:pt idx="371">
                    <c:v>1.7539185300514315E-3</c:v>
                  </c:pt>
                  <c:pt idx="372">
                    <c:v>1.72382500296286E-3</c:v>
                  </c:pt>
                  <c:pt idx="373">
                    <c:v>1.6906110311311041E-3</c:v>
                  </c:pt>
                  <c:pt idx="374">
                    <c:v>1.6548736575774277E-3</c:v>
                  </c:pt>
                  <c:pt idx="375">
                    <c:v>1.6172466763272671E-3</c:v>
                  </c:pt>
                  <c:pt idx="376">
                    <c:v>1.5783798294360719E-3</c:v>
                  </c:pt>
                  <c:pt idx="377">
                    <c:v>1.5389189712926301E-3</c:v>
                  </c:pt>
                  <c:pt idx="378">
                    <c:v>1.4994888666205065E-3</c:v>
                  </c:pt>
                  <c:pt idx="379">
                    <c:v>1.46068037434923E-3</c:v>
                  </c:pt>
                  <c:pt idx="380">
                    <c:v>1.4230433949994202E-3</c:v>
                  </c:pt>
                  <c:pt idx="381">
                    <c:v>1.3870867831678173E-3</c:v>
                  </c:pt>
                  <c:pt idx="382">
                    <c:v>1.3532857254542365E-3</c:v>
                  </c:pt>
                  <c:pt idx="383">
                    <c:v>1.3220966560255761E-3</c:v>
                  </c:pt>
                  <c:pt idx="384">
                    <c:v>1.2939791881816014E-3</c:v>
                  </c:pt>
                  <c:pt idx="385">
                    <c:v>1.2694242498632485E-3</c:v>
                  </c:pt>
                  <c:pt idx="386">
                    <c:v>1.2489875393146685E-3</c:v>
                  </c:pt>
                  <c:pt idx="387">
                    <c:v>1.2333274183232465E-3</c:v>
                  </c:pt>
                  <c:pt idx="388">
                    <c:v>1.2232459941802574E-3</c:v>
                  </c:pt>
                  <c:pt idx="389">
                    <c:v>1.2197308555069381E-3</c:v>
                  </c:pt>
                  <c:pt idx="390">
                    <c:v>1.2239914570808051E-3</c:v>
                  </c:pt>
                  <c:pt idx="391">
                    <c:v>1.2374789301408315E-3</c:v>
                  </c:pt>
                  <c:pt idx="392">
                    <c:v>1.2618717689361718E-3</c:v>
                  </c:pt>
                  <c:pt idx="393">
                    <c:v>1.2990069353932883E-3</c:v>
                  </c:pt>
                  <c:pt idx="394">
                    <c:v>1.3507417270474714E-3</c:v>
                  </c:pt>
                  <c:pt idx="395">
                    <c:v>1.4187495535283379E-3</c:v>
                  </c:pt>
                  <c:pt idx="396">
                    <c:v>1.5042789204778432E-3</c:v>
                  </c:pt>
                  <c:pt idx="397">
                    <c:v>1.6079260093853978E-3</c:v>
                  </c:pt>
                  <c:pt idx="398">
                    <c:v>1.7294748245688185E-3</c:v>
                  </c:pt>
                  <c:pt idx="399">
                    <c:v>1.8678418928383927E-3</c:v>
                  </c:pt>
                  <c:pt idx="400">
                    <c:v>2.0211367051246316E-3</c:v>
                  </c:pt>
                  <c:pt idx="401">
                    <c:v>2.1868269827283733E-3</c:v>
                  </c:pt>
                  <c:pt idx="402">
                    <c:v>2.3619825862635437E-3</c:v>
                  </c:pt>
                  <c:pt idx="403">
                    <c:v>2.5435557935614911E-3</c:v>
                  </c:pt>
                  <c:pt idx="404">
                    <c:v>2.7286329050448662E-3</c:v>
                  </c:pt>
                  <c:pt idx="405">
                    <c:v>2.9145723659362408E-3</c:v>
                  </c:pt>
                  <c:pt idx="406">
                    <c:v>3.0989576611190799E-3</c:v>
                  </c:pt>
                  <c:pt idx="407">
                    <c:v>3.279367179867064E-3</c:v>
                  </c:pt>
                  <c:pt idx="408">
                    <c:v>3.4530838296787142E-3</c:v>
                  </c:pt>
                  <c:pt idx="409">
                    <c:v>3.6169528583281851E-3</c:v>
                  </c:pt>
                  <c:pt idx="410">
                    <c:v>3.7675470139016962E-3</c:v>
                  </c:pt>
                  <c:pt idx="411">
                    <c:v>3.9016027545727911E-3</c:v>
                  </c:pt>
                  <c:pt idx="412">
                    <c:v>4.0164801439046523E-3</c:v>
                  </c:pt>
                  <c:pt idx="413">
                    <c:v>4.1103535433141582E-3</c:v>
                  </c:pt>
                  <c:pt idx="414">
                    <c:v>4.1820202611551963E-3</c:v>
                  </c:pt>
                  <c:pt idx="415">
                    <c:v>4.2304870633031941E-3</c:v>
                  </c:pt>
                  <c:pt idx="416">
                    <c:v>4.2546430588418028E-3</c:v>
                  </c:pt>
                  <c:pt idx="417">
                    <c:v>4.2532442115262139E-3</c:v>
                  </c:pt>
                  <c:pt idx="418">
                    <c:v>4.2252089656365397E-3</c:v>
                  </c:pt>
                  <c:pt idx="419">
                    <c:v>4.1700433410252766E-3</c:v>
                  </c:pt>
                  <c:pt idx="420">
                    <c:v>4.088187895280742E-3</c:v>
                  </c:pt>
                  <c:pt idx="421">
                    <c:v>3.981174681697632E-3</c:v>
                  </c:pt>
                  <c:pt idx="422">
                    <c:v>3.8515974305817803E-3</c:v>
                  </c:pt>
                  <c:pt idx="423">
                    <c:v>3.7029605233233594E-3</c:v>
                  </c:pt>
                  <c:pt idx="424">
                    <c:v>3.5394761182150737E-3</c:v>
                  </c:pt>
                  <c:pt idx="425">
                    <c:v>3.3658532555496268E-3</c:v>
                  </c:pt>
                  <c:pt idx="426">
                    <c:v>3.1870967824243462E-3</c:v>
                  </c:pt>
                  <c:pt idx="427">
                    <c:v>3.0083188117059493E-3</c:v>
                  </c:pt>
                  <c:pt idx="428">
                    <c:v>2.8345596066235595E-3</c:v>
                  </c:pt>
                  <c:pt idx="429">
                    <c:v>2.6706137116528977E-3</c:v>
                  </c:pt>
                  <c:pt idx="430">
                    <c:v>2.5208571906248029E-3</c:v>
                  </c:pt>
                  <c:pt idx="431">
                    <c:v>2.3890738379373213E-3</c:v>
                  </c:pt>
                  <c:pt idx="432">
                    <c:v>2.2782839893903256E-3</c:v>
                  </c:pt>
                  <c:pt idx="433">
                    <c:v>2.1905908911693962E-3</c:v>
                  </c:pt>
                  <c:pt idx="434">
                    <c:v>2.1270725053407252E-3</c:v>
                  </c:pt>
                  <c:pt idx="435">
                    <c:v>2.0877521730651642E-3</c:v>
                  </c:pt>
                  <c:pt idx="436">
                    <c:v>2.0716697243564654E-3</c:v>
                  </c:pt>
                  <c:pt idx="437">
                    <c:v>2.0770454041474508E-3</c:v>
                  </c:pt>
                  <c:pt idx="438">
                    <c:v>2.1014976814713385E-3</c:v>
                  </c:pt>
                  <c:pt idx="439">
                    <c:v>2.1422628177435359E-3</c:v>
                  </c:pt>
                  <c:pt idx="440">
                    <c:v>2.196376060922657E-3</c:v>
                  </c:pt>
                  <c:pt idx="441">
                    <c:v>2.2608011947622764E-3</c:v>
                  </c:pt>
                  <c:pt idx="442">
                    <c:v>2.3325189322971986E-3</c:v>
                  </c:pt>
                  <c:pt idx="443">
                    <c:v>2.4085946480088176E-3</c:v>
                  </c:pt>
                  <c:pt idx="444">
                    <c:v>2.4862418486445216E-3</c:v>
                  </c:pt>
                  <c:pt idx="445">
                    <c:v>2.5628861432135629E-3</c:v>
                  </c:pt>
                  <c:pt idx="446">
                    <c:v>2.6362233198878801E-3</c:v>
                  </c:pt>
                  <c:pt idx="447">
                    <c:v>2.7042598794917621E-3</c:v>
                  </c:pt>
                  <c:pt idx="448">
                    <c:v>2.7653267303589637E-3</c:v>
                  </c:pt>
                  <c:pt idx="449">
                    <c:v>2.8180648851532132E-3</c:v>
                  </c:pt>
                  <c:pt idx="450">
                    <c:v>2.8613912810069404E-3</c:v>
                  </c:pt>
                  <c:pt idx="451">
                    <c:v>2.8944578457793342E-3</c:v>
                  </c:pt>
                  <c:pt idx="452">
                    <c:v>2.9166149663025082E-3</c:v>
                  </c:pt>
                  <c:pt idx="453">
                    <c:v>2.9273818768438225E-3</c:v>
                  </c:pt>
                  <c:pt idx="454">
                    <c:v>2.9264162293833247E-3</c:v>
                  </c:pt>
                  <c:pt idx="455">
                    <c:v>2.9134698796240478E-3</c:v>
                  </c:pt>
                  <c:pt idx="456">
                    <c:v>2.8883229562230127E-3</c:v>
                  </c:pt>
                  <c:pt idx="457">
                    <c:v>2.8507035692586754E-3</c:v>
                  </c:pt>
                  <c:pt idx="458">
                    <c:v>2.8002197127039328E-3</c:v>
                  </c:pt>
                  <c:pt idx="459">
                    <c:v>2.7363421543263227E-3</c:v>
                  </c:pt>
                  <c:pt idx="460">
                    <c:v>2.6584727267123087E-3</c:v>
                  </c:pt>
                  <c:pt idx="461">
                    <c:v>2.5661088909850506E-3</c:v>
                  </c:pt>
                  <c:pt idx="462">
                    <c:v>2.4590800515834213E-3</c:v>
                  </c:pt>
                  <c:pt idx="463">
                    <c:v>2.3377993378739673E-3</c:v>
                  </c:pt>
                  <c:pt idx="464">
                    <c:v>2.2034600764355467E-3</c:v>
                  </c:pt>
                  <c:pt idx="465">
                    <c:v>2.0581159050929872E-3</c:v>
                  </c:pt>
                  <c:pt idx="466">
                    <c:v>1.9046131235927E-3</c:v>
                  </c:pt>
                  <c:pt idx="467">
                    <c:v>1.7463823241104248E-3</c:v>
                  </c:pt>
                  <c:pt idx="468">
                    <c:v>1.5871308357737609E-3</c:v>
                  </c:pt>
                  <c:pt idx="469">
                    <c:v>1.4304985248852346E-3</c:v>
                  </c:pt>
                  <c:pt idx="470">
                    <c:v>1.2797429425241858E-3</c:v>
                  </c:pt>
                  <c:pt idx="471">
                    <c:v>1.1375067887669898E-3</c:v>
                  </c:pt>
                  <c:pt idx="472">
                    <c:v>1.005696846253921E-3</c:v>
                  </c:pt>
                  <c:pt idx="473">
                    <c:v>8.8547602167895383E-4</c:v>
                  </c:pt>
                  <c:pt idx="474">
                    <c:v>7.773466911314195E-4</c:v>
                  </c:pt>
                  <c:pt idx="475">
                    <c:v>6.812896163834011E-4</c:v>
                  </c:pt>
                  <c:pt idx="476">
                    <c:v>5.9692059093091935E-4</c:v>
                  </c:pt>
                  <c:pt idx="477">
                    <c:v>5.2363441556923965E-4</c:v>
                  </c:pt>
                  <c:pt idx="478">
                    <c:v>4.6071846035373651E-4</c:v>
                  </c:pt>
                  <c:pt idx="479">
                    <c:v>4.0743019360892384E-4</c:v>
                  </c:pt>
                  <c:pt idx="480">
                    <c:v>3.6304120791332131E-4</c:v>
                  </c:pt>
                  <c:pt idx="481">
                    <c:v>3.268540994178243E-4</c:v>
                  </c:pt>
                  <c:pt idx="482">
                    <c:v>2.9819933559618856E-4</c:v>
                  </c:pt>
                  <c:pt idx="483">
                    <c:v>2.7642039851778554E-4</c:v>
                  </c:pt>
                  <c:pt idx="484">
                    <c:v>2.6085708390678536E-4</c:v>
                  </c:pt>
                  <c:pt idx="485">
                    <c:v>2.5083781555759467E-4</c:v>
                  </c:pt>
                  <c:pt idx="486">
                    <c:v>2.4568818223505494E-4</c:v>
                  </c:pt>
                  <c:pt idx="487">
                    <c:v>2.4475458818755814E-4</c:v>
                  </c:pt>
                  <c:pt idx="488">
                    <c:v>2.47433839134808E-4</c:v>
                  </c:pt>
                  <c:pt idx="489">
                    <c:v>2.5319717688481239E-4</c:v>
                  </c:pt>
                  <c:pt idx="490">
                    <c:v>2.6160179770569266E-4</c:v>
                  </c:pt>
                  <c:pt idx="491">
                    <c:v>2.7228934312037472E-4</c:v>
                  </c:pt>
                  <c:pt idx="492">
                    <c:v>2.8497521143648396E-4</c:v>
                  </c:pt>
                  <c:pt idx="493">
                    <c:v>2.9943352874638233E-4</c:v>
                  </c:pt>
                  <c:pt idx="494">
                    <c:v>3.1548168238682006E-4</c:v>
                  </c:pt>
                  <c:pt idx="495">
                    <c:v>3.3296658660476061E-4</c:v>
                  </c:pt>
                  <c:pt idx="496">
                    <c:v>3.517536314548107E-4</c:v>
                  </c:pt>
                  <c:pt idx="497">
                    <c:v>3.7171840599814363E-4</c:v>
                  </c:pt>
                  <c:pt idx="498">
                    <c:v>3.9274080537172838E-4</c:v>
                  </c:pt>
                  <c:pt idx="499">
                    <c:v>4.1470107931527241E-4</c:v>
                  </c:pt>
                  <c:pt idx="500">
                    <c:v>4.3747730030286452E-4</c:v>
                  </c:pt>
                  <c:pt idx="501">
                    <c:v>4.6094390435541841E-4</c:v>
                  </c:pt>
                  <c:pt idx="502">
                    <c:v>4.8497093288082108E-4</c:v>
                  </c:pt>
                  <c:pt idx="503">
                    <c:v>5.0942380492782877E-4</c:v>
                  </c:pt>
                  <c:pt idx="504">
                    <c:v>5.3416342199934133E-4</c:v>
                  </c:pt>
                  <c:pt idx="505">
                    <c:v>5.5904658125540926E-4</c:v>
                  </c:pt>
                  <c:pt idx="506">
                    <c:v>5.8392651799687577E-4</c:v>
                  </c:pt>
                  <c:pt idx="507">
                    <c:v>6.0865367553776116E-4</c:v>
                  </c:pt>
                  <c:pt idx="508">
                    <c:v>6.3307656882817726E-4</c:v>
                  </c:pt>
                  <c:pt idx="509">
                    <c:v>6.5704277016156662E-4</c:v>
                  </c:pt>
                  <c:pt idx="510">
                    <c:v>6.8039999372092601E-4</c:v>
                  </c:pt>
                  <c:pt idx="511">
                    <c:v>7.0299722022259853E-4</c:v>
                  </c:pt>
                  <c:pt idx="512">
                    <c:v>7.2468584483627253E-4</c:v>
                  </c:pt>
                  <c:pt idx="513">
                    <c:v>7.4532079578594544E-4</c:v>
                  </c:pt>
                  <c:pt idx="514">
                    <c:v>7.6476159084039677E-4</c:v>
                  </c:pt>
                  <c:pt idx="515">
                    <c:v>7.8287327612308567E-4</c:v>
                  </c:pt>
                  <c:pt idx="516">
                    <c:v>7.9952735174339316E-4</c:v>
                  </c:pt>
                  <c:pt idx="517">
                    <c:v>8.1460283113483044E-4</c:v>
                  </c:pt>
                  <c:pt idx="518">
                    <c:v>8.2798802063202895E-4</c:v>
                  </c:pt>
                  <c:pt idx="519">
                    <c:v>8.3958407796037827E-4</c:v>
                  </c:pt>
                  <c:pt idx="520">
                    <c:v>8.4931227529214787E-4</c:v>
                  </c:pt>
                  <c:pt idx="521">
                    <c:v>8.5712796319045888E-4</c:v>
                  </c:pt>
                  <c:pt idx="522">
                    <c:v>8.6304500646532307E-4</c:v>
                  </c:pt>
                  <c:pt idx="523">
                    <c:v>8.6717437020648555E-4</c:v>
                  </c:pt>
                  <c:pt idx="524">
                    <c:v>8.6977774583765364E-4</c:v>
                  </c:pt>
                  <c:pt idx="525">
                    <c:v>8.7133025188551008E-4</c:v>
                  </c:pt>
                  <c:pt idx="526">
                    <c:v>8.7257412776357564E-4</c:v>
                  </c:pt>
                  <c:pt idx="527">
                    <c:v>8.7452957842368143E-4</c:v>
                  </c:pt>
                  <c:pt idx="528">
                    <c:v>8.7841726768588522E-4</c:v>
                  </c:pt>
                  <c:pt idx="529">
                    <c:v>8.8545310842817857E-4</c:v>
                  </c:pt>
                  <c:pt idx="530">
                    <c:v>8.9651586953101898E-4</c:v>
                  </c:pt>
                  <c:pt idx="531">
                    <c:v>9.1175972176364554E-4</c:v>
                  </c:pt>
                  <c:pt idx="532">
                    <c:v>9.3031129004706185E-4</c:v>
                  </c:pt>
                  <c:pt idx="533">
                    <c:v>9.5019645470345267E-4</c:v>
                  </c:pt>
                  <c:pt idx="534">
                    <c:v>9.6856292009714763E-4</c:v>
                  </c:pt>
                  <c:pt idx="535">
                    <c:v>9.8214746287716395E-4</c:v>
                  </c:pt>
                  <c:pt idx="536">
                    <c:v>9.8785617903089109E-4</c:v>
                  </c:pt>
                  <c:pt idx="537">
                    <c:v>9.8331408505199528E-4</c:v>
                  </c:pt>
                  <c:pt idx="538">
                    <c:v>9.6727641400698688E-4</c:v>
                  </c:pt>
                  <c:pt idx="539">
                    <c:v>9.3984292476411671E-4</c:v>
                  </c:pt>
                  <c:pt idx="540">
                    <c:v>9.0245921743172723E-4</c:v>
                  </c:pt>
                  <c:pt idx="541">
                    <c:v>8.577207488594139E-4</c:v>
                  </c:pt>
                  <c:pt idx="542">
                    <c:v>8.0901693458416285E-4</c:v>
                  </c:pt>
                  <c:pt idx="543">
                    <c:v>7.6006652497097012E-4</c:v>
                  </c:pt>
                  <c:pt idx="544">
                    <c:v>7.1440646331462538E-4</c:v>
                  </c:pt>
                  <c:pt idx="545">
                    <c:v>6.749110992216302E-4</c:v>
                  </c:pt>
                  <c:pt idx="546">
                    <c:v>6.4343651653358625E-4</c:v>
                  </c:pt>
                  <c:pt idx="547">
                    <c:v>6.2068390133816222E-4</c:v>
                  </c:pt>
                  <c:pt idx="548">
                    <c:v>6.0632276410159543E-4</c:v>
                  </c:pt>
                  <c:pt idx="549">
                    <c:v>5.9931336309012825E-4</c:v>
                  </c:pt>
                  <c:pt idx="550">
                    <c:v>5.9828587498948955E-4</c:v>
                  </c:pt>
                  <c:pt idx="551">
                    <c:v>6.0183961088287375E-4</c:v>
                  </c:pt>
                  <c:pt idx="552">
                    <c:v>6.0870316490532371E-4</c:v>
                  </c:pt>
                  <c:pt idx="553">
                    <c:v>6.1777540511274835E-4</c:v>
                  </c:pt>
                  <c:pt idx="554">
                    <c:v>6.2810139938413551E-4</c:v>
                  </c:pt>
                  <c:pt idx="555">
                    <c:v>6.3883170561496736E-4</c:v>
                  </c:pt>
                  <c:pt idx="556">
                    <c:v>6.4919222992516608E-4</c:v>
                  </c:pt>
                  <c:pt idx="557">
                    <c:v>6.5847321492352269E-4</c:v>
                  </c:pt>
                  <c:pt idx="558">
                    <c:v>6.6603511656364875E-4</c:v>
                  </c:pt>
                  <c:pt idx="559">
                    <c:v>6.7132560498707342E-4</c:v>
                  </c:pt>
                  <c:pt idx="560">
                    <c:v>6.7390189587132566E-4</c:v>
                  </c:pt>
                  <c:pt idx="561">
                    <c:v>6.7345402990099485E-4</c:v>
                  </c:pt>
                  <c:pt idx="562">
                    <c:v>6.698261569094339E-4</c:v>
                  </c:pt>
                  <c:pt idx="563">
                    <c:v>6.6303375477397655E-4</c:v>
                  </c:pt>
                  <c:pt idx="564">
                    <c:v>6.5327508756011675E-4</c:v>
                  </c:pt>
                  <c:pt idx="565">
                    <c:v>6.4093530616847548E-4</c:v>
                  </c:pt>
                  <c:pt idx="566">
                    <c:v>6.2658124129618721E-4</c:v>
                  </c:pt>
                  <c:pt idx="567">
                    <c:v>6.1094457867704127E-4</c:v>
                  </c:pt>
                  <c:pt idx="568">
                    <c:v>5.9489051235263758E-4</c:v>
                  </c:pt>
                  <c:pt idx="569">
                    <c:v>5.7936910260461517E-4</c:v>
                  </c:pt>
                  <c:pt idx="570">
                    <c:v>5.653478433969301E-4</c:v>
                  </c:pt>
                  <c:pt idx="571">
                    <c:v>5.5372752765645472E-4</c:v>
                  </c:pt>
                  <c:pt idx="572">
                    <c:v>5.4524992145252359E-4</c:v>
                  </c:pt>
                  <c:pt idx="573">
                    <c:v>5.404130407499491E-4</c:v>
                  </c:pt>
                  <c:pt idx="574">
                    <c:v>5.394140232852703E-4</c:v>
                  </c:pt>
                  <c:pt idx="575">
                    <c:v>5.421359436179801E-4</c:v>
                  </c:pt>
                  <c:pt idx="576">
                    <c:v>5.4818251451935131E-4</c:v>
                  </c:pt>
                  <c:pt idx="577">
                    <c:v>5.5694941238091863E-4</c:v>
                  </c:pt>
                  <c:pt idx="578">
                    <c:v>5.6771135469158105E-4</c:v>
                  </c:pt>
                  <c:pt idx="579">
                    <c:v>5.7970408903249763E-4</c:v>
                  </c:pt>
                  <c:pt idx="580">
                    <c:v>5.9218802828230554E-4</c:v>
                  </c:pt>
                  <c:pt idx="581">
                    <c:v>6.0448932441086519E-4</c:v>
                  </c:pt>
                  <c:pt idx="582">
                    <c:v>6.1602079405560805E-4</c:v>
                  </c:pt>
                  <c:pt idx="583">
                    <c:v>6.2628819010906859E-4</c:v>
                  </c:pt>
                  <c:pt idx="584">
                    <c:v>6.3488774883657564E-4</c:v>
                  </c:pt>
                  <c:pt idx="585">
                    <c:v>6.4149998023759099E-4</c:v>
                  </c:pt>
                  <c:pt idx="586">
                    <c:v>6.4588342688330646E-4</c:v>
                  </c:pt>
                  <c:pt idx="587">
                    <c:v>6.4787093833567374E-4</c:v>
                  </c:pt>
                  <c:pt idx="588">
                    <c:v>6.4737010769203593E-4</c:v>
                  </c:pt>
                  <c:pt idx="589">
                    <c:v>6.44368735376192E-4</c:v>
                  </c:pt>
                  <c:pt idx="590">
                    <c:v>6.3894538600412897E-4</c:v>
                  </c:pt>
                  <c:pt idx="591">
                    <c:v>6.3128401521148352E-4</c:v>
                  </c:pt>
                  <c:pt idx="592">
                    <c:v>6.2169027218481759E-4</c:v>
                  </c:pt>
                  <c:pt idx="593">
                    <c:v>6.1060495535706293E-4</c:v>
                  </c:pt>
                  <c:pt idx="594">
                    <c:v>5.9860755238162863E-4</c:v>
                  </c:pt>
                  <c:pt idx="595">
                    <c:v>5.8640050590354914E-4</c:v>
                  </c:pt>
                  <c:pt idx="596">
                    <c:v>5.7476383918729707E-4</c:v>
                  </c:pt>
                  <c:pt idx="597">
                    <c:v>5.6447282851140141E-4</c:v>
                  </c:pt>
                  <c:pt idx="598">
                    <c:v>5.5618067373075758E-4</c:v>
                  </c:pt>
                  <c:pt idx="599">
                    <c:v>5.5028389632816093E-4</c:v>
                  </c:pt>
                  <c:pt idx="600">
                    <c:v>5.4680463364164655E-4</c:v>
                  </c:pt>
                  <c:pt idx="601">
                    <c:v>5.4533064477907595E-4</c:v>
                  </c:pt>
                  <c:pt idx="602">
                    <c:v>5.4504128138199183E-4</c:v>
                  </c:pt>
                  <c:pt idx="603">
                    <c:v>5.4481996158335167E-4</c:v>
                  </c:pt>
                  <c:pt idx="604">
                    <c:v>5.4342595082044283E-4</c:v>
                  </c:pt>
                  <c:pt idx="605">
                    <c:v>5.3968536468155029E-4</c:v>
                  </c:pt>
                  <c:pt idx="606">
                    <c:v>5.3266560948056106E-4</c:v>
                  </c:pt>
                  <c:pt idx="607">
                    <c:v>5.2181060725001291E-4</c:v>
                  </c:pt>
                  <c:pt idx="608">
                    <c:v>5.0702722376229999E-4</c:v>
                  </c:pt>
                  <c:pt idx="609">
                    <c:v>4.8872172503260081E-4</c:v>
                  </c:pt>
                  <c:pt idx="610">
                    <c:v>4.677883530405173E-4</c:v>
                  </c:pt>
                  <c:pt idx="611">
                    <c:v>4.4555113513306666E-4</c:v>
                  </c:pt>
                  <c:pt idx="612">
                    <c:v>4.2365558438625612E-4</c:v>
                  </c:pt>
                  <c:pt idx="613">
                    <c:v>4.0390214298260306E-4</c:v>
                  </c:pt>
                  <c:pt idx="614">
                    <c:v>3.8801636544081171E-4</c:v>
                  </c:pt>
                  <c:pt idx="615">
                    <c:v>3.773750174224141E-4</c:v>
                  </c:pt>
                  <c:pt idx="616">
                    <c:v>3.7275528480734026E-4</c:v>
                  </c:pt>
                  <c:pt idx="617">
                    <c:v>3.7421028175980492E-4</c:v>
                  </c:pt>
                  <c:pt idx="618">
                    <c:v>3.8113967917341614E-4</c:v>
                  </c:pt>
                  <c:pt idx="619">
                    <c:v>3.9252054190566318E-4</c:v>
                  </c:pt>
                  <c:pt idx="620">
                    <c:v>4.0718162522102648E-4</c:v>
                  </c:pt>
                  <c:pt idx="621">
                    <c:v>4.2401477020013892E-4</c:v>
                  </c:pt>
                  <c:pt idx="622">
                    <c:v>4.4208517960560387E-4</c:v>
                  </c:pt>
                  <c:pt idx="623">
                    <c:v>4.6065806880441195E-4</c:v>
                  </c:pt>
                  <c:pt idx="624">
                    <c:v>4.7917765174448397E-4</c:v>
                  </c:pt>
                  <c:pt idx="625">
                    <c:v>4.9722862222025064E-4</c:v>
                  </c:pt>
                  <c:pt idx="626">
                    <c:v>5.1449825691167223E-4</c:v>
                  </c:pt>
                  <c:pt idx="627">
                    <c:v>5.307472587451872E-4</c:v>
                  </c:pt>
                  <c:pt idx="628">
                    <c:v>5.4579167031611176E-4</c:v>
                  </c:pt>
                  <c:pt idx="629">
                    <c:v>5.5949496591067784E-4</c:v>
                  </c:pt>
                  <c:pt idx="630">
                    <c:v>5.7176812104486733E-4</c:v>
                  </c:pt>
                  <c:pt idx="631">
                    <c:v>5.8257463983506707E-4</c:v>
                  </c:pt>
                  <c:pt idx="632">
                    <c:v>5.9193700519904135E-4</c:v>
                  </c:pt>
                  <c:pt idx="633">
                    <c:v>5.9994027325832274E-4</c:v>
                  </c:pt>
                  <c:pt idx="634">
                    <c:v>6.0672818303954246E-4</c:v>
                  </c:pt>
                  <c:pt idx="635">
                    <c:v>6.1248723207878056E-4</c:v>
                  </c:pt>
                  <c:pt idx="636">
                    <c:v>6.1741577189501943E-4</c:v>
                  </c:pt>
                  <c:pt idx="637">
                    <c:v>6.2167843779089465E-4</c:v>
                  </c:pt>
                  <c:pt idx="638">
                    <c:v>6.2535125243066438E-4</c:v>
                  </c:pt>
                  <c:pt idx="639">
                    <c:v>6.2836804897674911E-4</c:v>
                  </c:pt>
                  <c:pt idx="640">
                    <c:v>6.3048241693151842E-4</c:v>
                  </c:pt>
                  <c:pt idx="641">
                    <c:v>6.3125877454853435E-4</c:v>
                  </c:pt>
                  <c:pt idx="642">
                    <c:v>6.3010062226842361E-4</c:v>
                  </c:pt>
                  <c:pt idx="643">
                    <c:v>6.2631500293804663E-4</c:v>
                  </c:pt>
                  <c:pt idx="644">
                    <c:v>6.1920308060133575E-4</c:v>
                  </c:pt>
                  <c:pt idx="645">
                    <c:v>6.081605125732144E-4</c:v>
                  </c:pt>
                  <c:pt idx="646">
                    <c:v>5.9276972772811024E-4</c:v>
                  </c:pt>
                  <c:pt idx="647">
                    <c:v>5.7286885777387106E-4</c:v>
                  </c:pt>
                  <c:pt idx="648">
                    <c:v>5.4858725743823762E-4</c:v>
                  </c:pt>
                  <c:pt idx="649">
                    <c:v>5.2034387338805333E-4</c:v>
                  </c:pt>
                  <c:pt idx="650">
                    <c:v>4.8881055603887684E-4</c:v>
                  </c:pt>
                  <c:pt idx="651">
                    <c:v>4.5484732463527068E-4</c:v>
                  </c:pt>
                  <c:pt idx="652">
                    <c:v>4.1941996876027662E-4</c:v>
                  </c:pt>
                  <c:pt idx="653">
                    <c:v>3.8351209690097669E-4</c:v>
                  </c:pt>
                  <c:pt idx="654">
                    <c:v>3.4804405480958302E-4</c:v>
                  </c:pt>
                  <c:pt idx="655">
                    <c:v>3.1381019791720864E-4</c:v>
                  </c:pt>
                  <c:pt idx="656">
                    <c:v>2.81444162955216E-4</c:v>
                  </c:pt>
                  <c:pt idx="657">
                    <c:v>2.5141952756825434E-4</c:v>
                  </c:pt>
                  <c:pt idx="658">
                    <c:v>2.2409108473618789E-4</c:v>
                  </c:pt>
                  <c:pt idx="659">
                    <c:v>1.9977948398505638E-4</c:v>
                  </c:pt>
                  <c:pt idx="660">
                    <c:v>1.7889710345018623E-4</c:v>
                  </c:pt>
                  <c:pt idx="661">
                    <c:v>1.6209691944708401E-4</c:v>
                  </c:pt>
                  <c:pt idx="662">
                    <c:v>1.5037983551429579E-4</c:v>
                  </c:pt>
                  <c:pt idx="663">
                    <c:v>1.4501605597070396E-4</c:v>
                  </c:pt>
                  <c:pt idx="664">
                    <c:v>1.4713612847155229E-4</c:v>
                  </c:pt>
                  <c:pt idx="665">
                    <c:v>1.5714987930492895E-4</c:v>
                  </c:pt>
                  <c:pt idx="666">
                    <c:v>1.7450688555178067E-4</c:v>
                  </c:pt>
                  <c:pt idx="667">
                    <c:v>1.9799211688701406E-4</c:v>
                  </c:pt>
                  <c:pt idx="668">
                    <c:v>2.2615992367131104E-4</c:v>
                  </c:pt>
                  <c:pt idx="669">
                    <c:v>2.5756957145235741E-4</c:v>
                  </c:pt>
                  <c:pt idx="670">
                    <c:v>2.9083254895474221E-4</c:v>
                  </c:pt>
                  <c:pt idx="671">
                    <c:v>3.2459146087421607E-4</c:v>
                  </c:pt>
                  <c:pt idx="672">
                    <c:v>3.5750308666518133E-4</c:v>
                  </c:pt>
                  <c:pt idx="673">
                    <c:v>3.8824774060035457E-4</c:v>
                  </c:pt>
                  <c:pt idx="674">
                    <c:v>4.1556400323157174E-4</c:v>
                  </c:pt>
                  <c:pt idx="675">
                    <c:v>4.3830060948695009E-4</c:v>
                  </c:pt>
                  <c:pt idx="676">
                    <c:v>4.554757515632011E-4</c:v>
                  </c:pt>
                  <c:pt idx="677">
                    <c:v>4.6633450503633718E-4</c:v>
                  </c:pt>
                  <c:pt idx="678">
                    <c:v>4.7039626464820031E-4</c:v>
                  </c:pt>
                  <c:pt idx="679">
                    <c:v>4.6748591648133685E-4</c:v>
                  </c:pt>
                  <c:pt idx="680">
                    <c:v>4.5774461621048032E-4</c:v>
                  </c:pt>
                  <c:pt idx="681">
                    <c:v>4.4161858599197008E-4</c:v>
                  </c:pt>
                  <c:pt idx="682">
                    <c:v>4.1982696263761756E-4</c:v>
                  </c:pt>
                  <c:pt idx="683">
                    <c:v>3.9331192187629311E-4</c:v>
                  </c:pt>
                  <c:pt idx="684">
                    <c:v>3.6317635881565882E-4</c:v>
                  </c:pt>
                  <c:pt idx="685">
                    <c:v>3.3061534788091757E-4</c:v>
                  </c:pt>
                  <c:pt idx="686">
                    <c:v>2.9684816415004713E-4</c:v>
                  </c:pt>
                  <c:pt idx="687">
                    <c:v>2.6305694830461312E-4</c:v>
                  </c:pt>
                  <c:pt idx="688">
                    <c:v>2.3033690783616539E-4</c:v>
                  </c:pt>
                  <c:pt idx="689">
                    <c:v>1.9966046621843308E-4</c:v>
                  </c:pt>
                  <c:pt idx="690">
                    <c:v>1.7185431376617497E-4</c:v>
                  </c:pt>
                  <c:pt idx="691">
                    <c:v>1.4758294604511231E-4</c:v>
                  </c:pt>
                  <c:pt idx="692">
                    <c:v>1.2732571336836882E-4</c:v>
                  </c:pt>
                  <c:pt idx="693">
                    <c:v>1.1133141737473098E-4</c:v>
                  </c:pt>
                  <c:pt idx="694">
                    <c:v>9.9548426885060615E-5</c:v>
                  </c:pt>
                  <c:pt idx="695">
                    <c:v>9.1569773014282783E-5</c:v>
                  </c:pt>
                  <c:pt idx="696">
                    <c:v>8.6667988088627807E-5</c:v>
                  </c:pt>
                  <c:pt idx="697">
                    <c:v>8.3949085952096046E-5</c:v>
                  </c:pt>
                  <c:pt idx="698">
                    <c:v>8.254988301978503E-5</c:v>
                  </c:pt>
                  <c:pt idx="699">
                    <c:v>8.1772914519376313E-5</c:v>
                  </c:pt>
                  <c:pt idx="700">
                    <c:v>8.1125440227365121E-5</c:v>
                  </c:pt>
                  <c:pt idx="701">
                    <c:v>8.0295294588747401E-5</c:v>
                  </c:pt>
                  <c:pt idx="702">
                    <c:v>7.9105761074592192E-5</c:v>
                  </c:pt>
                  <c:pt idx="703">
                    <c:v>7.7473308302998875E-5</c:v>
                  </c:pt>
                  <c:pt idx="704">
                    <c:v>7.5375673948824485E-5</c:v>
                  </c:pt>
                  <c:pt idx="705">
                    <c:v>7.2830054170561678E-5</c:v>
                  </c:pt>
                  <c:pt idx="706">
                    <c:v>6.9878778793008975E-5</c:v>
                  </c:pt>
                  <c:pt idx="707">
                    <c:v>6.658002881890347E-5</c:v>
                  </c:pt>
                  <c:pt idx="708">
                    <c:v>6.3001663170832582E-5</c:v>
                  </c:pt>
                  <c:pt idx="709">
                    <c:v>5.9216934303254416E-5</c:v>
                  </c:pt>
                  <c:pt idx="710">
                    <c:v>5.5301404111430691E-5</c:v>
                  </c:pt>
                  <c:pt idx="711">
                    <c:v>5.1330587632441362E-5</c:v>
                  </c:pt>
                  <c:pt idx="712">
                    <c:v>4.737820730625128E-5</c:v>
                  </c:pt>
                  <c:pt idx="713">
                    <c:v>4.3514843464593489E-5</c:v>
                  </c:pt>
                  <c:pt idx="714">
                    <c:v>3.9806986912245995E-5</c:v>
                  </c:pt>
                  <c:pt idx="715">
                    <c:v>3.6316349796812117E-5</c:v>
                  </c:pt>
                  <c:pt idx="716">
                    <c:v>3.3099265822584765E-5</c:v>
                  </c:pt>
                  <c:pt idx="717">
                    <c:v>3.0205918847098092E-5</c:v>
                  </c:pt>
                  <c:pt idx="718">
                    <c:v>2.7679019858367934E-5</c:v>
                  </c:pt>
                  <c:pt idx="719">
                    <c:v>2.5551609582730867E-5</c:v>
                  </c:pt>
                  <c:pt idx="720">
                    <c:v>2.3843914945111342E-5</c:v>
                  </c:pt>
                  <c:pt idx="721">
                    <c:v>2.2559886915864988E-5</c:v>
                  </c:pt>
                  <c:pt idx="722">
                    <c:v>2.1684880092233443E-5</c:v>
                  </c:pt>
                  <c:pt idx="723">
                    <c:v>2.118617041656967E-5</c:v>
                  </c:pt>
                  <c:pt idx="724">
                    <c:v>2.1017120642163606E-5</c:v>
                  </c:pt>
                  <c:pt idx="725">
                    <c:v>2.1123935620595052E-5</c:v>
                  </c:pt>
                  <c:pt idx="726">
                    <c:v>2.1452737773609705E-5</c:v>
                  </c:pt>
                  <c:pt idx="727">
                    <c:v>2.1954955087901799E-5</c:v>
                  </c:pt>
                  <c:pt idx="728">
                    <c:v>2.2590164169200074E-5</c:v>
                  </c:pt>
                  <c:pt idx="729">
                    <c:v>2.3326738429035055E-5</c:v>
                  </c:pt>
                  <c:pt idx="730">
                    <c:v>2.4141108245166629E-5</c:v>
                  </c:pt>
                  <c:pt idx="731">
                    <c:v>2.5016355572335511E-5</c:v>
                  </c:pt>
                  <c:pt idx="732">
                    <c:v>2.5940726169012792E-5</c:v>
                  </c:pt>
                  <c:pt idx="733">
                    <c:v>2.6906252594409849E-5</c:v>
                  </c:pt>
                  <c:pt idx="734">
                    <c:v>2.7907652452392317E-5</c:v>
                  </c:pt>
                  <c:pt idx="735">
                    <c:v>2.8941479262773595E-5</c:v>
                  </c:pt>
                  <c:pt idx="736">
                    <c:v>3.0005491338022926E-5</c:v>
                  </c:pt>
                  <c:pt idx="737">
                    <c:v>3.1098214755842578E-5</c:v>
                  </c:pt>
                  <c:pt idx="738">
                    <c:v>3.2218637117827248E-5</c:v>
                  </c:pt>
                  <c:pt idx="739">
                    <c:v>3.3365994638185789E-5</c:v>
                  </c:pt>
                  <c:pt idx="740">
                    <c:v>3.4539642686332879E-5</c:v>
                  </c:pt>
                  <c:pt idx="741">
                    <c:v>3.5738971339947809E-5</c:v>
                  </c:pt>
                  <c:pt idx="742">
                    <c:v>3.6963345822934733E-5</c:v>
                  </c:pt>
                  <c:pt idx="743">
                    <c:v>3.8212079338660532E-5</c:v>
                  </c:pt>
                  <c:pt idx="744">
                    <c:v>3.9484404629980668E-5</c:v>
                  </c:pt>
                  <c:pt idx="745">
                    <c:v>4.0779470912767443E-5</c:v>
                  </c:pt>
                  <c:pt idx="746">
                    <c:v>4.209633608559805E-5</c:v>
                  </c:pt>
                  <c:pt idx="747">
                    <c:v>4.3433967559174832E-5</c:v>
                  </c:pt>
                  <c:pt idx="748">
                    <c:v>4.4791232990272798E-5</c:v>
                  </c:pt>
                  <c:pt idx="749">
                    <c:v>4.6166906994440095E-5</c:v>
                  </c:pt>
                  <c:pt idx="750">
                    <c:v>4.7559678442764089E-5</c:v>
                  </c:pt>
                  <c:pt idx="751">
                    <c:v>4.8968142369030467E-5</c:v>
                  </c:pt>
                  <c:pt idx="752">
                    <c:v>5.039081061633056E-5</c:v>
                  </c:pt>
                  <c:pt idx="753">
                    <c:v>5.1826099839544457E-5</c:v>
                  </c:pt>
                  <c:pt idx="754">
                    <c:v>5.3272362142201271E-5</c:v>
                  </c:pt>
                  <c:pt idx="755">
                    <c:v>5.4727860082500344E-5</c:v>
                  </c:pt>
                  <c:pt idx="756">
                    <c:v>5.6190790429991915E-5</c:v>
                  </c:pt>
                  <c:pt idx="757">
                    <c:v>5.7659275512331995E-5</c:v>
                  </c:pt>
                  <c:pt idx="758">
                    <c:v>5.9131380562691935E-5</c:v>
                  </c:pt>
                  <c:pt idx="759">
                    <c:v>6.0605105125037473E-5</c:v>
                  </c:pt>
                  <c:pt idx="760">
                    <c:v>6.2078400460018022E-5</c:v>
                  </c:pt>
                  <c:pt idx="761">
                    <c:v>6.3549171138855174E-5</c:v>
                  </c:pt>
                  <c:pt idx="762">
                    <c:v>6.5015282657560118E-5</c:v>
                  </c:pt>
                  <c:pt idx="763">
                    <c:v>6.647455953244898E-5</c:v>
                  </c:pt>
                  <c:pt idx="764">
                    <c:v>6.7924813650249873E-5</c:v>
                  </c:pt>
                  <c:pt idx="765">
                    <c:v>6.9363825767248234E-5</c:v>
                  </c:pt>
                  <c:pt idx="766">
                    <c:v>7.0789380661159213E-5</c:v>
                  </c:pt>
                  <c:pt idx="767">
                    <c:v>7.2199245852379299E-5</c:v>
                  </c:pt>
                  <c:pt idx="768">
                    <c:v>7.3591216452775673E-5</c:v>
                  </c:pt>
                  <c:pt idx="769">
                    <c:v>7.4963088384067664E-5</c:v>
                  </c:pt>
                  <c:pt idx="770">
                    <c:v>7.6312693064368683E-5</c:v>
                  </c:pt>
                  <c:pt idx="771">
                    <c:v>7.7637900289229358E-5</c:v>
                  </c:pt>
                  <c:pt idx="772">
                    <c:v>7.8936621232165053E-5</c:v>
                  </c:pt>
                  <c:pt idx="773">
                    <c:v>8.0206830532589395E-5</c:v>
                  </c:pt>
                  <c:pt idx="774">
                    <c:v>8.1446563150820768E-5</c:v>
                  </c:pt>
                  <c:pt idx="775">
                    <c:v>8.2653939903688675E-5</c:v>
                  </c:pt>
                  <c:pt idx="776">
                    <c:v>8.3827164529641656E-5</c:v>
                  </c:pt>
                  <c:pt idx="777">
                    <c:v>8.496454921780613E-5</c:v>
                  </c:pt>
                  <c:pt idx="778">
                    <c:v>8.6064498448249494E-5</c:v>
                  </c:pt>
                  <c:pt idx="779">
                    <c:v>8.7125554035389103E-5</c:v>
                  </c:pt>
                  <c:pt idx="780">
                    <c:v>8.8146372835757892E-5</c:v>
                  </c:pt>
                  <c:pt idx="781">
                    <c:v>8.9125760844784932E-5</c:v>
                  </c:pt>
                  <c:pt idx="782">
                    <c:v>9.0062656836189517E-5</c:v>
                  </c:pt>
                  <c:pt idx="783">
                    <c:v>9.0956167141567555E-5</c:v>
                  </c:pt>
                  <c:pt idx="784">
                    <c:v>9.1805553335678919E-5</c:v>
                  </c:pt>
                  <c:pt idx="785">
                    <c:v>9.2610244726691016E-5</c:v>
                  </c:pt>
                  <c:pt idx="786">
                    <c:v>9.3369846229591981E-5</c:v>
                  </c:pt>
                  <c:pt idx="787">
                    <c:v>9.4084140781256934E-5</c:v>
                  </c:pt>
                  <c:pt idx="788">
                    <c:v>9.475308996046378E-5</c:v>
                  </c:pt>
                  <c:pt idx="789">
                    <c:v>9.5376837889164697E-5</c:v>
                  </c:pt>
                  <c:pt idx="790">
                    <c:v>9.5955715728476756E-5</c:v>
                  </c:pt>
                  <c:pt idx="791">
                    <c:v>9.649022387709028E-5</c:v>
                  </c:pt>
                  <c:pt idx="792">
                    <c:v>9.6981051965605157E-5</c:v>
                  </c:pt>
                  <c:pt idx="793">
                    <c:v>9.7429055019729338E-5</c:v>
                  </c:pt>
                  <c:pt idx="794">
                    <c:v>9.7835252253368422E-5</c:v>
                  </c:pt>
                  <c:pt idx="795">
                    <c:v>9.8200817759278833E-5</c:v>
                  </c:pt>
                  <c:pt idx="796">
                    <c:v>9.8527069570368848E-5</c:v>
                  </c:pt>
                  <c:pt idx="797">
                    <c:v>9.8815443163688602E-5</c:v>
                  </c:pt>
                  <c:pt idx="798">
                    <c:v>9.9067496285173932E-5</c:v>
                  </c:pt>
                  <c:pt idx="799">
                    <c:v>9.9284866231525535E-5</c:v>
                  </c:pt>
                  <c:pt idx="800">
                    <c:v>9.9469254147541614E-5</c:v>
                  </c:pt>
                  <c:pt idx="801">
                    <c:v>9.9622400193334677E-5</c:v>
                  </c:pt>
                  <c:pt idx="802">
                    <c:v>9.9746049199882656E-5</c:v>
                  </c:pt>
                  <c:pt idx="803">
                    <c:v>9.9841911891147847E-5</c:v>
                  </c:pt>
                  <c:pt idx="804">
                    <c:v>9.9911631330181072E-5</c:v>
                  </c:pt>
                  <c:pt idx="805">
                    <c:v>9.9956748256087383E-5</c:v>
                  </c:pt>
                  <c:pt idx="806">
                    <c:v>9.997864536988573E-5</c:v>
                  </c:pt>
                  <c:pt idx="807">
                    <c:v>9.9978544265260448E-5</c:v>
                  </c:pt>
                  <c:pt idx="808">
                    <c:v>9.9957460063941728E-5</c:v>
                  </c:pt>
                  <c:pt idx="809">
                    <c:v>9.9916266997357217E-5</c:v>
                  </c:pt>
                  <c:pt idx="810">
                    <c:v>9.9855786588888139E-5</c:v>
                  </c:pt>
                  <c:pt idx="811">
                    <c:v>9.9777030869752532E-5</c:v>
                  </c:pt>
                  <c:pt idx="812">
                    <c:v>9.9681686383627869E-5</c:v>
                  </c:pt>
                  <c:pt idx="813">
                    <c:v>9.9572932551201978E-5</c:v>
                  </c:pt>
                  <c:pt idx="814">
                    <c:v>9.9456824645458938E-5</c:v>
                  </c:pt>
                  <c:pt idx="815">
                    <c:v>9.9344500656468543E-5</c:v>
                  </c:pt>
                  <c:pt idx="816">
                    <c:v>9.9255492149657871E-5</c:v>
                  </c:pt>
                  <c:pt idx="817">
                    <c:v>9.9222547304511817E-5</c:v>
                  </c:pt>
                  <c:pt idx="818">
                    <c:v>9.929827278893609E-5</c:v>
                  </c:pt>
                  <c:pt idx="819">
                    <c:v>9.9563636352089087E-5</c:v>
                  </c:pt>
                  <c:pt idx="820">
                    <c:v>1.0013799943385751E-4</c:v>
                  </c:pt>
                  <c:pt idx="821">
                    <c:v>1.011891770505088E-4</c:v>
                  </c:pt>
                  <c:pt idx="822">
                    <c:v>1.0294069019706768E-4</c:v>
                  </c:pt>
                  <c:pt idx="823">
                    <c:v>1.0567168326098579E-4</c:v>
                  </c:pt>
                  <c:pt idx="824">
                    <c:v>1.0970444582392291E-4</c:v>
                  </c:pt>
                  <c:pt idx="825">
                    <c:v>1.1537661702991275E-4</c:v>
                  </c:pt>
                  <c:pt idx="826">
                    <c:v>1.2300084020772285E-4</c:v>
                  </c:pt>
                  <c:pt idx="827">
                    <c:v>1.3282152174087208E-4</c:v>
                  </c:pt>
                  <c:pt idx="828">
                    <c:v>1.4498084067384319E-4</c:v>
                  </c:pt>
                  <c:pt idx="829">
                    <c:v>1.5950191836525208E-4</c:v>
                  </c:pt>
                  <c:pt idx="830">
                    <c:v>1.7628848870615964E-4</c:v>
                  </c:pt>
                  <c:pt idx="831">
                    <c:v>1.9513494640536943E-4</c:v>
                  </c:pt>
                  <c:pt idx="832">
                    <c:v>2.1574009218263668E-4</c:v>
                  </c:pt>
                  <c:pt idx="833">
                    <c:v>2.3772089124962631E-4</c:v>
                  </c:pt>
                  <c:pt idx="834">
                    <c:v>2.6062541839239121E-4</c:v>
                  </c:pt>
                  <c:pt idx="835">
                    <c:v>2.8394588431131007E-4</c:v>
                  </c:pt>
                  <c:pt idx="836">
                    <c:v>3.0713278585986167E-4</c:v>
                  </c:pt>
                  <c:pt idx="837">
                    <c:v>3.2961103893338288E-4</c:v>
                  </c:pt>
                  <c:pt idx="838">
                    <c:v>3.507982113409997E-4</c:v>
                  </c:pt>
                  <c:pt idx="839">
                    <c:v>3.7012450826042934E-4</c:v>
                  </c:pt>
                  <c:pt idx="840">
                    <c:v>3.8705370073518938E-4</c:v>
                  </c:pt>
                  <c:pt idx="841">
                    <c:v>4.0110392219372935E-4</c:v>
                  </c:pt>
                  <c:pt idx="842">
                    <c:v>4.1186714215924938E-4</c:v>
                  </c:pt>
                  <c:pt idx="843">
                    <c:v>4.1902605668312355E-4</c:v>
                  </c:pt>
                  <c:pt idx="844">
                    <c:v>4.2236734541068447E-4</c:v>
                  </c:pt>
                  <c:pt idx="845">
                    <c:v>4.2179037825592898E-4</c:v>
                  </c:pt>
                  <c:pt idx="846">
                    <c:v>4.1731082757183382E-4</c:v>
                  </c:pt>
                  <c:pt idx="847">
                    <c:v>4.0905889255912786E-4</c:v>
                  </c:pt>
                  <c:pt idx="848">
                    <c:v>3.9727230633390204E-4</c:v>
                  </c:pt>
                  <c:pt idx="849">
                    <c:v>3.822845484802226E-4</c:v>
                  </c:pt>
                  <c:pt idx="850">
                    <c:v>3.6450910541644137E-4</c:v>
                  </c:pt>
                  <c:pt idx="851">
                    <c:v>3.4442069095529017E-4</c:v>
                  </c:pt>
                  <c:pt idx="852">
                    <c:v>3.2253471688751048E-4</c:v>
                  </c:pt>
                  <c:pt idx="853">
                    <c:v>2.9938611283055589E-4</c:v>
                  </c:pt>
                  <c:pt idx="854">
                    <c:v>2.7550880441896801E-4</c:v>
                  </c:pt>
                  <c:pt idx="855">
                    <c:v>2.5141679654160423E-4</c:v>
                  </c:pt>
                  <c:pt idx="856">
                    <c:v>2.2758784430406109E-4</c:v>
                  </c:pt>
                  <c:pt idx="857">
                    <c:v>2.044502117996489E-4</c:v>
                  </c:pt>
                  <c:pt idx="858">
                    <c:v>1.8237294717583623E-4</c:v>
                  </c:pt>
                  <c:pt idx="859">
                    <c:v>1.6165963262954262E-4</c:v>
                  </c:pt>
                  <c:pt idx="860">
                    <c:v>1.4254538285820811E-4</c:v>
                  </c:pt>
                  <c:pt idx="861">
                    <c:v>1.2519656024098858E-4</c:v>
                  </c:pt>
                  <c:pt idx="862">
                    <c:v>1.0971247403441933E-4</c:v>
                  </c:pt>
                  <c:pt idx="863">
                    <c:v>9.6128327556536987E-5</c:v>
                  </c:pt>
                  <c:pt idx="864">
                    <c:v>8.4418804181823147E-5</c:v>
                  </c:pt>
                  <c:pt idx="865">
                    <c:v>7.4502210010830692E-5</c:v>
                  </c:pt>
                  <c:pt idx="866">
                    <c:v>6.6245853448576852E-5</c:v>
                  </c:pt>
                  <c:pt idx="867">
                    <c:v>5.9474133793225827E-5</c:v>
                  </c:pt>
                  <c:pt idx="868">
                    <c:v>5.3980735182655417E-5</c:v>
                  </c:pt>
                  <c:pt idx="869">
                    <c:v>4.9545004383835974E-5</c:v>
                  </c:pt>
                  <c:pt idx="870">
                    <c:v>4.5950465981003674E-5</c:v>
                  </c:pt>
                  <c:pt idx="871">
                    <c:v>4.3001963225610632E-5</c:v>
                  </c:pt>
                  <c:pt idx="872">
                    <c:v>4.0538502001906763E-5</c:v>
                  </c:pt>
                  <c:pt idx="873">
                    <c:v>3.8441091979785828E-5</c:v>
                  </c:pt>
                  <c:pt idx="874">
                    <c:v>3.6637313923724352E-5</c:v>
                  </c:pt>
                  <c:pt idx="875">
                    <c:v>3.5105668225334953E-5</c:v>
                  </c:pt>
                  <c:pt idx="876">
                    <c:v>3.3882368209693237E-5</c:v>
                  </c:pt>
                  <c:pt idx="877">
                    <c:v>3.3071179401474473E-5</c:v>
                  </c:pt>
                  <c:pt idx="878">
                    <c:v>3.2851985556568296E-5</c:v>
                  </c:pt>
                  <c:pt idx="879">
                    <c:v>3.3476800427231422E-5</c:v>
                  </c:pt>
                  <c:pt idx="880">
                    <c:v>3.5238761384688733E-5</c:v>
                  </c:pt>
                  <c:pt idx="881">
                    <c:v>3.8413673068768607E-5</c:v>
                  </c:pt>
                  <c:pt idx="882">
                    <c:v>4.3201889350728622E-5</c:v>
                  </c:pt>
                  <c:pt idx="883">
                    <c:v>4.9705450589798823E-5</c:v>
                  </c:pt>
                  <c:pt idx="884">
                    <c:v>5.7943260071767911E-5</c:v>
                  </c:pt>
                  <c:pt idx="885">
                    <c:v>6.7878066218426917E-5</c:v>
                  </c:pt>
                  <c:pt idx="886">
                    <c:v>7.9433805629085846E-5</c:v>
                  </c:pt>
                  <c:pt idx="887">
                    <c:v>9.2499662929017775E-5</c:v>
                  </c:pt>
                  <c:pt idx="888">
                    <c:v>1.0692616641001894E-4</c:v>
                  </c:pt>
                  <c:pt idx="889">
                    <c:v>1.2251913610980715E-4</c:v>
                  </c:pt>
                  <c:pt idx="890">
                    <c:v>1.3903503249379016E-4</c:v>
                  </c:pt>
                  <c:pt idx="891">
                    <c:v>1.5617952722192188E-4</c:v>
                  </c:pt>
                  <c:pt idx="892">
                    <c:v>1.7361012068417176E-4</c:v>
                  </c:pt>
                  <c:pt idx="893">
                    <c:v>1.9094292689442532E-4</c:v>
                  </c:pt>
                  <c:pt idx="894">
                    <c:v>2.0776340601069557E-4</c:v>
                  </c:pt>
                  <c:pt idx="895">
                    <c:v>2.2364055879028262E-4</c:v>
                  </c:pt>
                  <c:pt idx="896">
                    <c:v>2.3814371442161262E-4</c:v>
                  </c:pt>
                  <c:pt idx="897">
                    <c:v>2.5086090920063323E-4</c:v>
                  </c:pt>
                  <c:pt idx="898">
                    <c:v>2.6141764380332809E-4</c:v>
                  </c:pt>
                  <c:pt idx="899">
                    <c:v>2.694947400461711E-4</c:v>
                  </c:pt>
                  <c:pt idx="900">
                    <c:v>2.7484404585813202E-4</c:v>
                  </c:pt>
                  <c:pt idx="901">
                    <c:v>2.7730086854721431E-4</c:v>
                  </c:pt>
                  <c:pt idx="902">
                    <c:v>2.767921947216123E-4</c:v>
                  </c:pt>
                  <c:pt idx="903">
                    <c:v>2.7334014075237276E-4</c:v>
                  </c:pt>
                  <c:pt idx="904">
                    <c:v>2.6706038076382261E-4</c:v>
                  </c:pt>
                  <c:pt idx="905">
                    <c:v>2.5815565761332088E-4</c:v>
                  </c:pt>
                  <c:pt idx="906">
                    <c:v>2.469048916445878E-4</c:v>
                  </c:pt>
                  <c:pt idx="907">
                    <c:v>2.3364871750022019E-4</c:v>
                  </c:pt>
                  <c:pt idx="908">
                    <c:v>2.1877242019804828E-4</c:v>
                  </c:pt>
                  <c:pt idx="909">
                    <c:v>2.0268752515564958E-4</c:v>
                  </c:pt>
                  <c:pt idx="910">
                    <c:v>1.8581320673742902E-4</c:v>
                  </c:pt>
                  <c:pt idx="911">
                    <c:v>1.6855865669326985E-4</c:v>
                  </c:pt>
                  <c:pt idx="912">
                    <c:v>1.5130745606751629E-4</c:v>
                  </c:pt>
                  <c:pt idx="913">
                    <c:v>1.344046327307313E-4</c:v>
                  </c:pt>
                  <c:pt idx="914">
                    <c:v>1.1814701392609334E-4</c:v>
                  </c:pt>
                  <c:pt idx="915">
                    <c:v>1.0277700063462047E-4</c:v>
                  </c:pt>
                  <c:pt idx="916">
                    <c:v>8.8479793912194454E-5</c:v>
                  </c:pt>
                  <c:pt idx="917">
                    <c:v>7.5383785084965713E-5</c:v>
                  </c:pt>
                  <c:pt idx="918">
                    <c:v>6.3563642786365721E-5</c:v>
                  </c:pt>
                  <c:pt idx="919">
                    <c:v>5.3045554718561204E-5</c:v>
                  </c:pt>
                  <c:pt idx="920">
                    <c:v>4.3813987301294927E-5</c:v>
                  </c:pt>
                  <c:pt idx="921">
                    <c:v>3.5819304851974546E-5</c:v>
                  </c:pt>
                  <c:pt idx="922">
                    <c:v>2.8985697997671551E-5</c:v>
                  </c:pt>
                  <c:pt idx="923">
                    <c:v>2.3218929976509517E-5</c:v>
                  </c:pt>
                  <c:pt idx="924">
                    <c:v>1.8413435389728246E-5</c:v>
                  </c:pt>
                  <c:pt idx="925">
                    <c:v>1.4458578939011131E-5</c:v>
                  </c:pt>
                  <c:pt idx="926">
                    <c:v>1.1243837797016672E-5</c:v>
                  </c:pt>
                  <c:pt idx="927">
                    <c:v>8.6628914016910198E-6</c:v>
                  </c:pt>
                  <c:pt idx="928">
                    <c:v>6.6166013246239334E-6</c:v>
                  </c:pt>
                  <c:pt idx="929">
                    <c:v>5.0149733067677394E-6</c:v>
                  </c:pt>
                  <c:pt idx="930">
                    <c:v>3.7782685464374446E-6</c:v>
                  </c:pt>
                  <c:pt idx="931">
                    <c:v>2.837296834589023E-6</c:v>
                  </c:pt>
                  <c:pt idx="932">
                    <c:v>2.1331359460502868E-6</c:v>
                  </c:pt>
                  <c:pt idx="933">
                    <c:v>1.6162610982094401E-6</c:v>
                  </c:pt>
                  <c:pt idx="934">
                    <c:v>1.2452852849018025E-6</c:v>
                  </c:pt>
                  <c:pt idx="935">
                    <c:v>9.8542295303402411E-7</c:v>
                  </c:pt>
                  <c:pt idx="936">
                    <c:v>8.07229808754745E-7</c:v>
                  </c:pt>
                  <c:pt idx="937">
                    <c:v>6.8608455113027394E-7</c:v>
                  </c:pt>
                  <c:pt idx="938">
                    <c:v>6.0247367600830734E-7</c:v>
                  </c:pt>
                  <c:pt idx="939">
                    <c:v>5.4223430433169217E-7</c:v>
                  </c:pt>
                  <c:pt idx="940">
                    <c:v>4.9604576547562243E-7</c:v>
                  </c:pt>
                  <c:pt idx="941">
                    <c:v>4.582747606731141E-7</c:v>
                  </c:pt>
                  <c:pt idx="942">
                    <c:v>4.2572817254284063E-7</c:v>
                  </c:pt>
                  <c:pt idx="943">
                    <c:v>3.966723629656353E-7</c:v>
                  </c:pt>
                  <c:pt idx="944">
                    <c:v>3.7017245079477131E-7</c:v>
                  </c:pt>
                  <c:pt idx="945">
                    <c:v>3.457177131948357E-7</c:v>
                  </c:pt>
                  <c:pt idx="946">
                    <c:v>3.2301772328167084E-7</c:v>
                  </c:pt>
                  <c:pt idx="947">
                    <c:v>3.018834271677041E-7</c:v>
                  </c:pt>
                  <c:pt idx="948">
                    <c:v>2.8217506879988916E-7</c:v>
                  </c:pt>
                  <c:pt idx="949">
                    <c:v>2.6378764064215661E-7</c:v>
                  </c:pt>
                  <c:pt idx="950">
                    <c:v>2.4662372372142593E-7</c:v>
                  </c:pt>
                  <c:pt idx="951">
                    <c:v>2.3059762712874436E-7</c:v>
                  </c:pt>
                  <c:pt idx="952">
                    <c:v>2.1562958014373389E-7</c:v>
                  </c:pt>
                  <c:pt idx="953">
                    <c:v>2.0164355957701424E-7</c:v>
                  </c:pt>
                  <c:pt idx="954">
                    <c:v>1.8857799494187093E-7</c:v>
                  </c:pt>
                  <c:pt idx="955">
                    <c:v>1.7636861845661855E-7</c:v>
                  </c:pt>
                  <c:pt idx="956">
                    <c:v>1.6495135957025049E-7</c:v>
                  </c:pt>
                  <c:pt idx="957">
                    <c:v>1.5427599014968813E-7</c:v>
                  </c:pt>
                  <c:pt idx="958">
                    <c:v>1.4429515740956748E-7</c:v>
                  </c:pt>
                  <c:pt idx="959">
                    <c:v>1.3495775356123965E-7</c:v>
                  </c:pt>
                  <c:pt idx="960">
                    <c:v>1.2622038140872085E-7</c:v>
                  </c:pt>
                  <c:pt idx="961">
                    <c:v>1.1804715197279809E-7</c:v>
                  </c:pt>
                  <c:pt idx="962">
                    <c:v>1.1039984590703147E-7</c:v>
                  </c:pt>
                  <c:pt idx="963">
                    <c:v>1.0324446984741639E-7</c:v>
                  </c:pt>
                  <c:pt idx="964">
                    <c:v>9.6544827784049896E-8</c:v>
                  </c:pt>
                  <c:pt idx="965">
                    <c:v>9.0277765861195805E-8</c:v>
                  </c:pt>
                  <c:pt idx="966">
                    <c:v>8.4408159911406847E-8</c:v>
                  </c:pt>
                  <c:pt idx="967">
                    <c:v>7.8917497803906762E-8</c:v>
                  </c:pt>
                  <c:pt idx="968">
                    <c:v>7.3777773600234146E-8</c:v>
                  </c:pt>
                  <c:pt idx="969">
                    <c:v>6.8967919447834323E-8</c:v>
                  </c:pt>
                  <c:pt idx="970">
                    <c:v>6.4463913617534018E-8</c:v>
                  </c:pt>
                  <c:pt idx="971">
                    <c:v>6.0251603786861055E-8</c:v>
                  </c:pt>
                  <c:pt idx="972">
                    <c:v>5.6307302693937194E-8</c:v>
                  </c:pt>
                  <c:pt idx="973">
                    <c:v>5.2617331903724138E-8</c:v>
                  </c:pt>
                  <c:pt idx="974">
                    <c:v>4.9164777022067632E-8</c:v>
                  </c:pt>
                  <c:pt idx="975">
                    <c:v>4.5932920353731295E-8</c:v>
                  </c:pt>
                  <c:pt idx="976">
                    <c:v>4.2911599036296138E-8</c:v>
                  </c:pt>
                  <c:pt idx="977">
                    <c:v>4.0084164879339501E-8</c:v>
                  </c:pt>
                  <c:pt idx="978">
                    <c:v>3.7440643537718723E-8</c:v>
                  </c:pt>
                  <c:pt idx="979">
                    <c:v>3.4964485373124075E-8</c:v>
                  </c:pt>
                  <c:pt idx="980">
                    <c:v>3.2652316099576566E-8</c:v>
                  </c:pt>
                  <c:pt idx="981">
                    <c:v>3.0490940731087099E-8</c:v>
                  </c:pt>
                  <c:pt idx="982">
                    <c:v>2.8467187895306175E-8</c:v>
                  </c:pt>
                  <c:pt idx="983">
                    <c:v>2.6574499779271831E-8</c:v>
                  </c:pt>
                  <c:pt idx="984">
                    <c:v>2.4806244949982221E-8</c:v>
                  </c:pt>
                  <c:pt idx="985">
                    <c:v>2.3155906605890878E-8</c:v>
                  </c:pt>
                  <c:pt idx="986">
                    <c:v>2.1610301290168348E-8</c:v>
                  </c:pt>
                  <c:pt idx="987">
                    <c:v>2.0166225523182366E-8</c:v>
                  </c:pt>
                  <c:pt idx="988">
                    <c:v>1.8820328095695613E-8</c:v>
                  </c:pt>
                  <c:pt idx="989">
                    <c:v>1.7559540869725369E-8</c:v>
                  </c:pt>
                  <c:pt idx="990">
                    <c:v>1.6380572560426802E-8</c:v>
                  </c:pt>
                  <c:pt idx="991">
                    <c:v>1.5283408929899064E-8</c:v>
                  </c:pt>
                  <c:pt idx="992">
                    <c:v>1.4255004956024962E-8</c:v>
                  </c:pt>
                  <c:pt idx="993">
                    <c:v>1.3295356318265022E-8</c:v>
                  </c:pt>
                  <c:pt idx="994">
                    <c:v>1.2401264406861458E-8</c:v>
                  </c:pt>
                  <c:pt idx="995">
                    <c:v>1.1562729012747044E-8</c:v>
                  </c:pt>
                  <c:pt idx="996">
                    <c:v>1.0783102762432768E-8</c:v>
                  </c:pt>
                  <c:pt idx="997">
                    <c:v>1.0052639767558385E-8</c:v>
                  </c:pt>
                  <c:pt idx="998">
                    <c:v>9.3745263386516775E-9</c:v>
                  </c:pt>
                  <c:pt idx="999">
                    <c:v>8.7390205400834251E-9</c:v>
                  </c:pt>
                  <c:pt idx="1000">
                    <c:v>0</c:v>
                  </c:pt>
                  <c:pt idx="1001">
                    <c:v>0</c:v>
                  </c:pt>
                  <c:pt idx="1002">
                    <c:v>0</c:v>
                  </c:pt>
                  <c:pt idx="1003">
                    <c:v>0</c:v>
                  </c:pt>
                  <c:pt idx="1004">
                    <c:v>0</c:v>
                  </c:pt>
                  <c:pt idx="1005">
                    <c:v>0</c:v>
                  </c:pt>
                  <c:pt idx="1006">
                    <c:v>0</c:v>
                  </c:pt>
                  <c:pt idx="1007">
                    <c:v>0</c:v>
                  </c:pt>
                  <c:pt idx="1008">
                    <c:v>0</c:v>
                  </c:pt>
                  <c:pt idx="1009">
                    <c:v>3.2773069341672503E-12</c:v>
                  </c:pt>
                  <c:pt idx="1010">
                    <c:v>2.3061913447323745E-11</c:v>
                  </c:pt>
                  <c:pt idx="1011">
                    <c:v>1.4892827008204194E-10</c:v>
                  </c:pt>
                  <c:pt idx="1012">
                    <c:v>2.0567090757377964E-9</c:v>
                  </c:pt>
                  <c:pt idx="1013">
                    <c:v>2.1465104058033874E-8</c:v>
                  </c:pt>
                  <c:pt idx="1014">
                    <c:v>1.4953901448191444E-7</c:v>
                  </c:pt>
                  <c:pt idx="1015">
                    <c:v>7.3358480118651028E-7</c:v>
                  </c:pt>
                  <c:pt idx="1016">
                    <c:v>2.6618419696021E-6</c:v>
                  </c:pt>
                  <c:pt idx="1017">
                    <c:v>8.7952869184560058E-6</c:v>
                  </c:pt>
                  <c:pt idx="1018">
                    <c:v>9.1762611720395468E-5</c:v>
                  </c:pt>
                  <c:pt idx="1019">
                    <c:v>5.4523071314005066E-4</c:v>
                  </c:pt>
                  <c:pt idx="1020">
                    <c:v>1.0967405960819103E-3</c:v>
                  </c:pt>
                  <c:pt idx="1021">
                    <c:v>8.1337197550574738E-4</c:v>
                  </c:pt>
                  <c:pt idx="1022">
                    <c:v>2.6407053080123726E-4</c:v>
                  </c:pt>
                  <c:pt idx="1023">
                    <c:v>8.6792538108156455E-5</c:v>
                  </c:pt>
                  <c:pt idx="1024">
                    <c:v>7.3748254809896855E-5</c:v>
                  </c:pt>
                  <c:pt idx="1025">
                    <c:v>6.4192219198759768E-5</c:v>
                  </c:pt>
                  <c:pt idx="1026">
                    <c:v>5.1972251021479505E-5</c:v>
                  </c:pt>
                  <c:pt idx="1027">
                    <c:v>3.9794852685156809E-5</c:v>
                  </c:pt>
                  <c:pt idx="1028">
                    <c:v>3.0011161374421453E-5</c:v>
                  </c:pt>
                  <c:pt idx="1029">
                    <c:v>2.7076520823784802E-5</c:v>
                  </c:pt>
                  <c:pt idx="1030">
                    <c:v>3.8173570822467482E-5</c:v>
                  </c:pt>
                  <c:pt idx="1031">
                    <c:v>5.7265090793625197E-5</c:v>
                  </c:pt>
                  <c:pt idx="1032">
                    <c:v>7.4700239279356731E-5</c:v>
                  </c:pt>
                  <c:pt idx="1033">
                    <c:v>1.177666666556296E-4</c:v>
                  </c:pt>
                  <c:pt idx="1034">
                    <c:v>5.3256852304895894E-4</c:v>
                  </c:pt>
                  <c:pt idx="1035">
                    <c:v>1.8894495400290261E-3</c:v>
                  </c:pt>
                  <c:pt idx="1036">
                    <c:v>3.688362807508362E-3</c:v>
                  </c:pt>
                  <c:pt idx="1037">
                    <c:v>4.2200484318222755E-3</c:v>
                  </c:pt>
                  <c:pt idx="1038">
                    <c:v>3.236408812361936E-3</c:v>
                  </c:pt>
                  <c:pt idx="1039">
                    <c:v>2.0328402757137831E-3</c:v>
                  </c:pt>
                  <c:pt idx="1040">
                    <c:v>1.5227693318833621E-3</c:v>
                  </c:pt>
                  <c:pt idx="1041">
                    <c:v>1.6599626650607329E-3</c:v>
                  </c:pt>
                  <c:pt idx="1042">
                    <c:v>1.8265532671234443E-3</c:v>
                  </c:pt>
                  <c:pt idx="1043">
                    <c:v>1.7203741145622104E-3</c:v>
                  </c:pt>
                  <c:pt idx="1044">
                    <c:v>1.4687575518930616E-3</c:v>
                  </c:pt>
                  <c:pt idx="1045">
                    <c:v>1.3650805611767048E-3</c:v>
                  </c:pt>
                  <c:pt idx="1046">
                    <c:v>1.5065176290396318E-3</c:v>
                  </c:pt>
                  <c:pt idx="1047">
                    <c:v>1.8770303769290663E-3</c:v>
                  </c:pt>
                  <c:pt idx="1048">
                    <c:v>2.7884934340398964E-3</c:v>
                  </c:pt>
                  <c:pt idx="1049">
                    <c:v>4.6763244394893424E-3</c:v>
                  </c:pt>
                  <c:pt idx="1050">
                    <c:v>7.1677092671331676E-3</c:v>
                  </c:pt>
                  <c:pt idx="1051">
                    <c:v>9.0798317346020424E-3</c:v>
                  </c:pt>
                  <c:pt idx="1052">
                    <c:v>9.4583727934086058E-3</c:v>
                  </c:pt>
                  <c:pt idx="1053">
                    <c:v>8.5422863395661301E-3</c:v>
                  </c:pt>
                  <c:pt idx="1054">
                    <c:v>7.6158310511878881E-3</c:v>
                  </c:pt>
                  <c:pt idx="1055">
                    <c:v>7.8302101850017854E-3</c:v>
                  </c:pt>
                  <c:pt idx="1056">
                    <c:v>9.2811445603806064E-3</c:v>
                  </c:pt>
                  <c:pt idx="1057">
                    <c:v>1.159486781685856E-2</c:v>
                  </c:pt>
                  <c:pt idx="1058">
                    <c:v>1.4536245362712702E-2</c:v>
                  </c:pt>
                  <c:pt idx="1059">
                    <c:v>1.7952087858184702E-2</c:v>
                  </c:pt>
                  <c:pt idx="1060">
                    <c:v>2.1666326436988875E-2</c:v>
                  </c:pt>
                  <c:pt idx="1061">
                    <c:v>2.5500786207815616E-2</c:v>
                  </c:pt>
                  <c:pt idx="1062">
                    <c:v>2.9390038776653356E-2</c:v>
                  </c:pt>
                  <c:pt idx="1063">
                    <c:v>3.3480681972252783E-2</c:v>
                  </c:pt>
                  <c:pt idx="1064">
                    <c:v>3.8089963419360856E-2</c:v>
                  </c:pt>
                  <c:pt idx="1065">
                    <c:v>4.3486216399921201E-2</c:v>
                  </c:pt>
                  <c:pt idx="1066">
                    <c:v>4.9639860134270367E-2</c:v>
                  </c:pt>
                  <c:pt idx="1067">
                    <c:v>5.6194027901963248E-2</c:v>
                  </c:pt>
                  <c:pt idx="1068">
                    <c:v>6.273768541449154E-2</c:v>
                  </c:pt>
                  <c:pt idx="1069">
                    <c:v>6.9219432909118042E-2</c:v>
                  </c:pt>
                  <c:pt idx="1070">
                    <c:v>7.6213731948293353E-2</c:v>
                  </c:pt>
                  <c:pt idx="1071">
                    <c:v>8.4681337323789449E-2</c:v>
                  </c:pt>
                  <c:pt idx="1072">
                    <c:v>9.5061655987429661E-2</c:v>
                  </c:pt>
                  <c:pt idx="1073">
                    <c:v>0.10642728396454083</c:v>
                  </c:pt>
                  <c:pt idx="1074">
                    <c:v>0.11683938501025379</c:v>
                  </c:pt>
                  <c:pt idx="1075">
                    <c:v>0.12464606643781791</c:v>
                  </c:pt>
                  <c:pt idx="1076">
                    <c:v>0.12939019780435299</c:v>
                  </c:pt>
                  <c:pt idx="1077">
                    <c:v>0.13174764508689321</c:v>
                  </c:pt>
                  <c:pt idx="1078">
                    <c:v>0.13296700359873617</c:v>
                  </c:pt>
                  <c:pt idx="1079">
                    <c:v>0.13433141994696685</c:v>
                  </c:pt>
                  <c:pt idx="1080">
                    <c:v>0.13667995812886663</c:v>
                  </c:pt>
                  <c:pt idx="1081">
                    <c:v>0.1400281930864756</c:v>
                  </c:pt>
                  <c:pt idx="1082">
                    <c:v>0.14360084545971505</c:v>
                  </c:pt>
                  <c:pt idx="1083">
                    <c:v>0.14633140273969339</c:v>
                  </c:pt>
                  <c:pt idx="1084">
                    <c:v>0.14742210987227758</c:v>
                  </c:pt>
                  <c:pt idx="1085">
                    <c:v>0.1465924622314442</c:v>
                  </c:pt>
                  <c:pt idx="1086">
                    <c:v>0.144002025939236</c:v>
                  </c:pt>
                  <c:pt idx="1087">
                    <c:v>0.14004881645044928</c:v>
                  </c:pt>
                  <c:pt idx="1088">
                    <c:v>0.1352115985817032</c:v>
                  </c:pt>
                  <c:pt idx="1089">
                    <c:v>0.12997022420356963</c:v>
                  </c:pt>
                  <c:pt idx="1090">
                    <c:v>0.12475502228720879</c:v>
                  </c:pt>
                  <c:pt idx="1091">
                    <c:v>0.11988400587854374</c:v>
                  </c:pt>
                  <c:pt idx="1092">
                    <c:v>0.11549824004055433</c:v>
                  </c:pt>
                  <c:pt idx="1093">
                    <c:v>0.11154181546918018</c:v>
                  </c:pt>
                  <c:pt idx="1094">
                    <c:v>0.10781856616663038</c:v>
                  </c:pt>
                  <c:pt idx="1095">
                    <c:v>0.10410464962761896</c:v>
                  </c:pt>
                  <c:pt idx="1096">
                    <c:v>0.1002580559271789</c:v>
                  </c:pt>
                  <c:pt idx="1097">
                    <c:v>9.6275736100019799E-2</c:v>
                  </c:pt>
                  <c:pt idx="1098">
                    <c:v>9.2284311771903951E-2</c:v>
                  </c:pt>
                  <c:pt idx="1099">
                    <c:v>8.8479595135708036E-2</c:v>
                  </c:pt>
                  <c:pt idx="1100">
                    <c:v>8.5047806991081568E-2</c:v>
                  </c:pt>
                  <c:pt idx="1101">
                    <c:v>8.2109294223243159E-2</c:v>
                  </c:pt>
                  <c:pt idx="1102">
                    <c:v>7.9711096597566158E-2</c:v>
                  </c:pt>
                  <c:pt idx="1103">
                    <c:v>7.7851892273242698E-2</c:v>
                  </c:pt>
                  <c:pt idx="1104">
                    <c:v>7.6494802229568643E-2</c:v>
                  </c:pt>
                  <c:pt idx="1105">
                    <c:v>7.5561634985020443E-2</c:v>
                  </c:pt>
                  <c:pt idx="1106">
                    <c:v>7.4945073234896548E-2</c:v>
                  </c:pt>
                  <c:pt idx="1107">
                    <c:v>7.4529521499581156E-2</c:v>
                  </c:pt>
                  <c:pt idx="1108">
                    <c:v>7.417446066840469E-2</c:v>
                  </c:pt>
                  <c:pt idx="1109">
                    <c:v>7.3689511438872451E-2</c:v>
                  </c:pt>
                  <c:pt idx="1110">
                    <c:v>7.2875602896780675E-2</c:v>
                  </c:pt>
                  <c:pt idx="1111">
                    <c:v>7.162876189401321E-2</c:v>
                  </c:pt>
                  <c:pt idx="1112">
                    <c:v>7.0029315863863795E-2</c:v>
                  </c:pt>
                  <c:pt idx="1113">
                    <c:v>6.8348929386816359E-2</c:v>
                  </c:pt>
                  <c:pt idx="1114">
                    <c:v>6.695719432762022E-2</c:v>
                  </c:pt>
                  <c:pt idx="1115">
                    <c:v>6.616519292355838E-2</c:v>
                  </c:pt>
                  <c:pt idx="1116">
                    <c:v>6.609063431515054E-2</c:v>
                  </c:pt>
                  <c:pt idx="1117">
                    <c:v>6.662528887858056E-2</c:v>
                  </c:pt>
                  <c:pt idx="1118">
                    <c:v>6.7512154794688917E-2</c:v>
                  </c:pt>
                  <c:pt idx="1119">
                    <c:v>6.846590783850573E-2</c:v>
                  </c:pt>
                  <c:pt idx="1120">
                    <c:v>6.9267118679097336E-2</c:v>
                  </c:pt>
                  <c:pt idx="1121">
                    <c:v>6.980487822599224E-2</c:v>
                  </c:pt>
                  <c:pt idx="1122">
                    <c:v>7.0075944589222394E-2</c:v>
                  </c:pt>
                  <c:pt idx="1123">
                    <c:v>7.0156281662057438E-2</c:v>
                  </c:pt>
                  <c:pt idx="1124">
                    <c:v>7.0157242322046204E-2</c:v>
                  </c:pt>
                  <c:pt idx="1125">
                    <c:v>7.0175053232291409E-2</c:v>
                  </c:pt>
                  <c:pt idx="1126">
                    <c:v>7.024122750584226E-2</c:v>
                  </c:pt>
                  <c:pt idx="1127">
                    <c:v>7.0282854257980948E-2</c:v>
                  </c:pt>
                  <c:pt idx="1128">
                    <c:v>7.0105262623887499E-2</c:v>
                  </c:pt>
                  <c:pt idx="1129">
                    <c:v>6.9412471143986271E-2</c:v>
                  </c:pt>
                  <c:pt idx="1130">
                    <c:v>6.7875753967467214E-2</c:v>
                  </c:pt>
                  <c:pt idx="1131">
                    <c:v>6.5242399165639633E-2</c:v>
                  </c:pt>
                  <c:pt idx="1132">
                    <c:v>6.1451781414324808E-2</c:v>
                  </c:pt>
                  <c:pt idx="1133">
                    <c:v>5.6710621192136774E-2</c:v>
                  </c:pt>
                  <c:pt idx="1134">
                    <c:v>5.1486413175766167E-2</c:v>
                  </c:pt>
                  <c:pt idx="1135">
                    <c:v>4.6405602202614561E-2</c:v>
                  </c:pt>
                  <c:pt idx="1136">
                    <c:v>4.2079222678342715E-2</c:v>
                  </c:pt>
                  <c:pt idx="1137">
                    <c:v>3.8916625224826314E-2</c:v>
                  </c:pt>
                  <c:pt idx="1138">
                    <c:v>3.7019029171865003E-2</c:v>
                  </c:pt>
                  <c:pt idx="1139">
                    <c:v>3.6219881239272889E-2</c:v>
                  </c:pt>
                  <c:pt idx="1140">
                    <c:v>3.6228285456684384E-2</c:v>
                  </c:pt>
                  <c:pt idx="1141">
                    <c:v>3.6754696391616479E-2</c:v>
                  </c:pt>
                  <c:pt idx="1142">
                    <c:v>3.7556372529603213E-2</c:v>
                  </c:pt>
                  <c:pt idx="1143">
                    <c:v>3.8430137071325157E-2</c:v>
                  </c:pt>
                  <c:pt idx="1144">
                    <c:v>3.9199690172818775E-2</c:v>
                  </c:pt>
                  <c:pt idx="1145">
                    <c:v>3.9718467971634169E-2</c:v>
                  </c:pt>
                  <c:pt idx="1146">
                    <c:v>3.9884607976426262E-2</c:v>
                  </c:pt>
                  <c:pt idx="1147">
                    <c:v>3.9656341191434255E-2</c:v>
                  </c:pt>
                  <c:pt idx="1148">
                    <c:v>3.9058819947630379E-2</c:v>
                  </c:pt>
                  <c:pt idx="1149">
                    <c:v>3.8178396449463928E-2</c:v>
                  </c:pt>
                  <c:pt idx="1150">
                    <c:v>3.714308442157925E-2</c:v>
                  </c:pt>
                  <c:pt idx="1151">
                    <c:v>3.6089923044752129E-2</c:v>
                  </c:pt>
                  <c:pt idx="1152">
                    <c:v>3.5125265203124527E-2</c:v>
                  </c:pt>
                  <c:pt idx="1153">
                    <c:v>3.4291928607751612E-2</c:v>
                  </c:pt>
                  <c:pt idx="1154">
                    <c:v>3.3559496396302145E-2</c:v>
                  </c:pt>
                  <c:pt idx="1155">
                    <c:v>3.2843790317538563E-2</c:v>
                  </c:pt>
                  <c:pt idx="1156">
                    <c:v>3.2044815508934177E-2</c:v>
                  </c:pt>
                  <c:pt idx="1157">
                    <c:v>3.1084038434535759E-2</c:v>
                  </c:pt>
                  <c:pt idx="1158">
                    <c:v>2.9926961630384524E-2</c:v>
                  </c:pt>
                  <c:pt idx="1159">
                    <c:v>2.8587575896885757E-2</c:v>
                  </c:pt>
                  <c:pt idx="1160">
                    <c:v>2.7118748645324642E-2</c:v>
                  </c:pt>
                  <c:pt idx="1161">
                    <c:v>2.5595100857628415E-2</c:v>
                  </c:pt>
                  <c:pt idx="1162">
                    <c:v>2.4094508291289358E-2</c:v>
                  </c:pt>
                  <c:pt idx="1163">
                    <c:v>2.2682932487062053E-2</c:v>
                  </c:pt>
                  <c:pt idx="1164">
                    <c:v>2.1405520683263009E-2</c:v>
                  </c:pt>
                  <c:pt idx="1165">
                    <c:v>2.0284899197660754E-2</c:v>
                  </c:pt>
                  <c:pt idx="1166">
                    <c:v>1.9325535803189988E-2</c:v>
                  </c:pt>
                  <c:pt idx="1167">
                    <c:v>1.8521523632867319E-2</c:v>
                  </c:pt>
                  <c:pt idx="1168">
                    <c:v>1.7864687666522102E-2</c:v>
                  </c:pt>
                  <c:pt idx="1169">
                    <c:v>1.7350541779705259E-2</c:v>
                  </c:pt>
                  <c:pt idx="1170">
                    <c:v>1.6980787807746669E-2</c:v>
                  </c:pt>
                  <c:pt idx="1171">
                    <c:v>1.6762191882922144E-2</c:v>
                  </c:pt>
                  <c:pt idx="1172">
                    <c:v>1.6702618412609248E-2</c:v>
                  </c:pt>
                  <c:pt idx="1173">
                    <c:v>1.6805775307721756E-2</c:v>
                  </c:pt>
                  <c:pt idx="1174">
                    <c:v>1.7066659116274013E-2</c:v>
                  </c:pt>
                  <c:pt idx="1175">
                    <c:v>1.7469414461358451E-2</c:v>
                  </c:pt>
                  <c:pt idx="1176">
                    <c:v>1.7988259487640362E-2</c:v>
                  </c:pt>
                  <c:pt idx="1177">
                    <c:v>1.8590832857566825E-2</c:v>
                  </c:pt>
                  <c:pt idx="1178">
                    <c:v>1.924255292324982E-2</c:v>
                  </c:pt>
                  <c:pt idx="1179">
                    <c:v>1.9910617118579478E-2</c:v>
                  </c:pt>
                  <c:pt idx="1180">
                    <c:v>2.0566787005548891E-2</c:v>
                  </c:pt>
                  <c:pt idx="1181">
                    <c:v>2.1188653778562758E-2</c:v>
                  </c:pt>
                  <c:pt idx="1182">
                    <c:v>2.1759451797186961E-2</c:v>
                  </c:pt>
                  <c:pt idx="1183">
                    <c:v>2.2266711952325255E-2</c:v>
                  </c:pt>
                  <c:pt idx="1184">
                    <c:v>2.2700221533798422E-2</c:v>
                  </c:pt>
                  <c:pt idx="1185">
                    <c:v>2.3049926719912975E-2</c:v>
                  </c:pt>
                  <c:pt idx="1186">
                    <c:v>2.3304531168627952E-2</c:v>
                  </c:pt>
                  <c:pt idx="1187">
                    <c:v>2.3451506713122617E-2</c:v>
                  </c:pt>
                  <c:pt idx="1188">
                    <c:v>2.3478952384680948E-2</c:v>
                  </c:pt>
                  <c:pt idx="1189">
                    <c:v>2.3379211473163897E-2</c:v>
                  </c:pt>
                  <c:pt idx="1190">
                    <c:v>2.3153481092861177E-2</c:v>
                  </c:pt>
                  <c:pt idx="1191">
                    <c:v>2.2815992104493761E-2</c:v>
                  </c:pt>
                  <c:pt idx="1192">
                    <c:v>2.2395896800307312E-2</c:v>
                  </c:pt>
                  <c:pt idx="1193">
                    <c:v>2.1935019363444917E-2</c:v>
                  </c:pt>
                  <c:pt idx="1194">
                    <c:v>2.14804212679282E-2</c:v>
                  </c:pt>
                  <c:pt idx="1195">
                    <c:v>2.1072582156728293E-2</c:v>
                  </c:pt>
                  <c:pt idx="1196">
                    <c:v>2.0732598894999291E-2</c:v>
                  </c:pt>
                  <c:pt idx="1197">
                    <c:v>2.0453705482108467E-2</c:v>
                  </c:pt>
                  <c:pt idx="1198">
                    <c:v>2.0201590662370851E-2</c:v>
                  </c:pt>
                  <c:pt idx="1199">
                    <c:v>1.992409467755293E-2</c:v>
                  </c:pt>
                  <c:pt idx="1200">
                    <c:v>1.9566474507849346E-2</c:v>
                  </c:pt>
                  <c:pt idx="1201">
                    <c:v>1.9086635766927471E-2</c:v>
                  </c:pt>
                  <c:pt idx="1202">
                    <c:v>1.8466006133117913E-2</c:v>
                  </c:pt>
                  <c:pt idx="1203">
                    <c:v>1.7714194930696366E-2</c:v>
                  </c:pt>
                  <c:pt idx="1204">
                    <c:v>1.6867469459579253E-2</c:v>
                  </c:pt>
                  <c:pt idx="1205">
                    <c:v>1.5981902995090509E-2</c:v>
                  </c:pt>
                  <c:pt idx="1206">
                    <c:v>1.5122264849668937E-2</c:v>
                  </c:pt>
                  <c:pt idx="1207">
                    <c:v>1.4348106912342597E-2</c:v>
                  </c:pt>
                  <c:pt idx="1208">
                    <c:v>1.3699661933999034E-2</c:v>
                  </c:pt>
                  <c:pt idx="1209">
                    <c:v>1.318773355788724E-2</c:v>
                  </c:pt>
                  <c:pt idx="1210">
                    <c:v>1.2791831878145907E-2</c:v>
                  </c:pt>
                  <c:pt idx="1211">
                    <c:v>1.246769626888899E-2</c:v>
                  </c:pt>
                  <c:pt idx="1212">
                    <c:v>1.2160675024437552E-2</c:v>
                  </c:pt>
                  <c:pt idx="1213">
                    <c:v>1.1819207921431379E-2</c:v>
                  </c:pt>
                  <c:pt idx="1214">
                    <c:v>1.1404286121048865E-2</c:v>
                  </c:pt>
                  <c:pt idx="1215">
                    <c:v>1.0893856857881107E-2</c:v>
                  </c:pt>
                  <c:pt idx="1216">
                    <c:v>1.0283200152746171E-2</c:v>
                  </c:pt>
                  <c:pt idx="1217">
                    <c:v>9.582897496853272E-3</c:v>
                  </c:pt>
                  <c:pt idx="1218">
                    <c:v>8.8158522630345845E-3</c:v>
                  </c:pt>
                  <c:pt idx="1219">
                    <c:v>8.0145300904790225E-3</c:v>
                  </c:pt>
                  <c:pt idx="1220">
                    <c:v>7.2193554582004492E-3</c:v>
                  </c:pt>
                  <c:pt idx="1221">
                    <c:v>6.4788447405357804E-3</c:v>
                  </c:pt>
                  <c:pt idx="1222">
                    <c:v>5.8509380696911799E-3</c:v>
                  </c:pt>
                  <c:pt idx="1223">
                    <c:v>5.4020251573025637E-3</c:v>
                  </c:pt>
                  <c:pt idx="1224">
                    <c:v>5.1960525022350136E-3</c:v>
                  </c:pt>
                  <c:pt idx="1225">
                    <c:v>5.2696971955318644E-3</c:v>
                  </c:pt>
                  <c:pt idx="1226">
                    <c:v>5.6097793620542343E-3</c:v>
                  </c:pt>
                  <c:pt idx="1227">
                    <c:v>6.1575816337230641E-3</c:v>
                  </c:pt>
                  <c:pt idx="1228">
                    <c:v>6.8342039826959806E-3</c:v>
                  </c:pt>
                  <c:pt idx="1229">
                    <c:v>7.5621087002765717E-3</c:v>
                  </c:pt>
                  <c:pt idx="1230">
                    <c:v>8.2749015166066267E-3</c:v>
                  </c:pt>
                  <c:pt idx="1231">
                    <c:v>8.9209762324996503E-3</c:v>
                  </c:pt>
                  <c:pt idx="1232">
                    <c:v>9.465643294540348E-3</c:v>
                  </c:pt>
                  <c:pt idx="1233">
                    <c:v>9.8924232473407113E-3</c:v>
                  </c:pt>
                  <c:pt idx="1234">
                    <c:v>1.0202384698907531E-2</c:v>
                  </c:pt>
                  <c:pt idx="1235">
                    <c:v>1.0410522529400246E-2</c:v>
                  </c:pt>
                  <c:pt idx="1236">
                    <c:v>1.0539418710034462E-2</c:v>
                  </c:pt>
                  <c:pt idx="1237">
                    <c:v>1.0612092701586574E-2</c:v>
                  </c:pt>
                  <c:pt idx="1238">
                    <c:v>1.0647005387812707E-2</c:v>
                  </c:pt>
                  <c:pt idx="1239">
                    <c:v>1.0657485568579499E-2</c:v>
                  </c:pt>
                  <c:pt idx="1240">
                    <c:v>1.0655099901436696E-2</c:v>
                  </c:pt>
                  <c:pt idx="1241">
                    <c:v>1.0653085834358537E-2</c:v>
                  </c:pt>
                  <c:pt idx="1242">
                    <c:v>1.0664822835709296E-2</c:v>
                  </c:pt>
                  <c:pt idx="1243">
                    <c:v>1.0695966727343433E-2</c:v>
                  </c:pt>
                  <c:pt idx="1244">
                    <c:v>1.073543457353505E-2</c:v>
                  </c:pt>
                  <c:pt idx="1245">
                    <c:v>1.0752582445666332E-2</c:v>
                  </c:pt>
                  <c:pt idx="1246">
                    <c:v>1.070250858080268E-2</c:v>
                  </c:pt>
                  <c:pt idx="1247">
                    <c:v>1.0536233581578814E-2</c:v>
                  </c:pt>
                  <c:pt idx="1248">
                    <c:v>1.0213045182676994E-2</c:v>
                  </c:pt>
                  <c:pt idx="1249">
                    <c:v>9.7131099927251149E-3</c:v>
                  </c:pt>
                  <c:pt idx="1250">
                    <c:v>9.0466193869288992E-3</c:v>
                  </c:pt>
                  <c:pt idx="1251">
                    <c:v>8.2558574548342954E-3</c:v>
                  </c:pt>
                  <c:pt idx="1252">
                    <c:v>7.4098853234417852E-3</c:v>
                  </c:pt>
                  <c:pt idx="1253">
                    <c:v>6.593854987135649E-3</c:v>
                  </c:pt>
                  <c:pt idx="1254">
                    <c:v>5.8939495365134056E-3</c:v>
                  </c:pt>
                  <c:pt idx="1255">
                    <c:v>5.377180117187878E-3</c:v>
                  </c:pt>
                  <c:pt idx="1256">
                    <c:v>5.0692160331193168E-3</c:v>
                  </c:pt>
                  <c:pt idx="1257">
                    <c:v>4.9443902744648292E-3</c:v>
                  </c:pt>
                  <c:pt idx="1258">
                    <c:v>4.9409529682683858E-3</c:v>
                  </c:pt>
                  <c:pt idx="1259">
                    <c:v>4.9910041361244601E-3</c:v>
                  </c:pt>
                  <c:pt idx="1260">
                    <c:v>5.0427855846328605E-3</c:v>
                  </c:pt>
                  <c:pt idx="1261">
                    <c:v>5.0679778288559027E-3</c:v>
                  </c:pt>
                  <c:pt idx="1262">
                    <c:v>5.0597586836061467E-3</c:v>
                  </c:pt>
                  <c:pt idx="1263">
                    <c:v>5.0275215922129524E-3</c:v>
                  </c:pt>
                  <c:pt idx="1264">
                    <c:v>4.9904540398727293E-3</c:v>
                  </c:pt>
                  <c:pt idx="1265">
                    <c:v>4.9703389649484652E-3</c:v>
                  </c:pt>
                  <c:pt idx="1266">
                    <c:v>4.984333045307124E-3</c:v>
                  </c:pt>
                  <c:pt idx="1267">
                    <c:v>5.0397864102950463E-3</c:v>
                  </c:pt>
                  <c:pt idx="1268">
                    <c:v>5.1334357691839843E-3</c:v>
                  </c:pt>
                  <c:pt idx="1269">
                    <c:v>5.2553822243492521E-3</c:v>
                  </c:pt>
                  <c:pt idx="1270">
                    <c:v>5.3955423408790495E-3</c:v>
                  </c:pt>
                  <c:pt idx="1271">
                    <c:v>5.5491413875679418E-3</c:v>
                  </c:pt>
                  <c:pt idx="1272">
                    <c:v>5.7187636704857546E-3</c:v>
                  </c:pt>
                  <c:pt idx="1273">
                    <c:v>5.9122713709916863E-3</c:v>
                  </c:pt>
                  <c:pt idx="1274">
                    <c:v>6.1376327399157169E-3</c:v>
                  </c:pt>
                  <c:pt idx="1275">
                    <c:v>6.3969960083947886E-3</c:v>
                  </c:pt>
                  <c:pt idx="1276">
                    <c:v>6.6826643415707522E-3</c:v>
                  </c:pt>
                  <c:pt idx="1277">
                    <c:v>6.9765676155311125E-3</c:v>
                  </c:pt>
                  <c:pt idx="1278">
                    <c:v>7.2530355457427961E-3</c:v>
                  </c:pt>
                  <c:pt idx="1279">
                    <c:v>7.4834472849032831E-3</c:v>
                  </c:pt>
                  <c:pt idx="1280">
                    <c:v>7.6411995356667562E-3</c:v>
                  </c:pt>
                  <c:pt idx="1281">
                    <c:v>7.7058918022013274E-3</c:v>
                  </c:pt>
                  <c:pt idx="1282">
                    <c:v>7.6660695851180393E-3</c:v>
                  </c:pt>
                  <c:pt idx="1283">
                    <c:v>7.5201837037413089E-3</c:v>
                  </c:pt>
                  <c:pt idx="1284">
                    <c:v>7.275779111787492E-3</c:v>
                  </c:pt>
                  <c:pt idx="1285">
                    <c:v>6.9473632903282317E-3</c:v>
                  </c:pt>
                  <c:pt idx="1286">
                    <c:v>6.5537412592602436E-3</c:v>
                  </c:pt>
                  <c:pt idx="1287">
                    <c:v>6.1156168502455891E-3</c:v>
                  </c:pt>
                  <c:pt idx="1288">
                    <c:v>5.6539172427049703E-3</c:v>
                  </c:pt>
                  <c:pt idx="1289">
                    <c:v>5.1888197746135269E-3</c:v>
                  </c:pt>
                  <c:pt idx="1290">
                    <c:v>4.7391377894893125E-3</c:v>
                  </c:pt>
                  <c:pt idx="1291">
                    <c:v>4.3216837587721508E-3</c:v>
                  </c:pt>
                  <c:pt idx="1292">
                    <c:v>3.9503907465533051E-3</c:v>
                  </c:pt>
                  <c:pt idx="1293">
                    <c:v>3.6351984010716126E-3</c:v>
                  </c:pt>
                  <c:pt idx="1294">
                    <c:v>3.3809429537311583E-3</c:v>
                  </c:pt>
                  <c:pt idx="1295">
                    <c:v>3.1867084498155424E-3</c:v>
                  </c:pt>
                  <c:pt idx="1296">
                    <c:v>3.0461471214236545E-3</c:v>
                  </c:pt>
                  <c:pt idx="1297">
                    <c:v>2.948953400881298E-3</c:v>
                  </c:pt>
                  <c:pt idx="1298">
                    <c:v>2.8830849377089441E-3</c:v>
                  </c:pt>
                  <c:pt idx="1299">
                    <c:v>2.8369484021930303E-3</c:v>
                  </c:pt>
                  <c:pt idx="1300">
                    <c:v>2.8009128203039303E-3</c:v>
                  </c:pt>
                  <c:pt idx="1301">
                    <c:v>2.7679545604225148E-3</c:v>
                  </c:pt>
                  <c:pt idx="1302">
                    <c:v>2.73359129905878E-3</c:v>
                  </c:pt>
                  <c:pt idx="1303">
                    <c:v>2.6953892099870771E-3</c:v>
                  </c:pt>
                  <c:pt idx="1304">
                    <c:v>2.6523061941054827E-3</c:v>
                  </c:pt>
                  <c:pt idx="1305">
                    <c:v>2.6040652502308365E-3</c:v>
                  </c:pt>
                  <c:pt idx="1306">
                    <c:v>2.5506792721072631E-3</c:v>
                  </c:pt>
                  <c:pt idx="1307">
                    <c:v>2.4921786604605576E-3</c:v>
                  </c:pt>
                  <c:pt idx="1308">
                    <c:v>2.4285299098618911E-3</c:v>
                  </c:pt>
                  <c:pt idx="1309">
                    <c:v>2.3596872141758716E-3</c:v>
                  </c:pt>
                  <c:pt idx="1310">
                    <c:v>2.2857009025435736E-3</c:v>
                  </c:pt>
                  <c:pt idx="1311">
                    <c:v>2.2068169844110049E-3</c:v>
                  </c:pt>
                  <c:pt idx="1312">
                    <c:v>2.1235302945050837E-3</c:v>
                  </c:pt>
                  <c:pt idx="1313">
                    <c:v>2.0365851715169669E-3</c:v>
                  </c:pt>
                  <c:pt idx="1314">
                    <c:v>1.9469422792289227E-3</c:v>
                  </c:pt>
                  <c:pt idx="1315">
                    <c:v>1.8557464702509093E-3</c:v>
                  </c:pt>
                  <c:pt idx="1316">
                    <c:v>1.7643448664085818E-3</c:v>
                  </c:pt>
                  <c:pt idx="1317">
                    <c:v>1.6744254452911345E-3</c:v>
                  </c:pt>
                  <c:pt idx="1318">
                    <c:v>1.588379334403352E-3</c:v>
                  </c:pt>
                  <c:pt idx="1319">
                    <c:v>1.5100189672628062E-3</c:v>
                  </c:pt>
                  <c:pt idx="1320">
                    <c:v>1.445738516651984E-3</c:v>
                  </c:pt>
                  <c:pt idx="1321">
                    <c:v>1.4058972269147603E-3</c:v>
                  </c:pt>
                  <c:pt idx="1322">
                    <c:v>1.4053929046877829E-3</c:v>
                  </c:pt>
                  <c:pt idx="1323">
                    <c:v>1.4614254648648818E-3</c:v>
                  </c:pt>
                  <c:pt idx="1324">
                    <c:v>1.587424026933926E-3</c:v>
                  </c:pt>
                  <c:pt idx="1325">
                    <c:v>1.78634054866E-3</c:v>
                  </c:pt>
                  <c:pt idx="1326">
                    <c:v>2.0484195422014826E-3</c:v>
                  </c:pt>
                  <c:pt idx="1327">
                    <c:v>2.353745357503447E-3</c:v>
                  </c:pt>
                  <c:pt idx="1328">
                    <c:v>2.6760871984176397E-3</c:v>
                  </c:pt>
                  <c:pt idx="1329">
                    <c:v>2.9861819236531354E-3</c:v>
                  </c:pt>
                  <c:pt idx="1330">
                    <c:v>3.2546975721919982E-3</c:v>
                  </c:pt>
                  <c:pt idx="1331">
                    <c:v>3.4553215117340079E-3</c:v>
                  </c:pt>
                  <c:pt idx="1332">
                    <c:v>3.5678646111954181E-3</c:v>
                  </c:pt>
                  <c:pt idx="1333">
                    <c:v>3.5808801483120964E-3</c:v>
                  </c:pt>
                  <c:pt idx="1334">
                    <c:v>3.4932316199293187E-3</c:v>
                  </c:pt>
                  <c:pt idx="1335">
                    <c:v>3.3142334389297608E-3</c:v>
                  </c:pt>
                  <c:pt idx="1336">
                    <c:v>3.0623169450118893E-3</c:v>
                  </c:pt>
                  <c:pt idx="1337">
                    <c:v>2.7625130806341754E-3</c:v>
                  </c:pt>
                  <c:pt idx="1338">
                    <c:v>2.4432675265815182E-3</c:v>
                  </c:pt>
                  <c:pt idx="1339">
                    <c:v>2.1331136721164084E-3</c:v>
                  </c:pt>
                  <c:pt idx="1340">
                    <c:v>1.8574838787449967E-3</c:v>
                  </c:pt>
                  <c:pt idx="1341">
                    <c:v>1.6355801669780531E-3</c:v>
                  </c:pt>
                  <c:pt idx="1342">
                    <c:v>1.4773026313813079E-3</c:v>
                  </c:pt>
                  <c:pt idx="1343">
                    <c:v>1.3813983099258441E-3</c:v>
                  </c:pt>
                  <c:pt idx="1344">
                    <c:v>1.33705266181422E-3</c:v>
                  </c:pt>
                  <c:pt idx="1345">
                    <c:v>1.3291062168818506E-3</c:v>
                  </c:pt>
                  <c:pt idx="1346">
                    <c:v>1.3435404506668329E-3</c:v>
                  </c:pt>
                  <c:pt idx="1347">
                    <c:v>1.3702094342531201E-3</c:v>
                  </c:pt>
                  <c:pt idx="1348">
                    <c:v>1.4028925555061699E-3</c:v>
                  </c:pt>
                  <c:pt idx="1349">
                    <c:v>1.438202645466829E-3</c:v>
                  </c:pt>
                  <c:pt idx="1350">
                    <c:v>1.4744464402176249E-3</c:v>
                  </c:pt>
                  <c:pt idx="1351">
                    <c:v>1.5108124796565571E-3</c:v>
                  </c:pt>
                  <c:pt idx="1352">
                    <c:v>1.5468882822786498E-3</c:v>
                  </c:pt>
                  <c:pt idx="1353">
                    <c:v>1.5824057385591744E-3</c:v>
                  </c:pt>
                  <c:pt idx="1354">
                    <c:v>1.6171200117063396E-3</c:v>
                  </c:pt>
                  <c:pt idx="1355">
                    <c:v>1.6507585741753264E-3</c:v>
                  </c:pt>
                  <c:pt idx="1356">
                    <c:v>1.6830044994463459E-3</c:v>
                  </c:pt>
                  <c:pt idx="1357">
                    <c:v>1.7134958738854308E-3</c:v>
                  </c:pt>
                  <c:pt idx="1358">
                    <c:v>1.7418329990104581E-3</c:v>
                  </c:pt>
                  <c:pt idx="1359">
                    <c:v>1.7675898314205628E-3</c:v>
                  </c:pt>
                  <c:pt idx="1360">
                    <c:v>1.7903282480962962E-3</c:v>
                  </c:pt>
                  <c:pt idx="1361">
                    <c:v>1.8096142872174551E-3</c:v>
                  </c:pt>
                  <c:pt idx="1362">
                    <c:v>1.825035757115288E-3</c:v>
                  </c:pt>
                  <c:pt idx="1363">
                    <c:v>1.836220414104626E-3</c:v>
                  </c:pt>
                  <c:pt idx="1364">
                    <c:v>1.8428538223632216E-3</c:v>
                  </c:pt>
                  <c:pt idx="1365">
                    <c:v>1.8446959028657335E-3</c:v>
                  </c:pt>
                  <c:pt idx="1366">
                    <c:v>1.8415952562491529E-3</c:v>
                  </c:pt>
                  <c:pt idx="1367">
                    <c:v>1.8335002751599559E-3</c:v>
                  </c:pt>
                  <c:pt idx="1368">
                    <c:v>1.8204664268853586E-3</c:v>
                  </c:pt>
                  <c:pt idx="1369">
                    <c:v>1.8026590610453748E-3</c:v>
                  </c:pt>
                  <c:pt idx="1370">
                    <c:v>1.780351527234507E-3</c:v>
                  </c:pt>
                  <c:pt idx="1371">
                    <c:v>1.7539185300514315E-3</c:v>
                  </c:pt>
                  <c:pt idx="1372">
                    <c:v>1.72382500296286E-3</c:v>
                  </c:pt>
                  <c:pt idx="1373">
                    <c:v>1.6906110311311041E-3</c:v>
                  </c:pt>
                  <c:pt idx="1374">
                    <c:v>1.6548736575774277E-3</c:v>
                  </c:pt>
                  <c:pt idx="1375">
                    <c:v>1.6172466763272671E-3</c:v>
                  </c:pt>
                  <c:pt idx="1376">
                    <c:v>1.5783798294360719E-3</c:v>
                  </c:pt>
                  <c:pt idx="1377">
                    <c:v>1.5389189712926301E-3</c:v>
                  </c:pt>
                  <c:pt idx="1378">
                    <c:v>1.4994888666205065E-3</c:v>
                  </c:pt>
                  <c:pt idx="1379">
                    <c:v>1.46068037434923E-3</c:v>
                  </c:pt>
                  <c:pt idx="1380">
                    <c:v>1.4230433949994202E-3</c:v>
                  </c:pt>
                  <c:pt idx="1381">
                    <c:v>1.3870867831678173E-3</c:v>
                  </c:pt>
                  <c:pt idx="1382">
                    <c:v>1.3532857254542365E-3</c:v>
                  </c:pt>
                  <c:pt idx="1383">
                    <c:v>1.3220966560255761E-3</c:v>
                  </c:pt>
                  <c:pt idx="1384">
                    <c:v>1.2939791881816014E-3</c:v>
                  </c:pt>
                  <c:pt idx="1385">
                    <c:v>1.2694242498632485E-3</c:v>
                  </c:pt>
                  <c:pt idx="1386">
                    <c:v>1.2489875393146685E-3</c:v>
                  </c:pt>
                  <c:pt idx="1387">
                    <c:v>1.2333274183232465E-3</c:v>
                  </c:pt>
                  <c:pt idx="1388">
                    <c:v>1.2232459941802574E-3</c:v>
                  </c:pt>
                  <c:pt idx="1389">
                    <c:v>1.2197308555069381E-3</c:v>
                  </c:pt>
                  <c:pt idx="1390">
                    <c:v>1.2239914570808051E-3</c:v>
                  </c:pt>
                  <c:pt idx="1391">
                    <c:v>1.2374789301408315E-3</c:v>
                  </c:pt>
                  <c:pt idx="1392">
                    <c:v>1.2618717689361718E-3</c:v>
                  </c:pt>
                  <c:pt idx="1393">
                    <c:v>1.2990069353932883E-3</c:v>
                  </c:pt>
                  <c:pt idx="1394">
                    <c:v>1.3507417270474714E-3</c:v>
                  </c:pt>
                  <c:pt idx="1395">
                    <c:v>1.4187495535283379E-3</c:v>
                  </c:pt>
                  <c:pt idx="1396">
                    <c:v>1.5042789204778432E-3</c:v>
                  </c:pt>
                  <c:pt idx="1397">
                    <c:v>1.6079260093853978E-3</c:v>
                  </c:pt>
                  <c:pt idx="1398">
                    <c:v>1.7294748245688185E-3</c:v>
                  </c:pt>
                  <c:pt idx="1399">
                    <c:v>1.8678418928383927E-3</c:v>
                  </c:pt>
                  <c:pt idx="1400">
                    <c:v>2.0211367051246316E-3</c:v>
                  </c:pt>
                  <c:pt idx="1401">
                    <c:v>2.1868269827283733E-3</c:v>
                  </c:pt>
                  <c:pt idx="1402">
                    <c:v>2.3619825862635437E-3</c:v>
                  </c:pt>
                  <c:pt idx="1403">
                    <c:v>2.5435557935614911E-3</c:v>
                  </c:pt>
                  <c:pt idx="1404">
                    <c:v>2.7286329050448662E-3</c:v>
                  </c:pt>
                  <c:pt idx="1405">
                    <c:v>2.9145723659362408E-3</c:v>
                  </c:pt>
                  <c:pt idx="1406">
                    <c:v>3.0989576611190799E-3</c:v>
                  </c:pt>
                  <c:pt idx="1407">
                    <c:v>3.279367179867064E-3</c:v>
                  </c:pt>
                  <c:pt idx="1408">
                    <c:v>3.4530838296787142E-3</c:v>
                  </c:pt>
                  <c:pt idx="1409">
                    <c:v>3.6169528583281851E-3</c:v>
                  </c:pt>
                  <c:pt idx="1410">
                    <c:v>3.7675470139016962E-3</c:v>
                  </c:pt>
                  <c:pt idx="1411">
                    <c:v>3.9016027545727911E-3</c:v>
                  </c:pt>
                  <c:pt idx="1412">
                    <c:v>4.0164801439046523E-3</c:v>
                  </c:pt>
                  <c:pt idx="1413">
                    <c:v>4.1103535433141582E-3</c:v>
                  </c:pt>
                  <c:pt idx="1414">
                    <c:v>4.1820202611551963E-3</c:v>
                  </c:pt>
                  <c:pt idx="1415">
                    <c:v>4.2304870633031941E-3</c:v>
                  </c:pt>
                  <c:pt idx="1416">
                    <c:v>4.2546430588418028E-3</c:v>
                  </c:pt>
                  <c:pt idx="1417">
                    <c:v>4.2532442115262139E-3</c:v>
                  </c:pt>
                  <c:pt idx="1418">
                    <c:v>4.2252089656365397E-3</c:v>
                  </c:pt>
                  <c:pt idx="1419">
                    <c:v>4.1700433410252766E-3</c:v>
                  </c:pt>
                  <c:pt idx="1420">
                    <c:v>4.088187895280742E-3</c:v>
                  </c:pt>
                  <c:pt idx="1421">
                    <c:v>3.981174681697632E-3</c:v>
                  </c:pt>
                  <c:pt idx="1422">
                    <c:v>3.8515974305817803E-3</c:v>
                  </c:pt>
                  <c:pt idx="1423">
                    <c:v>3.7029605233233594E-3</c:v>
                  </c:pt>
                  <c:pt idx="1424">
                    <c:v>3.5394761182150737E-3</c:v>
                  </c:pt>
                  <c:pt idx="1425">
                    <c:v>3.3658532555496268E-3</c:v>
                  </c:pt>
                  <c:pt idx="1426">
                    <c:v>3.1870967824243462E-3</c:v>
                  </c:pt>
                  <c:pt idx="1427">
                    <c:v>3.0083188117059493E-3</c:v>
                  </c:pt>
                  <c:pt idx="1428">
                    <c:v>2.8345596066235595E-3</c:v>
                  </c:pt>
                  <c:pt idx="1429">
                    <c:v>2.6706137116528977E-3</c:v>
                  </c:pt>
                  <c:pt idx="1430">
                    <c:v>2.5208571906248029E-3</c:v>
                  </c:pt>
                  <c:pt idx="1431">
                    <c:v>2.3890738379373213E-3</c:v>
                  </c:pt>
                  <c:pt idx="1432">
                    <c:v>2.2782839893903256E-3</c:v>
                  </c:pt>
                  <c:pt idx="1433">
                    <c:v>2.1905908911693962E-3</c:v>
                  </c:pt>
                  <c:pt idx="1434">
                    <c:v>2.1270725053407252E-3</c:v>
                  </c:pt>
                  <c:pt idx="1435">
                    <c:v>2.0877521730651642E-3</c:v>
                  </c:pt>
                  <c:pt idx="1436">
                    <c:v>2.0716697243564654E-3</c:v>
                  </c:pt>
                  <c:pt idx="1437">
                    <c:v>2.0770454041474508E-3</c:v>
                  </c:pt>
                  <c:pt idx="1438">
                    <c:v>2.1014976814713385E-3</c:v>
                  </c:pt>
                  <c:pt idx="1439">
                    <c:v>2.1422628177435359E-3</c:v>
                  </c:pt>
                  <c:pt idx="1440">
                    <c:v>2.196376060922657E-3</c:v>
                  </c:pt>
                  <c:pt idx="1441">
                    <c:v>2.2608011947622764E-3</c:v>
                  </c:pt>
                  <c:pt idx="1442">
                    <c:v>2.3325189322971986E-3</c:v>
                  </c:pt>
                  <c:pt idx="1443">
                    <c:v>2.4085946480088176E-3</c:v>
                  </c:pt>
                  <c:pt idx="1444">
                    <c:v>2.4862418486445216E-3</c:v>
                  </c:pt>
                  <c:pt idx="1445">
                    <c:v>2.5628861432135629E-3</c:v>
                  </c:pt>
                  <c:pt idx="1446">
                    <c:v>2.6362233198878801E-3</c:v>
                  </c:pt>
                  <c:pt idx="1447">
                    <c:v>2.7042598794917621E-3</c:v>
                  </c:pt>
                  <c:pt idx="1448">
                    <c:v>2.7653267303589637E-3</c:v>
                  </c:pt>
                  <c:pt idx="1449">
                    <c:v>2.8180648851532132E-3</c:v>
                  </c:pt>
                  <c:pt idx="1450">
                    <c:v>2.8613912810069404E-3</c:v>
                  </c:pt>
                  <c:pt idx="1451">
                    <c:v>2.8944578457793342E-3</c:v>
                  </c:pt>
                  <c:pt idx="1452">
                    <c:v>2.9166149663025082E-3</c:v>
                  </c:pt>
                  <c:pt idx="1453">
                    <c:v>2.9273818768438225E-3</c:v>
                  </c:pt>
                  <c:pt idx="1454">
                    <c:v>2.9264162293833247E-3</c:v>
                  </c:pt>
                  <c:pt idx="1455">
                    <c:v>2.9134698796240478E-3</c:v>
                  </c:pt>
                  <c:pt idx="1456">
                    <c:v>2.8883229562230127E-3</c:v>
                  </c:pt>
                  <c:pt idx="1457">
                    <c:v>2.8507035692586754E-3</c:v>
                  </c:pt>
                  <c:pt idx="1458">
                    <c:v>2.8002197127039328E-3</c:v>
                  </c:pt>
                  <c:pt idx="1459">
                    <c:v>2.7363421543263227E-3</c:v>
                  </c:pt>
                  <c:pt idx="1460">
                    <c:v>2.6584727267123087E-3</c:v>
                  </c:pt>
                  <c:pt idx="1461">
                    <c:v>2.5661088909850506E-3</c:v>
                  </c:pt>
                  <c:pt idx="1462">
                    <c:v>2.4590800515834213E-3</c:v>
                  </c:pt>
                  <c:pt idx="1463">
                    <c:v>2.3377993378739673E-3</c:v>
                  </c:pt>
                  <c:pt idx="1464">
                    <c:v>2.2034600764355467E-3</c:v>
                  </c:pt>
                  <c:pt idx="1465">
                    <c:v>2.0581159050929872E-3</c:v>
                  </c:pt>
                  <c:pt idx="1466">
                    <c:v>1.9046131235927E-3</c:v>
                  </c:pt>
                  <c:pt idx="1467">
                    <c:v>1.7463823241104248E-3</c:v>
                  </c:pt>
                  <c:pt idx="1468">
                    <c:v>1.5871308357737609E-3</c:v>
                  </c:pt>
                  <c:pt idx="1469">
                    <c:v>1.4304985248852346E-3</c:v>
                  </c:pt>
                  <c:pt idx="1470">
                    <c:v>1.2797429425241858E-3</c:v>
                  </c:pt>
                  <c:pt idx="1471">
                    <c:v>1.1375067887669898E-3</c:v>
                  </c:pt>
                  <c:pt idx="1472">
                    <c:v>1.005696846253921E-3</c:v>
                  </c:pt>
                  <c:pt idx="1473">
                    <c:v>8.8547602167895383E-4</c:v>
                  </c:pt>
                  <c:pt idx="1474">
                    <c:v>7.773466911314195E-4</c:v>
                  </c:pt>
                  <c:pt idx="1475">
                    <c:v>6.812896163834011E-4</c:v>
                  </c:pt>
                  <c:pt idx="1476">
                    <c:v>5.9692059093091935E-4</c:v>
                  </c:pt>
                  <c:pt idx="1477">
                    <c:v>5.2363441556923965E-4</c:v>
                  </c:pt>
                  <c:pt idx="1478">
                    <c:v>4.6071846035373651E-4</c:v>
                  </c:pt>
                  <c:pt idx="1479">
                    <c:v>4.0743019360892384E-4</c:v>
                  </c:pt>
                  <c:pt idx="1480">
                    <c:v>3.6304120791332131E-4</c:v>
                  </c:pt>
                  <c:pt idx="1481">
                    <c:v>3.268540994178243E-4</c:v>
                  </c:pt>
                  <c:pt idx="1482">
                    <c:v>2.9819933559618856E-4</c:v>
                  </c:pt>
                  <c:pt idx="1483">
                    <c:v>2.7642039851778554E-4</c:v>
                  </c:pt>
                  <c:pt idx="1484">
                    <c:v>2.6085708390678536E-4</c:v>
                  </c:pt>
                  <c:pt idx="1485">
                    <c:v>2.5083781555759467E-4</c:v>
                  </c:pt>
                  <c:pt idx="1486">
                    <c:v>2.4568818223505494E-4</c:v>
                  </c:pt>
                  <c:pt idx="1487">
                    <c:v>2.4475458818755814E-4</c:v>
                  </c:pt>
                  <c:pt idx="1488">
                    <c:v>2.47433839134808E-4</c:v>
                  </c:pt>
                  <c:pt idx="1489">
                    <c:v>2.5319717688481239E-4</c:v>
                  </c:pt>
                  <c:pt idx="1490">
                    <c:v>2.6160179770569266E-4</c:v>
                  </c:pt>
                  <c:pt idx="1491">
                    <c:v>2.7228934312037472E-4</c:v>
                  </c:pt>
                  <c:pt idx="1492">
                    <c:v>2.8497521143648396E-4</c:v>
                  </c:pt>
                  <c:pt idx="1493">
                    <c:v>2.9943352874638233E-4</c:v>
                  </c:pt>
                  <c:pt idx="1494">
                    <c:v>3.1548168238682006E-4</c:v>
                  </c:pt>
                  <c:pt idx="1495">
                    <c:v>3.3296658660476061E-4</c:v>
                  </c:pt>
                  <c:pt idx="1496">
                    <c:v>3.517536314548107E-4</c:v>
                  </c:pt>
                  <c:pt idx="1497">
                    <c:v>3.7171840599814363E-4</c:v>
                  </c:pt>
                  <c:pt idx="1498">
                    <c:v>3.9274080537172838E-4</c:v>
                  </c:pt>
                  <c:pt idx="1499">
                    <c:v>4.1470107931527241E-4</c:v>
                  </c:pt>
                  <c:pt idx="1500">
                    <c:v>4.3747730030286452E-4</c:v>
                  </c:pt>
                  <c:pt idx="1501">
                    <c:v>4.6094390435541841E-4</c:v>
                  </c:pt>
                  <c:pt idx="1502">
                    <c:v>4.8497093288082108E-4</c:v>
                  </c:pt>
                  <c:pt idx="1503">
                    <c:v>5.0942380492782877E-4</c:v>
                  </c:pt>
                  <c:pt idx="1504">
                    <c:v>5.3416342199934133E-4</c:v>
                  </c:pt>
                  <c:pt idx="1505">
                    <c:v>5.5904658125540926E-4</c:v>
                  </c:pt>
                  <c:pt idx="1506">
                    <c:v>5.8392651799687577E-4</c:v>
                  </c:pt>
                  <c:pt idx="1507">
                    <c:v>6.0865367553776116E-4</c:v>
                  </c:pt>
                  <c:pt idx="1508">
                    <c:v>6.3307656882817726E-4</c:v>
                  </c:pt>
                  <c:pt idx="1509">
                    <c:v>6.5704277016156662E-4</c:v>
                  </c:pt>
                  <c:pt idx="1510">
                    <c:v>6.8039999372092601E-4</c:v>
                  </c:pt>
                  <c:pt idx="1511">
                    <c:v>7.0299722022259853E-4</c:v>
                  </c:pt>
                  <c:pt idx="1512">
                    <c:v>7.2468584483627253E-4</c:v>
                  </c:pt>
                  <c:pt idx="1513">
                    <c:v>7.4532079578594544E-4</c:v>
                  </c:pt>
                  <c:pt idx="1514">
                    <c:v>7.6476159084039677E-4</c:v>
                  </c:pt>
                  <c:pt idx="1515">
                    <c:v>7.8287327612308567E-4</c:v>
                  </c:pt>
                  <c:pt idx="1516">
                    <c:v>7.9952735174339316E-4</c:v>
                  </c:pt>
                  <c:pt idx="1517">
                    <c:v>8.1460283113483044E-4</c:v>
                  </c:pt>
                  <c:pt idx="1518">
                    <c:v>8.2798802063202895E-4</c:v>
                  </c:pt>
                  <c:pt idx="1519">
                    <c:v>8.3958407796037827E-4</c:v>
                  </c:pt>
                  <c:pt idx="1520">
                    <c:v>8.4931227529214787E-4</c:v>
                  </c:pt>
                  <c:pt idx="1521">
                    <c:v>8.5712796319045888E-4</c:v>
                  </c:pt>
                  <c:pt idx="1522">
                    <c:v>8.6304500646532307E-4</c:v>
                  </c:pt>
                  <c:pt idx="1523">
                    <c:v>8.6717437020648555E-4</c:v>
                  </c:pt>
                  <c:pt idx="1524">
                    <c:v>8.6977774583765364E-4</c:v>
                  </c:pt>
                  <c:pt idx="1525">
                    <c:v>8.7133025188551008E-4</c:v>
                  </c:pt>
                  <c:pt idx="1526">
                    <c:v>8.7257412776357564E-4</c:v>
                  </c:pt>
                  <c:pt idx="1527">
                    <c:v>8.7452957842368143E-4</c:v>
                  </c:pt>
                  <c:pt idx="1528">
                    <c:v>8.7841726768588522E-4</c:v>
                  </c:pt>
                  <c:pt idx="1529">
                    <c:v>8.8545310842817857E-4</c:v>
                  </c:pt>
                  <c:pt idx="1530">
                    <c:v>8.9651586953101898E-4</c:v>
                  </c:pt>
                  <c:pt idx="1531">
                    <c:v>9.1175972176364554E-4</c:v>
                  </c:pt>
                  <c:pt idx="1532">
                    <c:v>9.3031129004706185E-4</c:v>
                  </c:pt>
                  <c:pt idx="1533">
                    <c:v>9.5019645470345267E-4</c:v>
                  </c:pt>
                  <c:pt idx="1534">
                    <c:v>9.6856292009714763E-4</c:v>
                  </c:pt>
                  <c:pt idx="1535">
                    <c:v>9.8214746287716395E-4</c:v>
                  </c:pt>
                  <c:pt idx="1536">
                    <c:v>9.8785617903089109E-4</c:v>
                  </c:pt>
                  <c:pt idx="1537">
                    <c:v>9.8331408505199528E-4</c:v>
                  </c:pt>
                  <c:pt idx="1538">
                    <c:v>9.6727641400698688E-4</c:v>
                  </c:pt>
                  <c:pt idx="1539">
                    <c:v>9.3984292476411671E-4</c:v>
                  </c:pt>
                  <c:pt idx="1540">
                    <c:v>9.0245921743172723E-4</c:v>
                  </c:pt>
                  <c:pt idx="1541">
                    <c:v>8.577207488594139E-4</c:v>
                  </c:pt>
                  <c:pt idx="1542">
                    <c:v>8.0901693458416285E-4</c:v>
                  </c:pt>
                  <c:pt idx="1543">
                    <c:v>7.6006652497097012E-4</c:v>
                  </c:pt>
                  <c:pt idx="1544">
                    <c:v>7.1440646331462538E-4</c:v>
                  </c:pt>
                  <c:pt idx="1545">
                    <c:v>6.749110992216302E-4</c:v>
                  </c:pt>
                  <c:pt idx="1546">
                    <c:v>6.4343651653358625E-4</c:v>
                  </c:pt>
                  <c:pt idx="1547">
                    <c:v>6.2068390133816222E-4</c:v>
                  </c:pt>
                  <c:pt idx="1548">
                    <c:v>6.0632276410159543E-4</c:v>
                  </c:pt>
                  <c:pt idx="1549">
                    <c:v>5.9931336309012825E-4</c:v>
                  </c:pt>
                  <c:pt idx="1550">
                    <c:v>5.9828587498948955E-4</c:v>
                  </c:pt>
                  <c:pt idx="1551">
                    <c:v>6.0183961088287375E-4</c:v>
                  </c:pt>
                  <c:pt idx="1552">
                    <c:v>6.0870316490532371E-4</c:v>
                  </c:pt>
                  <c:pt idx="1553">
                    <c:v>6.1777540511274835E-4</c:v>
                  </c:pt>
                  <c:pt idx="1554">
                    <c:v>6.2810139938413551E-4</c:v>
                  </c:pt>
                  <c:pt idx="1555">
                    <c:v>6.3883170561496736E-4</c:v>
                  </c:pt>
                  <c:pt idx="1556">
                    <c:v>6.4919222992516608E-4</c:v>
                  </c:pt>
                  <c:pt idx="1557">
                    <c:v>6.5847321492352269E-4</c:v>
                  </c:pt>
                  <c:pt idx="1558">
                    <c:v>6.6603511656364875E-4</c:v>
                  </c:pt>
                  <c:pt idx="1559">
                    <c:v>6.7132560498707342E-4</c:v>
                  </c:pt>
                  <c:pt idx="1560">
                    <c:v>6.7390189587132566E-4</c:v>
                  </c:pt>
                  <c:pt idx="1561">
                    <c:v>6.7345402990099485E-4</c:v>
                  </c:pt>
                  <c:pt idx="1562">
                    <c:v>6.698261569094339E-4</c:v>
                  </c:pt>
                  <c:pt idx="1563">
                    <c:v>6.6303375477397655E-4</c:v>
                  </c:pt>
                  <c:pt idx="1564">
                    <c:v>6.5327508756011675E-4</c:v>
                  </c:pt>
                  <c:pt idx="1565">
                    <c:v>6.4093530616847548E-4</c:v>
                  </c:pt>
                  <c:pt idx="1566">
                    <c:v>6.2658124129618721E-4</c:v>
                  </c:pt>
                  <c:pt idx="1567">
                    <c:v>6.1094457867704127E-4</c:v>
                  </c:pt>
                  <c:pt idx="1568">
                    <c:v>5.9489051235263758E-4</c:v>
                  </c:pt>
                  <c:pt idx="1569">
                    <c:v>5.7936910260461517E-4</c:v>
                  </c:pt>
                  <c:pt idx="1570">
                    <c:v>5.653478433969301E-4</c:v>
                  </c:pt>
                  <c:pt idx="1571">
                    <c:v>5.5372752765645472E-4</c:v>
                  </c:pt>
                  <c:pt idx="1572">
                    <c:v>5.4524992145252359E-4</c:v>
                  </c:pt>
                  <c:pt idx="1573">
                    <c:v>5.404130407499491E-4</c:v>
                  </c:pt>
                  <c:pt idx="1574">
                    <c:v>5.394140232852703E-4</c:v>
                  </c:pt>
                  <c:pt idx="1575">
                    <c:v>5.421359436179801E-4</c:v>
                  </c:pt>
                  <c:pt idx="1576">
                    <c:v>5.4818251451935131E-4</c:v>
                  </c:pt>
                  <c:pt idx="1577">
                    <c:v>5.5694941238091863E-4</c:v>
                  </c:pt>
                  <c:pt idx="1578">
                    <c:v>5.6771135469158105E-4</c:v>
                  </c:pt>
                  <c:pt idx="1579">
                    <c:v>5.7970408903249763E-4</c:v>
                  </c:pt>
                  <c:pt idx="1580">
                    <c:v>5.9218802828230554E-4</c:v>
                  </c:pt>
                  <c:pt idx="1581">
                    <c:v>6.0448932441086519E-4</c:v>
                  </c:pt>
                  <c:pt idx="1582">
                    <c:v>6.1602079405560805E-4</c:v>
                  </c:pt>
                  <c:pt idx="1583">
                    <c:v>6.2628819010906859E-4</c:v>
                  </c:pt>
                  <c:pt idx="1584">
                    <c:v>6.3488774883657564E-4</c:v>
                  </c:pt>
                  <c:pt idx="1585">
                    <c:v>6.4149998023759099E-4</c:v>
                  </c:pt>
                  <c:pt idx="1586">
                    <c:v>6.4588342688330646E-4</c:v>
                  </c:pt>
                  <c:pt idx="1587">
                    <c:v>6.4787093833567374E-4</c:v>
                  </c:pt>
                  <c:pt idx="1588">
                    <c:v>6.4737010769203593E-4</c:v>
                  </c:pt>
                  <c:pt idx="1589">
                    <c:v>6.44368735376192E-4</c:v>
                  </c:pt>
                  <c:pt idx="1590">
                    <c:v>6.3894538600412897E-4</c:v>
                  </c:pt>
                  <c:pt idx="1591">
                    <c:v>6.3128401521148352E-4</c:v>
                  </c:pt>
                  <c:pt idx="1592">
                    <c:v>6.2169027218481759E-4</c:v>
                  </c:pt>
                  <c:pt idx="1593">
                    <c:v>6.1060495535706293E-4</c:v>
                  </c:pt>
                  <c:pt idx="1594">
                    <c:v>5.9860755238162863E-4</c:v>
                  </c:pt>
                  <c:pt idx="1595">
                    <c:v>5.8640050590354914E-4</c:v>
                  </c:pt>
                  <c:pt idx="1596">
                    <c:v>5.7476383918729707E-4</c:v>
                  </c:pt>
                  <c:pt idx="1597">
                    <c:v>5.6447282851140141E-4</c:v>
                  </c:pt>
                  <c:pt idx="1598">
                    <c:v>5.5618067373075758E-4</c:v>
                  </c:pt>
                  <c:pt idx="1599">
                    <c:v>5.5028389632816093E-4</c:v>
                  </c:pt>
                  <c:pt idx="1600">
                    <c:v>5.4680463364164655E-4</c:v>
                  </c:pt>
                  <c:pt idx="1601">
                    <c:v>5.4533064477907595E-4</c:v>
                  </c:pt>
                  <c:pt idx="1602">
                    <c:v>5.4504128138199183E-4</c:v>
                  </c:pt>
                  <c:pt idx="1603">
                    <c:v>5.4481996158335167E-4</c:v>
                  </c:pt>
                  <c:pt idx="1604">
                    <c:v>5.4342595082044283E-4</c:v>
                  </c:pt>
                  <c:pt idx="1605">
                    <c:v>5.3968536468155029E-4</c:v>
                  </c:pt>
                  <c:pt idx="1606">
                    <c:v>5.3266560948056106E-4</c:v>
                  </c:pt>
                  <c:pt idx="1607">
                    <c:v>5.2181060725001291E-4</c:v>
                  </c:pt>
                  <c:pt idx="1608">
                    <c:v>5.0702722376229999E-4</c:v>
                  </c:pt>
                  <c:pt idx="1609">
                    <c:v>4.8872172503260081E-4</c:v>
                  </c:pt>
                  <c:pt idx="1610">
                    <c:v>4.677883530405173E-4</c:v>
                  </c:pt>
                  <c:pt idx="1611">
                    <c:v>4.4555113513306666E-4</c:v>
                  </c:pt>
                  <c:pt idx="1612">
                    <c:v>4.2365558438625612E-4</c:v>
                  </c:pt>
                  <c:pt idx="1613">
                    <c:v>4.0390214298260306E-4</c:v>
                  </c:pt>
                  <c:pt idx="1614">
                    <c:v>3.8801636544081171E-4</c:v>
                  </c:pt>
                  <c:pt idx="1615">
                    <c:v>3.773750174224141E-4</c:v>
                  </c:pt>
                  <c:pt idx="1616">
                    <c:v>3.7275528480734026E-4</c:v>
                  </c:pt>
                  <c:pt idx="1617">
                    <c:v>3.7421028175980492E-4</c:v>
                  </c:pt>
                  <c:pt idx="1618">
                    <c:v>3.8113967917341614E-4</c:v>
                  </c:pt>
                  <c:pt idx="1619">
                    <c:v>3.9252054190566318E-4</c:v>
                  </c:pt>
                  <c:pt idx="1620">
                    <c:v>4.0718162522102648E-4</c:v>
                  </c:pt>
                  <c:pt idx="1621">
                    <c:v>4.2401477020013892E-4</c:v>
                  </c:pt>
                  <c:pt idx="1622">
                    <c:v>4.4208517960560387E-4</c:v>
                  </c:pt>
                  <c:pt idx="1623">
                    <c:v>4.6065806880441195E-4</c:v>
                  </c:pt>
                  <c:pt idx="1624">
                    <c:v>4.7917765174448397E-4</c:v>
                  </c:pt>
                  <c:pt idx="1625">
                    <c:v>4.9722862222025064E-4</c:v>
                  </c:pt>
                  <c:pt idx="1626">
                    <c:v>5.1449825691167223E-4</c:v>
                  </c:pt>
                  <c:pt idx="1627">
                    <c:v>5.307472587451872E-4</c:v>
                  </c:pt>
                  <c:pt idx="1628">
                    <c:v>5.4579167031611176E-4</c:v>
                  </c:pt>
                  <c:pt idx="1629">
                    <c:v>5.5949496591067784E-4</c:v>
                  </c:pt>
                  <c:pt idx="1630">
                    <c:v>5.7176812104486733E-4</c:v>
                  </c:pt>
                  <c:pt idx="1631">
                    <c:v>5.8257463983506707E-4</c:v>
                  </c:pt>
                  <c:pt idx="1632">
                    <c:v>5.9193700519904135E-4</c:v>
                  </c:pt>
                  <c:pt idx="1633">
                    <c:v>5.9994027325832274E-4</c:v>
                  </c:pt>
                  <c:pt idx="1634">
                    <c:v>6.0672818303954246E-4</c:v>
                  </c:pt>
                  <c:pt idx="1635">
                    <c:v>6.1248723207878056E-4</c:v>
                  </c:pt>
                  <c:pt idx="1636">
                    <c:v>6.1741577189501943E-4</c:v>
                  </c:pt>
                  <c:pt idx="1637">
                    <c:v>6.2167843779089465E-4</c:v>
                  </c:pt>
                  <c:pt idx="1638">
                    <c:v>6.2535125243066438E-4</c:v>
                  </c:pt>
                  <c:pt idx="1639">
                    <c:v>6.2836804897674911E-4</c:v>
                  </c:pt>
                  <c:pt idx="1640">
                    <c:v>6.3048241693151842E-4</c:v>
                  </c:pt>
                  <c:pt idx="1641">
                    <c:v>6.3125877454853435E-4</c:v>
                  </c:pt>
                  <c:pt idx="1642">
                    <c:v>6.3010062226842361E-4</c:v>
                  </c:pt>
                  <c:pt idx="1643">
                    <c:v>6.2631500293804663E-4</c:v>
                  </c:pt>
                  <c:pt idx="1644">
                    <c:v>6.1920308060133575E-4</c:v>
                  </c:pt>
                  <c:pt idx="1645">
                    <c:v>6.081605125732144E-4</c:v>
                  </c:pt>
                  <c:pt idx="1646">
                    <c:v>5.9276972772811024E-4</c:v>
                  </c:pt>
                  <c:pt idx="1647">
                    <c:v>5.7286885777387106E-4</c:v>
                  </c:pt>
                  <c:pt idx="1648">
                    <c:v>5.4858725743823762E-4</c:v>
                  </c:pt>
                  <c:pt idx="1649">
                    <c:v>5.2034387338805333E-4</c:v>
                  </c:pt>
                  <c:pt idx="1650">
                    <c:v>4.8881055603887684E-4</c:v>
                  </c:pt>
                  <c:pt idx="1651">
                    <c:v>4.5484732463527068E-4</c:v>
                  </c:pt>
                  <c:pt idx="1652">
                    <c:v>4.1941996876027662E-4</c:v>
                  </c:pt>
                  <c:pt idx="1653">
                    <c:v>3.8351209690097669E-4</c:v>
                  </c:pt>
                  <c:pt idx="1654">
                    <c:v>3.4804405480958302E-4</c:v>
                  </c:pt>
                  <c:pt idx="1655">
                    <c:v>3.1381019791720864E-4</c:v>
                  </c:pt>
                  <c:pt idx="1656">
                    <c:v>2.81444162955216E-4</c:v>
                  </c:pt>
                  <c:pt idx="1657">
                    <c:v>2.5141952756825434E-4</c:v>
                  </c:pt>
                  <c:pt idx="1658">
                    <c:v>2.2409108473618789E-4</c:v>
                  </c:pt>
                  <c:pt idx="1659">
                    <c:v>1.9977948398505638E-4</c:v>
                  </c:pt>
                  <c:pt idx="1660">
                    <c:v>1.7889710345018623E-4</c:v>
                  </c:pt>
                  <c:pt idx="1661">
                    <c:v>1.6209691944708401E-4</c:v>
                  </c:pt>
                  <c:pt idx="1662">
                    <c:v>1.5037983551429579E-4</c:v>
                  </c:pt>
                  <c:pt idx="1663">
                    <c:v>1.4501605597070396E-4</c:v>
                  </c:pt>
                  <c:pt idx="1664">
                    <c:v>1.4713612847155229E-4</c:v>
                  </c:pt>
                  <c:pt idx="1665">
                    <c:v>1.5714987930492895E-4</c:v>
                  </c:pt>
                  <c:pt idx="1666">
                    <c:v>1.7450688555178067E-4</c:v>
                  </c:pt>
                  <c:pt idx="1667">
                    <c:v>1.9799211688701406E-4</c:v>
                  </c:pt>
                  <c:pt idx="1668">
                    <c:v>2.2615992367131104E-4</c:v>
                  </c:pt>
                  <c:pt idx="1669">
                    <c:v>2.5756957145235741E-4</c:v>
                  </c:pt>
                  <c:pt idx="1670">
                    <c:v>2.9083254895474221E-4</c:v>
                  </c:pt>
                  <c:pt idx="1671">
                    <c:v>3.2459146087421607E-4</c:v>
                  </c:pt>
                  <c:pt idx="1672">
                    <c:v>3.5750308666518133E-4</c:v>
                  </c:pt>
                  <c:pt idx="1673">
                    <c:v>3.8824774060035457E-4</c:v>
                  </c:pt>
                  <c:pt idx="1674">
                    <c:v>4.1556400323157174E-4</c:v>
                  </c:pt>
                  <c:pt idx="1675">
                    <c:v>4.3830060948695009E-4</c:v>
                  </c:pt>
                  <c:pt idx="1676">
                    <c:v>4.554757515632011E-4</c:v>
                  </c:pt>
                  <c:pt idx="1677">
                    <c:v>4.6633450503633718E-4</c:v>
                  </c:pt>
                  <c:pt idx="1678">
                    <c:v>4.7039626464820031E-4</c:v>
                  </c:pt>
                  <c:pt idx="1679">
                    <c:v>4.6748591648133685E-4</c:v>
                  </c:pt>
                  <c:pt idx="1680">
                    <c:v>4.5774461621048032E-4</c:v>
                  </c:pt>
                  <c:pt idx="1681">
                    <c:v>4.4161858599197008E-4</c:v>
                  </c:pt>
                  <c:pt idx="1682">
                    <c:v>4.1982696263761756E-4</c:v>
                  </c:pt>
                  <c:pt idx="1683">
                    <c:v>3.9331192187629311E-4</c:v>
                  </c:pt>
                  <c:pt idx="1684">
                    <c:v>3.6317635881565882E-4</c:v>
                  </c:pt>
                  <c:pt idx="1685">
                    <c:v>3.3061534788091757E-4</c:v>
                  </c:pt>
                  <c:pt idx="1686">
                    <c:v>2.9684816415004713E-4</c:v>
                  </c:pt>
                  <c:pt idx="1687">
                    <c:v>2.6305694830461312E-4</c:v>
                  </c:pt>
                  <c:pt idx="1688">
                    <c:v>2.3033690783616539E-4</c:v>
                  </c:pt>
                  <c:pt idx="1689">
                    <c:v>1.9966046621843308E-4</c:v>
                  </c:pt>
                  <c:pt idx="1690">
                    <c:v>1.7185431376617497E-4</c:v>
                  </c:pt>
                  <c:pt idx="1691">
                    <c:v>1.4758294604511231E-4</c:v>
                  </c:pt>
                  <c:pt idx="1692">
                    <c:v>1.2732571336836882E-4</c:v>
                  </c:pt>
                  <c:pt idx="1693">
                    <c:v>1.1133141737473098E-4</c:v>
                  </c:pt>
                  <c:pt idx="1694">
                    <c:v>9.9548426885060615E-5</c:v>
                  </c:pt>
                  <c:pt idx="1695">
                    <c:v>9.1569773014282783E-5</c:v>
                  </c:pt>
                  <c:pt idx="1696">
                    <c:v>8.6667988088627807E-5</c:v>
                  </c:pt>
                  <c:pt idx="1697">
                    <c:v>8.3949085952096046E-5</c:v>
                  </c:pt>
                  <c:pt idx="1698">
                    <c:v>8.254988301978503E-5</c:v>
                  </c:pt>
                  <c:pt idx="1699">
                    <c:v>8.1772914519376313E-5</c:v>
                  </c:pt>
                  <c:pt idx="1700">
                    <c:v>8.1125440227365121E-5</c:v>
                  </c:pt>
                  <c:pt idx="1701">
                    <c:v>8.0295294588747401E-5</c:v>
                  </c:pt>
                  <c:pt idx="1702">
                    <c:v>7.9105761074592192E-5</c:v>
                  </c:pt>
                  <c:pt idx="1703">
                    <c:v>7.7473308302998875E-5</c:v>
                  </c:pt>
                  <c:pt idx="1704">
                    <c:v>7.5375673948824485E-5</c:v>
                  </c:pt>
                  <c:pt idx="1705">
                    <c:v>7.2830054170561678E-5</c:v>
                  </c:pt>
                  <c:pt idx="1706">
                    <c:v>6.9878778793008975E-5</c:v>
                  </c:pt>
                  <c:pt idx="1707">
                    <c:v>6.658002881890347E-5</c:v>
                  </c:pt>
                  <c:pt idx="1708">
                    <c:v>6.3001663170832582E-5</c:v>
                  </c:pt>
                  <c:pt idx="1709">
                    <c:v>5.9216934303254416E-5</c:v>
                  </c:pt>
                  <c:pt idx="1710">
                    <c:v>5.5301404111430691E-5</c:v>
                  </c:pt>
                  <c:pt idx="1711">
                    <c:v>5.1330587632441362E-5</c:v>
                  </c:pt>
                  <c:pt idx="1712">
                    <c:v>4.737820730625128E-5</c:v>
                  </c:pt>
                  <c:pt idx="1713">
                    <c:v>4.3514843464593489E-5</c:v>
                  </c:pt>
                  <c:pt idx="1714">
                    <c:v>3.9806986912245995E-5</c:v>
                  </c:pt>
                  <c:pt idx="1715">
                    <c:v>3.6316349796812117E-5</c:v>
                  </c:pt>
                  <c:pt idx="1716">
                    <c:v>3.3099265822584765E-5</c:v>
                  </c:pt>
                  <c:pt idx="1717">
                    <c:v>3.0205918847098092E-5</c:v>
                  </c:pt>
                  <c:pt idx="1718">
                    <c:v>2.7679019858367934E-5</c:v>
                  </c:pt>
                  <c:pt idx="1719">
                    <c:v>2.5551609582730867E-5</c:v>
                  </c:pt>
                  <c:pt idx="1720">
                    <c:v>2.3843914945111342E-5</c:v>
                  </c:pt>
                  <c:pt idx="1721">
                    <c:v>2.2559886915864988E-5</c:v>
                  </c:pt>
                  <c:pt idx="1722">
                    <c:v>2.1684880092233443E-5</c:v>
                  </c:pt>
                  <c:pt idx="1723">
                    <c:v>2.118617041656967E-5</c:v>
                  </c:pt>
                  <c:pt idx="1724">
                    <c:v>2.1017120642163606E-5</c:v>
                  </c:pt>
                  <c:pt idx="1725">
                    <c:v>2.1123935620595052E-5</c:v>
                  </c:pt>
                  <c:pt idx="1726">
                    <c:v>2.1452737773609705E-5</c:v>
                  </c:pt>
                  <c:pt idx="1727">
                    <c:v>2.1954955087901799E-5</c:v>
                  </c:pt>
                  <c:pt idx="1728">
                    <c:v>2.2590164169200074E-5</c:v>
                  </c:pt>
                  <c:pt idx="1729">
                    <c:v>2.3326738429035055E-5</c:v>
                  </c:pt>
                  <c:pt idx="1730">
                    <c:v>2.4141108245166629E-5</c:v>
                  </c:pt>
                  <c:pt idx="1731">
                    <c:v>2.5016355572335511E-5</c:v>
                  </c:pt>
                  <c:pt idx="1732">
                    <c:v>2.5940726169012792E-5</c:v>
                  </c:pt>
                  <c:pt idx="1733">
                    <c:v>2.6906252594409849E-5</c:v>
                  </c:pt>
                  <c:pt idx="1734">
                    <c:v>2.7907652452392317E-5</c:v>
                  </c:pt>
                  <c:pt idx="1735">
                    <c:v>2.8941479262773595E-5</c:v>
                  </c:pt>
                  <c:pt idx="1736">
                    <c:v>3.0005491338022926E-5</c:v>
                  </c:pt>
                  <c:pt idx="1737">
                    <c:v>3.1098214755842578E-5</c:v>
                  </c:pt>
                  <c:pt idx="1738">
                    <c:v>3.2218637117827248E-5</c:v>
                  </c:pt>
                  <c:pt idx="1739">
                    <c:v>3.3365994638185789E-5</c:v>
                  </c:pt>
                  <c:pt idx="1740">
                    <c:v>3.4539642686332879E-5</c:v>
                  </c:pt>
                  <c:pt idx="1741">
                    <c:v>3.5738971339947809E-5</c:v>
                  </c:pt>
                  <c:pt idx="1742">
                    <c:v>3.6963345822934733E-5</c:v>
                  </c:pt>
                  <c:pt idx="1743">
                    <c:v>3.8212079338660532E-5</c:v>
                  </c:pt>
                  <c:pt idx="1744">
                    <c:v>3.9484404629980668E-5</c:v>
                  </c:pt>
                  <c:pt idx="1745">
                    <c:v>4.0779470912767443E-5</c:v>
                  </c:pt>
                  <c:pt idx="1746">
                    <c:v>4.209633608559805E-5</c:v>
                  </c:pt>
                  <c:pt idx="1747">
                    <c:v>4.3433967559174832E-5</c:v>
                  </c:pt>
                  <c:pt idx="1748">
                    <c:v>4.4791232990272798E-5</c:v>
                  </c:pt>
                  <c:pt idx="1749">
                    <c:v>4.6166906994440095E-5</c:v>
                  </c:pt>
                  <c:pt idx="1750">
                    <c:v>4.7559678442764089E-5</c:v>
                  </c:pt>
                  <c:pt idx="1751">
                    <c:v>4.8968142369030467E-5</c:v>
                  </c:pt>
                  <c:pt idx="1752">
                    <c:v>5.039081061633056E-5</c:v>
                  </c:pt>
                  <c:pt idx="1753">
                    <c:v>5.1826099839544457E-5</c:v>
                  </c:pt>
                  <c:pt idx="1754">
                    <c:v>5.3272362142201271E-5</c:v>
                  </c:pt>
                  <c:pt idx="1755">
                    <c:v>5.4727860082500344E-5</c:v>
                  </c:pt>
                  <c:pt idx="1756">
                    <c:v>5.6190790429991915E-5</c:v>
                  </c:pt>
                  <c:pt idx="1757">
                    <c:v>5.7659275512331995E-5</c:v>
                  </c:pt>
                  <c:pt idx="1758">
                    <c:v>5.9131380562691935E-5</c:v>
                  </c:pt>
                  <c:pt idx="1759">
                    <c:v>6.0605105125037473E-5</c:v>
                  </c:pt>
                  <c:pt idx="1760">
                    <c:v>6.2078400460018022E-5</c:v>
                  </c:pt>
                  <c:pt idx="1761">
                    <c:v>6.3549171138855174E-5</c:v>
                  </c:pt>
                  <c:pt idx="1762">
                    <c:v>6.5015282657560118E-5</c:v>
                  </c:pt>
                  <c:pt idx="1763">
                    <c:v>6.647455953244898E-5</c:v>
                  </c:pt>
                  <c:pt idx="1764">
                    <c:v>6.7924813650249873E-5</c:v>
                  </c:pt>
                  <c:pt idx="1765">
                    <c:v>6.9363825767248234E-5</c:v>
                  </c:pt>
                  <c:pt idx="1766">
                    <c:v>7.0789380661159213E-5</c:v>
                  </c:pt>
                  <c:pt idx="1767">
                    <c:v>7.2199245852379299E-5</c:v>
                  </c:pt>
                  <c:pt idx="1768">
                    <c:v>7.3591216452775673E-5</c:v>
                  </c:pt>
                  <c:pt idx="1769">
                    <c:v>7.4963088384067664E-5</c:v>
                  </c:pt>
                  <c:pt idx="1770">
                    <c:v>7.6312693064368683E-5</c:v>
                  </c:pt>
                  <c:pt idx="1771">
                    <c:v>7.7637900289229358E-5</c:v>
                  </c:pt>
                  <c:pt idx="1772">
                    <c:v>7.8936621232165053E-5</c:v>
                  </c:pt>
                  <c:pt idx="1773">
                    <c:v>8.0206830532589395E-5</c:v>
                  </c:pt>
                  <c:pt idx="1774">
                    <c:v>8.1446563150820768E-5</c:v>
                  </c:pt>
                  <c:pt idx="1775">
                    <c:v>8.2653939903688675E-5</c:v>
                  </c:pt>
                  <c:pt idx="1776">
                    <c:v>8.3827164529641656E-5</c:v>
                  </c:pt>
                  <c:pt idx="1777">
                    <c:v>8.496454921780613E-5</c:v>
                  </c:pt>
                  <c:pt idx="1778">
                    <c:v>8.6064498448249494E-5</c:v>
                  </c:pt>
                  <c:pt idx="1779">
                    <c:v>8.7125554035389103E-5</c:v>
                  </c:pt>
                  <c:pt idx="1780">
                    <c:v>8.8146372835757892E-5</c:v>
                  </c:pt>
                  <c:pt idx="1781">
                    <c:v>8.9125760844784932E-5</c:v>
                  </c:pt>
                  <c:pt idx="1782">
                    <c:v>9.0062656836189517E-5</c:v>
                  </c:pt>
                  <c:pt idx="1783">
                    <c:v>9.0956167141567555E-5</c:v>
                  </c:pt>
                  <c:pt idx="1784">
                    <c:v>9.1805553335678919E-5</c:v>
                  </c:pt>
                  <c:pt idx="1785">
                    <c:v>9.2610244726691016E-5</c:v>
                  </c:pt>
                  <c:pt idx="1786">
                    <c:v>9.3369846229591981E-5</c:v>
                  </c:pt>
                  <c:pt idx="1787">
                    <c:v>9.4084140781256934E-5</c:v>
                  </c:pt>
                  <c:pt idx="1788">
                    <c:v>9.475308996046378E-5</c:v>
                  </c:pt>
                  <c:pt idx="1789">
                    <c:v>9.5376837889164697E-5</c:v>
                  </c:pt>
                  <c:pt idx="1790">
                    <c:v>9.5955715728476756E-5</c:v>
                  </c:pt>
                  <c:pt idx="1791">
                    <c:v>9.649022387709028E-5</c:v>
                  </c:pt>
                  <c:pt idx="1792">
                    <c:v>9.6981051965605157E-5</c:v>
                  </c:pt>
                  <c:pt idx="1793">
                    <c:v>9.7429055019729338E-5</c:v>
                  </c:pt>
                  <c:pt idx="1794">
                    <c:v>9.7835252253368422E-5</c:v>
                  </c:pt>
                  <c:pt idx="1795">
                    <c:v>9.8200817759278833E-5</c:v>
                  </c:pt>
                  <c:pt idx="1796">
                    <c:v>9.8527069570368848E-5</c:v>
                  </c:pt>
                  <c:pt idx="1797">
                    <c:v>9.8815443163688602E-5</c:v>
                  </c:pt>
                  <c:pt idx="1798">
                    <c:v>9.9067496285173932E-5</c:v>
                  </c:pt>
                  <c:pt idx="1799">
                    <c:v>9.9284866231525535E-5</c:v>
                  </c:pt>
                  <c:pt idx="1800">
                    <c:v>9.9469254147541614E-5</c:v>
                  </c:pt>
                  <c:pt idx="1801">
                    <c:v>9.9622400193334677E-5</c:v>
                  </c:pt>
                  <c:pt idx="1802">
                    <c:v>9.9746049199882656E-5</c:v>
                  </c:pt>
                  <c:pt idx="1803">
                    <c:v>9.9841911891147847E-5</c:v>
                  </c:pt>
                  <c:pt idx="1804">
                    <c:v>9.9911631330181072E-5</c:v>
                  </c:pt>
                  <c:pt idx="1805">
                    <c:v>9.9956748256087383E-5</c:v>
                  </c:pt>
                  <c:pt idx="1806">
                    <c:v>9.997864536988573E-5</c:v>
                  </c:pt>
                  <c:pt idx="1807">
                    <c:v>9.9978544265260448E-5</c:v>
                  </c:pt>
                  <c:pt idx="1808">
                    <c:v>9.9957460063941728E-5</c:v>
                  </c:pt>
                  <c:pt idx="1809">
                    <c:v>9.9916266997357217E-5</c:v>
                  </c:pt>
                  <c:pt idx="1810">
                    <c:v>9.9855786588888139E-5</c:v>
                  </c:pt>
                  <c:pt idx="1811">
                    <c:v>9.9777030869752532E-5</c:v>
                  </c:pt>
                  <c:pt idx="1812">
                    <c:v>9.9681686383627869E-5</c:v>
                  </c:pt>
                  <c:pt idx="1813">
                    <c:v>9.9572932551201978E-5</c:v>
                  </c:pt>
                  <c:pt idx="1814">
                    <c:v>9.9456824645458938E-5</c:v>
                  </c:pt>
                  <c:pt idx="1815">
                    <c:v>9.9344500656468543E-5</c:v>
                  </c:pt>
                  <c:pt idx="1816">
                    <c:v>9.9255492149657871E-5</c:v>
                  </c:pt>
                  <c:pt idx="1817">
                    <c:v>9.9222547304511817E-5</c:v>
                  </c:pt>
                  <c:pt idx="1818">
                    <c:v>9.929827278893609E-5</c:v>
                  </c:pt>
                  <c:pt idx="1819">
                    <c:v>9.9563636352089087E-5</c:v>
                  </c:pt>
                  <c:pt idx="1820">
                    <c:v>1.0013799943385751E-4</c:v>
                  </c:pt>
                  <c:pt idx="1821">
                    <c:v>1.011891770505088E-4</c:v>
                  </c:pt>
                  <c:pt idx="1822">
                    <c:v>1.0294069019706768E-4</c:v>
                  </c:pt>
                  <c:pt idx="1823">
                    <c:v>1.0567168326098579E-4</c:v>
                  </c:pt>
                  <c:pt idx="1824">
                    <c:v>1.0970444582392291E-4</c:v>
                  </c:pt>
                  <c:pt idx="1825">
                    <c:v>1.1537661702991275E-4</c:v>
                  </c:pt>
                  <c:pt idx="1826">
                    <c:v>1.2300084020772285E-4</c:v>
                  </c:pt>
                  <c:pt idx="1827">
                    <c:v>1.3282152174087208E-4</c:v>
                  </c:pt>
                  <c:pt idx="1828">
                    <c:v>1.4498084067384319E-4</c:v>
                  </c:pt>
                  <c:pt idx="1829">
                    <c:v>1.5950191836525208E-4</c:v>
                  </c:pt>
                  <c:pt idx="1830">
                    <c:v>1.7628848870615964E-4</c:v>
                  </c:pt>
                  <c:pt idx="1831">
                    <c:v>1.9513494640536943E-4</c:v>
                  </c:pt>
                  <c:pt idx="1832">
                    <c:v>2.1574009218263668E-4</c:v>
                  </c:pt>
                  <c:pt idx="1833">
                    <c:v>2.3772089124962631E-4</c:v>
                  </c:pt>
                  <c:pt idx="1834">
                    <c:v>2.6062541839239121E-4</c:v>
                  </c:pt>
                  <c:pt idx="1835">
                    <c:v>2.8394588431131007E-4</c:v>
                  </c:pt>
                  <c:pt idx="1836">
                    <c:v>3.0713278585986167E-4</c:v>
                  </c:pt>
                  <c:pt idx="1837">
                    <c:v>3.2961103893338288E-4</c:v>
                  </c:pt>
                  <c:pt idx="1838">
                    <c:v>3.507982113409997E-4</c:v>
                  </c:pt>
                  <c:pt idx="1839">
                    <c:v>3.7012450826042934E-4</c:v>
                  </c:pt>
                  <c:pt idx="1840">
                    <c:v>3.8705370073518938E-4</c:v>
                  </c:pt>
                  <c:pt idx="1841">
                    <c:v>4.0110392219372935E-4</c:v>
                  </c:pt>
                  <c:pt idx="1842">
                    <c:v>4.1186714215924938E-4</c:v>
                  </c:pt>
                  <c:pt idx="1843">
                    <c:v>4.1902605668312355E-4</c:v>
                  </c:pt>
                  <c:pt idx="1844">
                    <c:v>4.2236734541068447E-4</c:v>
                  </c:pt>
                  <c:pt idx="1845">
                    <c:v>4.2179037825592898E-4</c:v>
                  </c:pt>
                  <c:pt idx="1846">
                    <c:v>4.1731082757183382E-4</c:v>
                  </c:pt>
                  <c:pt idx="1847">
                    <c:v>4.0905889255912786E-4</c:v>
                  </c:pt>
                  <c:pt idx="1848">
                    <c:v>3.9727230633390204E-4</c:v>
                  </c:pt>
                  <c:pt idx="1849">
                    <c:v>3.822845484802226E-4</c:v>
                  </c:pt>
                  <c:pt idx="1850">
                    <c:v>3.6450910541644137E-4</c:v>
                  </c:pt>
                  <c:pt idx="1851">
                    <c:v>3.4442069095529017E-4</c:v>
                  </c:pt>
                  <c:pt idx="1852">
                    <c:v>3.2253471688751048E-4</c:v>
                  </c:pt>
                  <c:pt idx="1853">
                    <c:v>2.9938611283055589E-4</c:v>
                  </c:pt>
                  <c:pt idx="1854">
                    <c:v>2.7550880441896801E-4</c:v>
                  </c:pt>
                  <c:pt idx="1855">
                    <c:v>2.5141679654160423E-4</c:v>
                  </c:pt>
                  <c:pt idx="1856">
                    <c:v>2.2758784430406109E-4</c:v>
                  </c:pt>
                  <c:pt idx="1857">
                    <c:v>2.044502117996489E-4</c:v>
                  </c:pt>
                  <c:pt idx="1858">
                    <c:v>1.8237294717583623E-4</c:v>
                  </c:pt>
                  <c:pt idx="1859">
                    <c:v>1.6165963262954262E-4</c:v>
                  </c:pt>
                  <c:pt idx="1860">
                    <c:v>1.4254538285820811E-4</c:v>
                  </c:pt>
                  <c:pt idx="1861">
                    <c:v>1.2519656024098858E-4</c:v>
                  </c:pt>
                  <c:pt idx="1862">
                    <c:v>1.0971247403441933E-4</c:v>
                  </c:pt>
                  <c:pt idx="1863">
                    <c:v>9.6128327556536987E-5</c:v>
                  </c:pt>
                  <c:pt idx="1864">
                    <c:v>8.4418804181823147E-5</c:v>
                  </c:pt>
                  <c:pt idx="1865">
                    <c:v>7.4502210010830692E-5</c:v>
                  </c:pt>
                  <c:pt idx="1866">
                    <c:v>6.6245853448576852E-5</c:v>
                  </c:pt>
                  <c:pt idx="1867">
                    <c:v>5.9474133793225827E-5</c:v>
                  </c:pt>
                  <c:pt idx="1868">
                    <c:v>5.3980735182655417E-5</c:v>
                  </c:pt>
                  <c:pt idx="1869">
                    <c:v>4.9545004383835974E-5</c:v>
                  </c:pt>
                  <c:pt idx="1870">
                    <c:v>4.5950465981003674E-5</c:v>
                  </c:pt>
                  <c:pt idx="1871">
                    <c:v>4.3001963225610632E-5</c:v>
                  </c:pt>
                  <c:pt idx="1872">
                    <c:v>4.0538502001906763E-5</c:v>
                  </c:pt>
                  <c:pt idx="1873">
                    <c:v>3.8441091979785828E-5</c:v>
                  </c:pt>
                  <c:pt idx="1874">
                    <c:v>3.6637313923724352E-5</c:v>
                  </c:pt>
                  <c:pt idx="1875">
                    <c:v>3.5105668225334953E-5</c:v>
                  </c:pt>
                  <c:pt idx="1876">
                    <c:v>3.3882368209693237E-5</c:v>
                  </c:pt>
                  <c:pt idx="1877">
                    <c:v>3.3071179401474473E-5</c:v>
                  </c:pt>
                  <c:pt idx="1878">
                    <c:v>3.2851985556568296E-5</c:v>
                  </c:pt>
                  <c:pt idx="1879">
                    <c:v>3.3476800427231422E-5</c:v>
                  </c:pt>
                  <c:pt idx="1880">
                    <c:v>3.5238761384688733E-5</c:v>
                  </c:pt>
                  <c:pt idx="1881">
                    <c:v>3.8413673068768607E-5</c:v>
                  </c:pt>
                  <c:pt idx="1882">
                    <c:v>4.3201889350728622E-5</c:v>
                  </c:pt>
                  <c:pt idx="1883">
                    <c:v>4.9705450589798823E-5</c:v>
                  </c:pt>
                  <c:pt idx="1884">
                    <c:v>5.7943260071767911E-5</c:v>
                  </c:pt>
                  <c:pt idx="1885">
                    <c:v>6.7878066218426917E-5</c:v>
                  </c:pt>
                  <c:pt idx="1886">
                    <c:v>7.9433805629085846E-5</c:v>
                  </c:pt>
                  <c:pt idx="1887">
                    <c:v>9.2499662929017775E-5</c:v>
                  </c:pt>
                  <c:pt idx="1888">
                    <c:v>1.0692616641001894E-4</c:v>
                  </c:pt>
                  <c:pt idx="1889">
                    <c:v>1.2251913610980715E-4</c:v>
                  </c:pt>
                  <c:pt idx="1890">
                    <c:v>1.3903503249379016E-4</c:v>
                  </c:pt>
                  <c:pt idx="1891">
                    <c:v>1.5617952722192188E-4</c:v>
                  </c:pt>
                  <c:pt idx="1892">
                    <c:v>1.7361012068417176E-4</c:v>
                  </c:pt>
                  <c:pt idx="1893">
                    <c:v>1.9094292689442532E-4</c:v>
                  </c:pt>
                  <c:pt idx="1894">
                    <c:v>2.0776340601069557E-4</c:v>
                  </c:pt>
                  <c:pt idx="1895">
                    <c:v>2.2364055879028262E-4</c:v>
                  </c:pt>
                  <c:pt idx="1896">
                    <c:v>2.3814371442161262E-4</c:v>
                  </c:pt>
                  <c:pt idx="1897">
                    <c:v>2.5086090920063323E-4</c:v>
                  </c:pt>
                  <c:pt idx="1898">
                    <c:v>2.6141764380332809E-4</c:v>
                  </c:pt>
                  <c:pt idx="1899">
                    <c:v>2.694947400461711E-4</c:v>
                  </c:pt>
                  <c:pt idx="1900">
                    <c:v>2.7484404585813202E-4</c:v>
                  </c:pt>
                  <c:pt idx="1901">
                    <c:v>2.7730086854721431E-4</c:v>
                  </c:pt>
                  <c:pt idx="1902">
                    <c:v>2.767921947216123E-4</c:v>
                  </c:pt>
                  <c:pt idx="1903">
                    <c:v>2.7334014075237276E-4</c:v>
                  </c:pt>
                  <c:pt idx="1904">
                    <c:v>2.6706038076382261E-4</c:v>
                  </c:pt>
                  <c:pt idx="1905">
                    <c:v>2.5815565761332088E-4</c:v>
                  </c:pt>
                  <c:pt idx="1906">
                    <c:v>2.469048916445878E-4</c:v>
                  </c:pt>
                  <c:pt idx="1907">
                    <c:v>2.3364871750022019E-4</c:v>
                  </c:pt>
                  <c:pt idx="1908">
                    <c:v>2.1877242019804828E-4</c:v>
                  </c:pt>
                  <c:pt idx="1909">
                    <c:v>2.0268752515564958E-4</c:v>
                  </c:pt>
                  <c:pt idx="1910">
                    <c:v>1.8581320673742902E-4</c:v>
                  </c:pt>
                  <c:pt idx="1911">
                    <c:v>1.6855865669326985E-4</c:v>
                  </c:pt>
                  <c:pt idx="1912">
                    <c:v>1.5130745606751629E-4</c:v>
                  </c:pt>
                  <c:pt idx="1913">
                    <c:v>1.344046327307313E-4</c:v>
                  </c:pt>
                  <c:pt idx="1914">
                    <c:v>1.1814701392609334E-4</c:v>
                  </c:pt>
                  <c:pt idx="1915">
                    <c:v>1.0277700063462047E-4</c:v>
                  </c:pt>
                  <c:pt idx="1916">
                    <c:v>8.8479793912194454E-5</c:v>
                  </c:pt>
                  <c:pt idx="1917">
                    <c:v>7.5383785084965713E-5</c:v>
                  </c:pt>
                  <c:pt idx="1918">
                    <c:v>6.3563642786365721E-5</c:v>
                  </c:pt>
                  <c:pt idx="1919">
                    <c:v>5.3045554718561204E-5</c:v>
                  </c:pt>
                  <c:pt idx="1920">
                    <c:v>4.3813987301294927E-5</c:v>
                  </c:pt>
                  <c:pt idx="1921">
                    <c:v>3.5819304851974546E-5</c:v>
                  </c:pt>
                  <c:pt idx="1922">
                    <c:v>2.8985697997671551E-5</c:v>
                  </c:pt>
                  <c:pt idx="1923">
                    <c:v>2.3218929976509517E-5</c:v>
                  </c:pt>
                  <c:pt idx="1924">
                    <c:v>1.8413435389728246E-5</c:v>
                  </c:pt>
                  <c:pt idx="1925">
                    <c:v>1.4458578939011131E-5</c:v>
                  </c:pt>
                  <c:pt idx="1926">
                    <c:v>1.1243837797016672E-5</c:v>
                  </c:pt>
                  <c:pt idx="1927">
                    <c:v>8.6628914016910198E-6</c:v>
                  </c:pt>
                  <c:pt idx="1928">
                    <c:v>6.6166013246239334E-6</c:v>
                  </c:pt>
                  <c:pt idx="1929">
                    <c:v>5.0149733067677394E-6</c:v>
                  </c:pt>
                  <c:pt idx="1930">
                    <c:v>3.7782685464374446E-6</c:v>
                  </c:pt>
                  <c:pt idx="1931">
                    <c:v>2.837296834589023E-6</c:v>
                  </c:pt>
                  <c:pt idx="1932">
                    <c:v>2.1331359460502868E-6</c:v>
                  </c:pt>
                  <c:pt idx="1933">
                    <c:v>1.6162610982094401E-6</c:v>
                  </c:pt>
                  <c:pt idx="1934">
                    <c:v>1.2452852849018025E-6</c:v>
                  </c:pt>
                  <c:pt idx="1935">
                    <c:v>9.8542295303402411E-7</c:v>
                  </c:pt>
                  <c:pt idx="1936">
                    <c:v>8.07229808754745E-7</c:v>
                  </c:pt>
                  <c:pt idx="1937">
                    <c:v>6.8608455113027394E-7</c:v>
                  </c:pt>
                  <c:pt idx="1938">
                    <c:v>6.0247367600830734E-7</c:v>
                  </c:pt>
                  <c:pt idx="1939">
                    <c:v>5.4223430433169217E-7</c:v>
                  </c:pt>
                  <c:pt idx="1940">
                    <c:v>4.9604576547562243E-7</c:v>
                  </c:pt>
                  <c:pt idx="1941">
                    <c:v>4.582747606731141E-7</c:v>
                  </c:pt>
                  <c:pt idx="1942">
                    <c:v>4.2572817254284063E-7</c:v>
                  </c:pt>
                  <c:pt idx="1943">
                    <c:v>3.966723629656353E-7</c:v>
                  </c:pt>
                  <c:pt idx="1944">
                    <c:v>3.7017245079477131E-7</c:v>
                  </c:pt>
                  <c:pt idx="1945">
                    <c:v>3.457177131948357E-7</c:v>
                  </c:pt>
                  <c:pt idx="1946">
                    <c:v>3.2301772328167084E-7</c:v>
                  </c:pt>
                  <c:pt idx="1947">
                    <c:v>3.018834271677041E-7</c:v>
                  </c:pt>
                  <c:pt idx="1948">
                    <c:v>2.8217506879988916E-7</c:v>
                  </c:pt>
                  <c:pt idx="1949">
                    <c:v>2.6378764064215661E-7</c:v>
                  </c:pt>
                  <c:pt idx="1950">
                    <c:v>2.4662372372142593E-7</c:v>
                  </c:pt>
                  <c:pt idx="1951">
                    <c:v>2.3059762712874436E-7</c:v>
                  </c:pt>
                  <c:pt idx="1952">
                    <c:v>2.1562958014373389E-7</c:v>
                  </c:pt>
                  <c:pt idx="1953">
                    <c:v>2.0164355957701424E-7</c:v>
                  </c:pt>
                  <c:pt idx="1954">
                    <c:v>1.8857799494187093E-7</c:v>
                  </c:pt>
                  <c:pt idx="1955">
                    <c:v>1.7636861845661855E-7</c:v>
                  </c:pt>
                  <c:pt idx="1956">
                    <c:v>1.6495135957025049E-7</c:v>
                  </c:pt>
                  <c:pt idx="1957">
                    <c:v>1.5427599014968813E-7</c:v>
                  </c:pt>
                  <c:pt idx="1958">
                    <c:v>1.4429515740956748E-7</c:v>
                  </c:pt>
                  <c:pt idx="1959">
                    <c:v>1.3495775356123965E-7</c:v>
                  </c:pt>
                  <c:pt idx="1960">
                    <c:v>1.2622038140872085E-7</c:v>
                  </c:pt>
                  <c:pt idx="1961">
                    <c:v>1.1804715197279809E-7</c:v>
                  </c:pt>
                  <c:pt idx="1962">
                    <c:v>1.1039984590703147E-7</c:v>
                  </c:pt>
                  <c:pt idx="1963">
                    <c:v>1.0324446984741639E-7</c:v>
                  </c:pt>
                  <c:pt idx="1964">
                    <c:v>9.6544827784049896E-8</c:v>
                  </c:pt>
                  <c:pt idx="1965">
                    <c:v>9.0277765861195805E-8</c:v>
                  </c:pt>
                  <c:pt idx="1966">
                    <c:v>8.4408159911406847E-8</c:v>
                  </c:pt>
                  <c:pt idx="1967">
                    <c:v>7.8917497803906762E-8</c:v>
                  </c:pt>
                  <c:pt idx="1968">
                    <c:v>7.3777773600234146E-8</c:v>
                  </c:pt>
                  <c:pt idx="1969">
                    <c:v>6.8967919447834323E-8</c:v>
                  </c:pt>
                  <c:pt idx="1970">
                    <c:v>6.4463913617534018E-8</c:v>
                  </c:pt>
                  <c:pt idx="1971">
                    <c:v>6.0251603786861055E-8</c:v>
                  </c:pt>
                  <c:pt idx="1972">
                    <c:v>5.6307302693937194E-8</c:v>
                  </c:pt>
                  <c:pt idx="1973">
                    <c:v>5.2617331903724138E-8</c:v>
                  </c:pt>
                  <c:pt idx="1974">
                    <c:v>4.9164777022067632E-8</c:v>
                  </c:pt>
                  <c:pt idx="1975">
                    <c:v>4.5932920353731295E-8</c:v>
                  </c:pt>
                  <c:pt idx="1976">
                    <c:v>4.2911599036296138E-8</c:v>
                  </c:pt>
                  <c:pt idx="1977">
                    <c:v>4.0084164879339501E-8</c:v>
                  </c:pt>
                  <c:pt idx="1978">
                    <c:v>3.7440643537718723E-8</c:v>
                  </c:pt>
                  <c:pt idx="1979">
                    <c:v>3.4964485373124075E-8</c:v>
                  </c:pt>
                  <c:pt idx="1980">
                    <c:v>3.2652316099576566E-8</c:v>
                  </c:pt>
                  <c:pt idx="1981">
                    <c:v>3.0490940731087099E-8</c:v>
                  </c:pt>
                  <c:pt idx="1982">
                    <c:v>2.8467187895306175E-8</c:v>
                  </c:pt>
                  <c:pt idx="1983">
                    <c:v>2.6574499779271831E-8</c:v>
                  </c:pt>
                  <c:pt idx="1984">
                    <c:v>2.4806244949982221E-8</c:v>
                  </c:pt>
                  <c:pt idx="1985">
                    <c:v>2.3155906605890878E-8</c:v>
                  </c:pt>
                  <c:pt idx="1986">
                    <c:v>2.1610301290168348E-8</c:v>
                  </c:pt>
                  <c:pt idx="1987">
                    <c:v>2.0166225523182366E-8</c:v>
                  </c:pt>
                  <c:pt idx="1988">
                    <c:v>1.8820328095695613E-8</c:v>
                  </c:pt>
                  <c:pt idx="1989">
                    <c:v>1.7559540869725369E-8</c:v>
                  </c:pt>
                  <c:pt idx="1990">
                    <c:v>1.6380572560426802E-8</c:v>
                  </c:pt>
                  <c:pt idx="1991">
                    <c:v>1.5283408929899064E-8</c:v>
                  </c:pt>
                  <c:pt idx="1992">
                    <c:v>1.4255004956024962E-8</c:v>
                  </c:pt>
                  <c:pt idx="1993">
                    <c:v>1.3295356318265022E-8</c:v>
                  </c:pt>
                  <c:pt idx="1994">
                    <c:v>1.2401264406861458E-8</c:v>
                  </c:pt>
                  <c:pt idx="1995">
                    <c:v>1.1562729012747044E-8</c:v>
                  </c:pt>
                  <c:pt idx="1996">
                    <c:v>1.0783102762432768E-8</c:v>
                  </c:pt>
                  <c:pt idx="1997">
                    <c:v>1.0052639767558385E-8</c:v>
                  </c:pt>
                  <c:pt idx="1998">
                    <c:v>9.3745263386516775E-9</c:v>
                  </c:pt>
                  <c:pt idx="1999">
                    <c:v>8.7390205400834251E-9</c:v>
                  </c:pt>
                </c:numCache>
              </c:numRef>
            </c:minus>
            <c:spPr>
              <a:ln>
                <a:solidFill>
                  <a:schemeClr val="bg1">
                    <a:lumMod val="50000"/>
                  </a:schemeClr>
                </a:solidFill>
              </a:ln>
            </c:spPr>
          </c:errBars>
          <c:errBars>
            <c:errDir val="x"/>
            <c:errBarType val="both"/>
            <c:errValType val="fixedVal"/>
            <c:noEndCap val="0"/>
            <c:val val="0.1"/>
          </c:errBars>
          <c:xVal>
            <c:numRef>
              <c:f>'[データまとめ (自動保存済み).xlsx]TM粒子数'!$A$3:$A$1002</c:f>
              <c:numCache>
                <c:formatCode>General</c:formatCode>
                <c:ptCount val="1000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  <c:pt idx="8">
                  <c:v>8.5</c:v>
                </c:pt>
                <c:pt idx="9">
                  <c:v>9.5</c:v>
                </c:pt>
                <c:pt idx="10">
                  <c:v>10.5</c:v>
                </c:pt>
                <c:pt idx="11">
                  <c:v>11.5</c:v>
                </c:pt>
                <c:pt idx="12">
                  <c:v>12.5</c:v>
                </c:pt>
                <c:pt idx="13">
                  <c:v>13.5</c:v>
                </c:pt>
                <c:pt idx="14">
                  <c:v>14.5</c:v>
                </c:pt>
                <c:pt idx="15">
                  <c:v>15.5</c:v>
                </c:pt>
                <c:pt idx="16">
                  <c:v>16.5</c:v>
                </c:pt>
                <c:pt idx="17">
                  <c:v>17.5</c:v>
                </c:pt>
                <c:pt idx="18">
                  <c:v>18.5</c:v>
                </c:pt>
                <c:pt idx="19">
                  <c:v>19.5</c:v>
                </c:pt>
                <c:pt idx="20">
                  <c:v>20.5</c:v>
                </c:pt>
                <c:pt idx="21">
                  <c:v>21.5</c:v>
                </c:pt>
                <c:pt idx="22">
                  <c:v>22.5</c:v>
                </c:pt>
                <c:pt idx="23">
                  <c:v>23.5</c:v>
                </c:pt>
                <c:pt idx="24">
                  <c:v>24.5</c:v>
                </c:pt>
                <c:pt idx="25">
                  <c:v>25.5</c:v>
                </c:pt>
                <c:pt idx="26">
                  <c:v>26.5</c:v>
                </c:pt>
                <c:pt idx="27">
                  <c:v>27.5</c:v>
                </c:pt>
                <c:pt idx="28">
                  <c:v>28.5</c:v>
                </c:pt>
                <c:pt idx="29">
                  <c:v>29.5</c:v>
                </c:pt>
                <c:pt idx="30">
                  <c:v>30.5</c:v>
                </c:pt>
                <c:pt idx="31">
                  <c:v>31.5</c:v>
                </c:pt>
                <c:pt idx="32">
                  <c:v>32.5</c:v>
                </c:pt>
                <c:pt idx="33">
                  <c:v>33.5</c:v>
                </c:pt>
                <c:pt idx="34">
                  <c:v>34.5</c:v>
                </c:pt>
                <c:pt idx="35">
                  <c:v>35.5</c:v>
                </c:pt>
                <c:pt idx="36">
                  <c:v>36.5</c:v>
                </c:pt>
                <c:pt idx="37">
                  <c:v>37.5</c:v>
                </c:pt>
                <c:pt idx="38">
                  <c:v>38.5</c:v>
                </c:pt>
                <c:pt idx="39">
                  <c:v>39.5</c:v>
                </c:pt>
                <c:pt idx="40">
                  <c:v>40.5</c:v>
                </c:pt>
                <c:pt idx="41">
                  <c:v>41.5</c:v>
                </c:pt>
                <c:pt idx="42">
                  <c:v>42.5</c:v>
                </c:pt>
                <c:pt idx="43">
                  <c:v>43.5</c:v>
                </c:pt>
                <c:pt idx="44">
                  <c:v>44.5</c:v>
                </c:pt>
                <c:pt idx="45">
                  <c:v>45.5</c:v>
                </c:pt>
                <c:pt idx="46">
                  <c:v>46.5</c:v>
                </c:pt>
                <c:pt idx="47">
                  <c:v>47.5</c:v>
                </c:pt>
                <c:pt idx="48">
                  <c:v>48.5</c:v>
                </c:pt>
                <c:pt idx="49">
                  <c:v>49.5</c:v>
                </c:pt>
                <c:pt idx="50">
                  <c:v>50.5</c:v>
                </c:pt>
                <c:pt idx="51">
                  <c:v>51.5</c:v>
                </c:pt>
                <c:pt idx="52">
                  <c:v>52.5</c:v>
                </c:pt>
                <c:pt idx="53">
                  <c:v>53.5</c:v>
                </c:pt>
                <c:pt idx="54">
                  <c:v>54.5</c:v>
                </c:pt>
                <c:pt idx="55">
                  <c:v>55.5</c:v>
                </c:pt>
                <c:pt idx="56">
                  <c:v>56.5</c:v>
                </c:pt>
                <c:pt idx="57">
                  <c:v>57.5</c:v>
                </c:pt>
                <c:pt idx="58">
                  <c:v>58.5</c:v>
                </c:pt>
                <c:pt idx="59">
                  <c:v>59.5</c:v>
                </c:pt>
                <c:pt idx="60">
                  <c:v>60.5</c:v>
                </c:pt>
                <c:pt idx="61">
                  <c:v>61.5</c:v>
                </c:pt>
                <c:pt idx="62">
                  <c:v>62.5</c:v>
                </c:pt>
                <c:pt idx="63">
                  <c:v>63.5</c:v>
                </c:pt>
                <c:pt idx="64">
                  <c:v>64.5</c:v>
                </c:pt>
                <c:pt idx="65">
                  <c:v>65.5</c:v>
                </c:pt>
                <c:pt idx="66">
                  <c:v>66.5</c:v>
                </c:pt>
                <c:pt idx="67">
                  <c:v>67.5</c:v>
                </c:pt>
                <c:pt idx="68">
                  <c:v>68.5</c:v>
                </c:pt>
                <c:pt idx="69">
                  <c:v>69.5</c:v>
                </c:pt>
                <c:pt idx="70">
                  <c:v>70.5</c:v>
                </c:pt>
                <c:pt idx="71">
                  <c:v>71.5</c:v>
                </c:pt>
                <c:pt idx="72">
                  <c:v>72.5</c:v>
                </c:pt>
                <c:pt idx="73">
                  <c:v>73.5</c:v>
                </c:pt>
                <c:pt idx="74">
                  <c:v>74.5</c:v>
                </c:pt>
                <c:pt idx="75">
                  <c:v>75.5</c:v>
                </c:pt>
                <c:pt idx="76">
                  <c:v>76.5</c:v>
                </c:pt>
                <c:pt idx="77">
                  <c:v>77.5</c:v>
                </c:pt>
                <c:pt idx="78">
                  <c:v>78.5</c:v>
                </c:pt>
                <c:pt idx="79">
                  <c:v>79.5</c:v>
                </c:pt>
                <c:pt idx="80">
                  <c:v>80.5</c:v>
                </c:pt>
                <c:pt idx="81">
                  <c:v>81.5</c:v>
                </c:pt>
                <c:pt idx="82">
                  <c:v>82.5</c:v>
                </c:pt>
                <c:pt idx="83">
                  <c:v>83.5</c:v>
                </c:pt>
                <c:pt idx="84">
                  <c:v>84.5</c:v>
                </c:pt>
                <c:pt idx="85">
                  <c:v>85.5</c:v>
                </c:pt>
                <c:pt idx="86">
                  <c:v>86.5</c:v>
                </c:pt>
                <c:pt idx="87">
                  <c:v>87.5</c:v>
                </c:pt>
                <c:pt idx="88">
                  <c:v>88.5</c:v>
                </c:pt>
                <c:pt idx="89">
                  <c:v>89.5</c:v>
                </c:pt>
                <c:pt idx="90">
                  <c:v>90.5</c:v>
                </c:pt>
                <c:pt idx="91">
                  <c:v>91.5</c:v>
                </c:pt>
                <c:pt idx="92">
                  <c:v>92.5</c:v>
                </c:pt>
                <c:pt idx="93">
                  <c:v>93.5</c:v>
                </c:pt>
                <c:pt idx="94">
                  <c:v>94.5</c:v>
                </c:pt>
                <c:pt idx="95">
                  <c:v>95.5</c:v>
                </c:pt>
                <c:pt idx="96">
                  <c:v>96.5</c:v>
                </c:pt>
                <c:pt idx="97">
                  <c:v>97.5</c:v>
                </c:pt>
                <c:pt idx="98">
                  <c:v>98.5</c:v>
                </c:pt>
                <c:pt idx="99">
                  <c:v>99.5</c:v>
                </c:pt>
                <c:pt idx="100">
                  <c:v>100.5</c:v>
                </c:pt>
                <c:pt idx="101">
                  <c:v>101.5</c:v>
                </c:pt>
                <c:pt idx="102">
                  <c:v>102.5</c:v>
                </c:pt>
                <c:pt idx="103">
                  <c:v>103.5</c:v>
                </c:pt>
                <c:pt idx="104">
                  <c:v>104.5</c:v>
                </c:pt>
                <c:pt idx="105">
                  <c:v>105.5</c:v>
                </c:pt>
                <c:pt idx="106">
                  <c:v>106.5</c:v>
                </c:pt>
                <c:pt idx="107">
                  <c:v>107.5</c:v>
                </c:pt>
                <c:pt idx="108">
                  <c:v>108.5</c:v>
                </c:pt>
                <c:pt idx="109">
                  <c:v>109.5</c:v>
                </c:pt>
                <c:pt idx="110">
                  <c:v>110.5</c:v>
                </c:pt>
                <c:pt idx="111">
                  <c:v>111.5</c:v>
                </c:pt>
                <c:pt idx="112">
                  <c:v>112.5</c:v>
                </c:pt>
                <c:pt idx="113">
                  <c:v>113.5</c:v>
                </c:pt>
                <c:pt idx="114">
                  <c:v>114.5</c:v>
                </c:pt>
                <c:pt idx="115">
                  <c:v>115.5</c:v>
                </c:pt>
                <c:pt idx="116">
                  <c:v>116.5</c:v>
                </c:pt>
                <c:pt idx="117">
                  <c:v>117.5</c:v>
                </c:pt>
                <c:pt idx="118">
                  <c:v>118.5</c:v>
                </c:pt>
                <c:pt idx="119">
                  <c:v>119.5</c:v>
                </c:pt>
                <c:pt idx="120">
                  <c:v>120.5</c:v>
                </c:pt>
                <c:pt idx="121">
                  <c:v>121.5</c:v>
                </c:pt>
                <c:pt idx="122">
                  <c:v>122.5</c:v>
                </c:pt>
                <c:pt idx="123">
                  <c:v>123.5</c:v>
                </c:pt>
                <c:pt idx="124">
                  <c:v>124.5</c:v>
                </c:pt>
                <c:pt idx="125">
                  <c:v>125.5</c:v>
                </c:pt>
                <c:pt idx="126">
                  <c:v>126.5</c:v>
                </c:pt>
                <c:pt idx="127">
                  <c:v>127.5</c:v>
                </c:pt>
                <c:pt idx="128">
                  <c:v>128.5</c:v>
                </c:pt>
                <c:pt idx="129">
                  <c:v>129.5</c:v>
                </c:pt>
                <c:pt idx="130">
                  <c:v>130.5</c:v>
                </c:pt>
                <c:pt idx="131">
                  <c:v>131.5</c:v>
                </c:pt>
                <c:pt idx="132">
                  <c:v>132.5</c:v>
                </c:pt>
                <c:pt idx="133">
                  <c:v>133.5</c:v>
                </c:pt>
                <c:pt idx="134">
                  <c:v>134.5</c:v>
                </c:pt>
                <c:pt idx="135">
                  <c:v>135.5</c:v>
                </c:pt>
                <c:pt idx="136">
                  <c:v>136.5</c:v>
                </c:pt>
                <c:pt idx="137">
                  <c:v>137.5</c:v>
                </c:pt>
                <c:pt idx="138">
                  <c:v>138.5</c:v>
                </c:pt>
                <c:pt idx="139">
                  <c:v>139.5</c:v>
                </c:pt>
                <c:pt idx="140">
                  <c:v>140.5</c:v>
                </c:pt>
                <c:pt idx="141">
                  <c:v>141.5</c:v>
                </c:pt>
                <c:pt idx="142">
                  <c:v>142.5</c:v>
                </c:pt>
                <c:pt idx="143">
                  <c:v>143.5</c:v>
                </c:pt>
                <c:pt idx="144">
                  <c:v>144.5</c:v>
                </c:pt>
                <c:pt idx="145">
                  <c:v>145.5</c:v>
                </c:pt>
                <c:pt idx="146">
                  <c:v>146.5</c:v>
                </c:pt>
                <c:pt idx="147">
                  <c:v>147.5</c:v>
                </c:pt>
                <c:pt idx="148">
                  <c:v>148.5</c:v>
                </c:pt>
                <c:pt idx="149">
                  <c:v>149.5</c:v>
                </c:pt>
                <c:pt idx="150">
                  <c:v>150.5</c:v>
                </c:pt>
                <c:pt idx="151">
                  <c:v>151.5</c:v>
                </c:pt>
                <c:pt idx="152">
                  <c:v>152.5</c:v>
                </c:pt>
                <c:pt idx="153">
                  <c:v>153.5</c:v>
                </c:pt>
                <c:pt idx="154">
                  <c:v>154.5</c:v>
                </c:pt>
                <c:pt idx="155">
                  <c:v>155.5</c:v>
                </c:pt>
                <c:pt idx="156">
                  <c:v>156.5</c:v>
                </c:pt>
                <c:pt idx="157">
                  <c:v>157.5</c:v>
                </c:pt>
                <c:pt idx="158">
                  <c:v>158.5</c:v>
                </c:pt>
                <c:pt idx="159">
                  <c:v>159.5</c:v>
                </c:pt>
                <c:pt idx="160">
                  <c:v>160.5</c:v>
                </c:pt>
                <c:pt idx="161">
                  <c:v>161.5</c:v>
                </c:pt>
                <c:pt idx="162">
                  <c:v>162.5</c:v>
                </c:pt>
                <c:pt idx="163">
                  <c:v>163.5</c:v>
                </c:pt>
                <c:pt idx="164">
                  <c:v>164.5</c:v>
                </c:pt>
                <c:pt idx="165">
                  <c:v>165.5</c:v>
                </c:pt>
                <c:pt idx="166">
                  <c:v>166.5</c:v>
                </c:pt>
                <c:pt idx="167">
                  <c:v>167.5</c:v>
                </c:pt>
                <c:pt idx="168">
                  <c:v>168.5</c:v>
                </c:pt>
                <c:pt idx="169">
                  <c:v>169.5</c:v>
                </c:pt>
                <c:pt idx="170">
                  <c:v>170.5</c:v>
                </c:pt>
                <c:pt idx="171">
                  <c:v>171.5</c:v>
                </c:pt>
                <c:pt idx="172">
                  <c:v>172.5</c:v>
                </c:pt>
                <c:pt idx="173">
                  <c:v>173.5</c:v>
                </c:pt>
                <c:pt idx="174">
                  <c:v>174.5</c:v>
                </c:pt>
                <c:pt idx="175">
                  <c:v>175.5</c:v>
                </c:pt>
                <c:pt idx="176">
                  <c:v>176.5</c:v>
                </c:pt>
                <c:pt idx="177">
                  <c:v>177.5</c:v>
                </c:pt>
                <c:pt idx="178">
                  <c:v>178.5</c:v>
                </c:pt>
                <c:pt idx="179">
                  <c:v>179.5</c:v>
                </c:pt>
                <c:pt idx="180">
                  <c:v>180.5</c:v>
                </c:pt>
                <c:pt idx="181">
                  <c:v>181.5</c:v>
                </c:pt>
                <c:pt idx="182">
                  <c:v>182.5</c:v>
                </c:pt>
                <c:pt idx="183">
                  <c:v>183.5</c:v>
                </c:pt>
                <c:pt idx="184">
                  <c:v>184.5</c:v>
                </c:pt>
                <c:pt idx="185">
                  <c:v>185.5</c:v>
                </c:pt>
                <c:pt idx="186">
                  <c:v>186.5</c:v>
                </c:pt>
                <c:pt idx="187">
                  <c:v>187.5</c:v>
                </c:pt>
                <c:pt idx="188">
                  <c:v>188.5</c:v>
                </c:pt>
                <c:pt idx="189">
                  <c:v>189.5</c:v>
                </c:pt>
                <c:pt idx="190">
                  <c:v>190.5</c:v>
                </c:pt>
                <c:pt idx="191">
                  <c:v>191.5</c:v>
                </c:pt>
                <c:pt idx="192">
                  <c:v>192.5</c:v>
                </c:pt>
                <c:pt idx="193">
                  <c:v>193.5</c:v>
                </c:pt>
                <c:pt idx="194">
                  <c:v>194.5</c:v>
                </c:pt>
                <c:pt idx="195">
                  <c:v>195.5</c:v>
                </c:pt>
                <c:pt idx="196">
                  <c:v>196.5</c:v>
                </c:pt>
                <c:pt idx="197">
                  <c:v>197.5</c:v>
                </c:pt>
                <c:pt idx="198">
                  <c:v>198.5</c:v>
                </c:pt>
                <c:pt idx="199">
                  <c:v>199.5</c:v>
                </c:pt>
                <c:pt idx="200">
                  <c:v>200.5</c:v>
                </c:pt>
                <c:pt idx="201">
                  <c:v>201.5</c:v>
                </c:pt>
                <c:pt idx="202">
                  <c:v>202.5</c:v>
                </c:pt>
                <c:pt idx="203">
                  <c:v>203.5</c:v>
                </c:pt>
                <c:pt idx="204">
                  <c:v>204.5</c:v>
                </c:pt>
                <c:pt idx="205">
                  <c:v>205.5</c:v>
                </c:pt>
                <c:pt idx="206">
                  <c:v>206.5</c:v>
                </c:pt>
                <c:pt idx="207">
                  <c:v>207.5</c:v>
                </c:pt>
                <c:pt idx="208">
                  <c:v>208.5</c:v>
                </c:pt>
                <c:pt idx="209">
                  <c:v>209.5</c:v>
                </c:pt>
                <c:pt idx="210">
                  <c:v>210.5</c:v>
                </c:pt>
                <c:pt idx="211">
                  <c:v>211.5</c:v>
                </c:pt>
                <c:pt idx="212">
                  <c:v>212.5</c:v>
                </c:pt>
                <c:pt idx="213">
                  <c:v>213.5</c:v>
                </c:pt>
                <c:pt idx="214">
                  <c:v>214.5</c:v>
                </c:pt>
                <c:pt idx="215">
                  <c:v>215.5</c:v>
                </c:pt>
                <c:pt idx="216">
                  <c:v>216.5</c:v>
                </c:pt>
                <c:pt idx="217">
                  <c:v>217.5</c:v>
                </c:pt>
                <c:pt idx="218">
                  <c:v>218.5</c:v>
                </c:pt>
                <c:pt idx="219">
                  <c:v>219.5</c:v>
                </c:pt>
                <c:pt idx="220">
                  <c:v>220.5</c:v>
                </c:pt>
                <c:pt idx="221">
                  <c:v>221.5</c:v>
                </c:pt>
                <c:pt idx="222">
                  <c:v>222.5</c:v>
                </c:pt>
                <c:pt idx="223">
                  <c:v>223.5</c:v>
                </c:pt>
                <c:pt idx="224">
                  <c:v>224.5</c:v>
                </c:pt>
                <c:pt idx="225">
                  <c:v>225.5</c:v>
                </c:pt>
                <c:pt idx="226">
                  <c:v>226.5</c:v>
                </c:pt>
                <c:pt idx="227">
                  <c:v>227.5</c:v>
                </c:pt>
                <c:pt idx="228">
                  <c:v>228.5</c:v>
                </c:pt>
                <c:pt idx="229">
                  <c:v>229.5</c:v>
                </c:pt>
                <c:pt idx="230">
                  <c:v>230.5</c:v>
                </c:pt>
                <c:pt idx="231">
                  <c:v>231.5</c:v>
                </c:pt>
                <c:pt idx="232">
                  <c:v>232.5</c:v>
                </c:pt>
                <c:pt idx="233">
                  <c:v>233.5</c:v>
                </c:pt>
                <c:pt idx="234">
                  <c:v>234.5</c:v>
                </c:pt>
                <c:pt idx="235">
                  <c:v>235.5</c:v>
                </c:pt>
                <c:pt idx="236">
                  <c:v>236.5</c:v>
                </c:pt>
                <c:pt idx="237">
                  <c:v>237.5</c:v>
                </c:pt>
                <c:pt idx="238">
                  <c:v>238.5</c:v>
                </c:pt>
                <c:pt idx="239">
                  <c:v>239.5</c:v>
                </c:pt>
                <c:pt idx="240">
                  <c:v>240.5</c:v>
                </c:pt>
                <c:pt idx="241">
                  <c:v>241.5</c:v>
                </c:pt>
                <c:pt idx="242">
                  <c:v>242.5</c:v>
                </c:pt>
                <c:pt idx="243">
                  <c:v>243.5</c:v>
                </c:pt>
                <c:pt idx="244">
                  <c:v>244.5</c:v>
                </c:pt>
                <c:pt idx="245">
                  <c:v>245.5</c:v>
                </c:pt>
                <c:pt idx="246">
                  <c:v>246.5</c:v>
                </c:pt>
                <c:pt idx="247">
                  <c:v>247.5</c:v>
                </c:pt>
                <c:pt idx="248">
                  <c:v>248.5</c:v>
                </c:pt>
                <c:pt idx="249">
                  <c:v>249.5</c:v>
                </c:pt>
                <c:pt idx="250">
                  <c:v>250.5</c:v>
                </c:pt>
                <c:pt idx="251">
                  <c:v>251.5</c:v>
                </c:pt>
                <c:pt idx="252">
                  <c:v>252.5</c:v>
                </c:pt>
                <c:pt idx="253">
                  <c:v>253.5</c:v>
                </c:pt>
                <c:pt idx="254">
                  <c:v>254.5</c:v>
                </c:pt>
                <c:pt idx="255">
                  <c:v>255.5</c:v>
                </c:pt>
                <c:pt idx="256">
                  <c:v>256.5</c:v>
                </c:pt>
                <c:pt idx="257">
                  <c:v>257.5</c:v>
                </c:pt>
                <c:pt idx="258">
                  <c:v>258.5</c:v>
                </c:pt>
                <c:pt idx="259">
                  <c:v>259.5</c:v>
                </c:pt>
                <c:pt idx="260">
                  <c:v>260.5</c:v>
                </c:pt>
                <c:pt idx="261">
                  <c:v>261.5</c:v>
                </c:pt>
                <c:pt idx="262">
                  <c:v>262.5</c:v>
                </c:pt>
                <c:pt idx="263">
                  <c:v>263.5</c:v>
                </c:pt>
                <c:pt idx="264">
                  <c:v>264.5</c:v>
                </c:pt>
                <c:pt idx="265">
                  <c:v>265.5</c:v>
                </c:pt>
                <c:pt idx="266">
                  <c:v>266.5</c:v>
                </c:pt>
                <c:pt idx="267">
                  <c:v>267.5</c:v>
                </c:pt>
                <c:pt idx="268">
                  <c:v>268.5</c:v>
                </c:pt>
                <c:pt idx="269">
                  <c:v>269.5</c:v>
                </c:pt>
                <c:pt idx="270">
                  <c:v>270.5</c:v>
                </c:pt>
                <c:pt idx="271">
                  <c:v>271.5</c:v>
                </c:pt>
                <c:pt idx="272">
                  <c:v>272.5</c:v>
                </c:pt>
                <c:pt idx="273">
                  <c:v>273.5</c:v>
                </c:pt>
                <c:pt idx="274">
                  <c:v>274.5</c:v>
                </c:pt>
                <c:pt idx="275">
                  <c:v>275.5</c:v>
                </c:pt>
                <c:pt idx="276">
                  <c:v>276.5</c:v>
                </c:pt>
                <c:pt idx="277">
                  <c:v>277.5</c:v>
                </c:pt>
                <c:pt idx="278">
                  <c:v>278.5</c:v>
                </c:pt>
                <c:pt idx="279">
                  <c:v>279.5</c:v>
                </c:pt>
                <c:pt idx="280">
                  <c:v>280.5</c:v>
                </c:pt>
                <c:pt idx="281">
                  <c:v>281.5</c:v>
                </c:pt>
                <c:pt idx="282">
                  <c:v>282.5</c:v>
                </c:pt>
                <c:pt idx="283">
                  <c:v>283.5</c:v>
                </c:pt>
                <c:pt idx="284">
                  <c:v>284.5</c:v>
                </c:pt>
                <c:pt idx="285">
                  <c:v>285.5</c:v>
                </c:pt>
                <c:pt idx="286">
                  <c:v>286.5</c:v>
                </c:pt>
                <c:pt idx="287">
                  <c:v>287.5</c:v>
                </c:pt>
                <c:pt idx="288">
                  <c:v>288.5</c:v>
                </c:pt>
                <c:pt idx="289">
                  <c:v>289.5</c:v>
                </c:pt>
                <c:pt idx="290">
                  <c:v>290.5</c:v>
                </c:pt>
                <c:pt idx="291">
                  <c:v>291.5</c:v>
                </c:pt>
                <c:pt idx="292">
                  <c:v>292.5</c:v>
                </c:pt>
                <c:pt idx="293">
                  <c:v>293.5</c:v>
                </c:pt>
                <c:pt idx="294">
                  <c:v>294.5</c:v>
                </c:pt>
                <c:pt idx="295">
                  <c:v>295.5</c:v>
                </c:pt>
                <c:pt idx="296">
                  <c:v>296.5</c:v>
                </c:pt>
                <c:pt idx="297">
                  <c:v>297.5</c:v>
                </c:pt>
                <c:pt idx="298">
                  <c:v>298.5</c:v>
                </c:pt>
                <c:pt idx="299">
                  <c:v>299.5</c:v>
                </c:pt>
                <c:pt idx="300">
                  <c:v>300.5</c:v>
                </c:pt>
                <c:pt idx="301">
                  <c:v>301.5</c:v>
                </c:pt>
                <c:pt idx="302">
                  <c:v>302.5</c:v>
                </c:pt>
                <c:pt idx="303">
                  <c:v>303.5</c:v>
                </c:pt>
                <c:pt idx="304">
                  <c:v>304.5</c:v>
                </c:pt>
                <c:pt idx="305">
                  <c:v>305.5</c:v>
                </c:pt>
                <c:pt idx="306">
                  <c:v>306.5</c:v>
                </c:pt>
                <c:pt idx="307">
                  <c:v>307.5</c:v>
                </c:pt>
                <c:pt idx="308">
                  <c:v>308.5</c:v>
                </c:pt>
                <c:pt idx="309">
                  <c:v>309.5</c:v>
                </c:pt>
                <c:pt idx="310">
                  <c:v>310.5</c:v>
                </c:pt>
                <c:pt idx="311">
                  <c:v>311.5</c:v>
                </c:pt>
                <c:pt idx="312">
                  <c:v>312.5</c:v>
                </c:pt>
                <c:pt idx="313">
                  <c:v>313.5</c:v>
                </c:pt>
                <c:pt idx="314">
                  <c:v>314.5</c:v>
                </c:pt>
                <c:pt idx="315">
                  <c:v>315.5</c:v>
                </c:pt>
                <c:pt idx="316">
                  <c:v>316.5</c:v>
                </c:pt>
                <c:pt idx="317">
                  <c:v>317.5</c:v>
                </c:pt>
                <c:pt idx="318">
                  <c:v>318.5</c:v>
                </c:pt>
                <c:pt idx="319">
                  <c:v>319.5</c:v>
                </c:pt>
                <c:pt idx="320">
                  <c:v>320.5</c:v>
                </c:pt>
                <c:pt idx="321">
                  <c:v>321.5</c:v>
                </c:pt>
                <c:pt idx="322">
                  <c:v>322.5</c:v>
                </c:pt>
                <c:pt idx="323">
                  <c:v>323.5</c:v>
                </c:pt>
                <c:pt idx="324">
                  <c:v>324.5</c:v>
                </c:pt>
                <c:pt idx="325">
                  <c:v>325.5</c:v>
                </c:pt>
                <c:pt idx="326">
                  <c:v>326.5</c:v>
                </c:pt>
                <c:pt idx="327">
                  <c:v>327.5</c:v>
                </c:pt>
                <c:pt idx="328">
                  <c:v>328.5</c:v>
                </c:pt>
                <c:pt idx="329">
                  <c:v>329.5</c:v>
                </c:pt>
                <c:pt idx="330">
                  <c:v>330.5</c:v>
                </c:pt>
                <c:pt idx="331">
                  <c:v>331.5</c:v>
                </c:pt>
                <c:pt idx="332">
                  <c:v>332.5</c:v>
                </c:pt>
                <c:pt idx="333">
                  <c:v>333.5</c:v>
                </c:pt>
                <c:pt idx="334">
                  <c:v>334.5</c:v>
                </c:pt>
                <c:pt idx="335">
                  <c:v>335.5</c:v>
                </c:pt>
                <c:pt idx="336">
                  <c:v>336.5</c:v>
                </c:pt>
                <c:pt idx="337">
                  <c:v>337.5</c:v>
                </c:pt>
                <c:pt idx="338">
                  <c:v>338.5</c:v>
                </c:pt>
                <c:pt idx="339">
                  <c:v>339.5</c:v>
                </c:pt>
                <c:pt idx="340">
                  <c:v>340.5</c:v>
                </c:pt>
                <c:pt idx="341">
                  <c:v>341.5</c:v>
                </c:pt>
                <c:pt idx="342">
                  <c:v>342.5</c:v>
                </c:pt>
                <c:pt idx="343">
                  <c:v>343.5</c:v>
                </c:pt>
                <c:pt idx="344">
                  <c:v>344.5</c:v>
                </c:pt>
                <c:pt idx="345">
                  <c:v>345.5</c:v>
                </c:pt>
                <c:pt idx="346">
                  <c:v>346.5</c:v>
                </c:pt>
                <c:pt idx="347">
                  <c:v>347.5</c:v>
                </c:pt>
                <c:pt idx="348">
                  <c:v>348.5</c:v>
                </c:pt>
                <c:pt idx="349">
                  <c:v>349.5</c:v>
                </c:pt>
                <c:pt idx="350">
                  <c:v>350.5</c:v>
                </c:pt>
                <c:pt idx="351">
                  <c:v>351.5</c:v>
                </c:pt>
                <c:pt idx="352">
                  <c:v>352.5</c:v>
                </c:pt>
                <c:pt idx="353">
                  <c:v>353.5</c:v>
                </c:pt>
                <c:pt idx="354">
                  <c:v>354.5</c:v>
                </c:pt>
                <c:pt idx="355">
                  <c:v>355.5</c:v>
                </c:pt>
                <c:pt idx="356">
                  <c:v>356.5</c:v>
                </c:pt>
                <c:pt idx="357">
                  <c:v>357.5</c:v>
                </c:pt>
                <c:pt idx="358">
                  <c:v>358.5</c:v>
                </c:pt>
                <c:pt idx="359">
                  <c:v>359.5</c:v>
                </c:pt>
                <c:pt idx="360">
                  <c:v>360.5</c:v>
                </c:pt>
                <c:pt idx="361">
                  <c:v>361.5</c:v>
                </c:pt>
                <c:pt idx="362">
                  <c:v>362.5</c:v>
                </c:pt>
                <c:pt idx="363">
                  <c:v>363.5</c:v>
                </c:pt>
                <c:pt idx="364">
                  <c:v>364.5</c:v>
                </c:pt>
                <c:pt idx="365">
                  <c:v>365.5</c:v>
                </c:pt>
                <c:pt idx="366">
                  <c:v>366.5</c:v>
                </c:pt>
                <c:pt idx="367">
                  <c:v>367.5</c:v>
                </c:pt>
                <c:pt idx="368">
                  <c:v>368.5</c:v>
                </c:pt>
                <c:pt idx="369">
                  <c:v>369.5</c:v>
                </c:pt>
                <c:pt idx="370">
                  <c:v>370.5</c:v>
                </c:pt>
                <c:pt idx="371">
                  <c:v>371.5</c:v>
                </c:pt>
                <c:pt idx="372">
                  <c:v>372.5</c:v>
                </c:pt>
                <c:pt idx="373">
                  <c:v>373.5</c:v>
                </c:pt>
                <c:pt idx="374">
                  <c:v>374.5</c:v>
                </c:pt>
                <c:pt idx="375">
                  <c:v>375.5</c:v>
                </c:pt>
                <c:pt idx="376">
                  <c:v>376.5</c:v>
                </c:pt>
                <c:pt idx="377">
                  <c:v>377.5</c:v>
                </c:pt>
                <c:pt idx="378">
                  <c:v>378.5</c:v>
                </c:pt>
                <c:pt idx="379">
                  <c:v>379.5</c:v>
                </c:pt>
                <c:pt idx="380">
                  <c:v>380.5</c:v>
                </c:pt>
                <c:pt idx="381">
                  <c:v>381.5</c:v>
                </c:pt>
                <c:pt idx="382">
                  <c:v>382.5</c:v>
                </c:pt>
                <c:pt idx="383">
                  <c:v>383.5</c:v>
                </c:pt>
                <c:pt idx="384">
                  <c:v>384.5</c:v>
                </c:pt>
                <c:pt idx="385">
                  <c:v>385.5</c:v>
                </c:pt>
                <c:pt idx="386">
                  <c:v>386.5</c:v>
                </c:pt>
                <c:pt idx="387">
                  <c:v>387.5</c:v>
                </c:pt>
                <c:pt idx="388">
                  <c:v>388.5</c:v>
                </c:pt>
                <c:pt idx="389">
                  <c:v>389.5</c:v>
                </c:pt>
                <c:pt idx="390">
                  <c:v>390.5</c:v>
                </c:pt>
                <c:pt idx="391">
                  <c:v>391.5</c:v>
                </c:pt>
                <c:pt idx="392">
                  <c:v>392.5</c:v>
                </c:pt>
                <c:pt idx="393">
                  <c:v>393.5</c:v>
                </c:pt>
                <c:pt idx="394">
                  <c:v>394.5</c:v>
                </c:pt>
                <c:pt idx="395">
                  <c:v>395.5</c:v>
                </c:pt>
                <c:pt idx="396">
                  <c:v>396.5</c:v>
                </c:pt>
                <c:pt idx="397">
                  <c:v>397.5</c:v>
                </c:pt>
                <c:pt idx="398">
                  <c:v>398.5</c:v>
                </c:pt>
                <c:pt idx="399">
                  <c:v>399.5</c:v>
                </c:pt>
                <c:pt idx="400">
                  <c:v>400.5</c:v>
                </c:pt>
                <c:pt idx="401">
                  <c:v>401.5</c:v>
                </c:pt>
                <c:pt idx="402">
                  <c:v>402.5</c:v>
                </c:pt>
                <c:pt idx="403">
                  <c:v>403.5</c:v>
                </c:pt>
                <c:pt idx="404">
                  <c:v>404.5</c:v>
                </c:pt>
                <c:pt idx="405">
                  <c:v>405.5</c:v>
                </c:pt>
                <c:pt idx="406">
                  <c:v>406.5</c:v>
                </c:pt>
                <c:pt idx="407">
                  <c:v>407.5</c:v>
                </c:pt>
                <c:pt idx="408">
                  <c:v>408.5</c:v>
                </c:pt>
                <c:pt idx="409">
                  <c:v>409.5</c:v>
                </c:pt>
                <c:pt idx="410">
                  <c:v>410.5</c:v>
                </c:pt>
                <c:pt idx="411">
                  <c:v>411.5</c:v>
                </c:pt>
                <c:pt idx="412">
                  <c:v>412.5</c:v>
                </c:pt>
                <c:pt idx="413">
                  <c:v>413.5</c:v>
                </c:pt>
                <c:pt idx="414">
                  <c:v>414.5</c:v>
                </c:pt>
                <c:pt idx="415">
                  <c:v>415.5</c:v>
                </c:pt>
                <c:pt idx="416">
                  <c:v>416.5</c:v>
                </c:pt>
                <c:pt idx="417">
                  <c:v>417.5</c:v>
                </c:pt>
                <c:pt idx="418">
                  <c:v>418.5</c:v>
                </c:pt>
                <c:pt idx="419">
                  <c:v>419.5</c:v>
                </c:pt>
                <c:pt idx="420">
                  <c:v>420.5</c:v>
                </c:pt>
                <c:pt idx="421">
                  <c:v>421.5</c:v>
                </c:pt>
                <c:pt idx="422">
                  <c:v>422.5</c:v>
                </c:pt>
                <c:pt idx="423">
                  <c:v>423.5</c:v>
                </c:pt>
                <c:pt idx="424">
                  <c:v>424.5</c:v>
                </c:pt>
                <c:pt idx="425">
                  <c:v>425.5</c:v>
                </c:pt>
                <c:pt idx="426">
                  <c:v>426.5</c:v>
                </c:pt>
                <c:pt idx="427">
                  <c:v>427.5</c:v>
                </c:pt>
                <c:pt idx="428">
                  <c:v>428.5</c:v>
                </c:pt>
                <c:pt idx="429">
                  <c:v>429.5</c:v>
                </c:pt>
                <c:pt idx="430">
                  <c:v>430.5</c:v>
                </c:pt>
                <c:pt idx="431">
                  <c:v>431.5</c:v>
                </c:pt>
                <c:pt idx="432">
                  <c:v>432.5</c:v>
                </c:pt>
                <c:pt idx="433">
                  <c:v>433.5</c:v>
                </c:pt>
                <c:pt idx="434">
                  <c:v>434.5</c:v>
                </c:pt>
                <c:pt idx="435">
                  <c:v>435.5</c:v>
                </c:pt>
                <c:pt idx="436">
                  <c:v>436.5</c:v>
                </c:pt>
                <c:pt idx="437">
                  <c:v>437.5</c:v>
                </c:pt>
                <c:pt idx="438">
                  <c:v>438.5</c:v>
                </c:pt>
                <c:pt idx="439">
                  <c:v>439.5</c:v>
                </c:pt>
                <c:pt idx="440">
                  <c:v>440.5</c:v>
                </c:pt>
                <c:pt idx="441">
                  <c:v>441.5</c:v>
                </c:pt>
                <c:pt idx="442">
                  <c:v>442.5</c:v>
                </c:pt>
                <c:pt idx="443">
                  <c:v>443.5</c:v>
                </c:pt>
                <c:pt idx="444">
                  <c:v>444.5</c:v>
                </c:pt>
                <c:pt idx="445">
                  <c:v>445.5</c:v>
                </c:pt>
                <c:pt idx="446">
                  <c:v>446.5</c:v>
                </c:pt>
                <c:pt idx="447">
                  <c:v>447.5</c:v>
                </c:pt>
                <c:pt idx="448">
                  <c:v>448.5</c:v>
                </c:pt>
                <c:pt idx="449">
                  <c:v>449.5</c:v>
                </c:pt>
                <c:pt idx="450">
                  <c:v>450.5</c:v>
                </c:pt>
                <c:pt idx="451">
                  <c:v>451.5</c:v>
                </c:pt>
                <c:pt idx="452">
                  <c:v>452.5</c:v>
                </c:pt>
                <c:pt idx="453">
                  <c:v>453.5</c:v>
                </c:pt>
                <c:pt idx="454">
                  <c:v>454.5</c:v>
                </c:pt>
                <c:pt idx="455">
                  <c:v>455.5</c:v>
                </c:pt>
                <c:pt idx="456">
                  <c:v>456.5</c:v>
                </c:pt>
                <c:pt idx="457">
                  <c:v>457.5</c:v>
                </c:pt>
                <c:pt idx="458">
                  <c:v>458.5</c:v>
                </c:pt>
                <c:pt idx="459">
                  <c:v>459.5</c:v>
                </c:pt>
                <c:pt idx="460">
                  <c:v>460.5</c:v>
                </c:pt>
                <c:pt idx="461">
                  <c:v>461.5</c:v>
                </c:pt>
                <c:pt idx="462">
                  <c:v>462.5</c:v>
                </c:pt>
                <c:pt idx="463">
                  <c:v>463.5</c:v>
                </c:pt>
                <c:pt idx="464">
                  <c:v>464.5</c:v>
                </c:pt>
                <c:pt idx="465">
                  <c:v>465.5</c:v>
                </c:pt>
                <c:pt idx="466">
                  <c:v>466.5</c:v>
                </c:pt>
                <c:pt idx="467">
                  <c:v>467.5</c:v>
                </c:pt>
                <c:pt idx="468">
                  <c:v>468.5</c:v>
                </c:pt>
                <c:pt idx="469">
                  <c:v>469.5</c:v>
                </c:pt>
                <c:pt idx="470">
                  <c:v>470.5</c:v>
                </c:pt>
                <c:pt idx="471">
                  <c:v>471.5</c:v>
                </c:pt>
                <c:pt idx="472">
                  <c:v>472.5</c:v>
                </c:pt>
                <c:pt idx="473">
                  <c:v>473.5</c:v>
                </c:pt>
                <c:pt idx="474">
                  <c:v>474.5</c:v>
                </c:pt>
                <c:pt idx="475">
                  <c:v>475.5</c:v>
                </c:pt>
                <c:pt idx="476">
                  <c:v>476.5</c:v>
                </c:pt>
                <c:pt idx="477">
                  <c:v>477.5</c:v>
                </c:pt>
                <c:pt idx="478">
                  <c:v>478.5</c:v>
                </c:pt>
                <c:pt idx="479">
                  <c:v>479.5</c:v>
                </c:pt>
                <c:pt idx="480">
                  <c:v>480.5</c:v>
                </c:pt>
                <c:pt idx="481">
                  <c:v>481.5</c:v>
                </c:pt>
                <c:pt idx="482">
                  <c:v>482.5</c:v>
                </c:pt>
                <c:pt idx="483">
                  <c:v>483.5</c:v>
                </c:pt>
                <c:pt idx="484">
                  <c:v>484.5</c:v>
                </c:pt>
                <c:pt idx="485">
                  <c:v>485.5</c:v>
                </c:pt>
                <c:pt idx="486">
                  <c:v>486.5</c:v>
                </c:pt>
                <c:pt idx="487">
                  <c:v>487.5</c:v>
                </c:pt>
                <c:pt idx="488">
                  <c:v>488.5</c:v>
                </c:pt>
                <c:pt idx="489">
                  <c:v>489.5</c:v>
                </c:pt>
                <c:pt idx="490">
                  <c:v>490.5</c:v>
                </c:pt>
                <c:pt idx="491">
                  <c:v>491.5</c:v>
                </c:pt>
                <c:pt idx="492">
                  <c:v>492.5</c:v>
                </c:pt>
                <c:pt idx="493">
                  <c:v>493.5</c:v>
                </c:pt>
                <c:pt idx="494">
                  <c:v>494.5</c:v>
                </c:pt>
                <c:pt idx="495">
                  <c:v>495.5</c:v>
                </c:pt>
                <c:pt idx="496">
                  <c:v>496.5</c:v>
                </c:pt>
                <c:pt idx="497">
                  <c:v>497.5</c:v>
                </c:pt>
                <c:pt idx="498">
                  <c:v>498.5</c:v>
                </c:pt>
                <c:pt idx="499">
                  <c:v>499.5</c:v>
                </c:pt>
                <c:pt idx="500">
                  <c:v>500.5</c:v>
                </c:pt>
                <c:pt idx="501">
                  <c:v>501.5</c:v>
                </c:pt>
                <c:pt idx="502">
                  <c:v>502.5</c:v>
                </c:pt>
                <c:pt idx="503">
                  <c:v>503.5</c:v>
                </c:pt>
                <c:pt idx="504">
                  <c:v>504.5</c:v>
                </c:pt>
                <c:pt idx="505">
                  <c:v>505.5</c:v>
                </c:pt>
                <c:pt idx="506">
                  <c:v>506.5</c:v>
                </c:pt>
                <c:pt idx="507">
                  <c:v>507.5</c:v>
                </c:pt>
                <c:pt idx="508">
                  <c:v>508.5</c:v>
                </c:pt>
                <c:pt idx="509">
                  <c:v>509.5</c:v>
                </c:pt>
                <c:pt idx="510">
                  <c:v>510.5</c:v>
                </c:pt>
                <c:pt idx="511">
                  <c:v>511.5</c:v>
                </c:pt>
                <c:pt idx="512">
                  <c:v>512.5</c:v>
                </c:pt>
                <c:pt idx="513">
                  <c:v>513.5</c:v>
                </c:pt>
                <c:pt idx="514">
                  <c:v>514.5</c:v>
                </c:pt>
                <c:pt idx="515">
                  <c:v>515.5</c:v>
                </c:pt>
                <c:pt idx="516">
                  <c:v>516.5</c:v>
                </c:pt>
                <c:pt idx="517">
                  <c:v>517.5</c:v>
                </c:pt>
                <c:pt idx="518">
                  <c:v>518.5</c:v>
                </c:pt>
                <c:pt idx="519">
                  <c:v>519.5</c:v>
                </c:pt>
                <c:pt idx="520">
                  <c:v>520.5</c:v>
                </c:pt>
                <c:pt idx="521">
                  <c:v>521.5</c:v>
                </c:pt>
                <c:pt idx="522">
                  <c:v>522.5</c:v>
                </c:pt>
                <c:pt idx="523">
                  <c:v>523.5</c:v>
                </c:pt>
                <c:pt idx="524">
                  <c:v>524.5</c:v>
                </c:pt>
                <c:pt idx="525">
                  <c:v>525.5</c:v>
                </c:pt>
                <c:pt idx="526">
                  <c:v>526.5</c:v>
                </c:pt>
                <c:pt idx="527">
                  <c:v>527.5</c:v>
                </c:pt>
                <c:pt idx="528">
                  <c:v>528.5</c:v>
                </c:pt>
                <c:pt idx="529">
                  <c:v>529.5</c:v>
                </c:pt>
                <c:pt idx="530">
                  <c:v>530.5</c:v>
                </c:pt>
                <c:pt idx="531">
                  <c:v>531.5</c:v>
                </c:pt>
                <c:pt idx="532">
                  <c:v>532.5</c:v>
                </c:pt>
                <c:pt idx="533">
                  <c:v>533.5</c:v>
                </c:pt>
                <c:pt idx="534">
                  <c:v>534.5</c:v>
                </c:pt>
                <c:pt idx="535">
                  <c:v>535.5</c:v>
                </c:pt>
                <c:pt idx="536">
                  <c:v>536.5</c:v>
                </c:pt>
                <c:pt idx="537">
                  <c:v>537.5</c:v>
                </c:pt>
                <c:pt idx="538">
                  <c:v>538.5</c:v>
                </c:pt>
                <c:pt idx="539">
                  <c:v>539.5</c:v>
                </c:pt>
                <c:pt idx="540">
                  <c:v>540.5</c:v>
                </c:pt>
                <c:pt idx="541">
                  <c:v>541.5</c:v>
                </c:pt>
                <c:pt idx="542">
                  <c:v>542.5</c:v>
                </c:pt>
                <c:pt idx="543">
                  <c:v>543.5</c:v>
                </c:pt>
                <c:pt idx="544">
                  <c:v>544.5</c:v>
                </c:pt>
                <c:pt idx="545">
                  <c:v>545.5</c:v>
                </c:pt>
                <c:pt idx="546">
                  <c:v>546.5</c:v>
                </c:pt>
                <c:pt idx="547">
                  <c:v>547.5</c:v>
                </c:pt>
                <c:pt idx="548">
                  <c:v>548.5</c:v>
                </c:pt>
                <c:pt idx="549">
                  <c:v>549.5</c:v>
                </c:pt>
                <c:pt idx="550">
                  <c:v>550.5</c:v>
                </c:pt>
                <c:pt idx="551">
                  <c:v>551.5</c:v>
                </c:pt>
                <c:pt idx="552">
                  <c:v>552.5</c:v>
                </c:pt>
                <c:pt idx="553">
                  <c:v>553.5</c:v>
                </c:pt>
                <c:pt idx="554">
                  <c:v>554.5</c:v>
                </c:pt>
                <c:pt idx="555">
                  <c:v>555.5</c:v>
                </c:pt>
                <c:pt idx="556">
                  <c:v>556.5</c:v>
                </c:pt>
                <c:pt idx="557">
                  <c:v>557.5</c:v>
                </c:pt>
                <c:pt idx="558">
                  <c:v>558.5</c:v>
                </c:pt>
                <c:pt idx="559">
                  <c:v>559.5</c:v>
                </c:pt>
                <c:pt idx="560">
                  <c:v>560.5</c:v>
                </c:pt>
                <c:pt idx="561">
                  <c:v>561.5</c:v>
                </c:pt>
                <c:pt idx="562">
                  <c:v>562.5</c:v>
                </c:pt>
                <c:pt idx="563">
                  <c:v>563.5</c:v>
                </c:pt>
                <c:pt idx="564">
                  <c:v>564.5</c:v>
                </c:pt>
                <c:pt idx="565">
                  <c:v>565.5</c:v>
                </c:pt>
                <c:pt idx="566">
                  <c:v>566.5</c:v>
                </c:pt>
                <c:pt idx="567">
                  <c:v>567.5</c:v>
                </c:pt>
                <c:pt idx="568">
                  <c:v>568.5</c:v>
                </c:pt>
                <c:pt idx="569">
                  <c:v>569.5</c:v>
                </c:pt>
                <c:pt idx="570">
                  <c:v>570.5</c:v>
                </c:pt>
                <c:pt idx="571">
                  <c:v>571.5</c:v>
                </c:pt>
                <c:pt idx="572">
                  <c:v>572.5</c:v>
                </c:pt>
                <c:pt idx="573">
                  <c:v>573.5</c:v>
                </c:pt>
                <c:pt idx="574">
                  <c:v>574.5</c:v>
                </c:pt>
                <c:pt idx="575">
                  <c:v>575.5</c:v>
                </c:pt>
                <c:pt idx="576">
                  <c:v>576.5</c:v>
                </c:pt>
                <c:pt idx="577">
                  <c:v>577.5</c:v>
                </c:pt>
                <c:pt idx="578">
                  <c:v>578.5</c:v>
                </c:pt>
                <c:pt idx="579">
                  <c:v>579.5</c:v>
                </c:pt>
                <c:pt idx="580">
                  <c:v>580.5</c:v>
                </c:pt>
                <c:pt idx="581">
                  <c:v>581.5</c:v>
                </c:pt>
                <c:pt idx="582">
                  <c:v>582.5</c:v>
                </c:pt>
                <c:pt idx="583">
                  <c:v>583.5</c:v>
                </c:pt>
                <c:pt idx="584">
                  <c:v>584.5</c:v>
                </c:pt>
                <c:pt idx="585">
                  <c:v>585.5</c:v>
                </c:pt>
                <c:pt idx="586">
                  <c:v>586.5</c:v>
                </c:pt>
                <c:pt idx="587">
                  <c:v>587.5</c:v>
                </c:pt>
                <c:pt idx="588">
                  <c:v>588.5</c:v>
                </c:pt>
                <c:pt idx="589">
                  <c:v>589.5</c:v>
                </c:pt>
                <c:pt idx="590">
                  <c:v>590.5</c:v>
                </c:pt>
                <c:pt idx="591">
                  <c:v>591.5</c:v>
                </c:pt>
                <c:pt idx="592">
                  <c:v>592.5</c:v>
                </c:pt>
                <c:pt idx="593">
                  <c:v>593.5</c:v>
                </c:pt>
                <c:pt idx="594">
                  <c:v>594.5</c:v>
                </c:pt>
                <c:pt idx="595">
                  <c:v>595.5</c:v>
                </c:pt>
                <c:pt idx="596">
                  <c:v>596.5</c:v>
                </c:pt>
                <c:pt idx="597">
                  <c:v>597.5</c:v>
                </c:pt>
                <c:pt idx="598">
                  <c:v>598.5</c:v>
                </c:pt>
                <c:pt idx="599">
                  <c:v>599.5</c:v>
                </c:pt>
                <c:pt idx="600">
                  <c:v>600.5</c:v>
                </c:pt>
                <c:pt idx="601">
                  <c:v>601.5</c:v>
                </c:pt>
                <c:pt idx="602">
                  <c:v>602.5</c:v>
                </c:pt>
                <c:pt idx="603">
                  <c:v>603.5</c:v>
                </c:pt>
                <c:pt idx="604">
                  <c:v>604.5</c:v>
                </c:pt>
                <c:pt idx="605">
                  <c:v>605.5</c:v>
                </c:pt>
                <c:pt idx="606">
                  <c:v>606.5</c:v>
                </c:pt>
                <c:pt idx="607">
                  <c:v>607.5</c:v>
                </c:pt>
                <c:pt idx="608">
                  <c:v>608.5</c:v>
                </c:pt>
                <c:pt idx="609">
                  <c:v>609.5</c:v>
                </c:pt>
                <c:pt idx="610">
                  <c:v>610.5</c:v>
                </c:pt>
                <c:pt idx="611">
                  <c:v>611.5</c:v>
                </c:pt>
                <c:pt idx="612">
                  <c:v>612.5</c:v>
                </c:pt>
                <c:pt idx="613">
                  <c:v>613.5</c:v>
                </c:pt>
                <c:pt idx="614">
                  <c:v>614.5</c:v>
                </c:pt>
                <c:pt idx="615">
                  <c:v>615.5</c:v>
                </c:pt>
                <c:pt idx="616">
                  <c:v>616.5</c:v>
                </c:pt>
                <c:pt idx="617">
                  <c:v>617.5</c:v>
                </c:pt>
                <c:pt idx="618">
                  <c:v>618.5</c:v>
                </c:pt>
                <c:pt idx="619">
                  <c:v>619.5</c:v>
                </c:pt>
                <c:pt idx="620">
                  <c:v>620.5</c:v>
                </c:pt>
                <c:pt idx="621">
                  <c:v>621.5</c:v>
                </c:pt>
                <c:pt idx="622">
                  <c:v>622.5</c:v>
                </c:pt>
                <c:pt idx="623">
                  <c:v>623.5</c:v>
                </c:pt>
                <c:pt idx="624">
                  <c:v>624.5</c:v>
                </c:pt>
                <c:pt idx="625">
                  <c:v>625.5</c:v>
                </c:pt>
                <c:pt idx="626">
                  <c:v>626.5</c:v>
                </c:pt>
                <c:pt idx="627">
                  <c:v>627.5</c:v>
                </c:pt>
                <c:pt idx="628">
                  <c:v>628.5</c:v>
                </c:pt>
                <c:pt idx="629">
                  <c:v>629.5</c:v>
                </c:pt>
                <c:pt idx="630">
                  <c:v>630.5</c:v>
                </c:pt>
                <c:pt idx="631">
                  <c:v>631.5</c:v>
                </c:pt>
                <c:pt idx="632">
                  <c:v>632.5</c:v>
                </c:pt>
                <c:pt idx="633">
                  <c:v>633.5</c:v>
                </c:pt>
                <c:pt idx="634">
                  <c:v>634.5</c:v>
                </c:pt>
                <c:pt idx="635">
                  <c:v>635.5</c:v>
                </c:pt>
                <c:pt idx="636">
                  <c:v>636.5</c:v>
                </c:pt>
                <c:pt idx="637">
                  <c:v>637.5</c:v>
                </c:pt>
                <c:pt idx="638">
                  <c:v>638.5</c:v>
                </c:pt>
                <c:pt idx="639">
                  <c:v>639.5</c:v>
                </c:pt>
                <c:pt idx="640">
                  <c:v>640.5</c:v>
                </c:pt>
                <c:pt idx="641">
                  <c:v>641.5</c:v>
                </c:pt>
                <c:pt idx="642">
                  <c:v>642.5</c:v>
                </c:pt>
                <c:pt idx="643">
                  <c:v>643.5</c:v>
                </c:pt>
                <c:pt idx="644">
                  <c:v>644.5</c:v>
                </c:pt>
                <c:pt idx="645">
                  <c:v>645.5</c:v>
                </c:pt>
                <c:pt idx="646">
                  <c:v>646.5</c:v>
                </c:pt>
                <c:pt idx="647">
                  <c:v>647.5</c:v>
                </c:pt>
                <c:pt idx="648">
                  <c:v>648.5</c:v>
                </c:pt>
                <c:pt idx="649">
                  <c:v>649.5</c:v>
                </c:pt>
                <c:pt idx="650">
                  <c:v>650.5</c:v>
                </c:pt>
                <c:pt idx="651">
                  <c:v>651.5</c:v>
                </c:pt>
                <c:pt idx="652">
                  <c:v>652.5</c:v>
                </c:pt>
                <c:pt idx="653">
                  <c:v>653.5</c:v>
                </c:pt>
                <c:pt idx="654">
                  <c:v>654.5</c:v>
                </c:pt>
                <c:pt idx="655">
                  <c:v>655.5</c:v>
                </c:pt>
                <c:pt idx="656">
                  <c:v>656.5</c:v>
                </c:pt>
                <c:pt idx="657">
                  <c:v>657.5</c:v>
                </c:pt>
                <c:pt idx="658">
                  <c:v>658.5</c:v>
                </c:pt>
                <c:pt idx="659">
                  <c:v>659.5</c:v>
                </c:pt>
                <c:pt idx="660">
                  <c:v>660.5</c:v>
                </c:pt>
                <c:pt idx="661">
                  <c:v>661.5</c:v>
                </c:pt>
                <c:pt idx="662">
                  <c:v>662.5</c:v>
                </c:pt>
                <c:pt idx="663">
                  <c:v>663.5</c:v>
                </c:pt>
                <c:pt idx="664">
                  <c:v>664.5</c:v>
                </c:pt>
                <c:pt idx="665">
                  <c:v>665.5</c:v>
                </c:pt>
                <c:pt idx="666">
                  <c:v>666.5</c:v>
                </c:pt>
                <c:pt idx="667">
                  <c:v>667.5</c:v>
                </c:pt>
                <c:pt idx="668">
                  <c:v>668.5</c:v>
                </c:pt>
                <c:pt idx="669">
                  <c:v>669.5</c:v>
                </c:pt>
                <c:pt idx="670">
                  <c:v>670.5</c:v>
                </c:pt>
                <c:pt idx="671">
                  <c:v>671.5</c:v>
                </c:pt>
                <c:pt idx="672">
                  <c:v>672.5</c:v>
                </c:pt>
                <c:pt idx="673">
                  <c:v>673.5</c:v>
                </c:pt>
                <c:pt idx="674">
                  <c:v>674.5</c:v>
                </c:pt>
                <c:pt idx="675">
                  <c:v>675.5</c:v>
                </c:pt>
                <c:pt idx="676">
                  <c:v>676.5</c:v>
                </c:pt>
                <c:pt idx="677">
                  <c:v>677.5</c:v>
                </c:pt>
                <c:pt idx="678">
                  <c:v>678.5</c:v>
                </c:pt>
                <c:pt idx="679">
                  <c:v>679.5</c:v>
                </c:pt>
                <c:pt idx="680">
                  <c:v>680.5</c:v>
                </c:pt>
                <c:pt idx="681">
                  <c:v>681.5</c:v>
                </c:pt>
                <c:pt idx="682">
                  <c:v>682.5</c:v>
                </c:pt>
                <c:pt idx="683">
                  <c:v>683.5</c:v>
                </c:pt>
                <c:pt idx="684">
                  <c:v>684.5</c:v>
                </c:pt>
                <c:pt idx="685">
                  <c:v>685.5</c:v>
                </c:pt>
                <c:pt idx="686">
                  <c:v>686.5</c:v>
                </c:pt>
                <c:pt idx="687">
                  <c:v>687.5</c:v>
                </c:pt>
                <c:pt idx="688">
                  <c:v>688.5</c:v>
                </c:pt>
                <c:pt idx="689">
                  <c:v>689.5</c:v>
                </c:pt>
                <c:pt idx="690">
                  <c:v>690.5</c:v>
                </c:pt>
                <c:pt idx="691">
                  <c:v>691.5</c:v>
                </c:pt>
                <c:pt idx="692">
                  <c:v>692.5</c:v>
                </c:pt>
                <c:pt idx="693">
                  <c:v>693.5</c:v>
                </c:pt>
                <c:pt idx="694">
                  <c:v>694.5</c:v>
                </c:pt>
                <c:pt idx="695">
                  <c:v>695.5</c:v>
                </c:pt>
                <c:pt idx="696">
                  <c:v>696.5</c:v>
                </c:pt>
                <c:pt idx="697">
                  <c:v>697.5</c:v>
                </c:pt>
                <c:pt idx="698">
                  <c:v>698.5</c:v>
                </c:pt>
                <c:pt idx="699">
                  <c:v>699.5</c:v>
                </c:pt>
                <c:pt idx="700">
                  <c:v>700.5</c:v>
                </c:pt>
                <c:pt idx="701">
                  <c:v>701.5</c:v>
                </c:pt>
                <c:pt idx="702">
                  <c:v>702.5</c:v>
                </c:pt>
                <c:pt idx="703">
                  <c:v>703.5</c:v>
                </c:pt>
                <c:pt idx="704">
                  <c:v>704.5</c:v>
                </c:pt>
                <c:pt idx="705">
                  <c:v>705.5</c:v>
                </c:pt>
                <c:pt idx="706">
                  <c:v>706.5</c:v>
                </c:pt>
                <c:pt idx="707">
                  <c:v>707.5</c:v>
                </c:pt>
                <c:pt idx="708">
                  <c:v>708.5</c:v>
                </c:pt>
                <c:pt idx="709">
                  <c:v>709.5</c:v>
                </c:pt>
                <c:pt idx="710">
                  <c:v>710.5</c:v>
                </c:pt>
                <c:pt idx="711">
                  <c:v>711.5</c:v>
                </c:pt>
                <c:pt idx="712">
                  <c:v>712.5</c:v>
                </c:pt>
                <c:pt idx="713">
                  <c:v>713.5</c:v>
                </c:pt>
                <c:pt idx="714">
                  <c:v>714.5</c:v>
                </c:pt>
                <c:pt idx="715">
                  <c:v>715.5</c:v>
                </c:pt>
                <c:pt idx="716">
                  <c:v>716.5</c:v>
                </c:pt>
                <c:pt idx="717">
                  <c:v>717.5</c:v>
                </c:pt>
                <c:pt idx="718">
                  <c:v>718.5</c:v>
                </c:pt>
                <c:pt idx="719">
                  <c:v>719.5</c:v>
                </c:pt>
                <c:pt idx="720">
                  <c:v>720.5</c:v>
                </c:pt>
                <c:pt idx="721">
                  <c:v>721.5</c:v>
                </c:pt>
                <c:pt idx="722">
                  <c:v>722.5</c:v>
                </c:pt>
                <c:pt idx="723">
                  <c:v>723.5</c:v>
                </c:pt>
                <c:pt idx="724">
                  <c:v>724.5</c:v>
                </c:pt>
                <c:pt idx="725">
                  <c:v>725.5</c:v>
                </c:pt>
                <c:pt idx="726">
                  <c:v>726.5</c:v>
                </c:pt>
                <c:pt idx="727">
                  <c:v>727.5</c:v>
                </c:pt>
                <c:pt idx="728">
                  <c:v>728.5</c:v>
                </c:pt>
                <c:pt idx="729">
                  <c:v>729.5</c:v>
                </c:pt>
                <c:pt idx="730">
                  <c:v>730.5</c:v>
                </c:pt>
                <c:pt idx="731">
                  <c:v>731.5</c:v>
                </c:pt>
                <c:pt idx="732">
                  <c:v>732.5</c:v>
                </c:pt>
                <c:pt idx="733">
                  <c:v>733.5</c:v>
                </c:pt>
                <c:pt idx="734">
                  <c:v>734.5</c:v>
                </c:pt>
                <c:pt idx="735">
                  <c:v>735.5</c:v>
                </c:pt>
                <c:pt idx="736">
                  <c:v>736.5</c:v>
                </c:pt>
                <c:pt idx="737">
                  <c:v>737.5</c:v>
                </c:pt>
                <c:pt idx="738">
                  <c:v>738.5</c:v>
                </c:pt>
                <c:pt idx="739">
                  <c:v>739.5</c:v>
                </c:pt>
                <c:pt idx="740">
                  <c:v>740.5</c:v>
                </c:pt>
                <c:pt idx="741">
                  <c:v>741.5</c:v>
                </c:pt>
                <c:pt idx="742">
                  <c:v>742.5</c:v>
                </c:pt>
                <c:pt idx="743">
                  <c:v>743.5</c:v>
                </c:pt>
                <c:pt idx="744">
                  <c:v>744.5</c:v>
                </c:pt>
                <c:pt idx="745">
                  <c:v>745.5</c:v>
                </c:pt>
                <c:pt idx="746">
                  <c:v>746.5</c:v>
                </c:pt>
                <c:pt idx="747">
                  <c:v>747.5</c:v>
                </c:pt>
                <c:pt idx="748">
                  <c:v>748.5</c:v>
                </c:pt>
                <c:pt idx="749">
                  <c:v>749.5</c:v>
                </c:pt>
                <c:pt idx="750">
                  <c:v>750.5</c:v>
                </c:pt>
                <c:pt idx="751">
                  <c:v>751.5</c:v>
                </c:pt>
                <c:pt idx="752">
                  <c:v>752.5</c:v>
                </c:pt>
                <c:pt idx="753">
                  <c:v>753.5</c:v>
                </c:pt>
                <c:pt idx="754">
                  <c:v>754.5</c:v>
                </c:pt>
                <c:pt idx="755">
                  <c:v>755.5</c:v>
                </c:pt>
                <c:pt idx="756">
                  <c:v>756.5</c:v>
                </c:pt>
                <c:pt idx="757">
                  <c:v>757.5</c:v>
                </c:pt>
                <c:pt idx="758">
                  <c:v>758.5</c:v>
                </c:pt>
                <c:pt idx="759">
                  <c:v>759.5</c:v>
                </c:pt>
                <c:pt idx="760">
                  <c:v>760.5</c:v>
                </c:pt>
                <c:pt idx="761">
                  <c:v>761.5</c:v>
                </c:pt>
                <c:pt idx="762">
                  <c:v>762.5</c:v>
                </c:pt>
                <c:pt idx="763">
                  <c:v>763.5</c:v>
                </c:pt>
                <c:pt idx="764">
                  <c:v>764.5</c:v>
                </c:pt>
                <c:pt idx="765">
                  <c:v>765.5</c:v>
                </c:pt>
                <c:pt idx="766">
                  <c:v>766.5</c:v>
                </c:pt>
                <c:pt idx="767">
                  <c:v>767.5</c:v>
                </c:pt>
                <c:pt idx="768">
                  <c:v>768.5</c:v>
                </c:pt>
                <c:pt idx="769">
                  <c:v>769.5</c:v>
                </c:pt>
                <c:pt idx="770">
                  <c:v>770.5</c:v>
                </c:pt>
                <c:pt idx="771">
                  <c:v>771.5</c:v>
                </c:pt>
                <c:pt idx="772">
                  <c:v>772.5</c:v>
                </c:pt>
                <c:pt idx="773">
                  <c:v>773.5</c:v>
                </c:pt>
                <c:pt idx="774">
                  <c:v>774.5</c:v>
                </c:pt>
                <c:pt idx="775">
                  <c:v>775.5</c:v>
                </c:pt>
                <c:pt idx="776">
                  <c:v>776.5</c:v>
                </c:pt>
                <c:pt idx="777">
                  <c:v>777.5</c:v>
                </c:pt>
                <c:pt idx="778">
                  <c:v>778.5</c:v>
                </c:pt>
                <c:pt idx="779">
                  <c:v>779.5</c:v>
                </c:pt>
                <c:pt idx="780">
                  <c:v>780.5</c:v>
                </c:pt>
                <c:pt idx="781">
                  <c:v>781.5</c:v>
                </c:pt>
                <c:pt idx="782">
                  <c:v>782.5</c:v>
                </c:pt>
                <c:pt idx="783">
                  <c:v>783.5</c:v>
                </c:pt>
                <c:pt idx="784">
                  <c:v>784.5</c:v>
                </c:pt>
                <c:pt idx="785">
                  <c:v>785.5</c:v>
                </c:pt>
                <c:pt idx="786">
                  <c:v>786.5</c:v>
                </c:pt>
                <c:pt idx="787">
                  <c:v>787.5</c:v>
                </c:pt>
                <c:pt idx="788">
                  <c:v>788.5</c:v>
                </c:pt>
                <c:pt idx="789">
                  <c:v>789.5</c:v>
                </c:pt>
                <c:pt idx="790">
                  <c:v>790.5</c:v>
                </c:pt>
                <c:pt idx="791">
                  <c:v>791.5</c:v>
                </c:pt>
                <c:pt idx="792">
                  <c:v>792.5</c:v>
                </c:pt>
                <c:pt idx="793">
                  <c:v>793.5</c:v>
                </c:pt>
                <c:pt idx="794">
                  <c:v>794.5</c:v>
                </c:pt>
                <c:pt idx="795">
                  <c:v>795.5</c:v>
                </c:pt>
                <c:pt idx="796">
                  <c:v>796.5</c:v>
                </c:pt>
                <c:pt idx="797">
                  <c:v>797.5</c:v>
                </c:pt>
                <c:pt idx="798">
                  <c:v>798.5</c:v>
                </c:pt>
                <c:pt idx="799">
                  <c:v>799.5</c:v>
                </c:pt>
                <c:pt idx="800">
                  <c:v>800.5</c:v>
                </c:pt>
                <c:pt idx="801">
                  <c:v>801.5</c:v>
                </c:pt>
                <c:pt idx="802">
                  <c:v>802.5</c:v>
                </c:pt>
                <c:pt idx="803">
                  <c:v>803.5</c:v>
                </c:pt>
                <c:pt idx="804">
                  <c:v>804.5</c:v>
                </c:pt>
                <c:pt idx="805">
                  <c:v>805.5</c:v>
                </c:pt>
                <c:pt idx="806">
                  <c:v>806.5</c:v>
                </c:pt>
                <c:pt idx="807">
                  <c:v>807.5</c:v>
                </c:pt>
                <c:pt idx="808">
                  <c:v>808.5</c:v>
                </c:pt>
                <c:pt idx="809">
                  <c:v>809.5</c:v>
                </c:pt>
                <c:pt idx="810">
                  <c:v>810.5</c:v>
                </c:pt>
                <c:pt idx="811">
                  <c:v>811.5</c:v>
                </c:pt>
                <c:pt idx="812">
                  <c:v>812.5</c:v>
                </c:pt>
                <c:pt idx="813">
                  <c:v>813.5</c:v>
                </c:pt>
                <c:pt idx="814">
                  <c:v>814.5</c:v>
                </c:pt>
                <c:pt idx="815">
                  <c:v>815.5</c:v>
                </c:pt>
                <c:pt idx="816">
                  <c:v>816.5</c:v>
                </c:pt>
                <c:pt idx="817">
                  <c:v>817.5</c:v>
                </c:pt>
                <c:pt idx="818">
                  <c:v>818.5</c:v>
                </c:pt>
                <c:pt idx="819">
                  <c:v>819.5</c:v>
                </c:pt>
                <c:pt idx="820">
                  <c:v>820.5</c:v>
                </c:pt>
                <c:pt idx="821">
                  <c:v>821.5</c:v>
                </c:pt>
                <c:pt idx="822">
                  <c:v>822.5</c:v>
                </c:pt>
                <c:pt idx="823">
                  <c:v>823.5</c:v>
                </c:pt>
                <c:pt idx="824">
                  <c:v>824.5</c:v>
                </c:pt>
                <c:pt idx="825">
                  <c:v>825.5</c:v>
                </c:pt>
                <c:pt idx="826">
                  <c:v>826.5</c:v>
                </c:pt>
                <c:pt idx="827">
                  <c:v>827.5</c:v>
                </c:pt>
                <c:pt idx="828">
                  <c:v>828.5</c:v>
                </c:pt>
                <c:pt idx="829">
                  <c:v>829.5</c:v>
                </c:pt>
                <c:pt idx="830">
                  <c:v>830.5</c:v>
                </c:pt>
                <c:pt idx="831">
                  <c:v>831.5</c:v>
                </c:pt>
                <c:pt idx="832">
                  <c:v>832.5</c:v>
                </c:pt>
                <c:pt idx="833">
                  <c:v>833.5</c:v>
                </c:pt>
                <c:pt idx="834">
                  <c:v>834.5</c:v>
                </c:pt>
                <c:pt idx="835">
                  <c:v>835.5</c:v>
                </c:pt>
                <c:pt idx="836">
                  <c:v>836.5</c:v>
                </c:pt>
                <c:pt idx="837">
                  <c:v>837.5</c:v>
                </c:pt>
                <c:pt idx="838">
                  <c:v>838.5</c:v>
                </c:pt>
                <c:pt idx="839">
                  <c:v>839.5</c:v>
                </c:pt>
                <c:pt idx="840">
                  <c:v>840.5</c:v>
                </c:pt>
                <c:pt idx="841">
                  <c:v>841.5</c:v>
                </c:pt>
                <c:pt idx="842">
                  <c:v>842.5</c:v>
                </c:pt>
                <c:pt idx="843">
                  <c:v>843.5</c:v>
                </c:pt>
                <c:pt idx="844">
                  <c:v>844.5</c:v>
                </c:pt>
                <c:pt idx="845">
                  <c:v>845.5</c:v>
                </c:pt>
                <c:pt idx="846">
                  <c:v>846.5</c:v>
                </c:pt>
                <c:pt idx="847">
                  <c:v>847.5</c:v>
                </c:pt>
                <c:pt idx="848">
                  <c:v>848.5</c:v>
                </c:pt>
                <c:pt idx="849">
                  <c:v>849.5</c:v>
                </c:pt>
                <c:pt idx="850">
                  <c:v>850.5</c:v>
                </c:pt>
                <c:pt idx="851">
                  <c:v>851.5</c:v>
                </c:pt>
                <c:pt idx="852">
                  <c:v>852.5</c:v>
                </c:pt>
                <c:pt idx="853">
                  <c:v>853.5</c:v>
                </c:pt>
                <c:pt idx="854">
                  <c:v>854.5</c:v>
                </c:pt>
                <c:pt idx="855">
                  <c:v>855.5</c:v>
                </c:pt>
                <c:pt idx="856">
                  <c:v>856.5</c:v>
                </c:pt>
                <c:pt idx="857">
                  <c:v>857.5</c:v>
                </c:pt>
                <c:pt idx="858">
                  <c:v>858.5</c:v>
                </c:pt>
                <c:pt idx="859">
                  <c:v>859.5</c:v>
                </c:pt>
                <c:pt idx="860">
                  <c:v>860.5</c:v>
                </c:pt>
                <c:pt idx="861">
                  <c:v>861.5</c:v>
                </c:pt>
                <c:pt idx="862">
                  <c:v>862.5</c:v>
                </c:pt>
                <c:pt idx="863">
                  <c:v>863.5</c:v>
                </c:pt>
                <c:pt idx="864">
                  <c:v>864.5</c:v>
                </c:pt>
                <c:pt idx="865">
                  <c:v>865.5</c:v>
                </c:pt>
                <c:pt idx="866">
                  <c:v>866.5</c:v>
                </c:pt>
                <c:pt idx="867">
                  <c:v>867.5</c:v>
                </c:pt>
                <c:pt idx="868">
                  <c:v>868.5</c:v>
                </c:pt>
                <c:pt idx="869">
                  <c:v>869.5</c:v>
                </c:pt>
                <c:pt idx="870">
                  <c:v>870.5</c:v>
                </c:pt>
                <c:pt idx="871">
                  <c:v>871.5</c:v>
                </c:pt>
                <c:pt idx="872">
                  <c:v>872.5</c:v>
                </c:pt>
                <c:pt idx="873">
                  <c:v>873.5</c:v>
                </c:pt>
                <c:pt idx="874">
                  <c:v>874.5</c:v>
                </c:pt>
                <c:pt idx="875">
                  <c:v>875.5</c:v>
                </c:pt>
                <c:pt idx="876">
                  <c:v>876.5</c:v>
                </c:pt>
                <c:pt idx="877">
                  <c:v>877.5</c:v>
                </c:pt>
                <c:pt idx="878">
                  <c:v>878.5</c:v>
                </c:pt>
                <c:pt idx="879">
                  <c:v>879.5</c:v>
                </c:pt>
                <c:pt idx="880">
                  <c:v>880.5</c:v>
                </c:pt>
                <c:pt idx="881">
                  <c:v>881.5</c:v>
                </c:pt>
                <c:pt idx="882">
                  <c:v>882.5</c:v>
                </c:pt>
                <c:pt idx="883">
                  <c:v>883.5</c:v>
                </c:pt>
                <c:pt idx="884">
                  <c:v>884.5</c:v>
                </c:pt>
                <c:pt idx="885">
                  <c:v>885.5</c:v>
                </c:pt>
                <c:pt idx="886">
                  <c:v>886.5</c:v>
                </c:pt>
                <c:pt idx="887">
                  <c:v>887.5</c:v>
                </c:pt>
                <c:pt idx="888">
                  <c:v>888.5</c:v>
                </c:pt>
                <c:pt idx="889">
                  <c:v>889.5</c:v>
                </c:pt>
                <c:pt idx="890">
                  <c:v>890.5</c:v>
                </c:pt>
                <c:pt idx="891">
                  <c:v>891.5</c:v>
                </c:pt>
                <c:pt idx="892">
                  <c:v>892.5</c:v>
                </c:pt>
                <c:pt idx="893">
                  <c:v>893.5</c:v>
                </c:pt>
                <c:pt idx="894">
                  <c:v>894.5</c:v>
                </c:pt>
                <c:pt idx="895">
                  <c:v>895.5</c:v>
                </c:pt>
                <c:pt idx="896">
                  <c:v>896.5</c:v>
                </c:pt>
                <c:pt idx="897">
                  <c:v>897.5</c:v>
                </c:pt>
                <c:pt idx="898">
                  <c:v>898.5</c:v>
                </c:pt>
                <c:pt idx="899">
                  <c:v>899.5</c:v>
                </c:pt>
                <c:pt idx="900">
                  <c:v>900.5</c:v>
                </c:pt>
                <c:pt idx="901">
                  <c:v>901.5</c:v>
                </c:pt>
                <c:pt idx="902">
                  <c:v>902.5</c:v>
                </c:pt>
                <c:pt idx="903">
                  <c:v>903.5</c:v>
                </c:pt>
                <c:pt idx="904">
                  <c:v>904.5</c:v>
                </c:pt>
                <c:pt idx="905">
                  <c:v>905.5</c:v>
                </c:pt>
                <c:pt idx="906">
                  <c:v>906.5</c:v>
                </c:pt>
                <c:pt idx="907">
                  <c:v>907.5</c:v>
                </c:pt>
                <c:pt idx="908">
                  <c:v>908.5</c:v>
                </c:pt>
                <c:pt idx="909">
                  <c:v>909.5</c:v>
                </c:pt>
                <c:pt idx="910">
                  <c:v>910.5</c:v>
                </c:pt>
                <c:pt idx="911">
                  <c:v>911.5</c:v>
                </c:pt>
                <c:pt idx="912">
                  <c:v>912.5</c:v>
                </c:pt>
                <c:pt idx="913">
                  <c:v>913.5</c:v>
                </c:pt>
                <c:pt idx="914">
                  <c:v>914.5</c:v>
                </c:pt>
                <c:pt idx="915">
                  <c:v>915.5</c:v>
                </c:pt>
                <c:pt idx="916">
                  <c:v>916.5</c:v>
                </c:pt>
                <c:pt idx="917">
                  <c:v>917.5</c:v>
                </c:pt>
                <c:pt idx="918">
                  <c:v>918.5</c:v>
                </c:pt>
                <c:pt idx="919">
                  <c:v>919.5</c:v>
                </c:pt>
                <c:pt idx="920">
                  <c:v>920.5</c:v>
                </c:pt>
                <c:pt idx="921">
                  <c:v>921.5</c:v>
                </c:pt>
                <c:pt idx="922">
                  <c:v>922.5</c:v>
                </c:pt>
                <c:pt idx="923">
                  <c:v>923.5</c:v>
                </c:pt>
                <c:pt idx="924">
                  <c:v>924.5</c:v>
                </c:pt>
                <c:pt idx="925">
                  <c:v>925.5</c:v>
                </c:pt>
                <c:pt idx="926">
                  <c:v>926.5</c:v>
                </c:pt>
                <c:pt idx="927">
                  <c:v>927.5</c:v>
                </c:pt>
                <c:pt idx="928">
                  <c:v>928.5</c:v>
                </c:pt>
                <c:pt idx="929">
                  <c:v>929.5</c:v>
                </c:pt>
                <c:pt idx="930">
                  <c:v>930.5</c:v>
                </c:pt>
                <c:pt idx="931">
                  <c:v>931.5</c:v>
                </c:pt>
                <c:pt idx="932">
                  <c:v>932.5</c:v>
                </c:pt>
                <c:pt idx="933">
                  <c:v>933.5</c:v>
                </c:pt>
                <c:pt idx="934">
                  <c:v>934.5</c:v>
                </c:pt>
                <c:pt idx="935">
                  <c:v>935.5</c:v>
                </c:pt>
                <c:pt idx="936">
                  <c:v>936.5</c:v>
                </c:pt>
                <c:pt idx="937">
                  <c:v>937.5</c:v>
                </c:pt>
                <c:pt idx="938">
                  <c:v>938.5</c:v>
                </c:pt>
                <c:pt idx="939">
                  <c:v>939.5</c:v>
                </c:pt>
                <c:pt idx="940">
                  <c:v>940.5</c:v>
                </c:pt>
                <c:pt idx="941">
                  <c:v>941.5</c:v>
                </c:pt>
                <c:pt idx="942">
                  <c:v>942.5</c:v>
                </c:pt>
                <c:pt idx="943">
                  <c:v>943.5</c:v>
                </c:pt>
                <c:pt idx="944">
                  <c:v>944.5</c:v>
                </c:pt>
                <c:pt idx="945">
                  <c:v>945.5</c:v>
                </c:pt>
                <c:pt idx="946">
                  <c:v>946.5</c:v>
                </c:pt>
                <c:pt idx="947">
                  <c:v>947.5</c:v>
                </c:pt>
                <c:pt idx="948">
                  <c:v>948.5</c:v>
                </c:pt>
                <c:pt idx="949">
                  <c:v>949.5</c:v>
                </c:pt>
                <c:pt idx="950">
                  <c:v>950.5</c:v>
                </c:pt>
                <c:pt idx="951">
                  <c:v>951.5</c:v>
                </c:pt>
                <c:pt idx="952">
                  <c:v>952.5</c:v>
                </c:pt>
                <c:pt idx="953">
                  <c:v>953.5</c:v>
                </c:pt>
                <c:pt idx="954">
                  <c:v>954.5</c:v>
                </c:pt>
                <c:pt idx="955">
                  <c:v>955.5</c:v>
                </c:pt>
                <c:pt idx="956">
                  <c:v>956.5</c:v>
                </c:pt>
                <c:pt idx="957">
                  <c:v>957.5</c:v>
                </c:pt>
                <c:pt idx="958">
                  <c:v>958.5</c:v>
                </c:pt>
                <c:pt idx="959">
                  <c:v>959.5</c:v>
                </c:pt>
                <c:pt idx="960">
                  <c:v>960.5</c:v>
                </c:pt>
                <c:pt idx="961">
                  <c:v>961.5</c:v>
                </c:pt>
                <c:pt idx="962">
                  <c:v>962.5</c:v>
                </c:pt>
                <c:pt idx="963">
                  <c:v>963.5</c:v>
                </c:pt>
                <c:pt idx="964">
                  <c:v>964.5</c:v>
                </c:pt>
                <c:pt idx="965">
                  <c:v>965.5</c:v>
                </c:pt>
                <c:pt idx="966">
                  <c:v>966.5</c:v>
                </c:pt>
                <c:pt idx="967">
                  <c:v>967.5</c:v>
                </c:pt>
                <c:pt idx="968">
                  <c:v>968.5</c:v>
                </c:pt>
                <c:pt idx="969">
                  <c:v>969.5</c:v>
                </c:pt>
                <c:pt idx="970">
                  <c:v>970.5</c:v>
                </c:pt>
                <c:pt idx="971">
                  <c:v>971.5</c:v>
                </c:pt>
                <c:pt idx="972">
                  <c:v>972.5</c:v>
                </c:pt>
                <c:pt idx="973">
                  <c:v>973.5</c:v>
                </c:pt>
                <c:pt idx="974">
                  <c:v>974.5</c:v>
                </c:pt>
                <c:pt idx="975">
                  <c:v>975.5</c:v>
                </c:pt>
                <c:pt idx="976">
                  <c:v>976.5</c:v>
                </c:pt>
                <c:pt idx="977">
                  <c:v>977.5</c:v>
                </c:pt>
                <c:pt idx="978">
                  <c:v>978.5</c:v>
                </c:pt>
                <c:pt idx="979">
                  <c:v>979.5</c:v>
                </c:pt>
                <c:pt idx="980">
                  <c:v>980.5</c:v>
                </c:pt>
                <c:pt idx="981">
                  <c:v>981.5</c:v>
                </c:pt>
                <c:pt idx="982">
                  <c:v>982.5</c:v>
                </c:pt>
                <c:pt idx="983">
                  <c:v>983.5</c:v>
                </c:pt>
                <c:pt idx="984">
                  <c:v>984.5</c:v>
                </c:pt>
                <c:pt idx="985">
                  <c:v>985.5</c:v>
                </c:pt>
                <c:pt idx="986">
                  <c:v>986.5</c:v>
                </c:pt>
                <c:pt idx="987">
                  <c:v>987.5</c:v>
                </c:pt>
                <c:pt idx="988">
                  <c:v>988.5</c:v>
                </c:pt>
                <c:pt idx="989">
                  <c:v>989.5</c:v>
                </c:pt>
                <c:pt idx="990">
                  <c:v>990.5</c:v>
                </c:pt>
                <c:pt idx="991">
                  <c:v>991.5</c:v>
                </c:pt>
                <c:pt idx="992">
                  <c:v>992.5</c:v>
                </c:pt>
                <c:pt idx="993">
                  <c:v>993.5</c:v>
                </c:pt>
                <c:pt idx="994">
                  <c:v>994.5</c:v>
                </c:pt>
                <c:pt idx="995">
                  <c:v>995.5</c:v>
                </c:pt>
                <c:pt idx="996">
                  <c:v>996.5</c:v>
                </c:pt>
                <c:pt idx="997">
                  <c:v>997.5</c:v>
                </c:pt>
                <c:pt idx="998">
                  <c:v>998.5</c:v>
                </c:pt>
                <c:pt idx="999">
                  <c:v>999.5</c:v>
                </c:pt>
              </c:numCache>
            </c:numRef>
          </c:xVal>
          <c:yVal>
            <c:numRef>
              <c:f>'[データまとめ (自動保存済み).xlsx]Ctrl粒子数'!$F$3:$F$1002</c:f>
              <c:numCache>
                <c:formatCode>General</c:formatCode>
                <c:ptCount val="100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3.3333333333333331E-12</c:v>
                </c:pt>
                <c:pt idx="10">
                  <c:v>2.6666666666666665E-11</c:v>
                </c:pt>
                <c:pt idx="11">
                  <c:v>2.1666666666666664E-10</c:v>
                </c:pt>
                <c:pt idx="12">
                  <c:v>2.4100000000000002E-9</c:v>
                </c:pt>
                <c:pt idx="13">
                  <c:v>2.2869999999999999E-8</c:v>
                </c:pt>
                <c:pt idx="14">
                  <c:v>1.5499000000000001E-7</c:v>
                </c:pt>
                <c:pt idx="15">
                  <c:v>7.5422666666666668E-7</c:v>
                </c:pt>
                <c:pt idx="16">
                  <c:v>2.8214833333333333E-6</c:v>
                </c:pt>
                <c:pt idx="17">
                  <c:v>1.263349E-5</c:v>
                </c:pt>
                <c:pt idx="18">
                  <c:v>1.0940118666666667E-4</c:v>
                </c:pt>
                <c:pt idx="19">
                  <c:v>5.8607762333333336E-4</c:v>
                </c:pt>
                <c:pt idx="20">
                  <c:v>1.1647060833333335E-3</c:v>
                </c:pt>
                <c:pt idx="21">
                  <c:v>8.9199226999999988E-4</c:v>
                </c:pt>
                <c:pt idx="22">
                  <c:v>3.3680308666666668E-4</c:v>
                </c:pt>
                <c:pt idx="23">
                  <c:v>1.2242543999999998E-4</c:v>
                </c:pt>
                <c:pt idx="24">
                  <c:v>8.1521119999999989E-5</c:v>
                </c:pt>
                <c:pt idx="25">
                  <c:v>6.8984800000000004E-5</c:v>
                </c:pt>
                <c:pt idx="26">
                  <c:v>5.7889036666666672E-5</c:v>
                </c:pt>
                <c:pt idx="27">
                  <c:v>4.8127006666666664E-5</c:v>
                </c:pt>
                <c:pt idx="28">
                  <c:v>4.3366663333333335E-5</c:v>
                </c:pt>
                <c:pt idx="29">
                  <c:v>4.8807033333333329E-5</c:v>
                </c:pt>
                <c:pt idx="30">
                  <c:v>6.6681033333333334E-5</c:v>
                </c:pt>
                <c:pt idx="31">
                  <c:v>9.1981869999999992E-5</c:v>
                </c:pt>
                <c:pt idx="32">
                  <c:v>1.2411344666666665E-4</c:v>
                </c:pt>
                <c:pt idx="33">
                  <c:v>2.2458981666666664E-4</c:v>
                </c:pt>
                <c:pt idx="34">
                  <c:v>7.1478049000000003E-4</c:v>
                </c:pt>
                <c:pt idx="35">
                  <c:v>2.1602634833333334E-3</c:v>
                </c:pt>
                <c:pt idx="36">
                  <c:v>4.0862807700000007E-3</c:v>
                </c:pt>
                <c:pt idx="37">
                  <c:v>4.7800928933333332E-3</c:v>
                </c:pt>
                <c:pt idx="38">
                  <c:v>4.0179753799999994E-3</c:v>
                </c:pt>
                <c:pt idx="39">
                  <c:v>3.0995126566666668E-3</c:v>
                </c:pt>
                <c:pt idx="40">
                  <c:v>2.7607100499999998E-3</c:v>
                </c:pt>
                <c:pt idx="41">
                  <c:v>2.8684203966666665E-3</c:v>
                </c:pt>
                <c:pt idx="42">
                  <c:v>3.0118623433333333E-3</c:v>
                </c:pt>
                <c:pt idx="43">
                  <c:v>2.9357006466666667E-3</c:v>
                </c:pt>
                <c:pt idx="44">
                  <c:v>2.7054321199999998E-3</c:v>
                </c:pt>
                <c:pt idx="45">
                  <c:v>2.5571252933333333E-3</c:v>
                </c:pt>
                <c:pt idx="46">
                  <c:v>2.7010617633333334E-3</c:v>
                </c:pt>
                <c:pt idx="47">
                  <c:v>3.3612508166666662E-3</c:v>
                </c:pt>
                <c:pt idx="48">
                  <c:v>4.8700644833333338E-3</c:v>
                </c:pt>
                <c:pt idx="49">
                  <c:v>7.4317327900000002E-3</c:v>
                </c:pt>
                <c:pt idx="50">
                  <c:v>1.061030525E-2</c:v>
                </c:pt>
                <c:pt idx="51">
                  <c:v>1.3301503250000001E-2</c:v>
                </c:pt>
                <c:pt idx="52">
                  <c:v>1.4645911069999998E-2</c:v>
                </c:pt>
                <c:pt idx="53">
                  <c:v>1.4967980176666668E-2</c:v>
                </c:pt>
                <c:pt idx="54">
                  <c:v>1.5598503516666666E-2</c:v>
                </c:pt>
                <c:pt idx="55">
                  <c:v>1.7892342830000001E-2</c:v>
                </c:pt>
                <c:pt idx="56">
                  <c:v>2.2538310830000002E-2</c:v>
                </c:pt>
                <c:pt idx="57">
                  <c:v>2.9563323486666668E-2</c:v>
                </c:pt>
                <c:pt idx="58">
                  <c:v>3.8701708223333332E-2</c:v>
                </c:pt>
                <c:pt idx="59">
                  <c:v>4.9738389760000001E-2</c:v>
                </c:pt>
                <c:pt idx="60">
                  <c:v>6.2667431300000007E-2</c:v>
                </c:pt>
                <c:pt idx="61">
                  <c:v>7.7704221023333339E-2</c:v>
                </c:pt>
                <c:pt idx="62">
                  <c:v>9.5243853536666673E-2</c:v>
                </c:pt>
                <c:pt idx="63">
                  <c:v>0.11580852630999999</c:v>
                </c:pt>
                <c:pt idx="64">
                  <c:v>0.14000294949666667</c:v>
                </c:pt>
                <c:pt idx="65">
                  <c:v>0.16853499341666667</c:v>
                </c:pt>
                <c:pt idx="66">
                  <c:v>0.20235205145333332</c:v>
                </c:pt>
                <c:pt idx="67">
                  <c:v>0.24281268489999999</c:v>
                </c:pt>
                <c:pt idx="68">
                  <c:v>0.29165988628666667</c:v>
                </c:pt>
                <c:pt idx="69">
                  <c:v>0.35057997470000002</c:v>
                </c:pt>
                <c:pt idx="70">
                  <c:v>0.42035355457666668</c:v>
                </c:pt>
                <c:pt idx="71">
                  <c:v>0.4998855184533334</c:v>
                </c:pt>
                <c:pt idx="72">
                  <c:v>0.58563689508333328</c:v>
                </c:pt>
                <c:pt idx="73">
                  <c:v>0.67205101693666669</c:v>
                </c:pt>
                <c:pt idx="74">
                  <c:v>0.75315622728666665</c:v>
                </c:pt>
                <c:pt idx="75">
                  <c:v>0.82462698973333326</c:v>
                </c:pt>
                <c:pt idx="76">
                  <c:v>0.88498704502999992</c:v>
                </c:pt>
                <c:pt idx="77">
                  <c:v>0.93514975210333329</c:v>
                </c:pt>
                <c:pt idx="78">
                  <c:v>0.9767709058766666</c:v>
                </c:pt>
                <c:pt idx="79">
                  <c:v>1.01070920543</c:v>
                </c:pt>
                <c:pt idx="80">
                  <c:v>1.0365347264933333</c:v>
                </c:pt>
                <c:pt idx="81">
                  <c:v>1.0530376571933333</c:v>
                </c:pt>
                <c:pt idx="82">
                  <c:v>1.0590784542833334</c:v>
                </c:pt>
                <c:pt idx="83">
                  <c:v>1.05421452381</c:v>
                </c:pt>
                <c:pt idx="84">
                  <c:v>1.0389319233700001</c:v>
                </c:pt>
                <c:pt idx="85">
                  <c:v>1.0145765948799998</c:v>
                </c:pt>
                <c:pt idx="86">
                  <c:v>0.98313148262999994</c:v>
                </c:pt>
                <c:pt idx="87">
                  <c:v>0.94693308894666672</c:v>
                </c:pt>
                <c:pt idx="88">
                  <c:v>0.90836795196666664</c:v>
                </c:pt>
                <c:pt idx="89">
                  <c:v>0.86957514779333323</c:v>
                </c:pt>
                <c:pt idx="90">
                  <c:v>0.83219701640999999</c:v>
                </c:pt>
                <c:pt idx="91">
                  <c:v>0.79723648086999999</c:v>
                </c:pt>
                <c:pt idx="92">
                  <c:v>0.76506448776000002</c:v>
                </c:pt>
                <c:pt idx="93">
                  <c:v>0.73556862655999999</c:v>
                </c:pt>
                <c:pt idx="94">
                  <c:v>0.70837473753333335</c:v>
                </c:pt>
                <c:pt idx="95">
                  <c:v>0.68305246218999993</c:v>
                </c:pt>
                <c:pt idx="96">
                  <c:v>0.65924800756666668</c:v>
                </c:pt>
                <c:pt idx="97">
                  <c:v>0.63674208608666671</c:v>
                </c:pt>
                <c:pt idx="98">
                  <c:v>0.61546448773999995</c:v>
                </c:pt>
                <c:pt idx="99">
                  <c:v>0.59549157806999997</c:v>
                </c:pt>
                <c:pt idx="100">
                  <c:v>0.57702328443666673</c:v>
                </c:pt>
                <c:pt idx="101">
                  <c:v>0.56031094691000005</c:v>
                </c:pt>
                <c:pt idx="102">
                  <c:v>0.54551842539999995</c:v>
                </c:pt>
                <c:pt idx="103">
                  <c:v>0.53256134781999998</c:v>
                </c:pt>
                <c:pt idx="104">
                  <c:v>0.52104124410666663</c:v>
                </c:pt>
                <c:pt idx="105">
                  <c:v>0.51037197763666664</c:v>
                </c:pt>
                <c:pt idx="106">
                  <c:v>0.50004524723333332</c:v>
                </c:pt>
                <c:pt idx="107">
                  <c:v>0.48983657741000003</c:v>
                </c:pt>
                <c:pt idx="108">
                  <c:v>0.47979700437333334</c:v>
                </c:pt>
                <c:pt idx="109">
                  <c:v>0.47007720006000003</c:v>
                </c:pt>
                <c:pt idx="110">
                  <c:v>0.46076320386000003</c:v>
                </c:pt>
                <c:pt idx="111">
                  <c:v>0.45184341070333339</c:v>
                </c:pt>
                <c:pt idx="112">
                  <c:v>0.44328196665666664</c:v>
                </c:pt>
                <c:pt idx="113">
                  <c:v>0.43509988630666668</c:v>
                </c:pt>
                <c:pt idx="114">
                  <c:v>0.42739460673666668</c:v>
                </c:pt>
                <c:pt idx="115">
                  <c:v>0.42029569253999999</c:v>
                </c:pt>
                <c:pt idx="116">
                  <c:v>0.41389666108666667</c:v>
                </c:pt>
                <c:pt idx="117">
                  <c:v>0.40820513779333334</c:v>
                </c:pt>
                <c:pt idx="118">
                  <c:v>0.40313212796333331</c:v>
                </c:pt>
                <c:pt idx="119">
                  <c:v>0.3985173115466667</c:v>
                </c:pt>
                <c:pt idx="120">
                  <c:v>0.39417289415333334</c:v>
                </c:pt>
                <c:pt idx="121">
                  <c:v>0.38992533112333333</c:v>
                </c:pt>
                <c:pt idx="122">
                  <c:v>0.38563863884333333</c:v>
                </c:pt>
                <c:pt idx="123">
                  <c:v>0.38121112638666665</c:v>
                </c:pt>
                <c:pt idx="124">
                  <c:v>0.37654669209666669</c:v>
                </c:pt>
                <c:pt idx="125">
                  <c:v>0.37151070269333336</c:v>
                </c:pt>
                <c:pt idx="126">
                  <c:v>0.36588742033999999</c:v>
                </c:pt>
                <c:pt idx="127">
                  <c:v>0.35935932462333331</c:v>
                </c:pt>
                <c:pt idx="128">
                  <c:v>0.35152662666333334</c:v>
                </c:pt>
                <c:pt idx="129">
                  <c:v>0.34197607861666662</c:v>
                </c:pt>
                <c:pt idx="130">
                  <c:v>0.3303917196133333</c:v>
                </c:pt>
                <c:pt idx="131">
                  <c:v>0.31668016356333334</c:v>
                </c:pt>
                <c:pt idx="132">
                  <c:v>0.30106789913999998</c:v>
                </c:pt>
                <c:pt idx="133">
                  <c:v>0.28412810681666667</c:v>
                </c:pt>
                <c:pt idx="134">
                  <c:v>0.26671483700666665</c:v>
                </c:pt>
                <c:pt idx="135">
                  <c:v>0.24981680382333332</c:v>
                </c:pt>
                <c:pt idx="136">
                  <c:v>0.23437490167666669</c:v>
                </c:pt>
                <c:pt idx="137">
                  <c:v>0.22111968060999998</c:v>
                </c:pt>
                <c:pt idx="138">
                  <c:v>0.21047165922666666</c:v>
                </c:pt>
                <c:pt idx="139">
                  <c:v>0.20251815898333334</c:v>
                </c:pt>
                <c:pt idx="140">
                  <c:v>0.19705284192333333</c:v>
                </c:pt>
                <c:pt idx="141">
                  <c:v>0.19365128395333334</c:v>
                </c:pt>
                <c:pt idx="142">
                  <c:v>0.19175880232</c:v>
                </c:pt>
                <c:pt idx="143">
                  <c:v>0.19077684170333334</c:v>
                </c:pt>
                <c:pt idx="144">
                  <c:v>0.19014154222333335</c:v>
                </c:pt>
                <c:pt idx="145">
                  <c:v>0.18938854713</c:v>
                </c:pt>
                <c:pt idx="146">
                  <c:v>0.18819516326333335</c:v>
                </c:pt>
                <c:pt idx="147">
                  <c:v>0.18639162964333333</c:v>
                </c:pt>
                <c:pt idx="148">
                  <c:v>0.18394108149000002</c:v>
                </c:pt>
                <c:pt idx="149">
                  <c:v>0.18089902109</c:v>
                </c:pt>
                <c:pt idx="150">
                  <c:v>0.17736935993</c:v>
                </c:pt>
                <c:pt idx="151">
                  <c:v>0.17347031458333331</c:v>
                </c:pt>
                <c:pt idx="152">
                  <c:v>0.16931317504333335</c:v>
                </c:pt>
                <c:pt idx="153">
                  <c:v>0.16498914718333332</c:v>
                </c:pt>
                <c:pt idx="154">
                  <c:v>0.16055964697333333</c:v>
                </c:pt>
                <c:pt idx="155">
                  <c:v>0.15605085967999999</c:v>
                </c:pt>
                <c:pt idx="156">
                  <c:v>0.15145690523666666</c:v>
                </c:pt>
                <c:pt idx="157">
                  <c:v>0.14675359675666666</c:v>
                </c:pt>
                <c:pt idx="158">
                  <c:v>0.14191891402333334</c:v>
                </c:pt>
                <c:pt idx="159">
                  <c:v>0.13695221012666667</c:v>
                </c:pt>
                <c:pt idx="160">
                  <c:v>0.13188485314333334</c:v>
                </c:pt>
                <c:pt idx="161">
                  <c:v>0.12677943494000002</c:v>
                </c:pt>
                <c:pt idx="162">
                  <c:v>0.12171965374666667</c:v>
                </c:pt>
                <c:pt idx="163">
                  <c:v>0.11679590597333334</c:v>
                </c:pt>
                <c:pt idx="164">
                  <c:v>0.11209179839333334</c:v>
                </c:pt>
                <c:pt idx="165">
                  <c:v>0.10767502874666667</c:v>
                </c:pt>
                <c:pt idx="166">
                  <c:v>0.10359370918333334</c:v>
                </c:pt>
                <c:pt idx="167">
                  <c:v>9.9877285779999991E-2</c:v>
                </c:pt>
                <c:pt idx="168">
                  <c:v>9.6540224940000002E-2</c:v>
                </c:pt>
                <c:pt idx="169">
                  <c:v>9.358655883E-2</c:v>
                </c:pt>
                <c:pt idx="170">
                  <c:v>9.1013872693333331E-2</c:v>
                </c:pt>
                <c:pt idx="171">
                  <c:v>8.8815992240000002E-2</c:v>
                </c:pt>
                <c:pt idx="172">
                  <c:v>8.6984215426666664E-2</c:v>
                </c:pt>
                <c:pt idx="173">
                  <c:v>8.5507320533333334E-2</c:v>
                </c:pt>
                <c:pt idx="174">
                  <c:v>8.4370780629999989E-2</c:v>
                </c:pt>
                <c:pt idx="175">
                  <c:v>8.3555676693333331E-2</c:v>
                </c:pt>
                <c:pt idx="176">
                  <c:v>8.3037773383333333E-2</c:v>
                </c:pt>
                <c:pt idx="177">
                  <c:v>8.2787121626666668E-2</c:v>
                </c:pt>
                <c:pt idx="178">
                  <c:v>8.2768394179999996E-2</c:v>
                </c:pt>
                <c:pt idx="179">
                  <c:v>8.2941967419999998E-2</c:v>
                </c:pt>
                <c:pt idx="180">
                  <c:v>8.3265574740000001E-2</c:v>
                </c:pt>
                <c:pt idx="181">
                  <c:v>8.3696220746666675E-2</c:v>
                </c:pt>
                <c:pt idx="182">
                  <c:v>8.419199695E-2</c:v>
                </c:pt>
                <c:pt idx="183">
                  <c:v>8.4713489273333331E-2</c:v>
                </c:pt>
                <c:pt idx="184">
                  <c:v>8.5224598153333331E-2</c:v>
                </c:pt>
                <c:pt idx="185">
                  <c:v>8.5692761556666677E-2</c:v>
                </c:pt>
                <c:pt idx="186">
                  <c:v>8.6088730216666659E-2</c:v>
                </c:pt>
                <c:pt idx="187">
                  <c:v>8.6386140816666665E-2</c:v>
                </c:pt>
                <c:pt idx="188">
                  <c:v>8.6561142699999996E-2</c:v>
                </c:pt>
                <c:pt idx="189">
                  <c:v>8.6592248796666674E-2</c:v>
                </c:pt>
                <c:pt idx="190">
                  <c:v>8.6460437656666667E-2</c:v>
                </c:pt>
                <c:pt idx="191">
                  <c:v>8.6149383499999996E-2</c:v>
                </c:pt>
                <c:pt idx="192">
                  <c:v>8.5645602429999995E-2</c:v>
                </c:pt>
                <c:pt idx="193">
                  <c:v>8.4938322639999994E-2</c:v>
                </c:pt>
                <c:pt idx="194">
                  <c:v>8.4019024693333333E-2</c:v>
                </c:pt>
                <c:pt idx="195">
                  <c:v>8.2880809173333334E-2</c:v>
                </c:pt>
                <c:pt idx="196">
                  <c:v>8.1517944046666665E-2</c:v>
                </c:pt>
                <c:pt idx="197">
                  <c:v>7.9926023320000011E-2</c:v>
                </c:pt>
                <c:pt idx="198">
                  <c:v>7.8103059170000003E-2</c:v>
                </c:pt>
                <c:pt idx="199">
                  <c:v>7.6051533560000009E-2</c:v>
                </c:pt>
                <c:pt idx="200">
                  <c:v>7.378103272E-2</c:v>
                </c:pt>
                <c:pt idx="201">
                  <c:v>7.1310724036666662E-2</c:v>
                </c:pt>
                <c:pt idx="202">
                  <c:v>6.867076342999999E-2</c:v>
                </c:pt>
                <c:pt idx="203">
                  <c:v>6.5901842736666674E-2</c:v>
                </c:pt>
                <c:pt idx="204">
                  <c:v>6.3052503043333333E-2</c:v>
                </c:pt>
                <c:pt idx="205">
                  <c:v>6.0174441020000004E-2</c:v>
                </c:pt>
                <c:pt idx="206">
                  <c:v>5.7316635529999993E-2</c:v>
                </c:pt>
                <c:pt idx="207">
                  <c:v>5.4519526076666665E-2</c:v>
                </c:pt>
                <c:pt idx="208">
                  <c:v>5.1810545829999999E-2</c:v>
                </c:pt>
                <c:pt idx="209">
                  <c:v>4.9202026000000003E-2</c:v>
                </c:pt>
                <c:pt idx="210">
                  <c:v>4.6691933389999996E-2</c:v>
                </c:pt>
                <c:pt idx="211">
                  <c:v>4.4267246493333336E-2</c:v>
                </c:pt>
                <c:pt idx="212">
                  <c:v>4.1909204743333331E-2</c:v>
                </c:pt>
                <c:pt idx="213">
                  <c:v>3.9599320889999998E-2</c:v>
                </c:pt>
                <c:pt idx="214">
                  <c:v>3.7324990576666668E-2</c:v>
                </c:pt>
                <c:pt idx="215">
                  <c:v>3.5083738156666669E-2</c:v>
                </c:pt>
                <c:pt idx="216">
                  <c:v>3.2885513533333334E-2</c:v>
                </c:pt>
                <c:pt idx="217">
                  <c:v>3.075288185E-2</c:v>
                </c:pt>
                <c:pt idx="218">
                  <c:v>2.8719318463333334E-2</c:v>
                </c:pt>
                <c:pt idx="219">
                  <c:v>2.6826066833333335E-2</c:v>
                </c:pt>
                <c:pt idx="220">
                  <c:v>2.511811286E-2</c:v>
                </c:pt>
                <c:pt idx="221">
                  <c:v>2.3639799303333334E-2</c:v>
                </c:pt>
                <c:pt idx="222">
                  <c:v>2.2430500476666667E-2</c:v>
                </c:pt>
                <c:pt idx="223">
                  <c:v>2.1520659406666667E-2</c:v>
                </c:pt>
                <c:pt idx="224">
                  <c:v>2.0928410416666664E-2</c:v>
                </c:pt>
                <c:pt idx="225">
                  <c:v>2.0656991756666666E-2</c:v>
                </c:pt>
                <c:pt idx="226">
                  <c:v>2.0693185240000002E-2</c:v>
                </c:pt>
                <c:pt idx="227">
                  <c:v>2.1007061646666665E-2</c:v>
                </c:pt>
                <c:pt idx="228">
                  <c:v>2.1553301109999999E-2</c:v>
                </c:pt>
                <c:pt idx="229">
                  <c:v>2.2274244209999999E-2</c:v>
                </c:pt>
                <c:pt idx="230">
                  <c:v>2.310459573E-2</c:v>
                </c:pt>
                <c:pt idx="231">
                  <c:v>2.3977380976666667E-2</c:v>
                </c:pt>
                <c:pt idx="232">
                  <c:v>2.4830435906666667E-2</c:v>
                </c:pt>
                <c:pt idx="233">
                  <c:v>2.5612515483333334E-2</c:v>
                </c:pt>
                <c:pt idx="234">
                  <c:v>2.6288124026666668E-2</c:v>
                </c:pt>
                <c:pt idx="235">
                  <c:v>2.6840415673333333E-2</c:v>
                </c:pt>
                <c:pt idx="236">
                  <c:v>2.7271828306666666E-2</c:v>
                </c:pt>
                <c:pt idx="237">
                  <c:v>2.7602219560000002E-2</c:v>
                </c:pt>
                <c:pt idx="238">
                  <c:v>2.7863966546666664E-2</c:v>
                </c:pt>
                <c:pt idx="239">
                  <c:v>2.8093097673333334E-2</c:v>
                </c:pt>
                <c:pt idx="240">
                  <c:v>2.831614171666667E-2</c:v>
                </c:pt>
                <c:pt idx="241">
                  <c:v>2.853512376666667E-2</c:v>
                </c:pt>
                <c:pt idx="242">
                  <c:v>2.8717229546666664E-2</c:v>
                </c:pt>
                <c:pt idx="243">
                  <c:v>2.8797304513333333E-2</c:v>
                </c:pt>
                <c:pt idx="244">
                  <c:v>2.8696393946666662E-2</c:v>
                </c:pt>
                <c:pt idx="245">
                  <c:v>2.8349113580000002E-2</c:v>
                </c:pt>
                <c:pt idx="246">
                  <c:v>2.7725070873333334E-2</c:v>
                </c:pt>
                <c:pt idx="247">
                  <c:v>2.6833064010000001E-2</c:v>
                </c:pt>
                <c:pt idx="248">
                  <c:v>2.5709520286666669E-2</c:v>
                </c:pt>
                <c:pt idx="249">
                  <c:v>2.4403053153333333E-2</c:v>
                </c:pt>
                <c:pt idx="250">
                  <c:v>2.2966068749999999E-2</c:v>
                </c:pt>
                <c:pt idx="251">
                  <c:v>2.1454920386666666E-2</c:v>
                </c:pt>
                <c:pt idx="252">
                  <c:v>1.9932365730000002E-2</c:v>
                </c:pt>
                <c:pt idx="253">
                  <c:v>1.846599308E-2</c:v>
                </c:pt>
                <c:pt idx="254">
                  <c:v>1.7121324996666666E-2</c:v>
                </c:pt>
                <c:pt idx="255">
                  <c:v>1.5952724303333332E-2</c:v>
                </c:pt>
                <c:pt idx="256">
                  <c:v>1.4996154023333331E-2</c:v>
                </c:pt>
                <c:pt idx="257">
                  <c:v>1.4266177730000001E-2</c:v>
                </c:pt>
                <c:pt idx="258">
                  <c:v>1.375741034E-2</c:v>
                </c:pt>
                <c:pt idx="259">
                  <c:v>1.3449185306666667E-2</c:v>
                </c:pt>
                <c:pt idx="260">
                  <c:v>1.3311684823333333E-2</c:v>
                </c:pt>
                <c:pt idx="261">
                  <c:v>1.3311913186666666E-2</c:v>
                </c:pt>
                <c:pt idx="262">
                  <c:v>1.3418375076666666E-2</c:v>
                </c:pt>
                <c:pt idx="263">
                  <c:v>1.3603923883333334E-2</c:v>
                </c:pt>
                <c:pt idx="264">
                  <c:v>1.3846814993333333E-2</c:v>
                </c:pt>
                <c:pt idx="265">
                  <c:v>1.4130421226666669E-2</c:v>
                </c:pt>
                <c:pt idx="266">
                  <c:v>1.4442273883333334E-2</c:v>
                </c:pt>
                <c:pt idx="267">
                  <c:v>1.4773068266666666E-2</c:v>
                </c:pt>
                <c:pt idx="268">
                  <c:v>1.5116050236666668E-2</c:v>
                </c:pt>
                <c:pt idx="269">
                  <c:v>1.5466869006666667E-2</c:v>
                </c:pt>
                <c:pt idx="270">
                  <c:v>1.5823652210000001E-2</c:v>
                </c:pt>
                <c:pt idx="271">
                  <c:v>1.6186847569999999E-2</c:v>
                </c:pt>
                <c:pt idx="272">
                  <c:v>1.655836053E-2</c:v>
                </c:pt>
                <c:pt idx="273">
                  <c:v>1.6939718196666669E-2</c:v>
                </c:pt>
                <c:pt idx="274">
                  <c:v>1.7329358976666667E-2</c:v>
                </c:pt>
                <c:pt idx="275">
                  <c:v>1.7719573156666665E-2</c:v>
                </c:pt>
                <c:pt idx="276">
                  <c:v>1.8093964203333333E-2</c:v>
                </c:pt>
                <c:pt idx="277">
                  <c:v>1.8426421660000001E-2</c:v>
                </c:pt>
                <c:pt idx="278">
                  <c:v>1.8682402609999999E-2</c:v>
                </c:pt>
                <c:pt idx="279">
                  <c:v>1.8822797973333333E-2</c:v>
                </c:pt>
                <c:pt idx="280">
                  <c:v>1.8809919666666664E-2</c:v>
                </c:pt>
                <c:pt idx="281">
                  <c:v>1.861440177E-2</c:v>
                </c:pt>
                <c:pt idx="282">
                  <c:v>1.8221338796666667E-2</c:v>
                </c:pt>
                <c:pt idx="283">
                  <c:v>1.763401589E-2</c:v>
                </c:pt>
                <c:pt idx="284">
                  <c:v>1.6874177176666668E-2</c:v>
                </c:pt>
                <c:pt idx="285">
                  <c:v>1.5978758406666665E-2</c:v>
                </c:pt>
                <c:pt idx="286">
                  <c:v>1.4994020049999999E-2</c:v>
                </c:pt>
                <c:pt idx="287">
                  <c:v>1.3968672136666667E-2</c:v>
                </c:pt>
                <c:pt idx="288">
                  <c:v>1.2947653999999999E-2</c:v>
                </c:pt>
                <c:pt idx="289">
                  <c:v>1.1967757490000001E-2</c:v>
                </c:pt>
                <c:pt idx="290">
                  <c:v>1.105552655E-2</c:v>
                </c:pt>
                <c:pt idx="291">
                  <c:v>1.0227165573333334E-2</c:v>
                </c:pt>
                <c:pt idx="292">
                  <c:v>9.4897860500000007E-3</c:v>
                </c:pt>
                <c:pt idx="293">
                  <c:v>8.843265576666667E-3</c:v>
                </c:pt>
                <c:pt idx="294">
                  <c:v>8.2821820099999999E-3</c:v>
                </c:pt>
                <c:pt idx="295">
                  <c:v>7.797548196666667E-3</c:v>
                </c:pt>
                <c:pt idx="296">
                  <c:v>7.37827938E-3</c:v>
                </c:pt>
                <c:pt idx="297">
                  <c:v>7.0124252266666664E-3</c:v>
                </c:pt>
                <c:pt idx="298">
                  <c:v>6.6882087066666672E-3</c:v>
                </c:pt>
                <c:pt idx="299">
                  <c:v>6.3948815466666666E-3</c:v>
                </c:pt>
                <c:pt idx="300">
                  <c:v>6.1233736533333333E-3</c:v>
                </c:pt>
                <c:pt idx="301">
                  <c:v>5.8667013733333332E-3</c:v>
                </c:pt>
                <c:pt idx="302">
                  <c:v>5.6201125500000004E-3</c:v>
                </c:pt>
                <c:pt idx="303">
                  <c:v>5.3809740899999998E-3</c:v>
                </c:pt>
                <c:pt idx="304">
                  <c:v>5.1484424233333333E-3</c:v>
                </c:pt>
                <c:pt idx="305">
                  <c:v>4.9229861566666673E-3</c:v>
                </c:pt>
                <c:pt idx="306">
                  <c:v>4.7058478866666663E-3</c:v>
                </c:pt>
                <c:pt idx="307">
                  <c:v>4.4985342766666664E-3</c:v>
                </c:pt>
                <c:pt idx="308">
                  <c:v>4.3024090833333334E-3</c:v>
                </c:pt>
                <c:pt idx="309">
                  <c:v>4.11843873E-3</c:v>
                </c:pt>
                <c:pt idx="310">
                  <c:v>3.9471075033333334E-3</c:v>
                </c:pt>
                <c:pt idx="311">
                  <c:v>3.7884907799999997E-3</c:v>
                </c:pt>
                <c:pt idx="312">
                  <c:v>3.6424525366666669E-3</c:v>
                </c:pt>
                <c:pt idx="313">
                  <c:v>3.5089223866666668E-3</c:v>
                </c:pt>
                <c:pt idx="314">
                  <c:v>3.3882074499999998E-3</c:v>
                </c:pt>
                <c:pt idx="315">
                  <c:v>3.2812991800000003E-3</c:v>
                </c:pt>
                <c:pt idx="316">
                  <c:v>3.1901422833333333E-3</c:v>
                </c:pt>
                <c:pt idx="317">
                  <c:v>3.1178335699999999E-3</c:v>
                </c:pt>
                <c:pt idx="318">
                  <c:v>3.068713433333333E-3</c:v>
                </c:pt>
                <c:pt idx="319">
                  <c:v>3.0483003600000002E-3</c:v>
                </c:pt>
                <c:pt idx="320">
                  <c:v>3.06300774E-3</c:v>
                </c:pt>
                <c:pt idx="321">
                  <c:v>3.1195813166666666E-3</c:v>
                </c:pt>
                <c:pt idx="322">
                  <c:v>3.2242173066666666E-3</c:v>
                </c:pt>
                <c:pt idx="323">
                  <c:v>3.3813738899999999E-3</c:v>
                </c:pt>
                <c:pt idx="324">
                  <c:v>3.5923741133333333E-3</c:v>
                </c:pt>
                <c:pt idx="325">
                  <c:v>3.8540017100000003E-3</c:v>
                </c:pt>
                <c:pt idx="326">
                  <c:v>4.1573863299999994E-3</c:v>
                </c:pt>
                <c:pt idx="327">
                  <c:v>4.4875216666666667E-3</c:v>
                </c:pt>
                <c:pt idx="328">
                  <c:v>4.8237228033333329E-3</c:v>
                </c:pt>
                <c:pt idx="329">
                  <c:v>5.1411874433333329E-3</c:v>
                </c:pt>
                <c:pt idx="330">
                  <c:v>5.4135945299999995E-3</c:v>
                </c:pt>
                <c:pt idx="331">
                  <c:v>5.6164025566666671E-3</c:v>
                </c:pt>
                <c:pt idx="332">
                  <c:v>5.730279913333333E-3</c:v>
                </c:pt>
                <c:pt idx="333">
                  <c:v>5.7439894600000005E-3</c:v>
                </c:pt>
                <c:pt idx="334">
                  <c:v>5.6561130399999998E-3</c:v>
                </c:pt>
                <c:pt idx="335">
                  <c:v>5.4752346533333334E-3</c:v>
                </c:pt>
                <c:pt idx="336">
                  <c:v>5.2185444033333332E-3</c:v>
                </c:pt>
                <c:pt idx="337">
                  <c:v>4.9091787866666669E-3</c:v>
                </c:pt>
                <c:pt idx="338">
                  <c:v>4.5728736033333328E-3</c:v>
                </c:pt>
                <c:pt idx="339">
                  <c:v>4.2346043E-3</c:v>
                </c:pt>
                <c:pt idx="340">
                  <c:v>3.9158123399999998E-3</c:v>
                </c:pt>
                <c:pt idx="341">
                  <c:v>3.6326065000000002E-3</c:v>
                </c:pt>
                <c:pt idx="342">
                  <c:v>3.3950624566666671E-3</c:v>
                </c:pt>
                <c:pt idx="343">
                  <c:v>3.2075015833333332E-3</c:v>
                </c:pt>
                <c:pt idx="344">
                  <c:v>3.0694683266666665E-3</c:v>
                </c:pt>
                <c:pt idx="345">
                  <c:v>2.9770654899999999E-3</c:v>
                </c:pt>
                <c:pt idx="346">
                  <c:v>2.9243367333333333E-3</c:v>
                </c:pt>
                <c:pt idx="347">
                  <c:v>2.9044710533333335E-3</c:v>
                </c:pt>
                <c:pt idx="348">
                  <c:v>2.9107088833333333E-3</c:v>
                </c:pt>
                <c:pt idx="349">
                  <c:v>2.9369223233333334E-3</c:v>
                </c:pt>
                <c:pt idx="350">
                  <c:v>2.9779067699999997E-3</c:v>
                </c:pt>
                <c:pt idx="351">
                  <c:v>3.0294543333333332E-3</c:v>
                </c:pt>
                <c:pt idx="352">
                  <c:v>3.0882863766666666E-3</c:v>
                </c:pt>
                <c:pt idx="353">
                  <c:v>3.15191206E-3</c:v>
                </c:pt>
                <c:pt idx="354">
                  <c:v>3.2184628033333335E-3</c:v>
                </c:pt>
                <c:pt idx="355">
                  <c:v>3.2865334600000002E-3</c:v>
                </c:pt>
                <c:pt idx="356">
                  <c:v>3.3550464233333336E-3</c:v>
                </c:pt>
                <c:pt idx="357">
                  <c:v>3.4231439933333331E-3</c:v>
                </c:pt>
                <c:pt idx="358">
                  <c:v>3.4901080033333332E-3</c:v>
                </c:pt>
                <c:pt idx="359">
                  <c:v>3.5553027766666665E-3</c:v>
                </c:pt>
                <c:pt idx="360">
                  <c:v>3.6181369833333337E-3</c:v>
                </c:pt>
                <c:pt idx="361">
                  <c:v>3.6780399733333333E-3</c:v>
                </c:pt>
                <c:pt idx="362">
                  <c:v>3.7344491333333335E-3</c:v>
                </c:pt>
                <c:pt idx="363">
                  <c:v>3.7868061566666668E-3</c:v>
                </c:pt>
                <c:pt idx="364">
                  <c:v>3.8345601033333331E-3</c:v>
                </c:pt>
                <c:pt idx="365">
                  <c:v>3.87717631E-3</c:v>
                </c:pt>
                <c:pt idx="366">
                  <c:v>3.9141499200000002E-3</c:v>
                </c:pt>
                <c:pt idx="367">
                  <c:v>3.9450231400000001E-3</c:v>
                </c:pt>
                <c:pt idx="368">
                  <c:v>3.9694049999999996E-3</c:v>
                </c:pt>
                <c:pt idx="369">
                  <c:v>3.9869925366666668E-3</c:v>
                </c:pt>
                <c:pt idx="370">
                  <c:v>3.9975919633333332E-3</c:v>
                </c:pt>
                <c:pt idx="371">
                  <c:v>4.0011382833333338E-3</c:v>
                </c:pt>
                <c:pt idx="372">
                  <c:v>3.9977125366666665E-3</c:v>
                </c:pt>
                <c:pt idx="373">
                  <c:v>3.9875551033333335E-3</c:v>
                </c:pt>
                <c:pt idx="374">
                  <c:v>3.9710747033333332E-3</c:v>
                </c:pt>
                <c:pt idx="375">
                  <c:v>3.9488527099999999E-3</c:v>
                </c:pt>
                <c:pt idx="376">
                  <c:v>3.9216430466666669E-3</c:v>
                </c:pt>
                <c:pt idx="377">
                  <c:v>3.8903684733333334E-3</c:v>
                </c:pt>
                <c:pt idx="378">
                  <c:v>3.8561142866666669E-3</c:v>
                </c:pt>
                <c:pt idx="379">
                  <c:v>3.8201213799999999E-3</c:v>
                </c:pt>
                <c:pt idx="380">
                  <c:v>3.783779953333333E-3</c:v>
                </c:pt>
                <c:pt idx="381">
                  <c:v>3.748625853333333E-3</c:v>
                </c:pt>
                <c:pt idx="382">
                  <c:v>3.7163406333333335E-3</c:v>
                </c:pt>
                <c:pt idx="383">
                  <c:v>3.6887560633333334E-3</c:v>
                </c:pt>
                <c:pt idx="384">
                  <c:v>3.667862506666667E-3</c:v>
                </c:pt>
                <c:pt idx="385">
                  <c:v>3.6558193833333336E-3</c:v>
                </c:pt>
                <c:pt idx="386">
                  <c:v>3.6549645766666664E-3</c:v>
                </c:pt>
                <c:pt idx="387">
                  <c:v>3.6678177700000003E-3</c:v>
                </c:pt>
                <c:pt idx="388">
                  <c:v>3.6970718366666666E-3</c:v>
                </c:pt>
                <c:pt idx="389">
                  <c:v>3.7455660133333332E-3</c:v>
                </c:pt>
                <c:pt idx="390">
                  <c:v>3.8162343799999997E-3</c:v>
                </c:pt>
                <c:pt idx="391">
                  <c:v>3.912025883333334E-3</c:v>
                </c:pt>
                <c:pt idx="392">
                  <c:v>4.0357949033333331E-3</c:v>
                </c:pt>
                <c:pt idx="393">
                  <c:v>4.1901664866666665E-3</c:v>
                </c:pt>
                <c:pt idx="394">
                  <c:v>4.3773864466666668E-3</c:v>
                </c:pt>
                <c:pt idx="395">
                  <c:v>4.5991729633333336E-3</c:v>
                </c:pt>
                <c:pt idx="396">
                  <c:v>4.8565912500000002E-3</c:v>
                </c:pt>
                <c:pt idx="397">
                  <c:v>5.1499735999999997E-3</c:v>
                </c:pt>
                <c:pt idx="398">
                  <c:v>5.478900613333333E-3</c:v>
                </c:pt>
                <c:pt idx="399">
                  <c:v>5.8422424100000002E-3</c:v>
                </c:pt>
                <c:pt idx="400">
                  <c:v>6.2382313466666671E-3</c:v>
                </c:pt>
                <c:pt idx="401">
                  <c:v>6.6645054466666666E-3</c:v>
                </c:pt>
                <c:pt idx="402">
                  <c:v>7.1180393833333326E-3</c:v>
                </c:pt>
                <c:pt idx="403">
                  <c:v>7.5948857900000003E-3</c:v>
                </c:pt>
                <c:pt idx="404">
                  <c:v>8.089703220000001E-3</c:v>
                </c:pt>
                <c:pt idx="405">
                  <c:v>8.5951476099999993E-3</c:v>
                </c:pt>
                <c:pt idx="406">
                  <c:v>9.1013273833333332E-3</c:v>
                </c:pt>
                <c:pt idx="407">
                  <c:v>9.5956109733333333E-3</c:v>
                </c:pt>
                <c:pt idx="408">
                  <c:v>1.006306521E-2</c:v>
                </c:pt>
                <c:pt idx="409">
                  <c:v>1.0487657809999999E-2</c:v>
                </c:pt>
                <c:pt idx="410">
                  <c:v>1.0854099226666667E-2</c:v>
                </c:pt>
                <c:pt idx="411">
                  <c:v>1.1149923776666666E-2</c:v>
                </c:pt>
                <c:pt idx="412">
                  <c:v>1.1367244153333332E-2</c:v>
                </c:pt>
                <c:pt idx="413">
                  <c:v>1.150365358E-2</c:v>
                </c:pt>
                <c:pt idx="414">
                  <c:v>1.1562004236666666E-2</c:v>
                </c:pt>
                <c:pt idx="415">
                  <c:v>1.1549159243333334E-2</c:v>
                </c:pt>
                <c:pt idx="416">
                  <c:v>1.1474143953333333E-2</c:v>
                </c:pt>
                <c:pt idx="417">
                  <c:v>1.1346272213333335E-2</c:v>
                </c:pt>
                <c:pt idx="418">
                  <c:v>1.1173750613333333E-2</c:v>
                </c:pt>
                <c:pt idx="419">
                  <c:v>1.0963023926666666E-2</c:v>
                </c:pt>
                <c:pt idx="420">
                  <c:v>1.0718840486666666E-2</c:v>
                </c:pt>
                <c:pt idx="421">
                  <c:v>1.0444803986666666E-2</c:v>
                </c:pt>
                <c:pt idx="422">
                  <c:v>1.0144099593333334E-2</c:v>
                </c:pt>
                <c:pt idx="423">
                  <c:v>9.8201278566666661E-3</c:v>
                </c:pt>
                <c:pt idx="424">
                  <c:v>9.4768946566666668E-3</c:v>
                </c:pt>
                <c:pt idx="425">
                  <c:v>9.119127329999999E-3</c:v>
                </c:pt>
                <c:pt idx="426">
                  <c:v>8.7521703499999996E-3</c:v>
                </c:pt>
                <c:pt idx="427">
                  <c:v>8.3817503000000008E-3</c:v>
                </c:pt>
                <c:pt idx="428">
                  <c:v>8.0136945333333324E-3</c:v>
                </c:pt>
                <c:pt idx="429">
                  <c:v>7.6536640866666662E-3</c:v>
                </c:pt>
                <c:pt idx="430">
                  <c:v>7.30693275E-3</c:v>
                </c:pt>
                <c:pt idx="431">
                  <c:v>6.9782217599999993E-3</c:v>
                </c:pt>
                <c:pt idx="432">
                  <c:v>6.6715859066666669E-3</c:v>
                </c:pt>
                <c:pt idx="433">
                  <c:v>6.3903402166666668E-3</c:v>
                </c:pt>
                <c:pt idx="434">
                  <c:v>6.1370154933333334E-3</c:v>
                </c:pt>
                <c:pt idx="435">
                  <c:v>5.9133323766666669E-3</c:v>
                </c:pt>
                <c:pt idx="436">
                  <c:v>5.7201880300000001E-3</c:v>
                </c:pt>
                <c:pt idx="437">
                  <c:v>5.5576539033333336E-3</c:v>
                </c:pt>
                <c:pt idx="438">
                  <c:v>5.4249881999999996E-3</c:v>
                </c:pt>
                <c:pt idx="439">
                  <c:v>5.3206710200000007E-3</c:v>
                </c:pt>
                <c:pt idx="440">
                  <c:v>5.2424723200000002E-3</c:v>
                </c:pt>
                <c:pt idx="441">
                  <c:v>5.1875621533333327E-3</c:v>
                </c:pt>
                <c:pt idx="442">
                  <c:v>5.1526681900000001E-3</c:v>
                </c:pt>
                <c:pt idx="443">
                  <c:v>5.1342775433333328E-3</c:v>
                </c:pt>
                <c:pt idx="444">
                  <c:v>5.1288693133333335E-3</c:v>
                </c:pt>
                <c:pt idx="445">
                  <c:v>5.1331539733333337E-3</c:v>
                </c:pt>
                <c:pt idx="446">
                  <c:v>5.1442870499999998E-3</c:v>
                </c:pt>
                <c:pt idx="447">
                  <c:v>5.1600216599999998E-3</c:v>
                </c:pt>
                <c:pt idx="448">
                  <c:v>5.1787680400000001E-3</c:v>
                </c:pt>
                <c:pt idx="449">
                  <c:v>5.1995389966666668E-3</c:v>
                </c:pt>
                <c:pt idx="450">
                  <c:v>5.2217780766666668E-3</c:v>
                </c:pt>
                <c:pt idx="451">
                  <c:v>5.2450869933333326E-3</c:v>
                </c:pt>
                <c:pt idx="452">
                  <c:v>5.2688899466666666E-3</c:v>
                </c:pt>
                <c:pt idx="453">
                  <c:v>5.2920879299999998E-3</c:v>
                </c:pt>
                <c:pt idx="454">
                  <c:v>5.3127649999999997E-3</c:v>
                </c:pt>
                <c:pt idx="455">
                  <c:v>5.3280059933333334E-3</c:v>
                </c:pt>
                <c:pt idx="456">
                  <c:v>5.3338736966666665E-3</c:v>
                </c:pt>
                <c:pt idx="457">
                  <c:v>5.3255708100000002E-3</c:v>
                </c:pt>
                <c:pt idx="458">
                  <c:v>5.2977842233333334E-3</c:v>
                </c:pt>
                <c:pt idx="459">
                  <c:v>5.2451779499999998E-3</c:v>
                </c:pt>
                <c:pt idx="460">
                  <c:v>5.1629737533333327E-3</c:v>
                </c:pt>
                <c:pt idx="461">
                  <c:v>5.0475388000000001E-3</c:v>
                </c:pt>
                <c:pt idx="462">
                  <c:v>4.8968931700000004E-3</c:v>
                </c:pt>
                <c:pt idx="463">
                  <c:v>4.7110583966666671E-3</c:v>
                </c:pt>
                <c:pt idx="464">
                  <c:v>4.4921906566666673E-3</c:v>
                </c:pt>
                <c:pt idx="465">
                  <c:v>4.2444756533333329E-3</c:v>
                </c:pt>
                <c:pt idx="466">
                  <c:v>3.9737997133333335E-3</c:v>
                </c:pt>
                <c:pt idx="467">
                  <c:v>3.6872461233333335E-3</c:v>
                </c:pt>
                <c:pt idx="468">
                  <c:v>3.3924907833333337E-3</c:v>
                </c:pt>
                <c:pt idx="469">
                  <c:v>3.0971809933333333E-3</c:v>
                </c:pt>
                <c:pt idx="470">
                  <c:v>2.80837709E-3</c:v>
                </c:pt>
                <c:pt idx="471">
                  <c:v>2.5321175266666664E-3</c:v>
                </c:pt>
                <c:pt idx="472">
                  <c:v>2.2731426766666664E-3</c:v>
                </c:pt>
                <c:pt idx="473">
                  <c:v>2.0347837500000001E-3</c:v>
                </c:pt>
                <c:pt idx="474">
                  <c:v>1.8189993766666666E-3</c:v>
                </c:pt>
                <c:pt idx="475">
                  <c:v>1.6265248699999998E-3</c:v>
                </c:pt>
                <c:pt idx="476">
                  <c:v>1.4570923266666667E-3</c:v>
                </c:pt>
                <c:pt idx="477">
                  <c:v>1.3096798933333333E-3</c:v>
                </c:pt>
                <c:pt idx="478">
                  <c:v>1.1827561499999999E-3</c:v>
                </c:pt>
                <c:pt idx="479">
                  <c:v>1.0744958766666667E-3</c:v>
                </c:pt>
                <c:pt idx="480">
                  <c:v>9.8295420999999989E-4</c:v>
                </c:pt>
                <c:pt idx="481">
                  <c:v>9.0619589666666664E-4</c:v>
                </c:pt>
                <c:pt idx="482">
                  <c:v>8.4238256666666663E-4</c:v>
                </c:pt>
                <c:pt idx="483">
                  <c:v>7.8982534333333341E-4</c:v>
                </c:pt>
                <c:pt idx="484">
                  <c:v>7.4701069000000005E-4</c:v>
                </c:pt>
                <c:pt idx="485">
                  <c:v>7.1260777666666661E-4</c:v>
                </c:pt>
                <c:pt idx="486">
                  <c:v>6.8546380333333332E-4</c:v>
                </c:pt>
                <c:pt idx="487">
                  <c:v>6.645920766666667E-4</c:v>
                </c:pt>
                <c:pt idx="488">
                  <c:v>6.4915667333333333E-4</c:v>
                </c:pt>
                <c:pt idx="489">
                  <c:v>6.3845532999999999E-4</c:v>
                </c:pt>
                <c:pt idx="490">
                  <c:v>6.3190231E-4</c:v>
                </c:pt>
                <c:pt idx="491">
                  <c:v>6.2901163666666661E-4</c:v>
                </c:pt>
                <c:pt idx="492">
                  <c:v>6.2938142333333338E-4</c:v>
                </c:pt>
                <c:pt idx="493">
                  <c:v>6.3267920666666667E-4</c:v>
                </c:pt>
                <c:pt idx="494">
                  <c:v>6.3862876999999998E-4</c:v>
                </c:pt>
                <c:pt idx="495">
                  <c:v>6.4699815000000003E-4</c:v>
                </c:pt>
                <c:pt idx="496">
                  <c:v>6.5758923333333332E-4</c:v>
                </c:pt>
                <c:pt idx="497">
                  <c:v>6.7022869666666666E-4</c:v>
                </c:pt>
                <c:pt idx="498">
                  <c:v>6.8476026000000001E-4</c:v>
                </c:pt>
                <c:pt idx="499">
                  <c:v>7.0103835666666665E-4</c:v>
                </c:pt>
                <c:pt idx="500">
                  <c:v>7.1892292999999996E-4</c:v>
                </c:pt>
                <c:pt idx="501">
                  <c:v>7.3827535333333334E-4</c:v>
                </c:pt>
                <c:pt idx="502">
                  <c:v>7.5895535666666665E-4</c:v>
                </c:pt>
                <c:pt idx="503">
                  <c:v>7.8081887333333335E-4</c:v>
                </c:pt>
                <c:pt idx="504">
                  <c:v>8.0371660333333327E-4</c:v>
                </c:pt>
                <c:pt idx="505">
                  <c:v>8.2749338333333328E-4</c:v>
                </c:pt>
                <c:pt idx="506">
                  <c:v>8.5198811333333331E-4</c:v>
                </c:pt>
                <c:pt idx="507">
                  <c:v>8.770343666666666E-4</c:v>
                </c:pt>
                <c:pt idx="508">
                  <c:v>9.0246153000000007E-4</c:v>
                </c:pt>
                <c:pt idx="509">
                  <c:v>9.2809670666666659E-4</c:v>
                </c:pt>
                <c:pt idx="510">
                  <c:v>9.5376740999999999E-4</c:v>
                </c:pt>
                <c:pt idx="511">
                  <c:v>9.7930543333333338E-4</c:v>
                </c:pt>
                <c:pt idx="512">
                  <c:v>1.0045522566666666E-3</c:v>
                </c:pt>
                <c:pt idx="513">
                  <c:v>1.02936662E-3</c:v>
                </c:pt>
                <c:pt idx="514">
                  <c:v>1.0536350433333333E-3</c:v>
                </c:pt>
                <c:pt idx="515">
                  <c:v>1.0772860166666665E-3</c:v>
                </c:pt>
                <c:pt idx="516">
                  <c:v>1.1003085333333334E-3</c:v>
                </c:pt>
                <c:pt idx="517">
                  <c:v>1.1227750366666668E-3</c:v>
                </c:pt>
                <c:pt idx="518">
                  <c:v>1.1448680466666667E-3</c:v>
                </c:pt>
                <c:pt idx="519">
                  <c:v>1.1669080266666668E-3</c:v>
                </c:pt>
                <c:pt idx="520">
                  <c:v>1.18937834E-3</c:v>
                </c:pt>
                <c:pt idx="521">
                  <c:v>1.2129407300000001E-3</c:v>
                </c:pt>
                <c:pt idx="522">
                  <c:v>1.2384329699999998E-3</c:v>
                </c:pt>
                <c:pt idx="523">
                  <c:v>1.2668393300000001E-3</c:v>
                </c:pt>
                <c:pt idx="524">
                  <c:v>1.2992254433333334E-3</c:v>
                </c:pt>
                <c:pt idx="525">
                  <c:v>1.33663253E-3</c:v>
                </c:pt>
                <c:pt idx="526">
                  <c:v>1.3799324999999999E-3</c:v>
                </c:pt>
                <c:pt idx="527">
                  <c:v>1.4296539633333334E-3</c:v>
                </c:pt>
                <c:pt idx="528">
                  <c:v>1.48579962E-3</c:v>
                </c:pt>
                <c:pt idx="529">
                  <c:v>1.5476837900000001E-3</c:v>
                </c:pt>
                <c:pt idx="530">
                  <c:v>1.61382476E-3</c:v>
                </c:pt>
                <c:pt idx="531">
                  <c:v>1.6819247166666668E-3</c:v>
                </c:pt>
                <c:pt idx="532">
                  <c:v>1.7489619133333333E-3</c:v>
                </c:pt>
                <c:pt idx="533">
                  <c:v>1.8114027E-3</c:v>
                </c:pt>
                <c:pt idx="534">
                  <c:v>1.8655200633333332E-3</c:v>
                </c:pt>
                <c:pt idx="535">
                  <c:v>1.9077828466666665E-3</c:v>
                </c:pt>
                <c:pt idx="536">
                  <c:v>1.9352621266666666E-3</c:v>
                </c:pt>
                <c:pt idx="537">
                  <c:v>1.9459922366666666E-3</c:v>
                </c:pt>
                <c:pt idx="538">
                  <c:v>1.9392275533333335E-3</c:v>
                </c:pt>
                <c:pt idx="539">
                  <c:v>1.9155516899999998E-3</c:v>
                </c:pt>
                <c:pt idx="540">
                  <c:v>1.87682036E-3</c:v>
                </c:pt>
                <c:pt idx="541">
                  <c:v>1.8259481066666666E-3</c:v>
                </c:pt>
                <c:pt idx="542">
                  <c:v>1.76657512E-3</c:v>
                </c:pt>
                <c:pt idx="543">
                  <c:v>1.70266872E-3</c:v>
                </c:pt>
                <c:pt idx="544">
                  <c:v>1.63812067E-3</c:v>
                </c:pt>
                <c:pt idx="545">
                  <c:v>1.5763963533333334E-3</c:v>
                </c:pt>
                <c:pt idx="546">
                  <c:v>1.5202766066666666E-3</c:v>
                </c:pt>
                <c:pt idx="547">
                  <c:v>1.4717129866666668E-3</c:v>
                </c:pt>
                <c:pt idx="548">
                  <c:v>1.4317958899999999E-3</c:v>
                </c:pt>
                <c:pt idx="549">
                  <c:v>1.4008183066666667E-3</c:v>
                </c:pt>
                <c:pt idx="550">
                  <c:v>1.37840671E-3</c:v>
                </c:pt>
                <c:pt idx="551">
                  <c:v>1.3636876133333333E-3</c:v>
                </c:pt>
                <c:pt idx="552">
                  <c:v>1.3554606566666667E-3</c:v>
                </c:pt>
                <c:pt idx="553">
                  <c:v>1.35235618E-3</c:v>
                </c:pt>
                <c:pt idx="554">
                  <c:v>1.3529639899999999E-3</c:v>
                </c:pt>
                <c:pt idx="555">
                  <c:v>1.3559282033333334E-3</c:v>
                </c:pt>
                <c:pt idx="556">
                  <c:v>1.3600097266666669E-3</c:v>
                </c:pt>
                <c:pt idx="557">
                  <c:v>1.3641221366666666E-3</c:v>
                </c:pt>
                <c:pt idx="558">
                  <c:v>1.3673479366666666E-3</c:v>
                </c:pt>
                <c:pt idx="559">
                  <c:v>1.36894258E-3</c:v>
                </c:pt>
                <c:pt idx="560">
                  <c:v>1.3683318433333333E-3</c:v>
                </c:pt>
                <c:pt idx="561">
                  <c:v>1.3651060766666668E-3</c:v>
                </c:pt>
                <c:pt idx="562">
                  <c:v>1.35901367E-3</c:v>
                </c:pt>
                <c:pt idx="563">
                  <c:v>1.3499537233333332E-3</c:v>
                </c:pt>
                <c:pt idx="564">
                  <c:v>1.33796772E-3</c:v>
                </c:pt>
                <c:pt idx="565">
                  <c:v>1.3232288833333334E-3</c:v>
                </c:pt>
                <c:pt idx="566">
                  <c:v>1.3060284966666667E-3</c:v>
                </c:pt>
                <c:pt idx="567">
                  <c:v>1.2867583866666666E-3</c:v>
                </c:pt>
                <c:pt idx="568">
                  <c:v>1.26588935E-3</c:v>
                </c:pt>
                <c:pt idx="569">
                  <c:v>1.2439460466666667E-3</c:v>
                </c:pt>
                <c:pt idx="570">
                  <c:v>1.2214791033333334E-3</c:v>
                </c:pt>
                <c:pt idx="571">
                  <c:v>1.1990359899999999E-3</c:v>
                </c:pt>
                <c:pt idx="572">
                  <c:v>1.1771322466666667E-3</c:v>
                </c:pt>
                <c:pt idx="573">
                  <c:v>1.1562249400000001E-3</c:v>
                </c:pt>
                <c:pt idx="574">
                  <c:v>1.1366899966666667E-3</c:v>
                </c:pt>
                <c:pt idx="575">
                  <c:v>1.11880513E-3</c:v>
                </c:pt>
                <c:pt idx="576">
                  <c:v>1.1027394066666666E-3</c:v>
                </c:pt>
                <c:pt idx="577">
                  <c:v>1.0885502366666667E-3</c:v>
                </c:pt>
                <c:pt idx="578">
                  <c:v>1.0761880633333332E-3</c:v>
                </c:pt>
                <c:pt idx="579">
                  <c:v>1.06550814E-3</c:v>
                </c:pt>
                <c:pt idx="580">
                  <c:v>1.05628888E-3</c:v>
                </c:pt>
                <c:pt idx="581">
                  <c:v>1.0482552599999999E-3</c:v>
                </c:pt>
                <c:pt idx="582">
                  <c:v>1.04110561E-3</c:v>
                </c:pt>
                <c:pt idx="583">
                  <c:v>1.0345399900000001E-3</c:v>
                </c:pt>
                <c:pt idx="584">
                  <c:v>1.0282879699999999E-3</c:v>
                </c:pt>
                <c:pt idx="585">
                  <c:v>1.0221338766666667E-3</c:v>
                </c:pt>
                <c:pt idx="586">
                  <c:v>1.01593727E-3</c:v>
                </c:pt>
                <c:pt idx="587">
                  <c:v>1.0096470166666665E-3</c:v>
                </c:pt>
                <c:pt idx="588">
                  <c:v>1.0033071433333334E-3</c:v>
                </c:pt>
                <c:pt idx="589">
                  <c:v>9.970534933333333E-4</c:v>
                </c:pt>
                <c:pt idx="590">
                  <c:v>9.9110041000000006E-4</c:v>
                </c:pt>
                <c:pt idx="591">
                  <c:v>9.8571748000000014E-4</c:v>
                </c:pt>
                <c:pt idx="592">
                  <c:v>9.8119728333333342E-4</c:v>
                </c:pt>
                <c:pt idx="593">
                  <c:v>9.7781605333333325E-4</c:v>
                </c:pt>
                <c:pt idx="594">
                  <c:v>9.7578995666666669E-4</c:v>
                </c:pt>
                <c:pt idx="595">
                  <c:v>9.7523105999999999E-4</c:v>
                </c:pt>
                <c:pt idx="596">
                  <c:v>9.7610750666666667E-4</c:v>
                </c:pt>
                <c:pt idx="597">
                  <c:v>9.782130033333333E-4</c:v>
                </c:pt>
                <c:pt idx="598">
                  <c:v>9.811503966666666E-4</c:v>
                </c:pt>
                <c:pt idx="599">
                  <c:v>9.8433358666666663E-4</c:v>
                </c:pt>
                <c:pt idx="600">
                  <c:v>9.8701019666666665E-4</c:v>
                </c:pt>
                <c:pt idx="601">
                  <c:v>9.8830560000000007E-4</c:v>
                </c:pt>
                <c:pt idx="602">
                  <c:v>9.8728599666666659E-4</c:v>
                </c:pt>
                <c:pt idx="603">
                  <c:v>9.8303590333333342E-4</c:v>
                </c:pt>
                <c:pt idx="604">
                  <c:v>9.7474286333333333E-4</c:v>
                </c:pt>
                <c:pt idx="605">
                  <c:v>9.6178046666666665E-4</c:v>
                </c:pt>
                <c:pt idx="606">
                  <c:v>9.4378030999999992E-4</c:v>
                </c:pt>
                <c:pt idx="607">
                  <c:v>9.2068412333333319E-4</c:v>
                </c:pt>
                <c:pt idx="608">
                  <c:v>8.9276913333333338E-4</c:v>
                </c:pt>
                <c:pt idx="609">
                  <c:v>8.6064286333333332E-4</c:v>
                </c:pt>
                <c:pt idx="610">
                  <c:v>8.2520717333333337E-4</c:v>
                </c:pt>
                <c:pt idx="611">
                  <c:v>7.8759499333333331E-4</c:v>
                </c:pt>
                <c:pt idx="612">
                  <c:v>7.4908675666666665E-4</c:v>
                </c:pt>
                <c:pt idx="613">
                  <c:v>7.1101565999999992E-4</c:v>
                </c:pt>
                <c:pt idx="614">
                  <c:v>6.7467202333333339E-4</c:v>
                </c:pt>
                <c:pt idx="615">
                  <c:v>6.4121661333333335E-4</c:v>
                </c:pt>
                <c:pt idx="616">
                  <c:v>6.1161114333333334E-4</c:v>
                </c:pt>
                <c:pt idx="617">
                  <c:v>5.8657162666666662E-4</c:v>
                </c:pt>
                <c:pt idx="618">
                  <c:v>5.6654685666666666E-4</c:v>
                </c:pt>
                <c:pt idx="619">
                  <c:v>5.5172179000000001E-4</c:v>
                </c:pt>
                <c:pt idx="620">
                  <c:v>5.4204220999999999E-4</c:v>
                </c:pt>
                <c:pt idx="621">
                  <c:v>5.3725589666666664E-4</c:v>
                </c:pt>
                <c:pt idx="622">
                  <c:v>5.3696403000000001E-4</c:v>
                </c:pt>
                <c:pt idx="623">
                  <c:v>5.4067664666666664E-4</c:v>
                </c:pt>
                <c:pt idx="624">
                  <c:v>5.4786655999999997E-4</c:v>
                </c:pt>
                <c:pt idx="625">
                  <c:v>5.5801701999999998E-4</c:v>
                </c:pt>
                <c:pt idx="626">
                  <c:v>5.7065974333333331E-4</c:v>
                </c:pt>
                <c:pt idx="627">
                  <c:v>5.8540111333333343E-4</c:v>
                </c:pt>
                <c:pt idx="628">
                  <c:v>6.0193538333333334E-4</c:v>
                </c:pt>
                <c:pt idx="629">
                  <c:v>6.2004468333333332E-4</c:v>
                </c:pt>
                <c:pt idx="630">
                  <c:v>6.3958634333333337E-4</c:v>
                </c:pt>
                <c:pt idx="631">
                  <c:v>6.6046867000000003E-4</c:v>
                </c:pt>
                <c:pt idx="632">
                  <c:v>6.826172566666666E-4</c:v>
                </c:pt>
                <c:pt idx="633">
                  <c:v>7.0593445999999997E-4</c:v>
                </c:pt>
                <c:pt idx="634">
                  <c:v>7.3025576333333336E-4</c:v>
                </c:pt>
                <c:pt idx="635">
                  <c:v>7.5530752333333336E-4</c:v>
                </c:pt>
                <c:pt idx="636">
                  <c:v>7.8067119666666671E-4</c:v>
                </c:pt>
                <c:pt idx="637">
                  <c:v>8.0575954666666665E-4</c:v>
                </c:pt>
                <c:pt idx="638">
                  <c:v>8.2980961666666666E-4</c:v>
                </c:pt>
                <c:pt idx="639">
                  <c:v>8.5189644666666664E-4</c:v>
                </c:pt>
                <c:pt idx="640">
                  <c:v>8.7096918000000012E-4</c:v>
                </c:pt>
                <c:pt idx="641">
                  <c:v>8.8590875999999992E-4</c:v>
                </c:pt>
                <c:pt idx="642">
                  <c:v>8.9560353000000007E-4</c:v>
                </c:pt>
                <c:pt idx="643">
                  <c:v>8.9903595666666663E-4</c:v>
                </c:pt>
                <c:pt idx="644">
                  <c:v>8.9537183666666667E-4</c:v>
                </c:pt>
                <c:pt idx="645">
                  <c:v>8.8404175666666662E-4</c:v>
                </c:pt>
                <c:pt idx="646">
                  <c:v>8.6480528999999999E-4</c:v>
                </c:pt>
                <c:pt idx="647">
                  <c:v>8.3778970666666661E-4</c:v>
                </c:pt>
                <c:pt idx="648">
                  <c:v>8.0349811333333342E-4</c:v>
                </c:pt>
                <c:pt idx="649">
                  <c:v>7.6278575999999998E-4</c:v>
                </c:pt>
                <c:pt idx="650">
                  <c:v>7.1680731333333342E-4</c:v>
                </c:pt>
                <c:pt idx="651">
                  <c:v>6.6694138E-4</c:v>
                </c:pt>
                <c:pt idx="652">
                  <c:v>6.1470133000000003E-4</c:v>
                </c:pt>
                <c:pt idx="653">
                  <c:v>5.6164265333333329E-4</c:v>
                </c:pt>
                <c:pt idx="654">
                  <c:v>5.0927645333333335E-4</c:v>
                </c:pt>
                <c:pt idx="655">
                  <c:v>4.5899745666666666E-4</c:v>
                </c:pt>
                <c:pt idx="656">
                  <c:v>4.1203153666666666E-4</c:v>
                </c:pt>
                <c:pt idx="657">
                  <c:v>3.6940470666666669E-4</c:v>
                </c:pt>
                <c:pt idx="658">
                  <c:v>3.3193246000000001E-4</c:v>
                </c:pt>
                <c:pt idx="659">
                  <c:v>3.0022539333333329E-4</c:v>
                </c:pt>
                <c:pt idx="660">
                  <c:v>2.7470553666666665E-4</c:v>
                </c:pt>
                <c:pt idx="661">
                  <c:v>2.5562724666666666E-4</c:v>
                </c:pt>
                <c:pt idx="662">
                  <c:v>2.4309674666666669E-4</c:v>
                </c:pt>
                <c:pt idx="663">
                  <c:v>2.3708626E-4</c:v>
                </c:pt>
                <c:pt idx="664">
                  <c:v>2.3744002000000003E-4</c:v>
                </c:pt>
                <c:pt idx="665">
                  <c:v>2.4387229666666667E-4</c:v>
                </c:pt>
                <c:pt idx="666">
                  <c:v>2.5595897666666668E-4</c:v>
                </c:pt>
                <c:pt idx="667">
                  <c:v>2.7312657333333334E-4</c:v>
                </c:pt>
                <c:pt idx="668">
                  <c:v>2.9464297333333333E-4</c:v>
                </c:pt>
                <c:pt idx="669">
                  <c:v>3.1961483333333335E-4</c:v>
                </c:pt>
                <c:pt idx="670">
                  <c:v>3.4699600000000002E-4</c:v>
                </c:pt>
                <c:pt idx="671">
                  <c:v>3.7560976333333334E-4</c:v>
                </c:pt>
                <c:pt idx="672">
                  <c:v>4.0418639999999998E-4</c:v>
                </c:pt>
                <c:pt idx="673">
                  <c:v>4.3141500333333333E-4</c:v>
                </c:pt>
                <c:pt idx="674">
                  <c:v>4.5600669999999998E-4</c:v>
                </c:pt>
                <c:pt idx="675">
                  <c:v>4.767643033333333E-4</c:v>
                </c:pt>
                <c:pt idx="676">
                  <c:v>4.9265227999999996E-4</c:v>
                </c:pt>
                <c:pt idx="677">
                  <c:v>5.0286029000000008E-4</c:v>
                </c:pt>
                <c:pt idx="678">
                  <c:v>5.0685369999999995E-4</c:v>
                </c:pt>
                <c:pt idx="679">
                  <c:v>5.0440591999999999E-4</c:v>
                </c:pt>
                <c:pt idx="680">
                  <c:v>4.9560876999999999E-4</c:v>
                </c:pt>
                <c:pt idx="681">
                  <c:v>4.8085976666666671E-4</c:v>
                </c:pt>
                <c:pt idx="682">
                  <c:v>4.6082747000000004E-4</c:v>
                </c:pt>
                <c:pt idx="683">
                  <c:v>4.3639827666666669E-4</c:v>
                </c:pt>
                <c:pt idx="684">
                  <c:v>4.0860998666666665E-4</c:v>
                </c:pt>
                <c:pt idx="685">
                  <c:v>3.7857847000000004E-4</c:v>
                </c:pt>
                <c:pt idx="686">
                  <c:v>3.4742413333333335E-4</c:v>
                </c:pt>
                <c:pt idx="687">
                  <c:v>3.1620448999999999E-4</c:v>
                </c:pt>
                <c:pt idx="688">
                  <c:v>2.8585796E-4</c:v>
                </c:pt>
                <c:pt idx="689">
                  <c:v>2.5716231333333331E-4</c:v>
                </c:pt>
                <c:pt idx="690">
                  <c:v>2.3070966666666664E-4</c:v>
                </c:pt>
                <c:pt idx="691">
                  <c:v>2.0689785000000001E-4</c:v>
                </c:pt>
                <c:pt idx="692">
                  <c:v>1.8593661333333333E-4</c:v>
                </c:pt>
                <c:pt idx="693">
                  <c:v>1.6786582333333335E-4</c:v>
                </c:pt>
                <c:pt idx="694">
                  <c:v>1.5258242333333335E-4</c:v>
                </c:pt>
                <c:pt idx="695">
                  <c:v>1.3987226999999998E-4</c:v>
                </c:pt>
                <c:pt idx="696">
                  <c:v>1.2944372666666667E-4</c:v>
                </c:pt>
                <c:pt idx="697">
                  <c:v>1.2095978000000001E-4</c:v>
                </c:pt>
                <c:pt idx="698">
                  <c:v>1.1406685666666667E-4</c:v>
                </c:pt>
                <c:pt idx="699">
                  <c:v>1.0841856999999999E-4</c:v>
                </c:pt>
                <c:pt idx="700">
                  <c:v>1.0369396E-4</c:v>
                </c:pt>
                <c:pt idx="701">
                  <c:v>9.9610049999999993E-5</c:v>
                </c:pt>
                <c:pt idx="702">
                  <c:v>9.5929193333333334E-5</c:v>
                </c:pt>
                <c:pt idx="703">
                  <c:v>9.2461930000000005E-5</c:v>
                </c:pt>
                <c:pt idx="704">
                  <c:v>8.9066263333333333E-5</c:v>
                </c:pt>
                <c:pt idx="705">
                  <c:v>8.5644323333333329E-5</c:v>
                </c:pt>
                <c:pt idx="706">
                  <c:v>8.2137240000000006E-5</c:v>
                </c:pt>
                <c:pt idx="707">
                  <c:v>7.8519053333333326E-5</c:v>
                </c:pt>
                <c:pt idx="708">
                  <c:v>7.4790273333333324E-5</c:v>
                </c:pt>
                <c:pt idx="709">
                  <c:v>7.0971513333333328E-5</c:v>
                </c:pt>
                <c:pt idx="710">
                  <c:v>6.709761E-5</c:v>
                </c:pt>
                <c:pt idx="711">
                  <c:v>6.3212319999999999E-5</c:v>
                </c:pt>
                <c:pt idx="712">
                  <c:v>5.9363863333333331E-5</c:v>
                </c:pt>
                <c:pt idx="713">
                  <c:v>5.5601190000000005E-5</c:v>
                </c:pt>
                <c:pt idx="714">
                  <c:v>5.1971059999999998E-5</c:v>
                </c:pt>
                <c:pt idx="715">
                  <c:v>4.8515923333333334E-5</c:v>
                </c:pt>
                <c:pt idx="716">
                  <c:v>4.527235E-5</c:v>
                </c:pt>
                <c:pt idx="717">
                  <c:v>4.2270179999999999E-5</c:v>
                </c:pt>
                <c:pt idx="718">
                  <c:v>3.9532076666666668E-5</c:v>
                </c:pt>
                <c:pt idx="719">
                  <c:v>3.7073543333333338E-5</c:v>
                </c:pt>
                <c:pt idx="720">
                  <c:v>3.4903256666666668E-5</c:v>
                </c:pt>
                <c:pt idx="721">
                  <c:v>3.3023646666666665E-5</c:v>
                </c:pt>
                <c:pt idx="722">
                  <c:v>3.143162E-5</c:v>
                </c:pt>
                <c:pt idx="723">
                  <c:v>3.0119406666666664E-5</c:v>
                </c:pt>
                <c:pt idx="724">
                  <c:v>2.9075476666666667E-5</c:v>
                </c:pt>
                <c:pt idx="725">
                  <c:v>2.8285399999999999E-5</c:v>
                </c:pt>
                <c:pt idx="726">
                  <c:v>2.7732713333333335E-5</c:v>
                </c:pt>
                <c:pt idx="727">
                  <c:v>2.7399666666666668E-5</c:v>
                </c:pt>
                <c:pt idx="728">
                  <c:v>2.7267936666666665E-5</c:v>
                </c:pt>
                <c:pt idx="729">
                  <c:v>2.7319173333333334E-5</c:v>
                </c:pt>
                <c:pt idx="730">
                  <c:v>2.7535509999999998E-5</c:v>
                </c:pt>
                <c:pt idx="731">
                  <c:v>2.7899903333333332E-5</c:v>
                </c:pt>
                <c:pt idx="732">
                  <c:v>2.8396413333333337E-5</c:v>
                </c:pt>
                <c:pt idx="733">
                  <c:v>2.9010379999999998E-5</c:v>
                </c:pt>
                <c:pt idx="734">
                  <c:v>2.9728509999999999E-5</c:v>
                </c:pt>
                <c:pt idx="735">
                  <c:v>3.0538926666666664E-5</c:v>
                </c:pt>
                <c:pt idx="736">
                  <c:v>3.1431140000000001E-5</c:v>
                </c:pt>
                <c:pt idx="737">
                  <c:v>3.2395986666666661E-5</c:v>
                </c:pt>
                <c:pt idx="738">
                  <c:v>3.3425540000000003E-5</c:v>
                </c:pt>
                <c:pt idx="739">
                  <c:v>3.4512993333333337E-5</c:v>
                </c:pt>
                <c:pt idx="740">
                  <c:v>3.5652543333333332E-5</c:v>
                </c:pt>
                <c:pt idx="741">
                  <c:v>3.6839263333333333E-5</c:v>
                </c:pt>
                <c:pt idx="742">
                  <c:v>3.8068999999999998E-5</c:v>
                </c:pt>
                <c:pt idx="743">
                  <c:v>3.9338226666666666E-5</c:v>
                </c:pt>
                <c:pt idx="744">
                  <c:v>4.0643950000000002E-5</c:v>
                </c:pt>
                <c:pt idx="745">
                  <c:v>4.1983616666666666E-5</c:v>
                </c:pt>
                <c:pt idx="746">
                  <c:v>4.3355016666666671E-5</c:v>
                </c:pt>
                <c:pt idx="747">
                  <c:v>4.475623333333333E-5</c:v>
                </c:pt>
                <c:pt idx="748">
                  <c:v>4.6185540000000003E-5</c:v>
                </c:pt>
                <c:pt idx="749">
                  <c:v>4.7641376666666668E-5</c:v>
                </c:pt>
                <c:pt idx="750">
                  <c:v>4.9122309999999996E-5</c:v>
                </c:pt>
                <c:pt idx="751">
                  <c:v>5.0626976666666669E-5</c:v>
                </c:pt>
                <c:pt idx="752">
                  <c:v>5.2154070000000001E-5</c:v>
                </c:pt>
                <c:pt idx="753">
                  <c:v>5.3702309999999996E-5</c:v>
                </c:pt>
                <c:pt idx="754">
                  <c:v>5.5270446666666671E-5</c:v>
                </c:pt>
                <c:pt idx="755">
                  <c:v>5.6857216666666665E-5</c:v>
                </c:pt>
                <c:pt idx="756">
                  <c:v>5.8461369999999994E-5</c:v>
                </c:pt>
                <c:pt idx="757">
                  <c:v>6.0081633333333338E-5</c:v>
                </c:pt>
                <c:pt idx="758">
                  <c:v>6.1716740000000001E-5</c:v>
                </c:pt>
                <c:pt idx="759">
                  <c:v>6.3365393333333339E-5</c:v>
                </c:pt>
                <c:pt idx="760">
                  <c:v>6.5026303333333329E-5</c:v>
                </c:pt>
                <c:pt idx="761">
                  <c:v>6.6698156666666664E-5</c:v>
                </c:pt>
                <c:pt idx="762">
                  <c:v>6.8379643333333332E-5</c:v>
                </c:pt>
                <c:pt idx="763">
                  <c:v>7.0069443333333338E-5</c:v>
                </c:pt>
                <c:pt idx="764">
                  <c:v>7.1766249999999994E-5</c:v>
                </c:pt>
                <c:pt idx="765">
                  <c:v>7.3468749999999993E-5</c:v>
                </c:pt>
                <c:pt idx="766">
                  <c:v>7.5175640000000002E-5</c:v>
                </c:pt>
                <c:pt idx="767">
                  <c:v>7.6885626666666672E-5</c:v>
                </c:pt>
                <c:pt idx="768">
                  <c:v>7.8597443333333335E-5</c:v>
                </c:pt>
                <c:pt idx="769">
                  <c:v>8.0309833333333335E-5</c:v>
                </c:pt>
                <c:pt idx="770">
                  <c:v>8.2021563333333329E-5</c:v>
                </c:pt>
                <c:pt idx="771">
                  <c:v>8.3731436666666667E-5</c:v>
                </c:pt>
                <c:pt idx="772">
                  <c:v>8.5438269999999996E-5</c:v>
                </c:pt>
                <c:pt idx="773">
                  <c:v>8.7140916666666668E-5</c:v>
                </c:pt>
                <c:pt idx="774">
                  <c:v>8.8838259999999997E-5</c:v>
                </c:pt>
                <c:pt idx="775">
                  <c:v>9.0529216666666664E-5</c:v>
                </c:pt>
                <c:pt idx="776">
                  <c:v>9.2212736666666664E-5</c:v>
                </c:pt>
                <c:pt idx="777">
                  <c:v>9.3887806666666669E-5</c:v>
                </c:pt>
                <c:pt idx="778">
                  <c:v>9.5553430000000001E-5</c:v>
                </c:pt>
                <c:pt idx="779">
                  <c:v>9.7208653333333338E-5</c:v>
                </c:pt>
                <c:pt idx="780">
                  <c:v>9.8852546666666668E-5</c:v>
                </c:pt>
                <c:pt idx="781">
                  <c:v>1.0048420666666666E-4</c:v>
                </c:pt>
                <c:pt idx="782">
                  <c:v>1.0210274E-4</c:v>
                </c:pt>
                <c:pt idx="783">
                  <c:v>1.0370728666666667E-4</c:v>
                </c:pt>
                <c:pt idx="784">
                  <c:v>1.0529698999999999E-4</c:v>
                </c:pt>
                <c:pt idx="785">
                  <c:v>1.06871E-4</c:v>
                </c:pt>
                <c:pt idx="786">
                  <c:v>1.0842846666666668E-4</c:v>
                </c:pt>
                <c:pt idx="787">
                  <c:v>1.0996854666666666E-4</c:v>
                </c:pt>
                <c:pt idx="788">
                  <c:v>1.1149038E-4</c:v>
                </c:pt>
                <c:pt idx="789">
                  <c:v>1.1299308333333332E-4</c:v>
                </c:pt>
                <c:pt idx="790">
                  <c:v>1.1447577333333334E-4</c:v>
                </c:pt>
                <c:pt idx="791">
                  <c:v>1.1593751666666667E-4</c:v>
                </c:pt>
                <c:pt idx="792">
                  <c:v>1.1737738000000001E-4</c:v>
                </c:pt>
                <c:pt idx="793">
                  <c:v>1.1879438333333333E-4</c:v>
                </c:pt>
                <c:pt idx="794">
                  <c:v>1.2018753666666667E-4</c:v>
                </c:pt>
                <c:pt idx="795">
                  <c:v>1.2155583E-4</c:v>
                </c:pt>
                <c:pt idx="796">
                  <c:v>1.2289826000000002E-4</c:v>
                </c:pt>
                <c:pt idx="797">
                  <c:v>1.2421385666666667E-4</c:v>
                </c:pt>
                <c:pt idx="798">
                  <c:v>1.2550174666666665E-4</c:v>
                </c:pt>
                <c:pt idx="799">
                  <c:v>1.2676119E-4</c:v>
                </c:pt>
                <c:pt idx="800">
                  <c:v>1.2799171666666667E-4</c:v>
                </c:pt>
                <c:pt idx="801">
                  <c:v>1.2919324333333332E-4</c:v>
                </c:pt>
                <c:pt idx="802">
                  <c:v>1.3036628E-4</c:v>
                </c:pt>
                <c:pt idx="803">
                  <c:v>1.3151217333333333E-4</c:v>
                </c:pt>
                <c:pt idx="804">
                  <c:v>1.3263347333333333E-4</c:v>
                </c:pt>
                <c:pt idx="805">
                  <c:v>1.3373437E-4</c:v>
                </c:pt>
                <c:pt idx="806">
                  <c:v>1.3482124333333333E-4</c:v>
                </c:pt>
                <c:pt idx="807">
                  <c:v>1.3590339333333334E-4</c:v>
                </c:pt>
                <c:pt idx="808">
                  <c:v>1.3699385000000001E-4</c:v>
                </c:pt>
                <c:pt idx="809">
                  <c:v>1.3811042666666667E-4</c:v>
                </c:pt>
                <c:pt idx="810">
                  <c:v>1.3927684999999999E-4</c:v>
                </c:pt>
                <c:pt idx="811">
                  <c:v>1.4052407666666667E-4</c:v>
                </c:pt>
                <c:pt idx="812">
                  <c:v>1.4189172E-4</c:v>
                </c:pt>
                <c:pt idx="813">
                  <c:v>1.4342949333333334E-4</c:v>
                </c:pt>
                <c:pt idx="814">
                  <c:v>1.4519863999999999E-4</c:v>
                </c:pt>
                <c:pt idx="815">
                  <c:v>1.4727324E-4</c:v>
                </c:pt>
                <c:pt idx="816">
                  <c:v>1.4974117333333334E-4</c:v>
                </c:pt>
                <c:pt idx="817">
                  <c:v>1.5270467666666666E-4</c:v>
                </c:pt>
                <c:pt idx="818">
                  <c:v>1.5628026666666668E-4</c:v>
                </c:pt>
                <c:pt idx="819">
                  <c:v>1.6059776000000001E-4</c:v>
                </c:pt>
                <c:pt idx="820">
                  <c:v>1.6579831666666667E-4</c:v>
                </c:pt>
                <c:pt idx="821">
                  <c:v>1.7203125000000001E-4</c:v>
                </c:pt>
                <c:pt idx="822">
                  <c:v>1.7944950666666667E-4</c:v>
                </c:pt>
                <c:pt idx="823">
                  <c:v>1.8820376000000001E-4</c:v>
                </c:pt>
                <c:pt idx="824">
                  <c:v>1.9843514666666667E-4</c:v>
                </c:pt>
                <c:pt idx="825">
                  <c:v>2.102668066666667E-4</c:v>
                </c:pt>
                <c:pt idx="826">
                  <c:v>2.2379444666666669E-4</c:v>
                </c:pt>
                <c:pt idx="827">
                  <c:v>2.3907647000000001E-4</c:v>
                </c:pt>
                <c:pt idx="828">
                  <c:v>2.5612397666666668E-4</c:v>
                </c:pt>
                <c:pt idx="829">
                  <c:v>2.7489153666666665E-4</c:v>
                </c:pt>
                <c:pt idx="830">
                  <c:v>2.9526918999999997E-4</c:v>
                </c:pt>
                <c:pt idx="831">
                  <c:v>3.1707660333333334E-4</c:v>
                </c:pt>
                <c:pt idx="832">
                  <c:v>3.4005993666666668E-4</c:v>
                </c:pt>
                <c:pt idx="833">
                  <c:v>3.6389211666666666E-4</c:v>
                </c:pt>
                <c:pt idx="834">
                  <c:v>3.8817688666666669E-4</c:v>
                </c:pt>
                <c:pt idx="835">
                  <c:v>4.1245695666666668E-4</c:v>
                </c:pt>
                <c:pt idx="836">
                  <c:v>4.3622607666666667E-4</c:v>
                </c:pt>
                <c:pt idx="837">
                  <c:v>4.5894484333333337E-4</c:v>
                </c:pt>
                <c:pt idx="838">
                  <c:v>4.800595633333334E-4</c:v>
                </c:pt>
                <c:pt idx="839">
                  <c:v>4.9902329333333334E-4</c:v>
                </c:pt>
                <c:pt idx="840">
                  <c:v>5.1531799333333339E-4</c:v>
                </c:pt>
                <c:pt idx="841">
                  <c:v>5.284764766666667E-4</c:v>
                </c:pt>
                <c:pt idx="842">
                  <c:v>5.3810298999999999E-4</c:v>
                </c:pt>
                <c:pt idx="843">
                  <c:v>5.4389099333333334E-4</c:v>
                </c:pt>
                <c:pt idx="844">
                  <c:v>5.4563719000000007E-4</c:v>
                </c:pt>
                <c:pt idx="845">
                  <c:v>5.432507633333334E-4</c:v>
                </c:pt>
                <c:pt idx="846">
                  <c:v>5.3675738333333329E-4</c:v>
                </c:pt>
                <c:pt idx="847">
                  <c:v>5.2629765000000001E-4</c:v>
                </c:pt>
                <c:pt idx="848">
                  <c:v>5.1212012999999994E-4</c:v>
                </c:pt>
                <c:pt idx="849">
                  <c:v>4.9456951666666674E-4</c:v>
                </c:pt>
                <c:pt idx="850">
                  <c:v>4.7407064333333338E-4</c:v>
                </c:pt>
                <c:pt idx="851">
                  <c:v>4.5110943333333329E-4</c:v>
                </c:pt>
                <c:pt idx="852">
                  <c:v>4.2621198E-4</c:v>
                </c:pt>
                <c:pt idx="853">
                  <c:v>3.9992298999999999E-4</c:v>
                </c:pt>
                <c:pt idx="854">
                  <c:v>3.7278482E-4</c:v>
                </c:pt>
                <c:pt idx="855">
                  <c:v>3.4531817666666665E-4</c:v>
                </c:pt>
                <c:pt idx="856">
                  <c:v>3.1800550666666669E-4</c:v>
                </c:pt>
                <c:pt idx="857">
                  <c:v>2.9127753333333333E-4</c:v>
                </c:pt>
                <c:pt idx="858">
                  <c:v>2.655035566666667E-4</c:v>
                </c:pt>
                <c:pt idx="859">
                  <c:v>2.4098553666666666E-4</c:v>
                </c:pt>
                <c:pt idx="860">
                  <c:v>2.1795587333333334E-4</c:v>
                </c:pt>
                <c:pt idx="861">
                  <c:v>1.9657860333333334E-4</c:v>
                </c:pt>
                <c:pt idx="862">
                  <c:v>1.7695347E-4</c:v>
                </c:pt>
                <c:pt idx="863">
                  <c:v>1.5912232999999999E-4</c:v>
                </c:pt>
                <c:pt idx="864">
                  <c:v>1.4307728333333333E-4</c:v>
                </c:pt>
                <c:pt idx="865">
                  <c:v>1.2876987999999999E-4</c:v>
                </c:pt>
                <c:pt idx="866">
                  <c:v>1.1612073666666667E-4</c:v>
                </c:pt>
                <c:pt idx="867">
                  <c:v>1.0502922333333334E-4</c:v>
                </c:pt>
                <c:pt idx="868">
                  <c:v>9.5382653333333332E-5</c:v>
                </c:pt>
                <c:pt idx="869">
                  <c:v>8.7064743333333341E-5</c:v>
                </c:pt>
                <c:pt idx="870">
                  <c:v>7.9963093333333338E-5</c:v>
                </c:pt>
                <c:pt idx="871">
                  <c:v>7.3975559999999994E-5</c:v>
                </c:pt>
                <c:pt idx="872">
                  <c:v>6.9015473333333333E-5</c:v>
                </c:pt>
                <c:pt idx="873">
                  <c:v>6.5015626666666665E-5</c:v>
                </c:pt>
                <c:pt idx="874">
                  <c:v>6.1931076666666668E-5</c:v>
                </c:pt>
                <c:pt idx="875">
                  <c:v>5.9740769999999994E-5</c:v>
                </c:pt>
                <c:pt idx="876">
                  <c:v>5.8447880000000005E-5</c:v>
                </c:pt>
                <c:pt idx="877">
                  <c:v>5.8079006666666667E-5</c:v>
                </c:pt>
                <c:pt idx="878">
                  <c:v>5.868201333333333E-5</c:v>
                </c:pt>
                <c:pt idx="879">
                  <c:v>6.0322656666666663E-5</c:v>
                </c:pt>
                <c:pt idx="880">
                  <c:v>6.3079766666666659E-5</c:v>
                </c:pt>
                <c:pt idx="881">
                  <c:v>6.7039213333333332E-5</c:v>
                </c:pt>
                <c:pt idx="882">
                  <c:v>7.2286606666666669E-5</c:v>
                </c:pt>
                <c:pt idx="883">
                  <c:v>7.889890666666666E-5</c:v>
                </c:pt>
                <c:pt idx="884">
                  <c:v>8.6935300000000001E-5</c:v>
                </c:pt>
                <c:pt idx="885">
                  <c:v>9.642764666666667E-5</c:v>
                </c:pt>
                <c:pt idx="886">
                  <c:v>1.0737110333333334E-4</c:v>
                </c:pt>
                <c:pt idx="887">
                  <c:v>1.1971544333333333E-4</c:v>
                </c:pt>
                <c:pt idx="888">
                  <c:v>1.3335780666666667E-4</c:v>
                </c:pt>
                <c:pt idx="889">
                  <c:v>1.4813758999999998E-4</c:v>
                </c:pt>
                <c:pt idx="890">
                  <c:v>1.6383408666666667E-4</c:v>
                </c:pt>
                <c:pt idx="891">
                  <c:v>1.8016741333333334E-4</c:v>
                </c:pt>
                <c:pt idx="892">
                  <c:v>1.9680313E-4</c:v>
                </c:pt>
                <c:pt idx="893">
                  <c:v>2.1336064666666667E-4</c:v>
                </c:pt>
                <c:pt idx="894">
                  <c:v>2.2942524666666667E-4</c:v>
                </c:pt>
                <c:pt idx="895">
                  <c:v>2.4456331666666663E-4</c:v>
                </c:pt>
                <c:pt idx="896">
                  <c:v>2.5833998666666667E-4</c:v>
                </c:pt>
                <c:pt idx="897">
                  <c:v>2.7033824999999999E-4</c:v>
                </c:pt>
                <c:pt idx="898">
                  <c:v>2.8017835333333331E-4</c:v>
                </c:pt>
                <c:pt idx="899">
                  <c:v>2.8753614666666668E-4</c:v>
                </c:pt>
                <c:pt idx="900">
                  <c:v>2.9215923666666668E-4</c:v>
                </c:pt>
                <c:pt idx="901">
                  <c:v>2.9387976333333332E-4</c:v>
                </c:pt>
                <c:pt idx="902">
                  <c:v>2.9262281666666667E-4</c:v>
                </c:pt>
                <c:pt idx="903">
                  <c:v>2.8841005333333331E-4</c:v>
                </c:pt>
                <c:pt idx="904">
                  <c:v>2.8135812333333335E-4</c:v>
                </c:pt>
                <c:pt idx="905">
                  <c:v>2.7167211999999999E-4</c:v>
                </c:pt>
                <c:pt idx="906">
                  <c:v>2.5963453333333335E-4</c:v>
                </c:pt>
                <c:pt idx="907">
                  <c:v>2.4559056666666667E-4</c:v>
                </c:pt>
                <c:pt idx="908">
                  <c:v>2.2993079999999999E-4</c:v>
                </c:pt>
                <c:pt idx="909">
                  <c:v>2.1307247333333335E-4</c:v>
                </c:pt>
                <c:pt idx="910">
                  <c:v>1.9544060333333334E-4</c:v>
                </c:pt>
                <c:pt idx="911">
                  <c:v>1.7745004666666666E-4</c:v>
                </c:pt>
                <c:pt idx="912">
                  <c:v>1.5948962333333334E-4</c:v>
                </c:pt>
                <c:pt idx="913">
                  <c:v>1.4190896000000001E-4</c:v>
                </c:pt>
                <c:pt idx="914">
                  <c:v>1.2500866666666666E-4</c:v>
                </c:pt>
                <c:pt idx="915">
                  <c:v>1.0903402666666666E-4</c:v>
                </c:pt>
                <c:pt idx="916">
                  <c:v>9.4172183333333343E-5</c:v>
                </c:pt>
                <c:pt idx="917">
                  <c:v>8.055250333333333E-5</c:v>
                </c:pt>
                <c:pt idx="918">
                  <c:v>6.8249756666666664E-5</c:v>
                </c:pt>
                <c:pt idx="919">
                  <c:v>5.7289430000000003E-5</c:v>
                </c:pt>
                <c:pt idx="920">
                  <c:v>4.7654596666666665E-5</c:v>
                </c:pt>
                <c:pt idx="921">
                  <c:v>3.9293673333333336E-5</c:v>
                </c:pt>
                <c:pt idx="922">
                  <c:v>3.2128473333333332E-5</c:v>
                </c:pt>
                <c:pt idx="923">
                  <c:v>2.6062089999999998E-5</c:v>
                </c:pt>
                <c:pt idx="924">
                  <c:v>2.0986089999999998E-5</c:v>
                </c:pt>
                <c:pt idx="925">
                  <c:v>1.6786886666666668E-5</c:v>
                </c:pt>
                <c:pt idx="926">
                  <c:v>1.3350993333333332E-5</c:v>
                </c:pt>
                <c:pt idx="927">
                  <c:v>1.056917E-5</c:v>
                </c:pt>
                <c:pt idx="928">
                  <c:v>8.3394433333333343E-6</c:v>
                </c:pt>
                <c:pt idx="929">
                  <c:v>6.5690766666666659E-6</c:v>
                </c:pt>
                <c:pt idx="930">
                  <c:v>5.1757266666666668E-6</c:v>
                </c:pt>
                <c:pt idx="931">
                  <c:v>4.0877400000000001E-6</c:v>
                </c:pt>
                <c:pt idx="932">
                  <c:v>3.2440266666666668E-6</c:v>
                </c:pt>
                <c:pt idx="933">
                  <c:v>2.5933666666666666E-6</c:v>
                </c:pt>
                <c:pt idx="934">
                  <c:v>2.0935766666666666E-6</c:v>
                </c:pt>
                <c:pt idx="935">
                  <c:v>1.7104366666666666E-6</c:v>
                </c:pt>
                <c:pt idx="936">
                  <c:v>1.41662E-6</c:v>
                </c:pt>
                <c:pt idx="937">
                  <c:v>1.1905966666666667E-6</c:v>
                </c:pt>
                <c:pt idx="938">
                  <c:v>1.0156466666666668E-6</c:v>
                </c:pt>
                <c:pt idx="939">
                  <c:v>8.7894666666666675E-7</c:v>
                </c:pt>
                <c:pt idx="940">
                  <c:v>7.7078333333333329E-7</c:v>
                </c:pt>
                <c:pt idx="941">
                  <c:v>6.8386999999999994E-7</c:v>
                </c:pt>
                <c:pt idx="942">
                  <c:v>6.1281000000000005E-7</c:v>
                </c:pt>
                <c:pt idx="943">
                  <c:v>5.5363333333333328E-7</c:v>
                </c:pt>
                <c:pt idx="944">
                  <c:v>5.034466666666666E-7</c:v>
                </c:pt>
                <c:pt idx="945">
                  <c:v>4.6015E-7</c:v>
                </c:pt>
                <c:pt idx="946">
                  <c:v>4.2222666666666662E-7</c:v>
                </c:pt>
                <c:pt idx="947">
                  <c:v>3.8857333333333331E-7</c:v>
                </c:pt>
                <c:pt idx="948">
                  <c:v>3.5839000000000002E-7</c:v>
                </c:pt>
                <c:pt idx="949">
                  <c:v>3.3109999999999999E-7</c:v>
                </c:pt>
                <c:pt idx="950">
                  <c:v>3.0625999999999999E-7</c:v>
                </c:pt>
                <c:pt idx="951">
                  <c:v>2.8354333333333333E-7</c:v>
                </c:pt>
                <c:pt idx="952">
                  <c:v>2.6269666666666667E-7</c:v>
                </c:pt>
                <c:pt idx="953">
                  <c:v>2.4350999999999999E-7</c:v>
                </c:pt>
                <c:pt idx="954">
                  <c:v>2.2582666666666669E-7</c:v>
                </c:pt>
                <c:pt idx="955">
                  <c:v>2.0950666666666666E-7</c:v>
                </c:pt>
                <c:pt idx="956">
                  <c:v>1.9441666666666667E-7</c:v>
                </c:pt>
                <c:pt idx="957">
                  <c:v>1.8047E-7</c:v>
                </c:pt>
                <c:pt idx="958">
                  <c:v>1.6756666666666666E-7</c:v>
                </c:pt>
                <c:pt idx="959">
                  <c:v>1.5561666666666667E-7</c:v>
                </c:pt>
                <c:pt idx="960">
                  <c:v>1.4455333333333333E-7</c:v>
                </c:pt>
                <c:pt idx="961">
                  <c:v>1.343E-7</c:v>
                </c:pt>
                <c:pt idx="962">
                  <c:v>1.2480666666666667E-7</c:v>
                </c:pt>
                <c:pt idx="963">
                  <c:v>1.1600666666666666E-7</c:v>
                </c:pt>
                <c:pt idx="964">
                  <c:v>1.0784666666666667E-7</c:v>
                </c:pt>
                <c:pt idx="965">
                  <c:v>1.0028E-7</c:v>
                </c:pt>
                <c:pt idx="966">
                  <c:v>9.325666666666667E-8</c:v>
                </c:pt>
                <c:pt idx="967">
                  <c:v>8.6743333333333327E-8</c:v>
                </c:pt>
                <c:pt idx="968">
                  <c:v>8.0696666666666669E-8</c:v>
                </c:pt>
                <c:pt idx="969">
                  <c:v>7.5083333333333341E-8</c:v>
                </c:pt>
                <c:pt idx="970">
                  <c:v>6.9870000000000003E-8</c:v>
                </c:pt>
                <c:pt idx="971">
                  <c:v>6.5029999999999994E-8</c:v>
                </c:pt>
                <c:pt idx="972">
                  <c:v>6.053E-8</c:v>
                </c:pt>
                <c:pt idx="973">
                  <c:v>5.6349999999999998E-8</c:v>
                </c:pt>
                <c:pt idx="974">
                  <c:v>5.2463333333333334E-8</c:v>
                </c:pt>
                <c:pt idx="975">
                  <c:v>4.8849999999999997E-8</c:v>
                </c:pt>
                <c:pt idx="976">
                  <c:v>4.5493333333333332E-8</c:v>
                </c:pt>
                <c:pt idx="977">
                  <c:v>4.2366666666666669E-8</c:v>
                </c:pt>
                <c:pt idx="978">
                  <c:v>3.946333333333333E-8</c:v>
                </c:pt>
                <c:pt idx="979">
                  <c:v>3.6756666666666667E-8</c:v>
                </c:pt>
                <c:pt idx="980">
                  <c:v>3.4240000000000001E-8</c:v>
                </c:pt>
                <c:pt idx="981">
                  <c:v>3.1900000000000001E-8</c:v>
                </c:pt>
                <c:pt idx="982">
                  <c:v>2.9719999999999997E-8</c:v>
                </c:pt>
                <c:pt idx="983">
                  <c:v>2.7686666666666666E-8</c:v>
                </c:pt>
                <c:pt idx="984">
                  <c:v>2.5796666666666663E-8</c:v>
                </c:pt>
                <c:pt idx="985">
                  <c:v>2.4036666666666666E-8</c:v>
                </c:pt>
                <c:pt idx="986">
                  <c:v>2.2396666666666666E-8</c:v>
                </c:pt>
                <c:pt idx="987">
                  <c:v>2.0866666666666665E-8</c:v>
                </c:pt>
                <c:pt idx="988">
                  <c:v>1.9446666666666666E-8</c:v>
                </c:pt>
                <c:pt idx="989">
                  <c:v>1.8119999999999999E-8</c:v>
                </c:pt>
                <c:pt idx="990">
                  <c:v>1.6883333333333336E-8</c:v>
                </c:pt>
                <c:pt idx="991">
                  <c:v>1.5736666666666668E-8</c:v>
                </c:pt>
                <c:pt idx="992">
                  <c:v>1.4663333333333333E-8</c:v>
                </c:pt>
                <c:pt idx="993">
                  <c:v>1.3663333333333332E-8</c:v>
                </c:pt>
                <c:pt idx="994">
                  <c:v>1.2730000000000001E-8</c:v>
                </c:pt>
                <c:pt idx="995">
                  <c:v>1.186E-8</c:v>
                </c:pt>
                <c:pt idx="996">
                  <c:v>1.1053333333333332E-8</c:v>
                </c:pt>
                <c:pt idx="997">
                  <c:v>1.0296666666666667E-8</c:v>
                </c:pt>
                <c:pt idx="998">
                  <c:v>9.5966666666666672E-9</c:v>
                </c:pt>
                <c:pt idx="999">
                  <c:v>8.940000000000001E-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644-4E56-94C6-D1419AEF9F18}"/>
            </c:ext>
          </c:extLst>
        </c:ser>
        <c:ser>
          <c:idx val="1"/>
          <c:order val="1"/>
          <c:tx>
            <c:strRef>
              <c:f>'[データまとめ (自動保存済み).xlsx]TM粒子数'!$C$1</c:f>
              <c:strCache>
                <c:ptCount val="1"/>
                <c:pt idx="0">
                  <c:v>TM (n=7)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1"/>
            <c:plus>
              <c:numRef>
                <c:f>'[データまとめ (自動保存済み).xlsx]TM粒子数'!$G$3:$G$1002</c:f>
                <c:numCache>
                  <c:formatCode>General</c:formatCode>
                  <c:ptCount val="1000"/>
                  <c:pt idx="0">
                    <c:v>0</c:v>
                  </c:pt>
                  <c:pt idx="1">
                    <c:v>0</c:v>
                  </c:pt>
                  <c:pt idx="2">
                    <c:v>5.8084486570640593E-10</c:v>
                  </c:pt>
                  <c:pt idx="3">
                    <c:v>1.7086840602832018E-7</c:v>
                  </c:pt>
                  <c:pt idx="4">
                    <c:v>2.8681614417274375E-6</c:v>
                  </c:pt>
                  <c:pt idx="5">
                    <c:v>1.0624136515881482E-5</c:v>
                  </c:pt>
                  <c:pt idx="6">
                    <c:v>1.7740163923992588E-5</c:v>
                  </c:pt>
                  <c:pt idx="7">
                    <c:v>1.898281617235804E-5</c:v>
                  </c:pt>
                  <c:pt idx="8">
                    <c:v>4.0749336541968202E-5</c:v>
                  </c:pt>
                  <c:pt idx="9">
                    <c:v>6.5103333540804503E-5</c:v>
                  </c:pt>
                  <c:pt idx="10">
                    <c:v>8.1673429625389113E-5</c:v>
                  </c:pt>
                  <c:pt idx="11">
                    <c:v>7.3418676196899724E-5</c:v>
                  </c:pt>
                  <c:pt idx="12">
                    <c:v>3.8997690833980366E-5</c:v>
                  </c:pt>
                  <c:pt idx="13">
                    <c:v>1.8864711089629475E-5</c:v>
                  </c:pt>
                  <c:pt idx="14">
                    <c:v>1.2735764180774528E-5</c:v>
                  </c:pt>
                  <c:pt idx="15">
                    <c:v>2.796265988028986E-5</c:v>
                  </c:pt>
                  <c:pt idx="16">
                    <c:v>5.1828335878684213E-5</c:v>
                  </c:pt>
                  <c:pt idx="17">
                    <c:v>5.9705633321227579E-5</c:v>
                  </c:pt>
                  <c:pt idx="18">
                    <c:v>7.42183549160471E-5</c:v>
                  </c:pt>
                  <c:pt idx="19">
                    <c:v>1.0033330608583059E-4</c:v>
                  </c:pt>
                  <c:pt idx="20">
                    <c:v>9.2509447792540845E-5</c:v>
                  </c:pt>
                  <c:pt idx="21">
                    <c:v>1.1080597718167802E-3</c:v>
                  </c:pt>
                  <c:pt idx="22">
                    <c:v>4.0687642876634212E-4</c:v>
                  </c:pt>
                  <c:pt idx="23">
                    <c:v>1.5457694004334646E-4</c:v>
                  </c:pt>
                  <c:pt idx="24">
                    <c:v>1.3149272177172066E-4</c:v>
                  </c:pt>
                  <c:pt idx="25">
                    <c:v>1.2379723103897767E-4</c:v>
                  </c:pt>
                  <c:pt idx="26">
                    <c:v>1.1564806213492276E-4</c:v>
                  </c:pt>
                  <c:pt idx="27">
                    <c:v>9.7205139607061021E-5</c:v>
                  </c:pt>
                  <c:pt idx="28">
                    <c:v>7.7583328219336088E-5</c:v>
                  </c:pt>
                  <c:pt idx="29">
                    <c:v>6.6685409874775074E-5</c:v>
                  </c:pt>
                  <c:pt idx="30">
                    <c:v>6.2792069722673684E-5</c:v>
                  </c:pt>
                  <c:pt idx="31">
                    <c:v>6.6454315719092577E-5</c:v>
                  </c:pt>
                  <c:pt idx="32">
                    <c:v>9.6942442004818496E-5</c:v>
                  </c:pt>
                  <c:pt idx="33">
                    <c:v>1.9570037422755746E-4</c:v>
                  </c:pt>
                  <c:pt idx="34">
                    <c:v>3.736221434867457E-4</c:v>
                  </c:pt>
                  <c:pt idx="35">
                    <c:v>5.6274007643724721E-4</c:v>
                  </c:pt>
                  <c:pt idx="36">
                    <c:v>6.6422049081856036E-4</c:v>
                  </c:pt>
                  <c:pt idx="37">
                    <c:v>7.5903394894775696E-4</c:v>
                  </c:pt>
                  <c:pt idx="38">
                    <c:v>1.0838161253838763E-3</c:v>
                  </c:pt>
                  <c:pt idx="39">
                    <c:v>1.2025436908868906E-3</c:v>
                  </c:pt>
                  <c:pt idx="40">
                    <c:v>8.126507018919102E-4</c:v>
                  </c:pt>
                  <c:pt idx="41">
                    <c:v>3.641579130724533E-4</c:v>
                  </c:pt>
                  <c:pt idx="42">
                    <c:v>2.239198978382396E-4</c:v>
                  </c:pt>
                  <c:pt idx="43">
                    <c:v>1.9791439347731878E-4</c:v>
                  </c:pt>
                  <c:pt idx="44">
                    <c:v>1.4575298575845733E-4</c:v>
                  </c:pt>
                  <c:pt idx="45">
                    <c:v>9.8053707662239874E-5</c:v>
                  </c:pt>
                  <c:pt idx="46">
                    <c:v>7.4819708462938817E-5</c:v>
                  </c:pt>
                  <c:pt idx="47">
                    <c:v>7.0753111768250056E-5</c:v>
                  </c:pt>
                  <c:pt idx="48">
                    <c:v>1.3503450123844555E-4</c:v>
                  </c:pt>
                  <c:pt idx="49">
                    <c:v>3.5512637968031403E-4</c:v>
                  </c:pt>
                  <c:pt idx="50">
                    <c:v>5.9272738163902131E-4</c:v>
                  </c:pt>
                  <c:pt idx="51">
                    <c:v>5.64149138098683E-4</c:v>
                  </c:pt>
                  <c:pt idx="52">
                    <c:v>3.7807673206303528E-4</c:v>
                  </c:pt>
                  <c:pt idx="53">
                    <c:v>4.5232303105235668E-4</c:v>
                  </c:pt>
                  <c:pt idx="54">
                    <c:v>7.1693701079030307E-4</c:v>
                  </c:pt>
                  <c:pt idx="55">
                    <c:v>1.0051679568564738E-3</c:v>
                  </c:pt>
                  <c:pt idx="56">
                    <c:v>1.2860538030944953E-3</c:v>
                  </c:pt>
                  <c:pt idx="57">
                    <c:v>1.5351418701990938E-3</c:v>
                  </c:pt>
                  <c:pt idx="58">
                    <c:v>1.7018877314322802E-3</c:v>
                  </c:pt>
                  <c:pt idx="59">
                    <c:v>1.8059508578817864E-3</c:v>
                  </c:pt>
                  <c:pt idx="60">
                    <c:v>1.9164569367619328E-3</c:v>
                  </c:pt>
                  <c:pt idx="61">
                    <c:v>2.0398063716712848E-3</c:v>
                  </c:pt>
                  <c:pt idx="62">
                    <c:v>2.1562305091273651E-3</c:v>
                  </c:pt>
                  <c:pt idx="63">
                    <c:v>2.2883495382186414E-3</c:v>
                  </c:pt>
                  <c:pt idx="64">
                    <c:v>2.5218292108348844E-3</c:v>
                  </c:pt>
                  <c:pt idx="65">
                    <c:v>2.9518567248317702E-3</c:v>
                  </c:pt>
                  <c:pt idx="66">
                    <c:v>3.4966400602694371E-3</c:v>
                  </c:pt>
                  <c:pt idx="67">
                    <c:v>3.8870602437675772E-3</c:v>
                  </c:pt>
                  <c:pt idx="68">
                    <c:v>3.9396700331787663E-3</c:v>
                  </c:pt>
                  <c:pt idx="69">
                    <c:v>3.7146602012467205E-3</c:v>
                  </c:pt>
                  <c:pt idx="70">
                    <c:v>3.4428410324182099E-3</c:v>
                  </c:pt>
                  <c:pt idx="71">
                    <c:v>3.4120592785969427E-3</c:v>
                  </c:pt>
                  <c:pt idx="72">
                    <c:v>3.6897198583409289E-3</c:v>
                  </c:pt>
                  <c:pt idx="73">
                    <c:v>3.8807455658746272E-3</c:v>
                  </c:pt>
                  <c:pt idx="74">
                    <c:v>3.6480162974906259E-3</c:v>
                  </c:pt>
                  <c:pt idx="75">
                    <c:v>3.1472796545596211E-3</c:v>
                  </c:pt>
                  <c:pt idx="76">
                    <c:v>2.7810069064615737E-3</c:v>
                  </c:pt>
                  <c:pt idx="77">
                    <c:v>2.7212872249787585E-3</c:v>
                  </c:pt>
                  <c:pt idx="78">
                    <c:v>2.8467322830635334E-3</c:v>
                  </c:pt>
                  <c:pt idx="79">
                    <c:v>3.0237219479089202E-3</c:v>
                  </c:pt>
                  <c:pt idx="80">
                    <c:v>3.1914597110701787E-3</c:v>
                  </c:pt>
                  <c:pt idx="81">
                    <c:v>3.3138545390248323E-3</c:v>
                  </c:pt>
                  <c:pt idx="82">
                    <c:v>3.3674883341994772E-3</c:v>
                  </c:pt>
                  <c:pt idx="83">
                    <c:v>3.3582338631542867E-3</c:v>
                  </c:pt>
                  <c:pt idx="84">
                    <c:v>3.3203670273984458E-3</c:v>
                  </c:pt>
                  <c:pt idx="85">
                    <c:v>3.2916454059400209E-3</c:v>
                  </c:pt>
                  <c:pt idx="86">
                    <c:v>3.2901113574121846E-3</c:v>
                  </c:pt>
                  <c:pt idx="87">
                    <c:v>3.313584513047794E-3</c:v>
                  </c:pt>
                  <c:pt idx="88">
                    <c:v>3.354147919842604E-3</c:v>
                  </c:pt>
                  <c:pt idx="89">
                    <c:v>3.4059935812221901E-3</c:v>
                  </c:pt>
                  <c:pt idx="90">
                    <c:v>3.4608835402504326E-3</c:v>
                  </c:pt>
                  <c:pt idx="91">
                    <c:v>3.5027321702970505E-3</c:v>
                  </c:pt>
                  <c:pt idx="92">
                    <c:v>3.5106709345531536E-3</c:v>
                  </c:pt>
                  <c:pt idx="93">
                    <c:v>3.4682805854916112E-3</c:v>
                  </c:pt>
                  <c:pt idx="94">
                    <c:v>3.3705985616398915E-3</c:v>
                  </c:pt>
                  <c:pt idx="95">
                    <c:v>3.2235495649920645E-3</c:v>
                  </c:pt>
                  <c:pt idx="96">
                    <c:v>3.0383538757567702E-3</c:v>
                  </c:pt>
                  <c:pt idx="97">
                    <c:v>2.8278956664312548E-3</c:v>
                  </c:pt>
                  <c:pt idx="98">
                    <c:v>2.6080487312204431E-3</c:v>
                  </c:pt>
                  <c:pt idx="99">
                    <c:v>2.4001692738083256E-3</c:v>
                  </c:pt>
                  <c:pt idx="100">
                    <c:v>2.2287062416762623E-3</c:v>
                  </c:pt>
                  <c:pt idx="101">
                    <c:v>2.1113478582774369E-3</c:v>
                  </c:pt>
                  <c:pt idx="102">
                    <c:v>2.0481256858158347E-3</c:v>
                  </c:pt>
                  <c:pt idx="103">
                    <c:v>2.0227118539618374E-3</c:v>
                  </c:pt>
                  <c:pt idx="104">
                    <c:v>2.0171721860598388E-3</c:v>
                  </c:pt>
                  <c:pt idx="105">
                    <c:v>2.0228142052068966E-3</c:v>
                  </c:pt>
                  <c:pt idx="106">
                    <c:v>2.0357422140288104E-3</c:v>
                  </c:pt>
                  <c:pt idx="107">
                    <c:v>2.047534289693067E-3</c:v>
                  </c:pt>
                  <c:pt idx="108">
                    <c:v>2.0458561369230545E-3</c:v>
                  </c:pt>
                  <c:pt idx="109">
                    <c:v>2.0229891838582825E-3</c:v>
                  </c:pt>
                  <c:pt idx="110">
                    <c:v>1.9810124666986085E-3</c:v>
                  </c:pt>
                  <c:pt idx="111">
                    <c:v>1.9299095433556515E-3</c:v>
                  </c:pt>
                  <c:pt idx="112">
                    <c:v>1.8819693085915725E-3</c:v>
                  </c:pt>
                  <c:pt idx="113">
                    <c:v>1.8459823099805854E-3</c:v>
                  </c:pt>
                  <c:pt idx="114">
                    <c:v>1.8234881130997904E-3</c:v>
                  </c:pt>
                  <c:pt idx="115">
                    <c:v>1.8089358209642322E-3</c:v>
                  </c:pt>
                  <c:pt idx="116">
                    <c:v>1.7941355629008521E-3</c:v>
                  </c:pt>
                  <c:pt idx="117">
                    <c:v>1.7748405814649417E-3</c:v>
                  </c:pt>
                  <c:pt idx="118">
                    <c:v>1.755759288858286E-3</c:v>
                  </c:pt>
                  <c:pt idx="119">
                    <c:v>1.7499213328989159E-3</c:v>
                  </c:pt>
                  <c:pt idx="120">
                    <c:v>1.7696951569413182E-3</c:v>
                  </c:pt>
                  <c:pt idx="121">
                    <c:v>1.8138508934788559E-3</c:v>
                  </c:pt>
                  <c:pt idx="122">
                    <c:v>1.8634155147822025E-3</c:v>
                  </c:pt>
                  <c:pt idx="123">
                    <c:v>1.8919544247240692E-3</c:v>
                  </c:pt>
                  <c:pt idx="124">
                    <c:v>1.8794962090690904E-3</c:v>
                  </c:pt>
                  <c:pt idx="125">
                    <c:v>1.8185203371303088E-3</c:v>
                  </c:pt>
                  <c:pt idx="126">
                    <c:v>1.7118632942888185E-3</c:v>
                  </c:pt>
                  <c:pt idx="127">
                    <c:v>1.5684926403650981E-3</c:v>
                  </c:pt>
                  <c:pt idx="128">
                    <c:v>1.4008285760161064E-3</c:v>
                  </c:pt>
                  <c:pt idx="129">
                    <c:v>1.2233092276367147E-3</c:v>
                  </c:pt>
                  <c:pt idx="130">
                    <c:v>1.0507324593765207E-3</c:v>
                  </c:pt>
                  <c:pt idx="131">
                    <c:v>8.9590489625892785E-4</c:v>
                  </c:pt>
                  <c:pt idx="132">
                    <c:v>7.6717746026269587E-4</c:v>
                  </c:pt>
                  <c:pt idx="133">
                    <c:v>6.6691502177876425E-4</c:v>
                  </c:pt>
                  <c:pt idx="134">
                    <c:v>5.919631636811597E-4</c:v>
                  </c:pt>
                  <c:pt idx="135">
                    <c:v>5.3626365727092956E-4</c:v>
                  </c:pt>
                  <c:pt idx="136">
                    <c:v>4.9410788154886454E-4</c:v>
                  </c:pt>
                  <c:pt idx="137">
                    <c:v>4.621372356691668E-4</c:v>
                  </c:pt>
                  <c:pt idx="138">
                    <c:v>4.3966911360863883E-4</c:v>
                  </c:pt>
                  <c:pt idx="139">
                    <c:v>4.2799630559662644E-4</c:v>
                  </c:pt>
                  <c:pt idx="140">
                    <c:v>4.2876826175649343E-4</c:v>
                  </c:pt>
                  <c:pt idx="141">
                    <c:v>4.4121242169196869E-4</c:v>
                  </c:pt>
                  <c:pt idx="142">
                    <c:v>4.5999490142116544E-4</c:v>
                  </c:pt>
                  <c:pt idx="143">
                    <c:v>4.7700405044262827E-4</c:v>
                  </c:pt>
                  <c:pt idx="144">
                    <c:v>4.8676056716635954E-4</c:v>
                  </c:pt>
                  <c:pt idx="145">
                    <c:v>4.9079940433093818E-4</c:v>
                  </c:pt>
                  <c:pt idx="146">
                    <c:v>4.9680260118877017E-4</c:v>
                  </c:pt>
                  <c:pt idx="147">
                    <c:v>5.1272637843641103E-4</c:v>
                  </c:pt>
                  <c:pt idx="148">
                    <c:v>5.4135686653674839E-4</c:v>
                  </c:pt>
                  <c:pt idx="149">
                    <c:v>5.8036829334266195E-4</c:v>
                  </c:pt>
                  <c:pt idx="150">
                    <c:v>6.2607684107456572E-4</c:v>
                  </c:pt>
                  <c:pt idx="151">
                    <c:v>6.7625872947711272E-4</c:v>
                  </c:pt>
                  <c:pt idx="152">
                    <c:v>7.3087352680641733E-4</c:v>
                  </c:pt>
                  <c:pt idx="153">
                    <c:v>7.9171241372663029E-4</c:v>
                  </c:pt>
                  <c:pt idx="154">
                    <c:v>8.6092265137062299E-4</c:v>
                  </c:pt>
                  <c:pt idx="155">
                    <c:v>9.3739413507737737E-4</c:v>
                  </c:pt>
                  <c:pt idx="156">
                    <c:v>1.0122777627093761E-3</c:v>
                  </c:pt>
                  <c:pt idx="157">
                    <c:v>1.0680656523157114E-3</c:v>
                  </c:pt>
                  <c:pt idx="158">
                    <c:v>1.0840559310530868E-3</c:v>
                  </c:pt>
                  <c:pt idx="159">
                    <c:v>1.0459279063382097E-3</c:v>
                  </c:pt>
                  <c:pt idx="160">
                    <c:v>9.5422203591019172E-4</c:v>
                  </c:pt>
                  <c:pt idx="161">
                    <c:v>8.2695821205084361E-4</c:v>
                  </c:pt>
                  <c:pt idx="162">
                    <c:v>6.9396100284576919E-4</c:v>
                  </c:pt>
                  <c:pt idx="163">
                    <c:v>5.8377982046681936E-4</c:v>
                  </c:pt>
                  <c:pt idx="164">
                    <c:v>5.0921977322342354E-4</c:v>
                  </c:pt>
                  <c:pt idx="165">
                    <c:v>4.6394552623144921E-4</c:v>
                  </c:pt>
                  <c:pt idx="166">
                    <c:v>4.3465274656882759E-4</c:v>
                  </c:pt>
                  <c:pt idx="167">
                    <c:v>4.1282862291154576E-4</c:v>
                  </c:pt>
                  <c:pt idx="168">
                    <c:v>3.9584841694498041E-4</c:v>
                  </c:pt>
                  <c:pt idx="169">
                    <c:v>3.8370717641764444E-4</c:v>
                  </c:pt>
                  <c:pt idx="170">
                    <c:v>3.7714813099995026E-4</c:v>
                  </c:pt>
                  <c:pt idx="171">
                    <c:v>3.7717194529390043E-4</c:v>
                  </c:pt>
                  <c:pt idx="172">
                    <c:v>3.8410574035491326E-4</c:v>
                  </c:pt>
                  <c:pt idx="173">
                    <c:v>3.9577396065796613E-4</c:v>
                  </c:pt>
                  <c:pt idx="174">
                    <c:v>4.0696895338405498E-4</c:v>
                  </c:pt>
                  <c:pt idx="175">
                    <c:v>4.1221902553948098E-4</c:v>
                  </c:pt>
                  <c:pt idx="176">
                    <c:v>4.0939808053487515E-4</c:v>
                  </c:pt>
                  <c:pt idx="177">
                    <c:v>4.0031609362936149E-4</c:v>
                  </c:pt>
                  <c:pt idx="178">
                    <c:v>3.8859274900788105E-4</c:v>
                  </c:pt>
                  <c:pt idx="179">
                    <c:v>3.7747961482146594E-4</c:v>
                  </c:pt>
                  <c:pt idx="180">
                    <c:v>3.6849614548452032E-4</c:v>
                  </c:pt>
                  <c:pt idx="181">
                    <c:v>3.6098144089138332E-4</c:v>
                  </c:pt>
                  <c:pt idx="182">
                    <c:v>3.530740330680266E-4</c:v>
                  </c:pt>
                  <c:pt idx="183">
                    <c:v>3.4338279768320404E-4</c:v>
                  </c:pt>
                  <c:pt idx="184">
                    <c:v>3.3188052371095731E-4</c:v>
                  </c:pt>
                  <c:pt idx="185">
                    <c:v>3.196681627133859E-4</c:v>
                  </c:pt>
                  <c:pt idx="186">
                    <c:v>3.0823459850459848E-4</c:v>
                  </c:pt>
                  <c:pt idx="187">
                    <c:v>2.9881169013640458E-4</c:v>
                  </c:pt>
                  <c:pt idx="188">
                    <c:v>2.9202941112568175E-4</c:v>
                  </c:pt>
                  <c:pt idx="189">
                    <c:v>2.8781381028470651E-4</c:v>
                  </c:pt>
                  <c:pt idx="190">
                    <c:v>2.8543089152072263E-4</c:v>
                  </c:pt>
                  <c:pt idx="191">
                    <c:v>2.8367039064404058E-4</c:v>
                  </c:pt>
                  <c:pt idx="192">
                    <c:v>2.8121469057420254E-4</c:v>
                  </c:pt>
                  <c:pt idx="193">
                    <c:v>2.771381339755897E-4</c:v>
                  </c:pt>
                  <c:pt idx="194">
                    <c:v>2.7132070842239363E-4</c:v>
                  </c:pt>
                  <c:pt idx="195">
                    <c:v>2.6453629015036706E-4</c:v>
                  </c:pt>
                  <c:pt idx="196">
                    <c:v>2.5815454718418042E-4</c:v>
                  </c:pt>
                  <c:pt idx="197">
                    <c:v>2.5362938772511499E-4</c:v>
                  </c:pt>
                  <c:pt idx="198">
                    <c:v>2.5203461202015764E-4</c:v>
                  </c:pt>
                  <c:pt idx="199">
                    <c:v>2.5380969811781998E-4</c:v>
                  </c:pt>
                  <c:pt idx="200">
                    <c:v>2.5873497151523349E-4</c:v>
                  </c:pt>
                  <c:pt idx="201">
                    <c:v>2.6608057362135108E-4</c:v>
                  </c:pt>
                  <c:pt idx="202">
                    <c:v>2.7485077798312675E-4</c:v>
                  </c:pt>
                  <c:pt idx="203">
                    <c:v>2.8404458161974266E-4</c:v>
                  </c:pt>
                  <c:pt idx="204">
                    <c:v>2.9288087754566453E-4</c:v>
                  </c:pt>
                  <c:pt idx="205">
                    <c:v>3.0097117033214436E-4</c:v>
                  </c:pt>
                  <c:pt idx="206">
                    <c:v>3.0842471593223837E-4</c:v>
                  </c:pt>
                  <c:pt idx="207">
                    <c:v>3.1583570044628814E-4</c:v>
                  </c:pt>
                  <c:pt idx="208">
                    <c:v>3.2407196531566225E-4</c:v>
                  </c:pt>
                  <c:pt idx="209">
                    <c:v>3.3382983142108585E-4</c:v>
                  </c:pt>
                  <c:pt idx="210">
                    <c:v>3.4507748644584601E-4</c:v>
                  </c:pt>
                  <c:pt idx="211">
                    <c:v>3.5668088893406054E-4</c:v>
                  </c:pt>
                  <c:pt idx="212">
                    <c:v>3.6648616631822966E-4</c:v>
                  </c:pt>
                  <c:pt idx="213">
                    <c:v>3.7187694422106591E-4</c:v>
                  </c:pt>
                  <c:pt idx="214">
                    <c:v>3.7056285792525802E-4</c:v>
                  </c:pt>
                  <c:pt idx="215">
                    <c:v>3.612846953242491E-4</c:v>
                  </c:pt>
                  <c:pt idx="216">
                    <c:v>3.4421001923279088E-4</c:v>
                  </c:pt>
                  <c:pt idx="217">
                    <c:v>3.2092712546701106E-4</c:v>
                  </c:pt>
                  <c:pt idx="218">
                    <c:v>2.9406786986818417E-4</c:v>
                  </c:pt>
                  <c:pt idx="219">
                    <c:v>2.6668361128255071E-4</c:v>
                  </c:pt>
                  <c:pt idx="220">
                    <c:v>2.415491295079037E-4</c:v>
                  </c:pt>
                  <c:pt idx="221">
                    <c:v>2.2057846741311689E-4</c:v>
                  </c:pt>
                  <c:pt idx="222">
                    <c:v>2.0452022059838293E-4</c:v>
                  </c:pt>
                  <c:pt idx="223">
                    <c:v>1.9303916379662431E-4</c:v>
                  </c:pt>
                  <c:pt idx="224">
                    <c:v>1.8514216940101943E-4</c:v>
                  </c:pt>
                  <c:pt idx="225">
                    <c:v>1.7974333998255521E-4</c:v>
                  </c:pt>
                  <c:pt idx="226">
                    <c:v>1.7616037669162252E-4</c:v>
                  </c:pt>
                  <c:pt idx="227">
                    <c:v>1.7447087754080402E-4</c:v>
                  </c:pt>
                  <c:pt idx="228">
                    <c:v>1.7570182198131478E-4</c:v>
                  </c:pt>
                  <c:pt idx="229">
                    <c:v>1.8165794850774373E-4</c:v>
                  </c:pt>
                  <c:pt idx="230">
                    <c:v>1.9407358684382986E-4</c:v>
                  </c:pt>
                  <c:pt idx="231">
                    <c:v>2.1325502970598326E-4</c:v>
                  </c:pt>
                  <c:pt idx="232">
                    <c:v>2.3719923061153256E-4</c:v>
                  </c:pt>
                  <c:pt idx="233">
                    <c:v>2.6191486547837926E-4</c:v>
                  </c:pt>
                  <c:pt idx="234">
                    <c:v>2.8256975898968174E-4</c:v>
                  </c:pt>
                  <c:pt idx="235">
                    <c:v>2.9476304566424807E-4</c:v>
                  </c:pt>
                  <c:pt idx="236">
                    <c:v>2.9554794992199811E-4</c:v>
                  </c:pt>
                  <c:pt idx="237">
                    <c:v>2.8404026090464337E-4</c:v>
                  </c:pt>
                  <c:pt idx="238">
                    <c:v>2.6151922304592492E-4</c:v>
                  </c:pt>
                  <c:pt idx="239">
                    <c:v>2.3102818740441142E-4</c:v>
                  </c:pt>
                  <c:pt idx="240">
                    <c:v>1.9661470303523949E-4</c:v>
                  </c:pt>
                  <c:pt idx="241">
                    <c:v>1.6243891829292089E-4</c:v>
                  </c:pt>
                  <c:pt idx="242">
                    <c:v>1.3197286786007114E-4</c:v>
                  </c:pt>
                  <c:pt idx="243">
                    <c:v>1.0742474257259184E-4</c:v>
                  </c:pt>
                  <c:pt idx="244">
                    <c:v>8.9449046909230234E-5</c:v>
                  </c:pt>
                  <c:pt idx="245">
                    <c:v>7.7252298077760484E-5</c:v>
                  </c:pt>
                  <c:pt idx="246">
                    <c:v>6.9197308639342919E-5</c:v>
                  </c:pt>
                  <c:pt idx="247">
                    <c:v>6.3629148593072427E-5</c:v>
                  </c:pt>
                  <c:pt idx="248">
                    <c:v>5.9382089376088665E-5</c:v>
                  </c:pt>
                  <c:pt idx="249">
                    <c:v>5.5818142605824291E-5</c:v>
                  </c:pt>
                  <c:pt idx="250">
                    <c:v>5.2648411689396212E-5</c:v>
                  </c:pt>
                  <c:pt idx="251">
                    <c:v>4.9760414087656496E-5</c:v>
                  </c:pt>
                  <c:pt idx="252">
                    <c:v>4.711513066342888E-5</c:v>
                  </c:pt>
                  <c:pt idx="253">
                    <c:v>4.4698863299110616E-5</c:v>
                  </c:pt>
                  <c:pt idx="254">
                    <c:v>4.2503988907960148E-5</c:v>
                  </c:pt>
                  <c:pt idx="255">
                    <c:v>4.0521891002771747E-5</c:v>
                  </c:pt>
                  <c:pt idx="256">
                    <c:v>3.8740400227518456E-5</c:v>
                  </c:pt>
                  <c:pt idx="257">
                    <c:v>3.7142934442118923E-5</c:v>
                  </c:pt>
                  <c:pt idx="258">
                    <c:v>3.5708661401912748E-5</c:v>
                  </c:pt>
                  <c:pt idx="259">
                    <c:v>3.4413439865982306E-5</c:v>
                  </c:pt>
                  <c:pt idx="260">
                    <c:v>3.3231504282812598E-5</c:v>
                  </c:pt>
                  <c:pt idx="261">
                    <c:v>3.2137563003324083E-5</c:v>
                  </c:pt>
                  <c:pt idx="262">
                    <c:v>3.110901328017081E-5</c:v>
                  </c:pt>
                  <c:pt idx="263">
                    <c:v>3.0127826137449972E-5</c:v>
                  </c:pt>
                  <c:pt idx="264">
                    <c:v>2.9181875444524667E-5</c:v>
                  </c:pt>
                  <c:pt idx="265">
                    <c:v>2.8265456607215455E-5</c:v>
                  </c:pt>
                  <c:pt idx="266">
                    <c:v>2.7379001396347488E-5</c:v>
                  </c:pt>
                  <c:pt idx="267">
                    <c:v>2.6528073076862681E-5</c:v>
                  </c:pt>
                  <c:pt idx="268">
                    <c:v>2.5721801650444025E-5</c:v>
                  </c:pt>
                  <c:pt idx="269">
                    <c:v>2.49710522922432E-5</c:v>
                  </c:pt>
                  <c:pt idx="270">
                    <c:v>2.4286557514989382E-5</c:v>
                  </c:pt>
                  <c:pt idx="271">
                    <c:v>2.3677309520336509E-5</c:v>
                  </c:pt>
                  <c:pt idx="272">
                    <c:v>2.3149446961302799E-5</c:v>
                  </c:pt>
                  <c:pt idx="273">
                    <c:v>2.2705701904226141E-5</c:v>
                  </c:pt>
                  <c:pt idx="274">
                    <c:v>2.2345468725969493E-5</c:v>
                  </c:pt>
                  <c:pt idx="275">
                    <c:v>2.2065349107787979E-5</c:v>
                  </c:pt>
                  <c:pt idx="276">
                    <c:v>2.1859982364068684E-5</c:v>
                  </c:pt>
                  <c:pt idx="277">
                    <c:v>2.1722976946070302E-5</c:v>
                  </c:pt>
                  <c:pt idx="278">
                    <c:v>2.1647710937405884E-5</c:v>
                  </c:pt>
                  <c:pt idx="279">
                    <c:v>2.1627955016543764E-5</c:v>
                  </c:pt>
                  <c:pt idx="280">
                    <c:v>2.1658225999946305E-5</c:v>
                  </c:pt>
                  <c:pt idx="281">
                    <c:v>2.1733903900370467E-5</c:v>
                  </c:pt>
                  <c:pt idx="282">
                    <c:v>2.1851212513811488E-5</c:v>
                  </c:pt>
                  <c:pt idx="283">
                    <c:v>2.2007169337519407E-5</c:v>
                  </c:pt>
                  <c:pt idx="284">
                    <c:v>2.2199864032869732E-5</c:v>
                  </c:pt>
                  <c:pt idx="285">
                    <c:v>2.2429673194345156E-5</c:v>
                  </c:pt>
                  <c:pt idx="286">
                    <c:v>2.2703003630849662E-5</c:v>
                  </c:pt>
                  <c:pt idx="287">
                    <c:v>2.3041482369930042E-5</c:v>
                  </c:pt>
                  <c:pt idx="288">
                    <c:v>2.3501396972461522E-5</c:v>
                  </c:pt>
                  <c:pt idx="289">
                    <c:v>2.4208417477767518E-5</c:v>
                  </c:pt>
                  <c:pt idx="290">
                    <c:v>2.5404694102098788E-5</c:v>
                  </c:pt>
                  <c:pt idx="291">
                    <c:v>2.7480550378619E-5</c:v>
                  </c:pt>
                  <c:pt idx="292">
                    <c:v>3.0930208588476465E-5</c:v>
                  </c:pt>
                  <c:pt idx="293">
                    <c:v>3.6194534134822282E-5</c:v>
                  </c:pt>
                  <c:pt idx="294">
                    <c:v>4.3466524601142617E-5</c:v>
                  </c:pt>
                  <c:pt idx="295">
                    <c:v>5.2584271659829651E-5</c:v>
                  </c:pt>
                  <c:pt idx="296">
                    <c:v>6.3032204138224827E-5</c:v>
                  </c:pt>
                  <c:pt idx="297">
                    <c:v>7.3998604595487734E-5</c:v>
                  </c:pt>
                  <c:pt idx="298">
                    <c:v>8.4466148436984262E-5</c:v>
                  </c:pt>
                  <c:pt idx="299">
                    <c:v>9.3340439446067342E-5</c:v>
                  </c:pt>
                  <c:pt idx="300">
                    <c:v>9.9612699816511944E-5</c:v>
                  </c:pt>
                  <c:pt idx="301">
                    <c:v>1.0253201596080073E-4</c:v>
                  </c:pt>
                  <c:pt idx="302">
                    <c:v>1.017492345762157E-4</c:v>
                  </c:pt>
                  <c:pt idx="303">
                    <c:v>9.7395999938362213E-5</c:v>
                  </c:pt>
                  <c:pt idx="304">
                    <c:v>9.0077355215360013E-5</c:v>
                  </c:pt>
                  <c:pt idx="305">
                    <c:v>8.0779196116503131E-5</c:v>
                  </c:pt>
                  <c:pt idx="306">
                    <c:v>7.071238109580671E-5</c:v>
                  </c:pt>
                  <c:pt idx="307">
                    <c:v>6.1121830777818528E-5</c:v>
                  </c:pt>
                  <c:pt idx="308">
                    <c:v>5.3077079017201568E-5</c:v>
                  </c:pt>
                  <c:pt idx="309">
                    <c:v>4.725223196066554E-5</c:v>
                  </c:pt>
                  <c:pt idx="310">
                    <c:v>4.3758996197418817E-5</c:v>
                  </c:pt>
                  <c:pt idx="311">
                    <c:v>4.2185636581411706E-5</c:v>
                  </c:pt>
                  <c:pt idx="312">
                    <c:v>4.1882190074665964E-5</c:v>
                  </c:pt>
                  <c:pt idx="313">
                    <c:v>4.2267919402360756E-5</c:v>
                  </c:pt>
                  <c:pt idx="314">
                    <c:v>4.2960378914741511E-5</c:v>
                  </c:pt>
                  <c:pt idx="315">
                    <c:v>4.3752787648060541E-5</c:v>
                  </c:pt>
                  <c:pt idx="316">
                    <c:v>4.4545858523292742E-5</c:v>
                  </c:pt>
                  <c:pt idx="317">
                    <c:v>4.5292509128295864E-5</c:v>
                  </c:pt>
                  <c:pt idx="318">
                    <c:v>4.5966658581976619E-5</c:v>
                  </c:pt>
                  <c:pt idx="319">
                    <c:v>4.6549760089401234E-5</c:v>
                  </c:pt>
                  <c:pt idx="320">
                    <c:v>4.7027069813905507E-5</c:v>
                  </c:pt>
                  <c:pt idx="321">
                    <c:v>4.7388118177504093E-5</c:v>
                  </c:pt>
                  <c:pt idx="322">
                    <c:v>4.7628371949910791E-5</c:v>
                  </c:pt>
                  <c:pt idx="323">
                    <c:v>4.7750694345762156E-5</c:v>
                  </c:pt>
                  <c:pt idx="324">
                    <c:v>4.7765966912409176E-5</c:v>
                  </c:pt>
                  <c:pt idx="325">
                    <c:v>4.7692762320322241E-5</c:v>
                  </c:pt>
                  <c:pt idx="326">
                    <c:v>4.7556104323909656E-5</c:v>
                  </c:pt>
                  <c:pt idx="327">
                    <c:v>4.738554101791962E-5</c:v>
                  </c:pt>
                  <c:pt idx="328">
                    <c:v>4.7212787992541885E-5</c:v>
                  </c:pt>
                  <c:pt idx="329">
                    <c:v>4.7069263203256004E-5</c:v>
                  </c:pt>
                  <c:pt idx="330">
                    <c:v>4.6983755518691792E-5</c:v>
                  </c:pt>
                  <c:pt idx="331">
                    <c:v>4.6980466814234045E-5</c:v>
                  </c:pt>
                  <c:pt idx="332">
                    <c:v>4.7077536871829853E-5</c:v>
                  </c:pt>
                  <c:pt idx="333">
                    <c:v>4.7286068437036888E-5</c:v>
                  </c:pt>
                  <c:pt idx="334">
                    <c:v>4.7609646586821842E-5</c:v>
                  </c:pt>
                  <c:pt idx="335">
                    <c:v>4.804427982943955E-5</c:v>
                  </c:pt>
                  <c:pt idx="336">
                    <c:v>4.8578698651959488E-5</c:v>
                  </c:pt>
                  <c:pt idx="337">
                    <c:v>4.9195020715229417E-5</c:v>
                  </c:pt>
                  <c:pt idx="338">
                    <c:v>4.9869762455914228E-5</c:v>
                  </c:pt>
                  <c:pt idx="339">
                    <c:v>5.0575194682051414E-5</c:v>
                  </c:pt>
                  <c:pt idx="340">
                    <c:v>5.1281020701255244E-5</c:v>
                  </c:pt>
                  <c:pt idx="341">
                    <c:v>5.1956293717660147E-5</c:v>
                  </c:pt>
                  <c:pt idx="342">
                    <c:v>5.2571468204030188E-5</c:v>
                  </c:pt>
                  <c:pt idx="343">
                    <c:v>5.3100385556944447E-5</c:v>
                  </c:pt>
                  <c:pt idx="344">
                    <c:v>5.3522074494410471E-5</c:v>
                  </c:pt>
                  <c:pt idx="345">
                    <c:v>5.3822166455196354E-5</c:v>
                  </c:pt>
                  <c:pt idx="346">
                    <c:v>5.3993760189238357E-5</c:v>
                  </c:pt>
                  <c:pt idx="347">
                    <c:v>5.403770993176083E-5</c:v>
                  </c:pt>
                  <c:pt idx="348">
                    <c:v>5.3962202073664099E-5</c:v>
                  </c:pt>
                  <c:pt idx="349">
                    <c:v>5.378168071885578E-5</c:v>
                  </c:pt>
                  <c:pt idx="350">
                    <c:v>5.3515200045411976E-5</c:v>
                  </c:pt>
                  <c:pt idx="351">
                    <c:v>5.3184318538178633E-5</c:v>
                  </c:pt>
                  <c:pt idx="352">
                    <c:v>5.2810789808287318E-5</c:v>
                  </c:pt>
                  <c:pt idx="353">
                    <c:v>5.2414255726128475E-5</c:v>
                  </c:pt>
                  <c:pt idx="354">
                    <c:v>5.2010275575681075E-5</c:v>
                  </c:pt>
                  <c:pt idx="355">
                    <c:v>5.1608879276011387E-5</c:v>
                  </c:pt>
                  <c:pt idx="356">
                    <c:v>5.1213851182829623E-5</c:v>
                  </c:pt>
                  <c:pt idx="357">
                    <c:v>5.0822791425061502E-5</c:v>
                  </c:pt>
                  <c:pt idx="358">
                    <c:v>5.0427897964800746E-5</c:v>
                  </c:pt>
                  <c:pt idx="359">
                    <c:v>5.0017295907001131E-5</c:v>
                  </c:pt>
                  <c:pt idx="360">
                    <c:v>4.9576678994305999E-5</c:v>
                  </c:pt>
                  <c:pt idx="361">
                    <c:v>4.9091039222236348E-5</c:v>
                  </c:pt>
                  <c:pt idx="362">
                    <c:v>4.8546259963946907E-5</c:v>
                  </c:pt>
                  <c:pt idx="363">
                    <c:v>4.7930419665884838E-5</c:v>
                  </c:pt>
                  <c:pt idx="364">
                    <c:v>4.7234736149618066E-5</c:v>
                  </c:pt>
                  <c:pt idx="365">
                    <c:v>4.6454155795196222E-5</c:v>
                  </c:pt>
                  <c:pt idx="366">
                    <c:v>4.5587563126622633E-5</c:v>
                  </c:pt>
                  <c:pt idx="367">
                    <c:v>4.4637686756436041E-5</c:v>
                  </c:pt>
                  <c:pt idx="368">
                    <c:v>4.3610809079991221E-5</c:v>
                  </c:pt>
                  <c:pt idx="369">
                    <c:v>4.2516257959558083E-5</c:v>
                  </c:pt>
                  <c:pt idx="370">
                    <c:v>4.1365805743988723E-5</c:v>
                  </c:pt>
                  <c:pt idx="371">
                    <c:v>4.0173018051442892E-5</c:v>
                  </c:pt>
                  <c:pt idx="372">
                    <c:v>3.8952575557228175E-5</c:v>
                  </c:pt>
                  <c:pt idx="373">
                    <c:v>3.7719631737819028E-5</c:v>
                  </c:pt>
                  <c:pt idx="374">
                    <c:v>3.6489215754981361E-5</c:v>
                  </c:pt>
                  <c:pt idx="375">
                    <c:v>3.5275726261671221E-5</c:v>
                  </c:pt>
                  <c:pt idx="376">
                    <c:v>3.4092540199842356E-5</c:v>
                  </c:pt>
                  <c:pt idx="377">
                    <c:v>3.295174298892031E-5</c:v>
                  </c:pt>
                  <c:pt idx="378">
                    <c:v>3.1864005564780535E-5</c:v>
                  </c:pt>
                  <c:pt idx="379">
                    <c:v>3.083861649648264E-5</c:v>
                  </c:pt>
                  <c:pt idx="380">
                    <c:v>2.9883668195133429E-5</c:v>
                  </c:pt>
                  <c:pt idx="381">
                    <c:v>2.900638970420735E-5</c:v>
                  </c:pt>
                  <c:pt idx="382">
                    <c:v>2.821357050292205E-5</c:v>
                  </c:pt>
                  <c:pt idx="383">
                    <c:v>2.75120944654645E-5</c:v>
                  </c:pt>
                  <c:pt idx="384">
                    <c:v>2.6909467912557553E-5</c:v>
                  </c:pt>
                  <c:pt idx="385">
                    <c:v>2.6414282216775562E-5</c:v>
                  </c:pt>
                  <c:pt idx="386">
                    <c:v>2.6036558059177804E-5</c:v>
                  </c:pt>
                  <c:pt idx="387">
                    <c:v>2.5787840898061905E-5</c:v>
                  </c:pt>
                  <c:pt idx="388">
                    <c:v>2.5680984180585442E-5</c:v>
                  </c:pt>
                  <c:pt idx="389">
                    <c:v>2.5729568450976659E-5</c:v>
                  </c:pt>
                  <c:pt idx="390">
                    <c:v>2.5946965787370266E-5</c:v>
                  </c:pt>
                  <c:pt idx="391">
                    <c:v>2.6345134768937288E-5</c:v>
                  </c:pt>
                  <c:pt idx="392">
                    <c:v>2.69332877943757E-5</c:v>
                  </c:pt>
                  <c:pt idx="393">
                    <c:v>2.7716668856912442E-5</c:v>
                  </c:pt>
                  <c:pt idx="394">
                    <c:v>2.8695606938450177E-5</c:v>
                  </c:pt>
                  <c:pt idx="395">
                    <c:v>2.9864998912669734E-5</c:v>
                  </c:pt>
                  <c:pt idx="396">
                    <c:v>3.1214209855713796E-5</c:v>
                  </c:pt>
                  <c:pt idx="397">
                    <c:v>3.2727380535744097E-5</c:v>
                  </c:pt>
                  <c:pt idx="398">
                    <c:v>3.4383973743124293E-5</c:v>
                  </c:pt>
                  <c:pt idx="399">
                    <c:v>3.615946231403439E-5</c:v>
                  </c:pt>
                  <c:pt idx="400">
                    <c:v>3.8026070748675403E-5</c:v>
                  </c:pt>
                  <c:pt idx="401">
                    <c:v>3.9953472404720853E-5</c:v>
                  </c:pt>
                  <c:pt idx="402">
                    <c:v>4.1909498826695981E-5</c:v>
                  </c:pt>
                  <c:pt idx="403">
                    <c:v>4.3860782204920447E-5</c:v>
                  </c:pt>
                  <c:pt idx="404">
                    <c:v>4.5773401904500122E-5</c:v>
                  </c:pt>
                  <c:pt idx="405">
                    <c:v>4.7613519501830585E-5</c:v>
                  </c:pt>
                  <c:pt idx="406">
                    <c:v>4.9348011322033361E-5</c:v>
                  </c:pt>
                  <c:pt idx="407">
                    <c:v>5.0945106228092851E-5</c:v>
                  </c:pt>
                  <c:pt idx="408">
                    <c:v>5.2375011763605531E-5</c:v>
                  </c:pt>
                  <c:pt idx="409">
                    <c:v>5.361053372160847E-5</c:v>
                  </c:pt>
                  <c:pt idx="410">
                    <c:v>5.4627646155537446E-5</c:v>
                  </c:pt>
                  <c:pt idx="411">
                    <c:v>5.5406010194721258E-5</c:v>
                  </c:pt>
                  <c:pt idx="412">
                    <c:v>5.5929429629157404E-5</c:v>
                  </c:pt>
                  <c:pt idx="413">
                    <c:v>5.6186189385259083E-5</c:v>
                  </c:pt>
                  <c:pt idx="414">
                    <c:v>5.6169323158203895E-5</c:v>
                  </c:pt>
                  <c:pt idx="415">
                    <c:v>5.5876726320662406E-5</c:v>
                  </c:pt>
                  <c:pt idx="416">
                    <c:v>5.5311160038114969E-5</c:v>
                  </c:pt>
                  <c:pt idx="417">
                    <c:v>5.4480137665261108E-5</c:v>
                  </c:pt>
                  <c:pt idx="418">
                    <c:v>5.3395669754184885E-5</c:v>
                  </c:pt>
                  <c:pt idx="419">
                    <c:v>5.207390888271534E-5</c:v>
                  </c:pt>
                  <c:pt idx="420">
                    <c:v>5.0534674694679812E-5</c:v>
                  </c:pt>
                  <c:pt idx="421">
                    <c:v>4.8800918792254491E-5</c:v>
                  </c:pt>
                  <c:pt idx="422">
                    <c:v>4.6898114482184912E-5</c:v>
                  </c:pt>
                  <c:pt idx="423">
                    <c:v>4.4853592743519997E-5</c:v>
                  </c:pt>
                  <c:pt idx="424">
                    <c:v>4.2695878151637965E-5</c:v>
                  </c:pt>
                  <c:pt idx="425">
                    <c:v>4.0454020792927793E-5</c:v>
                  </c:pt>
                  <c:pt idx="426">
                    <c:v>3.8156954165056846E-5</c:v>
                  </c:pt>
                  <c:pt idx="427">
                    <c:v>3.5832901208472931E-5</c:v>
                  </c:pt>
                  <c:pt idx="428">
                    <c:v>3.350883047833636E-5</c:v>
                  </c:pt>
                  <c:pt idx="429">
                    <c:v>3.1209991672499182E-5</c:v>
                  </c:pt>
                  <c:pt idx="430">
                    <c:v>2.8959539547196792E-5</c:v>
                  </c:pt>
                  <c:pt idx="431">
                    <c:v>2.6778222988649335E-5</c:v>
                  </c:pt>
                  <c:pt idx="432">
                    <c:v>2.4684175244874116E-5</c:v>
                  </c:pt>
                  <c:pt idx="433">
                    <c:v>2.2692774774849368E-5</c:v>
                  </c:pt>
                  <c:pt idx="434">
                    <c:v>2.0816569892960783E-5</c:v>
                  </c:pt>
                  <c:pt idx="435">
                    <c:v>1.9065277951079285E-5</c:v>
                  </c:pt>
                  <c:pt idx="436">
                    <c:v>1.7445810373743776E-5</c:v>
                  </c:pt>
                  <c:pt idx="437">
                    <c:v>1.5962348548388011E-5</c:v>
                  </c:pt>
                  <c:pt idx="438">
                    <c:v>1.4616440502878042E-5</c:v>
                  </c:pt>
                  <c:pt idx="439">
                    <c:v>1.3407100087892937E-5</c:v>
                  </c:pt>
                  <c:pt idx="440">
                    <c:v>1.2330965203648296E-5</c:v>
                  </c:pt>
                  <c:pt idx="441">
                    <c:v>1.138245390099735E-5</c:v>
                  </c:pt>
                  <c:pt idx="442">
                    <c:v>1.0554012970171702E-5</c:v>
                  </c:pt>
                  <c:pt idx="443">
                    <c:v>9.8364194174551938E-6</c:v>
                  </c:pt>
                  <c:pt idx="444">
                    <c:v>9.2191736004950219E-6</c:v>
                  </c:pt>
                  <c:pt idx="445">
                    <c:v>8.6909805647439513E-6</c:v>
                  </c:pt>
                  <c:pt idx="446">
                    <c:v>8.2402574589843541E-6</c:v>
                  </c:pt>
                  <c:pt idx="447">
                    <c:v>7.8556407163687665E-6</c:v>
                  </c:pt>
                  <c:pt idx="448">
                    <c:v>7.526420545506463E-6</c:v>
                  </c:pt>
                  <c:pt idx="449">
                    <c:v>7.2428872045617576E-6</c:v>
                  </c:pt>
                  <c:pt idx="450">
                    <c:v>6.9965314438172001E-6</c:v>
                  </c:pt>
                  <c:pt idx="451">
                    <c:v>6.7801255106693382E-6</c:v>
                  </c:pt>
                  <c:pt idx="452">
                    <c:v>6.5877005826180353E-6</c:v>
                  </c:pt>
                  <c:pt idx="453">
                    <c:v>6.414459549508611E-6</c:v>
                  </c:pt>
                  <c:pt idx="454">
                    <c:v>6.2566277325556534E-6</c:v>
                  </c:pt>
                  <c:pt idx="455">
                    <c:v>6.1113020677146538E-6</c:v>
                  </c:pt>
                  <c:pt idx="456">
                    <c:v>5.9762883721657843E-6</c:v>
                  </c:pt>
                  <c:pt idx="457">
                    <c:v>5.8499580661048381E-6</c:v>
                  </c:pt>
                  <c:pt idx="458">
                    <c:v>5.7311205442209037E-6</c:v>
                  </c:pt>
                  <c:pt idx="459">
                    <c:v>5.6189093042028097E-6</c:v>
                  </c:pt>
                  <c:pt idx="460">
                    <c:v>5.5127045554440666E-6</c:v>
                  </c:pt>
                  <c:pt idx="461">
                    <c:v>5.412058482430403E-6</c:v>
                  </c:pt>
                  <c:pt idx="462">
                    <c:v>5.3166382232605062E-6</c:v>
                  </c:pt>
                  <c:pt idx="463">
                    <c:v>5.2261921506999064E-6</c:v>
                  </c:pt>
                  <c:pt idx="464">
                    <c:v>5.1405185904242221E-6</c:v>
                  </c:pt>
                  <c:pt idx="465">
                    <c:v>5.0594479458217109E-6</c:v>
                  </c:pt>
                  <c:pt idx="466">
                    <c:v>4.9828223402069099E-6</c:v>
                  </c:pt>
                  <c:pt idx="467">
                    <c:v>4.9104877981606659E-6</c:v>
                  </c:pt>
                  <c:pt idx="468">
                    <c:v>4.8422924852882385E-6</c:v>
                  </c:pt>
                  <c:pt idx="469">
                    <c:v>4.7780885933779169E-6</c:v>
                  </c:pt>
                  <c:pt idx="470">
                    <c:v>4.7177176202578289E-6</c:v>
                  </c:pt>
                  <c:pt idx="471">
                    <c:v>4.6610240504681802E-6</c:v>
                  </c:pt>
                  <c:pt idx="472">
                    <c:v>4.607851508619715E-6</c:v>
                  </c:pt>
                  <c:pt idx="473">
                    <c:v>4.5580422079106813E-6</c:v>
                  </c:pt>
                  <c:pt idx="474">
                    <c:v>4.5114427984868281E-6</c:v>
                  </c:pt>
                  <c:pt idx="475">
                    <c:v>4.4679056019987462E-6</c:v>
                  </c:pt>
                  <c:pt idx="476">
                    <c:v>4.4272868884512253E-6</c:v>
                  </c:pt>
                  <c:pt idx="477">
                    <c:v>4.389451652233685E-6</c:v>
                  </c:pt>
                  <c:pt idx="478">
                    <c:v>4.3542685053105218E-6</c:v>
                  </c:pt>
                  <c:pt idx="479">
                    <c:v>4.3216213201892912E-6</c:v>
                  </c:pt>
                  <c:pt idx="480">
                    <c:v>4.2913964475064957E-6</c:v>
                  </c:pt>
                  <c:pt idx="481">
                    <c:v>4.2634983545623974E-6</c:v>
                  </c:pt>
                  <c:pt idx="482">
                    <c:v>4.2378284959967384E-6</c:v>
                  </c:pt>
                  <c:pt idx="483">
                    <c:v>4.2143063859950988E-6</c:v>
                  </c:pt>
                  <c:pt idx="484">
                    <c:v>4.1928558972648847E-6</c:v>
                  </c:pt>
                  <c:pt idx="485">
                    <c:v>4.1734098559528828E-6</c:v>
                  </c:pt>
                  <c:pt idx="486">
                    <c:v>4.1559044507665362E-6</c:v>
                  </c:pt>
                  <c:pt idx="487">
                    <c:v>4.1402894677577379E-6</c:v>
                  </c:pt>
                  <c:pt idx="488">
                    <c:v>4.1265164918242757E-6</c:v>
                  </c:pt>
                  <c:pt idx="489">
                    <c:v>4.1145385818712753E-6</c:v>
                  </c:pt>
                  <c:pt idx="490">
                    <c:v>4.1043207376945026E-6</c:v>
                  </c:pt>
                  <c:pt idx="491">
                    <c:v>4.0958312369963988E-6</c:v>
                  </c:pt>
                  <c:pt idx="492">
                    <c:v>4.0890350436447559E-6</c:v>
                  </c:pt>
                  <c:pt idx="493">
                    <c:v>4.0839051109052632E-6</c:v>
                  </c:pt>
                  <c:pt idx="494">
                    <c:v>4.080421809504374E-6</c:v>
                  </c:pt>
                  <c:pt idx="495">
                    <c:v>4.0785586478820737E-6</c:v>
                  </c:pt>
                  <c:pt idx="496">
                    <c:v>4.0782984784366457E-6</c:v>
                  </c:pt>
                  <c:pt idx="497">
                    <c:v>4.0796197682934821E-6</c:v>
                  </c:pt>
                  <c:pt idx="498">
                    <c:v>4.0825099339875394E-6</c:v>
                  </c:pt>
                  <c:pt idx="499">
                    <c:v>4.0869515030263774E-6</c:v>
                  </c:pt>
                  <c:pt idx="500">
                    <c:v>4.0929302822093694E-6</c:v>
                  </c:pt>
                  <c:pt idx="501">
                    <c:v>4.1004321963842125E-6</c:v>
                  </c:pt>
                  <c:pt idx="502">
                    <c:v>4.1094462810148405E-6</c:v>
                  </c:pt>
                  <c:pt idx="503">
                    <c:v>4.1199590618576361E-6</c:v>
                  </c:pt>
                  <c:pt idx="504">
                    <c:v>4.1319596529713183E-6</c:v>
                  </c:pt>
                  <c:pt idx="505">
                    <c:v>4.1454402475133512E-6</c:v>
                  </c:pt>
                  <c:pt idx="506">
                    <c:v>4.1603875438949092E-6</c:v>
                  </c:pt>
                  <c:pt idx="507">
                    <c:v>4.1767936620743251E-6</c:v>
                  </c:pt>
                  <c:pt idx="508">
                    <c:v>4.1946450192206415E-6</c:v>
                  </c:pt>
                  <c:pt idx="509">
                    <c:v>4.213933722579056E-6</c:v>
                  </c:pt>
                  <c:pt idx="510">
                    <c:v>4.2346547450382113E-6</c:v>
                  </c:pt>
                  <c:pt idx="511">
                    <c:v>4.2567917476921033E-6</c:v>
                  </c:pt>
                  <c:pt idx="512">
                    <c:v>4.2803366229014468E-6</c:v>
                  </c:pt>
                  <c:pt idx="513">
                    <c:v>4.3052841011190352E-6</c:v>
                  </c:pt>
                  <c:pt idx="514">
                    <c:v>4.331620557325475E-6</c:v>
                  </c:pt>
                  <c:pt idx="515">
                    <c:v>4.3593376824753515E-6</c:v>
                  </c:pt>
                  <c:pt idx="516">
                    <c:v>4.3884247703495883E-6</c:v>
                  </c:pt>
                  <c:pt idx="517">
                    <c:v>4.4188732777721193E-6</c:v>
                  </c:pt>
                  <c:pt idx="518">
                    <c:v>4.4506667112014893E-6</c:v>
                  </c:pt>
                  <c:pt idx="519">
                    <c:v>4.4837995145661398E-6</c:v>
                  </c:pt>
                  <c:pt idx="520">
                    <c:v>4.5182550355231259E-6</c:v>
                  </c:pt>
                  <c:pt idx="521">
                    <c:v>4.5540249047445094E-6</c:v>
                  </c:pt>
                  <c:pt idx="522">
                    <c:v>4.5910924722951052E-6</c:v>
                  </c:pt>
                  <c:pt idx="523">
                    <c:v>4.6294463896966106E-6</c:v>
                  </c:pt>
                  <c:pt idx="524">
                    <c:v>4.6690698425928633E-6</c:v>
                  </c:pt>
                  <c:pt idx="525">
                    <c:v>4.7099489981126042E-6</c:v>
                  </c:pt>
                  <c:pt idx="526">
                    <c:v>4.7520668770267787E-6</c:v>
                  </c:pt>
                  <c:pt idx="527">
                    <c:v>4.7954038495060799E-6</c:v>
                  </c:pt>
                  <c:pt idx="528">
                    <c:v>4.8399402858763398E-6</c:v>
                  </c:pt>
                  <c:pt idx="529">
                    <c:v>4.8856619403092984E-6</c:v>
                  </c:pt>
                  <c:pt idx="530">
                    <c:v>4.9325410662807468E-6</c:v>
                  </c:pt>
                  <c:pt idx="531">
                    <c:v>4.9805603536560523E-6</c:v>
                  </c:pt>
                  <c:pt idx="532">
                    <c:v>5.0296920560069206E-6</c:v>
                  </c:pt>
                  <c:pt idx="533">
                    <c:v>5.0799133967082747E-6</c:v>
                  </c:pt>
                  <c:pt idx="534">
                    <c:v>5.131196298220348E-6</c:v>
                  </c:pt>
                  <c:pt idx="535">
                    <c:v>5.1835126002204975E-6</c:v>
                  </c:pt>
                  <c:pt idx="536">
                    <c:v>5.236831243566247E-6</c:v>
                  </c:pt>
                  <c:pt idx="537">
                    <c:v>5.291121500310666E-6</c:v>
                  </c:pt>
                  <c:pt idx="538">
                    <c:v>5.3463493297042787E-6</c:v>
                  </c:pt>
                  <c:pt idx="539">
                    <c:v>5.402478206123762E-6</c:v>
                  </c:pt>
                  <c:pt idx="540">
                    <c:v>5.4594743372083451E-6</c:v>
                  </c:pt>
                  <c:pt idx="541">
                    <c:v>5.5172926664782407E-6</c:v>
                  </c:pt>
                  <c:pt idx="542">
                    <c:v>5.5758964199234989E-6</c:v>
                  </c:pt>
                  <c:pt idx="543">
                    <c:v>5.635237725162412E-6</c:v>
                  </c:pt>
                  <c:pt idx="544">
                    <c:v>5.6952769094506913E-6</c:v>
                  </c:pt>
                  <c:pt idx="545">
                    <c:v>5.7559605513737831E-6</c:v>
                  </c:pt>
                  <c:pt idx="546">
                    <c:v>5.8172403650460157E-6</c:v>
                  </c:pt>
                  <c:pt idx="547">
                    <c:v>5.8790625163046051E-6</c:v>
                  </c:pt>
                  <c:pt idx="548">
                    <c:v>5.9413759884820271E-6</c:v>
                  </c:pt>
                  <c:pt idx="549">
                    <c:v>6.0041238876455312E-6</c:v>
                  </c:pt>
                  <c:pt idx="550">
                    <c:v>6.0672405464983684E-6</c:v>
                  </c:pt>
                  <c:pt idx="551">
                    <c:v>6.1306714910406564E-6</c:v>
                  </c:pt>
                  <c:pt idx="552">
                    <c:v>6.1943447947130897E-6</c:v>
                  </c:pt>
                  <c:pt idx="553">
                    <c:v>6.2581993386235674E-6</c:v>
                  </c:pt>
                  <c:pt idx="554">
                    <c:v>6.3221594226697767E-6</c:v>
                  </c:pt>
                  <c:pt idx="555">
                    <c:v>6.3861571848101113E-6</c:v>
                  </c:pt>
                  <c:pt idx="556">
                    <c:v>6.4501123451113184E-6</c:v>
                  </c:pt>
                  <c:pt idx="557">
                    <c:v>6.5139469535736759E-6</c:v>
                  </c:pt>
                  <c:pt idx="558">
                    <c:v>6.5775788563962521E-6</c:v>
                  </c:pt>
                  <c:pt idx="559">
                    <c:v>6.640922691712284E-6</c:v>
                  </c:pt>
                  <c:pt idx="560">
                    <c:v>6.7038922034521454E-6</c:v>
                  </c:pt>
                  <c:pt idx="561">
                    <c:v>6.766398982864077E-6</c:v>
                  </c:pt>
                  <c:pt idx="562">
                    <c:v>6.8283512092953156E-6</c:v>
                  </c:pt>
                  <c:pt idx="563">
                    <c:v>6.889667289890039E-6</c:v>
                  </c:pt>
                  <c:pt idx="564">
                    <c:v>6.9502666127741311E-6</c:v>
                  </c:pt>
                  <c:pt idx="565">
                    <c:v>7.010088371637529E-6</c:v>
                  </c:pt>
                  <c:pt idx="566">
                    <c:v>7.0690967630575542E-6</c:v>
                  </c:pt>
                  <c:pt idx="567">
                    <c:v>7.1273011042046924E-6</c:v>
                  </c:pt>
                  <c:pt idx="568">
                    <c:v>7.1847739920273193E-6</c:v>
                  </c:pt>
                  <c:pt idx="569">
                    <c:v>7.24169812546375E-6</c:v>
                  </c:pt>
                  <c:pt idx="570">
                    <c:v>7.2984027337278443E-6</c:v>
                  </c:pt>
                  <c:pt idx="571">
                    <c:v>7.3554349861274196E-6</c:v>
                  </c:pt>
                  <c:pt idx="572">
                    <c:v>7.4136517868314095E-6</c:v>
                  </c:pt>
                  <c:pt idx="573">
                    <c:v>7.4743162636729177E-6</c:v>
                  </c:pt>
                  <c:pt idx="574">
                    <c:v>7.539246048667605E-6</c:v>
                  </c:pt>
                  <c:pt idx="575">
                    <c:v>7.6109723832311137E-6</c:v>
                  </c:pt>
                  <c:pt idx="576">
                    <c:v>7.6929251731339415E-6</c:v>
                  </c:pt>
                  <c:pt idx="577">
                    <c:v>7.7896148718205083E-6</c:v>
                  </c:pt>
                  <c:pt idx="578">
                    <c:v>7.9068081497664878E-6</c:v>
                  </c:pt>
                  <c:pt idx="579">
                    <c:v>8.0516414863087419E-6</c:v>
                  </c:pt>
                  <c:pt idx="580">
                    <c:v>8.2326345310039681E-6</c:v>
                  </c:pt>
                  <c:pt idx="581">
                    <c:v>8.459548306182094E-6</c:v>
                  </c:pt>
                  <c:pt idx="582">
                    <c:v>8.7430515033308724E-6</c:v>
                  </c:pt>
                  <c:pt idx="583">
                    <c:v>9.0941741246386339E-6</c:v>
                  </c:pt>
                  <c:pt idx="584">
                    <c:v>9.523598046538954E-6</c:v>
                  </c:pt>
                  <c:pt idx="585">
                    <c:v>1.0040864049623834E-5</c:v>
                  </c:pt>
                  <c:pt idx="586">
                    <c:v>1.06536193866513E-5</c:v>
                  </c:pt>
                  <c:pt idx="587">
                    <c:v>1.1367011410295084E-5</c:v>
                  </c:pt>
                  <c:pt idx="588">
                    <c:v>1.2183327610602724E-5</c:v>
                  </c:pt>
                  <c:pt idx="589">
                    <c:v>1.3101849114675687E-5</c:v>
                  </c:pt>
                  <c:pt idx="590">
                    <c:v>1.4118900214079484E-5</c:v>
                  </c:pt>
                  <c:pt idx="591">
                    <c:v>1.5228027856231516E-5</c:v>
                  </c:pt>
                  <c:pt idx="592">
                    <c:v>1.6420235977388985E-5</c:v>
                  </c:pt>
                  <c:pt idx="593">
                    <c:v>1.7684265071156775E-5</c:v>
                  </c:pt>
                  <c:pt idx="594">
                    <c:v>1.9006849324214949E-5</c:v>
                  </c:pt>
                  <c:pt idx="595">
                    <c:v>2.0373005692635351E-5</c:v>
                  </c:pt>
                  <c:pt idx="596">
                    <c:v>2.1766304031150836E-5</c:v>
                  </c:pt>
                  <c:pt idx="597">
                    <c:v>2.3169166160939579E-5</c:v>
                  </c:pt>
                  <c:pt idx="598">
                    <c:v>2.4563193426752444E-5</c:v>
                  </c:pt>
                  <c:pt idx="599">
                    <c:v>2.592948067093322E-5</c:v>
                  </c:pt>
                  <c:pt idx="600">
                    <c:v>2.7248993966556218E-5</c:v>
                  </c:pt>
                  <c:pt idx="601">
                    <c:v>2.850293935568774E-5</c:v>
                  </c:pt>
                  <c:pt idx="602">
                    <c:v>2.9673131362127781E-5</c:v>
                  </c:pt>
                  <c:pt idx="603">
                    <c:v>3.0742386157237342E-5</c:v>
                  </c:pt>
                  <c:pt idx="604">
                    <c:v>3.169488016428826E-5</c:v>
                  </c:pt>
                  <c:pt idx="605">
                    <c:v>3.2516478699818918E-5</c:v>
                  </c:pt>
                  <c:pt idx="606">
                    <c:v>3.3195047843988445E-5</c:v>
                  </c:pt>
                  <c:pt idx="607">
                    <c:v>3.3720710084043068E-5</c:v>
                  </c:pt>
                  <c:pt idx="608">
                    <c:v>3.4086041186404343E-5</c:v>
                  </c:pt>
                  <c:pt idx="609">
                    <c:v>3.4286199985983045E-5</c:v>
                  </c:pt>
                  <c:pt idx="610">
                    <c:v>3.4319027898947348E-5</c:v>
                  </c:pt>
                  <c:pt idx="611">
                    <c:v>3.4185031170289594E-5</c:v>
                  </c:pt>
                  <c:pt idx="612">
                    <c:v>3.3887337193204093E-5</c:v>
                  </c:pt>
                  <c:pt idx="613">
                    <c:v>3.3431566418452464E-5</c:v>
                  </c:pt>
                  <c:pt idx="614">
                    <c:v>3.2825657773058499E-5</c:v>
                  </c:pt>
                  <c:pt idx="615">
                    <c:v>3.2079630202186425E-5</c:v>
                  </c:pt>
                  <c:pt idx="616">
                    <c:v>3.1205326345208232E-5</c:v>
                  </c:pt>
                  <c:pt idx="617">
                    <c:v>3.0216091995089216E-5</c:v>
                  </c:pt>
                  <c:pt idx="618">
                    <c:v>2.9126469163247635E-5</c:v>
                  </c:pt>
                  <c:pt idx="619">
                    <c:v>2.7951847742456245E-5</c:v>
                  </c:pt>
                  <c:pt idx="620">
                    <c:v>2.6708132438818534E-5</c:v>
                  </c:pt>
                  <c:pt idx="621">
                    <c:v>2.5411414830724013E-5</c:v>
                  </c:pt>
                  <c:pt idx="622">
                    <c:v>2.4077667354006569E-5</c:v>
                  </c:pt>
                  <c:pt idx="623">
                    <c:v>2.2722466303859905E-5</c:v>
                  </c:pt>
                  <c:pt idx="624">
                    <c:v>2.1360716163460314E-5</c:v>
                  </c:pt>
                  <c:pt idx="625">
                    <c:v>2.0006464008205947E-5</c:v>
                  </c:pt>
                  <c:pt idx="626">
                    <c:v>1.8672702023215747E-5</c:v>
                  </c:pt>
                  <c:pt idx="627">
                    <c:v>1.7371236946027564E-5</c:v>
                  </c:pt>
                  <c:pt idx="628">
                    <c:v>1.6112594564594662E-5</c:v>
                  </c:pt>
                  <c:pt idx="629">
                    <c:v>1.4905958177352502E-5</c:v>
                  </c:pt>
                  <c:pt idx="630">
                    <c:v>1.3759142385727915E-5</c:v>
                  </c:pt>
                  <c:pt idx="631">
                    <c:v>1.2678602062634554E-5</c:v>
                  </c:pt>
                  <c:pt idx="632">
                    <c:v>1.1669458832042559E-5</c:v>
                  </c:pt>
                  <c:pt idx="633">
                    <c:v>1.0735537903357354E-5</c:v>
                  </c:pt>
                  <c:pt idx="634">
                    <c:v>9.8794393449132618E-6</c:v>
                  </c:pt>
                  <c:pt idx="635">
                    <c:v>9.1025826070011071E-6</c:v>
                  </c:pt>
                  <c:pt idx="636">
                    <c:v>8.4052752846968594E-6</c:v>
                  </c:pt>
                  <c:pt idx="637">
                    <c:v>7.7867663082069987E-6</c:v>
                  </c:pt>
                  <c:pt idx="638">
                    <c:v>7.2453032493156004E-6</c:v>
                  </c:pt>
                  <c:pt idx="639">
                    <c:v>6.778198968542513E-6</c:v>
                  </c:pt>
                  <c:pt idx="640">
                    <c:v>6.3819206446582994E-6</c:v>
                  </c:pt>
                  <c:pt idx="641">
                    <c:v>6.0522111480505827E-6</c:v>
                  </c:pt>
                  <c:pt idx="642">
                    <c:v>5.7842526803936934E-6</c:v>
                  </c:pt>
                  <c:pt idx="643">
                    <c:v>5.5728708469666865E-6</c:v>
                  </c:pt>
                  <c:pt idx="644">
                    <c:v>5.412759868862857E-6</c:v>
                  </c:pt>
                  <c:pt idx="645">
                    <c:v>5.2987111216530571E-6</c:v>
                  </c:pt>
                  <c:pt idx="646">
                    <c:v>5.2258153533912938E-6</c:v>
                  </c:pt>
                  <c:pt idx="647">
                    <c:v>5.1895965625027889E-6</c:v>
                  </c:pt>
                  <c:pt idx="648">
                    <c:v>5.1861163651123421E-6</c:v>
                  </c:pt>
                  <c:pt idx="649">
                    <c:v>5.2119807934605355E-6</c:v>
                  </c:pt>
                  <c:pt idx="650">
                    <c:v>5.2643183128768876E-6</c:v>
                  </c:pt>
                  <c:pt idx="651">
                    <c:v>5.3407248807162697E-6</c:v>
                  </c:pt>
                  <c:pt idx="652">
                    <c:v>5.439183552774571E-6</c:v>
                  </c:pt>
                  <c:pt idx="653">
                    <c:v>5.5579862908013804E-6</c:v>
                  </c:pt>
                  <c:pt idx="654">
                    <c:v>5.6956547496251955E-6</c:v>
                  </c:pt>
                  <c:pt idx="655">
                    <c:v>5.8508775588951989E-6</c:v>
                  </c:pt>
                  <c:pt idx="656">
                    <c:v>6.0224535747166609E-6</c:v>
                  </c:pt>
                  <c:pt idx="657">
                    <c:v>6.2092568829612766E-6</c:v>
                  </c:pt>
                  <c:pt idx="658">
                    <c:v>6.4101995928618012E-6</c:v>
                  </c:pt>
                  <c:pt idx="659">
                    <c:v>6.6242198816705787E-6</c:v>
                  </c:pt>
                  <c:pt idx="660">
                    <c:v>6.8502679051760289E-6</c:v>
                  </c:pt>
                  <c:pt idx="661">
                    <c:v>7.0872885831889448E-6</c:v>
                  </c:pt>
                  <c:pt idx="662">
                    <c:v>7.3342311902612884E-6</c:v>
                  </c:pt>
                  <c:pt idx="663">
                    <c:v>7.590038918975633E-6</c:v>
                  </c:pt>
                  <c:pt idx="664">
                    <c:v>7.8536489756356169E-6</c:v>
                  </c:pt>
                  <c:pt idx="665">
                    <c:v>8.1239966820145877E-6</c:v>
                  </c:pt>
                  <c:pt idx="666">
                    <c:v>8.4000110002217288E-6</c:v>
                  </c:pt>
                  <c:pt idx="667">
                    <c:v>8.6806145826554325E-6</c:v>
                  </c:pt>
                  <c:pt idx="668">
                    <c:v>8.9647370801336929E-6</c:v>
                  </c:pt>
                  <c:pt idx="669">
                    <c:v>9.2512979092163371E-6</c:v>
                  </c:pt>
                  <c:pt idx="670">
                    <c:v>9.5392250287790626E-6</c:v>
                  </c:pt>
                  <c:pt idx="671">
                    <c:v>9.8274464762382362E-6</c:v>
                  </c:pt>
                  <c:pt idx="672">
                    <c:v>1.0114888666823082E-5</c:v>
                  </c:pt>
                  <c:pt idx="673">
                    <c:v>1.0400494224500767E-5</c:v>
                  </c:pt>
                  <c:pt idx="674">
                    <c:v>1.0683206811825363E-5</c:v>
                  </c:pt>
                  <c:pt idx="675">
                    <c:v>1.0961979751576671E-5</c:v>
                  </c:pt>
                  <c:pt idx="676">
                    <c:v>1.123578950639871E-5</c:v>
                  </c:pt>
                  <c:pt idx="677">
                    <c:v>1.1503616284257918E-5</c:v>
                  </c:pt>
                  <c:pt idx="678">
                    <c:v>1.1764468882060973E-5</c:v>
                  </c:pt>
                  <c:pt idx="679">
                    <c:v>1.2017376793344179E-5</c:v>
                  </c:pt>
                  <c:pt idx="680">
                    <c:v>1.2261390138390154E-5</c:v>
                  </c:pt>
                  <c:pt idx="681">
                    <c:v>1.2495596839177732E-5</c:v>
                  </c:pt>
                  <c:pt idx="682">
                    <c:v>1.2719114368878903E-5</c:v>
                  </c:pt>
                  <c:pt idx="683">
                    <c:v>1.2931096499854779E-5</c:v>
                  </c:pt>
                  <c:pt idx="684">
                    <c:v>1.3130738034802229E-5</c:v>
                  </c:pt>
                  <c:pt idx="685">
                    <c:v>1.3317277683478672E-5</c:v>
                  </c:pt>
                  <c:pt idx="686">
                    <c:v>1.3489999132951872E-5</c:v>
                  </c:pt>
                  <c:pt idx="687">
                    <c:v>1.3648242346298928E-5</c:v>
                  </c:pt>
                  <c:pt idx="688">
                    <c:v>1.3791399951410172E-5</c:v>
                  </c:pt>
                  <c:pt idx="689">
                    <c:v>1.3918914010930226E-5</c:v>
                  </c:pt>
                  <c:pt idx="690">
                    <c:v>1.4030292212843062E-5</c:v>
                  </c:pt>
                  <c:pt idx="691">
                    <c:v>1.412510783390317E-5</c:v>
                  </c:pt>
                  <c:pt idx="692">
                    <c:v>1.4202987733222091E-5</c:v>
                  </c:pt>
                  <c:pt idx="693">
                    <c:v>1.426363477401098E-5</c:v>
                  </c:pt>
                  <c:pt idx="694">
                    <c:v>1.4306807806590164E-5</c:v>
                  </c:pt>
                  <c:pt idx="695">
                    <c:v>1.4332346620593774E-5</c:v>
                  </c:pt>
                  <c:pt idx="696">
                    <c:v>1.4340146560725881E-5</c:v>
                  </c:pt>
                  <c:pt idx="697">
                    <c:v>1.433017783275946E-5</c:v>
                  </c:pt>
                  <c:pt idx="698">
                    <c:v>1.4302482589326695E-5</c:v>
                  </c:pt>
                  <c:pt idx="699">
                    <c:v>1.4257166204850329E-5</c:v>
                  </c:pt>
                  <c:pt idx="700">
                    <c:v>1.4194400292822462E-5</c:v>
                  </c:pt>
                  <c:pt idx="701">
                    <c:v>1.4114424789445107E-5</c:v>
                  </c:pt>
                  <c:pt idx="702">
                    <c:v>1.4017545619967528E-5</c:v>
                  </c:pt>
                  <c:pt idx="703">
                    <c:v>1.3904125808380099E-5</c:v>
                  </c:pt>
                  <c:pt idx="704">
                    <c:v>1.3774588224542746E-5</c:v>
                  </c:pt>
                  <c:pt idx="705">
                    <c:v>1.3629412791945456E-5</c:v>
                  </c:pt>
                  <c:pt idx="706">
                    <c:v>1.3469136302217803E-5</c:v>
                  </c:pt>
                  <c:pt idx="707">
                    <c:v>1.3294343997973212E-5</c:v>
                  </c:pt>
                  <c:pt idx="708">
                    <c:v>1.3105663727220641E-5</c:v>
                  </c:pt>
                  <c:pt idx="709">
                    <c:v>1.2903766105969467E-5</c:v>
                  </c:pt>
                  <c:pt idx="710">
                    <c:v>1.2689367089977419E-5</c:v>
                  </c:pt>
                  <c:pt idx="711">
                    <c:v>1.2463208341063574E-5</c:v>
                  </c:pt>
                  <c:pt idx="712">
                    <c:v>1.2226065570041766E-5</c:v>
                  </c:pt>
                  <c:pt idx="713">
                    <c:v>1.1978742905886444E-5</c:v>
                  </c:pt>
                  <c:pt idx="714">
                    <c:v>1.1722055974094042E-5</c:v>
                  </c:pt>
                  <c:pt idx="715">
                    <c:v>1.1456843044013859E-5</c:v>
                  </c:pt>
                  <c:pt idx="716">
                    <c:v>1.1183959595089553E-5</c:v>
                  </c:pt>
                  <c:pt idx="717">
                    <c:v>1.0904252687982391E-5</c:v>
                  </c:pt>
                  <c:pt idx="718">
                    <c:v>1.0618589182398674E-5</c:v>
                  </c:pt>
                  <c:pt idx="719">
                    <c:v>1.0327824948414838E-5</c:v>
                  </c:pt>
                  <c:pt idx="720">
                    <c:v>1.0032810135652618E-5</c:v>
                  </c:pt>
                  <c:pt idx="721">
                    <c:v>9.7343866444194691E-6</c:v>
                  </c:pt>
                  <c:pt idx="722">
                    <c:v>9.4333879628206804E-6</c:v>
                  </c:pt>
                  <c:pt idx="723">
                    <c:v>9.1306251289346339E-6</c:v>
                  </c:pt>
                  <c:pt idx="724">
                    <c:v>8.8268894241320498E-6</c:v>
                  </c:pt>
                  <c:pt idx="725">
                    <c:v>8.522947016298328E-6</c:v>
                  </c:pt>
                  <c:pt idx="726">
                    <c:v>8.2195384941362587E-6</c:v>
                  </c:pt>
                  <c:pt idx="727">
                    <c:v>7.9173821965254069E-6</c:v>
                  </c:pt>
                  <c:pt idx="728">
                    <c:v>7.6171541482846325E-6</c:v>
                  </c:pt>
                  <c:pt idx="729">
                    <c:v>7.3195022507696381E-6</c:v>
                  </c:pt>
                  <c:pt idx="730">
                    <c:v>7.0250377054615605E-6</c:v>
                  </c:pt>
                  <c:pt idx="731">
                    <c:v>6.7343408887443202E-6</c:v>
                  </c:pt>
                  <c:pt idx="732">
                    <c:v>6.4479442689149749E-6</c:v>
                  </c:pt>
                  <c:pt idx="733">
                    <c:v>6.1663464801212348E-6</c:v>
                  </c:pt>
                  <c:pt idx="734">
                    <c:v>5.8900068157661068E-6</c:v>
                  </c:pt>
                  <c:pt idx="735">
                    <c:v>5.619342216475977E-6</c:v>
                  </c:pt>
                  <c:pt idx="736">
                    <c:v>5.3547359098275557E-6</c:v>
                  </c:pt>
                  <c:pt idx="737">
                    <c:v>5.0965233320365797E-6</c:v>
                  </c:pt>
                  <c:pt idx="738">
                    <c:v>4.8450030563349544E-6</c:v>
                  </c:pt>
                  <c:pt idx="739">
                    <c:v>4.6004345088619291E-6</c:v>
                  </c:pt>
                  <c:pt idx="740">
                    <c:v>4.3630402470652702E-6</c:v>
                  </c:pt>
                  <c:pt idx="741">
                    <c:v>4.1330064309560384E-6</c:v>
                  </c:pt>
                  <c:pt idx="742">
                    <c:v>3.9104796673800333E-6</c:v>
                  </c:pt>
                  <c:pt idx="743">
                    <c:v>3.6955728458181499E-6</c:v>
                  </c:pt>
                  <c:pt idx="744">
                    <c:v>3.488364860352823E-6</c:v>
                  </c:pt>
                  <c:pt idx="745">
                    <c:v>3.2889067274358195E-6</c:v>
                  </c:pt>
                  <c:pt idx="746">
                    <c:v>3.0972125801073581E-6</c:v>
                  </c:pt>
                  <c:pt idx="747">
                    <c:v>2.9132770531341732E-6</c:v>
                  </c:pt>
                  <c:pt idx="748">
                    <c:v>2.7370551484667494E-6</c:v>
                  </c:pt>
                  <c:pt idx="749">
                    <c:v>2.5684907478652044E-6</c:v>
                  </c:pt>
                  <c:pt idx="750">
                    <c:v>2.4074967601396265E-6</c:v>
                  </c:pt>
                  <c:pt idx="751">
                    <c:v>2.2539633528952918E-6</c:v>
                  </c:pt>
                  <c:pt idx="752">
                    <c:v>2.1077696461076644E-6</c:v>
                  </c:pt>
                  <c:pt idx="753">
                    <c:v>1.9687664573031466E-6</c:v>
                  </c:pt>
                  <c:pt idx="754">
                    <c:v>1.8368019340301526E-6</c:v>
                  </c:pt>
                  <c:pt idx="755">
                    <c:v>1.7116958472536255E-6</c:v>
                  </c:pt>
                  <c:pt idx="756">
                    <c:v>1.5932681138727452E-6</c:v>
                  </c:pt>
                  <c:pt idx="757">
                    <c:v>1.4813244987170632E-6</c:v>
                  </c:pt>
                  <c:pt idx="758">
                    <c:v>1.3756567605426954E-6</c:v>
                  </c:pt>
                  <c:pt idx="759">
                    <c:v>1.2760565855950837E-6</c:v>
                  </c:pt>
                  <c:pt idx="760">
                    <c:v>1.1823099546398917E-6</c:v>
                  </c:pt>
                  <c:pt idx="761">
                    <c:v>1.094194548206053E-6</c:v>
                  </c:pt>
                  <c:pt idx="762">
                    <c:v>1.0114850834974495E-6</c:v>
                  </c:pt>
                  <c:pt idx="763">
                    <c:v>9.3395924217399098E-7</c:v>
                  </c:pt>
                  <c:pt idx="764">
                    <c:v>8.6138892589122983E-7</c:v>
                  </c:pt>
                  <c:pt idx="765">
                    <c:v>7.935544841712749E-7</c:v>
                  </c:pt>
                  <c:pt idx="766">
                    <c:v>7.3023078379117121E-7</c:v>
                  </c:pt>
                  <c:pt idx="767">
                    <c:v>6.7119543354830219E-7</c:v>
                  </c:pt>
                  <c:pt idx="768">
                    <c:v>6.1623434072611187E-7</c:v>
                  </c:pt>
                  <c:pt idx="769">
                    <c:v>5.6513074611855363E-7</c:v>
                  </c:pt>
                  <c:pt idx="770">
                    <c:v>5.1768197094265033E-7</c:v>
                  </c:pt>
                  <c:pt idx="771">
                    <c:v>4.7367970467167217E-7</c:v>
                  </c:pt>
                  <c:pt idx="772">
                    <c:v>4.3292949115970579E-7</c:v>
                  </c:pt>
                  <c:pt idx="773">
                    <c:v>3.9524006657769178E-7</c:v>
                  </c:pt>
                  <c:pt idx="774">
                    <c:v>3.604283141286988E-7</c:v>
                  </c:pt>
                  <c:pt idx="775">
                    <c:v>3.2831126775522606E-7</c:v>
                  </c:pt>
                  <c:pt idx="776">
                    <c:v>2.9872278213782629E-7</c:v>
                  </c:pt>
                  <c:pt idx="777">
                    <c:v>2.7149671190058268E-7</c:v>
                  </c:pt>
                  <c:pt idx="778">
                    <c:v>2.4647817571428151E-7</c:v>
                  </c:pt>
                  <c:pt idx="779">
                    <c:v>2.2351236803785423E-7</c:v>
                  </c:pt>
                  <c:pt idx="780">
                    <c:v>2.0246411980582227E-7</c:v>
                  </c:pt>
                  <c:pt idx="781">
                    <c:v>1.8319262987963172E-7</c:v>
                  </c:pt>
                  <c:pt idx="782">
                    <c:v>1.65573993232589E-7</c:v>
                  </c:pt>
                  <c:pt idx="783">
                    <c:v>1.4948156477889293E-7</c:v>
                  </c:pt>
                  <c:pt idx="784">
                    <c:v>1.3480544367030838E-7</c:v>
                  </c:pt>
                  <c:pt idx="785">
                    <c:v>1.214358809996827E-7</c:v>
                  </c:pt>
                  <c:pt idx="786">
                    <c:v>1.092714999682265E-7</c:v>
                  </c:pt>
                  <c:pt idx="787">
                    <c:v>9.8219371835948922E-8</c:v>
                  </c:pt>
                  <c:pt idx="788">
                    <c:v>8.8186491717927167E-8</c:v>
                  </c:pt>
                  <c:pt idx="789">
                    <c:v>7.9091347165802257E-8</c:v>
                  </c:pt>
                  <c:pt idx="790">
                    <c:v>7.0857829463427819E-8</c:v>
                  </c:pt>
                  <c:pt idx="791">
                    <c:v>6.3412722020525803E-8</c:v>
                  </c:pt>
                  <c:pt idx="792">
                    <c:v>5.6685700366193154E-8</c:v>
                  </c:pt>
                  <c:pt idx="793">
                    <c:v>5.0617551926501442E-8</c:v>
                  </c:pt>
                  <c:pt idx="794">
                    <c:v>4.515203235613224E-8</c:v>
                  </c:pt>
                  <c:pt idx="795">
                    <c:v>4.0232745075703327E-8</c:v>
                  </c:pt>
                  <c:pt idx="796">
                    <c:v>3.5809077813838647E-8</c:v>
                  </c:pt>
                  <c:pt idx="797">
                    <c:v>3.1838714076615566E-8</c:v>
                  </c:pt>
                  <c:pt idx="798">
                    <c:v>2.8276673649017864E-8</c:v>
                  </c:pt>
                  <c:pt idx="799">
                    <c:v>2.5086348232424821E-8</c:v>
                  </c:pt>
                  <c:pt idx="800">
                    <c:v>2.223105339482886E-8</c:v>
                  </c:pt>
                  <c:pt idx="801">
                    <c:v>1.9682705057164954E-8</c:v>
                  </c:pt>
                  <c:pt idx="802">
                    <c:v>1.740469487949721E-8</c:v>
                  </c:pt>
                  <c:pt idx="803">
                    <c:v>1.5374494694581106E-8</c:v>
                  </c:pt>
                  <c:pt idx="804">
                    <c:v>1.3569500305548252E-8</c:v>
                  </c:pt>
                  <c:pt idx="805">
                    <c:v>1.1961627608470839E-8</c:v>
                  </c:pt>
                  <c:pt idx="806">
                    <c:v>1.0531240035075871E-8</c:v>
                  </c:pt>
                  <c:pt idx="807">
                    <c:v>9.2641059224446494E-9</c:v>
                  </c:pt>
                  <c:pt idx="808">
                    <c:v>8.1405889572824257E-9</c:v>
                  </c:pt>
                  <c:pt idx="809">
                    <c:v>7.1465334212953178E-9</c:v>
                  </c:pt>
                  <c:pt idx="810">
                    <c:v>6.2651942235570095E-9</c:v>
                  </c:pt>
                  <c:pt idx="811">
                    <c:v>5.4880478455019825E-9</c:v>
                  </c:pt>
                  <c:pt idx="812">
                    <c:v>4.8009389266329425E-9</c:v>
                  </c:pt>
                  <c:pt idx="813">
                    <c:v>4.1983856400415729E-9</c:v>
                  </c:pt>
                  <c:pt idx="814">
                    <c:v>3.6661580210853585E-9</c:v>
                  </c:pt>
                  <c:pt idx="815">
                    <c:v>3.1959575778865004E-9</c:v>
                  </c:pt>
                  <c:pt idx="816">
                    <c:v>2.784818736217136E-9</c:v>
                  </c:pt>
                  <c:pt idx="817">
                    <c:v>2.4244433583129217E-9</c:v>
                  </c:pt>
                  <c:pt idx="818">
                    <c:v>2.1090488923495111E-9</c:v>
                  </c:pt>
                  <c:pt idx="819">
                    <c:v>1.8302629930987254E-9</c:v>
                  </c:pt>
                  <c:pt idx="820">
                    <c:v>1.5880856693813657E-9</c:v>
                  </c:pt>
                  <c:pt idx="821">
                    <c:v>1.376959086730834E-9</c:v>
                  </c:pt>
                  <c:pt idx="822">
                    <c:v>1.1939175294195968E-9</c:v>
                  </c:pt>
                  <c:pt idx="823">
                    <c:v>1.0305882720994458E-9</c:v>
                  </c:pt>
                  <c:pt idx="824">
                    <c:v>8.9268174603744122E-10</c:v>
                  </c:pt>
                  <c:pt idx="825">
                    <c:v>7.6877639327514662E-10</c:v>
                  </c:pt>
                  <c:pt idx="826">
                    <c:v>6.645832557250352E-10</c:v>
                  </c:pt>
                  <c:pt idx="827">
                    <c:v>5.716542411533141E-10</c:v>
                  </c:pt>
                  <c:pt idx="828">
                    <c:v>4.9280538030458111E-10</c:v>
                  </c:pt>
                  <c:pt idx="829">
                    <c:v>4.2240461168964096E-10</c:v>
                  </c:pt>
                  <c:pt idx="830">
                    <c:v>3.632679660530912E-10</c:v>
                  </c:pt>
                  <c:pt idx="831">
                    <c:v>3.1257941265033427E-10</c:v>
                  </c:pt>
                  <c:pt idx="832">
                    <c:v>2.6752292073677262E-10</c:v>
                  </c:pt>
                  <c:pt idx="833">
                    <c:v>2.2809849031240615E-10</c:v>
                  </c:pt>
                  <c:pt idx="834">
                    <c:v>1.9430612137723487E-10</c:v>
                  </c:pt>
                  <c:pt idx="835">
                    <c:v>1.661458139312588E-10</c:v>
                  </c:pt>
                  <c:pt idx="836">
                    <c:v>1.4361756797447795E-10</c:v>
                  </c:pt>
                  <c:pt idx="837">
                    <c:v>1.2108932201769709E-10</c:v>
                  </c:pt>
                  <c:pt idx="838">
                    <c:v>1.0419313755011144E-10</c:v>
                  </c:pt>
                  <c:pt idx="839">
                    <c:v>8.7296953082525797E-11</c:v>
                  </c:pt>
                  <c:pt idx="840">
                    <c:v>7.603283010413537E-11</c:v>
                  </c:pt>
                  <c:pt idx="841">
                    <c:v>6.4768707125744956E-11</c:v>
                  </c:pt>
                  <c:pt idx="842">
                    <c:v>5.3504584147354529E-11</c:v>
                  </c:pt>
                  <c:pt idx="843">
                    <c:v>4.5056491913561702E-11</c:v>
                  </c:pt>
                  <c:pt idx="844">
                    <c:v>3.9424430424366495E-11</c:v>
                  </c:pt>
                  <c:pt idx="845">
                    <c:v>3.3792368935171281E-11</c:v>
                  </c:pt>
                  <c:pt idx="846">
                    <c:v>2.8160307445976061E-11</c:v>
                  </c:pt>
                  <c:pt idx="847">
                    <c:v>2.2528245956780851E-11</c:v>
                  </c:pt>
                  <c:pt idx="848">
                    <c:v>1.9712215212183247E-11</c:v>
                  </c:pt>
                  <c:pt idx="849">
                    <c:v>1.6896184467585641E-11</c:v>
                  </c:pt>
                  <c:pt idx="850">
                    <c:v>1.4080153722988031E-11</c:v>
                  </c:pt>
                  <c:pt idx="851">
                    <c:v>1.1264122978390425E-11</c:v>
                  </c:pt>
                  <c:pt idx="852">
                    <c:v>1.1264122978390425E-11</c:v>
                  </c:pt>
                  <c:pt idx="853">
                    <c:v>8.4480922337928203E-12</c:v>
                  </c:pt>
                  <c:pt idx="854">
                    <c:v>5.6320614891952127E-12</c:v>
                  </c:pt>
                  <c:pt idx="855">
                    <c:v>5.6320614891952127E-12</c:v>
                  </c:pt>
                  <c:pt idx="856">
                    <c:v>5.6320614891952127E-12</c:v>
                  </c:pt>
                  <c:pt idx="857">
                    <c:v>2.8160307445976064E-12</c:v>
                  </c:pt>
                  <c:pt idx="858">
                    <c:v>2.8160307445976064E-12</c:v>
                  </c:pt>
                  <c:pt idx="859">
                    <c:v>2.8160307445976064E-12</c:v>
                  </c:pt>
                  <c:pt idx="860">
                    <c:v>0</c:v>
                  </c:pt>
                  <c:pt idx="861">
                    <c:v>0</c:v>
                  </c:pt>
                  <c:pt idx="862">
                    <c:v>0</c:v>
                  </c:pt>
                  <c:pt idx="863">
                    <c:v>0</c:v>
                  </c:pt>
                  <c:pt idx="864">
                    <c:v>0</c:v>
                  </c:pt>
                  <c:pt idx="865">
                    <c:v>0</c:v>
                  </c:pt>
                  <c:pt idx="866">
                    <c:v>0</c:v>
                  </c:pt>
                  <c:pt idx="867">
                    <c:v>0</c:v>
                  </c:pt>
                  <c:pt idx="868">
                    <c:v>0</c:v>
                  </c:pt>
                  <c:pt idx="869">
                    <c:v>0</c:v>
                  </c:pt>
                  <c:pt idx="870">
                    <c:v>0</c:v>
                  </c:pt>
                  <c:pt idx="871">
                    <c:v>0</c:v>
                  </c:pt>
                  <c:pt idx="872">
                    <c:v>0</c:v>
                  </c:pt>
                  <c:pt idx="873">
                    <c:v>0</c:v>
                  </c:pt>
                  <c:pt idx="874">
                    <c:v>0</c:v>
                  </c:pt>
                  <c:pt idx="875">
                    <c:v>0</c:v>
                  </c:pt>
                  <c:pt idx="876">
                    <c:v>0</c:v>
                  </c:pt>
                  <c:pt idx="877">
                    <c:v>0</c:v>
                  </c:pt>
                  <c:pt idx="878">
                    <c:v>0</c:v>
                  </c:pt>
                  <c:pt idx="879">
                    <c:v>0</c:v>
                  </c:pt>
                  <c:pt idx="880">
                    <c:v>0</c:v>
                  </c:pt>
                  <c:pt idx="881">
                    <c:v>0</c:v>
                  </c:pt>
                  <c:pt idx="882">
                    <c:v>0</c:v>
                  </c:pt>
                  <c:pt idx="883">
                    <c:v>0</c:v>
                  </c:pt>
                  <c:pt idx="884">
                    <c:v>0</c:v>
                  </c:pt>
                  <c:pt idx="885">
                    <c:v>0</c:v>
                  </c:pt>
                  <c:pt idx="886">
                    <c:v>0</c:v>
                  </c:pt>
                  <c:pt idx="887">
                    <c:v>0</c:v>
                  </c:pt>
                  <c:pt idx="888">
                    <c:v>0</c:v>
                  </c:pt>
                  <c:pt idx="889">
                    <c:v>0</c:v>
                  </c:pt>
                  <c:pt idx="890">
                    <c:v>0</c:v>
                  </c:pt>
                  <c:pt idx="891">
                    <c:v>0</c:v>
                  </c:pt>
                  <c:pt idx="892">
                    <c:v>0</c:v>
                  </c:pt>
                  <c:pt idx="893">
                    <c:v>0</c:v>
                  </c:pt>
                  <c:pt idx="894">
                    <c:v>0</c:v>
                  </c:pt>
                  <c:pt idx="895">
                    <c:v>0</c:v>
                  </c:pt>
                  <c:pt idx="896">
                    <c:v>0</c:v>
                  </c:pt>
                  <c:pt idx="897">
                    <c:v>0</c:v>
                  </c:pt>
                  <c:pt idx="898">
                    <c:v>0</c:v>
                  </c:pt>
                  <c:pt idx="899">
                    <c:v>0</c:v>
                  </c:pt>
                  <c:pt idx="900">
                    <c:v>0</c:v>
                  </c:pt>
                  <c:pt idx="901">
                    <c:v>0</c:v>
                  </c:pt>
                  <c:pt idx="902">
                    <c:v>0</c:v>
                  </c:pt>
                  <c:pt idx="903">
                    <c:v>0</c:v>
                  </c:pt>
                  <c:pt idx="904">
                    <c:v>0</c:v>
                  </c:pt>
                  <c:pt idx="905">
                    <c:v>0</c:v>
                  </c:pt>
                  <c:pt idx="906">
                    <c:v>0</c:v>
                  </c:pt>
                  <c:pt idx="907">
                    <c:v>0</c:v>
                  </c:pt>
                  <c:pt idx="908">
                    <c:v>0</c:v>
                  </c:pt>
                  <c:pt idx="909">
                    <c:v>0</c:v>
                  </c:pt>
                  <c:pt idx="910">
                    <c:v>0</c:v>
                  </c:pt>
                  <c:pt idx="911">
                    <c:v>0</c:v>
                  </c:pt>
                  <c:pt idx="912">
                    <c:v>0</c:v>
                  </c:pt>
                  <c:pt idx="913">
                    <c:v>0</c:v>
                  </c:pt>
                  <c:pt idx="914">
                    <c:v>0</c:v>
                  </c:pt>
                  <c:pt idx="915">
                    <c:v>0</c:v>
                  </c:pt>
                  <c:pt idx="916">
                    <c:v>0</c:v>
                  </c:pt>
                  <c:pt idx="917">
                    <c:v>0</c:v>
                  </c:pt>
                  <c:pt idx="918">
                    <c:v>0</c:v>
                  </c:pt>
                  <c:pt idx="919">
                    <c:v>0</c:v>
                  </c:pt>
                  <c:pt idx="920">
                    <c:v>0</c:v>
                  </c:pt>
                  <c:pt idx="921">
                    <c:v>0</c:v>
                  </c:pt>
                  <c:pt idx="922">
                    <c:v>0</c:v>
                  </c:pt>
                  <c:pt idx="923">
                    <c:v>0</c:v>
                  </c:pt>
                  <c:pt idx="924">
                    <c:v>0</c:v>
                  </c:pt>
                  <c:pt idx="925">
                    <c:v>0</c:v>
                  </c:pt>
                  <c:pt idx="926">
                    <c:v>0</c:v>
                  </c:pt>
                  <c:pt idx="927">
                    <c:v>0</c:v>
                  </c:pt>
                  <c:pt idx="928">
                    <c:v>0</c:v>
                  </c:pt>
                  <c:pt idx="929">
                    <c:v>0</c:v>
                  </c:pt>
                  <c:pt idx="930">
                    <c:v>0</c:v>
                  </c:pt>
                  <c:pt idx="931">
                    <c:v>0</c:v>
                  </c:pt>
                  <c:pt idx="932">
                    <c:v>0</c:v>
                  </c:pt>
                  <c:pt idx="933">
                    <c:v>0</c:v>
                  </c:pt>
                  <c:pt idx="934">
                    <c:v>0</c:v>
                  </c:pt>
                  <c:pt idx="935">
                    <c:v>0</c:v>
                  </c:pt>
                  <c:pt idx="936">
                    <c:v>0</c:v>
                  </c:pt>
                  <c:pt idx="937">
                    <c:v>0</c:v>
                  </c:pt>
                  <c:pt idx="938">
                    <c:v>0</c:v>
                  </c:pt>
                  <c:pt idx="939">
                    <c:v>0</c:v>
                  </c:pt>
                  <c:pt idx="940">
                    <c:v>0</c:v>
                  </c:pt>
                  <c:pt idx="941">
                    <c:v>0</c:v>
                  </c:pt>
                  <c:pt idx="942">
                    <c:v>0</c:v>
                  </c:pt>
                  <c:pt idx="943">
                    <c:v>0</c:v>
                  </c:pt>
                  <c:pt idx="944">
                    <c:v>0</c:v>
                  </c:pt>
                  <c:pt idx="945">
                    <c:v>0</c:v>
                  </c:pt>
                  <c:pt idx="946">
                    <c:v>0</c:v>
                  </c:pt>
                  <c:pt idx="947">
                    <c:v>0</c:v>
                  </c:pt>
                  <c:pt idx="948">
                    <c:v>0</c:v>
                  </c:pt>
                  <c:pt idx="949">
                    <c:v>0</c:v>
                  </c:pt>
                  <c:pt idx="950">
                    <c:v>0</c:v>
                  </c:pt>
                  <c:pt idx="951">
                    <c:v>0</c:v>
                  </c:pt>
                  <c:pt idx="952">
                    <c:v>0</c:v>
                  </c:pt>
                  <c:pt idx="953">
                    <c:v>0</c:v>
                  </c:pt>
                  <c:pt idx="954">
                    <c:v>0</c:v>
                  </c:pt>
                  <c:pt idx="955">
                    <c:v>0</c:v>
                  </c:pt>
                  <c:pt idx="956">
                    <c:v>0</c:v>
                  </c:pt>
                  <c:pt idx="957">
                    <c:v>0</c:v>
                  </c:pt>
                  <c:pt idx="958">
                    <c:v>0</c:v>
                  </c:pt>
                  <c:pt idx="959">
                    <c:v>0</c:v>
                  </c:pt>
                  <c:pt idx="960">
                    <c:v>0</c:v>
                  </c:pt>
                  <c:pt idx="961">
                    <c:v>0</c:v>
                  </c:pt>
                  <c:pt idx="962">
                    <c:v>0</c:v>
                  </c:pt>
                  <c:pt idx="963">
                    <c:v>0</c:v>
                  </c:pt>
                  <c:pt idx="964">
                    <c:v>0</c:v>
                  </c:pt>
                  <c:pt idx="965">
                    <c:v>0</c:v>
                  </c:pt>
                  <c:pt idx="966">
                    <c:v>0</c:v>
                  </c:pt>
                  <c:pt idx="967">
                    <c:v>0</c:v>
                  </c:pt>
                  <c:pt idx="968">
                    <c:v>0</c:v>
                  </c:pt>
                  <c:pt idx="969">
                    <c:v>0</c:v>
                  </c:pt>
                  <c:pt idx="970">
                    <c:v>0</c:v>
                  </c:pt>
                  <c:pt idx="971">
                    <c:v>0</c:v>
                  </c:pt>
                  <c:pt idx="972">
                    <c:v>0</c:v>
                  </c:pt>
                  <c:pt idx="973">
                    <c:v>0</c:v>
                  </c:pt>
                  <c:pt idx="974">
                    <c:v>0</c:v>
                  </c:pt>
                  <c:pt idx="975">
                    <c:v>0</c:v>
                  </c:pt>
                  <c:pt idx="976">
                    <c:v>0</c:v>
                  </c:pt>
                  <c:pt idx="977">
                    <c:v>0</c:v>
                  </c:pt>
                  <c:pt idx="978">
                    <c:v>0</c:v>
                  </c:pt>
                  <c:pt idx="979">
                    <c:v>0</c:v>
                  </c:pt>
                  <c:pt idx="980">
                    <c:v>0</c:v>
                  </c:pt>
                  <c:pt idx="981">
                    <c:v>0</c:v>
                  </c:pt>
                  <c:pt idx="982">
                    <c:v>0</c:v>
                  </c:pt>
                  <c:pt idx="983">
                    <c:v>0</c:v>
                  </c:pt>
                  <c:pt idx="984">
                    <c:v>0</c:v>
                  </c:pt>
                  <c:pt idx="985">
                    <c:v>0</c:v>
                  </c:pt>
                  <c:pt idx="986">
                    <c:v>0</c:v>
                  </c:pt>
                  <c:pt idx="987">
                    <c:v>0</c:v>
                  </c:pt>
                  <c:pt idx="988">
                    <c:v>0</c:v>
                  </c:pt>
                  <c:pt idx="989">
                    <c:v>0</c:v>
                  </c:pt>
                  <c:pt idx="990">
                    <c:v>0</c:v>
                  </c:pt>
                  <c:pt idx="991">
                    <c:v>0</c:v>
                  </c:pt>
                  <c:pt idx="992">
                    <c:v>0</c:v>
                  </c:pt>
                  <c:pt idx="993">
                    <c:v>0</c:v>
                  </c:pt>
                  <c:pt idx="994">
                    <c:v>0</c:v>
                  </c:pt>
                  <c:pt idx="995">
                    <c:v>0</c:v>
                  </c:pt>
                  <c:pt idx="996">
                    <c:v>0</c:v>
                  </c:pt>
                  <c:pt idx="997">
                    <c:v>0</c:v>
                  </c:pt>
                  <c:pt idx="998">
                    <c:v>0</c:v>
                  </c:pt>
                  <c:pt idx="999">
                    <c:v>0</c:v>
                  </c:pt>
                </c:numCache>
              </c:numRef>
            </c:plus>
            <c:minus>
              <c:numRef>
                <c:f>'[データまとめ (自動保存済み).xlsx]TM粒子数'!$G$3:$G$1002</c:f>
                <c:numCache>
                  <c:formatCode>General</c:formatCode>
                  <c:ptCount val="1000"/>
                  <c:pt idx="0">
                    <c:v>0</c:v>
                  </c:pt>
                  <c:pt idx="1">
                    <c:v>0</c:v>
                  </c:pt>
                  <c:pt idx="2">
                    <c:v>5.8084486570640593E-10</c:v>
                  </c:pt>
                  <c:pt idx="3">
                    <c:v>1.7086840602832018E-7</c:v>
                  </c:pt>
                  <c:pt idx="4">
                    <c:v>2.8681614417274375E-6</c:v>
                  </c:pt>
                  <c:pt idx="5">
                    <c:v>1.0624136515881482E-5</c:v>
                  </c:pt>
                  <c:pt idx="6">
                    <c:v>1.7740163923992588E-5</c:v>
                  </c:pt>
                  <c:pt idx="7">
                    <c:v>1.898281617235804E-5</c:v>
                  </c:pt>
                  <c:pt idx="8">
                    <c:v>4.0749336541968202E-5</c:v>
                  </c:pt>
                  <c:pt idx="9">
                    <c:v>6.5103333540804503E-5</c:v>
                  </c:pt>
                  <c:pt idx="10">
                    <c:v>8.1673429625389113E-5</c:v>
                  </c:pt>
                  <c:pt idx="11">
                    <c:v>7.3418676196899724E-5</c:v>
                  </c:pt>
                  <c:pt idx="12">
                    <c:v>3.8997690833980366E-5</c:v>
                  </c:pt>
                  <c:pt idx="13">
                    <c:v>1.8864711089629475E-5</c:v>
                  </c:pt>
                  <c:pt idx="14">
                    <c:v>1.2735764180774528E-5</c:v>
                  </c:pt>
                  <c:pt idx="15">
                    <c:v>2.796265988028986E-5</c:v>
                  </c:pt>
                  <c:pt idx="16">
                    <c:v>5.1828335878684213E-5</c:v>
                  </c:pt>
                  <c:pt idx="17">
                    <c:v>5.9705633321227579E-5</c:v>
                  </c:pt>
                  <c:pt idx="18">
                    <c:v>7.42183549160471E-5</c:v>
                  </c:pt>
                  <c:pt idx="19">
                    <c:v>1.0033330608583059E-4</c:v>
                  </c:pt>
                  <c:pt idx="20">
                    <c:v>9.2509447792540845E-5</c:v>
                  </c:pt>
                  <c:pt idx="21">
                    <c:v>1.1080597718167802E-3</c:v>
                  </c:pt>
                  <c:pt idx="22">
                    <c:v>4.0687642876634212E-4</c:v>
                  </c:pt>
                  <c:pt idx="23">
                    <c:v>1.5457694004334646E-4</c:v>
                  </c:pt>
                  <c:pt idx="24">
                    <c:v>1.3149272177172066E-4</c:v>
                  </c:pt>
                  <c:pt idx="25">
                    <c:v>1.2379723103897767E-4</c:v>
                  </c:pt>
                  <c:pt idx="26">
                    <c:v>1.1564806213492276E-4</c:v>
                  </c:pt>
                  <c:pt idx="27">
                    <c:v>9.7205139607061021E-5</c:v>
                  </c:pt>
                  <c:pt idx="28">
                    <c:v>7.7583328219336088E-5</c:v>
                  </c:pt>
                  <c:pt idx="29">
                    <c:v>6.6685409874775074E-5</c:v>
                  </c:pt>
                  <c:pt idx="30">
                    <c:v>6.2792069722673684E-5</c:v>
                  </c:pt>
                  <c:pt idx="31">
                    <c:v>6.6454315719092577E-5</c:v>
                  </c:pt>
                  <c:pt idx="32">
                    <c:v>9.6942442004818496E-5</c:v>
                  </c:pt>
                  <c:pt idx="33">
                    <c:v>1.9570037422755746E-4</c:v>
                  </c:pt>
                  <c:pt idx="34">
                    <c:v>3.736221434867457E-4</c:v>
                  </c:pt>
                  <c:pt idx="35">
                    <c:v>5.6274007643724721E-4</c:v>
                  </c:pt>
                  <c:pt idx="36">
                    <c:v>6.6422049081856036E-4</c:v>
                  </c:pt>
                  <c:pt idx="37">
                    <c:v>7.5903394894775696E-4</c:v>
                  </c:pt>
                  <c:pt idx="38">
                    <c:v>1.0838161253838763E-3</c:v>
                  </c:pt>
                  <c:pt idx="39">
                    <c:v>1.2025436908868906E-3</c:v>
                  </c:pt>
                  <c:pt idx="40">
                    <c:v>8.126507018919102E-4</c:v>
                  </c:pt>
                  <c:pt idx="41">
                    <c:v>3.641579130724533E-4</c:v>
                  </c:pt>
                  <c:pt idx="42">
                    <c:v>2.239198978382396E-4</c:v>
                  </c:pt>
                  <c:pt idx="43">
                    <c:v>1.9791439347731878E-4</c:v>
                  </c:pt>
                  <c:pt idx="44">
                    <c:v>1.4575298575845733E-4</c:v>
                  </c:pt>
                  <c:pt idx="45">
                    <c:v>9.8053707662239874E-5</c:v>
                  </c:pt>
                  <c:pt idx="46">
                    <c:v>7.4819708462938817E-5</c:v>
                  </c:pt>
                  <c:pt idx="47">
                    <c:v>7.0753111768250056E-5</c:v>
                  </c:pt>
                  <c:pt idx="48">
                    <c:v>1.3503450123844555E-4</c:v>
                  </c:pt>
                  <c:pt idx="49">
                    <c:v>3.5512637968031403E-4</c:v>
                  </c:pt>
                  <c:pt idx="50">
                    <c:v>5.9272738163902131E-4</c:v>
                  </c:pt>
                  <c:pt idx="51">
                    <c:v>5.64149138098683E-4</c:v>
                  </c:pt>
                  <c:pt idx="52">
                    <c:v>3.7807673206303528E-4</c:v>
                  </c:pt>
                  <c:pt idx="53">
                    <c:v>4.5232303105235668E-4</c:v>
                  </c:pt>
                  <c:pt idx="54">
                    <c:v>7.1693701079030307E-4</c:v>
                  </c:pt>
                  <c:pt idx="55">
                    <c:v>1.0051679568564738E-3</c:v>
                  </c:pt>
                  <c:pt idx="56">
                    <c:v>1.2860538030944953E-3</c:v>
                  </c:pt>
                  <c:pt idx="57">
                    <c:v>1.5351418701990938E-3</c:v>
                  </c:pt>
                  <c:pt idx="58">
                    <c:v>1.7018877314322802E-3</c:v>
                  </c:pt>
                  <c:pt idx="59">
                    <c:v>1.8059508578817864E-3</c:v>
                  </c:pt>
                  <c:pt idx="60">
                    <c:v>1.9164569367619328E-3</c:v>
                  </c:pt>
                  <c:pt idx="61">
                    <c:v>2.0398063716712848E-3</c:v>
                  </c:pt>
                  <c:pt idx="62">
                    <c:v>2.1562305091273651E-3</c:v>
                  </c:pt>
                  <c:pt idx="63">
                    <c:v>2.2883495382186414E-3</c:v>
                  </c:pt>
                  <c:pt idx="64">
                    <c:v>2.5218292108348844E-3</c:v>
                  </c:pt>
                  <c:pt idx="65">
                    <c:v>2.9518567248317702E-3</c:v>
                  </c:pt>
                  <c:pt idx="66">
                    <c:v>3.4966400602694371E-3</c:v>
                  </c:pt>
                  <c:pt idx="67">
                    <c:v>3.8870602437675772E-3</c:v>
                  </c:pt>
                  <c:pt idx="68">
                    <c:v>3.9396700331787663E-3</c:v>
                  </c:pt>
                  <c:pt idx="69">
                    <c:v>3.7146602012467205E-3</c:v>
                  </c:pt>
                  <c:pt idx="70">
                    <c:v>3.4428410324182099E-3</c:v>
                  </c:pt>
                  <c:pt idx="71">
                    <c:v>3.4120592785969427E-3</c:v>
                  </c:pt>
                  <c:pt idx="72">
                    <c:v>3.6897198583409289E-3</c:v>
                  </c:pt>
                  <c:pt idx="73">
                    <c:v>3.8807455658746272E-3</c:v>
                  </c:pt>
                  <c:pt idx="74">
                    <c:v>3.6480162974906259E-3</c:v>
                  </c:pt>
                  <c:pt idx="75">
                    <c:v>3.1472796545596211E-3</c:v>
                  </c:pt>
                  <c:pt idx="76">
                    <c:v>2.7810069064615737E-3</c:v>
                  </c:pt>
                  <c:pt idx="77">
                    <c:v>2.7212872249787585E-3</c:v>
                  </c:pt>
                  <c:pt idx="78">
                    <c:v>2.8467322830635334E-3</c:v>
                  </c:pt>
                  <c:pt idx="79">
                    <c:v>3.0237219479089202E-3</c:v>
                  </c:pt>
                  <c:pt idx="80">
                    <c:v>3.1914597110701787E-3</c:v>
                  </c:pt>
                  <c:pt idx="81">
                    <c:v>3.3138545390248323E-3</c:v>
                  </c:pt>
                  <c:pt idx="82">
                    <c:v>3.3674883341994772E-3</c:v>
                  </c:pt>
                  <c:pt idx="83">
                    <c:v>3.3582338631542867E-3</c:v>
                  </c:pt>
                  <c:pt idx="84">
                    <c:v>3.3203670273984458E-3</c:v>
                  </c:pt>
                  <c:pt idx="85">
                    <c:v>3.2916454059400209E-3</c:v>
                  </c:pt>
                  <c:pt idx="86">
                    <c:v>3.2901113574121846E-3</c:v>
                  </c:pt>
                  <c:pt idx="87">
                    <c:v>3.313584513047794E-3</c:v>
                  </c:pt>
                  <c:pt idx="88">
                    <c:v>3.354147919842604E-3</c:v>
                  </c:pt>
                  <c:pt idx="89">
                    <c:v>3.4059935812221901E-3</c:v>
                  </c:pt>
                  <c:pt idx="90">
                    <c:v>3.4608835402504326E-3</c:v>
                  </c:pt>
                  <c:pt idx="91">
                    <c:v>3.5027321702970505E-3</c:v>
                  </c:pt>
                  <c:pt idx="92">
                    <c:v>3.5106709345531536E-3</c:v>
                  </c:pt>
                  <c:pt idx="93">
                    <c:v>3.4682805854916112E-3</c:v>
                  </c:pt>
                  <c:pt idx="94">
                    <c:v>3.3705985616398915E-3</c:v>
                  </c:pt>
                  <c:pt idx="95">
                    <c:v>3.2235495649920645E-3</c:v>
                  </c:pt>
                  <c:pt idx="96">
                    <c:v>3.0383538757567702E-3</c:v>
                  </c:pt>
                  <c:pt idx="97">
                    <c:v>2.8278956664312548E-3</c:v>
                  </c:pt>
                  <c:pt idx="98">
                    <c:v>2.6080487312204431E-3</c:v>
                  </c:pt>
                  <c:pt idx="99">
                    <c:v>2.4001692738083256E-3</c:v>
                  </c:pt>
                  <c:pt idx="100">
                    <c:v>2.2287062416762623E-3</c:v>
                  </c:pt>
                  <c:pt idx="101">
                    <c:v>2.1113478582774369E-3</c:v>
                  </c:pt>
                  <c:pt idx="102">
                    <c:v>2.0481256858158347E-3</c:v>
                  </c:pt>
                  <c:pt idx="103">
                    <c:v>2.0227118539618374E-3</c:v>
                  </c:pt>
                  <c:pt idx="104">
                    <c:v>2.0171721860598388E-3</c:v>
                  </c:pt>
                  <c:pt idx="105">
                    <c:v>2.0228142052068966E-3</c:v>
                  </c:pt>
                  <c:pt idx="106">
                    <c:v>2.0357422140288104E-3</c:v>
                  </c:pt>
                  <c:pt idx="107">
                    <c:v>2.047534289693067E-3</c:v>
                  </c:pt>
                  <c:pt idx="108">
                    <c:v>2.0458561369230545E-3</c:v>
                  </c:pt>
                  <c:pt idx="109">
                    <c:v>2.0229891838582825E-3</c:v>
                  </c:pt>
                  <c:pt idx="110">
                    <c:v>1.9810124666986085E-3</c:v>
                  </c:pt>
                  <c:pt idx="111">
                    <c:v>1.9299095433556515E-3</c:v>
                  </c:pt>
                  <c:pt idx="112">
                    <c:v>1.8819693085915725E-3</c:v>
                  </c:pt>
                  <c:pt idx="113">
                    <c:v>1.8459823099805854E-3</c:v>
                  </c:pt>
                  <c:pt idx="114">
                    <c:v>1.8234881130997904E-3</c:v>
                  </c:pt>
                  <c:pt idx="115">
                    <c:v>1.8089358209642322E-3</c:v>
                  </c:pt>
                  <c:pt idx="116">
                    <c:v>1.7941355629008521E-3</c:v>
                  </c:pt>
                  <c:pt idx="117">
                    <c:v>1.7748405814649417E-3</c:v>
                  </c:pt>
                  <c:pt idx="118">
                    <c:v>1.755759288858286E-3</c:v>
                  </c:pt>
                  <c:pt idx="119">
                    <c:v>1.7499213328989159E-3</c:v>
                  </c:pt>
                  <c:pt idx="120">
                    <c:v>1.7696951569413182E-3</c:v>
                  </c:pt>
                  <c:pt idx="121">
                    <c:v>1.8138508934788559E-3</c:v>
                  </c:pt>
                  <c:pt idx="122">
                    <c:v>1.8634155147822025E-3</c:v>
                  </c:pt>
                  <c:pt idx="123">
                    <c:v>1.8919544247240692E-3</c:v>
                  </c:pt>
                  <c:pt idx="124">
                    <c:v>1.8794962090690904E-3</c:v>
                  </c:pt>
                  <c:pt idx="125">
                    <c:v>1.8185203371303088E-3</c:v>
                  </c:pt>
                  <c:pt idx="126">
                    <c:v>1.7118632942888185E-3</c:v>
                  </c:pt>
                  <c:pt idx="127">
                    <c:v>1.5684926403650981E-3</c:v>
                  </c:pt>
                  <c:pt idx="128">
                    <c:v>1.4008285760161064E-3</c:v>
                  </c:pt>
                  <c:pt idx="129">
                    <c:v>1.2233092276367147E-3</c:v>
                  </c:pt>
                  <c:pt idx="130">
                    <c:v>1.0507324593765207E-3</c:v>
                  </c:pt>
                  <c:pt idx="131">
                    <c:v>8.9590489625892785E-4</c:v>
                  </c:pt>
                  <c:pt idx="132">
                    <c:v>7.6717746026269587E-4</c:v>
                  </c:pt>
                  <c:pt idx="133">
                    <c:v>6.6691502177876425E-4</c:v>
                  </c:pt>
                  <c:pt idx="134">
                    <c:v>5.919631636811597E-4</c:v>
                  </c:pt>
                  <c:pt idx="135">
                    <c:v>5.3626365727092956E-4</c:v>
                  </c:pt>
                  <c:pt idx="136">
                    <c:v>4.9410788154886454E-4</c:v>
                  </c:pt>
                  <c:pt idx="137">
                    <c:v>4.621372356691668E-4</c:v>
                  </c:pt>
                  <c:pt idx="138">
                    <c:v>4.3966911360863883E-4</c:v>
                  </c:pt>
                  <c:pt idx="139">
                    <c:v>4.2799630559662644E-4</c:v>
                  </c:pt>
                  <c:pt idx="140">
                    <c:v>4.2876826175649343E-4</c:v>
                  </c:pt>
                  <c:pt idx="141">
                    <c:v>4.4121242169196869E-4</c:v>
                  </c:pt>
                  <c:pt idx="142">
                    <c:v>4.5999490142116544E-4</c:v>
                  </c:pt>
                  <c:pt idx="143">
                    <c:v>4.7700405044262827E-4</c:v>
                  </c:pt>
                  <c:pt idx="144">
                    <c:v>4.8676056716635954E-4</c:v>
                  </c:pt>
                  <c:pt idx="145">
                    <c:v>4.9079940433093818E-4</c:v>
                  </c:pt>
                  <c:pt idx="146">
                    <c:v>4.9680260118877017E-4</c:v>
                  </c:pt>
                  <c:pt idx="147">
                    <c:v>5.1272637843641103E-4</c:v>
                  </c:pt>
                  <c:pt idx="148">
                    <c:v>5.4135686653674839E-4</c:v>
                  </c:pt>
                  <c:pt idx="149">
                    <c:v>5.8036829334266195E-4</c:v>
                  </c:pt>
                  <c:pt idx="150">
                    <c:v>6.2607684107456572E-4</c:v>
                  </c:pt>
                  <c:pt idx="151">
                    <c:v>6.7625872947711272E-4</c:v>
                  </c:pt>
                  <c:pt idx="152">
                    <c:v>7.3087352680641733E-4</c:v>
                  </c:pt>
                  <c:pt idx="153">
                    <c:v>7.9171241372663029E-4</c:v>
                  </c:pt>
                  <c:pt idx="154">
                    <c:v>8.6092265137062299E-4</c:v>
                  </c:pt>
                  <c:pt idx="155">
                    <c:v>9.3739413507737737E-4</c:v>
                  </c:pt>
                  <c:pt idx="156">
                    <c:v>1.0122777627093761E-3</c:v>
                  </c:pt>
                  <c:pt idx="157">
                    <c:v>1.0680656523157114E-3</c:v>
                  </c:pt>
                  <c:pt idx="158">
                    <c:v>1.0840559310530868E-3</c:v>
                  </c:pt>
                  <c:pt idx="159">
                    <c:v>1.0459279063382097E-3</c:v>
                  </c:pt>
                  <c:pt idx="160">
                    <c:v>9.5422203591019172E-4</c:v>
                  </c:pt>
                  <c:pt idx="161">
                    <c:v>8.2695821205084361E-4</c:v>
                  </c:pt>
                  <c:pt idx="162">
                    <c:v>6.9396100284576919E-4</c:v>
                  </c:pt>
                  <c:pt idx="163">
                    <c:v>5.8377982046681936E-4</c:v>
                  </c:pt>
                  <c:pt idx="164">
                    <c:v>5.0921977322342354E-4</c:v>
                  </c:pt>
                  <c:pt idx="165">
                    <c:v>4.6394552623144921E-4</c:v>
                  </c:pt>
                  <c:pt idx="166">
                    <c:v>4.3465274656882759E-4</c:v>
                  </c:pt>
                  <c:pt idx="167">
                    <c:v>4.1282862291154576E-4</c:v>
                  </c:pt>
                  <c:pt idx="168">
                    <c:v>3.9584841694498041E-4</c:v>
                  </c:pt>
                  <c:pt idx="169">
                    <c:v>3.8370717641764444E-4</c:v>
                  </c:pt>
                  <c:pt idx="170">
                    <c:v>3.7714813099995026E-4</c:v>
                  </c:pt>
                  <c:pt idx="171">
                    <c:v>3.7717194529390043E-4</c:v>
                  </c:pt>
                  <c:pt idx="172">
                    <c:v>3.8410574035491326E-4</c:v>
                  </c:pt>
                  <c:pt idx="173">
                    <c:v>3.9577396065796613E-4</c:v>
                  </c:pt>
                  <c:pt idx="174">
                    <c:v>4.0696895338405498E-4</c:v>
                  </c:pt>
                  <c:pt idx="175">
                    <c:v>4.1221902553948098E-4</c:v>
                  </c:pt>
                  <c:pt idx="176">
                    <c:v>4.0939808053487515E-4</c:v>
                  </c:pt>
                  <c:pt idx="177">
                    <c:v>4.0031609362936149E-4</c:v>
                  </c:pt>
                  <c:pt idx="178">
                    <c:v>3.8859274900788105E-4</c:v>
                  </c:pt>
                  <c:pt idx="179">
                    <c:v>3.7747961482146594E-4</c:v>
                  </c:pt>
                  <c:pt idx="180">
                    <c:v>3.6849614548452032E-4</c:v>
                  </c:pt>
                  <c:pt idx="181">
                    <c:v>3.6098144089138332E-4</c:v>
                  </c:pt>
                  <c:pt idx="182">
                    <c:v>3.530740330680266E-4</c:v>
                  </c:pt>
                  <c:pt idx="183">
                    <c:v>3.4338279768320404E-4</c:v>
                  </c:pt>
                  <c:pt idx="184">
                    <c:v>3.3188052371095731E-4</c:v>
                  </c:pt>
                  <c:pt idx="185">
                    <c:v>3.196681627133859E-4</c:v>
                  </c:pt>
                  <c:pt idx="186">
                    <c:v>3.0823459850459848E-4</c:v>
                  </c:pt>
                  <c:pt idx="187">
                    <c:v>2.9881169013640458E-4</c:v>
                  </c:pt>
                  <c:pt idx="188">
                    <c:v>2.9202941112568175E-4</c:v>
                  </c:pt>
                  <c:pt idx="189">
                    <c:v>2.8781381028470651E-4</c:v>
                  </c:pt>
                  <c:pt idx="190">
                    <c:v>2.8543089152072263E-4</c:v>
                  </c:pt>
                  <c:pt idx="191">
                    <c:v>2.8367039064404058E-4</c:v>
                  </c:pt>
                  <c:pt idx="192">
                    <c:v>2.8121469057420254E-4</c:v>
                  </c:pt>
                  <c:pt idx="193">
                    <c:v>2.771381339755897E-4</c:v>
                  </c:pt>
                  <c:pt idx="194">
                    <c:v>2.7132070842239363E-4</c:v>
                  </c:pt>
                  <c:pt idx="195">
                    <c:v>2.6453629015036706E-4</c:v>
                  </c:pt>
                  <c:pt idx="196">
                    <c:v>2.5815454718418042E-4</c:v>
                  </c:pt>
                  <c:pt idx="197">
                    <c:v>2.5362938772511499E-4</c:v>
                  </c:pt>
                  <c:pt idx="198">
                    <c:v>2.5203461202015764E-4</c:v>
                  </c:pt>
                  <c:pt idx="199">
                    <c:v>2.5380969811781998E-4</c:v>
                  </c:pt>
                  <c:pt idx="200">
                    <c:v>2.5873497151523349E-4</c:v>
                  </c:pt>
                  <c:pt idx="201">
                    <c:v>2.6608057362135108E-4</c:v>
                  </c:pt>
                  <c:pt idx="202">
                    <c:v>2.7485077798312675E-4</c:v>
                  </c:pt>
                  <c:pt idx="203">
                    <c:v>2.8404458161974266E-4</c:v>
                  </c:pt>
                  <c:pt idx="204">
                    <c:v>2.9288087754566453E-4</c:v>
                  </c:pt>
                  <c:pt idx="205">
                    <c:v>3.0097117033214436E-4</c:v>
                  </c:pt>
                  <c:pt idx="206">
                    <c:v>3.0842471593223837E-4</c:v>
                  </c:pt>
                  <c:pt idx="207">
                    <c:v>3.1583570044628814E-4</c:v>
                  </c:pt>
                  <c:pt idx="208">
                    <c:v>3.2407196531566225E-4</c:v>
                  </c:pt>
                  <c:pt idx="209">
                    <c:v>3.3382983142108585E-4</c:v>
                  </c:pt>
                  <c:pt idx="210">
                    <c:v>3.4507748644584601E-4</c:v>
                  </c:pt>
                  <c:pt idx="211">
                    <c:v>3.5668088893406054E-4</c:v>
                  </c:pt>
                  <c:pt idx="212">
                    <c:v>3.6648616631822966E-4</c:v>
                  </c:pt>
                  <c:pt idx="213">
                    <c:v>3.7187694422106591E-4</c:v>
                  </c:pt>
                  <c:pt idx="214">
                    <c:v>3.7056285792525802E-4</c:v>
                  </c:pt>
                  <c:pt idx="215">
                    <c:v>3.612846953242491E-4</c:v>
                  </c:pt>
                  <c:pt idx="216">
                    <c:v>3.4421001923279088E-4</c:v>
                  </c:pt>
                  <c:pt idx="217">
                    <c:v>3.2092712546701106E-4</c:v>
                  </c:pt>
                  <c:pt idx="218">
                    <c:v>2.9406786986818417E-4</c:v>
                  </c:pt>
                  <c:pt idx="219">
                    <c:v>2.6668361128255071E-4</c:v>
                  </c:pt>
                  <c:pt idx="220">
                    <c:v>2.415491295079037E-4</c:v>
                  </c:pt>
                  <c:pt idx="221">
                    <c:v>2.2057846741311689E-4</c:v>
                  </c:pt>
                  <c:pt idx="222">
                    <c:v>2.0452022059838293E-4</c:v>
                  </c:pt>
                  <c:pt idx="223">
                    <c:v>1.9303916379662431E-4</c:v>
                  </c:pt>
                  <c:pt idx="224">
                    <c:v>1.8514216940101943E-4</c:v>
                  </c:pt>
                  <c:pt idx="225">
                    <c:v>1.7974333998255521E-4</c:v>
                  </c:pt>
                  <c:pt idx="226">
                    <c:v>1.7616037669162252E-4</c:v>
                  </c:pt>
                  <c:pt idx="227">
                    <c:v>1.7447087754080402E-4</c:v>
                  </c:pt>
                  <c:pt idx="228">
                    <c:v>1.7570182198131478E-4</c:v>
                  </c:pt>
                  <c:pt idx="229">
                    <c:v>1.8165794850774373E-4</c:v>
                  </c:pt>
                  <c:pt idx="230">
                    <c:v>1.9407358684382986E-4</c:v>
                  </c:pt>
                  <c:pt idx="231">
                    <c:v>2.1325502970598326E-4</c:v>
                  </c:pt>
                  <c:pt idx="232">
                    <c:v>2.3719923061153256E-4</c:v>
                  </c:pt>
                  <c:pt idx="233">
                    <c:v>2.6191486547837926E-4</c:v>
                  </c:pt>
                  <c:pt idx="234">
                    <c:v>2.8256975898968174E-4</c:v>
                  </c:pt>
                  <c:pt idx="235">
                    <c:v>2.9476304566424807E-4</c:v>
                  </c:pt>
                  <c:pt idx="236">
                    <c:v>2.9554794992199811E-4</c:v>
                  </c:pt>
                  <c:pt idx="237">
                    <c:v>2.8404026090464337E-4</c:v>
                  </c:pt>
                  <c:pt idx="238">
                    <c:v>2.6151922304592492E-4</c:v>
                  </c:pt>
                  <c:pt idx="239">
                    <c:v>2.3102818740441142E-4</c:v>
                  </c:pt>
                  <c:pt idx="240">
                    <c:v>1.9661470303523949E-4</c:v>
                  </c:pt>
                  <c:pt idx="241">
                    <c:v>1.6243891829292089E-4</c:v>
                  </c:pt>
                  <c:pt idx="242">
                    <c:v>1.3197286786007114E-4</c:v>
                  </c:pt>
                  <c:pt idx="243">
                    <c:v>1.0742474257259184E-4</c:v>
                  </c:pt>
                  <c:pt idx="244">
                    <c:v>8.9449046909230234E-5</c:v>
                  </c:pt>
                  <c:pt idx="245">
                    <c:v>7.7252298077760484E-5</c:v>
                  </c:pt>
                  <c:pt idx="246">
                    <c:v>6.9197308639342919E-5</c:v>
                  </c:pt>
                  <c:pt idx="247">
                    <c:v>6.3629148593072427E-5</c:v>
                  </c:pt>
                  <c:pt idx="248">
                    <c:v>5.9382089376088665E-5</c:v>
                  </c:pt>
                  <c:pt idx="249">
                    <c:v>5.5818142605824291E-5</c:v>
                  </c:pt>
                  <c:pt idx="250">
                    <c:v>5.2648411689396212E-5</c:v>
                  </c:pt>
                  <c:pt idx="251">
                    <c:v>4.9760414087656496E-5</c:v>
                  </c:pt>
                  <c:pt idx="252">
                    <c:v>4.711513066342888E-5</c:v>
                  </c:pt>
                  <c:pt idx="253">
                    <c:v>4.4698863299110616E-5</c:v>
                  </c:pt>
                  <c:pt idx="254">
                    <c:v>4.2503988907960148E-5</c:v>
                  </c:pt>
                  <c:pt idx="255">
                    <c:v>4.0521891002771747E-5</c:v>
                  </c:pt>
                  <c:pt idx="256">
                    <c:v>3.8740400227518456E-5</c:v>
                  </c:pt>
                  <c:pt idx="257">
                    <c:v>3.7142934442118923E-5</c:v>
                  </c:pt>
                  <c:pt idx="258">
                    <c:v>3.5708661401912748E-5</c:v>
                  </c:pt>
                  <c:pt idx="259">
                    <c:v>3.4413439865982306E-5</c:v>
                  </c:pt>
                  <c:pt idx="260">
                    <c:v>3.3231504282812598E-5</c:v>
                  </c:pt>
                  <c:pt idx="261">
                    <c:v>3.2137563003324083E-5</c:v>
                  </c:pt>
                  <c:pt idx="262">
                    <c:v>3.110901328017081E-5</c:v>
                  </c:pt>
                  <c:pt idx="263">
                    <c:v>3.0127826137449972E-5</c:v>
                  </c:pt>
                  <c:pt idx="264">
                    <c:v>2.9181875444524667E-5</c:v>
                  </c:pt>
                  <c:pt idx="265">
                    <c:v>2.8265456607215455E-5</c:v>
                  </c:pt>
                  <c:pt idx="266">
                    <c:v>2.7379001396347488E-5</c:v>
                  </c:pt>
                  <c:pt idx="267">
                    <c:v>2.6528073076862681E-5</c:v>
                  </c:pt>
                  <c:pt idx="268">
                    <c:v>2.5721801650444025E-5</c:v>
                  </c:pt>
                  <c:pt idx="269">
                    <c:v>2.49710522922432E-5</c:v>
                  </c:pt>
                  <c:pt idx="270">
                    <c:v>2.4286557514989382E-5</c:v>
                  </c:pt>
                  <c:pt idx="271">
                    <c:v>2.3677309520336509E-5</c:v>
                  </c:pt>
                  <c:pt idx="272">
                    <c:v>2.3149446961302799E-5</c:v>
                  </c:pt>
                  <c:pt idx="273">
                    <c:v>2.2705701904226141E-5</c:v>
                  </c:pt>
                  <c:pt idx="274">
                    <c:v>2.2345468725969493E-5</c:v>
                  </c:pt>
                  <c:pt idx="275">
                    <c:v>2.2065349107787979E-5</c:v>
                  </c:pt>
                  <c:pt idx="276">
                    <c:v>2.1859982364068684E-5</c:v>
                  </c:pt>
                  <c:pt idx="277">
                    <c:v>2.1722976946070302E-5</c:v>
                  </c:pt>
                  <c:pt idx="278">
                    <c:v>2.1647710937405884E-5</c:v>
                  </c:pt>
                  <c:pt idx="279">
                    <c:v>2.1627955016543764E-5</c:v>
                  </c:pt>
                  <c:pt idx="280">
                    <c:v>2.1658225999946305E-5</c:v>
                  </c:pt>
                  <c:pt idx="281">
                    <c:v>2.1733903900370467E-5</c:v>
                  </c:pt>
                  <c:pt idx="282">
                    <c:v>2.1851212513811488E-5</c:v>
                  </c:pt>
                  <c:pt idx="283">
                    <c:v>2.2007169337519407E-5</c:v>
                  </c:pt>
                  <c:pt idx="284">
                    <c:v>2.2199864032869732E-5</c:v>
                  </c:pt>
                  <c:pt idx="285">
                    <c:v>2.2429673194345156E-5</c:v>
                  </c:pt>
                  <c:pt idx="286">
                    <c:v>2.2703003630849662E-5</c:v>
                  </c:pt>
                  <c:pt idx="287">
                    <c:v>2.3041482369930042E-5</c:v>
                  </c:pt>
                  <c:pt idx="288">
                    <c:v>2.3501396972461522E-5</c:v>
                  </c:pt>
                  <c:pt idx="289">
                    <c:v>2.4208417477767518E-5</c:v>
                  </c:pt>
                  <c:pt idx="290">
                    <c:v>2.5404694102098788E-5</c:v>
                  </c:pt>
                  <c:pt idx="291">
                    <c:v>2.7480550378619E-5</c:v>
                  </c:pt>
                  <c:pt idx="292">
                    <c:v>3.0930208588476465E-5</c:v>
                  </c:pt>
                  <c:pt idx="293">
                    <c:v>3.6194534134822282E-5</c:v>
                  </c:pt>
                  <c:pt idx="294">
                    <c:v>4.3466524601142617E-5</c:v>
                  </c:pt>
                  <c:pt idx="295">
                    <c:v>5.2584271659829651E-5</c:v>
                  </c:pt>
                  <c:pt idx="296">
                    <c:v>6.3032204138224827E-5</c:v>
                  </c:pt>
                  <c:pt idx="297">
                    <c:v>7.3998604595487734E-5</c:v>
                  </c:pt>
                  <c:pt idx="298">
                    <c:v>8.4466148436984262E-5</c:v>
                  </c:pt>
                  <c:pt idx="299">
                    <c:v>9.3340439446067342E-5</c:v>
                  </c:pt>
                  <c:pt idx="300">
                    <c:v>9.9612699816511944E-5</c:v>
                  </c:pt>
                  <c:pt idx="301">
                    <c:v>1.0253201596080073E-4</c:v>
                  </c:pt>
                  <c:pt idx="302">
                    <c:v>1.017492345762157E-4</c:v>
                  </c:pt>
                  <c:pt idx="303">
                    <c:v>9.7395999938362213E-5</c:v>
                  </c:pt>
                  <c:pt idx="304">
                    <c:v>9.0077355215360013E-5</c:v>
                  </c:pt>
                  <c:pt idx="305">
                    <c:v>8.0779196116503131E-5</c:v>
                  </c:pt>
                  <c:pt idx="306">
                    <c:v>7.071238109580671E-5</c:v>
                  </c:pt>
                  <c:pt idx="307">
                    <c:v>6.1121830777818528E-5</c:v>
                  </c:pt>
                  <c:pt idx="308">
                    <c:v>5.3077079017201568E-5</c:v>
                  </c:pt>
                  <c:pt idx="309">
                    <c:v>4.725223196066554E-5</c:v>
                  </c:pt>
                  <c:pt idx="310">
                    <c:v>4.3758996197418817E-5</c:v>
                  </c:pt>
                  <c:pt idx="311">
                    <c:v>4.2185636581411706E-5</c:v>
                  </c:pt>
                  <c:pt idx="312">
                    <c:v>4.1882190074665964E-5</c:v>
                  </c:pt>
                  <c:pt idx="313">
                    <c:v>4.2267919402360756E-5</c:v>
                  </c:pt>
                  <c:pt idx="314">
                    <c:v>4.2960378914741511E-5</c:v>
                  </c:pt>
                  <c:pt idx="315">
                    <c:v>4.3752787648060541E-5</c:v>
                  </c:pt>
                  <c:pt idx="316">
                    <c:v>4.4545858523292742E-5</c:v>
                  </c:pt>
                  <c:pt idx="317">
                    <c:v>4.5292509128295864E-5</c:v>
                  </c:pt>
                  <c:pt idx="318">
                    <c:v>4.5966658581976619E-5</c:v>
                  </c:pt>
                  <c:pt idx="319">
                    <c:v>4.6549760089401234E-5</c:v>
                  </c:pt>
                  <c:pt idx="320">
                    <c:v>4.7027069813905507E-5</c:v>
                  </c:pt>
                  <c:pt idx="321">
                    <c:v>4.7388118177504093E-5</c:v>
                  </c:pt>
                  <c:pt idx="322">
                    <c:v>4.7628371949910791E-5</c:v>
                  </c:pt>
                  <c:pt idx="323">
                    <c:v>4.7750694345762156E-5</c:v>
                  </c:pt>
                  <c:pt idx="324">
                    <c:v>4.7765966912409176E-5</c:v>
                  </c:pt>
                  <c:pt idx="325">
                    <c:v>4.7692762320322241E-5</c:v>
                  </c:pt>
                  <c:pt idx="326">
                    <c:v>4.7556104323909656E-5</c:v>
                  </c:pt>
                  <c:pt idx="327">
                    <c:v>4.738554101791962E-5</c:v>
                  </c:pt>
                  <c:pt idx="328">
                    <c:v>4.7212787992541885E-5</c:v>
                  </c:pt>
                  <c:pt idx="329">
                    <c:v>4.7069263203256004E-5</c:v>
                  </c:pt>
                  <c:pt idx="330">
                    <c:v>4.6983755518691792E-5</c:v>
                  </c:pt>
                  <c:pt idx="331">
                    <c:v>4.6980466814234045E-5</c:v>
                  </c:pt>
                  <c:pt idx="332">
                    <c:v>4.7077536871829853E-5</c:v>
                  </c:pt>
                  <c:pt idx="333">
                    <c:v>4.7286068437036888E-5</c:v>
                  </c:pt>
                  <c:pt idx="334">
                    <c:v>4.7609646586821842E-5</c:v>
                  </c:pt>
                  <c:pt idx="335">
                    <c:v>4.804427982943955E-5</c:v>
                  </c:pt>
                  <c:pt idx="336">
                    <c:v>4.8578698651959488E-5</c:v>
                  </c:pt>
                  <c:pt idx="337">
                    <c:v>4.9195020715229417E-5</c:v>
                  </c:pt>
                  <c:pt idx="338">
                    <c:v>4.9869762455914228E-5</c:v>
                  </c:pt>
                  <c:pt idx="339">
                    <c:v>5.0575194682051414E-5</c:v>
                  </c:pt>
                  <c:pt idx="340">
                    <c:v>5.1281020701255244E-5</c:v>
                  </c:pt>
                  <c:pt idx="341">
                    <c:v>5.1956293717660147E-5</c:v>
                  </c:pt>
                  <c:pt idx="342">
                    <c:v>5.2571468204030188E-5</c:v>
                  </c:pt>
                  <c:pt idx="343">
                    <c:v>5.3100385556944447E-5</c:v>
                  </c:pt>
                  <c:pt idx="344">
                    <c:v>5.3522074494410471E-5</c:v>
                  </c:pt>
                  <c:pt idx="345">
                    <c:v>5.3822166455196354E-5</c:v>
                  </c:pt>
                  <c:pt idx="346">
                    <c:v>5.3993760189238357E-5</c:v>
                  </c:pt>
                  <c:pt idx="347">
                    <c:v>5.403770993176083E-5</c:v>
                  </c:pt>
                  <c:pt idx="348">
                    <c:v>5.3962202073664099E-5</c:v>
                  </c:pt>
                  <c:pt idx="349">
                    <c:v>5.378168071885578E-5</c:v>
                  </c:pt>
                  <c:pt idx="350">
                    <c:v>5.3515200045411976E-5</c:v>
                  </c:pt>
                  <c:pt idx="351">
                    <c:v>5.3184318538178633E-5</c:v>
                  </c:pt>
                  <c:pt idx="352">
                    <c:v>5.2810789808287318E-5</c:v>
                  </c:pt>
                  <c:pt idx="353">
                    <c:v>5.2414255726128475E-5</c:v>
                  </c:pt>
                  <c:pt idx="354">
                    <c:v>5.2010275575681075E-5</c:v>
                  </c:pt>
                  <c:pt idx="355">
                    <c:v>5.1608879276011387E-5</c:v>
                  </c:pt>
                  <c:pt idx="356">
                    <c:v>5.1213851182829623E-5</c:v>
                  </c:pt>
                  <c:pt idx="357">
                    <c:v>5.0822791425061502E-5</c:v>
                  </c:pt>
                  <c:pt idx="358">
                    <c:v>5.0427897964800746E-5</c:v>
                  </c:pt>
                  <c:pt idx="359">
                    <c:v>5.0017295907001131E-5</c:v>
                  </c:pt>
                  <c:pt idx="360">
                    <c:v>4.9576678994305999E-5</c:v>
                  </c:pt>
                  <c:pt idx="361">
                    <c:v>4.9091039222236348E-5</c:v>
                  </c:pt>
                  <c:pt idx="362">
                    <c:v>4.8546259963946907E-5</c:v>
                  </c:pt>
                  <c:pt idx="363">
                    <c:v>4.7930419665884838E-5</c:v>
                  </c:pt>
                  <c:pt idx="364">
                    <c:v>4.7234736149618066E-5</c:v>
                  </c:pt>
                  <c:pt idx="365">
                    <c:v>4.6454155795196222E-5</c:v>
                  </c:pt>
                  <c:pt idx="366">
                    <c:v>4.5587563126622633E-5</c:v>
                  </c:pt>
                  <c:pt idx="367">
                    <c:v>4.4637686756436041E-5</c:v>
                  </c:pt>
                  <c:pt idx="368">
                    <c:v>4.3610809079991221E-5</c:v>
                  </c:pt>
                  <c:pt idx="369">
                    <c:v>4.2516257959558083E-5</c:v>
                  </c:pt>
                  <c:pt idx="370">
                    <c:v>4.1365805743988723E-5</c:v>
                  </c:pt>
                  <c:pt idx="371">
                    <c:v>4.0173018051442892E-5</c:v>
                  </c:pt>
                  <c:pt idx="372">
                    <c:v>3.8952575557228175E-5</c:v>
                  </c:pt>
                  <c:pt idx="373">
                    <c:v>3.7719631737819028E-5</c:v>
                  </c:pt>
                  <c:pt idx="374">
                    <c:v>3.6489215754981361E-5</c:v>
                  </c:pt>
                  <c:pt idx="375">
                    <c:v>3.5275726261671221E-5</c:v>
                  </c:pt>
                  <c:pt idx="376">
                    <c:v>3.4092540199842356E-5</c:v>
                  </c:pt>
                  <c:pt idx="377">
                    <c:v>3.295174298892031E-5</c:v>
                  </c:pt>
                  <c:pt idx="378">
                    <c:v>3.1864005564780535E-5</c:v>
                  </c:pt>
                  <c:pt idx="379">
                    <c:v>3.083861649648264E-5</c:v>
                  </c:pt>
                  <c:pt idx="380">
                    <c:v>2.9883668195133429E-5</c:v>
                  </c:pt>
                  <c:pt idx="381">
                    <c:v>2.900638970420735E-5</c:v>
                  </c:pt>
                  <c:pt idx="382">
                    <c:v>2.821357050292205E-5</c:v>
                  </c:pt>
                  <c:pt idx="383">
                    <c:v>2.75120944654645E-5</c:v>
                  </c:pt>
                  <c:pt idx="384">
                    <c:v>2.6909467912557553E-5</c:v>
                  </c:pt>
                  <c:pt idx="385">
                    <c:v>2.6414282216775562E-5</c:v>
                  </c:pt>
                  <c:pt idx="386">
                    <c:v>2.6036558059177804E-5</c:v>
                  </c:pt>
                  <c:pt idx="387">
                    <c:v>2.5787840898061905E-5</c:v>
                  </c:pt>
                  <c:pt idx="388">
                    <c:v>2.5680984180585442E-5</c:v>
                  </c:pt>
                  <c:pt idx="389">
                    <c:v>2.5729568450976659E-5</c:v>
                  </c:pt>
                  <c:pt idx="390">
                    <c:v>2.5946965787370266E-5</c:v>
                  </c:pt>
                  <c:pt idx="391">
                    <c:v>2.6345134768937288E-5</c:v>
                  </c:pt>
                  <c:pt idx="392">
                    <c:v>2.69332877943757E-5</c:v>
                  </c:pt>
                  <c:pt idx="393">
                    <c:v>2.7716668856912442E-5</c:v>
                  </c:pt>
                  <c:pt idx="394">
                    <c:v>2.8695606938450177E-5</c:v>
                  </c:pt>
                  <c:pt idx="395">
                    <c:v>2.9864998912669734E-5</c:v>
                  </c:pt>
                  <c:pt idx="396">
                    <c:v>3.1214209855713796E-5</c:v>
                  </c:pt>
                  <c:pt idx="397">
                    <c:v>3.2727380535744097E-5</c:v>
                  </c:pt>
                  <c:pt idx="398">
                    <c:v>3.4383973743124293E-5</c:v>
                  </c:pt>
                  <c:pt idx="399">
                    <c:v>3.615946231403439E-5</c:v>
                  </c:pt>
                  <c:pt idx="400">
                    <c:v>3.8026070748675403E-5</c:v>
                  </c:pt>
                  <c:pt idx="401">
                    <c:v>3.9953472404720853E-5</c:v>
                  </c:pt>
                  <c:pt idx="402">
                    <c:v>4.1909498826695981E-5</c:v>
                  </c:pt>
                  <c:pt idx="403">
                    <c:v>4.3860782204920447E-5</c:v>
                  </c:pt>
                  <c:pt idx="404">
                    <c:v>4.5773401904500122E-5</c:v>
                  </c:pt>
                  <c:pt idx="405">
                    <c:v>4.7613519501830585E-5</c:v>
                  </c:pt>
                  <c:pt idx="406">
                    <c:v>4.9348011322033361E-5</c:v>
                  </c:pt>
                  <c:pt idx="407">
                    <c:v>5.0945106228092851E-5</c:v>
                  </c:pt>
                  <c:pt idx="408">
                    <c:v>5.2375011763605531E-5</c:v>
                  </c:pt>
                  <c:pt idx="409">
                    <c:v>5.361053372160847E-5</c:v>
                  </c:pt>
                  <c:pt idx="410">
                    <c:v>5.4627646155537446E-5</c:v>
                  </c:pt>
                  <c:pt idx="411">
                    <c:v>5.5406010194721258E-5</c:v>
                  </c:pt>
                  <c:pt idx="412">
                    <c:v>5.5929429629157404E-5</c:v>
                  </c:pt>
                  <c:pt idx="413">
                    <c:v>5.6186189385259083E-5</c:v>
                  </c:pt>
                  <c:pt idx="414">
                    <c:v>5.6169323158203895E-5</c:v>
                  </c:pt>
                  <c:pt idx="415">
                    <c:v>5.5876726320662406E-5</c:v>
                  </c:pt>
                  <c:pt idx="416">
                    <c:v>5.5311160038114969E-5</c:v>
                  </c:pt>
                  <c:pt idx="417">
                    <c:v>5.4480137665261108E-5</c:v>
                  </c:pt>
                  <c:pt idx="418">
                    <c:v>5.3395669754184885E-5</c:v>
                  </c:pt>
                  <c:pt idx="419">
                    <c:v>5.207390888271534E-5</c:v>
                  </c:pt>
                  <c:pt idx="420">
                    <c:v>5.0534674694679812E-5</c:v>
                  </c:pt>
                  <c:pt idx="421">
                    <c:v>4.8800918792254491E-5</c:v>
                  </c:pt>
                  <c:pt idx="422">
                    <c:v>4.6898114482184912E-5</c:v>
                  </c:pt>
                  <c:pt idx="423">
                    <c:v>4.4853592743519997E-5</c:v>
                  </c:pt>
                  <c:pt idx="424">
                    <c:v>4.2695878151637965E-5</c:v>
                  </c:pt>
                  <c:pt idx="425">
                    <c:v>4.0454020792927793E-5</c:v>
                  </c:pt>
                  <c:pt idx="426">
                    <c:v>3.8156954165056846E-5</c:v>
                  </c:pt>
                  <c:pt idx="427">
                    <c:v>3.5832901208472931E-5</c:v>
                  </c:pt>
                  <c:pt idx="428">
                    <c:v>3.350883047833636E-5</c:v>
                  </c:pt>
                  <c:pt idx="429">
                    <c:v>3.1209991672499182E-5</c:v>
                  </c:pt>
                  <c:pt idx="430">
                    <c:v>2.8959539547196792E-5</c:v>
                  </c:pt>
                  <c:pt idx="431">
                    <c:v>2.6778222988649335E-5</c:v>
                  </c:pt>
                  <c:pt idx="432">
                    <c:v>2.4684175244874116E-5</c:v>
                  </c:pt>
                  <c:pt idx="433">
                    <c:v>2.2692774774849368E-5</c:v>
                  </c:pt>
                  <c:pt idx="434">
                    <c:v>2.0816569892960783E-5</c:v>
                  </c:pt>
                  <c:pt idx="435">
                    <c:v>1.9065277951079285E-5</c:v>
                  </c:pt>
                  <c:pt idx="436">
                    <c:v>1.7445810373743776E-5</c:v>
                  </c:pt>
                  <c:pt idx="437">
                    <c:v>1.5962348548388011E-5</c:v>
                  </c:pt>
                  <c:pt idx="438">
                    <c:v>1.4616440502878042E-5</c:v>
                  </c:pt>
                  <c:pt idx="439">
                    <c:v>1.3407100087892937E-5</c:v>
                  </c:pt>
                  <c:pt idx="440">
                    <c:v>1.2330965203648296E-5</c:v>
                  </c:pt>
                  <c:pt idx="441">
                    <c:v>1.138245390099735E-5</c:v>
                  </c:pt>
                  <c:pt idx="442">
                    <c:v>1.0554012970171702E-5</c:v>
                  </c:pt>
                  <c:pt idx="443">
                    <c:v>9.8364194174551938E-6</c:v>
                  </c:pt>
                  <c:pt idx="444">
                    <c:v>9.2191736004950219E-6</c:v>
                  </c:pt>
                  <c:pt idx="445">
                    <c:v>8.6909805647439513E-6</c:v>
                  </c:pt>
                  <c:pt idx="446">
                    <c:v>8.2402574589843541E-6</c:v>
                  </c:pt>
                  <c:pt idx="447">
                    <c:v>7.8556407163687665E-6</c:v>
                  </c:pt>
                  <c:pt idx="448">
                    <c:v>7.526420545506463E-6</c:v>
                  </c:pt>
                  <c:pt idx="449">
                    <c:v>7.2428872045617576E-6</c:v>
                  </c:pt>
                  <c:pt idx="450">
                    <c:v>6.9965314438172001E-6</c:v>
                  </c:pt>
                  <c:pt idx="451">
                    <c:v>6.7801255106693382E-6</c:v>
                  </c:pt>
                  <c:pt idx="452">
                    <c:v>6.5877005826180353E-6</c:v>
                  </c:pt>
                  <c:pt idx="453">
                    <c:v>6.414459549508611E-6</c:v>
                  </c:pt>
                  <c:pt idx="454">
                    <c:v>6.2566277325556534E-6</c:v>
                  </c:pt>
                  <c:pt idx="455">
                    <c:v>6.1113020677146538E-6</c:v>
                  </c:pt>
                  <c:pt idx="456">
                    <c:v>5.9762883721657843E-6</c:v>
                  </c:pt>
                  <c:pt idx="457">
                    <c:v>5.8499580661048381E-6</c:v>
                  </c:pt>
                  <c:pt idx="458">
                    <c:v>5.7311205442209037E-6</c:v>
                  </c:pt>
                  <c:pt idx="459">
                    <c:v>5.6189093042028097E-6</c:v>
                  </c:pt>
                  <c:pt idx="460">
                    <c:v>5.5127045554440666E-6</c:v>
                  </c:pt>
                  <c:pt idx="461">
                    <c:v>5.412058482430403E-6</c:v>
                  </c:pt>
                  <c:pt idx="462">
                    <c:v>5.3166382232605062E-6</c:v>
                  </c:pt>
                  <c:pt idx="463">
                    <c:v>5.2261921506999064E-6</c:v>
                  </c:pt>
                  <c:pt idx="464">
                    <c:v>5.1405185904242221E-6</c:v>
                  </c:pt>
                  <c:pt idx="465">
                    <c:v>5.0594479458217109E-6</c:v>
                  </c:pt>
                  <c:pt idx="466">
                    <c:v>4.9828223402069099E-6</c:v>
                  </c:pt>
                  <c:pt idx="467">
                    <c:v>4.9104877981606659E-6</c:v>
                  </c:pt>
                  <c:pt idx="468">
                    <c:v>4.8422924852882385E-6</c:v>
                  </c:pt>
                  <c:pt idx="469">
                    <c:v>4.7780885933779169E-6</c:v>
                  </c:pt>
                  <c:pt idx="470">
                    <c:v>4.7177176202578289E-6</c:v>
                  </c:pt>
                  <c:pt idx="471">
                    <c:v>4.6610240504681802E-6</c:v>
                  </c:pt>
                  <c:pt idx="472">
                    <c:v>4.607851508619715E-6</c:v>
                  </c:pt>
                  <c:pt idx="473">
                    <c:v>4.5580422079106813E-6</c:v>
                  </c:pt>
                  <c:pt idx="474">
                    <c:v>4.5114427984868281E-6</c:v>
                  </c:pt>
                  <c:pt idx="475">
                    <c:v>4.4679056019987462E-6</c:v>
                  </c:pt>
                  <c:pt idx="476">
                    <c:v>4.4272868884512253E-6</c:v>
                  </c:pt>
                  <c:pt idx="477">
                    <c:v>4.389451652233685E-6</c:v>
                  </c:pt>
                  <c:pt idx="478">
                    <c:v>4.3542685053105218E-6</c:v>
                  </c:pt>
                  <c:pt idx="479">
                    <c:v>4.3216213201892912E-6</c:v>
                  </c:pt>
                  <c:pt idx="480">
                    <c:v>4.2913964475064957E-6</c:v>
                  </c:pt>
                  <c:pt idx="481">
                    <c:v>4.2634983545623974E-6</c:v>
                  </c:pt>
                  <c:pt idx="482">
                    <c:v>4.2378284959967384E-6</c:v>
                  </c:pt>
                  <c:pt idx="483">
                    <c:v>4.2143063859950988E-6</c:v>
                  </c:pt>
                  <c:pt idx="484">
                    <c:v>4.1928558972648847E-6</c:v>
                  </c:pt>
                  <c:pt idx="485">
                    <c:v>4.1734098559528828E-6</c:v>
                  </c:pt>
                  <c:pt idx="486">
                    <c:v>4.1559044507665362E-6</c:v>
                  </c:pt>
                  <c:pt idx="487">
                    <c:v>4.1402894677577379E-6</c:v>
                  </c:pt>
                  <c:pt idx="488">
                    <c:v>4.1265164918242757E-6</c:v>
                  </c:pt>
                  <c:pt idx="489">
                    <c:v>4.1145385818712753E-6</c:v>
                  </c:pt>
                  <c:pt idx="490">
                    <c:v>4.1043207376945026E-6</c:v>
                  </c:pt>
                  <c:pt idx="491">
                    <c:v>4.0958312369963988E-6</c:v>
                  </c:pt>
                  <c:pt idx="492">
                    <c:v>4.0890350436447559E-6</c:v>
                  </c:pt>
                  <c:pt idx="493">
                    <c:v>4.0839051109052632E-6</c:v>
                  </c:pt>
                  <c:pt idx="494">
                    <c:v>4.080421809504374E-6</c:v>
                  </c:pt>
                  <c:pt idx="495">
                    <c:v>4.0785586478820737E-6</c:v>
                  </c:pt>
                  <c:pt idx="496">
                    <c:v>4.0782984784366457E-6</c:v>
                  </c:pt>
                  <c:pt idx="497">
                    <c:v>4.0796197682934821E-6</c:v>
                  </c:pt>
                  <c:pt idx="498">
                    <c:v>4.0825099339875394E-6</c:v>
                  </c:pt>
                  <c:pt idx="499">
                    <c:v>4.0869515030263774E-6</c:v>
                  </c:pt>
                  <c:pt idx="500">
                    <c:v>4.0929302822093694E-6</c:v>
                  </c:pt>
                  <c:pt idx="501">
                    <c:v>4.1004321963842125E-6</c:v>
                  </c:pt>
                  <c:pt idx="502">
                    <c:v>4.1094462810148405E-6</c:v>
                  </c:pt>
                  <c:pt idx="503">
                    <c:v>4.1199590618576361E-6</c:v>
                  </c:pt>
                  <c:pt idx="504">
                    <c:v>4.1319596529713183E-6</c:v>
                  </c:pt>
                  <c:pt idx="505">
                    <c:v>4.1454402475133512E-6</c:v>
                  </c:pt>
                  <c:pt idx="506">
                    <c:v>4.1603875438949092E-6</c:v>
                  </c:pt>
                  <c:pt idx="507">
                    <c:v>4.1767936620743251E-6</c:v>
                  </c:pt>
                  <c:pt idx="508">
                    <c:v>4.1946450192206415E-6</c:v>
                  </c:pt>
                  <c:pt idx="509">
                    <c:v>4.213933722579056E-6</c:v>
                  </c:pt>
                  <c:pt idx="510">
                    <c:v>4.2346547450382113E-6</c:v>
                  </c:pt>
                  <c:pt idx="511">
                    <c:v>4.2567917476921033E-6</c:v>
                  </c:pt>
                  <c:pt idx="512">
                    <c:v>4.2803366229014468E-6</c:v>
                  </c:pt>
                  <c:pt idx="513">
                    <c:v>4.3052841011190352E-6</c:v>
                  </c:pt>
                  <c:pt idx="514">
                    <c:v>4.331620557325475E-6</c:v>
                  </c:pt>
                  <c:pt idx="515">
                    <c:v>4.3593376824753515E-6</c:v>
                  </c:pt>
                  <c:pt idx="516">
                    <c:v>4.3884247703495883E-6</c:v>
                  </c:pt>
                  <c:pt idx="517">
                    <c:v>4.4188732777721193E-6</c:v>
                  </c:pt>
                  <c:pt idx="518">
                    <c:v>4.4506667112014893E-6</c:v>
                  </c:pt>
                  <c:pt idx="519">
                    <c:v>4.4837995145661398E-6</c:v>
                  </c:pt>
                  <c:pt idx="520">
                    <c:v>4.5182550355231259E-6</c:v>
                  </c:pt>
                  <c:pt idx="521">
                    <c:v>4.5540249047445094E-6</c:v>
                  </c:pt>
                  <c:pt idx="522">
                    <c:v>4.5910924722951052E-6</c:v>
                  </c:pt>
                  <c:pt idx="523">
                    <c:v>4.6294463896966106E-6</c:v>
                  </c:pt>
                  <c:pt idx="524">
                    <c:v>4.6690698425928633E-6</c:v>
                  </c:pt>
                  <c:pt idx="525">
                    <c:v>4.7099489981126042E-6</c:v>
                  </c:pt>
                  <c:pt idx="526">
                    <c:v>4.7520668770267787E-6</c:v>
                  </c:pt>
                  <c:pt idx="527">
                    <c:v>4.7954038495060799E-6</c:v>
                  </c:pt>
                  <c:pt idx="528">
                    <c:v>4.8399402858763398E-6</c:v>
                  </c:pt>
                  <c:pt idx="529">
                    <c:v>4.8856619403092984E-6</c:v>
                  </c:pt>
                  <c:pt idx="530">
                    <c:v>4.9325410662807468E-6</c:v>
                  </c:pt>
                  <c:pt idx="531">
                    <c:v>4.9805603536560523E-6</c:v>
                  </c:pt>
                  <c:pt idx="532">
                    <c:v>5.0296920560069206E-6</c:v>
                  </c:pt>
                  <c:pt idx="533">
                    <c:v>5.0799133967082747E-6</c:v>
                  </c:pt>
                  <c:pt idx="534">
                    <c:v>5.131196298220348E-6</c:v>
                  </c:pt>
                  <c:pt idx="535">
                    <c:v>5.1835126002204975E-6</c:v>
                  </c:pt>
                  <c:pt idx="536">
                    <c:v>5.236831243566247E-6</c:v>
                  </c:pt>
                  <c:pt idx="537">
                    <c:v>5.291121500310666E-6</c:v>
                  </c:pt>
                  <c:pt idx="538">
                    <c:v>5.3463493297042787E-6</c:v>
                  </c:pt>
                  <c:pt idx="539">
                    <c:v>5.402478206123762E-6</c:v>
                  </c:pt>
                  <c:pt idx="540">
                    <c:v>5.4594743372083451E-6</c:v>
                  </c:pt>
                  <c:pt idx="541">
                    <c:v>5.5172926664782407E-6</c:v>
                  </c:pt>
                  <c:pt idx="542">
                    <c:v>5.5758964199234989E-6</c:v>
                  </c:pt>
                  <c:pt idx="543">
                    <c:v>5.635237725162412E-6</c:v>
                  </c:pt>
                  <c:pt idx="544">
                    <c:v>5.6952769094506913E-6</c:v>
                  </c:pt>
                  <c:pt idx="545">
                    <c:v>5.7559605513737831E-6</c:v>
                  </c:pt>
                  <c:pt idx="546">
                    <c:v>5.8172403650460157E-6</c:v>
                  </c:pt>
                  <c:pt idx="547">
                    <c:v>5.8790625163046051E-6</c:v>
                  </c:pt>
                  <c:pt idx="548">
                    <c:v>5.9413759884820271E-6</c:v>
                  </c:pt>
                  <c:pt idx="549">
                    <c:v>6.0041238876455312E-6</c:v>
                  </c:pt>
                  <c:pt idx="550">
                    <c:v>6.0672405464983684E-6</c:v>
                  </c:pt>
                  <c:pt idx="551">
                    <c:v>6.1306714910406564E-6</c:v>
                  </c:pt>
                  <c:pt idx="552">
                    <c:v>6.1943447947130897E-6</c:v>
                  </c:pt>
                  <c:pt idx="553">
                    <c:v>6.2581993386235674E-6</c:v>
                  </c:pt>
                  <c:pt idx="554">
                    <c:v>6.3221594226697767E-6</c:v>
                  </c:pt>
                  <c:pt idx="555">
                    <c:v>6.3861571848101113E-6</c:v>
                  </c:pt>
                  <c:pt idx="556">
                    <c:v>6.4501123451113184E-6</c:v>
                  </c:pt>
                  <c:pt idx="557">
                    <c:v>6.5139469535736759E-6</c:v>
                  </c:pt>
                  <c:pt idx="558">
                    <c:v>6.5775788563962521E-6</c:v>
                  </c:pt>
                  <c:pt idx="559">
                    <c:v>6.640922691712284E-6</c:v>
                  </c:pt>
                  <c:pt idx="560">
                    <c:v>6.7038922034521454E-6</c:v>
                  </c:pt>
                  <c:pt idx="561">
                    <c:v>6.766398982864077E-6</c:v>
                  </c:pt>
                  <c:pt idx="562">
                    <c:v>6.8283512092953156E-6</c:v>
                  </c:pt>
                  <c:pt idx="563">
                    <c:v>6.889667289890039E-6</c:v>
                  </c:pt>
                  <c:pt idx="564">
                    <c:v>6.9502666127741311E-6</c:v>
                  </c:pt>
                  <c:pt idx="565">
                    <c:v>7.010088371637529E-6</c:v>
                  </c:pt>
                  <c:pt idx="566">
                    <c:v>7.0690967630575542E-6</c:v>
                  </c:pt>
                  <c:pt idx="567">
                    <c:v>7.1273011042046924E-6</c:v>
                  </c:pt>
                  <c:pt idx="568">
                    <c:v>7.1847739920273193E-6</c:v>
                  </c:pt>
                  <c:pt idx="569">
                    <c:v>7.24169812546375E-6</c:v>
                  </c:pt>
                  <c:pt idx="570">
                    <c:v>7.2984027337278443E-6</c:v>
                  </c:pt>
                  <c:pt idx="571">
                    <c:v>7.3554349861274196E-6</c:v>
                  </c:pt>
                  <c:pt idx="572">
                    <c:v>7.4136517868314095E-6</c:v>
                  </c:pt>
                  <c:pt idx="573">
                    <c:v>7.4743162636729177E-6</c:v>
                  </c:pt>
                  <c:pt idx="574">
                    <c:v>7.539246048667605E-6</c:v>
                  </c:pt>
                  <c:pt idx="575">
                    <c:v>7.6109723832311137E-6</c:v>
                  </c:pt>
                  <c:pt idx="576">
                    <c:v>7.6929251731339415E-6</c:v>
                  </c:pt>
                  <c:pt idx="577">
                    <c:v>7.7896148718205083E-6</c:v>
                  </c:pt>
                  <c:pt idx="578">
                    <c:v>7.9068081497664878E-6</c:v>
                  </c:pt>
                  <c:pt idx="579">
                    <c:v>8.0516414863087419E-6</c:v>
                  </c:pt>
                  <c:pt idx="580">
                    <c:v>8.2326345310039681E-6</c:v>
                  </c:pt>
                  <c:pt idx="581">
                    <c:v>8.459548306182094E-6</c:v>
                  </c:pt>
                  <c:pt idx="582">
                    <c:v>8.7430515033308724E-6</c:v>
                  </c:pt>
                  <c:pt idx="583">
                    <c:v>9.0941741246386339E-6</c:v>
                  </c:pt>
                  <c:pt idx="584">
                    <c:v>9.523598046538954E-6</c:v>
                  </c:pt>
                  <c:pt idx="585">
                    <c:v>1.0040864049623834E-5</c:v>
                  </c:pt>
                  <c:pt idx="586">
                    <c:v>1.06536193866513E-5</c:v>
                  </c:pt>
                  <c:pt idx="587">
                    <c:v>1.1367011410295084E-5</c:v>
                  </c:pt>
                  <c:pt idx="588">
                    <c:v>1.2183327610602724E-5</c:v>
                  </c:pt>
                  <c:pt idx="589">
                    <c:v>1.3101849114675687E-5</c:v>
                  </c:pt>
                  <c:pt idx="590">
                    <c:v>1.4118900214079484E-5</c:v>
                  </c:pt>
                  <c:pt idx="591">
                    <c:v>1.5228027856231516E-5</c:v>
                  </c:pt>
                  <c:pt idx="592">
                    <c:v>1.6420235977388985E-5</c:v>
                  </c:pt>
                  <c:pt idx="593">
                    <c:v>1.7684265071156775E-5</c:v>
                  </c:pt>
                  <c:pt idx="594">
                    <c:v>1.9006849324214949E-5</c:v>
                  </c:pt>
                  <c:pt idx="595">
                    <c:v>2.0373005692635351E-5</c:v>
                  </c:pt>
                  <c:pt idx="596">
                    <c:v>2.1766304031150836E-5</c:v>
                  </c:pt>
                  <c:pt idx="597">
                    <c:v>2.3169166160939579E-5</c:v>
                  </c:pt>
                  <c:pt idx="598">
                    <c:v>2.4563193426752444E-5</c:v>
                  </c:pt>
                  <c:pt idx="599">
                    <c:v>2.592948067093322E-5</c:v>
                  </c:pt>
                  <c:pt idx="600">
                    <c:v>2.7248993966556218E-5</c:v>
                  </c:pt>
                  <c:pt idx="601">
                    <c:v>2.850293935568774E-5</c:v>
                  </c:pt>
                  <c:pt idx="602">
                    <c:v>2.9673131362127781E-5</c:v>
                  </c:pt>
                  <c:pt idx="603">
                    <c:v>3.0742386157237342E-5</c:v>
                  </c:pt>
                  <c:pt idx="604">
                    <c:v>3.169488016428826E-5</c:v>
                  </c:pt>
                  <c:pt idx="605">
                    <c:v>3.2516478699818918E-5</c:v>
                  </c:pt>
                  <c:pt idx="606">
                    <c:v>3.3195047843988445E-5</c:v>
                  </c:pt>
                  <c:pt idx="607">
                    <c:v>3.3720710084043068E-5</c:v>
                  </c:pt>
                  <c:pt idx="608">
                    <c:v>3.4086041186404343E-5</c:v>
                  </c:pt>
                  <c:pt idx="609">
                    <c:v>3.4286199985983045E-5</c:v>
                  </c:pt>
                  <c:pt idx="610">
                    <c:v>3.4319027898947348E-5</c:v>
                  </c:pt>
                  <c:pt idx="611">
                    <c:v>3.4185031170289594E-5</c:v>
                  </c:pt>
                  <c:pt idx="612">
                    <c:v>3.3887337193204093E-5</c:v>
                  </c:pt>
                  <c:pt idx="613">
                    <c:v>3.3431566418452464E-5</c:v>
                  </c:pt>
                  <c:pt idx="614">
                    <c:v>3.2825657773058499E-5</c:v>
                  </c:pt>
                  <c:pt idx="615">
                    <c:v>3.2079630202186425E-5</c:v>
                  </c:pt>
                  <c:pt idx="616">
                    <c:v>3.1205326345208232E-5</c:v>
                  </c:pt>
                  <c:pt idx="617">
                    <c:v>3.0216091995089216E-5</c:v>
                  </c:pt>
                  <c:pt idx="618">
                    <c:v>2.9126469163247635E-5</c:v>
                  </c:pt>
                  <c:pt idx="619">
                    <c:v>2.7951847742456245E-5</c:v>
                  </c:pt>
                  <c:pt idx="620">
                    <c:v>2.6708132438818534E-5</c:v>
                  </c:pt>
                  <c:pt idx="621">
                    <c:v>2.5411414830724013E-5</c:v>
                  </c:pt>
                  <c:pt idx="622">
                    <c:v>2.4077667354006569E-5</c:v>
                  </c:pt>
                  <c:pt idx="623">
                    <c:v>2.2722466303859905E-5</c:v>
                  </c:pt>
                  <c:pt idx="624">
                    <c:v>2.1360716163460314E-5</c:v>
                  </c:pt>
                  <c:pt idx="625">
                    <c:v>2.0006464008205947E-5</c:v>
                  </c:pt>
                  <c:pt idx="626">
                    <c:v>1.8672702023215747E-5</c:v>
                  </c:pt>
                  <c:pt idx="627">
                    <c:v>1.7371236946027564E-5</c:v>
                  </c:pt>
                  <c:pt idx="628">
                    <c:v>1.6112594564594662E-5</c:v>
                  </c:pt>
                  <c:pt idx="629">
                    <c:v>1.4905958177352502E-5</c:v>
                  </c:pt>
                  <c:pt idx="630">
                    <c:v>1.3759142385727915E-5</c:v>
                  </c:pt>
                  <c:pt idx="631">
                    <c:v>1.2678602062634554E-5</c:v>
                  </c:pt>
                  <c:pt idx="632">
                    <c:v>1.1669458832042559E-5</c:v>
                  </c:pt>
                  <c:pt idx="633">
                    <c:v>1.0735537903357354E-5</c:v>
                  </c:pt>
                  <c:pt idx="634">
                    <c:v>9.8794393449132618E-6</c:v>
                  </c:pt>
                  <c:pt idx="635">
                    <c:v>9.1025826070011071E-6</c:v>
                  </c:pt>
                  <c:pt idx="636">
                    <c:v>8.4052752846968594E-6</c:v>
                  </c:pt>
                  <c:pt idx="637">
                    <c:v>7.7867663082069987E-6</c:v>
                  </c:pt>
                  <c:pt idx="638">
                    <c:v>7.2453032493156004E-6</c:v>
                  </c:pt>
                  <c:pt idx="639">
                    <c:v>6.778198968542513E-6</c:v>
                  </c:pt>
                  <c:pt idx="640">
                    <c:v>6.3819206446582994E-6</c:v>
                  </c:pt>
                  <c:pt idx="641">
                    <c:v>6.0522111480505827E-6</c:v>
                  </c:pt>
                  <c:pt idx="642">
                    <c:v>5.7842526803936934E-6</c:v>
                  </c:pt>
                  <c:pt idx="643">
                    <c:v>5.5728708469666865E-6</c:v>
                  </c:pt>
                  <c:pt idx="644">
                    <c:v>5.412759868862857E-6</c:v>
                  </c:pt>
                  <c:pt idx="645">
                    <c:v>5.2987111216530571E-6</c:v>
                  </c:pt>
                  <c:pt idx="646">
                    <c:v>5.2258153533912938E-6</c:v>
                  </c:pt>
                  <c:pt idx="647">
                    <c:v>5.1895965625027889E-6</c:v>
                  </c:pt>
                  <c:pt idx="648">
                    <c:v>5.1861163651123421E-6</c:v>
                  </c:pt>
                  <c:pt idx="649">
                    <c:v>5.2119807934605355E-6</c:v>
                  </c:pt>
                  <c:pt idx="650">
                    <c:v>5.2643183128768876E-6</c:v>
                  </c:pt>
                  <c:pt idx="651">
                    <c:v>5.3407248807162697E-6</c:v>
                  </c:pt>
                  <c:pt idx="652">
                    <c:v>5.439183552774571E-6</c:v>
                  </c:pt>
                  <c:pt idx="653">
                    <c:v>5.5579862908013804E-6</c:v>
                  </c:pt>
                  <c:pt idx="654">
                    <c:v>5.6956547496251955E-6</c:v>
                  </c:pt>
                  <c:pt idx="655">
                    <c:v>5.8508775588951989E-6</c:v>
                  </c:pt>
                  <c:pt idx="656">
                    <c:v>6.0224535747166609E-6</c:v>
                  </c:pt>
                  <c:pt idx="657">
                    <c:v>6.2092568829612766E-6</c:v>
                  </c:pt>
                  <c:pt idx="658">
                    <c:v>6.4101995928618012E-6</c:v>
                  </c:pt>
                  <c:pt idx="659">
                    <c:v>6.6242198816705787E-6</c:v>
                  </c:pt>
                  <c:pt idx="660">
                    <c:v>6.8502679051760289E-6</c:v>
                  </c:pt>
                  <c:pt idx="661">
                    <c:v>7.0872885831889448E-6</c:v>
                  </c:pt>
                  <c:pt idx="662">
                    <c:v>7.3342311902612884E-6</c:v>
                  </c:pt>
                  <c:pt idx="663">
                    <c:v>7.590038918975633E-6</c:v>
                  </c:pt>
                  <c:pt idx="664">
                    <c:v>7.8536489756356169E-6</c:v>
                  </c:pt>
                  <c:pt idx="665">
                    <c:v>8.1239966820145877E-6</c:v>
                  </c:pt>
                  <c:pt idx="666">
                    <c:v>8.4000110002217288E-6</c:v>
                  </c:pt>
                  <c:pt idx="667">
                    <c:v>8.6806145826554325E-6</c:v>
                  </c:pt>
                  <c:pt idx="668">
                    <c:v>8.9647370801336929E-6</c:v>
                  </c:pt>
                  <c:pt idx="669">
                    <c:v>9.2512979092163371E-6</c:v>
                  </c:pt>
                  <c:pt idx="670">
                    <c:v>9.5392250287790626E-6</c:v>
                  </c:pt>
                  <c:pt idx="671">
                    <c:v>9.8274464762382362E-6</c:v>
                  </c:pt>
                  <c:pt idx="672">
                    <c:v>1.0114888666823082E-5</c:v>
                  </c:pt>
                  <c:pt idx="673">
                    <c:v>1.0400494224500767E-5</c:v>
                  </c:pt>
                  <c:pt idx="674">
                    <c:v>1.0683206811825363E-5</c:v>
                  </c:pt>
                  <c:pt idx="675">
                    <c:v>1.0961979751576671E-5</c:v>
                  </c:pt>
                  <c:pt idx="676">
                    <c:v>1.123578950639871E-5</c:v>
                  </c:pt>
                  <c:pt idx="677">
                    <c:v>1.1503616284257918E-5</c:v>
                  </c:pt>
                  <c:pt idx="678">
                    <c:v>1.1764468882060973E-5</c:v>
                  </c:pt>
                  <c:pt idx="679">
                    <c:v>1.2017376793344179E-5</c:v>
                  </c:pt>
                  <c:pt idx="680">
                    <c:v>1.2261390138390154E-5</c:v>
                  </c:pt>
                  <c:pt idx="681">
                    <c:v>1.2495596839177732E-5</c:v>
                  </c:pt>
                  <c:pt idx="682">
                    <c:v>1.2719114368878903E-5</c:v>
                  </c:pt>
                  <c:pt idx="683">
                    <c:v>1.2931096499854779E-5</c:v>
                  </c:pt>
                  <c:pt idx="684">
                    <c:v>1.3130738034802229E-5</c:v>
                  </c:pt>
                  <c:pt idx="685">
                    <c:v>1.3317277683478672E-5</c:v>
                  </c:pt>
                  <c:pt idx="686">
                    <c:v>1.3489999132951872E-5</c:v>
                  </c:pt>
                  <c:pt idx="687">
                    <c:v>1.3648242346298928E-5</c:v>
                  </c:pt>
                  <c:pt idx="688">
                    <c:v>1.3791399951410172E-5</c:v>
                  </c:pt>
                  <c:pt idx="689">
                    <c:v>1.3918914010930226E-5</c:v>
                  </c:pt>
                  <c:pt idx="690">
                    <c:v>1.4030292212843062E-5</c:v>
                  </c:pt>
                  <c:pt idx="691">
                    <c:v>1.412510783390317E-5</c:v>
                  </c:pt>
                  <c:pt idx="692">
                    <c:v>1.4202987733222091E-5</c:v>
                  </c:pt>
                  <c:pt idx="693">
                    <c:v>1.426363477401098E-5</c:v>
                  </c:pt>
                  <c:pt idx="694">
                    <c:v>1.4306807806590164E-5</c:v>
                  </c:pt>
                  <c:pt idx="695">
                    <c:v>1.4332346620593774E-5</c:v>
                  </c:pt>
                  <c:pt idx="696">
                    <c:v>1.4340146560725881E-5</c:v>
                  </c:pt>
                  <c:pt idx="697">
                    <c:v>1.433017783275946E-5</c:v>
                  </c:pt>
                  <c:pt idx="698">
                    <c:v>1.4302482589326695E-5</c:v>
                  </c:pt>
                  <c:pt idx="699">
                    <c:v>1.4257166204850329E-5</c:v>
                  </c:pt>
                  <c:pt idx="700">
                    <c:v>1.4194400292822462E-5</c:v>
                  </c:pt>
                  <c:pt idx="701">
                    <c:v>1.4114424789445107E-5</c:v>
                  </c:pt>
                  <c:pt idx="702">
                    <c:v>1.4017545619967528E-5</c:v>
                  </c:pt>
                  <c:pt idx="703">
                    <c:v>1.3904125808380099E-5</c:v>
                  </c:pt>
                  <c:pt idx="704">
                    <c:v>1.3774588224542746E-5</c:v>
                  </c:pt>
                  <c:pt idx="705">
                    <c:v>1.3629412791945456E-5</c:v>
                  </c:pt>
                  <c:pt idx="706">
                    <c:v>1.3469136302217803E-5</c:v>
                  </c:pt>
                  <c:pt idx="707">
                    <c:v>1.3294343997973212E-5</c:v>
                  </c:pt>
                  <c:pt idx="708">
                    <c:v>1.3105663727220641E-5</c:v>
                  </c:pt>
                  <c:pt idx="709">
                    <c:v>1.2903766105969467E-5</c:v>
                  </c:pt>
                  <c:pt idx="710">
                    <c:v>1.2689367089977419E-5</c:v>
                  </c:pt>
                  <c:pt idx="711">
                    <c:v>1.2463208341063574E-5</c:v>
                  </c:pt>
                  <c:pt idx="712">
                    <c:v>1.2226065570041766E-5</c:v>
                  </c:pt>
                  <c:pt idx="713">
                    <c:v>1.1978742905886444E-5</c:v>
                  </c:pt>
                  <c:pt idx="714">
                    <c:v>1.1722055974094042E-5</c:v>
                  </c:pt>
                  <c:pt idx="715">
                    <c:v>1.1456843044013859E-5</c:v>
                  </c:pt>
                  <c:pt idx="716">
                    <c:v>1.1183959595089553E-5</c:v>
                  </c:pt>
                  <c:pt idx="717">
                    <c:v>1.0904252687982391E-5</c:v>
                  </c:pt>
                  <c:pt idx="718">
                    <c:v>1.0618589182398674E-5</c:v>
                  </c:pt>
                  <c:pt idx="719">
                    <c:v>1.0327824948414838E-5</c:v>
                  </c:pt>
                  <c:pt idx="720">
                    <c:v>1.0032810135652618E-5</c:v>
                  </c:pt>
                  <c:pt idx="721">
                    <c:v>9.7343866444194691E-6</c:v>
                  </c:pt>
                  <c:pt idx="722">
                    <c:v>9.4333879628206804E-6</c:v>
                  </c:pt>
                  <c:pt idx="723">
                    <c:v>9.1306251289346339E-6</c:v>
                  </c:pt>
                  <c:pt idx="724">
                    <c:v>8.8268894241320498E-6</c:v>
                  </c:pt>
                  <c:pt idx="725">
                    <c:v>8.522947016298328E-6</c:v>
                  </c:pt>
                  <c:pt idx="726">
                    <c:v>8.2195384941362587E-6</c:v>
                  </c:pt>
                  <c:pt idx="727">
                    <c:v>7.9173821965254069E-6</c:v>
                  </c:pt>
                  <c:pt idx="728">
                    <c:v>7.6171541482846325E-6</c:v>
                  </c:pt>
                  <c:pt idx="729">
                    <c:v>7.3195022507696381E-6</c:v>
                  </c:pt>
                  <c:pt idx="730">
                    <c:v>7.0250377054615605E-6</c:v>
                  </c:pt>
                  <c:pt idx="731">
                    <c:v>6.7343408887443202E-6</c:v>
                  </c:pt>
                  <c:pt idx="732">
                    <c:v>6.4479442689149749E-6</c:v>
                  </c:pt>
                  <c:pt idx="733">
                    <c:v>6.1663464801212348E-6</c:v>
                  </c:pt>
                  <c:pt idx="734">
                    <c:v>5.8900068157661068E-6</c:v>
                  </c:pt>
                  <c:pt idx="735">
                    <c:v>5.619342216475977E-6</c:v>
                  </c:pt>
                  <c:pt idx="736">
                    <c:v>5.3547359098275557E-6</c:v>
                  </c:pt>
                  <c:pt idx="737">
                    <c:v>5.0965233320365797E-6</c:v>
                  </c:pt>
                  <c:pt idx="738">
                    <c:v>4.8450030563349544E-6</c:v>
                  </c:pt>
                  <c:pt idx="739">
                    <c:v>4.6004345088619291E-6</c:v>
                  </c:pt>
                  <c:pt idx="740">
                    <c:v>4.3630402470652702E-6</c:v>
                  </c:pt>
                  <c:pt idx="741">
                    <c:v>4.1330064309560384E-6</c:v>
                  </c:pt>
                  <c:pt idx="742">
                    <c:v>3.9104796673800333E-6</c:v>
                  </c:pt>
                  <c:pt idx="743">
                    <c:v>3.6955728458181499E-6</c:v>
                  </c:pt>
                  <c:pt idx="744">
                    <c:v>3.488364860352823E-6</c:v>
                  </c:pt>
                  <c:pt idx="745">
                    <c:v>3.2889067274358195E-6</c:v>
                  </c:pt>
                  <c:pt idx="746">
                    <c:v>3.0972125801073581E-6</c:v>
                  </c:pt>
                  <c:pt idx="747">
                    <c:v>2.9132770531341732E-6</c:v>
                  </c:pt>
                  <c:pt idx="748">
                    <c:v>2.7370551484667494E-6</c:v>
                  </c:pt>
                  <c:pt idx="749">
                    <c:v>2.5684907478652044E-6</c:v>
                  </c:pt>
                  <c:pt idx="750">
                    <c:v>2.4074967601396265E-6</c:v>
                  </c:pt>
                  <c:pt idx="751">
                    <c:v>2.2539633528952918E-6</c:v>
                  </c:pt>
                  <c:pt idx="752">
                    <c:v>2.1077696461076644E-6</c:v>
                  </c:pt>
                  <c:pt idx="753">
                    <c:v>1.9687664573031466E-6</c:v>
                  </c:pt>
                  <c:pt idx="754">
                    <c:v>1.8368019340301526E-6</c:v>
                  </c:pt>
                  <c:pt idx="755">
                    <c:v>1.7116958472536255E-6</c:v>
                  </c:pt>
                  <c:pt idx="756">
                    <c:v>1.5932681138727452E-6</c:v>
                  </c:pt>
                  <c:pt idx="757">
                    <c:v>1.4813244987170632E-6</c:v>
                  </c:pt>
                  <c:pt idx="758">
                    <c:v>1.3756567605426954E-6</c:v>
                  </c:pt>
                  <c:pt idx="759">
                    <c:v>1.2760565855950837E-6</c:v>
                  </c:pt>
                  <c:pt idx="760">
                    <c:v>1.1823099546398917E-6</c:v>
                  </c:pt>
                  <c:pt idx="761">
                    <c:v>1.094194548206053E-6</c:v>
                  </c:pt>
                  <c:pt idx="762">
                    <c:v>1.0114850834974495E-6</c:v>
                  </c:pt>
                  <c:pt idx="763">
                    <c:v>9.3395924217399098E-7</c:v>
                  </c:pt>
                  <c:pt idx="764">
                    <c:v>8.6138892589122983E-7</c:v>
                  </c:pt>
                  <c:pt idx="765">
                    <c:v>7.935544841712749E-7</c:v>
                  </c:pt>
                  <c:pt idx="766">
                    <c:v>7.3023078379117121E-7</c:v>
                  </c:pt>
                  <c:pt idx="767">
                    <c:v>6.7119543354830219E-7</c:v>
                  </c:pt>
                  <c:pt idx="768">
                    <c:v>6.1623434072611187E-7</c:v>
                  </c:pt>
                  <c:pt idx="769">
                    <c:v>5.6513074611855363E-7</c:v>
                  </c:pt>
                  <c:pt idx="770">
                    <c:v>5.1768197094265033E-7</c:v>
                  </c:pt>
                  <c:pt idx="771">
                    <c:v>4.7367970467167217E-7</c:v>
                  </c:pt>
                  <c:pt idx="772">
                    <c:v>4.3292949115970579E-7</c:v>
                  </c:pt>
                  <c:pt idx="773">
                    <c:v>3.9524006657769178E-7</c:v>
                  </c:pt>
                  <c:pt idx="774">
                    <c:v>3.604283141286988E-7</c:v>
                  </c:pt>
                  <c:pt idx="775">
                    <c:v>3.2831126775522606E-7</c:v>
                  </c:pt>
                  <c:pt idx="776">
                    <c:v>2.9872278213782629E-7</c:v>
                  </c:pt>
                  <c:pt idx="777">
                    <c:v>2.7149671190058268E-7</c:v>
                  </c:pt>
                  <c:pt idx="778">
                    <c:v>2.4647817571428151E-7</c:v>
                  </c:pt>
                  <c:pt idx="779">
                    <c:v>2.2351236803785423E-7</c:v>
                  </c:pt>
                  <c:pt idx="780">
                    <c:v>2.0246411980582227E-7</c:v>
                  </c:pt>
                  <c:pt idx="781">
                    <c:v>1.8319262987963172E-7</c:v>
                  </c:pt>
                  <c:pt idx="782">
                    <c:v>1.65573993232589E-7</c:v>
                  </c:pt>
                  <c:pt idx="783">
                    <c:v>1.4948156477889293E-7</c:v>
                  </c:pt>
                  <c:pt idx="784">
                    <c:v>1.3480544367030838E-7</c:v>
                  </c:pt>
                  <c:pt idx="785">
                    <c:v>1.214358809996827E-7</c:v>
                  </c:pt>
                  <c:pt idx="786">
                    <c:v>1.092714999682265E-7</c:v>
                  </c:pt>
                  <c:pt idx="787">
                    <c:v>9.8219371835948922E-8</c:v>
                  </c:pt>
                  <c:pt idx="788">
                    <c:v>8.8186491717927167E-8</c:v>
                  </c:pt>
                  <c:pt idx="789">
                    <c:v>7.9091347165802257E-8</c:v>
                  </c:pt>
                  <c:pt idx="790">
                    <c:v>7.0857829463427819E-8</c:v>
                  </c:pt>
                  <c:pt idx="791">
                    <c:v>6.3412722020525803E-8</c:v>
                  </c:pt>
                  <c:pt idx="792">
                    <c:v>5.6685700366193154E-8</c:v>
                  </c:pt>
                  <c:pt idx="793">
                    <c:v>5.0617551926501442E-8</c:v>
                  </c:pt>
                  <c:pt idx="794">
                    <c:v>4.515203235613224E-8</c:v>
                  </c:pt>
                  <c:pt idx="795">
                    <c:v>4.0232745075703327E-8</c:v>
                  </c:pt>
                  <c:pt idx="796">
                    <c:v>3.5809077813838647E-8</c:v>
                  </c:pt>
                  <c:pt idx="797">
                    <c:v>3.1838714076615566E-8</c:v>
                  </c:pt>
                  <c:pt idx="798">
                    <c:v>2.8276673649017864E-8</c:v>
                  </c:pt>
                  <c:pt idx="799">
                    <c:v>2.5086348232424821E-8</c:v>
                  </c:pt>
                  <c:pt idx="800">
                    <c:v>2.223105339482886E-8</c:v>
                  </c:pt>
                  <c:pt idx="801">
                    <c:v>1.9682705057164954E-8</c:v>
                  </c:pt>
                  <c:pt idx="802">
                    <c:v>1.740469487949721E-8</c:v>
                  </c:pt>
                  <c:pt idx="803">
                    <c:v>1.5374494694581106E-8</c:v>
                  </c:pt>
                  <c:pt idx="804">
                    <c:v>1.3569500305548252E-8</c:v>
                  </c:pt>
                  <c:pt idx="805">
                    <c:v>1.1961627608470839E-8</c:v>
                  </c:pt>
                  <c:pt idx="806">
                    <c:v>1.0531240035075871E-8</c:v>
                  </c:pt>
                  <c:pt idx="807">
                    <c:v>9.2641059224446494E-9</c:v>
                  </c:pt>
                  <c:pt idx="808">
                    <c:v>8.1405889572824257E-9</c:v>
                  </c:pt>
                  <c:pt idx="809">
                    <c:v>7.1465334212953178E-9</c:v>
                  </c:pt>
                  <c:pt idx="810">
                    <c:v>6.2651942235570095E-9</c:v>
                  </c:pt>
                  <c:pt idx="811">
                    <c:v>5.4880478455019825E-9</c:v>
                  </c:pt>
                  <c:pt idx="812">
                    <c:v>4.8009389266329425E-9</c:v>
                  </c:pt>
                  <c:pt idx="813">
                    <c:v>4.1983856400415729E-9</c:v>
                  </c:pt>
                  <c:pt idx="814">
                    <c:v>3.6661580210853585E-9</c:v>
                  </c:pt>
                  <c:pt idx="815">
                    <c:v>3.1959575778865004E-9</c:v>
                  </c:pt>
                  <c:pt idx="816">
                    <c:v>2.784818736217136E-9</c:v>
                  </c:pt>
                  <c:pt idx="817">
                    <c:v>2.4244433583129217E-9</c:v>
                  </c:pt>
                  <c:pt idx="818">
                    <c:v>2.1090488923495111E-9</c:v>
                  </c:pt>
                  <c:pt idx="819">
                    <c:v>1.8302629930987254E-9</c:v>
                  </c:pt>
                  <c:pt idx="820">
                    <c:v>1.5880856693813657E-9</c:v>
                  </c:pt>
                  <c:pt idx="821">
                    <c:v>1.376959086730834E-9</c:v>
                  </c:pt>
                  <c:pt idx="822">
                    <c:v>1.1939175294195968E-9</c:v>
                  </c:pt>
                  <c:pt idx="823">
                    <c:v>1.0305882720994458E-9</c:v>
                  </c:pt>
                  <c:pt idx="824">
                    <c:v>8.9268174603744122E-10</c:v>
                  </c:pt>
                  <c:pt idx="825">
                    <c:v>7.6877639327514662E-10</c:v>
                  </c:pt>
                  <c:pt idx="826">
                    <c:v>6.645832557250352E-10</c:v>
                  </c:pt>
                  <c:pt idx="827">
                    <c:v>5.716542411533141E-10</c:v>
                  </c:pt>
                  <c:pt idx="828">
                    <c:v>4.9280538030458111E-10</c:v>
                  </c:pt>
                  <c:pt idx="829">
                    <c:v>4.2240461168964096E-10</c:v>
                  </c:pt>
                  <c:pt idx="830">
                    <c:v>3.632679660530912E-10</c:v>
                  </c:pt>
                  <c:pt idx="831">
                    <c:v>3.1257941265033427E-10</c:v>
                  </c:pt>
                  <c:pt idx="832">
                    <c:v>2.6752292073677262E-10</c:v>
                  </c:pt>
                  <c:pt idx="833">
                    <c:v>2.2809849031240615E-10</c:v>
                  </c:pt>
                  <c:pt idx="834">
                    <c:v>1.9430612137723487E-10</c:v>
                  </c:pt>
                  <c:pt idx="835">
                    <c:v>1.661458139312588E-10</c:v>
                  </c:pt>
                  <c:pt idx="836">
                    <c:v>1.4361756797447795E-10</c:v>
                  </c:pt>
                  <c:pt idx="837">
                    <c:v>1.2108932201769709E-10</c:v>
                  </c:pt>
                  <c:pt idx="838">
                    <c:v>1.0419313755011144E-10</c:v>
                  </c:pt>
                  <c:pt idx="839">
                    <c:v>8.7296953082525797E-11</c:v>
                  </c:pt>
                  <c:pt idx="840">
                    <c:v>7.603283010413537E-11</c:v>
                  </c:pt>
                  <c:pt idx="841">
                    <c:v>6.4768707125744956E-11</c:v>
                  </c:pt>
                  <c:pt idx="842">
                    <c:v>5.3504584147354529E-11</c:v>
                  </c:pt>
                  <c:pt idx="843">
                    <c:v>4.5056491913561702E-11</c:v>
                  </c:pt>
                  <c:pt idx="844">
                    <c:v>3.9424430424366495E-11</c:v>
                  </c:pt>
                  <c:pt idx="845">
                    <c:v>3.3792368935171281E-11</c:v>
                  </c:pt>
                  <c:pt idx="846">
                    <c:v>2.8160307445976061E-11</c:v>
                  </c:pt>
                  <c:pt idx="847">
                    <c:v>2.2528245956780851E-11</c:v>
                  </c:pt>
                  <c:pt idx="848">
                    <c:v>1.9712215212183247E-11</c:v>
                  </c:pt>
                  <c:pt idx="849">
                    <c:v>1.6896184467585641E-11</c:v>
                  </c:pt>
                  <c:pt idx="850">
                    <c:v>1.4080153722988031E-11</c:v>
                  </c:pt>
                  <c:pt idx="851">
                    <c:v>1.1264122978390425E-11</c:v>
                  </c:pt>
                  <c:pt idx="852">
                    <c:v>1.1264122978390425E-11</c:v>
                  </c:pt>
                  <c:pt idx="853">
                    <c:v>8.4480922337928203E-12</c:v>
                  </c:pt>
                  <c:pt idx="854">
                    <c:v>5.6320614891952127E-12</c:v>
                  </c:pt>
                  <c:pt idx="855">
                    <c:v>5.6320614891952127E-12</c:v>
                  </c:pt>
                  <c:pt idx="856">
                    <c:v>5.6320614891952127E-12</c:v>
                  </c:pt>
                  <c:pt idx="857">
                    <c:v>2.8160307445976064E-12</c:v>
                  </c:pt>
                  <c:pt idx="858">
                    <c:v>2.8160307445976064E-12</c:v>
                  </c:pt>
                  <c:pt idx="859">
                    <c:v>2.8160307445976064E-12</c:v>
                  </c:pt>
                  <c:pt idx="860">
                    <c:v>0</c:v>
                  </c:pt>
                  <c:pt idx="861">
                    <c:v>0</c:v>
                  </c:pt>
                  <c:pt idx="862">
                    <c:v>0</c:v>
                  </c:pt>
                  <c:pt idx="863">
                    <c:v>0</c:v>
                  </c:pt>
                  <c:pt idx="864">
                    <c:v>0</c:v>
                  </c:pt>
                  <c:pt idx="865">
                    <c:v>0</c:v>
                  </c:pt>
                  <c:pt idx="866">
                    <c:v>0</c:v>
                  </c:pt>
                  <c:pt idx="867">
                    <c:v>0</c:v>
                  </c:pt>
                  <c:pt idx="868">
                    <c:v>0</c:v>
                  </c:pt>
                  <c:pt idx="869">
                    <c:v>0</c:v>
                  </c:pt>
                  <c:pt idx="870">
                    <c:v>0</c:v>
                  </c:pt>
                  <c:pt idx="871">
                    <c:v>0</c:v>
                  </c:pt>
                  <c:pt idx="872">
                    <c:v>0</c:v>
                  </c:pt>
                  <c:pt idx="873">
                    <c:v>0</c:v>
                  </c:pt>
                  <c:pt idx="874">
                    <c:v>0</c:v>
                  </c:pt>
                  <c:pt idx="875">
                    <c:v>0</c:v>
                  </c:pt>
                  <c:pt idx="876">
                    <c:v>0</c:v>
                  </c:pt>
                  <c:pt idx="877">
                    <c:v>0</c:v>
                  </c:pt>
                  <c:pt idx="878">
                    <c:v>0</c:v>
                  </c:pt>
                  <c:pt idx="879">
                    <c:v>0</c:v>
                  </c:pt>
                  <c:pt idx="880">
                    <c:v>0</c:v>
                  </c:pt>
                  <c:pt idx="881">
                    <c:v>0</c:v>
                  </c:pt>
                  <c:pt idx="882">
                    <c:v>0</c:v>
                  </c:pt>
                  <c:pt idx="883">
                    <c:v>0</c:v>
                  </c:pt>
                  <c:pt idx="884">
                    <c:v>0</c:v>
                  </c:pt>
                  <c:pt idx="885">
                    <c:v>0</c:v>
                  </c:pt>
                  <c:pt idx="886">
                    <c:v>0</c:v>
                  </c:pt>
                  <c:pt idx="887">
                    <c:v>0</c:v>
                  </c:pt>
                  <c:pt idx="888">
                    <c:v>0</c:v>
                  </c:pt>
                  <c:pt idx="889">
                    <c:v>0</c:v>
                  </c:pt>
                  <c:pt idx="890">
                    <c:v>0</c:v>
                  </c:pt>
                  <c:pt idx="891">
                    <c:v>0</c:v>
                  </c:pt>
                  <c:pt idx="892">
                    <c:v>0</c:v>
                  </c:pt>
                  <c:pt idx="893">
                    <c:v>0</c:v>
                  </c:pt>
                  <c:pt idx="894">
                    <c:v>0</c:v>
                  </c:pt>
                  <c:pt idx="895">
                    <c:v>0</c:v>
                  </c:pt>
                  <c:pt idx="896">
                    <c:v>0</c:v>
                  </c:pt>
                  <c:pt idx="897">
                    <c:v>0</c:v>
                  </c:pt>
                  <c:pt idx="898">
                    <c:v>0</c:v>
                  </c:pt>
                  <c:pt idx="899">
                    <c:v>0</c:v>
                  </c:pt>
                  <c:pt idx="900">
                    <c:v>0</c:v>
                  </c:pt>
                  <c:pt idx="901">
                    <c:v>0</c:v>
                  </c:pt>
                  <c:pt idx="902">
                    <c:v>0</c:v>
                  </c:pt>
                  <c:pt idx="903">
                    <c:v>0</c:v>
                  </c:pt>
                  <c:pt idx="904">
                    <c:v>0</c:v>
                  </c:pt>
                  <c:pt idx="905">
                    <c:v>0</c:v>
                  </c:pt>
                  <c:pt idx="906">
                    <c:v>0</c:v>
                  </c:pt>
                  <c:pt idx="907">
                    <c:v>0</c:v>
                  </c:pt>
                  <c:pt idx="908">
                    <c:v>0</c:v>
                  </c:pt>
                  <c:pt idx="909">
                    <c:v>0</c:v>
                  </c:pt>
                  <c:pt idx="910">
                    <c:v>0</c:v>
                  </c:pt>
                  <c:pt idx="911">
                    <c:v>0</c:v>
                  </c:pt>
                  <c:pt idx="912">
                    <c:v>0</c:v>
                  </c:pt>
                  <c:pt idx="913">
                    <c:v>0</c:v>
                  </c:pt>
                  <c:pt idx="914">
                    <c:v>0</c:v>
                  </c:pt>
                  <c:pt idx="915">
                    <c:v>0</c:v>
                  </c:pt>
                  <c:pt idx="916">
                    <c:v>0</c:v>
                  </c:pt>
                  <c:pt idx="917">
                    <c:v>0</c:v>
                  </c:pt>
                  <c:pt idx="918">
                    <c:v>0</c:v>
                  </c:pt>
                  <c:pt idx="919">
                    <c:v>0</c:v>
                  </c:pt>
                  <c:pt idx="920">
                    <c:v>0</c:v>
                  </c:pt>
                  <c:pt idx="921">
                    <c:v>0</c:v>
                  </c:pt>
                  <c:pt idx="922">
                    <c:v>0</c:v>
                  </c:pt>
                  <c:pt idx="923">
                    <c:v>0</c:v>
                  </c:pt>
                  <c:pt idx="924">
                    <c:v>0</c:v>
                  </c:pt>
                  <c:pt idx="925">
                    <c:v>0</c:v>
                  </c:pt>
                  <c:pt idx="926">
                    <c:v>0</c:v>
                  </c:pt>
                  <c:pt idx="927">
                    <c:v>0</c:v>
                  </c:pt>
                  <c:pt idx="928">
                    <c:v>0</c:v>
                  </c:pt>
                  <c:pt idx="929">
                    <c:v>0</c:v>
                  </c:pt>
                  <c:pt idx="930">
                    <c:v>0</c:v>
                  </c:pt>
                  <c:pt idx="931">
                    <c:v>0</c:v>
                  </c:pt>
                  <c:pt idx="932">
                    <c:v>0</c:v>
                  </c:pt>
                  <c:pt idx="933">
                    <c:v>0</c:v>
                  </c:pt>
                  <c:pt idx="934">
                    <c:v>0</c:v>
                  </c:pt>
                  <c:pt idx="935">
                    <c:v>0</c:v>
                  </c:pt>
                  <c:pt idx="936">
                    <c:v>0</c:v>
                  </c:pt>
                  <c:pt idx="937">
                    <c:v>0</c:v>
                  </c:pt>
                  <c:pt idx="938">
                    <c:v>0</c:v>
                  </c:pt>
                  <c:pt idx="939">
                    <c:v>0</c:v>
                  </c:pt>
                  <c:pt idx="940">
                    <c:v>0</c:v>
                  </c:pt>
                  <c:pt idx="941">
                    <c:v>0</c:v>
                  </c:pt>
                  <c:pt idx="942">
                    <c:v>0</c:v>
                  </c:pt>
                  <c:pt idx="943">
                    <c:v>0</c:v>
                  </c:pt>
                  <c:pt idx="944">
                    <c:v>0</c:v>
                  </c:pt>
                  <c:pt idx="945">
                    <c:v>0</c:v>
                  </c:pt>
                  <c:pt idx="946">
                    <c:v>0</c:v>
                  </c:pt>
                  <c:pt idx="947">
                    <c:v>0</c:v>
                  </c:pt>
                  <c:pt idx="948">
                    <c:v>0</c:v>
                  </c:pt>
                  <c:pt idx="949">
                    <c:v>0</c:v>
                  </c:pt>
                  <c:pt idx="950">
                    <c:v>0</c:v>
                  </c:pt>
                  <c:pt idx="951">
                    <c:v>0</c:v>
                  </c:pt>
                  <c:pt idx="952">
                    <c:v>0</c:v>
                  </c:pt>
                  <c:pt idx="953">
                    <c:v>0</c:v>
                  </c:pt>
                  <c:pt idx="954">
                    <c:v>0</c:v>
                  </c:pt>
                  <c:pt idx="955">
                    <c:v>0</c:v>
                  </c:pt>
                  <c:pt idx="956">
                    <c:v>0</c:v>
                  </c:pt>
                  <c:pt idx="957">
                    <c:v>0</c:v>
                  </c:pt>
                  <c:pt idx="958">
                    <c:v>0</c:v>
                  </c:pt>
                  <c:pt idx="959">
                    <c:v>0</c:v>
                  </c:pt>
                  <c:pt idx="960">
                    <c:v>0</c:v>
                  </c:pt>
                  <c:pt idx="961">
                    <c:v>0</c:v>
                  </c:pt>
                  <c:pt idx="962">
                    <c:v>0</c:v>
                  </c:pt>
                  <c:pt idx="963">
                    <c:v>0</c:v>
                  </c:pt>
                  <c:pt idx="964">
                    <c:v>0</c:v>
                  </c:pt>
                  <c:pt idx="965">
                    <c:v>0</c:v>
                  </c:pt>
                  <c:pt idx="966">
                    <c:v>0</c:v>
                  </c:pt>
                  <c:pt idx="967">
                    <c:v>0</c:v>
                  </c:pt>
                  <c:pt idx="968">
                    <c:v>0</c:v>
                  </c:pt>
                  <c:pt idx="969">
                    <c:v>0</c:v>
                  </c:pt>
                  <c:pt idx="970">
                    <c:v>0</c:v>
                  </c:pt>
                  <c:pt idx="971">
                    <c:v>0</c:v>
                  </c:pt>
                  <c:pt idx="972">
                    <c:v>0</c:v>
                  </c:pt>
                  <c:pt idx="973">
                    <c:v>0</c:v>
                  </c:pt>
                  <c:pt idx="974">
                    <c:v>0</c:v>
                  </c:pt>
                  <c:pt idx="975">
                    <c:v>0</c:v>
                  </c:pt>
                  <c:pt idx="976">
                    <c:v>0</c:v>
                  </c:pt>
                  <c:pt idx="977">
                    <c:v>0</c:v>
                  </c:pt>
                  <c:pt idx="978">
                    <c:v>0</c:v>
                  </c:pt>
                  <c:pt idx="979">
                    <c:v>0</c:v>
                  </c:pt>
                  <c:pt idx="980">
                    <c:v>0</c:v>
                  </c:pt>
                  <c:pt idx="981">
                    <c:v>0</c:v>
                  </c:pt>
                  <c:pt idx="982">
                    <c:v>0</c:v>
                  </c:pt>
                  <c:pt idx="983">
                    <c:v>0</c:v>
                  </c:pt>
                  <c:pt idx="984">
                    <c:v>0</c:v>
                  </c:pt>
                  <c:pt idx="985">
                    <c:v>0</c:v>
                  </c:pt>
                  <c:pt idx="986">
                    <c:v>0</c:v>
                  </c:pt>
                  <c:pt idx="987">
                    <c:v>0</c:v>
                  </c:pt>
                  <c:pt idx="988">
                    <c:v>0</c:v>
                  </c:pt>
                  <c:pt idx="989">
                    <c:v>0</c:v>
                  </c:pt>
                  <c:pt idx="990">
                    <c:v>0</c:v>
                  </c:pt>
                  <c:pt idx="991">
                    <c:v>0</c:v>
                  </c:pt>
                  <c:pt idx="992">
                    <c:v>0</c:v>
                  </c:pt>
                  <c:pt idx="993">
                    <c:v>0</c:v>
                  </c:pt>
                  <c:pt idx="994">
                    <c:v>0</c:v>
                  </c:pt>
                  <c:pt idx="995">
                    <c:v>0</c:v>
                  </c:pt>
                  <c:pt idx="996">
                    <c:v>0</c:v>
                  </c:pt>
                  <c:pt idx="997">
                    <c:v>0</c:v>
                  </c:pt>
                  <c:pt idx="998">
                    <c:v>0</c:v>
                  </c:pt>
                  <c:pt idx="999">
                    <c:v>0</c:v>
                  </c:pt>
                </c:numCache>
              </c:numRef>
            </c:minus>
            <c:spPr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errBars>
          <c:errBars>
            <c:errDir val="x"/>
            <c:errBarType val="both"/>
            <c:errValType val="fixedVal"/>
            <c:noEndCap val="0"/>
            <c:val val="0.1"/>
            <c:spPr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errBars>
          <c:xVal>
            <c:numRef>
              <c:f>'[データまとめ (自動保存済み).xlsx]TM粒子数'!$A$3:$A$1002</c:f>
              <c:numCache>
                <c:formatCode>General</c:formatCode>
                <c:ptCount val="1000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  <c:pt idx="8">
                  <c:v>8.5</c:v>
                </c:pt>
                <c:pt idx="9">
                  <c:v>9.5</c:v>
                </c:pt>
                <c:pt idx="10">
                  <c:v>10.5</c:v>
                </c:pt>
                <c:pt idx="11">
                  <c:v>11.5</c:v>
                </c:pt>
                <c:pt idx="12">
                  <c:v>12.5</c:v>
                </c:pt>
                <c:pt idx="13">
                  <c:v>13.5</c:v>
                </c:pt>
                <c:pt idx="14">
                  <c:v>14.5</c:v>
                </c:pt>
                <c:pt idx="15">
                  <c:v>15.5</c:v>
                </c:pt>
                <c:pt idx="16">
                  <c:v>16.5</c:v>
                </c:pt>
                <c:pt idx="17">
                  <c:v>17.5</c:v>
                </c:pt>
                <c:pt idx="18">
                  <c:v>18.5</c:v>
                </c:pt>
                <c:pt idx="19">
                  <c:v>19.5</c:v>
                </c:pt>
                <c:pt idx="20">
                  <c:v>20.5</c:v>
                </c:pt>
                <c:pt idx="21">
                  <c:v>21.5</c:v>
                </c:pt>
                <c:pt idx="22">
                  <c:v>22.5</c:v>
                </c:pt>
                <c:pt idx="23">
                  <c:v>23.5</c:v>
                </c:pt>
                <c:pt idx="24">
                  <c:v>24.5</c:v>
                </c:pt>
                <c:pt idx="25">
                  <c:v>25.5</c:v>
                </c:pt>
                <c:pt idx="26">
                  <c:v>26.5</c:v>
                </c:pt>
                <c:pt idx="27">
                  <c:v>27.5</c:v>
                </c:pt>
                <c:pt idx="28">
                  <c:v>28.5</c:v>
                </c:pt>
                <c:pt idx="29">
                  <c:v>29.5</c:v>
                </c:pt>
                <c:pt idx="30">
                  <c:v>30.5</c:v>
                </c:pt>
                <c:pt idx="31">
                  <c:v>31.5</c:v>
                </c:pt>
                <c:pt idx="32">
                  <c:v>32.5</c:v>
                </c:pt>
                <c:pt idx="33">
                  <c:v>33.5</c:v>
                </c:pt>
                <c:pt idx="34">
                  <c:v>34.5</c:v>
                </c:pt>
                <c:pt idx="35">
                  <c:v>35.5</c:v>
                </c:pt>
                <c:pt idx="36">
                  <c:v>36.5</c:v>
                </c:pt>
                <c:pt idx="37">
                  <c:v>37.5</c:v>
                </c:pt>
                <c:pt idx="38">
                  <c:v>38.5</c:v>
                </c:pt>
                <c:pt idx="39">
                  <c:v>39.5</c:v>
                </c:pt>
                <c:pt idx="40">
                  <c:v>40.5</c:v>
                </c:pt>
                <c:pt idx="41">
                  <c:v>41.5</c:v>
                </c:pt>
                <c:pt idx="42">
                  <c:v>42.5</c:v>
                </c:pt>
                <c:pt idx="43">
                  <c:v>43.5</c:v>
                </c:pt>
                <c:pt idx="44">
                  <c:v>44.5</c:v>
                </c:pt>
                <c:pt idx="45">
                  <c:v>45.5</c:v>
                </c:pt>
                <c:pt idx="46">
                  <c:v>46.5</c:v>
                </c:pt>
                <c:pt idx="47">
                  <c:v>47.5</c:v>
                </c:pt>
                <c:pt idx="48">
                  <c:v>48.5</c:v>
                </c:pt>
                <c:pt idx="49">
                  <c:v>49.5</c:v>
                </c:pt>
                <c:pt idx="50">
                  <c:v>50.5</c:v>
                </c:pt>
                <c:pt idx="51">
                  <c:v>51.5</c:v>
                </c:pt>
                <c:pt idx="52">
                  <c:v>52.5</c:v>
                </c:pt>
                <c:pt idx="53">
                  <c:v>53.5</c:v>
                </c:pt>
                <c:pt idx="54">
                  <c:v>54.5</c:v>
                </c:pt>
                <c:pt idx="55">
                  <c:v>55.5</c:v>
                </c:pt>
                <c:pt idx="56">
                  <c:v>56.5</c:v>
                </c:pt>
                <c:pt idx="57">
                  <c:v>57.5</c:v>
                </c:pt>
                <c:pt idx="58">
                  <c:v>58.5</c:v>
                </c:pt>
                <c:pt idx="59">
                  <c:v>59.5</c:v>
                </c:pt>
                <c:pt idx="60">
                  <c:v>60.5</c:v>
                </c:pt>
                <c:pt idx="61">
                  <c:v>61.5</c:v>
                </c:pt>
                <c:pt idx="62">
                  <c:v>62.5</c:v>
                </c:pt>
                <c:pt idx="63">
                  <c:v>63.5</c:v>
                </c:pt>
                <c:pt idx="64">
                  <c:v>64.5</c:v>
                </c:pt>
                <c:pt idx="65">
                  <c:v>65.5</c:v>
                </c:pt>
                <c:pt idx="66">
                  <c:v>66.5</c:v>
                </c:pt>
                <c:pt idx="67">
                  <c:v>67.5</c:v>
                </c:pt>
                <c:pt idx="68">
                  <c:v>68.5</c:v>
                </c:pt>
                <c:pt idx="69">
                  <c:v>69.5</c:v>
                </c:pt>
                <c:pt idx="70">
                  <c:v>70.5</c:v>
                </c:pt>
                <c:pt idx="71">
                  <c:v>71.5</c:v>
                </c:pt>
                <c:pt idx="72">
                  <c:v>72.5</c:v>
                </c:pt>
                <c:pt idx="73">
                  <c:v>73.5</c:v>
                </c:pt>
                <c:pt idx="74">
                  <c:v>74.5</c:v>
                </c:pt>
                <c:pt idx="75">
                  <c:v>75.5</c:v>
                </c:pt>
                <c:pt idx="76">
                  <c:v>76.5</c:v>
                </c:pt>
                <c:pt idx="77">
                  <c:v>77.5</c:v>
                </c:pt>
                <c:pt idx="78">
                  <c:v>78.5</c:v>
                </c:pt>
                <c:pt idx="79">
                  <c:v>79.5</c:v>
                </c:pt>
                <c:pt idx="80">
                  <c:v>80.5</c:v>
                </c:pt>
                <c:pt idx="81">
                  <c:v>81.5</c:v>
                </c:pt>
                <c:pt idx="82">
                  <c:v>82.5</c:v>
                </c:pt>
                <c:pt idx="83">
                  <c:v>83.5</c:v>
                </c:pt>
                <c:pt idx="84">
                  <c:v>84.5</c:v>
                </c:pt>
                <c:pt idx="85">
                  <c:v>85.5</c:v>
                </c:pt>
                <c:pt idx="86">
                  <c:v>86.5</c:v>
                </c:pt>
                <c:pt idx="87">
                  <c:v>87.5</c:v>
                </c:pt>
                <c:pt idx="88">
                  <c:v>88.5</c:v>
                </c:pt>
                <c:pt idx="89">
                  <c:v>89.5</c:v>
                </c:pt>
                <c:pt idx="90">
                  <c:v>90.5</c:v>
                </c:pt>
                <c:pt idx="91">
                  <c:v>91.5</c:v>
                </c:pt>
                <c:pt idx="92">
                  <c:v>92.5</c:v>
                </c:pt>
                <c:pt idx="93">
                  <c:v>93.5</c:v>
                </c:pt>
                <c:pt idx="94">
                  <c:v>94.5</c:v>
                </c:pt>
                <c:pt idx="95">
                  <c:v>95.5</c:v>
                </c:pt>
                <c:pt idx="96">
                  <c:v>96.5</c:v>
                </c:pt>
                <c:pt idx="97">
                  <c:v>97.5</c:v>
                </c:pt>
                <c:pt idx="98">
                  <c:v>98.5</c:v>
                </c:pt>
                <c:pt idx="99">
                  <c:v>99.5</c:v>
                </c:pt>
                <c:pt idx="100">
                  <c:v>100.5</c:v>
                </c:pt>
                <c:pt idx="101">
                  <c:v>101.5</c:v>
                </c:pt>
                <c:pt idx="102">
                  <c:v>102.5</c:v>
                </c:pt>
                <c:pt idx="103">
                  <c:v>103.5</c:v>
                </c:pt>
                <c:pt idx="104">
                  <c:v>104.5</c:v>
                </c:pt>
                <c:pt idx="105">
                  <c:v>105.5</c:v>
                </c:pt>
                <c:pt idx="106">
                  <c:v>106.5</c:v>
                </c:pt>
                <c:pt idx="107">
                  <c:v>107.5</c:v>
                </c:pt>
                <c:pt idx="108">
                  <c:v>108.5</c:v>
                </c:pt>
                <c:pt idx="109">
                  <c:v>109.5</c:v>
                </c:pt>
                <c:pt idx="110">
                  <c:v>110.5</c:v>
                </c:pt>
                <c:pt idx="111">
                  <c:v>111.5</c:v>
                </c:pt>
                <c:pt idx="112">
                  <c:v>112.5</c:v>
                </c:pt>
                <c:pt idx="113">
                  <c:v>113.5</c:v>
                </c:pt>
                <c:pt idx="114">
                  <c:v>114.5</c:v>
                </c:pt>
                <c:pt idx="115">
                  <c:v>115.5</c:v>
                </c:pt>
                <c:pt idx="116">
                  <c:v>116.5</c:v>
                </c:pt>
                <c:pt idx="117">
                  <c:v>117.5</c:v>
                </c:pt>
                <c:pt idx="118">
                  <c:v>118.5</c:v>
                </c:pt>
                <c:pt idx="119">
                  <c:v>119.5</c:v>
                </c:pt>
                <c:pt idx="120">
                  <c:v>120.5</c:v>
                </c:pt>
                <c:pt idx="121">
                  <c:v>121.5</c:v>
                </c:pt>
                <c:pt idx="122">
                  <c:v>122.5</c:v>
                </c:pt>
                <c:pt idx="123">
                  <c:v>123.5</c:v>
                </c:pt>
                <c:pt idx="124">
                  <c:v>124.5</c:v>
                </c:pt>
                <c:pt idx="125">
                  <c:v>125.5</c:v>
                </c:pt>
                <c:pt idx="126">
                  <c:v>126.5</c:v>
                </c:pt>
                <c:pt idx="127">
                  <c:v>127.5</c:v>
                </c:pt>
                <c:pt idx="128">
                  <c:v>128.5</c:v>
                </c:pt>
                <c:pt idx="129">
                  <c:v>129.5</c:v>
                </c:pt>
                <c:pt idx="130">
                  <c:v>130.5</c:v>
                </c:pt>
                <c:pt idx="131">
                  <c:v>131.5</c:v>
                </c:pt>
                <c:pt idx="132">
                  <c:v>132.5</c:v>
                </c:pt>
                <c:pt idx="133">
                  <c:v>133.5</c:v>
                </c:pt>
                <c:pt idx="134">
                  <c:v>134.5</c:v>
                </c:pt>
                <c:pt idx="135">
                  <c:v>135.5</c:v>
                </c:pt>
                <c:pt idx="136">
                  <c:v>136.5</c:v>
                </c:pt>
                <c:pt idx="137">
                  <c:v>137.5</c:v>
                </c:pt>
                <c:pt idx="138">
                  <c:v>138.5</c:v>
                </c:pt>
                <c:pt idx="139">
                  <c:v>139.5</c:v>
                </c:pt>
                <c:pt idx="140">
                  <c:v>140.5</c:v>
                </c:pt>
                <c:pt idx="141">
                  <c:v>141.5</c:v>
                </c:pt>
                <c:pt idx="142">
                  <c:v>142.5</c:v>
                </c:pt>
                <c:pt idx="143">
                  <c:v>143.5</c:v>
                </c:pt>
                <c:pt idx="144">
                  <c:v>144.5</c:v>
                </c:pt>
                <c:pt idx="145">
                  <c:v>145.5</c:v>
                </c:pt>
                <c:pt idx="146">
                  <c:v>146.5</c:v>
                </c:pt>
                <c:pt idx="147">
                  <c:v>147.5</c:v>
                </c:pt>
                <c:pt idx="148">
                  <c:v>148.5</c:v>
                </c:pt>
                <c:pt idx="149">
                  <c:v>149.5</c:v>
                </c:pt>
                <c:pt idx="150">
                  <c:v>150.5</c:v>
                </c:pt>
                <c:pt idx="151">
                  <c:v>151.5</c:v>
                </c:pt>
                <c:pt idx="152">
                  <c:v>152.5</c:v>
                </c:pt>
                <c:pt idx="153">
                  <c:v>153.5</c:v>
                </c:pt>
                <c:pt idx="154">
                  <c:v>154.5</c:v>
                </c:pt>
                <c:pt idx="155">
                  <c:v>155.5</c:v>
                </c:pt>
                <c:pt idx="156">
                  <c:v>156.5</c:v>
                </c:pt>
                <c:pt idx="157">
                  <c:v>157.5</c:v>
                </c:pt>
                <c:pt idx="158">
                  <c:v>158.5</c:v>
                </c:pt>
                <c:pt idx="159">
                  <c:v>159.5</c:v>
                </c:pt>
                <c:pt idx="160">
                  <c:v>160.5</c:v>
                </c:pt>
                <c:pt idx="161">
                  <c:v>161.5</c:v>
                </c:pt>
                <c:pt idx="162">
                  <c:v>162.5</c:v>
                </c:pt>
                <c:pt idx="163">
                  <c:v>163.5</c:v>
                </c:pt>
                <c:pt idx="164">
                  <c:v>164.5</c:v>
                </c:pt>
                <c:pt idx="165">
                  <c:v>165.5</c:v>
                </c:pt>
                <c:pt idx="166">
                  <c:v>166.5</c:v>
                </c:pt>
                <c:pt idx="167">
                  <c:v>167.5</c:v>
                </c:pt>
                <c:pt idx="168">
                  <c:v>168.5</c:v>
                </c:pt>
                <c:pt idx="169">
                  <c:v>169.5</c:v>
                </c:pt>
                <c:pt idx="170">
                  <c:v>170.5</c:v>
                </c:pt>
                <c:pt idx="171">
                  <c:v>171.5</c:v>
                </c:pt>
                <c:pt idx="172">
                  <c:v>172.5</c:v>
                </c:pt>
                <c:pt idx="173">
                  <c:v>173.5</c:v>
                </c:pt>
                <c:pt idx="174">
                  <c:v>174.5</c:v>
                </c:pt>
                <c:pt idx="175">
                  <c:v>175.5</c:v>
                </c:pt>
                <c:pt idx="176">
                  <c:v>176.5</c:v>
                </c:pt>
                <c:pt idx="177">
                  <c:v>177.5</c:v>
                </c:pt>
                <c:pt idx="178">
                  <c:v>178.5</c:v>
                </c:pt>
                <c:pt idx="179">
                  <c:v>179.5</c:v>
                </c:pt>
                <c:pt idx="180">
                  <c:v>180.5</c:v>
                </c:pt>
                <c:pt idx="181">
                  <c:v>181.5</c:v>
                </c:pt>
                <c:pt idx="182">
                  <c:v>182.5</c:v>
                </c:pt>
                <c:pt idx="183">
                  <c:v>183.5</c:v>
                </c:pt>
                <c:pt idx="184">
                  <c:v>184.5</c:v>
                </c:pt>
                <c:pt idx="185">
                  <c:v>185.5</c:v>
                </c:pt>
                <c:pt idx="186">
                  <c:v>186.5</c:v>
                </c:pt>
                <c:pt idx="187">
                  <c:v>187.5</c:v>
                </c:pt>
                <c:pt idx="188">
                  <c:v>188.5</c:v>
                </c:pt>
                <c:pt idx="189">
                  <c:v>189.5</c:v>
                </c:pt>
                <c:pt idx="190">
                  <c:v>190.5</c:v>
                </c:pt>
                <c:pt idx="191">
                  <c:v>191.5</c:v>
                </c:pt>
                <c:pt idx="192">
                  <c:v>192.5</c:v>
                </c:pt>
                <c:pt idx="193">
                  <c:v>193.5</c:v>
                </c:pt>
                <c:pt idx="194">
                  <c:v>194.5</c:v>
                </c:pt>
                <c:pt idx="195">
                  <c:v>195.5</c:v>
                </c:pt>
                <c:pt idx="196">
                  <c:v>196.5</c:v>
                </c:pt>
                <c:pt idx="197">
                  <c:v>197.5</c:v>
                </c:pt>
                <c:pt idx="198">
                  <c:v>198.5</c:v>
                </c:pt>
                <c:pt idx="199">
                  <c:v>199.5</c:v>
                </c:pt>
                <c:pt idx="200">
                  <c:v>200.5</c:v>
                </c:pt>
                <c:pt idx="201">
                  <c:v>201.5</c:v>
                </c:pt>
                <c:pt idx="202">
                  <c:v>202.5</c:v>
                </c:pt>
                <c:pt idx="203">
                  <c:v>203.5</c:v>
                </c:pt>
                <c:pt idx="204">
                  <c:v>204.5</c:v>
                </c:pt>
                <c:pt idx="205">
                  <c:v>205.5</c:v>
                </c:pt>
                <c:pt idx="206">
                  <c:v>206.5</c:v>
                </c:pt>
                <c:pt idx="207">
                  <c:v>207.5</c:v>
                </c:pt>
                <c:pt idx="208">
                  <c:v>208.5</c:v>
                </c:pt>
                <c:pt idx="209">
                  <c:v>209.5</c:v>
                </c:pt>
                <c:pt idx="210">
                  <c:v>210.5</c:v>
                </c:pt>
                <c:pt idx="211">
                  <c:v>211.5</c:v>
                </c:pt>
                <c:pt idx="212">
                  <c:v>212.5</c:v>
                </c:pt>
                <c:pt idx="213">
                  <c:v>213.5</c:v>
                </c:pt>
                <c:pt idx="214">
                  <c:v>214.5</c:v>
                </c:pt>
                <c:pt idx="215">
                  <c:v>215.5</c:v>
                </c:pt>
                <c:pt idx="216">
                  <c:v>216.5</c:v>
                </c:pt>
                <c:pt idx="217">
                  <c:v>217.5</c:v>
                </c:pt>
                <c:pt idx="218">
                  <c:v>218.5</c:v>
                </c:pt>
                <c:pt idx="219">
                  <c:v>219.5</c:v>
                </c:pt>
                <c:pt idx="220">
                  <c:v>220.5</c:v>
                </c:pt>
                <c:pt idx="221">
                  <c:v>221.5</c:v>
                </c:pt>
                <c:pt idx="222">
                  <c:v>222.5</c:v>
                </c:pt>
                <c:pt idx="223">
                  <c:v>223.5</c:v>
                </c:pt>
                <c:pt idx="224">
                  <c:v>224.5</c:v>
                </c:pt>
                <c:pt idx="225">
                  <c:v>225.5</c:v>
                </c:pt>
                <c:pt idx="226">
                  <c:v>226.5</c:v>
                </c:pt>
                <c:pt idx="227">
                  <c:v>227.5</c:v>
                </c:pt>
                <c:pt idx="228">
                  <c:v>228.5</c:v>
                </c:pt>
                <c:pt idx="229">
                  <c:v>229.5</c:v>
                </c:pt>
                <c:pt idx="230">
                  <c:v>230.5</c:v>
                </c:pt>
                <c:pt idx="231">
                  <c:v>231.5</c:v>
                </c:pt>
                <c:pt idx="232">
                  <c:v>232.5</c:v>
                </c:pt>
                <c:pt idx="233">
                  <c:v>233.5</c:v>
                </c:pt>
                <c:pt idx="234">
                  <c:v>234.5</c:v>
                </c:pt>
                <c:pt idx="235">
                  <c:v>235.5</c:v>
                </c:pt>
                <c:pt idx="236">
                  <c:v>236.5</c:v>
                </c:pt>
                <c:pt idx="237">
                  <c:v>237.5</c:v>
                </c:pt>
                <c:pt idx="238">
                  <c:v>238.5</c:v>
                </c:pt>
                <c:pt idx="239">
                  <c:v>239.5</c:v>
                </c:pt>
                <c:pt idx="240">
                  <c:v>240.5</c:v>
                </c:pt>
                <c:pt idx="241">
                  <c:v>241.5</c:v>
                </c:pt>
                <c:pt idx="242">
                  <c:v>242.5</c:v>
                </c:pt>
                <c:pt idx="243">
                  <c:v>243.5</c:v>
                </c:pt>
                <c:pt idx="244">
                  <c:v>244.5</c:v>
                </c:pt>
                <c:pt idx="245">
                  <c:v>245.5</c:v>
                </c:pt>
                <c:pt idx="246">
                  <c:v>246.5</c:v>
                </c:pt>
                <c:pt idx="247">
                  <c:v>247.5</c:v>
                </c:pt>
                <c:pt idx="248">
                  <c:v>248.5</c:v>
                </c:pt>
                <c:pt idx="249">
                  <c:v>249.5</c:v>
                </c:pt>
                <c:pt idx="250">
                  <c:v>250.5</c:v>
                </c:pt>
                <c:pt idx="251">
                  <c:v>251.5</c:v>
                </c:pt>
                <c:pt idx="252">
                  <c:v>252.5</c:v>
                </c:pt>
                <c:pt idx="253">
                  <c:v>253.5</c:v>
                </c:pt>
                <c:pt idx="254">
                  <c:v>254.5</c:v>
                </c:pt>
                <c:pt idx="255">
                  <c:v>255.5</c:v>
                </c:pt>
                <c:pt idx="256">
                  <c:v>256.5</c:v>
                </c:pt>
                <c:pt idx="257">
                  <c:v>257.5</c:v>
                </c:pt>
                <c:pt idx="258">
                  <c:v>258.5</c:v>
                </c:pt>
                <c:pt idx="259">
                  <c:v>259.5</c:v>
                </c:pt>
                <c:pt idx="260">
                  <c:v>260.5</c:v>
                </c:pt>
                <c:pt idx="261">
                  <c:v>261.5</c:v>
                </c:pt>
                <c:pt idx="262">
                  <c:v>262.5</c:v>
                </c:pt>
                <c:pt idx="263">
                  <c:v>263.5</c:v>
                </c:pt>
                <c:pt idx="264">
                  <c:v>264.5</c:v>
                </c:pt>
                <c:pt idx="265">
                  <c:v>265.5</c:v>
                </c:pt>
                <c:pt idx="266">
                  <c:v>266.5</c:v>
                </c:pt>
                <c:pt idx="267">
                  <c:v>267.5</c:v>
                </c:pt>
                <c:pt idx="268">
                  <c:v>268.5</c:v>
                </c:pt>
                <c:pt idx="269">
                  <c:v>269.5</c:v>
                </c:pt>
                <c:pt idx="270">
                  <c:v>270.5</c:v>
                </c:pt>
                <c:pt idx="271">
                  <c:v>271.5</c:v>
                </c:pt>
                <c:pt idx="272">
                  <c:v>272.5</c:v>
                </c:pt>
                <c:pt idx="273">
                  <c:v>273.5</c:v>
                </c:pt>
                <c:pt idx="274">
                  <c:v>274.5</c:v>
                </c:pt>
                <c:pt idx="275">
                  <c:v>275.5</c:v>
                </c:pt>
                <c:pt idx="276">
                  <c:v>276.5</c:v>
                </c:pt>
                <c:pt idx="277">
                  <c:v>277.5</c:v>
                </c:pt>
                <c:pt idx="278">
                  <c:v>278.5</c:v>
                </c:pt>
                <c:pt idx="279">
                  <c:v>279.5</c:v>
                </c:pt>
                <c:pt idx="280">
                  <c:v>280.5</c:v>
                </c:pt>
                <c:pt idx="281">
                  <c:v>281.5</c:v>
                </c:pt>
                <c:pt idx="282">
                  <c:v>282.5</c:v>
                </c:pt>
                <c:pt idx="283">
                  <c:v>283.5</c:v>
                </c:pt>
                <c:pt idx="284">
                  <c:v>284.5</c:v>
                </c:pt>
                <c:pt idx="285">
                  <c:v>285.5</c:v>
                </c:pt>
                <c:pt idx="286">
                  <c:v>286.5</c:v>
                </c:pt>
                <c:pt idx="287">
                  <c:v>287.5</c:v>
                </c:pt>
                <c:pt idx="288">
                  <c:v>288.5</c:v>
                </c:pt>
                <c:pt idx="289">
                  <c:v>289.5</c:v>
                </c:pt>
                <c:pt idx="290">
                  <c:v>290.5</c:v>
                </c:pt>
                <c:pt idx="291">
                  <c:v>291.5</c:v>
                </c:pt>
                <c:pt idx="292">
                  <c:v>292.5</c:v>
                </c:pt>
                <c:pt idx="293">
                  <c:v>293.5</c:v>
                </c:pt>
                <c:pt idx="294">
                  <c:v>294.5</c:v>
                </c:pt>
                <c:pt idx="295">
                  <c:v>295.5</c:v>
                </c:pt>
                <c:pt idx="296">
                  <c:v>296.5</c:v>
                </c:pt>
                <c:pt idx="297">
                  <c:v>297.5</c:v>
                </c:pt>
                <c:pt idx="298">
                  <c:v>298.5</c:v>
                </c:pt>
                <c:pt idx="299">
                  <c:v>299.5</c:v>
                </c:pt>
                <c:pt idx="300">
                  <c:v>300.5</c:v>
                </c:pt>
                <c:pt idx="301">
                  <c:v>301.5</c:v>
                </c:pt>
                <c:pt idx="302">
                  <c:v>302.5</c:v>
                </c:pt>
                <c:pt idx="303">
                  <c:v>303.5</c:v>
                </c:pt>
                <c:pt idx="304">
                  <c:v>304.5</c:v>
                </c:pt>
                <c:pt idx="305">
                  <c:v>305.5</c:v>
                </c:pt>
                <c:pt idx="306">
                  <c:v>306.5</c:v>
                </c:pt>
                <c:pt idx="307">
                  <c:v>307.5</c:v>
                </c:pt>
                <c:pt idx="308">
                  <c:v>308.5</c:v>
                </c:pt>
                <c:pt idx="309">
                  <c:v>309.5</c:v>
                </c:pt>
                <c:pt idx="310">
                  <c:v>310.5</c:v>
                </c:pt>
                <c:pt idx="311">
                  <c:v>311.5</c:v>
                </c:pt>
                <c:pt idx="312">
                  <c:v>312.5</c:v>
                </c:pt>
                <c:pt idx="313">
                  <c:v>313.5</c:v>
                </c:pt>
                <c:pt idx="314">
                  <c:v>314.5</c:v>
                </c:pt>
                <c:pt idx="315">
                  <c:v>315.5</c:v>
                </c:pt>
                <c:pt idx="316">
                  <c:v>316.5</c:v>
                </c:pt>
                <c:pt idx="317">
                  <c:v>317.5</c:v>
                </c:pt>
                <c:pt idx="318">
                  <c:v>318.5</c:v>
                </c:pt>
                <c:pt idx="319">
                  <c:v>319.5</c:v>
                </c:pt>
                <c:pt idx="320">
                  <c:v>320.5</c:v>
                </c:pt>
                <c:pt idx="321">
                  <c:v>321.5</c:v>
                </c:pt>
                <c:pt idx="322">
                  <c:v>322.5</c:v>
                </c:pt>
                <c:pt idx="323">
                  <c:v>323.5</c:v>
                </c:pt>
                <c:pt idx="324">
                  <c:v>324.5</c:v>
                </c:pt>
                <c:pt idx="325">
                  <c:v>325.5</c:v>
                </c:pt>
                <c:pt idx="326">
                  <c:v>326.5</c:v>
                </c:pt>
                <c:pt idx="327">
                  <c:v>327.5</c:v>
                </c:pt>
                <c:pt idx="328">
                  <c:v>328.5</c:v>
                </c:pt>
                <c:pt idx="329">
                  <c:v>329.5</c:v>
                </c:pt>
                <c:pt idx="330">
                  <c:v>330.5</c:v>
                </c:pt>
                <c:pt idx="331">
                  <c:v>331.5</c:v>
                </c:pt>
                <c:pt idx="332">
                  <c:v>332.5</c:v>
                </c:pt>
                <c:pt idx="333">
                  <c:v>333.5</c:v>
                </c:pt>
                <c:pt idx="334">
                  <c:v>334.5</c:v>
                </c:pt>
                <c:pt idx="335">
                  <c:v>335.5</c:v>
                </c:pt>
                <c:pt idx="336">
                  <c:v>336.5</c:v>
                </c:pt>
                <c:pt idx="337">
                  <c:v>337.5</c:v>
                </c:pt>
                <c:pt idx="338">
                  <c:v>338.5</c:v>
                </c:pt>
                <c:pt idx="339">
                  <c:v>339.5</c:v>
                </c:pt>
                <c:pt idx="340">
                  <c:v>340.5</c:v>
                </c:pt>
                <c:pt idx="341">
                  <c:v>341.5</c:v>
                </c:pt>
                <c:pt idx="342">
                  <c:v>342.5</c:v>
                </c:pt>
                <c:pt idx="343">
                  <c:v>343.5</c:v>
                </c:pt>
                <c:pt idx="344">
                  <c:v>344.5</c:v>
                </c:pt>
                <c:pt idx="345">
                  <c:v>345.5</c:v>
                </c:pt>
                <c:pt idx="346">
                  <c:v>346.5</c:v>
                </c:pt>
                <c:pt idx="347">
                  <c:v>347.5</c:v>
                </c:pt>
                <c:pt idx="348">
                  <c:v>348.5</c:v>
                </c:pt>
                <c:pt idx="349">
                  <c:v>349.5</c:v>
                </c:pt>
                <c:pt idx="350">
                  <c:v>350.5</c:v>
                </c:pt>
                <c:pt idx="351">
                  <c:v>351.5</c:v>
                </c:pt>
                <c:pt idx="352">
                  <c:v>352.5</c:v>
                </c:pt>
                <c:pt idx="353">
                  <c:v>353.5</c:v>
                </c:pt>
                <c:pt idx="354">
                  <c:v>354.5</c:v>
                </c:pt>
                <c:pt idx="355">
                  <c:v>355.5</c:v>
                </c:pt>
                <c:pt idx="356">
                  <c:v>356.5</c:v>
                </c:pt>
                <c:pt idx="357">
                  <c:v>357.5</c:v>
                </c:pt>
                <c:pt idx="358">
                  <c:v>358.5</c:v>
                </c:pt>
                <c:pt idx="359">
                  <c:v>359.5</c:v>
                </c:pt>
                <c:pt idx="360">
                  <c:v>360.5</c:v>
                </c:pt>
                <c:pt idx="361">
                  <c:v>361.5</c:v>
                </c:pt>
                <c:pt idx="362">
                  <c:v>362.5</c:v>
                </c:pt>
                <c:pt idx="363">
                  <c:v>363.5</c:v>
                </c:pt>
                <c:pt idx="364">
                  <c:v>364.5</c:v>
                </c:pt>
                <c:pt idx="365">
                  <c:v>365.5</c:v>
                </c:pt>
                <c:pt idx="366">
                  <c:v>366.5</c:v>
                </c:pt>
                <c:pt idx="367">
                  <c:v>367.5</c:v>
                </c:pt>
                <c:pt idx="368">
                  <c:v>368.5</c:v>
                </c:pt>
                <c:pt idx="369">
                  <c:v>369.5</c:v>
                </c:pt>
                <c:pt idx="370">
                  <c:v>370.5</c:v>
                </c:pt>
                <c:pt idx="371">
                  <c:v>371.5</c:v>
                </c:pt>
                <c:pt idx="372">
                  <c:v>372.5</c:v>
                </c:pt>
                <c:pt idx="373">
                  <c:v>373.5</c:v>
                </c:pt>
                <c:pt idx="374">
                  <c:v>374.5</c:v>
                </c:pt>
                <c:pt idx="375">
                  <c:v>375.5</c:v>
                </c:pt>
                <c:pt idx="376">
                  <c:v>376.5</c:v>
                </c:pt>
                <c:pt idx="377">
                  <c:v>377.5</c:v>
                </c:pt>
                <c:pt idx="378">
                  <c:v>378.5</c:v>
                </c:pt>
                <c:pt idx="379">
                  <c:v>379.5</c:v>
                </c:pt>
                <c:pt idx="380">
                  <c:v>380.5</c:v>
                </c:pt>
                <c:pt idx="381">
                  <c:v>381.5</c:v>
                </c:pt>
                <c:pt idx="382">
                  <c:v>382.5</c:v>
                </c:pt>
                <c:pt idx="383">
                  <c:v>383.5</c:v>
                </c:pt>
                <c:pt idx="384">
                  <c:v>384.5</c:v>
                </c:pt>
                <c:pt idx="385">
                  <c:v>385.5</c:v>
                </c:pt>
                <c:pt idx="386">
                  <c:v>386.5</c:v>
                </c:pt>
                <c:pt idx="387">
                  <c:v>387.5</c:v>
                </c:pt>
                <c:pt idx="388">
                  <c:v>388.5</c:v>
                </c:pt>
                <c:pt idx="389">
                  <c:v>389.5</c:v>
                </c:pt>
                <c:pt idx="390">
                  <c:v>390.5</c:v>
                </c:pt>
                <c:pt idx="391">
                  <c:v>391.5</c:v>
                </c:pt>
                <c:pt idx="392">
                  <c:v>392.5</c:v>
                </c:pt>
                <c:pt idx="393">
                  <c:v>393.5</c:v>
                </c:pt>
                <c:pt idx="394">
                  <c:v>394.5</c:v>
                </c:pt>
                <c:pt idx="395">
                  <c:v>395.5</c:v>
                </c:pt>
                <c:pt idx="396">
                  <c:v>396.5</c:v>
                </c:pt>
                <c:pt idx="397">
                  <c:v>397.5</c:v>
                </c:pt>
                <c:pt idx="398">
                  <c:v>398.5</c:v>
                </c:pt>
                <c:pt idx="399">
                  <c:v>399.5</c:v>
                </c:pt>
                <c:pt idx="400">
                  <c:v>400.5</c:v>
                </c:pt>
                <c:pt idx="401">
                  <c:v>401.5</c:v>
                </c:pt>
                <c:pt idx="402">
                  <c:v>402.5</c:v>
                </c:pt>
                <c:pt idx="403">
                  <c:v>403.5</c:v>
                </c:pt>
                <c:pt idx="404">
                  <c:v>404.5</c:v>
                </c:pt>
                <c:pt idx="405">
                  <c:v>405.5</c:v>
                </c:pt>
                <c:pt idx="406">
                  <c:v>406.5</c:v>
                </c:pt>
                <c:pt idx="407">
                  <c:v>407.5</c:v>
                </c:pt>
                <c:pt idx="408">
                  <c:v>408.5</c:v>
                </c:pt>
                <c:pt idx="409">
                  <c:v>409.5</c:v>
                </c:pt>
                <c:pt idx="410">
                  <c:v>410.5</c:v>
                </c:pt>
                <c:pt idx="411">
                  <c:v>411.5</c:v>
                </c:pt>
                <c:pt idx="412">
                  <c:v>412.5</c:v>
                </c:pt>
                <c:pt idx="413">
                  <c:v>413.5</c:v>
                </c:pt>
                <c:pt idx="414">
                  <c:v>414.5</c:v>
                </c:pt>
                <c:pt idx="415">
                  <c:v>415.5</c:v>
                </c:pt>
                <c:pt idx="416">
                  <c:v>416.5</c:v>
                </c:pt>
                <c:pt idx="417">
                  <c:v>417.5</c:v>
                </c:pt>
                <c:pt idx="418">
                  <c:v>418.5</c:v>
                </c:pt>
                <c:pt idx="419">
                  <c:v>419.5</c:v>
                </c:pt>
                <c:pt idx="420">
                  <c:v>420.5</c:v>
                </c:pt>
                <c:pt idx="421">
                  <c:v>421.5</c:v>
                </c:pt>
                <c:pt idx="422">
                  <c:v>422.5</c:v>
                </c:pt>
                <c:pt idx="423">
                  <c:v>423.5</c:v>
                </c:pt>
                <c:pt idx="424">
                  <c:v>424.5</c:v>
                </c:pt>
                <c:pt idx="425">
                  <c:v>425.5</c:v>
                </c:pt>
                <c:pt idx="426">
                  <c:v>426.5</c:v>
                </c:pt>
                <c:pt idx="427">
                  <c:v>427.5</c:v>
                </c:pt>
                <c:pt idx="428">
                  <c:v>428.5</c:v>
                </c:pt>
                <c:pt idx="429">
                  <c:v>429.5</c:v>
                </c:pt>
                <c:pt idx="430">
                  <c:v>430.5</c:v>
                </c:pt>
                <c:pt idx="431">
                  <c:v>431.5</c:v>
                </c:pt>
                <c:pt idx="432">
                  <c:v>432.5</c:v>
                </c:pt>
                <c:pt idx="433">
                  <c:v>433.5</c:v>
                </c:pt>
                <c:pt idx="434">
                  <c:v>434.5</c:v>
                </c:pt>
                <c:pt idx="435">
                  <c:v>435.5</c:v>
                </c:pt>
                <c:pt idx="436">
                  <c:v>436.5</c:v>
                </c:pt>
                <c:pt idx="437">
                  <c:v>437.5</c:v>
                </c:pt>
                <c:pt idx="438">
                  <c:v>438.5</c:v>
                </c:pt>
                <c:pt idx="439">
                  <c:v>439.5</c:v>
                </c:pt>
                <c:pt idx="440">
                  <c:v>440.5</c:v>
                </c:pt>
                <c:pt idx="441">
                  <c:v>441.5</c:v>
                </c:pt>
                <c:pt idx="442">
                  <c:v>442.5</c:v>
                </c:pt>
                <c:pt idx="443">
                  <c:v>443.5</c:v>
                </c:pt>
                <c:pt idx="444">
                  <c:v>444.5</c:v>
                </c:pt>
                <c:pt idx="445">
                  <c:v>445.5</c:v>
                </c:pt>
                <c:pt idx="446">
                  <c:v>446.5</c:v>
                </c:pt>
                <c:pt idx="447">
                  <c:v>447.5</c:v>
                </c:pt>
                <c:pt idx="448">
                  <c:v>448.5</c:v>
                </c:pt>
                <c:pt idx="449">
                  <c:v>449.5</c:v>
                </c:pt>
                <c:pt idx="450">
                  <c:v>450.5</c:v>
                </c:pt>
                <c:pt idx="451">
                  <c:v>451.5</c:v>
                </c:pt>
                <c:pt idx="452">
                  <c:v>452.5</c:v>
                </c:pt>
                <c:pt idx="453">
                  <c:v>453.5</c:v>
                </c:pt>
                <c:pt idx="454">
                  <c:v>454.5</c:v>
                </c:pt>
                <c:pt idx="455">
                  <c:v>455.5</c:v>
                </c:pt>
                <c:pt idx="456">
                  <c:v>456.5</c:v>
                </c:pt>
                <c:pt idx="457">
                  <c:v>457.5</c:v>
                </c:pt>
                <c:pt idx="458">
                  <c:v>458.5</c:v>
                </c:pt>
                <c:pt idx="459">
                  <c:v>459.5</c:v>
                </c:pt>
                <c:pt idx="460">
                  <c:v>460.5</c:v>
                </c:pt>
                <c:pt idx="461">
                  <c:v>461.5</c:v>
                </c:pt>
                <c:pt idx="462">
                  <c:v>462.5</c:v>
                </c:pt>
                <c:pt idx="463">
                  <c:v>463.5</c:v>
                </c:pt>
                <c:pt idx="464">
                  <c:v>464.5</c:v>
                </c:pt>
                <c:pt idx="465">
                  <c:v>465.5</c:v>
                </c:pt>
                <c:pt idx="466">
                  <c:v>466.5</c:v>
                </c:pt>
                <c:pt idx="467">
                  <c:v>467.5</c:v>
                </c:pt>
                <c:pt idx="468">
                  <c:v>468.5</c:v>
                </c:pt>
                <c:pt idx="469">
                  <c:v>469.5</c:v>
                </c:pt>
                <c:pt idx="470">
                  <c:v>470.5</c:v>
                </c:pt>
                <c:pt idx="471">
                  <c:v>471.5</c:v>
                </c:pt>
                <c:pt idx="472">
                  <c:v>472.5</c:v>
                </c:pt>
                <c:pt idx="473">
                  <c:v>473.5</c:v>
                </c:pt>
                <c:pt idx="474">
                  <c:v>474.5</c:v>
                </c:pt>
                <c:pt idx="475">
                  <c:v>475.5</c:v>
                </c:pt>
                <c:pt idx="476">
                  <c:v>476.5</c:v>
                </c:pt>
                <c:pt idx="477">
                  <c:v>477.5</c:v>
                </c:pt>
                <c:pt idx="478">
                  <c:v>478.5</c:v>
                </c:pt>
                <c:pt idx="479">
                  <c:v>479.5</c:v>
                </c:pt>
                <c:pt idx="480">
                  <c:v>480.5</c:v>
                </c:pt>
                <c:pt idx="481">
                  <c:v>481.5</c:v>
                </c:pt>
                <c:pt idx="482">
                  <c:v>482.5</c:v>
                </c:pt>
                <c:pt idx="483">
                  <c:v>483.5</c:v>
                </c:pt>
                <c:pt idx="484">
                  <c:v>484.5</c:v>
                </c:pt>
                <c:pt idx="485">
                  <c:v>485.5</c:v>
                </c:pt>
                <c:pt idx="486">
                  <c:v>486.5</c:v>
                </c:pt>
                <c:pt idx="487">
                  <c:v>487.5</c:v>
                </c:pt>
                <c:pt idx="488">
                  <c:v>488.5</c:v>
                </c:pt>
                <c:pt idx="489">
                  <c:v>489.5</c:v>
                </c:pt>
                <c:pt idx="490">
                  <c:v>490.5</c:v>
                </c:pt>
                <c:pt idx="491">
                  <c:v>491.5</c:v>
                </c:pt>
                <c:pt idx="492">
                  <c:v>492.5</c:v>
                </c:pt>
                <c:pt idx="493">
                  <c:v>493.5</c:v>
                </c:pt>
                <c:pt idx="494">
                  <c:v>494.5</c:v>
                </c:pt>
                <c:pt idx="495">
                  <c:v>495.5</c:v>
                </c:pt>
                <c:pt idx="496">
                  <c:v>496.5</c:v>
                </c:pt>
                <c:pt idx="497">
                  <c:v>497.5</c:v>
                </c:pt>
                <c:pt idx="498">
                  <c:v>498.5</c:v>
                </c:pt>
                <c:pt idx="499">
                  <c:v>499.5</c:v>
                </c:pt>
                <c:pt idx="500">
                  <c:v>500.5</c:v>
                </c:pt>
                <c:pt idx="501">
                  <c:v>501.5</c:v>
                </c:pt>
                <c:pt idx="502">
                  <c:v>502.5</c:v>
                </c:pt>
                <c:pt idx="503">
                  <c:v>503.5</c:v>
                </c:pt>
                <c:pt idx="504">
                  <c:v>504.5</c:v>
                </c:pt>
                <c:pt idx="505">
                  <c:v>505.5</c:v>
                </c:pt>
                <c:pt idx="506">
                  <c:v>506.5</c:v>
                </c:pt>
                <c:pt idx="507">
                  <c:v>507.5</c:v>
                </c:pt>
                <c:pt idx="508">
                  <c:v>508.5</c:v>
                </c:pt>
                <c:pt idx="509">
                  <c:v>509.5</c:v>
                </c:pt>
                <c:pt idx="510">
                  <c:v>510.5</c:v>
                </c:pt>
                <c:pt idx="511">
                  <c:v>511.5</c:v>
                </c:pt>
                <c:pt idx="512">
                  <c:v>512.5</c:v>
                </c:pt>
                <c:pt idx="513">
                  <c:v>513.5</c:v>
                </c:pt>
                <c:pt idx="514">
                  <c:v>514.5</c:v>
                </c:pt>
                <c:pt idx="515">
                  <c:v>515.5</c:v>
                </c:pt>
                <c:pt idx="516">
                  <c:v>516.5</c:v>
                </c:pt>
                <c:pt idx="517">
                  <c:v>517.5</c:v>
                </c:pt>
                <c:pt idx="518">
                  <c:v>518.5</c:v>
                </c:pt>
                <c:pt idx="519">
                  <c:v>519.5</c:v>
                </c:pt>
                <c:pt idx="520">
                  <c:v>520.5</c:v>
                </c:pt>
                <c:pt idx="521">
                  <c:v>521.5</c:v>
                </c:pt>
                <c:pt idx="522">
                  <c:v>522.5</c:v>
                </c:pt>
                <c:pt idx="523">
                  <c:v>523.5</c:v>
                </c:pt>
                <c:pt idx="524">
                  <c:v>524.5</c:v>
                </c:pt>
                <c:pt idx="525">
                  <c:v>525.5</c:v>
                </c:pt>
                <c:pt idx="526">
                  <c:v>526.5</c:v>
                </c:pt>
                <c:pt idx="527">
                  <c:v>527.5</c:v>
                </c:pt>
                <c:pt idx="528">
                  <c:v>528.5</c:v>
                </c:pt>
                <c:pt idx="529">
                  <c:v>529.5</c:v>
                </c:pt>
                <c:pt idx="530">
                  <c:v>530.5</c:v>
                </c:pt>
                <c:pt idx="531">
                  <c:v>531.5</c:v>
                </c:pt>
                <c:pt idx="532">
                  <c:v>532.5</c:v>
                </c:pt>
                <c:pt idx="533">
                  <c:v>533.5</c:v>
                </c:pt>
                <c:pt idx="534">
                  <c:v>534.5</c:v>
                </c:pt>
                <c:pt idx="535">
                  <c:v>535.5</c:v>
                </c:pt>
                <c:pt idx="536">
                  <c:v>536.5</c:v>
                </c:pt>
                <c:pt idx="537">
                  <c:v>537.5</c:v>
                </c:pt>
                <c:pt idx="538">
                  <c:v>538.5</c:v>
                </c:pt>
                <c:pt idx="539">
                  <c:v>539.5</c:v>
                </c:pt>
                <c:pt idx="540">
                  <c:v>540.5</c:v>
                </c:pt>
                <c:pt idx="541">
                  <c:v>541.5</c:v>
                </c:pt>
                <c:pt idx="542">
                  <c:v>542.5</c:v>
                </c:pt>
                <c:pt idx="543">
                  <c:v>543.5</c:v>
                </c:pt>
                <c:pt idx="544">
                  <c:v>544.5</c:v>
                </c:pt>
                <c:pt idx="545">
                  <c:v>545.5</c:v>
                </c:pt>
                <c:pt idx="546">
                  <c:v>546.5</c:v>
                </c:pt>
                <c:pt idx="547">
                  <c:v>547.5</c:v>
                </c:pt>
                <c:pt idx="548">
                  <c:v>548.5</c:v>
                </c:pt>
                <c:pt idx="549">
                  <c:v>549.5</c:v>
                </c:pt>
                <c:pt idx="550">
                  <c:v>550.5</c:v>
                </c:pt>
                <c:pt idx="551">
                  <c:v>551.5</c:v>
                </c:pt>
                <c:pt idx="552">
                  <c:v>552.5</c:v>
                </c:pt>
                <c:pt idx="553">
                  <c:v>553.5</c:v>
                </c:pt>
                <c:pt idx="554">
                  <c:v>554.5</c:v>
                </c:pt>
                <c:pt idx="555">
                  <c:v>555.5</c:v>
                </c:pt>
                <c:pt idx="556">
                  <c:v>556.5</c:v>
                </c:pt>
                <c:pt idx="557">
                  <c:v>557.5</c:v>
                </c:pt>
                <c:pt idx="558">
                  <c:v>558.5</c:v>
                </c:pt>
                <c:pt idx="559">
                  <c:v>559.5</c:v>
                </c:pt>
                <c:pt idx="560">
                  <c:v>560.5</c:v>
                </c:pt>
                <c:pt idx="561">
                  <c:v>561.5</c:v>
                </c:pt>
                <c:pt idx="562">
                  <c:v>562.5</c:v>
                </c:pt>
                <c:pt idx="563">
                  <c:v>563.5</c:v>
                </c:pt>
                <c:pt idx="564">
                  <c:v>564.5</c:v>
                </c:pt>
                <c:pt idx="565">
                  <c:v>565.5</c:v>
                </c:pt>
                <c:pt idx="566">
                  <c:v>566.5</c:v>
                </c:pt>
                <c:pt idx="567">
                  <c:v>567.5</c:v>
                </c:pt>
                <c:pt idx="568">
                  <c:v>568.5</c:v>
                </c:pt>
                <c:pt idx="569">
                  <c:v>569.5</c:v>
                </c:pt>
                <c:pt idx="570">
                  <c:v>570.5</c:v>
                </c:pt>
                <c:pt idx="571">
                  <c:v>571.5</c:v>
                </c:pt>
                <c:pt idx="572">
                  <c:v>572.5</c:v>
                </c:pt>
                <c:pt idx="573">
                  <c:v>573.5</c:v>
                </c:pt>
                <c:pt idx="574">
                  <c:v>574.5</c:v>
                </c:pt>
                <c:pt idx="575">
                  <c:v>575.5</c:v>
                </c:pt>
                <c:pt idx="576">
                  <c:v>576.5</c:v>
                </c:pt>
                <c:pt idx="577">
                  <c:v>577.5</c:v>
                </c:pt>
                <c:pt idx="578">
                  <c:v>578.5</c:v>
                </c:pt>
                <c:pt idx="579">
                  <c:v>579.5</c:v>
                </c:pt>
                <c:pt idx="580">
                  <c:v>580.5</c:v>
                </c:pt>
                <c:pt idx="581">
                  <c:v>581.5</c:v>
                </c:pt>
                <c:pt idx="582">
                  <c:v>582.5</c:v>
                </c:pt>
                <c:pt idx="583">
                  <c:v>583.5</c:v>
                </c:pt>
                <c:pt idx="584">
                  <c:v>584.5</c:v>
                </c:pt>
                <c:pt idx="585">
                  <c:v>585.5</c:v>
                </c:pt>
                <c:pt idx="586">
                  <c:v>586.5</c:v>
                </c:pt>
                <c:pt idx="587">
                  <c:v>587.5</c:v>
                </c:pt>
                <c:pt idx="588">
                  <c:v>588.5</c:v>
                </c:pt>
                <c:pt idx="589">
                  <c:v>589.5</c:v>
                </c:pt>
                <c:pt idx="590">
                  <c:v>590.5</c:v>
                </c:pt>
                <c:pt idx="591">
                  <c:v>591.5</c:v>
                </c:pt>
                <c:pt idx="592">
                  <c:v>592.5</c:v>
                </c:pt>
                <c:pt idx="593">
                  <c:v>593.5</c:v>
                </c:pt>
                <c:pt idx="594">
                  <c:v>594.5</c:v>
                </c:pt>
                <c:pt idx="595">
                  <c:v>595.5</c:v>
                </c:pt>
                <c:pt idx="596">
                  <c:v>596.5</c:v>
                </c:pt>
                <c:pt idx="597">
                  <c:v>597.5</c:v>
                </c:pt>
                <c:pt idx="598">
                  <c:v>598.5</c:v>
                </c:pt>
                <c:pt idx="599">
                  <c:v>599.5</c:v>
                </c:pt>
                <c:pt idx="600">
                  <c:v>600.5</c:v>
                </c:pt>
                <c:pt idx="601">
                  <c:v>601.5</c:v>
                </c:pt>
                <c:pt idx="602">
                  <c:v>602.5</c:v>
                </c:pt>
                <c:pt idx="603">
                  <c:v>603.5</c:v>
                </c:pt>
                <c:pt idx="604">
                  <c:v>604.5</c:v>
                </c:pt>
                <c:pt idx="605">
                  <c:v>605.5</c:v>
                </c:pt>
                <c:pt idx="606">
                  <c:v>606.5</c:v>
                </c:pt>
                <c:pt idx="607">
                  <c:v>607.5</c:v>
                </c:pt>
                <c:pt idx="608">
                  <c:v>608.5</c:v>
                </c:pt>
                <c:pt idx="609">
                  <c:v>609.5</c:v>
                </c:pt>
                <c:pt idx="610">
                  <c:v>610.5</c:v>
                </c:pt>
                <c:pt idx="611">
                  <c:v>611.5</c:v>
                </c:pt>
                <c:pt idx="612">
                  <c:v>612.5</c:v>
                </c:pt>
                <c:pt idx="613">
                  <c:v>613.5</c:v>
                </c:pt>
                <c:pt idx="614">
                  <c:v>614.5</c:v>
                </c:pt>
                <c:pt idx="615">
                  <c:v>615.5</c:v>
                </c:pt>
                <c:pt idx="616">
                  <c:v>616.5</c:v>
                </c:pt>
                <c:pt idx="617">
                  <c:v>617.5</c:v>
                </c:pt>
                <c:pt idx="618">
                  <c:v>618.5</c:v>
                </c:pt>
                <c:pt idx="619">
                  <c:v>619.5</c:v>
                </c:pt>
                <c:pt idx="620">
                  <c:v>620.5</c:v>
                </c:pt>
                <c:pt idx="621">
                  <c:v>621.5</c:v>
                </c:pt>
                <c:pt idx="622">
                  <c:v>622.5</c:v>
                </c:pt>
                <c:pt idx="623">
                  <c:v>623.5</c:v>
                </c:pt>
                <c:pt idx="624">
                  <c:v>624.5</c:v>
                </c:pt>
                <c:pt idx="625">
                  <c:v>625.5</c:v>
                </c:pt>
                <c:pt idx="626">
                  <c:v>626.5</c:v>
                </c:pt>
                <c:pt idx="627">
                  <c:v>627.5</c:v>
                </c:pt>
                <c:pt idx="628">
                  <c:v>628.5</c:v>
                </c:pt>
                <c:pt idx="629">
                  <c:v>629.5</c:v>
                </c:pt>
                <c:pt idx="630">
                  <c:v>630.5</c:v>
                </c:pt>
                <c:pt idx="631">
                  <c:v>631.5</c:v>
                </c:pt>
                <c:pt idx="632">
                  <c:v>632.5</c:v>
                </c:pt>
                <c:pt idx="633">
                  <c:v>633.5</c:v>
                </c:pt>
                <c:pt idx="634">
                  <c:v>634.5</c:v>
                </c:pt>
                <c:pt idx="635">
                  <c:v>635.5</c:v>
                </c:pt>
                <c:pt idx="636">
                  <c:v>636.5</c:v>
                </c:pt>
                <c:pt idx="637">
                  <c:v>637.5</c:v>
                </c:pt>
                <c:pt idx="638">
                  <c:v>638.5</c:v>
                </c:pt>
                <c:pt idx="639">
                  <c:v>639.5</c:v>
                </c:pt>
                <c:pt idx="640">
                  <c:v>640.5</c:v>
                </c:pt>
                <c:pt idx="641">
                  <c:v>641.5</c:v>
                </c:pt>
                <c:pt idx="642">
                  <c:v>642.5</c:v>
                </c:pt>
                <c:pt idx="643">
                  <c:v>643.5</c:v>
                </c:pt>
                <c:pt idx="644">
                  <c:v>644.5</c:v>
                </c:pt>
                <c:pt idx="645">
                  <c:v>645.5</c:v>
                </c:pt>
                <c:pt idx="646">
                  <c:v>646.5</c:v>
                </c:pt>
                <c:pt idx="647">
                  <c:v>647.5</c:v>
                </c:pt>
                <c:pt idx="648">
                  <c:v>648.5</c:v>
                </c:pt>
                <c:pt idx="649">
                  <c:v>649.5</c:v>
                </c:pt>
                <c:pt idx="650">
                  <c:v>650.5</c:v>
                </c:pt>
                <c:pt idx="651">
                  <c:v>651.5</c:v>
                </c:pt>
                <c:pt idx="652">
                  <c:v>652.5</c:v>
                </c:pt>
                <c:pt idx="653">
                  <c:v>653.5</c:v>
                </c:pt>
                <c:pt idx="654">
                  <c:v>654.5</c:v>
                </c:pt>
                <c:pt idx="655">
                  <c:v>655.5</c:v>
                </c:pt>
                <c:pt idx="656">
                  <c:v>656.5</c:v>
                </c:pt>
                <c:pt idx="657">
                  <c:v>657.5</c:v>
                </c:pt>
                <c:pt idx="658">
                  <c:v>658.5</c:v>
                </c:pt>
                <c:pt idx="659">
                  <c:v>659.5</c:v>
                </c:pt>
                <c:pt idx="660">
                  <c:v>660.5</c:v>
                </c:pt>
                <c:pt idx="661">
                  <c:v>661.5</c:v>
                </c:pt>
                <c:pt idx="662">
                  <c:v>662.5</c:v>
                </c:pt>
                <c:pt idx="663">
                  <c:v>663.5</c:v>
                </c:pt>
                <c:pt idx="664">
                  <c:v>664.5</c:v>
                </c:pt>
                <c:pt idx="665">
                  <c:v>665.5</c:v>
                </c:pt>
                <c:pt idx="666">
                  <c:v>666.5</c:v>
                </c:pt>
                <c:pt idx="667">
                  <c:v>667.5</c:v>
                </c:pt>
                <c:pt idx="668">
                  <c:v>668.5</c:v>
                </c:pt>
                <c:pt idx="669">
                  <c:v>669.5</c:v>
                </c:pt>
                <c:pt idx="670">
                  <c:v>670.5</c:v>
                </c:pt>
                <c:pt idx="671">
                  <c:v>671.5</c:v>
                </c:pt>
                <c:pt idx="672">
                  <c:v>672.5</c:v>
                </c:pt>
                <c:pt idx="673">
                  <c:v>673.5</c:v>
                </c:pt>
                <c:pt idx="674">
                  <c:v>674.5</c:v>
                </c:pt>
                <c:pt idx="675">
                  <c:v>675.5</c:v>
                </c:pt>
                <c:pt idx="676">
                  <c:v>676.5</c:v>
                </c:pt>
                <c:pt idx="677">
                  <c:v>677.5</c:v>
                </c:pt>
                <c:pt idx="678">
                  <c:v>678.5</c:v>
                </c:pt>
                <c:pt idx="679">
                  <c:v>679.5</c:v>
                </c:pt>
                <c:pt idx="680">
                  <c:v>680.5</c:v>
                </c:pt>
                <c:pt idx="681">
                  <c:v>681.5</c:v>
                </c:pt>
                <c:pt idx="682">
                  <c:v>682.5</c:v>
                </c:pt>
                <c:pt idx="683">
                  <c:v>683.5</c:v>
                </c:pt>
                <c:pt idx="684">
                  <c:v>684.5</c:v>
                </c:pt>
                <c:pt idx="685">
                  <c:v>685.5</c:v>
                </c:pt>
                <c:pt idx="686">
                  <c:v>686.5</c:v>
                </c:pt>
                <c:pt idx="687">
                  <c:v>687.5</c:v>
                </c:pt>
                <c:pt idx="688">
                  <c:v>688.5</c:v>
                </c:pt>
                <c:pt idx="689">
                  <c:v>689.5</c:v>
                </c:pt>
                <c:pt idx="690">
                  <c:v>690.5</c:v>
                </c:pt>
                <c:pt idx="691">
                  <c:v>691.5</c:v>
                </c:pt>
                <c:pt idx="692">
                  <c:v>692.5</c:v>
                </c:pt>
                <c:pt idx="693">
                  <c:v>693.5</c:v>
                </c:pt>
                <c:pt idx="694">
                  <c:v>694.5</c:v>
                </c:pt>
                <c:pt idx="695">
                  <c:v>695.5</c:v>
                </c:pt>
                <c:pt idx="696">
                  <c:v>696.5</c:v>
                </c:pt>
                <c:pt idx="697">
                  <c:v>697.5</c:v>
                </c:pt>
                <c:pt idx="698">
                  <c:v>698.5</c:v>
                </c:pt>
                <c:pt idx="699">
                  <c:v>699.5</c:v>
                </c:pt>
                <c:pt idx="700">
                  <c:v>700.5</c:v>
                </c:pt>
                <c:pt idx="701">
                  <c:v>701.5</c:v>
                </c:pt>
                <c:pt idx="702">
                  <c:v>702.5</c:v>
                </c:pt>
                <c:pt idx="703">
                  <c:v>703.5</c:v>
                </c:pt>
                <c:pt idx="704">
                  <c:v>704.5</c:v>
                </c:pt>
                <c:pt idx="705">
                  <c:v>705.5</c:v>
                </c:pt>
                <c:pt idx="706">
                  <c:v>706.5</c:v>
                </c:pt>
                <c:pt idx="707">
                  <c:v>707.5</c:v>
                </c:pt>
                <c:pt idx="708">
                  <c:v>708.5</c:v>
                </c:pt>
                <c:pt idx="709">
                  <c:v>709.5</c:v>
                </c:pt>
                <c:pt idx="710">
                  <c:v>710.5</c:v>
                </c:pt>
                <c:pt idx="711">
                  <c:v>711.5</c:v>
                </c:pt>
                <c:pt idx="712">
                  <c:v>712.5</c:v>
                </c:pt>
                <c:pt idx="713">
                  <c:v>713.5</c:v>
                </c:pt>
                <c:pt idx="714">
                  <c:v>714.5</c:v>
                </c:pt>
                <c:pt idx="715">
                  <c:v>715.5</c:v>
                </c:pt>
                <c:pt idx="716">
                  <c:v>716.5</c:v>
                </c:pt>
                <c:pt idx="717">
                  <c:v>717.5</c:v>
                </c:pt>
                <c:pt idx="718">
                  <c:v>718.5</c:v>
                </c:pt>
                <c:pt idx="719">
                  <c:v>719.5</c:v>
                </c:pt>
                <c:pt idx="720">
                  <c:v>720.5</c:v>
                </c:pt>
                <c:pt idx="721">
                  <c:v>721.5</c:v>
                </c:pt>
                <c:pt idx="722">
                  <c:v>722.5</c:v>
                </c:pt>
                <c:pt idx="723">
                  <c:v>723.5</c:v>
                </c:pt>
                <c:pt idx="724">
                  <c:v>724.5</c:v>
                </c:pt>
                <c:pt idx="725">
                  <c:v>725.5</c:v>
                </c:pt>
                <c:pt idx="726">
                  <c:v>726.5</c:v>
                </c:pt>
                <c:pt idx="727">
                  <c:v>727.5</c:v>
                </c:pt>
                <c:pt idx="728">
                  <c:v>728.5</c:v>
                </c:pt>
                <c:pt idx="729">
                  <c:v>729.5</c:v>
                </c:pt>
                <c:pt idx="730">
                  <c:v>730.5</c:v>
                </c:pt>
                <c:pt idx="731">
                  <c:v>731.5</c:v>
                </c:pt>
                <c:pt idx="732">
                  <c:v>732.5</c:v>
                </c:pt>
                <c:pt idx="733">
                  <c:v>733.5</c:v>
                </c:pt>
                <c:pt idx="734">
                  <c:v>734.5</c:v>
                </c:pt>
                <c:pt idx="735">
                  <c:v>735.5</c:v>
                </c:pt>
                <c:pt idx="736">
                  <c:v>736.5</c:v>
                </c:pt>
                <c:pt idx="737">
                  <c:v>737.5</c:v>
                </c:pt>
                <c:pt idx="738">
                  <c:v>738.5</c:v>
                </c:pt>
                <c:pt idx="739">
                  <c:v>739.5</c:v>
                </c:pt>
                <c:pt idx="740">
                  <c:v>740.5</c:v>
                </c:pt>
                <c:pt idx="741">
                  <c:v>741.5</c:v>
                </c:pt>
                <c:pt idx="742">
                  <c:v>742.5</c:v>
                </c:pt>
                <c:pt idx="743">
                  <c:v>743.5</c:v>
                </c:pt>
                <c:pt idx="744">
                  <c:v>744.5</c:v>
                </c:pt>
                <c:pt idx="745">
                  <c:v>745.5</c:v>
                </c:pt>
                <c:pt idx="746">
                  <c:v>746.5</c:v>
                </c:pt>
                <c:pt idx="747">
                  <c:v>747.5</c:v>
                </c:pt>
                <c:pt idx="748">
                  <c:v>748.5</c:v>
                </c:pt>
                <c:pt idx="749">
                  <c:v>749.5</c:v>
                </c:pt>
                <c:pt idx="750">
                  <c:v>750.5</c:v>
                </c:pt>
                <c:pt idx="751">
                  <c:v>751.5</c:v>
                </c:pt>
                <c:pt idx="752">
                  <c:v>752.5</c:v>
                </c:pt>
                <c:pt idx="753">
                  <c:v>753.5</c:v>
                </c:pt>
                <c:pt idx="754">
                  <c:v>754.5</c:v>
                </c:pt>
                <c:pt idx="755">
                  <c:v>755.5</c:v>
                </c:pt>
                <c:pt idx="756">
                  <c:v>756.5</c:v>
                </c:pt>
                <c:pt idx="757">
                  <c:v>757.5</c:v>
                </c:pt>
                <c:pt idx="758">
                  <c:v>758.5</c:v>
                </c:pt>
                <c:pt idx="759">
                  <c:v>759.5</c:v>
                </c:pt>
                <c:pt idx="760">
                  <c:v>760.5</c:v>
                </c:pt>
                <c:pt idx="761">
                  <c:v>761.5</c:v>
                </c:pt>
                <c:pt idx="762">
                  <c:v>762.5</c:v>
                </c:pt>
                <c:pt idx="763">
                  <c:v>763.5</c:v>
                </c:pt>
                <c:pt idx="764">
                  <c:v>764.5</c:v>
                </c:pt>
                <c:pt idx="765">
                  <c:v>765.5</c:v>
                </c:pt>
                <c:pt idx="766">
                  <c:v>766.5</c:v>
                </c:pt>
                <c:pt idx="767">
                  <c:v>767.5</c:v>
                </c:pt>
                <c:pt idx="768">
                  <c:v>768.5</c:v>
                </c:pt>
                <c:pt idx="769">
                  <c:v>769.5</c:v>
                </c:pt>
                <c:pt idx="770">
                  <c:v>770.5</c:v>
                </c:pt>
                <c:pt idx="771">
                  <c:v>771.5</c:v>
                </c:pt>
                <c:pt idx="772">
                  <c:v>772.5</c:v>
                </c:pt>
                <c:pt idx="773">
                  <c:v>773.5</c:v>
                </c:pt>
                <c:pt idx="774">
                  <c:v>774.5</c:v>
                </c:pt>
                <c:pt idx="775">
                  <c:v>775.5</c:v>
                </c:pt>
                <c:pt idx="776">
                  <c:v>776.5</c:v>
                </c:pt>
                <c:pt idx="777">
                  <c:v>777.5</c:v>
                </c:pt>
                <c:pt idx="778">
                  <c:v>778.5</c:v>
                </c:pt>
                <c:pt idx="779">
                  <c:v>779.5</c:v>
                </c:pt>
                <c:pt idx="780">
                  <c:v>780.5</c:v>
                </c:pt>
                <c:pt idx="781">
                  <c:v>781.5</c:v>
                </c:pt>
                <c:pt idx="782">
                  <c:v>782.5</c:v>
                </c:pt>
                <c:pt idx="783">
                  <c:v>783.5</c:v>
                </c:pt>
                <c:pt idx="784">
                  <c:v>784.5</c:v>
                </c:pt>
                <c:pt idx="785">
                  <c:v>785.5</c:v>
                </c:pt>
                <c:pt idx="786">
                  <c:v>786.5</c:v>
                </c:pt>
                <c:pt idx="787">
                  <c:v>787.5</c:v>
                </c:pt>
                <c:pt idx="788">
                  <c:v>788.5</c:v>
                </c:pt>
                <c:pt idx="789">
                  <c:v>789.5</c:v>
                </c:pt>
                <c:pt idx="790">
                  <c:v>790.5</c:v>
                </c:pt>
                <c:pt idx="791">
                  <c:v>791.5</c:v>
                </c:pt>
                <c:pt idx="792">
                  <c:v>792.5</c:v>
                </c:pt>
                <c:pt idx="793">
                  <c:v>793.5</c:v>
                </c:pt>
                <c:pt idx="794">
                  <c:v>794.5</c:v>
                </c:pt>
                <c:pt idx="795">
                  <c:v>795.5</c:v>
                </c:pt>
                <c:pt idx="796">
                  <c:v>796.5</c:v>
                </c:pt>
                <c:pt idx="797">
                  <c:v>797.5</c:v>
                </c:pt>
                <c:pt idx="798">
                  <c:v>798.5</c:v>
                </c:pt>
                <c:pt idx="799">
                  <c:v>799.5</c:v>
                </c:pt>
                <c:pt idx="800">
                  <c:v>800.5</c:v>
                </c:pt>
                <c:pt idx="801">
                  <c:v>801.5</c:v>
                </c:pt>
                <c:pt idx="802">
                  <c:v>802.5</c:v>
                </c:pt>
                <c:pt idx="803">
                  <c:v>803.5</c:v>
                </c:pt>
                <c:pt idx="804">
                  <c:v>804.5</c:v>
                </c:pt>
                <c:pt idx="805">
                  <c:v>805.5</c:v>
                </c:pt>
                <c:pt idx="806">
                  <c:v>806.5</c:v>
                </c:pt>
                <c:pt idx="807">
                  <c:v>807.5</c:v>
                </c:pt>
                <c:pt idx="808">
                  <c:v>808.5</c:v>
                </c:pt>
                <c:pt idx="809">
                  <c:v>809.5</c:v>
                </c:pt>
                <c:pt idx="810">
                  <c:v>810.5</c:v>
                </c:pt>
                <c:pt idx="811">
                  <c:v>811.5</c:v>
                </c:pt>
                <c:pt idx="812">
                  <c:v>812.5</c:v>
                </c:pt>
                <c:pt idx="813">
                  <c:v>813.5</c:v>
                </c:pt>
                <c:pt idx="814">
                  <c:v>814.5</c:v>
                </c:pt>
                <c:pt idx="815">
                  <c:v>815.5</c:v>
                </c:pt>
                <c:pt idx="816">
                  <c:v>816.5</c:v>
                </c:pt>
                <c:pt idx="817">
                  <c:v>817.5</c:v>
                </c:pt>
                <c:pt idx="818">
                  <c:v>818.5</c:v>
                </c:pt>
                <c:pt idx="819">
                  <c:v>819.5</c:v>
                </c:pt>
                <c:pt idx="820">
                  <c:v>820.5</c:v>
                </c:pt>
                <c:pt idx="821">
                  <c:v>821.5</c:v>
                </c:pt>
                <c:pt idx="822">
                  <c:v>822.5</c:v>
                </c:pt>
                <c:pt idx="823">
                  <c:v>823.5</c:v>
                </c:pt>
                <c:pt idx="824">
                  <c:v>824.5</c:v>
                </c:pt>
                <c:pt idx="825">
                  <c:v>825.5</c:v>
                </c:pt>
                <c:pt idx="826">
                  <c:v>826.5</c:v>
                </c:pt>
                <c:pt idx="827">
                  <c:v>827.5</c:v>
                </c:pt>
                <c:pt idx="828">
                  <c:v>828.5</c:v>
                </c:pt>
                <c:pt idx="829">
                  <c:v>829.5</c:v>
                </c:pt>
                <c:pt idx="830">
                  <c:v>830.5</c:v>
                </c:pt>
                <c:pt idx="831">
                  <c:v>831.5</c:v>
                </c:pt>
                <c:pt idx="832">
                  <c:v>832.5</c:v>
                </c:pt>
                <c:pt idx="833">
                  <c:v>833.5</c:v>
                </c:pt>
                <c:pt idx="834">
                  <c:v>834.5</c:v>
                </c:pt>
                <c:pt idx="835">
                  <c:v>835.5</c:v>
                </c:pt>
                <c:pt idx="836">
                  <c:v>836.5</c:v>
                </c:pt>
                <c:pt idx="837">
                  <c:v>837.5</c:v>
                </c:pt>
                <c:pt idx="838">
                  <c:v>838.5</c:v>
                </c:pt>
                <c:pt idx="839">
                  <c:v>839.5</c:v>
                </c:pt>
                <c:pt idx="840">
                  <c:v>840.5</c:v>
                </c:pt>
                <c:pt idx="841">
                  <c:v>841.5</c:v>
                </c:pt>
                <c:pt idx="842">
                  <c:v>842.5</c:v>
                </c:pt>
                <c:pt idx="843">
                  <c:v>843.5</c:v>
                </c:pt>
                <c:pt idx="844">
                  <c:v>844.5</c:v>
                </c:pt>
                <c:pt idx="845">
                  <c:v>845.5</c:v>
                </c:pt>
                <c:pt idx="846">
                  <c:v>846.5</c:v>
                </c:pt>
                <c:pt idx="847">
                  <c:v>847.5</c:v>
                </c:pt>
                <c:pt idx="848">
                  <c:v>848.5</c:v>
                </c:pt>
                <c:pt idx="849">
                  <c:v>849.5</c:v>
                </c:pt>
                <c:pt idx="850">
                  <c:v>850.5</c:v>
                </c:pt>
                <c:pt idx="851">
                  <c:v>851.5</c:v>
                </c:pt>
                <c:pt idx="852">
                  <c:v>852.5</c:v>
                </c:pt>
                <c:pt idx="853">
                  <c:v>853.5</c:v>
                </c:pt>
                <c:pt idx="854">
                  <c:v>854.5</c:v>
                </c:pt>
                <c:pt idx="855">
                  <c:v>855.5</c:v>
                </c:pt>
                <c:pt idx="856">
                  <c:v>856.5</c:v>
                </c:pt>
                <c:pt idx="857">
                  <c:v>857.5</c:v>
                </c:pt>
                <c:pt idx="858">
                  <c:v>858.5</c:v>
                </c:pt>
                <c:pt idx="859">
                  <c:v>859.5</c:v>
                </c:pt>
                <c:pt idx="860">
                  <c:v>860.5</c:v>
                </c:pt>
                <c:pt idx="861">
                  <c:v>861.5</c:v>
                </c:pt>
                <c:pt idx="862">
                  <c:v>862.5</c:v>
                </c:pt>
                <c:pt idx="863">
                  <c:v>863.5</c:v>
                </c:pt>
                <c:pt idx="864">
                  <c:v>864.5</c:v>
                </c:pt>
                <c:pt idx="865">
                  <c:v>865.5</c:v>
                </c:pt>
                <c:pt idx="866">
                  <c:v>866.5</c:v>
                </c:pt>
                <c:pt idx="867">
                  <c:v>867.5</c:v>
                </c:pt>
                <c:pt idx="868">
                  <c:v>868.5</c:v>
                </c:pt>
                <c:pt idx="869">
                  <c:v>869.5</c:v>
                </c:pt>
                <c:pt idx="870">
                  <c:v>870.5</c:v>
                </c:pt>
                <c:pt idx="871">
                  <c:v>871.5</c:v>
                </c:pt>
                <c:pt idx="872">
                  <c:v>872.5</c:v>
                </c:pt>
                <c:pt idx="873">
                  <c:v>873.5</c:v>
                </c:pt>
                <c:pt idx="874">
                  <c:v>874.5</c:v>
                </c:pt>
                <c:pt idx="875">
                  <c:v>875.5</c:v>
                </c:pt>
                <c:pt idx="876">
                  <c:v>876.5</c:v>
                </c:pt>
                <c:pt idx="877">
                  <c:v>877.5</c:v>
                </c:pt>
                <c:pt idx="878">
                  <c:v>878.5</c:v>
                </c:pt>
                <c:pt idx="879">
                  <c:v>879.5</c:v>
                </c:pt>
                <c:pt idx="880">
                  <c:v>880.5</c:v>
                </c:pt>
                <c:pt idx="881">
                  <c:v>881.5</c:v>
                </c:pt>
                <c:pt idx="882">
                  <c:v>882.5</c:v>
                </c:pt>
                <c:pt idx="883">
                  <c:v>883.5</c:v>
                </c:pt>
                <c:pt idx="884">
                  <c:v>884.5</c:v>
                </c:pt>
                <c:pt idx="885">
                  <c:v>885.5</c:v>
                </c:pt>
                <c:pt idx="886">
                  <c:v>886.5</c:v>
                </c:pt>
                <c:pt idx="887">
                  <c:v>887.5</c:v>
                </c:pt>
                <c:pt idx="888">
                  <c:v>888.5</c:v>
                </c:pt>
                <c:pt idx="889">
                  <c:v>889.5</c:v>
                </c:pt>
                <c:pt idx="890">
                  <c:v>890.5</c:v>
                </c:pt>
                <c:pt idx="891">
                  <c:v>891.5</c:v>
                </c:pt>
                <c:pt idx="892">
                  <c:v>892.5</c:v>
                </c:pt>
                <c:pt idx="893">
                  <c:v>893.5</c:v>
                </c:pt>
                <c:pt idx="894">
                  <c:v>894.5</c:v>
                </c:pt>
                <c:pt idx="895">
                  <c:v>895.5</c:v>
                </c:pt>
                <c:pt idx="896">
                  <c:v>896.5</c:v>
                </c:pt>
                <c:pt idx="897">
                  <c:v>897.5</c:v>
                </c:pt>
                <c:pt idx="898">
                  <c:v>898.5</c:v>
                </c:pt>
                <c:pt idx="899">
                  <c:v>899.5</c:v>
                </c:pt>
                <c:pt idx="900">
                  <c:v>900.5</c:v>
                </c:pt>
                <c:pt idx="901">
                  <c:v>901.5</c:v>
                </c:pt>
                <c:pt idx="902">
                  <c:v>902.5</c:v>
                </c:pt>
                <c:pt idx="903">
                  <c:v>903.5</c:v>
                </c:pt>
                <c:pt idx="904">
                  <c:v>904.5</c:v>
                </c:pt>
                <c:pt idx="905">
                  <c:v>905.5</c:v>
                </c:pt>
                <c:pt idx="906">
                  <c:v>906.5</c:v>
                </c:pt>
                <c:pt idx="907">
                  <c:v>907.5</c:v>
                </c:pt>
                <c:pt idx="908">
                  <c:v>908.5</c:v>
                </c:pt>
                <c:pt idx="909">
                  <c:v>909.5</c:v>
                </c:pt>
                <c:pt idx="910">
                  <c:v>910.5</c:v>
                </c:pt>
                <c:pt idx="911">
                  <c:v>911.5</c:v>
                </c:pt>
                <c:pt idx="912">
                  <c:v>912.5</c:v>
                </c:pt>
                <c:pt idx="913">
                  <c:v>913.5</c:v>
                </c:pt>
                <c:pt idx="914">
                  <c:v>914.5</c:v>
                </c:pt>
                <c:pt idx="915">
                  <c:v>915.5</c:v>
                </c:pt>
                <c:pt idx="916">
                  <c:v>916.5</c:v>
                </c:pt>
                <c:pt idx="917">
                  <c:v>917.5</c:v>
                </c:pt>
                <c:pt idx="918">
                  <c:v>918.5</c:v>
                </c:pt>
                <c:pt idx="919">
                  <c:v>919.5</c:v>
                </c:pt>
                <c:pt idx="920">
                  <c:v>920.5</c:v>
                </c:pt>
                <c:pt idx="921">
                  <c:v>921.5</c:v>
                </c:pt>
                <c:pt idx="922">
                  <c:v>922.5</c:v>
                </c:pt>
                <c:pt idx="923">
                  <c:v>923.5</c:v>
                </c:pt>
                <c:pt idx="924">
                  <c:v>924.5</c:v>
                </c:pt>
                <c:pt idx="925">
                  <c:v>925.5</c:v>
                </c:pt>
                <c:pt idx="926">
                  <c:v>926.5</c:v>
                </c:pt>
                <c:pt idx="927">
                  <c:v>927.5</c:v>
                </c:pt>
                <c:pt idx="928">
                  <c:v>928.5</c:v>
                </c:pt>
                <c:pt idx="929">
                  <c:v>929.5</c:v>
                </c:pt>
                <c:pt idx="930">
                  <c:v>930.5</c:v>
                </c:pt>
                <c:pt idx="931">
                  <c:v>931.5</c:v>
                </c:pt>
                <c:pt idx="932">
                  <c:v>932.5</c:v>
                </c:pt>
                <c:pt idx="933">
                  <c:v>933.5</c:v>
                </c:pt>
                <c:pt idx="934">
                  <c:v>934.5</c:v>
                </c:pt>
                <c:pt idx="935">
                  <c:v>935.5</c:v>
                </c:pt>
                <c:pt idx="936">
                  <c:v>936.5</c:v>
                </c:pt>
                <c:pt idx="937">
                  <c:v>937.5</c:v>
                </c:pt>
                <c:pt idx="938">
                  <c:v>938.5</c:v>
                </c:pt>
                <c:pt idx="939">
                  <c:v>939.5</c:v>
                </c:pt>
                <c:pt idx="940">
                  <c:v>940.5</c:v>
                </c:pt>
                <c:pt idx="941">
                  <c:v>941.5</c:v>
                </c:pt>
                <c:pt idx="942">
                  <c:v>942.5</c:v>
                </c:pt>
                <c:pt idx="943">
                  <c:v>943.5</c:v>
                </c:pt>
                <c:pt idx="944">
                  <c:v>944.5</c:v>
                </c:pt>
                <c:pt idx="945">
                  <c:v>945.5</c:v>
                </c:pt>
                <c:pt idx="946">
                  <c:v>946.5</c:v>
                </c:pt>
                <c:pt idx="947">
                  <c:v>947.5</c:v>
                </c:pt>
                <c:pt idx="948">
                  <c:v>948.5</c:v>
                </c:pt>
                <c:pt idx="949">
                  <c:v>949.5</c:v>
                </c:pt>
                <c:pt idx="950">
                  <c:v>950.5</c:v>
                </c:pt>
                <c:pt idx="951">
                  <c:v>951.5</c:v>
                </c:pt>
                <c:pt idx="952">
                  <c:v>952.5</c:v>
                </c:pt>
                <c:pt idx="953">
                  <c:v>953.5</c:v>
                </c:pt>
                <c:pt idx="954">
                  <c:v>954.5</c:v>
                </c:pt>
                <c:pt idx="955">
                  <c:v>955.5</c:v>
                </c:pt>
                <c:pt idx="956">
                  <c:v>956.5</c:v>
                </c:pt>
                <c:pt idx="957">
                  <c:v>957.5</c:v>
                </c:pt>
                <c:pt idx="958">
                  <c:v>958.5</c:v>
                </c:pt>
                <c:pt idx="959">
                  <c:v>959.5</c:v>
                </c:pt>
                <c:pt idx="960">
                  <c:v>960.5</c:v>
                </c:pt>
                <c:pt idx="961">
                  <c:v>961.5</c:v>
                </c:pt>
                <c:pt idx="962">
                  <c:v>962.5</c:v>
                </c:pt>
                <c:pt idx="963">
                  <c:v>963.5</c:v>
                </c:pt>
                <c:pt idx="964">
                  <c:v>964.5</c:v>
                </c:pt>
                <c:pt idx="965">
                  <c:v>965.5</c:v>
                </c:pt>
                <c:pt idx="966">
                  <c:v>966.5</c:v>
                </c:pt>
                <c:pt idx="967">
                  <c:v>967.5</c:v>
                </c:pt>
                <c:pt idx="968">
                  <c:v>968.5</c:v>
                </c:pt>
                <c:pt idx="969">
                  <c:v>969.5</c:v>
                </c:pt>
                <c:pt idx="970">
                  <c:v>970.5</c:v>
                </c:pt>
                <c:pt idx="971">
                  <c:v>971.5</c:v>
                </c:pt>
                <c:pt idx="972">
                  <c:v>972.5</c:v>
                </c:pt>
                <c:pt idx="973">
                  <c:v>973.5</c:v>
                </c:pt>
                <c:pt idx="974">
                  <c:v>974.5</c:v>
                </c:pt>
                <c:pt idx="975">
                  <c:v>975.5</c:v>
                </c:pt>
                <c:pt idx="976">
                  <c:v>976.5</c:v>
                </c:pt>
                <c:pt idx="977">
                  <c:v>977.5</c:v>
                </c:pt>
                <c:pt idx="978">
                  <c:v>978.5</c:v>
                </c:pt>
                <c:pt idx="979">
                  <c:v>979.5</c:v>
                </c:pt>
                <c:pt idx="980">
                  <c:v>980.5</c:v>
                </c:pt>
                <c:pt idx="981">
                  <c:v>981.5</c:v>
                </c:pt>
                <c:pt idx="982">
                  <c:v>982.5</c:v>
                </c:pt>
                <c:pt idx="983">
                  <c:v>983.5</c:v>
                </c:pt>
                <c:pt idx="984">
                  <c:v>984.5</c:v>
                </c:pt>
                <c:pt idx="985">
                  <c:v>985.5</c:v>
                </c:pt>
                <c:pt idx="986">
                  <c:v>986.5</c:v>
                </c:pt>
                <c:pt idx="987">
                  <c:v>987.5</c:v>
                </c:pt>
                <c:pt idx="988">
                  <c:v>988.5</c:v>
                </c:pt>
                <c:pt idx="989">
                  <c:v>989.5</c:v>
                </c:pt>
                <c:pt idx="990">
                  <c:v>990.5</c:v>
                </c:pt>
                <c:pt idx="991">
                  <c:v>991.5</c:v>
                </c:pt>
                <c:pt idx="992">
                  <c:v>992.5</c:v>
                </c:pt>
                <c:pt idx="993">
                  <c:v>993.5</c:v>
                </c:pt>
                <c:pt idx="994">
                  <c:v>994.5</c:v>
                </c:pt>
                <c:pt idx="995">
                  <c:v>995.5</c:v>
                </c:pt>
                <c:pt idx="996">
                  <c:v>996.5</c:v>
                </c:pt>
                <c:pt idx="997">
                  <c:v>997.5</c:v>
                </c:pt>
                <c:pt idx="998">
                  <c:v>998.5</c:v>
                </c:pt>
                <c:pt idx="999">
                  <c:v>999.5</c:v>
                </c:pt>
              </c:numCache>
            </c:numRef>
          </c:xVal>
          <c:yVal>
            <c:numRef>
              <c:f>'[データまとめ (自動保存済み).xlsx]TM粒子数'!$F$3:$F$1002</c:f>
              <c:numCache>
                <c:formatCode>General</c:formatCode>
                <c:ptCount val="1000"/>
                <c:pt idx="0">
                  <c:v>0</c:v>
                </c:pt>
                <c:pt idx="1">
                  <c:v>0</c:v>
                </c:pt>
                <c:pt idx="2">
                  <c:v>7.7142857142857145E-10</c:v>
                </c:pt>
                <c:pt idx="3">
                  <c:v>2.2880571428571428E-7</c:v>
                </c:pt>
                <c:pt idx="4">
                  <c:v>4.044202857142857E-6</c:v>
                </c:pt>
                <c:pt idx="5">
                  <c:v>1.5473357142857144E-5</c:v>
                </c:pt>
                <c:pt idx="6">
                  <c:v>2.4904545714285715E-5</c:v>
                </c:pt>
                <c:pt idx="7">
                  <c:v>2.8793159999999998E-5</c:v>
                </c:pt>
                <c:pt idx="8">
                  <c:v>5.8968254285714286E-5</c:v>
                </c:pt>
                <c:pt idx="9">
                  <c:v>9.9793494285714286E-5</c:v>
                </c:pt>
                <c:pt idx="10">
                  <c:v>1.141826342857143E-4</c:v>
                </c:pt>
                <c:pt idx="11">
                  <c:v>8.7215700000000006E-5</c:v>
                </c:pt>
                <c:pt idx="12">
                  <c:v>4.999372571428571E-5</c:v>
                </c:pt>
                <c:pt idx="13">
                  <c:v>3.0584554285714289E-5</c:v>
                </c:pt>
                <c:pt idx="14">
                  <c:v>2.7503445714285715E-5</c:v>
                </c:pt>
                <c:pt idx="15">
                  <c:v>4.7198757142857143E-5</c:v>
                </c:pt>
                <c:pt idx="16">
                  <c:v>8.4178817142857142E-5</c:v>
                </c:pt>
                <c:pt idx="17">
                  <c:v>1.2242789428571429E-4</c:v>
                </c:pt>
                <c:pt idx="18">
                  <c:v>1.9412275142857143E-4</c:v>
                </c:pt>
                <c:pt idx="19">
                  <c:v>2.3475430285714287E-4</c:v>
                </c:pt>
                <c:pt idx="20">
                  <c:v>2.4310458285714285E-4</c:v>
                </c:pt>
                <c:pt idx="21">
                  <c:v>1.3972670257142857E-3</c:v>
                </c:pt>
                <c:pt idx="22">
                  <c:v>7.2744097428571438E-4</c:v>
                </c:pt>
                <c:pt idx="23">
                  <c:v>3.6038599999999997E-4</c:v>
                </c:pt>
                <c:pt idx="24">
                  <c:v>3.3242652285714287E-4</c:v>
                </c:pt>
                <c:pt idx="25">
                  <c:v>2.9552625714285714E-4</c:v>
                </c:pt>
                <c:pt idx="26">
                  <c:v>2.5164266571428573E-4</c:v>
                </c:pt>
                <c:pt idx="27">
                  <c:v>2.0395887142857143E-4</c:v>
                </c:pt>
                <c:pt idx="28">
                  <c:v>1.6459782571428571E-4</c:v>
                </c:pt>
                <c:pt idx="29">
                  <c:v>1.4180894857142857E-4</c:v>
                </c:pt>
                <c:pt idx="30">
                  <c:v>1.3555944E-4</c:v>
                </c:pt>
                <c:pt idx="31">
                  <c:v>1.5439616000000001E-4</c:v>
                </c:pt>
                <c:pt idx="32">
                  <c:v>2.1072288857142856E-4</c:v>
                </c:pt>
                <c:pt idx="33">
                  <c:v>3.2676818E-4</c:v>
                </c:pt>
                <c:pt idx="34">
                  <c:v>5.245059257142857E-4</c:v>
                </c:pt>
                <c:pt idx="35">
                  <c:v>7.9352147142857147E-4</c:v>
                </c:pt>
                <c:pt idx="36">
                  <c:v>1.1015602028571429E-3</c:v>
                </c:pt>
                <c:pt idx="37">
                  <c:v>1.4311280885714284E-3</c:v>
                </c:pt>
                <c:pt idx="38">
                  <c:v>1.7505112685714285E-3</c:v>
                </c:pt>
                <c:pt idx="39">
                  <c:v>1.7627572342857141E-3</c:v>
                </c:pt>
                <c:pt idx="40">
                  <c:v>1.3157301571428571E-3</c:v>
                </c:pt>
                <c:pt idx="41">
                  <c:v>8.2051796285714286E-4</c:v>
                </c:pt>
                <c:pt idx="42">
                  <c:v>5.6148850571428573E-4</c:v>
                </c:pt>
                <c:pt idx="43">
                  <c:v>4.3370358857142859E-4</c:v>
                </c:pt>
                <c:pt idx="44">
                  <c:v>3.272091057142857E-4</c:v>
                </c:pt>
                <c:pt idx="45">
                  <c:v>2.4616776285714284E-4</c:v>
                </c:pt>
                <c:pt idx="46">
                  <c:v>2.1208141714285715E-4</c:v>
                </c:pt>
                <c:pt idx="47">
                  <c:v>2.3446376000000002E-4</c:v>
                </c:pt>
                <c:pt idx="48">
                  <c:v>3.5803339714285713E-4</c:v>
                </c:pt>
                <c:pt idx="49">
                  <c:v>6.4842213142857143E-4</c:v>
                </c:pt>
                <c:pt idx="50">
                  <c:v>9.8985376857142868E-4</c:v>
                </c:pt>
                <c:pt idx="51">
                  <c:v>1.1339146E-3</c:v>
                </c:pt>
                <c:pt idx="52">
                  <c:v>1.2077397771428572E-3</c:v>
                </c:pt>
                <c:pt idx="53">
                  <c:v>1.5470296771428573E-3</c:v>
                </c:pt>
                <c:pt idx="54">
                  <c:v>2.2271814085714284E-3</c:v>
                </c:pt>
                <c:pt idx="55">
                  <c:v>3.1521418000000001E-3</c:v>
                </c:pt>
                <c:pt idx="56">
                  <c:v>4.201863968571428E-3</c:v>
                </c:pt>
                <c:pt idx="57">
                  <c:v>5.2109739142857138E-3</c:v>
                </c:pt>
                <c:pt idx="58">
                  <c:v>6.0160111114285712E-3</c:v>
                </c:pt>
                <c:pt idx="59">
                  <c:v>6.6076416657142858E-3</c:v>
                </c:pt>
                <c:pt idx="60">
                  <c:v>7.1445363971428576E-3</c:v>
                </c:pt>
                <c:pt idx="61">
                  <c:v>7.8115652485714285E-3</c:v>
                </c:pt>
                <c:pt idx="62">
                  <c:v>8.750158928571429E-3</c:v>
                </c:pt>
                <c:pt idx="63">
                  <c:v>1.0068579605714285E-2</c:v>
                </c:pt>
                <c:pt idx="64">
                  <c:v>1.1783124354285714E-2</c:v>
                </c:pt>
                <c:pt idx="65">
                  <c:v>1.3708720145714287E-2</c:v>
                </c:pt>
                <c:pt idx="66">
                  <c:v>1.5467599891428572E-2</c:v>
                </c:pt>
                <c:pt idx="67">
                  <c:v>1.6711554508571428E-2</c:v>
                </c:pt>
                <c:pt idx="68">
                  <c:v>1.7400142134285715E-2</c:v>
                </c:pt>
                <c:pt idx="69">
                  <c:v>1.7863647045714286E-2</c:v>
                </c:pt>
                <c:pt idx="70">
                  <c:v>1.8574814205714284E-2</c:v>
                </c:pt>
                <c:pt idx="71">
                  <c:v>1.9735396597142858E-2</c:v>
                </c:pt>
                <c:pt idx="72">
                  <c:v>2.0976224708571429E-2</c:v>
                </c:pt>
                <c:pt idx="73">
                  <c:v>2.1613359991428573E-2</c:v>
                </c:pt>
                <c:pt idx="74">
                  <c:v>2.1317404202857142E-2</c:v>
                </c:pt>
                <c:pt idx="75">
                  <c:v>2.0403307814285714E-2</c:v>
                </c:pt>
                <c:pt idx="76">
                  <c:v>1.9455520408571427E-2</c:v>
                </c:pt>
                <c:pt idx="77">
                  <c:v>1.8841476757142858E-2</c:v>
                </c:pt>
                <c:pt idx="78">
                  <c:v>1.859203937714286E-2</c:v>
                </c:pt>
                <c:pt idx="79">
                  <c:v>1.8568353028571429E-2</c:v>
                </c:pt>
                <c:pt idx="80">
                  <c:v>1.863848141142857E-2</c:v>
                </c:pt>
                <c:pt idx="81">
                  <c:v>1.8740744162857141E-2</c:v>
                </c:pt>
                <c:pt idx="82">
                  <c:v>1.8861879794285715E-2</c:v>
                </c:pt>
                <c:pt idx="83">
                  <c:v>1.8994084380000002E-2</c:v>
                </c:pt>
                <c:pt idx="84">
                  <c:v>1.9109089562857142E-2</c:v>
                </c:pt>
                <c:pt idx="85">
                  <c:v>1.9157561908571426E-2</c:v>
                </c:pt>
                <c:pt idx="86">
                  <c:v>1.908783177714286E-2</c:v>
                </c:pt>
                <c:pt idx="87">
                  <c:v>1.8871774394285716E-2</c:v>
                </c:pt>
                <c:pt idx="88">
                  <c:v>1.8521318965714285E-2</c:v>
                </c:pt>
                <c:pt idx="89">
                  <c:v>1.8082843059999999E-2</c:v>
                </c:pt>
                <c:pt idx="90">
                  <c:v>1.761193021142857E-2</c:v>
                </c:pt>
                <c:pt idx="91">
                  <c:v>1.7146385994285716E-2</c:v>
                </c:pt>
                <c:pt idx="92">
                  <c:v>1.6696328048571428E-2</c:v>
                </c:pt>
                <c:pt idx="93">
                  <c:v>1.6255438348571429E-2</c:v>
                </c:pt>
                <c:pt idx="94">
                  <c:v>1.582086542E-2</c:v>
                </c:pt>
                <c:pt idx="95">
                  <c:v>1.5405284637142858E-2</c:v>
                </c:pt>
                <c:pt idx="96">
                  <c:v>1.5034430694285715E-2</c:v>
                </c:pt>
                <c:pt idx="97">
                  <c:v>1.4735279848571429E-2</c:v>
                </c:pt>
                <c:pt idx="98">
                  <c:v>1.4523292394285715E-2</c:v>
                </c:pt>
                <c:pt idx="99">
                  <c:v>1.4392880314285714E-2</c:v>
                </c:pt>
                <c:pt idx="100">
                  <c:v>1.43119357E-2</c:v>
                </c:pt>
                <c:pt idx="101">
                  <c:v>1.4222778837142859E-2</c:v>
                </c:pt>
                <c:pt idx="102">
                  <c:v>1.4053935108571428E-2</c:v>
                </c:pt>
                <c:pt idx="103">
                  <c:v>1.3743542697142857E-2</c:v>
                </c:pt>
                <c:pt idx="104">
                  <c:v>1.3265983674285714E-2</c:v>
                </c:pt>
                <c:pt idx="105">
                  <c:v>1.2646501702857143E-2</c:v>
                </c:pt>
                <c:pt idx="106">
                  <c:v>1.1952912537142856E-2</c:v>
                </c:pt>
                <c:pt idx="107">
                  <c:v>1.1268305334285713E-2</c:v>
                </c:pt>
                <c:pt idx="108">
                  <c:v>1.0661630788571429E-2</c:v>
                </c:pt>
                <c:pt idx="109">
                  <c:v>1.0172171922857144E-2</c:v>
                </c:pt>
                <c:pt idx="110">
                  <c:v>9.8107522257142865E-3</c:v>
                </c:pt>
                <c:pt idx="111">
                  <c:v>9.5686940400000007E-3</c:v>
                </c:pt>
                <c:pt idx="112">
                  <c:v>9.4248362142857148E-3</c:v>
                </c:pt>
                <c:pt idx="113">
                  <c:v>9.3483346942857138E-3</c:v>
                </c:pt>
                <c:pt idx="114">
                  <c:v>9.3011943485714291E-3</c:v>
                </c:pt>
                <c:pt idx="115">
                  <c:v>9.2444343314285714E-3</c:v>
                </c:pt>
                <c:pt idx="116">
                  <c:v>9.1472843085714274E-3</c:v>
                </c:pt>
                <c:pt idx="117">
                  <c:v>8.9946384428571426E-3</c:v>
                </c:pt>
                <c:pt idx="118">
                  <c:v>8.7876307971428581E-3</c:v>
                </c:pt>
                <c:pt idx="119">
                  <c:v>8.535992479999999E-3</c:v>
                </c:pt>
                <c:pt idx="120">
                  <c:v>8.2463838999999994E-3</c:v>
                </c:pt>
                <c:pt idx="121">
                  <c:v>7.9143437457142862E-3</c:v>
                </c:pt>
                <c:pt idx="122">
                  <c:v>7.5257729657142863E-3</c:v>
                </c:pt>
                <c:pt idx="123">
                  <c:v>7.0673438371428561E-3</c:v>
                </c:pt>
                <c:pt idx="124">
                  <c:v>6.5386442542857137E-3</c:v>
                </c:pt>
                <c:pt idx="125">
                  <c:v>5.9577487085714287E-3</c:v>
                </c:pt>
                <c:pt idx="126">
                  <c:v>5.3570187685714286E-3</c:v>
                </c:pt>
                <c:pt idx="127">
                  <c:v>4.7725697657142853E-3</c:v>
                </c:pt>
                <c:pt idx="128">
                  <c:v>4.2338469428571425E-3</c:v>
                </c:pt>
                <c:pt idx="129">
                  <c:v>3.7580274999999999E-3</c:v>
                </c:pt>
                <c:pt idx="130">
                  <c:v>3.3500726657142857E-3</c:v>
                </c:pt>
                <c:pt idx="131">
                  <c:v>3.006299237142857E-3</c:v>
                </c:pt>
                <c:pt idx="132">
                  <c:v>2.7187006971428574E-3</c:v>
                </c:pt>
                <c:pt idx="133">
                  <c:v>2.4783192971428573E-3</c:v>
                </c:pt>
                <c:pt idx="134">
                  <c:v>2.2773087342857143E-3</c:v>
                </c:pt>
                <c:pt idx="135">
                  <c:v>2.110000134285714E-3</c:v>
                </c:pt>
                <c:pt idx="136">
                  <c:v>1.9732903114285717E-3</c:v>
                </c:pt>
                <c:pt idx="137">
                  <c:v>1.8664347742857143E-3</c:v>
                </c:pt>
                <c:pt idx="138">
                  <c:v>1.790158457142857E-3</c:v>
                </c:pt>
                <c:pt idx="139">
                  <c:v>1.7450340428571429E-3</c:v>
                </c:pt>
                <c:pt idx="140">
                  <c:v>1.7294342257142858E-3</c:v>
                </c:pt>
                <c:pt idx="141">
                  <c:v>1.7380066E-3</c:v>
                </c:pt>
                <c:pt idx="142">
                  <c:v>1.7620429171428572E-3</c:v>
                </c:pt>
                <c:pt idx="143">
                  <c:v>1.7924942914285715E-3</c:v>
                </c:pt>
                <c:pt idx="144">
                  <c:v>1.8245494742857144E-3</c:v>
                </c:pt>
                <c:pt idx="145">
                  <c:v>1.8609556457142855E-3</c:v>
                </c:pt>
                <c:pt idx="146">
                  <c:v>1.9114936857142859E-3</c:v>
                </c:pt>
                <c:pt idx="147">
                  <c:v>1.9884442171428573E-3</c:v>
                </c:pt>
                <c:pt idx="148">
                  <c:v>2.1004407342857141E-3</c:v>
                </c:pt>
                <c:pt idx="149">
                  <c:v>2.2476865571428571E-3</c:v>
                </c:pt>
                <c:pt idx="150">
                  <c:v>2.4202275142857143E-3</c:v>
                </c:pt>
                <c:pt idx="151">
                  <c:v>2.5995054571428572E-3</c:v>
                </c:pt>
                <c:pt idx="152">
                  <c:v>2.7626759057142857E-3</c:v>
                </c:pt>
                <c:pt idx="153">
                  <c:v>2.8885728171428571E-3</c:v>
                </c:pt>
                <c:pt idx="154">
                  <c:v>2.9632321171428572E-3</c:v>
                </c:pt>
                <c:pt idx="155">
                  <c:v>2.9823853971428574E-3</c:v>
                </c:pt>
                <c:pt idx="156">
                  <c:v>2.949566142857143E-3</c:v>
                </c:pt>
                <c:pt idx="157">
                  <c:v>2.8711969657142858E-3</c:v>
                </c:pt>
                <c:pt idx="158">
                  <c:v>2.7521902514285714E-3</c:v>
                </c:pt>
                <c:pt idx="159">
                  <c:v>2.5951877657142859E-3</c:v>
                </c:pt>
                <c:pt idx="160">
                  <c:v>2.4036381571428569E-3</c:v>
                </c:pt>
                <c:pt idx="161">
                  <c:v>2.1857474457142854E-3</c:v>
                </c:pt>
                <c:pt idx="162">
                  <c:v>1.9556056857142857E-3</c:v>
                </c:pt>
                <c:pt idx="163">
                  <c:v>1.7301843914285715E-3</c:v>
                </c:pt>
                <c:pt idx="164">
                  <c:v>1.5243172114285716E-3</c:v>
                </c:pt>
                <c:pt idx="165">
                  <c:v>1.3471913714285715E-3</c:v>
                </c:pt>
                <c:pt idx="166">
                  <c:v>1.2022723114285714E-3</c:v>
                </c:pt>
                <c:pt idx="167">
                  <c:v>1.0898031057142857E-3</c:v>
                </c:pt>
                <c:pt idx="168">
                  <c:v>1.0095656714285714E-3</c:v>
                </c:pt>
                <c:pt idx="169">
                  <c:v>9.6210129428571422E-4</c:v>
                </c:pt>
                <c:pt idx="170">
                  <c:v>9.4785074000000005E-4</c:v>
                </c:pt>
                <c:pt idx="171">
                  <c:v>9.6462931428571437E-4</c:v>
                </c:pt>
                <c:pt idx="172">
                  <c:v>1.0046948742857143E-3</c:v>
                </c:pt>
                <c:pt idx="173">
                  <c:v>1.0536762628571429E-3</c:v>
                </c:pt>
                <c:pt idx="174">
                  <c:v>1.0935804342857142E-3</c:v>
                </c:pt>
                <c:pt idx="175">
                  <c:v>1.1094457228571428E-3</c:v>
                </c:pt>
                <c:pt idx="176">
                  <c:v>1.0954954400000001E-3</c:v>
                </c:pt>
                <c:pt idx="177">
                  <c:v>1.0562349228571428E-3</c:v>
                </c:pt>
                <c:pt idx="178">
                  <c:v>1.0021679714285715E-3</c:v>
                </c:pt>
                <c:pt idx="179">
                  <c:v>9.4408408857142849E-4</c:v>
                </c:pt>
                <c:pt idx="180">
                  <c:v>8.8966002285714284E-4</c:v>
                </c:pt>
                <c:pt idx="181">
                  <c:v>8.4289634285714295E-4</c:v>
                </c:pt>
                <c:pt idx="182">
                  <c:v>8.0491606571428571E-4</c:v>
                </c:pt>
                <c:pt idx="183">
                  <c:v>7.7498781714285716E-4</c:v>
                </c:pt>
                <c:pt idx="184">
                  <c:v>7.5149137428571437E-4</c:v>
                </c:pt>
                <c:pt idx="185">
                  <c:v>7.3274802571428571E-4</c:v>
                </c:pt>
                <c:pt idx="186">
                  <c:v>7.1753233428571434E-4</c:v>
                </c:pt>
                <c:pt idx="187">
                  <c:v>7.0515256285714285E-4</c:v>
                </c:pt>
                <c:pt idx="188">
                  <c:v>6.9519018857142859E-4</c:v>
                </c:pt>
                <c:pt idx="189">
                  <c:v>6.8711698285714288E-4</c:v>
                </c:pt>
                <c:pt idx="190">
                  <c:v>6.8001275142857141E-4</c:v>
                </c:pt>
                <c:pt idx="191">
                  <c:v>6.7254254571428565E-4</c:v>
                </c:pt>
                <c:pt idx="192">
                  <c:v>6.6324522000000001E-4</c:v>
                </c:pt>
                <c:pt idx="193">
                  <c:v>6.510379657142857E-4</c:v>
                </c:pt>
                <c:pt idx="194">
                  <c:v>6.357020485714286E-4</c:v>
                </c:pt>
                <c:pt idx="195">
                  <c:v>6.1808386285714279E-4</c:v>
                </c:pt>
                <c:pt idx="196">
                  <c:v>5.9988026285714285E-4</c:v>
                </c:pt>
                <c:pt idx="197">
                  <c:v>5.8310962857142858E-4</c:v>
                </c:pt>
                <c:pt idx="198">
                  <c:v>5.6953729714285715E-4</c:v>
                </c:pt>
                <c:pt idx="199">
                  <c:v>5.6031150857142854E-4</c:v>
                </c:pt>
                <c:pt idx="200">
                  <c:v>5.5590438857142858E-4</c:v>
                </c:pt>
                <c:pt idx="201">
                  <c:v>5.5628006857142863E-4</c:v>
                </c:pt>
                <c:pt idx="202">
                  <c:v>5.6113802285714292E-4</c:v>
                </c:pt>
                <c:pt idx="203">
                  <c:v>5.7011147142857141E-4</c:v>
                </c:pt>
                <c:pt idx="204">
                  <c:v>5.8287032857142851E-4</c:v>
                </c:pt>
                <c:pt idx="205">
                  <c:v>5.9912780857142853E-4</c:v>
                </c:pt>
                <c:pt idx="206">
                  <c:v>6.1856702285714292E-4</c:v>
                </c:pt>
                <c:pt idx="207">
                  <c:v>6.4070918857142859E-4</c:v>
                </c:pt>
                <c:pt idx="208">
                  <c:v>6.6475608285714288E-4</c:v>
                </c:pt>
                <c:pt idx="209">
                  <c:v>6.8945570285714288E-4</c:v>
                </c:pt>
                <c:pt idx="210">
                  <c:v>7.1304937714285709E-4</c:v>
                </c:pt>
                <c:pt idx="211">
                  <c:v>7.3334716571428569E-4</c:v>
                </c:pt>
                <c:pt idx="212">
                  <c:v>7.4794474285714283E-4</c:v>
                </c:pt>
                <c:pt idx="213">
                  <c:v>7.5454859142857144E-4</c:v>
                </c:pt>
                <c:pt idx="214">
                  <c:v>7.5133808285714285E-4</c:v>
                </c:pt>
                <c:pt idx="215">
                  <c:v>7.372790942857143E-4</c:v>
                </c:pt>
                <c:pt idx="216">
                  <c:v>7.1232132857142855E-4</c:v>
                </c:pt>
                <c:pt idx="217">
                  <c:v>6.7744710857142851E-4</c:v>
                </c:pt>
                <c:pt idx="218">
                  <c:v>6.3457537999999996E-4</c:v>
                </c:pt>
                <c:pt idx="219">
                  <c:v>5.863458742857143E-4</c:v>
                </c:pt>
                <c:pt idx="220">
                  <c:v>5.3581708857142858E-4</c:v>
                </c:pt>
                <c:pt idx="221">
                  <c:v>4.861201914285715E-4</c:v>
                </c:pt>
                <c:pt idx="222">
                  <c:v>4.401245914285715E-4</c:v>
                </c:pt>
                <c:pt idx="223">
                  <c:v>4.0018110571428568E-4</c:v>
                </c:pt>
                <c:pt idx="224">
                  <c:v>3.6799700857142857E-4</c:v>
                </c:pt>
                <c:pt idx="225">
                  <c:v>3.4465490857142855E-4</c:v>
                </c:pt>
                <c:pt idx="226">
                  <c:v>3.3072729142857144E-4</c:v>
                </c:pt>
                <c:pt idx="227">
                  <c:v>3.2639192E-4</c:v>
                </c:pt>
                <c:pt idx="228">
                  <c:v>3.3144910857142859E-4</c:v>
                </c:pt>
                <c:pt idx="229">
                  <c:v>3.4519139142857142E-4</c:v>
                </c:pt>
                <c:pt idx="230">
                  <c:v>3.6616187714285715E-4</c:v>
                </c:pt>
                <c:pt idx="231">
                  <c:v>3.9192353999999998E-4</c:v>
                </c:pt>
                <c:pt idx="232">
                  <c:v>4.1900403714285715E-4</c:v>
                </c:pt>
                <c:pt idx="233">
                  <c:v>4.4314928857142858E-4</c:v>
                </c:pt>
                <c:pt idx="234">
                  <c:v>4.5991521428571426E-4</c:v>
                </c:pt>
                <c:pt idx="235">
                  <c:v>4.6548530857142852E-4</c:v>
                </c:pt>
                <c:pt idx="236">
                  <c:v>4.5748492285714289E-4</c:v>
                </c:pt>
                <c:pt idx="237">
                  <c:v>4.3552907428571434E-4</c:v>
                </c:pt>
                <c:pt idx="238">
                  <c:v>4.0131352857142858E-4</c:v>
                </c:pt>
                <c:pt idx="239">
                  <c:v>3.5821223999999997E-4</c:v>
                </c:pt>
                <c:pt idx="240">
                  <c:v>3.1051222857142859E-4</c:v>
                </c:pt>
                <c:pt idx="241">
                  <c:v>2.6252707714285718E-4</c:v>
                </c:pt>
                <c:pt idx="242">
                  <c:v>2.1784159714285714E-4</c:v>
                </c:pt>
                <c:pt idx="243">
                  <c:v>1.7886075714285712E-4</c:v>
                </c:pt>
                <c:pt idx="244">
                  <c:v>1.4671050857142858E-4</c:v>
                </c:pt>
                <c:pt idx="245">
                  <c:v>1.2142487428571428E-4</c:v>
                </c:pt>
                <c:pt idx="246">
                  <c:v>1.0229071714285714E-4</c:v>
                </c:pt>
                <c:pt idx="247">
                  <c:v>8.8218171428571426E-5</c:v>
                </c:pt>
                <c:pt idx="248">
                  <c:v>7.8043022857142853E-5</c:v>
                </c:pt>
                <c:pt idx="249">
                  <c:v>7.0720351428571425E-5</c:v>
                </c:pt>
                <c:pt idx="250">
                  <c:v>6.5412842857142848E-5</c:v>
                </c:pt>
                <c:pt idx="251">
                  <c:v>6.1502008571428569E-5</c:v>
                </c:pt>
                <c:pt idx="252">
                  <c:v>5.8556428571428569E-5</c:v>
                </c:pt>
                <c:pt idx="253">
                  <c:v>5.6284791428571426E-5</c:v>
                </c:pt>
                <c:pt idx="254">
                  <c:v>5.449109428571429E-5</c:v>
                </c:pt>
                <c:pt idx="255">
                  <c:v>5.3039682857142852E-5</c:v>
                </c:pt>
                <c:pt idx="256">
                  <c:v>5.1831477142857145E-5</c:v>
                </c:pt>
                <c:pt idx="257">
                  <c:v>5.0789477142857144E-5</c:v>
                </c:pt>
                <c:pt idx="258">
                  <c:v>4.9850968571428572E-5</c:v>
                </c:pt>
                <c:pt idx="259">
                  <c:v>4.8963779999999999E-5</c:v>
                </c:pt>
                <c:pt idx="260">
                  <c:v>4.808488857142857E-5</c:v>
                </c:pt>
                <c:pt idx="261">
                  <c:v>4.7180157142857143E-5</c:v>
                </c:pt>
                <c:pt idx="262">
                  <c:v>4.6224434285714286E-5</c:v>
                </c:pt>
                <c:pt idx="263">
                  <c:v>4.5201625714285713E-5</c:v>
                </c:pt>
                <c:pt idx="264">
                  <c:v>4.4104519999999999E-5</c:v>
                </c:pt>
                <c:pt idx="265">
                  <c:v>4.2934188571428572E-5</c:v>
                </c:pt>
                <c:pt idx="266">
                  <c:v>4.1699051428571432E-5</c:v>
                </c:pt>
                <c:pt idx="267">
                  <c:v>4.0413559999999999E-5</c:v>
                </c:pt>
                <c:pt idx="268">
                  <c:v>3.9096637142857144E-5</c:v>
                </c:pt>
                <c:pt idx="269">
                  <c:v>3.7770037142857142E-5</c:v>
                </c:pt>
                <c:pt idx="270">
                  <c:v>3.6456625714285714E-5</c:v>
                </c:pt>
                <c:pt idx="271">
                  <c:v>3.5178845714285712E-5</c:v>
                </c:pt>
                <c:pt idx="272">
                  <c:v>3.3957400000000001E-5</c:v>
                </c:pt>
                <c:pt idx="273">
                  <c:v>3.2810240000000003E-5</c:v>
                </c:pt>
                <c:pt idx="274">
                  <c:v>3.1751934285714286E-5</c:v>
                </c:pt>
                <c:pt idx="275">
                  <c:v>3.0793342857142858E-5</c:v>
                </c:pt>
                <c:pt idx="276">
                  <c:v>2.9941708571428572E-5</c:v>
                </c:pt>
                <c:pt idx="277">
                  <c:v>2.9201102857142854E-5</c:v>
                </c:pt>
                <c:pt idx="278">
                  <c:v>2.8573120000000001E-5</c:v>
                </c:pt>
                <c:pt idx="279">
                  <c:v>2.8058002857142855E-5</c:v>
                </c:pt>
                <c:pt idx="280">
                  <c:v>2.7656134285714287E-5</c:v>
                </c:pt>
                <c:pt idx="281">
                  <c:v>2.7370182857142853E-5</c:v>
                </c:pt>
                <c:pt idx="282">
                  <c:v>2.7208020000000002E-5</c:v>
                </c:pt>
                <c:pt idx="283">
                  <c:v>2.7186877142857144E-5</c:v>
                </c:pt>
                <c:pt idx="284">
                  <c:v>2.7338928571428575E-5</c:v>
                </c:pt>
                <c:pt idx="285">
                  <c:v>2.7718534285714285E-5</c:v>
                </c:pt>
                <c:pt idx="286">
                  <c:v>2.8410954285714286E-5</c:v>
                </c:pt>
                <c:pt idx="287">
                  <c:v>2.9541271428571426E-5</c:v>
                </c:pt>
                <c:pt idx="288">
                  <c:v>3.1281505714285716E-5</c:v>
                </c:pt>
                <c:pt idx="289">
                  <c:v>3.3852285714285713E-5</c:v>
                </c:pt>
                <c:pt idx="290">
                  <c:v>3.7514342857142857E-5</c:v>
                </c:pt>
                <c:pt idx="291">
                  <c:v>4.2545011428571428E-5</c:v>
                </c:pt>
                <c:pt idx="292">
                  <c:v>4.9196285714285714E-5</c:v>
                </c:pt>
                <c:pt idx="293">
                  <c:v>5.7635105714285714E-5</c:v>
                </c:pt>
                <c:pt idx="294">
                  <c:v>6.7872545714285707E-5</c:v>
                </c:pt>
                <c:pt idx="295">
                  <c:v>7.969575428571428E-5</c:v>
                </c:pt>
                <c:pt idx="296">
                  <c:v>9.2622451428571426E-5</c:v>
                </c:pt>
                <c:pt idx="297">
                  <c:v>1.0589885142857144E-4</c:v>
                </c:pt>
                <c:pt idx="298">
                  <c:v>1.1855620571428573E-4</c:v>
                </c:pt>
                <c:pt idx="299">
                  <c:v>1.2952806000000001E-4</c:v>
                </c:pt>
                <c:pt idx="300">
                  <c:v>1.3781235142857143E-4</c:v>
                </c:pt>
                <c:pt idx="301">
                  <c:v>1.426460857142857E-4</c:v>
                </c:pt>
                <c:pt idx="302">
                  <c:v>1.4365039142857144E-4</c:v>
                </c:pt>
                <c:pt idx="303">
                  <c:v>1.4090786857142858E-4</c:v>
                </c:pt>
                <c:pt idx="304">
                  <c:v>1.3494967142857144E-4</c:v>
                </c:pt>
                <c:pt idx="305">
                  <c:v>1.2665443714285715E-4</c:v>
                </c:pt>
                <c:pt idx="306">
                  <c:v>1.1708519142857142E-4</c:v>
                </c:pt>
                <c:pt idx="307">
                  <c:v>1.0730579142857143E-4</c:v>
                </c:pt>
                <c:pt idx="308">
                  <c:v>9.8220442857142848E-5</c:v>
                </c:pt>
                <c:pt idx="309">
                  <c:v>9.0468240000000005E-5</c:v>
                </c:pt>
                <c:pt idx="310">
                  <c:v>8.4385899999999994E-5</c:v>
                </c:pt>
                <c:pt idx="311">
                  <c:v>8.0032039999999998E-5</c:v>
                </c:pt>
                <c:pt idx="312">
                  <c:v>7.7253065714285712E-5</c:v>
                </c:pt>
                <c:pt idx="313">
                  <c:v>7.5765797142857139E-5</c:v>
                </c:pt>
                <c:pt idx="314">
                  <c:v>7.5235411428571436E-5</c:v>
                </c:pt>
                <c:pt idx="315">
                  <c:v>7.5335222857142851E-5</c:v>
                </c:pt>
                <c:pt idx="316">
                  <c:v>7.5783642857142847E-5</c:v>
                </c:pt>
                <c:pt idx="317">
                  <c:v>7.6360431428571424E-5</c:v>
                </c:pt>
                <c:pt idx="318">
                  <c:v>7.6908074285714288E-5</c:v>
                </c:pt>
                <c:pt idx="319">
                  <c:v>7.7324668571428573E-5</c:v>
                </c:pt>
                <c:pt idx="320">
                  <c:v>7.7553534285714284E-5</c:v>
                </c:pt>
                <c:pt idx="321">
                  <c:v>7.7572900000000004E-5</c:v>
                </c:pt>
                <c:pt idx="322">
                  <c:v>7.7387168571428568E-5</c:v>
                </c:pt>
                <c:pt idx="323">
                  <c:v>7.7020137142857147E-5</c:v>
                </c:pt>
                <c:pt idx="324">
                  <c:v>7.650978857142857E-5</c:v>
                </c:pt>
                <c:pt idx="325">
                  <c:v>7.590409142857143E-5</c:v>
                </c:pt>
                <c:pt idx="326">
                  <c:v>7.5257405714285709E-5</c:v>
                </c:pt>
                <c:pt idx="327">
                  <c:v>7.4627131428571425E-5</c:v>
                </c:pt>
                <c:pt idx="328">
                  <c:v>7.4070442857142858E-5</c:v>
                </c:pt>
                <c:pt idx="329">
                  <c:v>7.364122285714285E-5</c:v>
                </c:pt>
                <c:pt idx="330">
                  <c:v>7.3387174285714286E-5</c:v>
                </c:pt>
                <c:pt idx="331">
                  <c:v>7.3347265714285713E-5</c:v>
                </c:pt>
                <c:pt idx="332">
                  <c:v>7.3549737142857141E-5</c:v>
                </c:pt>
                <c:pt idx="333">
                  <c:v>7.401065428571429E-5</c:v>
                </c:pt>
                <c:pt idx="334">
                  <c:v>7.4733160000000002E-5</c:v>
                </c:pt>
                <c:pt idx="335">
                  <c:v>7.5707491428571433E-5</c:v>
                </c:pt>
                <c:pt idx="336">
                  <c:v>7.6911580000000009E-5</c:v>
                </c:pt>
                <c:pt idx="337">
                  <c:v>7.8312434285714288E-5</c:v>
                </c:pt>
                <c:pt idx="338">
                  <c:v>7.9867948571428571E-5</c:v>
                </c:pt>
                <c:pt idx="339">
                  <c:v>8.1529148571428568E-5</c:v>
                </c:pt>
                <c:pt idx="340">
                  <c:v>8.3242725714285717E-5</c:v>
                </c:pt>
                <c:pt idx="341">
                  <c:v>8.495366571428571E-5</c:v>
                </c:pt>
                <c:pt idx="342">
                  <c:v>8.660782857142857E-5</c:v>
                </c:pt>
                <c:pt idx="343">
                  <c:v>8.8154282857142856E-5</c:v>
                </c:pt>
                <c:pt idx="344">
                  <c:v>8.9547434285714285E-5</c:v>
                </c:pt>
                <c:pt idx="345">
                  <c:v>9.0748625714285716E-5</c:v>
                </c:pt>
                <c:pt idx="346">
                  <c:v>9.1727262857142856E-5</c:v>
                </c:pt>
                <c:pt idx="347">
                  <c:v>9.246151999999999E-5</c:v>
                </c:pt>
                <c:pt idx="348">
                  <c:v>9.2938385714285717E-5</c:v>
                </c:pt>
                <c:pt idx="349">
                  <c:v>9.3153319999999989E-5</c:v>
                </c:pt>
                <c:pt idx="350">
                  <c:v>9.3109442857142849E-5</c:v>
                </c:pt>
                <c:pt idx="351">
                  <c:v>9.2816437142857137E-5</c:v>
                </c:pt>
                <c:pt idx="352">
                  <c:v>9.2289185714285716E-5</c:v>
                </c:pt>
                <c:pt idx="353">
                  <c:v>9.1546302857142855E-5</c:v>
                </c:pt>
                <c:pt idx="354">
                  <c:v>9.0608677142857137E-5</c:v>
                </c:pt>
                <c:pt idx="355">
                  <c:v>8.9498097142857143E-5</c:v>
                </c:pt>
                <c:pt idx="356">
                  <c:v>8.8236048571428577E-5</c:v>
                </c:pt>
                <c:pt idx="357">
                  <c:v>8.6842751428571431E-5</c:v>
                </c:pt>
                <c:pt idx="358">
                  <c:v>8.5336488571428564E-5</c:v>
                </c:pt>
                <c:pt idx="359">
                  <c:v>8.3733174285714285E-5</c:v>
                </c:pt>
                <c:pt idx="360">
                  <c:v>8.2046257142857145E-5</c:v>
                </c:pt>
                <c:pt idx="361">
                  <c:v>8.0286811428571439E-5</c:v>
                </c:pt>
                <c:pt idx="362">
                  <c:v>7.8463868571428564E-5</c:v>
                </c:pt>
                <c:pt idx="363">
                  <c:v>7.6584860000000003E-5</c:v>
                </c:pt>
                <c:pt idx="364">
                  <c:v>7.4656159999999996E-5</c:v>
                </c:pt>
                <c:pt idx="365">
                  <c:v>7.2683660000000001E-5</c:v>
                </c:pt>
                <c:pt idx="366">
                  <c:v>7.0673305714285707E-5</c:v>
                </c:pt>
                <c:pt idx="367">
                  <c:v>6.8631582857142854E-5</c:v>
                </c:pt>
                <c:pt idx="368">
                  <c:v>6.6565900000000006E-5</c:v>
                </c:pt>
                <c:pt idx="369">
                  <c:v>6.4484868571428568E-5</c:v>
                </c:pt>
                <c:pt idx="370">
                  <c:v>6.2398448571428572E-5</c:v>
                </c:pt>
                <c:pt idx="371">
                  <c:v>6.0317974285714279E-5</c:v>
                </c:pt>
                <c:pt idx="372">
                  <c:v>5.8256085714285719E-5</c:v>
                </c:pt>
                <c:pt idx="373">
                  <c:v>5.6226565714285712E-5</c:v>
                </c:pt>
                <c:pt idx="374">
                  <c:v>5.4244119999999993E-5</c:v>
                </c:pt>
                <c:pt idx="375">
                  <c:v>5.232406285714286E-5</c:v>
                </c:pt>
                <c:pt idx="376">
                  <c:v>5.0482048571428572E-5</c:v>
                </c:pt>
                <c:pt idx="377">
                  <c:v>4.8733754285714288E-5</c:v>
                </c:pt>
                <c:pt idx="378">
                  <c:v>4.7094574285714286E-5</c:v>
                </c:pt>
                <c:pt idx="379">
                  <c:v>4.5579342857142855E-5</c:v>
                </c:pt>
                <c:pt idx="380">
                  <c:v>4.4202120000000003E-5</c:v>
                </c:pt>
                <c:pt idx="381">
                  <c:v>4.297596E-5</c:v>
                </c:pt>
                <c:pt idx="382">
                  <c:v>4.1912751428571433E-5</c:v>
                </c:pt>
                <c:pt idx="383">
                  <c:v>4.1023054285714287E-5</c:v>
                </c:pt>
                <c:pt idx="384">
                  <c:v>4.031602285714286E-5</c:v>
                </c:pt>
                <c:pt idx="385">
                  <c:v>3.9799257142857141E-5</c:v>
                </c:pt>
                <c:pt idx="386">
                  <c:v>3.9478748571428569E-5</c:v>
                </c:pt>
                <c:pt idx="387">
                  <c:v>3.935880571428572E-5</c:v>
                </c:pt>
                <c:pt idx="388">
                  <c:v>3.9441914285714287E-5</c:v>
                </c:pt>
                <c:pt idx="389">
                  <c:v>3.9728697142857144E-5</c:v>
                </c:pt>
                <c:pt idx="390">
                  <c:v>4.0217782857142852E-5</c:v>
                </c:pt>
                <c:pt idx="391">
                  <c:v>4.0905705714285717E-5</c:v>
                </c:pt>
                <c:pt idx="392">
                  <c:v>4.1786774285714289E-5</c:v>
                </c:pt>
                <c:pt idx="393">
                  <c:v>4.2852977142857143E-5</c:v>
                </c:pt>
                <c:pt idx="394">
                  <c:v>4.4093874285714286E-5</c:v>
                </c:pt>
                <c:pt idx="395">
                  <c:v>4.5496522857142855E-5</c:v>
                </c:pt>
                <c:pt idx="396">
                  <c:v>4.704537714285714E-5</c:v>
                </c:pt>
                <c:pt idx="397">
                  <c:v>4.8722345714285716E-5</c:v>
                </c:pt>
                <c:pt idx="398">
                  <c:v>5.0506782857142854E-5</c:v>
                </c:pt>
                <c:pt idx="399">
                  <c:v>5.2375602857142854E-5</c:v>
                </c:pt>
                <c:pt idx="400">
                  <c:v>5.4303485714285718E-5</c:v>
                </c:pt>
                <c:pt idx="401">
                  <c:v>5.6263094285714286E-5</c:v>
                </c:pt>
                <c:pt idx="402">
                  <c:v>5.8225434285714289E-5</c:v>
                </c:pt>
                <c:pt idx="403">
                  <c:v>6.0160257142857151E-5</c:v>
                </c:pt>
                <c:pt idx="404">
                  <c:v>6.2036545714285718E-5</c:v>
                </c:pt>
                <c:pt idx="405">
                  <c:v>6.3823077142857141E-5</c:v>
                </c:pt>
                <c:pt idx="406">
                  <c:v>6.548900857142857E-5</c:v>
                </c:pt>
                <c:pt idx="407">
                  <c:v>6.700451714285714E-5</c:v>
                </c:pt>
                <c:pt idx="408">
                  <c:v>6.8341454285714286E-5</c:v>
                </c:pt>
                <c:pt idx="409">
                  <c:v>6.9473968571428577E-5</c:v>
                </c:pt>
                <c:pt idx="410">
                  <c:v>7.037911714285714E-5</c:v>
                </c:pt>
                <c:pt idx="411">
                  <c:v>7.1037425714285714E-5</c:v>
                </c:pt>
                <c:pt idx="412">
                  <c:v>7.1433368571428564E-5</c:v>
                </c:pt>
                <c:pt idx="413">
                  <c:v>7.1555742857142853E-5</c:v>
                </c:pt>
                <c:pt idx="414">
                  <c:v>7.1397931428571432E-5</c:v>
                </c:pt>
                <c:pt idx="415">
                  <c:v>7.095808571428572E-5</c:v>
                </c:pt>
                <c:pt idx="416">
                  <c:v>7.0239102857142863E-5</c:v>
                </c:pt>
                <c:pt idx="417">
                  <c:v>6.9248545714285716E-5</c:v>
                </c:pt>
                <c:pt idx="418">
                  <c:v>6.7998394285714289E-5</c:v>
                </c:pt>
                <c:pt idx="419">
                  <c:v>6.6504699999999994E-5</c:v>
                </c:pt>
                <c:pt idx="420">
                  <c:v>6.4787114285714289E-5</c:v>
                </c:pt>
                <c:pt idx="421">
                  <c:v>6.2868357142857153E-5</c:v>
                </c:pt>
                <c:pt idx="422">
                  <c:v>6.0773597142857137E-5</c:v>
                </c:pt>
                <c:pt idx="423">
                  <c:v>5.852980571428571E-5</c:v>
                </c:pt>
                <c:pt idx="424">
                  <c:v>5.616507428571428E-5</c:v>
                </c:pt>
                <c:pt idx="425">
                  <c:v>5.3707954285714285E-5</c:v>
                </c:pt>
                <c:pt idx="426">
                  <c:v>5.118681142857143E-5</c:v>
                </c:pt>
                <c:pt idx="427">
                  <c:v>4.862922285714286E-5</c:v>
                </c:pt>
                <c:pt idx="428">
                  <c:v>4.6061451428571429E-5</c:v>
                </c:pt>
                <c:pt idx="429">
                  <c:v>4.3507965714285715E-5</c:v>
                </c:pt>
                <c:pt idx="430">
                  <c:v>4.0991091428571427E-5</c:v>
                </c:pt>
                <c:pt idx="431">
                  <c:v>3.853069428571428E-5</c:v>
                </c:pt>
                <c:pt idx="432">
                  <c:v>3.6144005714285719E-5</c:v>
                </c:pt>
                <c:pt idx="433">
                  <c:v>3.384550571428572E-5</c:v>
                </c:pt>
                <c:pt idx="434">
                  <c:v>3.1646905714285717E-5</c:v>
                </c:pt>
                <c:pt idx="435">
                  <c:v>2.9557202857142856E-5</c:v>
                </c:pt>
                <c:pt idx="436">
                  <c:v>2.7582774285714288E-5</c:v>
                </c:pt>
                <c:pt idx="437">
                  <c:v>2.572758857142857E-5</c:v>
                </c:pt>
                <c:pt idx="438">
                  <c:v>2.3993385714285712E-5</c:v>
                </c:pt>
                <c:pt idx="439">
                  <c:v>2.2379939999999998E-5</c:v>
                </c:pt>
                <c:pt idx="440">
                  <c:v>2.0885322857142856E-5</c:v>
                </c:pt>
                <c:pt idx="441">
                  <c:v>1.950616E-5</c:v>
                </c:pt>
                <c:pt idx="442">
                  <c:v>1.8237925714285715E-5</c:v>
                </c:pt>
                <c:pt idx="443">
                  <c:v>1.7075182857142858E-5</c:v>
                </c:pt>
                <c:pt idx="444">
                  <c:v>1.6011834285714284E-5</c:v>
                </c:pt>
                <c:pt idx="445">
                  <c:v>1.5041351428571428E-5</c:v>
                </c:pt>
                <c:pt idx="446">
                  <c:v>1.415696857142857E-5</c:v>
                </c:pt>
                <c:pt idx="447">
                  <c:v>1.3351862857142856E-5</c:v>
                </c:pt>
                <c:pt idx="448">
                  <c:v>1.2619277142857143E-5</c:v>
                </c:pt>
                <c:pt idx="449">
                  <c:v>1.1952668571428571E-5</c:v>
                </c:pt>
                <c:pt idx="450">
                  <c:v>1.1345788571428572E-5</c:v>
                </c:pt>
                <c:pt idx="451">
                  <c:v>1.0792742857142857E-5</c:v>
                </c:pt>
                <c:pt idx="452">
                  <c:v>1.0288045714285714E-5</c:v>
                </c:pt>
                <c:pt idx="453">
                  <c:v>9.826657142857144E-6</c:v>
                </c:pt>
                <c:pt idx="454">
                  <c:v>9.4039800000000004E-6</c:v>
                </c:pt>
                <c:pt idx="455">
                  <c:v>9.0158685714285724E-6</c:v>
                </c:pt>
                <c:pt idx="456">
                  <c:v>8.6586142857142847E-6</c:v>
                </c:pt>
                <c:pt idx="457">
                  <c:v>8.3289228571428574E-6</c:v>
                </c:pt>
                <c:pt idx="458">
                  <c:v>8.0238942857142858E-6</c:v>
                </c:pt>
                <c:pt idx="459">
                  <c:v>7.7409828571428581E-6</c:v>
                </c:pt>
                <c:pt idx="460">
                  <c:v>7.477974285714286E-6</c:v>
                </c:pt>
                <c:pt idx="461">
                  <c:v>7.2329514285714292E-6</c:v>
                </c:pt>
                <c:pt idx="462">
                  <c:v>7.0042514285714292E-6</c:v>
                </c:pt>
                <c:pt idx="463">
                  <c:v>6.7904428571428565E-6</c:v>
                </c:pt>
                <c:pt idx="464">
                  <c:v>6.5902942857142857E-6</c:v>
                </c:pt>
                <c:pt idx="465">
                  <c:v>6.4027514285714282E-6</c:v>
                </c:pt>
                <c:pt idx="466">
                  <c:v>6.2268971428571428E-6</c:v>
                </c:pt>
                <c:pt idx="467">
                  <c:v>6.061934285714286E-6</c:v>
                </c:pt>
                <c:pt idx="468">
                  <c:v>5.9071771428571434E-6</c:v>
                </c:pt>
                <c:pt idx="469">
                  <c:v>5.7620199999999998E-6</c:v>
                </c:pt>
                <c:pt idx="470">
                  <c:v>5.6259228571428572E-6</c:v>
                </c:pt>
                <c:pt idx="471">
                  <c:v>5.4984085714285712E-6</c:v>
                </c:pt>
                <c:pt idx="472">
                  <c:v>5.3790399999999999E-6</c:v>
                </c:pt>
                <c:pt idx="473">
                  <c:v>5.2674228571428572E-6</c:v>
                </c:pt>
                <c:pt idx="474">
                  <c:v>5.1631857142857148E-6</c:v>
                </c:pt>
                <c:pt idx="475">
                  <c:v>5.065988571428572E-6</c:v>
                </c:pt>
                <c:pt idx="476">
                  <c:v>4.9755057142857146E-6</c:v>
                </c:pt>
                <c:pt idx="477">
                  <c:v>4.891434285714286E-6</c:v>
                </c:pt>
                <c:pt idx="478">
                  <c:v>4.8134685714285709E-6</c:v>
                </c:pt>
                <c:pt idx="479">
                  <c:v>4.7413314285714287E-6</c:v>
                </c:pt>
                <c:pt idx="480">
                  <c:v>4.6747514285714289E-6</c:v>
                </c:pt>
                <c:pt idx="481">
                  <c:v>4.613471428571428E-6</c:v>
                </c:pt>
                <c:pt idx="482">
                  <c:v>4.557231428571429E-6</c:v>
                </c:pt>
                <c:pt idx="483">
                  <c:v>4.5057857142857141E-6</c:v>
                </c:pt>
                <c:pt idx="484">
                  <c:v>4.4589114285714281E-6</c:v>
                </c:pt>
                <c:pt idx="485">
                  <c:v>4.4163771428571432E-6</c:v>
                </c:pt>
                <c:pt idx="486">
                  <c:v>4.3779657142857137E-6</c:v>
                </c:pt>
                <c:pt idx="487">
                  <c:v>4.343471428571428E-6</c:v>
                </c:pt>
                <c:pt idx="488">
                  <c:v>4.3127028571428571E-6</c:v>
                </c:pt>
                <c:pt idx="489">
                  <c:v>4.2854714285714279E-6</c:v>
                </c:pt>
                <c:pt idx="490">
                  <c:v>4.2616028571428568E-6</c:v>
                </c:pt>
                <c:pt idx="491">
                  <c:v>4.2409314285714292E-6</c:v>
                </c:pt>
                <c:pt idx="492">
                  <c:v>4.223297142857143E-6</c:v>
                </c:pt>
                <c:pt idx="493">
                  <c:v>4.2085571428571427E-6</c:v>
                </c:pt>
                <c:pt idx="494">
                  <c:v>4.1965771428571432E-6</c:v>
                </c:pt>
                <c:pt idx="495">
                  <c:v>4.1872228571428569E-6</c:v>
                </c:pt>
                <c:pt idx="496">
                  <c:v>4.1803857142857147E-6</c:v>
                </c:pt>
                <c:pt idx="497">
                  <c:v>4.1759485714285718E-6</c:v>
                </c:pt>
                <c:pt idx="498">
                  <c:v>4.1738199999999995E-6</c:v>
                </c:pt>
                <c:pt idx="499">
                  <c:v>4.1739028571428568E-6</c:v>
                </c:pt>
                <c:pt idx="500">
                  <c:v>4.1761085714285711E-6</c:v>
                </c:pt>
                <c:pt idx="501">
                  <c:v>4.1803628571428573E-6</c:v>
                </c:pt>
                <c:pt idx="502">
                  <c:v>4.186597142857143E-6</c:v>
                </c:pt>
                <c:pt idx="503">
                  <c:v>4.1947400000000001E-6</c:v>
                </c:pt>
                <c:pt idx="504">
                  <c:v>4.20474E-6</c:v>
                </c:pt>
                <c:pt idx="505">
                  <c:v>4.2165457142857142E-6</c:v>
                </c:pt>
                <c:pt idx="506">
                  <c:v>4.2301000000000004E-6</c:v>
                </c:pt>
                <c:pt idx="507">
                  <c:v>4.2453628571428566E-6</c:v>
                </c:pt>
                <c:pt idx="508">
                  <c:v>4.2622942857142861E-6</c:v>
                </c:pt>
                <c:pt idx="509">
                  <c:v>4.2808599999999997E-6</c:v>
                </c:pt>
                <c:pt idx="510">
                  <c:v>4.301028571428572E-6</c:v>
                </c:pt>
                <c:pt idx="511">
                  <c:v>4.3227600000000001E-6</c:v>
                </c:pt>
                <c:pt idx="512">
                  <c:v>4.3460314285714292E-6</c:v>
                </c:pt>
                <c:pt idx="513">
                  <c:v>4.3708228571428571E-6</c:v>
                </c:pt>
                <c:pt idx="514">
                  <c:v>4.3971028571428575E-6</c:v>
                </c:pt>
                <c:pt idx="515">
                  <c:v>4.4248571428571426E-6</c:v>
                </c:pt>
                <c:pt idx="516">
                  <c:v>4.4540542857142854E-6</c:v>
                </c:pt>
                <c:pt idx="517">
                  <c:v>4.4846885714285713E-6</c:v>
                </c:pt>
                <c:pt idx="518">
                  <c:v>4.5167285714285714E-6</c:v>
                </c:pt>
                <c:pt idx="519">
                  <c:v>4.5501657142857144E-6</c:v>
                </c:pt>
                <c:pt idx="520">
                  <c:v>4.584974285714285E-6</c:v>
                </c:pt>
                <c:pt idx="521">
                  <c:v>4.6211428571428576E-6</c:v>
                </c:pt>
                <c:pt idx="522">
                  <c:v>4.6586457142857146E-6</c:v>
                </c:pt>
                <c:pt idx="523">
                  <c:v>4.6974742857142852E-6</c:v>
                </c:pt>
                <c:pt idx="524">
                  <c:v>4.7376085714285716E-6</c:v>
                </c:pt>
                <c:pt idx="525">
                  <c:v>4.7790257142857146E-6</c:v>
                </c:pt>
                <c:pt idx="526">
                  <c:v>4.8217114285714282E-6</c:v>
                </c:pt>
                <c:pt idx="527">
                  <c:v>4.8656428571428576E-6</c:v>
                </c:pt>
                <c:pt idx="528">
                  <c:v>4.9107971428571428E-6</c:v>
                </c:pt>
                <c:pt idx="529">
                  <c:v>4.957165714285714E-6</c:v>
                </c:pt>
                <c:pt idx="530">
                  <c:v>5.0047057142857143E-6</c:v>
                </c:pt>
                <c:pt idx="531">
                  <c:v>5.0534142857142857E-6</c:v>
                </c:pt>
                <c:pt idx="532">
                  <c:v>5.1032485714285714E-6</c:v>
                </c:pt>
                <c:pt idx="533">
                  <c:v>5.154194285714286E-6</c:v>
                </c:pt>
                <c:pt idx="534">
                  <c:v>5.2062199999999999E-6</c:v>
                </c:pt>
                <c:pt idx="535">
                  <c:v>5.2592971428571429E-6</c:v>
                </c:pt>
                <c:pt idx="536">
                  <c:v>5.313397142857143E-6</c:v>
                </c:pt>
                <c:pt idx="537">
                  <c:v>5.3684800000000006E-6</c:v>
                </c:pt>
                <c:pt idx="538">
                  <c:v>5.42452E-6</c:v>
                </c:pt>
                <c:pt idx="539">
                  <c:v>5.4814771428571434E-6</c:v>
                </c:pt>
                <c:pt idx="540">
                  <c:v>5.5393171428571425E-6</c:v>
                </c:pt>
                <c:pt idx="541">
                  <c:v>5.5979942857142859E-6</c:v>
                </c:pt>
                <c:pt idx="542">
                  <c:v>5.6574771428571431E-6</c:v>
                </c:pt>
                <c:pt idx="543">
                  <c:v>5.7177171428571423E-6</c:v>
                </c:pt>
                <c:pt idx="544">
                  <c:v>5.7786828571428574E-6</c:v>
                </c:pt>
                <c:pt idx="545">
                  <c:v>5.8403171428571426E-6</c:v>
                </c:pt>
                <c:pt idx="546">
                  <c:v>5.9025857142857149E-6</c:v>
                </c:pt>
                <c:pt idx="547">
                  <c:v>5.9654457142857145E-6</c:v>
                </c:pt>
                <c:pt idx="548">
                  <c:v>6.0288571428571429E-6</c:v>
                </c:pt>
                <c:pt idx="549">
                  <c:v>6.0927828571428575E-6</c:v>
                </c:pt>
                <c:pt idx="550">
                  <c:v>6.1571885714285718E-6</c:v>
                </c:pt>
                <c:pt idx="551">
                  <c:v>6.2220542857142853E-6</c:v>
                </c:pt>
                <c:pt idx="552">
                  <c:v>6.2873628571428567E-6</c:v>
                </c:pt>
                <c:pt idx="553">
                  <c:v>6.3531257142857145E-6</c:v>
                </c:pt>
                <c:pt idx="554">
                  <c:v>6.4193599999999996E-6</c:v>
                </c:pt>
                <c:pt idx="555">
                  <c:v>6.4861171428571425E-6</c:v>
                </c:pt>
                <c:pt idx="556">
                  <c:v>6.5534857142857149E-6</c:v>
                </c:pt>
                <c:pt idx="557">
                  <c:v>6.621588571428572E-6</c:v>
                </c:pt>
                <c:pt idx="558">
                  <c:v>6.6906199999999996E-6</c:v>
                </c:pt>
                <c:pt idx="559">
                  <c:v>6.7608285714285708E-6</c:v>
                </c:pt>
                <c:pt idx="560">
                  <c:v>6.8325685714285716E-6</c:v>
                </c:pt>
                <c:pt idx="561">
                  <c:v>6.9062914285714288E-6</c:v>
                </c:pt>
                <c:pt idx="562">
                  <c:v>6.982565714285715E-6</c:v>
                </c:pt>
                <c:pt idx="563">
                  <c:v>7.0621285714285708E-6</c:v>
                </c:pt>
                <c:pt idx="564">
                  <c:v>7.1458914285714291E-6</c:v>
                </c:pt>
                <c:pt idx="565">
                  <c:v>7.2349685714285722E-6</c:v>
                </c:pt>
                <c:pt idx="566">
                  <c:v>7.3307228571428565E-6</c:v>
                </c:pt>
                <c:pt idx="567">
                  <c:v>7.4347742857142861E-6</c:v>
                </c:pt>
                <c:pt idx="568">
                  <c:v>7.5490514285714294E-6</c:v>
                </c:pt>
                <c:pt idx="569">
                  <c:v>7.6758142857142863E-6</c:v>
                </c:pt>
                <c:pt idx="570">
                  <c:v>7.8176685714285726E-6</c:v>
                </c:pt>
                <c:pt idx="571">
                  <c:v>7.9776114285714288E-6</c:v>
                </c:pt>
                <c:pt idx="572">
                  <c:v>8.159019999999999E-6</c:v>
                </c:pt>
                <c:pt idx="573">
                  <c:v>8.3656628571428577E-6</c:v>
                </c:pt>
                <c:pt idx="574">
                  <c:v>8.6017057142857147E-6</c:v>
                </c:pt>
                <c:pt idx="575">
                  <c:v>8.8716571428571438E-6</c:v>
                </c:pt>
                <c:pt idx="576">
                  <c:v>9.1803714285714291E-6</c:v>
                </c:pt>
                <c:pt idx="577">
                  <c:v>9.5329457142857129E-6</c:v>
                </c:pt>
                <c:pt idx="578">
                  <c:v>9.9346742857142865E-6</c:v>
                </c:pt>
                <c:pt idx="579">
                  <c:v>1.0390934285714285E-5</c:v>
                </c:pt>
                <c:pt idx="580">
                  <c:v>1.0907062857142858E-5</c:v>
                </c:pt>
                <c:pt idx="581">
                  <c:v>1.1488217142857142E-5</c:v>
                </c:pt>
                <c:pt idx="582">
                  <c:v>1.2139214285714285E-5</c:v>
                </c:pt>
                <c:pt idx="583">
                  <c:v>1.286435142857143E-5</c:v>
                </c:pt>
                <c:pt idx="584">
                  <c:v>1.3667217142857143E-5</c:v>
                </c:pt>
                <c:pt idx="585">
                  <c:v>1.4550502857142859E-5</c:v>
                </c:pt>
                <c:pt idx="586">
                  <c:v>1.5515797142857141E-5</c:v>
                </c:pt>
                <c:pt idx="587">
                  <c:v>1.6563394285714284E-5</c:v>
                </c:pt>
                <c:pt idx="588">
                  <c:v>1.7692128571428572E-5</c:v>
                </c:pt>
                <c:pt idx="589">
                  <c:v>1.8899225714285715E-5</c:v>
                </c:pt>
                <c:pt idx="590">
                  <c:v>2.0180165714285715E-5</c:v>
                </c:pt>
                <c:pt idx="591">
                  <c:v>2.1528617142857144E-5</c:v>
                </c:pt>
                <c:pt idx="592">
                  <c:v>2.2936379999999998E-5</c:v>
                </c:pt>
                <c:pt idx="593">
                  <c:v>2.4393420000000001E-5</c:v>
                </c:pt>
                <c:pt idx="594">
                  <c:v>2.5887908571428574E-5</c:v>
                </c:pt>
                <c:pt idx="595">
                  <c:v>2.7406374285714287E-5</c:v>
                </c:pt>
                <c:pt idx="596">
                  <c:v>2.8933859999999998E-5</c:v>
                </c:pt>
                <c:pt idx="597">
                  <c:v>3.0454159999999998E-5</c:v>
                </c:pt>
                <c:pt idx="598">
                  <c:v>3.1950125714285713E-5</c:v>
                </c:pt>
                <c:pt idx="599">
                  <c:v>3.3403954285714284E-5</c:v>
                </c:pt>
                <c:pt idx="600">
                  <c:v>3.4797579999999999E-5</c:v>
                </c:pt>
                <c:pt idx="601">
                  <c:v>3.6113042857142861E-5</c:v>
                </c:pt>
                <c:pt idx="602">
                  <c:v>3.7332877142857141E-5</c:v>
                </c:pt>
                <c:pt idx="603">
                  <c:v>3.8440531428571428E-5</c:v>
                </c:pt>
                <c:pt idx="604">
                  <c:v>3.9420725714285715E-5</c:v>
                </c:pt>
                <c:pt idx="605">
                  <c:v>4.0259808571428571E-5</c:v>
                </c:pt>
                <c:pt idx="606">
                  <c:v>4.094608857142857E-5</c:v>
                </c:pt>
                <c:pt idx="607">
                  <c:v>4.1470085714285714E-5</c:v>
                </c:pt>
                <c:pt idx="608">
                  <c:v>4.1824768571428571E-5</c:v>
                </c:pt>
                <c:pt idx="609">
                  <c:v>4.2005665714285714E-5</c:v>
                </c:pt>
                <c:pt idx="610">
                  <c:v>4.2010982857142854E-5</c:v>
                </c:pt>
                <c:pt idx="611">
                  <c:v>4.184160857142857E-5</c:v>
                </c:pt>
                <c:pt idx="612">
                  <c:v>4.1501040000000004E-5</c:v>
                </c:pt>
                <c:pt idx="613">
                  <c:v>4.0995285714285716E-5</c:v>
                </c:pt>
                <c:pt idx="614">
                  <c:v>4.033268E-5</c:v>
                </c:pt>
                <c:pt idx="615">
                  <c:v>3.9523640000000005E-5</c:v>
                </c:pt>
                <c:pt idx="616">
                  <c:v>3.8580417142857149E-5</c:v>
                </c:pt>
                <c:pt idx="617">
                  <c:v>3.7516757142857143E-5</c:v>
                </c:pt>
                <c:pt idx="618">
                  <c:v>3.6347605714285718E-5</c:v>
                </c:pt>
                <c:pt idx="619">
                  <c:v>3.5088740000000004E-5</c:v>
                </c:pt>
                <c:pt idx="620">
                  <c:v>3.3756437142857143E-5</c:v>
                </c:pt>
                <c:pt idx="621">
                  <c:v>3.2367145714285714E-5</c:v>
                </c:pt>
                <c:pt idx="622">
                  <c:v>3.0937151428571429E-5</c:v>
                </c:pt>
                <c:pt idx="623">
                  <c:v>2.9482317142857145E-5</c:v>
                </c:pt>
                <c:pt idx="624">
                  <c:v>2.8017788571428571E-5</c:v>
                </c:pt>
                <c:pt idx="625">
                  <c:v>2.6557794285714281E-5</c:v>
                </c:pt>
                <c:pt idx="626">
                  <c:v>2.5115462857142858E-5</c:v>
                </c:pt>
                <c:pt idx="627">
                  <c:v>2.370266857142857E-5</c:v>
                </c:pt>
                <c:pt idx="628">
                  <c:v>2.2329937142857144E-5</c:v>
                </c:pt>
                <c:pt idx="629">
                  <c:v>2.1006385714285712E-5</c:v>
                </c:pt>
                <c:pt idx="630">
                  <c:v>1.973969714285714E-5</c:v>
                </c:pt>
                <c:pt idx="631">
                  <c:v>1.8536131428571429E-5</c:v>
                </c:pt>
                <c:pt idx="632">
                  <c:v>1.7400577142857142E-5</c:v>
                </c:pt>
                <c:pt idx="633">
                  <c:v>1.6336591428571428E-5</c:v>
                </c:pt>
                <c:pt idx="634">
                  <c:v>1.5346517142857144E-5</c:v>
                </c:pt>
                <c:pt idx="635">
                  <c:v>1.4431574285714284E-5</c:v>
                </c:pt>
                <c:pt idx="636">
                  <c:v>1.3591971428571429E-5</c:v>
                </c:pt>
                <c:pt idx="637">
                  <c:v>1.2827034285714285E-5</c:v>
                </c:pt>
                <c:pt idx="638">
                  <c:v>1.2135331428571428E-5</c:v>
                </c:pt>
                <c:pt idx="639">
                  <c:v>1.1514797142857143E-5</c:v>
                </c:pt>
                <c:pt idx="640">
                  <c:v>1.0962845714285714E-5</c:v>
                </c:pt>
                <c:pt idx="641">
                  <c:v>1.04765E-5</c:v>
                </c:pt>
                <c:pt idx="642">
                  <c:v>1.0052480000000001E-5</c:v>
                </c:pt>
                <c:pt idx="643">
                  <c:v>9.6873171428571424E-6</c:v>
                </c:pt>
                <c:pt idx="644">
                  <c:v>9.3774199999999991E-6</c:v>
                </c:pt>
                <c:pt idx="645">
                  <c:v>9.1191600000000013E-6</c:v>
                </c:pt>
                <c:pt idx="646">
                  <c:v>8.9089371428571429E-6</c:v>
                </c:pt>
                <c:pt idx="647">
                  <c:v>8.7432085714285718E-6</c:v>
                </c:pt>
                <c:pt idx="648">
                  <c:v>8.618568571428572E-6</c:v>
                </c:pt>
                <c:pt idx="649">
                  <c:v>8.5317457142857131E-6</c:v>
                </c:pt>
                <c:pt idx="650">
                  <c:v>8.4796285714285712E-6</c:v>
                </c:pt>
                <c:pt idx="651">
                  <c:v>8.4592971428571436E-6</c:v>
                </c:pt>
                <c:pt idx="652">
                  <c:v>8.4680085714285715E-6</c:v>
                </c:pt>
                <c:pt idx="653">
                  <c:v>8.5032228571428567E-6</c:v>
                </c:pt>
                <c:pt idx="654">
                  <c:v>8.5625742857142866E-6</c:v>
                </c:pt>
                <c:pt idx="655">
                  <c:v>8.6438828571428575E-6</c:v>
                </c:pt>
                <c:pt idx="656">
                  <c:v>8.7451285714285706E-6</c:v>
                </c:pt>
                <c:pt idx="657">
                  <c:v>8.8644514285714296E-6</c:v>
                </c:pt>
                <c:pt idx="658">
                  <c:v>9.0001342857142844E-6</c:v>
                </c:pt>
                <c:pt idx="659">
                  <c:v>9.1505771428571435E-6</c:v>
                </c:pt>
                <c:pt idx="660">
                  <c:v>9.3143057142857136E-6</c:v>
                </c:pt>
                <c:pt idx="661">
                  <c:v>9.4899314285714275E-6</c:v>
                </c:pt>
                <c:pt idx="662">
                  <c:v>9.6761542857142858E-6</c:v>
                </c:pt>
                <c:pt idx="663">
                  <c:v>9.8717457142857138E-6</c:v>
                </c:pt>
                <c:pt idx="664">
                  <c:v>1.0075531428571427E-5</c:v>
                </c:pt>
                <c:pt idx="665">
                  <c:v>1.0286388571428571E-5</c:v>
                </c:pt>
                <c:pt idx="666">
                  <c:v>1.0503228571428572E-5</c:v>
                </c:pt>
                <c:pt idx="667">
                  <c:v>1.0724991428571429E-5</c:v>
                </c:pt>
                <c:pt idx="668">
                  <c:v>1.0950645714285713E-5</c:v>
                </c:pt>
                <c:pt idx="669">
                  <c:v>1.1179171428571429E-5</c:v>
                </c:pt>
                <c:pt idx="670">
                  <c:v>1.1409560000000001E-5</c:v>
                </c:pt>
                <c:pt idx="671">
                  <c:v>1.164082E-5</c:v>
                </c:pt>
                <c:pt idx="672">
                  <c:v>1.1871954285714286E-5</c:v>
                </c:pt>
                <c:pt idx="673">
                  <c:v>1.2101988571428571E-5</c:v>
                </c:pt>
                <c:pt idx="674">
                  <c:v>1.232994E-5</c:v>
                </c:pt>
                <c:pt idx="675">
                  <c:v>1.2554837142857143E-5</c:v>
                </c:pt>
                <c:pt idx="676">
                  <c:v>1.2775722857142857E-5</c:v>
                </c:pt>
                <c:pt idx="677">
                  <c:v>1.2991634285714285E-5</c:v>
                </c:pt>
                <c:pt idx="678">
                  <c:v>1.3201637142857143E-5</c:v>
                </c:pt>
                <c:pt idx="679">
                  <c:v>1.3404805714285715E-5</c:v>
                </c:pt>
                <c:pt idx="680">
                  <c:v>1.3600234285714285E-5</c:v>
                </c:pt>
                <c:pt idx="681">
                  <c:v>1.378704E-5</c:v>
                </c:pt>
                <c:pt idx="682">
                  <c:v>1.3964362857142855E-5</c:v>
                </c:pt>
                <c:pt idx="683">
                  <c:v>1.4131377142857143E-5</c:v>
                </c:pt>
                <c:pt idx="684">
                  <c:v>1.4287291428571427E-5</c:v>
                </c:pt>
                <c:pt idx="685">
                  <c:v>1.4431345714285713E-5</c:v>
                </c:pt>
                <c:pt idx="686">
                  <c:v>1.4562825714285716E-5</c:v>
                </c:pt>
                <c:pt idx="687">
                  <c:v>1.4681071428571429E-5</c:v>
                </c:pt>
                <c:pt idx="688">
                  <c:v>1.4785462857142857E-5</c:v>
                </c:pt>
                <c:pt idx="689">
                  <c:v>1.4875431428571429E-5</c:v>
                </c:pt>
                <c:pt idx="690">
                  <c:v>1.4950462857142856E-5</c:v>
                </c:pt>
                <c:pt idx="691">
                  <c:v>1.5010120000000002E-5</c:v>
                </c:pt>
                <c:pt idx="692">
                  <c:v>1.5054E-5</c:v>
                </c:pt>
                <c:pt idx="693">
                  <c:v>1.5081782857142857E-5</c:v>
                </c:pt>
                <c:pt idx="694">
                  <c:v>1.5093205714285713E-5</c:v>
                </c:pt>
                <c:pt idx="695">
                  <c:v>1.5088079999999999E-5</c:v>
                </c:pt>
                <c:pt idx="696">
                  <c:v>1.5066268571428571E-5</c:v>
                </c:pt>
                <c:pt idx="697">
                  <c:v>1.5027711428571428E-5</c:v>
                </c:pt>
                <c:pt idx="698">
                  <c:v>1.4972422857142857E-5</c:v>
                </c:pt>
                <c:pt idx="699">
                  <c:v>1.4900482857142858E-5</c:v>
                </c:pt>
                <c:pt idx="700">
                  <c:v>1.4812020000000001E-5</c:v>
                </c:pt>
                <c:pt idx="701">
                  <c:v>1.4707257142857143E-5</c:v>
                </c:pt>
                <c:pt idx="702">
                  <c:v>1.4586462857142856E-5</c:v>
                </c:pt>
                <c:pt idx="703">
                  <c:v>1.444996857142857E-5</c:v>
                </c:pt>
                <c:pt idx="704">
                  <c:v>1.4298174285714285E-5</c:v>
                </c:pt>
                <c:pt idx="705">
                  <c:v>1.4131525714285715E-5</c:v>
                </c:pt>
                <c:pt idx="706">
                  <c:v>1.3950534285714285E-5</c:v>
                </c:pt>
                <c:pt idx="707">
                  <c:v>1.3755754285714287E-5</c:v>
                </c:pt>
                <c:pt idx="708">
                  <c:v>1.3547794285714286E-5</c:v>
                </c:pt>
                <c:pt idx="709">
                  <c:v>1.3327294285714287E-5</c:v>
                </c:pt>
                <c:pt idx="710">
                  <c:v>1.3094948571428571E-5</c:v>
                </c:pt>
                <c:pt idx="711">
                  <c:v>1.2851474285714285E-5</c:v>
                </c:pt>
                <c:pt idx="712">
                  <c:v>1.2597625714285715E-5</c:v>
                </c:pt>
                <c:pt idx="713">
                  <c:v>1.2334185714285715E-5</c:v>
                </c:pt>
                <c:pt idx="714">
                  <c:v>1.206194857142857E-5</c:v>
                </c:pt>
                <c:pt idx="715">
                  <c:v>1.1781737142857142E-5</c:v>
                </c:pt>
                <c:pt idx="716">
                  <c:v>1.1494382857142857E-5</c:v>
                </c:pt>
                <c:pt idx="717">
                  <c:v>1.1200717142857142E-5</c:v>
                </c:pt>
                <c:pt idx="718">
                  <c:v>1.0901594285714285E-5</c:v>
                </c:pt>
                <c:pt idx="719">
                  <c:v>1.059784857142857E-5</c:v>
                </c:pt>
                <c:pt idx="720">
                  <c:v>1.029032E-5</c:v>
                </c:pt>
                <c:pt idx="721">
                  <c:v>9.9798342857142846E-6</c:v>
                </c:pt>
                <c:pt idx="722">
                  <c:v>9.6672114285714287E-6</c:v>
                </c:pt>
                <c:pt idx="723">
                  <c:v>9.3532485714285705E-6</c:v>
                </c:pt>
                <c:pt idx="724">
                  <c:v>9.0387285714285707E-6</c:v>
                </c:pt>
                <c:pt idx="725">
                  <c:v>8.7244000000000007E-6</c:v>
                </c:pt>
                <c:pt idx="726">
                  <c:v>8.4109999999999996E-6</c:v>
                </c:pt>
                <c:pt idx="727">
                  <c:v>8.0992314285714275E-6</c:v>
                </c:pt>
                <c:pt idx="728">
                  <c:v>7.7897600000000001E-6</c:v>
                </c:pt>
                <c:pt idx="729">
                  <c:v>7.4832228571428572E-6</c:v>
                </c:pt>
                <c:pt idx="730">
                  <c:v>7.1802257142857137E-6</c:v>
                </c:pt>
                <c:pt idx="731">
                  <c:v>6.8813371428571422E-6</c:v>
                </c:pt>
                <c:pt idx="732">
                  <c:v>6.5870800000000003E-6</c:v>
                </c:pt>
                <c:pt idx="733">
                  <c:v>6.2979457142857143E-6</c:v>
                </c:pt>
                <c:pt idx="734">
                  <c:v>6.0143828571428575E-6</c:v>
                </c:pt>
                <c:pt idx="735">
                  <c:v>5.7368028571428567E-6</c:v>
                </c:pt>
                <c:pt idx="736">
                  <c:v>5.4655800000000001E-6</c:v>
                </c:pt>
                <c:pt idx="737">
                  <c:v>5.2010371428571432E-6</c:v>
                </c:pt>
                <c:pt idx="738">
                  <c:v>4.9434714285714282E-6</c:v>
                </c:pt>
                <c:pt idx="739">
                  <c:v>4.693128571428572E-6</c:v>
                </c:pt>
                <c:pt idx="740">
                  <c:v>4.4502285714285722E-6</c:v>
                </c:pt>
                <c:pt idx="741">
                  <c:v>4.2149457142857141E-6</c:v>
                </c:pt>
                <c:pt idx="742">
                  <c:v>3.9874199999999998E-6</c:v>
                </c:pt>
                <c:pt idx="743">
                  <c:v>3.7677542857142858E-6</c:v>
                </c:pt>
                <c:pt idx="744">
                  <c:v>3.5560257142857146E-6</c:v>
                </c:pt>
                <c:pt idx="745">
                  <c:v>3.3522714285714281E-6</c:v>
                </c:pt>
                <c:pt idx="746">
                  <c:v>3.156502857142857E-6</c:v>
                </c:pt>
                <c:pt idx="747">
                  <c:v>2.9687028571428569E-6</c:v>
                </c:pt>
                <c:pt idx="748">
                  <c:v>2.7888228571428573E-6</c:v>
                </c:pt>
                <c:pt idx="749">
                  <c:v>2.6167971428571428E-6</c:v>
                </c:pt>
                <c:pt idx="750">
                  <c:v>2.4525285714285714E-6</c:v>
                </c:pt>
                <c:pt idx="751">
                  <c:v>2.295905714285714E-6</c:v>
                </c:pt>
                <c:pt idx="752">
                  <c:v>2.1467971428571431E-6</c:v>
                </c:pt>
                <c:pt idx="753">
                  <c:v>2.0050485714285715E-6</c:v>
                </c:pt>
                <c:pt idx="754">
                  <c:v>1.8704971428571429E-6</c:v>
                </c:pt>
                <c:pt idx="755">
                  <c:v>1.7429599999999998E-6</c:v>
                </c:pt>
                <c:pt idx="756">
                  <c:v>1.6222485714285714E-6</c:v>
                </c:pt>
                <c:pt idx="757">
                  <c:v>1.508162857142857E-6</c:v>
                </c:pt>
                <c:pt idx="758">
                  <c:v>1.4004857142857144E-6</c:v>
                </c:pt>
                <c:pt idx="759">
                  <c:v>1.299002857142857E-6</c:v>
                </c:pt>
                <c:pt idx="760">
                  <c:v>1.2034971428571429E-6</c:v>
                </c:pt>
                <c:pt idx="761">
                  <c:v>1.1137371428571428E-6</c:v>
                </c:pt>
                <c:pt idx="762">
                  <c:v>1.0294942857142857E-6</c:v>
                </c:pt>
                <c:pt idx="763">
                  <c:v>9.5053714285714281E-7</c:v>
                </c:pt>
                <c:pt idx="764">
                  <c:v>8.766342857142858E-7</c:v>
                </c:pt>
                <c:pt idx="765">
                  <c:v>8.0756285714285714E-7</c:v>
                </c:pt>
                <c:pt idx="766">
                  <c:v>7.4308857142857143E-7</c:v>
                </c:pt>
                <c:pt idx="767">
                  <c:v>6.8298285714285712E-7</c:v>
                </c:pt>
                <c:pt idx="768">
                  <c:v>6.2703142857142861E-7</c:v>
                </c:pt>
                <c:pt idx="769">
                  <c:v>5.750114285714286E-7</c:v>
                </c:pt>
                <c:pt idx="770">
                  <c:v>5.2671428571428564E-7</c:v>
                </c:pt>
                <c:pt idx="771">
                  <c:v>4.8192571428571426E-7</c:v>
                </c:pt>
                <c:pt idx="772">
                  <c:v>4.4045428571428577E-7</c:v>
                </c:pt>
                <c:pt idx="773">
                  <c:v>4.0209714285714286E-7</c:v>
                </c:pt>
                <c:pt idx="774">
                  <c:v>3.6667142857142858E-7</c:v>
                </c:pt>
                <c:pt idx="775">
                  <c:v>3.339885714285714E-7</c:v>
                </c:pt>
                <c:pt idx="776">
                  <c:v>3.0387999999999999E-7</c:v>
                </c:pt>
                <c:pt idx="777">
                  <c:v>2.7617714285714285E-7</c:v>
                </c:pt>
                <c:pt idx="778">
                  <c:v>2.5072285714285713E-7</c:v>
                </c:pt>
                <c:pt idx="779">
                  <c:v>2.2735714285714284E-7</c:v>
                </c:pt>
                <c:pt idx="780">
                  <c:v>2.0594285714285715E-7</c:v>
                </c:pt>
                <c:pt idx="781">
                  <c:v>1.8633714285714286E-7</c:v>
                </c:pt>
                <c:pt idx="782">
                  <c:v>1.6841428571428572E-7</c:v>
                </c:pt>
                <c:pt idx="783">
                  <c:v>1.5204285714285713E-7</c:v>
                </c:pt>
                <c:pt idx="784">
                  <c:v>1.371142857142857E-7</c:v>
                </c:pt>
                <c:pt idx="785">
                  <c:v>1.2351428571428571E-7</c:v>
                </c:pt>
                <c:pt idx="786">
                  <c:v>1.1114000000000001E-7</c:v>
                </c:pt>
                <c:pt idx="787">
                  <c:v>9.9897142857142851E-8</c:v>
                </c:pt>
                <c:pt idx="788">
                  <c:v>8.9694285714285716E-8</c:v>
                </c:pt>
                <c:pt idx="789">
                  <c:v>8.0442857142857148E-8</c:v>
                </c:pt>
                <c:pt idx="790">
                  <c:v>7.2068571428571434E-8</c:v>
                </c:pt>
                <c:pt idx="791">
                  <c:v>6.4497142857142852E-8</c:v>
                </c:pt>
                <c:pt idx="792">
                  <c:v>5.7654285714285708E-8</c:v>
                </c:pt>
                <c:pt idx="793">
                  <c:v>5.1482857142857145E-8</c:v>
                </c:pt>
                <c:pt idx="794">
                  <c:v>4.5922857142857147E-8</c:v>
                </c:pt>
                <c:pt idx="795">
                  <c:v>4.0919999999999998E-8</c:v>
                </c:pt>
                <c:pt idx="796">
                  <c:v>3.6419999999999998E-8</c:v>
                </c:pt>
                <c:pt idx="797">
                  <c:v>3.2382857142857139E-8</c:v>
                </c:pt>
                <c:pt idx="798">
                  <c:v>2.8760000000000001E-8</c:v>
                </c:pt>
                <c:pt idx="799">
                  <c:v>2.5514285714285713E-8</c:v>
                </c:pt>
                <c:pt idx="800">
                  <c:v>2.2611428571428574E-8</c:v>
                </c:pt>
                <c:pt idx="801">
                  <c:v>2.002E-8</c:v>
                </c:pt>
                <c:pt idx="802">
                  <c:v>1.7702857142857143E-8</c:v>
                </c:pt>
                <c:pt idx="803">
                  <c:v>1.5637142857142856E-8</c:v>
                </c:pt>
                <c:pt idx="804">
                  <c:v>1.3802857142857144E-8</c:v>
                </c:pt>
                <c:pt idx="805">
                  <c:v>1.2168571428571429E-8</c:v>
                </c:pt>
                <c:pt idx="806">
                  <c:v>1.0711428571428571E-8</c:v>
                </c:pt>
                <c:pt idx="807">
                  <c:v>9.4228571428571426E-9</c:v>
                </c:pt>
                <c:pt idx="808">
                  <c:v>8.2800000000000004E-9</c:v>
                </c:pt>
                <c:pt idx="809">
                  <c:v>7.2714285714285707E-9</c:v>
                </c:pt>
                <c:pt idx="810">
                  <c:v>6.3742857142857142E-9</c:v>
                </c:pt>
                <c:pt idx="811">
                  <c:v>5.5828571428571426E-9</c:v>
                </c:pt>
                <c:pt idx="812">
                  <c:v>4.8857142857142854E-9</c:v>
                </c:pt>
                <c:pt idx="813">
                  <c:v>4.2714285714285712E-9</c:v>
                </c:pt>
                <c:pt idx="814">
                  <c:v>3.7314285714285718E-9</c:v>
                </c:pt>
                <c:pt idx="815">
                  <c:v>3.2514285714285714E-9</c:v>
                </c:pt>
                <c:pt idx="816">
                  <c:v>2.834285714285714E-9</c:v>
                </c:pt>
                <c:pt idx="817">
                  <c:v>2.4657142857142859E-9</c:v>
                </c:pt>
                <c:pt idx="818">
                  <c:v>2.1457142857142857E-9</c:v>
                </c:pt>
                <c:pt idx="819">
                  <c:v>1.862857142857143E-9</c:v>
                </c:pt>
                <c:pt idx="820">
                  <c:v>1.6171428571428571E-9</c:v>
                </c:pt>
                <c:pt idx="821">
                  <c:v>1.3999999999999999E-9</c:v>
                </c:pt>
                <c:pt idx="822">
                  <c:v>1.2142857142857142E-9</c:v>
                </c:pt>
                <c:pt idx="823">
                  <c:v>1.0485714285714287E-9</c:v>
                </c:pt>
                <c:pt idx="824">
                  <c:v>9.0571428571428569E-10</c:v>
                </c:pt>
                <c:pt idx="825">
                  <c:v>7.7999999999999999E-10</c:v>
                </c:pt>
                <c:pt idx="826">
                  <c:v>6.7428571428571434E-10</c:v>
                </c:pt>
                <c:pt idx="827">
                  <c:v>5.7999999999999996E-10</c:v>
                </c:pt>
                <c:pt idx="828">
                  <c:v>5.0000000000000003E-10</c:v>
                </c:pt>
                <c:pt idx="829">
                  <c:v>4.2857142857142854E-10</c:v>
                </c:pt>
                <c:pt idx="830">
                  <c:v>3.6857142857142854E-10</c:v>
                </c:pt>
                <c:pt idx="831">
                  <c:v>3.1714285714285713E-10</c:v>
                </c:pt>
                <c:pt idx="832">
                  <c:v>2.7142857142857142E-10</c:v>
                </c:pt>
                <c:pt idx="833">
                  <c:v>2.3142857142857146E-10</c:v>
                </c:pt>
                <c:pt idx="834">
                  <c:v>1.9714285714285716E-10</c:v>
                </c:pt>
                <c:pt idx="835">
                  <c:v>1.6857142857142858E-10</c:v>
                </c:pt>
                <c:pt idx="836">
                  <c:v>1.457142857142857E-10</c:v>
                </c:pt>
                <c:pt idx="837">
                  <c:v>1.2285714285714287E-10</c:v>
                </c:pt>
                <c:pt idx="838">
                  <c:v>1.0571428571428571E-10</c:v>
                </c:pt>
                <c:pt idx="839">
                  <c:v>8.8571428571428563E-11</c:v>
                </c:pt>
                <c:pt idx="840">
                  <c:v>7.7142857142857148E-11</c:v>
                </c:pt>
                <c:pt idx="841">
                  <c:v>6.571428571428572E-11</c:v>
                </c:pt>
                <c:pt idx="842">
                  <c:v>5.4285714285714279E-11</c:v>
                </c:pt>
                <c:pt idx="843">
                  <c:v>4.5714285714285712E-11</c:v>
                </c:pt>
                <c:pt idx="844">
                  <c:v>4.0000000000000004E-11</c:v>
                </c:pt>
                <c:pt idx="845">
                  <c:v>3.4285714285714284E-11</c:v>
                </c:pt>
                <c:pt idx="846">
                  <c:v>2.857142857142857E-11</c:v>
                </c:pt>
                <c:pt idx="847">
                  <c:v>2.2857142857142856E-11</c:v>
                </c:pt>
                <c:pt idx="848">
                  <c:v>2.0000000000000002E-11</c:v>
                </c:pt>
                <c:pt idx="849">
                  <c:v>1.7142857142857142E-11</c:v>
                </c:pt>
                <c:pt idx="850">
                  <c:v>1.4285714285714285E-11</c:v>
                </c:pt>
                <c:pt idx="851">
                  <c:v>1.1428571428571428E-11</c:v>
                </c:pt>
                <c:pt idx="852">
                  <c:v>1.1428571428571428E-11</c:v>
                </c:pt>
                <c:pt idx="853">
                  <c:v>8.5714285714285709E-12</c:v>
                </c:pt>
                <c:pt idx="854">
                  <c:v>5.7142857142857139E-12</c:v>
                </c:pt>
                <c:pt idx="855">
                  <c:v>5.7142857142857139E-12</c:v>
                </c:pt>
                <c:pt idx="856">
                  <c:v>5.7142857142857139E-12</c:v>
                </c:pt>
                <c:pt idx="857">
                  <c:v>2.857142857142857E-12</c:v>
                </c:pt>
                <c:pt idx="858">
                  <c:v>2.857142857142857E-12</c:v>
                </c:pt>
                <c:pt idx="859">
                  <c:v>2.857142857142857E-12</c:v>
                </c:pt>
                <c:pt idx="860">
                  <c:v>0</c:v>
                </c:pt>
                <c:pt idx="861">
                  <c:v>0</c:v>
                </c:pt>
                <c:pt idx="862">
                  <c:v>0</c:v>
                </c:pt>
                <c:pt idx="863">
                  <c:v>0</c:v>
                </c:pt>
                <c:pt idx="864">
                  <c:v>0</c:v>
                </c:pt>
                <c:pt idx="865">
                  <c:v>0</c:v>
                </c:pt>
                <c:pt idx="866">
                  <c:v>0</c:v>
                </c:pt>
                <c:pt idx="867">
                  <c:v>0</c:v>
                </c:pt>
                <c:pt idx="868">
                  <c:v>0</c:v>
                </c:pt>
                <c:pt idx="869">
                  <c:v>0</c:v>
                </c:pt>
                <c:pt idx="870">
                  <c:v>0</c:v>
                </c:pt>
                <c:pt idx="871">
                  <c:v>0</c:v>
                </c:pt>
                <c:pt idx="872">
                  <c:v>0</c:v>
                </c:pt>
                <c:pt idx="873">
                  <c:v>0</c:v>
                </c:pt>
                <c:pt idx="874">
                  <c:v>0</c:v>
                </c:pt>
                <c:pt idx="875">
                  <c:v>0</c:v>
                </c:pt>
                <c:pt idx="876">
                  <c:v>0</c:v>
                </c:pt>
                <c:pt idx="877">
                  <c:v>0</c:v>
                </c:pt>
                <c:pt idx="878">
                  <c:v>0</c:v>
                </c:pt>
                <c:pt idx="879">
                  <c:v>0</c:v>
                </c:pt>
                <c:pt idx="880">
                  <c:v>0</c:v>
                </c:pt>
                <c:pt idx="881">
                  <c:v>0</c:v>
                </c:pt>
                <c:pt idx="882">
                  <c:v>0</c:v>
                </c:pt>
                <c:pt idx="883">
                  <c:v>0</c:v>
                </c:pt>
                <c:pt idx="884">
                  <c:v>0</c:v>
                </c:pt>
                <c:pt idx="885">
                  <c:v>0</c:v>
                </c:pt>
                <c:pt idx="886">
                  <c:v>0</c:v>
                </c:pt>
                <c:pt idx="887">
                  <c:v>0</c:v>
                </c:pt>
                <c:pt idx="888">
                  <c:v>0</c:v>
                </c:pt>
                <c:pt idx="889">
                  <c:v>0</c:v>
                </c:pt>
                <c:pt idx="890">
                  <c:v>0</c:v>
                </c:pt>
                <c:pt idx="891">
                  <c:v>0</c:v>
                </c:pt>
                <c:pt idx="892">
                  <c:v>0</c:v>
                </c:pt>
                <c:pt idx="893">
                  <c:v>0</c:v>
                </c:pt>
                <c:pt idx="894">
                  <c:v>0</c:v>
                </c:pt>
                <c:pt idx="895">
                  <c:v>0</c:v>
                </c:pt>
                <c:pt idx="896">
                  <c:v>0</c:v>
                </c:pt>
                <c:pt idx="897">
                  <c:v>0</c:v>
                </c:pt>
                <c:pt idx="898">
                  <c:v>0</c:v>
                </c:pt>
                <c:pt idx="899">
                  <c:v>0</c:v>
                </c:pt>
                <c:pt idx="900">
                  <c:v>0</c:v>
                </c:pt>
                <c:pt idx="901">
                  <c:v>0</c:v>
                </c:pt>
                <c:pt idx="902">
                  <c:v>0</c:v>
                </c:pt>
                <c:pt idx="903">
                  <c:v>0</c:v>
                </c:pt>
                <c:pt idx="904">
                  <c:v>0</c:v>
                </c:pt>
                <c:pt idx="905">
                  <c:v>0</c:v>
                </c:pt>
                <c:pt idx="906">
                  <c:v>0</c:v>
                </c:pt>
                <c:pt idx="907">
                  <c:v>0</c:v>
                </c:pt>
                <c:pt idx="908">
                  <c:v>0</c:v>
                </c:pt>
                <c:pt idx="909">
                  <c:v>0</c:v>
                </c:pt>
                <c:pt idx="910">
                  <c:v>0</c:v>
                </c:pt>
                <c:pt idx="911">
                  <c:v>0</c:v>
                </c:pt>
                <c:pt idx="912">
                  <c:v>0</c:v>
                </c:pt>
                <c:pt idx="913">
                  <c:v>0</c:v>
                </c:pt>
                <c:pt idx="914">
                  <c:v>0</c:v>
                </c:pt>
                <c:pt idx="915">
                  <c:v>0</c:v>
                </c:pt>
                <c:pt idx="916">
                  <c:v>0</c:v>
                </c:pt>
                <c:pt idx="917">
                  <c:v>0</c:v>
                </c:pt>
                <c:pt idx="918">
                  <c:v>0</c:v>
                </c:pt>
                <c:pt idx="919">
                  <c:v>0</c:v>
                </c:pt>
                <c:pt idx="920">
                  <c:v>0</c:v>
                </c:pt>
                <c:pt idx="921">
                  <c:v>0</c:v>
                </c:pt>
                <c:pt idx="922">
                  <c:v>0</c:v>
                </c:pt>
                <c:pt idx="923">
                  <c:v>0</c:v>
                </c:pt>
                <c:pt idx="924">
                  <c:v>0</c:v>
                </c:pt>
                <c:pt idx="925">
                  <c:v>0</c:v>
                </c:pt>
                <c:pt idx="926">
                  <c:v>0</c:v>
                </c:pt>
                <c:pt idx="927">
                  <c:v>0</c:v>
                </c:pt>
                <c:pt idx="928">
                  <c:v>0</c:v>
                </c:pt>
                <c:pt idx="929">
                  <c:v>0</c:v>
                </c:pt>
                <c:pt idx="930">
                  <c:v>0</c:v>
                </c:pt>
                <c:pt idx="931">
                  <c:v>0</c:v>
                </c:pt>
                <c:pt idx="932">
                  <c:v>0</c:v>
                </c:pt>
                <c:pt idx="933">
                  <c:v>0</c:v>
                </c:pt>
                <c:pt idx="934">
                  <c:v>0</c:v>
                </c:pt>
                <c:pt idx="935">
                  <c:v>0</c:v>
                </c:pt>
                <c:pt idx="936">
                  <c:v>0</c:v>
                </c:pt>
                <c:pt idx="937">
                  <c:v>0</c:v>
                </c:pt>
                <c:pt idx="938">
                  <c:v>0</c:v>
                </c:pt>
                <c:pt idx="939">
                  <c:v>0</c:v>
                </c:pt>
                <c:pt idx="940">
                  <c:v>0</c:v>
                </c:pt>
                <c:pt idx="941">
                  <c:v>0</c:v>
                </c:pt>
                <c:pt idx="942">
                  <c:v>0</c:v>
                </c:pt>
                <c:pt idx="943">
                  <c:v>0</c:v>
                </c:pt>
                <c:pt idx="944">
                  <c:v>0</c:v>
                </c:pt>
                <c:pt idx="945">
                  <c:v>0</c:v>
                </c:pt>
                <c:pt idx="946">
                  <c:v>0</c:v>
                </c:pt>
                <c:pt idx="947">
                  <c:v>0</c:v>
                </c:pt>
                <c:pt idx="948">
                  <c:v>0</c:v>
                </c:pt>
                <c:pt idx="949">
                  <c:v>0</c:v>
                </c:pt>
                <c:pt idx="950">
                  <c:v>0</c:v>
                </c:pt>
                <c:pt idx="951">
                  <c:v>0</c:v>
                </c:pt>
                <c:pt idx="952">
                  <c:v>0</c:v>
                </c:pt>
                <c:pt idx="953">
                  <c:v>0</c:v>
                </c:pt>
                <c:pt idx="954">
                  <c:v>0</c:v>
                </c:pt>
                <c:pt idx="955">
                  <c:v>0</c:v>
                </c:pt>
                <c:pt idx="956">
                  <c:v>0</c:v>
                </c:pt>
                <c:pt idx="957">
                  <c:v>0</c:v>
                </c:pt>
                <c:pt idx="958">
                  <c:v>0</c:v>
                </c:pt>
                <c:pt idx="959">
                  <c:v>0</c:v>
                </c:pt>
                <c:pt idx="960">
                  <c:v>0</c:v>
                </c:pt>
                <c:pt idx="961">
                  <c:v>0</c:v>
                </c:pt>
                <c:pt idx="962">
                  <c:v>0</c:v>
                </c:pt>
                <c:pt idx="963">
                  <c:v>0</c:v>
                </c:pt>
                <c:pt idx="964">
                  <c:v>0</c:v>
                </c:pt>
                <c:pt idx="965">
                  <c:v>0</c:v>
                </c:pt>
                <c:pt idx="966">
                  <c:v>0</c:v>
                </c:pt>
                <c:pt idx="967">
                  <c:v>0</c:v>
                </c:pt>
                <c:pt idx="968">
                  <c:v>0</c:v>
                </c:pt>
                <c:pt idx="969">
                  <c:v>0</c:v>
                </c:pt>
                <c:pt idx="970">
                  <c:v>0</c:v>
                </c:pt>
                <c:pt idx="971">
                  <c:v>0</c:v>
                </c:pt>
                <c:pt idx="972">
                  <c:v>0</c:v>
                </c:pt>
                <c:pt idx="973">
                  <c:v>0</c:v>
                </c:pt>
                <c:pt idx="974">
                  <c:v>0</c:v>
                </c:pt>
                <c:pt idx="975">
                  <c:v>0</c:v>
                </c:pt>
                <c:pt idx="976">
                  <c:v>0</c:v>
                </c:pt>
                <c:pt idx="977">
                  <c:v>0</c:v>
                </c:pt>
                <c:pt idx="978">
                  <c:v>0</c:v>
                </c:pt>
                <c:pt idx="979">
                  <c:v>0</c:v>
                </c:pt>
                <c:pt idx="980">
                  <c:v>0</c:v>
                </c:pt>
                <c:pt idx="981">
                  <c:v>0</c:v>
                </c:pt>
                <c:pt idx="982">
                  <c:v>0</c:v>
                </c:pt>
                <c:pt idx="983">
                  <c:v>0</c:v>
                </c:pt>
                <c:pt idx="984">
                  <c:v>0</c:v>
                </c:pt>
                <c:pt idx="985">
                  <c:v>0</c:v>
                </c:pt>
                <c:pt idx="986">
                  <c:v>0</c:v>
                </c:pt>
                <c:pt idx="987">
                  <c:v>0</c:v>
                </c:pt>
                <c:pt idx="988">
                  <c:v>0</c:v>
                </c:pt>
                <c:pt idx="989">
                  <c:v>0</c:v>
                </c:pt>
                <c:pt idx="990">
                  <c:v>0</c:v>
                </c:pt>
                <c:pt idx="991">
                  <c:v>0</c:v>
                </c:pt>
                <c:pt idx="992">
                  <c:v>0</c:v>
                </c:pt>
                <c:pt idx="993">
                  <c:v>0</c:v>
                </c:pt>
                <c:pt idx="994">
                  <c:v>0</c:v>
                </c:pt>
                <c:pt idx="995">
                  <c:v>0</c:v>
                </c:pt>
                <c:pt idx="996">
                  <c:v>0</c:v>
                </c:pt>
                <c:pt idx="997">
                  <c:v>0</c:v>
                </c:pt>
                <c:pt idx="998">
                  <c:v>0</c:v>
                </c:pt>
                <c:pt idx="999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644-4E56-94C6-D1419AEF9F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4554696"/>
        <c:axId val="514550432"/>
      </c:scatterChart>
      <c:valAx>
        <c:axId val="514554696"/>
        <c:scaling>
          <c:orientation val="minMax"/>
          <c:max val="10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particle size (nm)</a:t>
                </a:r>
                <a:endParaRPr lang="ja-JP" alt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4550432"/>
        <c:crosses val="autoZero"/>
        <c:crossBetween val="midCat"/>
      </c:valAx>
      <c:valAx>
        <c:axId val="514550432"/>
        <c:scaling>
          <c:orientation val="minMax"/>
          <c:max val="4.0000000000000008E-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Concentration (</a:t>
                </a:r>
                <a:r>
                  <a:rPr lang="en-US" altLang="ja-JP">
                    <a:latin typeface="Yu Gothic UI" panose="020B0500000000000000" pitchFamily="50" charset="-128"/>
                    <a:ea typeface="Yu Gothic UI" panose="020B0500000000000000" pitchFamily="50" charset="-128"/>
                  </a:rPr>
                  <a:t>×10^10 </a:t>
                </a:r>
                <a:r>
                  <a:rPr lang="en-US" altLang="ja-JP"/>
                  <a:t>particles/mL)</a:t>
                </a:r>
                <a:endParaRPr lang="ja-JP" alt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.000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14554696"/>
        <c:crosses val="autoZero"/>
        <c:crossBetween val="midCat"/>
      </c:valAx>
    </c:plotArea>
    <c:legend>
      <c:legendPos val="tr"/>
      <c:layout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 smtClean="0"/>
              <a:t>Body weight (0h)</a:t>
            </a:r>
            <a:endParaRPr lang="ja-JP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48A-4C84-8F31-A976A982F498}"/>
              </c:ext>
            </c:extLst>
          </c:dPt>
          <c:errBars>
            <c:errBarType val="plus"/>
            <c:errValType val="cust"/>
            <c:noEndCap val="0"/>
            <c:plus>
              <c:numRef>
                <c:f>'[230410 TMip body weight.xlsx]summary'!$O$2:$O$3</c:f>
                <c:numCache>
                  <c:formatCode>General</c:formatCode>
                  <c:ptCount val="2"/>
                  <c:pt idx="0">
                    <c:v>0.43066082942380557</c:v>
                  </c:pt>
                  <c:pt idx="1">
                    <c:v>0.556610110234098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30410 TMip body weight.xlsx]summary'!$G$2:$G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'[230410 TMip body weight.xlsx]summary'!$H$2:$H$3</c:f>
              <c:numCache>
                <c:formatCode>0.00</c:formatCode>
                <c:ptCount val="2"/>
                <c:pt idx="0">
                  <c:v>24.574999999999999</c:v>
                </c:pt>
                <c:pt idx="1">
                  <c:v>24.6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48A-4C84-8F31-A976A982F4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53426256"/>
        <c:axId val="45343380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30410 TMip body weight.xlsx]summary'!$G$2:$G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summary'!$I$2:$I$3</c:f>
              <c:numCache>
                <c:formatCode>General</c:formatCode>
                <c:ptCount val="2"/>
                <c:pt idx="0">
                  <c:v>25</c:v>
                </c:pt>
                <c:pt idx="1">
                  <c:v>24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48A-4C84-8F31-A976A982F498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30410 TMip body weight.xlsx]summary'!$G$2:$G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summary'!$J$2:$J$3</c:f>
              <c:numCache>
                <c:formatCode>General</c:formatCode>
                <c:ptCount val="2"/>
                <c:pt idx="0">
                  <c:v>24.2</c:v>
                </c:pt>
                <c:pt idx="1">
                  <c:v>22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48A-4C84-8F31-A976A982F498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30410 TMip body weight.xlsx]summary'!$G$2:$G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summary'!$K$2:$K$3</c:f>
              <c:numCache>
                <c:formatCode>General</c:formatCode>
                <c:ptCount val="2"/>
                <c:pt idx="0">
                  <c:v>23.4</c:v>
                </c:pt>
                <c:pt idx="1">
                  <c:v>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48A-4C84-8F31-A976A982F498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30410 TMip body weight.xlsx]summary'!$G$2:$G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summary'!$L$2:$L$3</c:f>
              <c:numCache>
                <c:formatCode>General</c:formatCode>
                <c:ptCount val="2"/>
                <c:pt idx="0">
                  <c:v>25.7</c:v>
                </c:pt>
                <c:pt idx="1">
                  <c:v>26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148A-4C84-8F31-A976A982F498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30410 TMip body weight.xlsx]summary'!$G$2:$G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summary'!$M$2:$M$3</c:f>
              <c:numCache>
                <c:formatCode>General</c:formatCode>
                <c:ptCount val="2"/>
                <c:pt idx="1">
                  <c:v>25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148A-4C84-8F31-A976A982F498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30410 TMip body weight.xlsx]summary'!$G$2:$G$3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summary'!$N$2:$N$3</c:f>
              <c:numCache>
                <c:formatCode>General</c:formatCode>
                <c:ptCount val="2"/>
                <c:pt idx="1">
                  <c:v>25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148A-4C84-8F31-A976A982F4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3426256"/>
        <c:axId val="453433800"/>
      </c:scatterChart>
      <c:catAx>
        <c:axId val="453426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53433800"/>
        <c:crosses val="autoZero"/>
        <c:auto val="1"/>
        <c:lblAlgn val="ctr"/>
        <c:lblOffset val="100"/>
        <c:noMultiLvlLbl val="0"/>
      </c:catAx>
      <c:valAx>
        <c:axId val="453433800"/>
        <c:scaling>
          <c:orientation val="minMax"/>
          <c:max val="3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body </a:t>
                </a:r>
                <a:r>
                  <a:rPr lang="en-US" dirty="0" smtClean="0"/>
                  <a:t>weight (g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5342625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dirty="0" smtClean="0"/>
              <a:t>Body weight (28h)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D5D-480A-91B5-125B67484C53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O$11:$O$12</c:f>
                <c:numCache>
                  <c:formatCode>General</c:formatCode>
                  <c:ptCount val="2"/>
                  <c:pt idx="0">
                    <c:v>0.37583240945932239</c:v>
                  </c:pt>
                  <c:pt idx="1">
                    <c:v>0.500370233297675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ummary!$G$11:$G$1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summary!$H$11:$H$12</c:f>
              <c:numCache>
                <c:formatCode>0.00</c:formatCode>
                <c:ptCount val="2"/>
                <c:pt idx="0">
                  <c:v>20.6</c:v>
                </c:pt>
                <c:pt idx="1">
                  <c:v>20.6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D5D-480A-91B5-125B67484C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53426256"/>
        <c:axId val="45343380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summary!$G$11:$G$1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summary!$I$11:$I$12</c:f>
              <c:numCache>
                <c:formatCode>General</c:formatCode>
                <c:ptCount val="2"/>
                <c:pt idx="0">
                  <c:v>20.2</c:v>
                </c:pt>
                <c:pt idx="1">
                  <c:v>19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D5D-480A-91B5-125B67484C53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summary!$G$11:$G$1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summary!$J$11:$J$12</c:f>
              <c:numCache>
                <c:formatCode>General</c:formatCode>
                <c:ptCount val="2"/>
                <c:pt idx="0">
                  <c:v>20.2</c:v>
                </c:pt>
                <c:pt idx="1">
                  <c:v>18.8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4D5D-480A-91B5-125B67484C53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summary!$G$11:$G$1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summary!$K$11:$K$12</c:f>
              <c:numCache>
                <c:formatCode>General</c:formatCode>
                <c:ptCount val="2"/>
                <c:pt idx="0">
                  <c:v>20.100000000000001</c:v>
                </c:pt>
                <c:pt idx="1">
                  <c:v>2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D5D-480A-91B5-125B67484C53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summary!$G$11:$G$1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summary!$L$11:$L$12</c:f>
              <c:numCache>
                <c:formatCode>General</c:formatCode>
                <c:ptCount val="2"/>
                <c:pt idx="0">
                  <c:v>21.9</c:v>
                </c:pt>
                <c:pt idx="1">
                  <c:v>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4D5D-480A-91B5-125B67484C53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summary!$G$11:$G$1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summary!$M$11:$M$12</c:f>
              <c:numCache>
                <c:formatCode>General</c:formatCode>
                <c:ptCount val="2"/>
                <c:pt idx="1">
                  <c:v>2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4D5D-480A-91B5-125B67484C53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summary!$G$11:$G$1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summary!$N$11:$N$12</c:f>
              <c:numCache>
                <c:formatCode>General</c:formatCode>
                <c:ptCount val="2"/>
                <c:pt idx="1">
                  <c:v>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4D5D-480A-91B5-125B67484C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3426256"/>
        <c:axId val="453433800"/>
      </c:scatterChart>
      <c:catAx>
        <c:axId val="453426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33800"/>
        <c:crosses val="autoZero"/>
        <c:auto val="1"/>
        <c:lblAlgn val="ctr"/>
        <c:lblOffset val="100"/>
        <c:noMultiLvlLbl val="0"/>
      </c:catAx>
      <c:valAx>
        <c:axId val="453433800"/>
        <c:scaling>
          <c:orientation val="minMax"/>
          <c:max val="3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body </a:t>
                </a:r>
                <a:r>
                  <a:rPr lang="en-US" dirty="0" smtClean="0"/>
                  <a:t>weight (g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26256"/>
        <c:crosses val="autoZero"/>
        <c:crossBetween val="between"/>
        <c:majorUnit val="5"/>
      </c:valAx>
    </c:plotArea>
    <c:plotVisOnly val="1"/>
    <c:dispBlanksAs val="gap"/>
    <c:showDLblsOverMax val="0"/>
  </c:chart>
  <c:txPr>
    <a:bodyPr/>
    <a:lstStyle/>
    <a:p>
      <a:pPr>
        <a:defRPr sz="1100" b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i="1" dirty="0" smtClean="0"/>
              <a:t>Xbp1</a:t>
            </a:r>
            <a:r>
              <a:rPr lang="en-US" dirty="0" smtClean="0"/>
              <a:t> </a:t>
            </a:r>
            <a:r>
              <a:rPr lang="en-US" dirty="0"/>
              <a:t>splicing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D78-4082-9940-4A967FEE5E80}"/>
              </c:ext>
            </c:extLst>
          </c:dPt>
          <c:errBars>
            <c:errBarType val="plus"/>
            <c:errValType val="cust"/>
            <c:noEndCap val="0"/>
            <c:plus>
              <c:numRef>
                <c:f>'[230410 TMip body weight.xlsx]XBP1'!$Q$27:$Q$28</c:f>
                <c:numCache>
                  <c:formatCode>General</c:formatCode>
                  <c:ptCount val="2"/>
                  <c:pt idx="0">
                    <c:v>9.9539955314618858E-2</c:v>
                  </c:pt>
                  <c:pt idx="1">
                    <c:v>1.35450052760289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30410 TMip body weight.xlsx]XBP1'!$I$27:$I$28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'[230410 TMip body weight.xlsx]XBP1'!$J$27:$J$28</c:f>
              <c:numCache>
                <c:formatCode>0.00</c:formatCode>
                <c:ptCount val="2"/>
                <c:pt idx="0">
                  <c:v>9.1502166836809575</c:v>
                </c:pt>
                <c:pt idx="1">
                  <c:v>19.6282743064304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D78-4082-9940-4A967FEE5E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53426256"/>
        <c:axId val="45343380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30410 TMip body weight.xlsx]XBP1'!$I$27:$I$28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XBP1'!$K$27:$K$28</c:f>
              <c:numCache>
                <c:formatCode>General</c:formatCode>
                <c:ptCount val="2"/>
                <c:pt idx="0">
                  <c:v>9.2656122846342779</c:v>
                </c:pt>
                <c:pt idx="1">
                  <c:v>18.6838108111995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D78-4082-9940-4A967FEE5E80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30410 TMip body weight.xlsx]XBP1'!$I$27:$I$28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XBP1'!$L$27:$L$28</c:f>
              <c:numCache>
                <c:formatCode>General</c:formatCode>
                <c:ptCount val="2"/>
                <c:pt idx="0">
                  <c:v>9.3003273417683197</c:v>
                </c:pt>
                <c:pt idx="1">
                  <c:v>23.0616874562039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BD78-4082-9940-4A967FEE5E80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30410 TMip body weight.xlsx]XBP1'!$I$27:$I$28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XBP1'!$M$27:$M$28</c:f>
              <c:numCache>
                <c:formatCode>General</c:formatCode>
                <c:ptCount val="2"/>
                <c:pt idx="0">
                  <c:v>9.2265509785539734</c:v>
                </c:pt>
                <c:pt idx="1">
                  <c:v>19.0781673582036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D78-4082-9940-4A967FEE5E80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30410 TMip body weight.xlsx]XBP1'!$I$27:$I$28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XBP1'!$N$27:$N$28</c:f>
              <c:numCache>
                <c:formatCode>General</c:formatCode>
                <c:ptCount val="2"/>
                <c:pt idx="0">
                  <c:v>8.8083761297672627</c:v>
                </c:pt>
                <c:pt idx="1">
                  <c:v>21.3145955231342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BD78-4082-9940-4A967FEE5E80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30410 TMip body weight.xlsx]XBP1'!$I$27:$I$28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XBP1'!$O$27:$O$28</c:f>
              <c:numCache>
                <c:formatCode>General</c:formatCode>
                <c:ptCount val="2"/>
                <c:pt idx="1">
                  <c:v>22.4874500263676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BD78-4082-9940-4A967FEE5E80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30410 TMip body weight.xlsx]XBP1'!$I$27:$I$28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30410 TMip body weight.xlsx]XBP1'!$P$27:$P$28</c:f>
              <c:numCache>
                <c:formatCode>General</c:formatCode>
                <c:ptCount val="2"/>
                <c:pt idx="1">
                  <c:v>13.1439346634735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BD78-4082-9940-4A967FEE5E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3426256"/>
        <c:axId val="453433800"/>
      </c:scatterChart>
      <c:catAx>
        <c:axId val="453426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33800"/>
        <c:crosses val="autoZero"/>
        <c:auto val="1"/>
        <c:lblAlgn val="ctr"/>
        <c:lblOffset val="100"/>
        <c:noMultiLvlLbl val="0"/>
      </c:catAx>
      <c:valAx>
        <c:axId val="453433800"/>
        <c:scaling>
          <c:orientation val="minMax"/>
          <c:max val="3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i="1" dirty="0" smtClean="0"/>
                  <a:t>% Xbp1</a:t>
                </a:r>
                <a:r>
                  <a:rPr lang="en-US" dirty="0" smtClean="0"/>
                  <a:t> </a:t>
                </a:r>
                <a:r>
                  <a:rPr lang="en-US" dirty="0"/>
                  <a:t>splicing </a:t>
                </a:r>
                <a:r>
                  <a:rPr lang="en-US" dirty="0" smtClean="0"/>
                  <a:t>amplicons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26256"/>
        <c:crosses val="autoZero"/>
        <c:crossBetween val="between"/>
        <c:majorUnit val="5"/>
      </c:valAx>
    </c:plotArea>
    <c:plotVisOnly val="1"/>
    <c:dispBlanksAs val="gap"/>
    <c:showDLblsOverMax val="0"/>
  </c:chart>
  <c:txPr>
    <a:bodyPr/>
    <a:lstStyle/>
    <a:p>
      <a:pPr>
        <a:defRPr sz="1100" b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BiP mRNA</a:t>
            </a: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3FE-45A4-992B-22D734002D9C}"/>
              </c:ext>
            </c:extLst>
          </c:dPt>
          <c:errBars>
            <c:errBarType val="plus"/>
            <c:errValType val="cust"/>
            <c:noEndCap val="0"/>
            <c:plus>
              <c:numRef>
                <c:f>'[2023-04-21 165019.xls]calc'!$J$56:$J$57</c:f>
                <c:numCache>
                  <c:formatCode>General</c:formatCode>
                  <c:ptCount val="2"/>
                  <c:pt idx="0">
                    <c:v>0.32043576243525612</c:v>
                  </c:pt>
                  <c:pt idx="1">
                    <c:v>2.0456967500960208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[2023-04-21 165019.xls]calc'!$B$56:$B$57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'[2023-04-21 165019.xls]calc'!$C$56:$C$57</c:f>
              <c:numCache>
                <c:formatCode>General</c:formatCode>
                <c:ptCount val="2"/>
                <c:pt idx="0">
                  <c:v>1</c:v>
                </c:pt>
                <c:pt idx="1">
                  <c:v>4.36721621617215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3FE-45A4-992B-22D734002D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515535088"/>
        <c:axId val="1"/>
      </c:barChart>
      <c:scatterChart>
        <c:scatterStyle val="lineMarker"/>
        <c:varyColors val="0"/>
        <c:ser>
          <c:idx val="1"/>
          <c:order val="1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023-04-21 165019.xls]calc'!$B$56:$B$57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023-04-21 165019.xls]calc'!$D$56:$D$57</c:f>
              <c:numCache>
                <c:formatCode>General</c:formatCode>
                <c:ptCount val="2"/>
                <c:pt idx="0">
                  <c:v>0.9120508571673368</c:v>
                </c:pt>
                <c:pt idx="1">
                  <c:v>12.177873387910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3FE-45A4-992B-22D734002D9C}"/>
            </c:ext>
          </c:extLst>
        </c:ser>
        <c:ser>
          <c:idx val="2"/>
          <c:order val="2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023-04-21 165019.xls]calc'!$B$56:$B$57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023-04-21 165019.xls]calc'!$E$56:$E$57</c:f>
              <c:numCache>
                <c:formatCode>General</c:formatCode>
                <c:ptCount val="2"/>
                <c:pt idx="0">
                  <c:v>1.9129779062828591</c:v>
                </c:pt>
                <c:pt idx="1">
                  <c:v>3.24515761264720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D3FE-45A4-992B-22D734002D9C}"/>
            </c:ext>
          </c:extLst>
        </c:ser>
        <c:ser>
          <c:idx val="3"/>
          <c:order val="3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023-04-21 165019.xls]calc'!$B$56:$B$57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023-04-21 165019.xls]calc'!$F$56:$F$57</c:f>
              <c:numCache>
                <c:formatCode>General</c:formatCode>
                <c:ptCount val="2"/>
                <c:pt idx="0">
                  <c:v>1.067727904112848</c:v>
                </c:pt>
                <c:pt idx="1">
                  <c:v>2.43990956103314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3FE-45A4-992B-22D734002D9C}"/>
            </c:ext>
          </c:extLst>
        </c:ser>
        <c:ser>
          <c:idx val="4"/>
          <c:order val="4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023-04-21 165019.xls]calc'!$B$56:$B$57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023-04-21 165019.xls]calc'!$G$56:$G$57</c:f>
              <c:numCache>
                <c:formatCode>General</c:formatCode>
                <c:ptCount val="2"/>
                <c:pt idx="0">
                  <c:v>0.10724333243695625</c:v>
                </c:pt>
                <c:pt idx="1">
                  <c:v>2.5809384060899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D3FE-45A4-992B-22D734002D9C}"/>
            </c:ext>
          </c:extLst>
        </c:ser>
        <c:ser>
          <c:idx val="5"/>
          <c:order val="5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023-04-21 165019.xls]calc'!$B$56:$B$57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023-04-21 165019.xls]calc'!$H$56:$H$57</c:f>
              <c:numCache>
                <c:formatCode>General</c:formatCode>
                <c:ptCount val="2"/>
                <c:pt idx="1">
                  <c:v>3.7160473796902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D3FE-45A4-992B-22D734002D9C}"/>
            </c:ext>
          </c:extLst>
        </c:ser>
        <c:ser>
          <c:idx val="6"/>
          <c:order val="6"/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2023-04-21 165019.xls]calc'!$B$56:$B$57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2023-04-21 165019.xls]calc'!$I$56:$I$57</c:f>
              <c:numCache>
                <c:formatCode>General</c:formatCode>
                <c:ptCount val="2"/>
                <c:pt idx="1">
                  <c:v>2.04337094966199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D3FE-45A4-992B-22D734002D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5535088"/>
        <c:axId val="1"/>
      </c:scatterChart>
      <c:catAx>
        <c:axId val="515535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 i="1" dirty="0" smtClean="0"/>
                  <a:t>Hspa5/Rplp0</a:t>
                </a:r>
                <a:r>
                  <a:rPr lang="en-US" altLang="ja-JP" dirty="0" smtClean="0"/>
                  <a:t> (AU)</a:t>
                </a:r>
                <a:endParaRPr lang="ja-JP" dirty="0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15535088"/>
        <c:crosses val="autoZero"/>
        <c:crossBetween val="between"/>
        <c:majorUnit val="5"/>
      </c:valAx>
    </c:plotArea>
    <c:plotVisOnly val="1"/>
    <c:dispBlanksAs val="gap"/>
    <c:showDLblsOverMax val="0"/>
  </c:chart>
  <c:txPr>
    <a:bodyPr/>
    <a:lstStyle/>
    <a:p>
      <a:pPr>
        <a:defRPr sz="1100" b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ja-JP" dirty="0" err="1" smtClean="0"/>
              <a:t>exosomal</a:t>
            </a:r>
            <a:r>
              <a:rPr lang="en-US" altLang="ja-JP" dirty="0" smtClean="0"/>
              <a:t> </a:t>
            </a:r>
            <a:r>
              <a:rPr lang="en-US" altLang="ja-JP" dirty="0" err="1" smtClean="0"/>
              <a:t>Alix</a:t>
            </a:r>
            <a:endParaRPr lang="ja-JP" altLang="en-US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6664960317460318"/>
          <c:y val="0.28539410038971935"/>
          <c:w val="0.67791388888888893"/>
          <c:h val="0.5784923967424906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116-4C39-A036-09C81176350E}"/>
              </c:ext>
            </c:extLst>
          </c:dPt>
          <c:errBars>
            <c:errBarType val="plus"/>
            <c:errValType val="cust"/>
            <c:noEndCap val="0"/>
            <c:plus>
              <c:numRef>
                <c:f>'[band intensity.xlsx]Alix 24'!$S$31:$S$32</c:f>
                <c:numCache>
                  <c:formatCode>General</c:formatCode>
                  <c:ptCount val="2"/>
                  <c:pt idx="0">
                    <c:v>0.30841530911505594</c:v>
                  </c:pt>
                  <c:pt idx="1">
                    <c:v>3.805010794135078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band intensity.xlsx]Alix 24'!$B$31:$B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'[band intensity.xlsx]Alix 24'!$L$31:$L$32</c:f>
              <c:numCache>
                <c:formatCode>General</c:formatCode>
                <c:ptCount val="2"/>
                <c:pt idx="0">
                  <c:v>1</c:v>
                </c:pt>
                <c:pt idx="1">
                  <c:v>7.95358539765319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116-4C39-A036-09C8117635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53426256"/>
        <c:axId val="45343380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yVal>
            <c:numRef>
              <c:f>'[band intensity.xlsx]Alix 24'!$M$31:$M$32</c:f>
              <c:numCache>
                <c:formatCode>General</c:formatCode>
                <c:ptCount val="2"/>
                <c:pt idx="0">
                  <c:v>1.351019556714472</c:v>
                </c:pt>
                <c:pt idx="1">
                  <c:v>3.7235984354628423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116-4C39-A036-09C81176350E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'[band intensity.xlsx]Alix 24'!$N$31:$N$32</c:f>
              <c:numCache>
                <c:formatCode>General</c:formatCode>
                <c:ptCount val="2"/>
                <c:pt idx="0">
                  <c:v>1.8330117340286831</c:v>
                </c:pt>
                <c:pt idx="1">
                  <c:v>3.596349413298565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116-4C39-A036-09C81176350E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'[band intensity.xlsx]Alix 24'!$O$31:$O$32</c:f>
              <c:numCache>
                <c:formatCode>General</c:formatCode>
                <c:ptCount val="2"/>
                <c:pt idx="0">
                  <c:v>0.451754889178618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116-4C39-A036-09C81176350E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'[band intensity.xlsx]Alix 24'!$P$31:$P$32</c:f>
              <c:numCache>
                <c:formatCode>General</c:formatCode>
                <c:ptCount val="2"/>
                <c:pt idx="0">
                  <c:v>0.36421382007822684</c:v>
                </c:pt>
                <c:pt idx="1">
                  <c:v>8.155410691003911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7116-4C39-A036-09C81176350E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yVal>
            <c:numRef>
              <c:f>'[band intensity.xlsx]Alix 24'!$Q$31:$Q$32</c:f>
              <c:numCache>
                <c:formatCode>General</c:formatCode>
                <c:ptCount val="2"/>
                <c:pt idx="1">
                  <c:v>8.113689700130377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7116-4C39-A036-09C81176350E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yVal>
            <c:numRef>
              <c:f>'[band intensity.xlsx]Alix 24'!$R$31:$R$32</c:f>
              <c:numCache>
                <c:formatCode>General</c:formatCode>
                <c:ptCount val="2"/>
                <c:pt idx="1">
                  <c:v>0.274837027379400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7116-4C39-A036-09C8117635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3426256"/>
        <c:axId val="453433800"/>
      </c:scatterChart>
      <c:catAx>
        <c:axId val="453426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33800"/>
        <c:crosses val="autoZero"/>
        <c:auto val="1"/>
        <c:lblAlgn val="ctr"/>
        <c:lblOffset val="100"/>
        <c:noMultiLvlLbl val="0"/>
      </c:catAx>
      <c:valAx>
        <c:axId val="4534338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band intensity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262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ja-JP" dirty="0" err="1" smtClean="0"/>
              <a:t>exosomal</a:t>
            </a:r>
            <a:r>
              <a:rPr lang="en-US" altLang="ja-JP" dirty="0" smtClean="0"/>
              <a:t> Tsg101</a:t>
            </a:r>
            <a:endParaRPr lang="ja-JP" altLang="en-US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6664960317460318"/>
          <c:y val="0.26933666788467137"/>
          <c:w val="0.67791388888888893"/>
          <c:h val="0.5945498292475386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6CB-44BF-B948-2DCC5B239A44}"/>
              </c:ext>
            </c:extLst>
          </c:dPt>
          <c:errBars>
            <c:errBarType val="plus"/>
            <c:errValType val="cust"/>
            <c:noEndCap val="0"/>
            <c:plus>
              <c:numRef>
                <c:f>'[band intensity.xlsx]Tsg 24'!$S$31:$S$32</c:f>
                <c:numCache>
                  <c:formatCode>General</c:formatCode>
                  <c:ptCount val="2"/>
                  <c:pt idx="0">
                    <c:v>0.12263157226353684</c:v>
                  </c:pt>
                  <c:pt idx="1">
                    <c:v>0.103746271921614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band intensity.xlsx]Tsg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'[band intensity.xlsx]Tsg 24'!$L$31:$L$32</c:f>
              <c:numCache>
                <c:formatCode>General</c:formatCode>
                <c:ptCount val="2"/>
                <c:pt idx="0">
                  <c:v>1</c:v>
                </c:pt>
                <c:pt idx="1">
                  <c:v>0.185849022662570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6CB-44BF-B948-2DCC5B239A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53426256"/>
        <c:axId val="45343380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band intensity.xlsx]Tsg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Tsg 24'!$M$31:$M$32</c:f>
              <c:numCache>
                <c:formatCode>General</c:formatCode>
                <c:ptCount val="2"/>
                <c:pt idx="0">
                  <c:v>1.1797592187616071</c:v>
                </c:pt>
                <c:pt idx="1">
                  <c:v>7.7447769604144625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6CB-44BF-B948-2DCC5B239A44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band intensity.xlsx]Tsg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Tsg 24'!$N$31:$N$32</c:f>
              <c:numCache>
                <c:formatCode>General</c:formatCode>
                <c:ptCount val="2"/>
                <c:pt idx="0">
                  <c:v>1.2779953549974155</c:v>
                </c:pt>
                <c:pt idx="1">
                  <c:v>3.1740592161474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6CB-44BF-B948-2DCC5B239A44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band intensity.xlsx]Tsg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Tsg 24'!$O$31:$O$32</c:f>
              <c:numCache>
                <c:formatCode>General</c:formatCode>
                <c:ptCount val="2"/>
                <c:pt idx="0">
                  <c:v>0.65655478299896963</c:v>
                </c:pt>
                <c:pt idx="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6CB-44BF-B948-2DCC5B239A44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band intensity.xlsx]Tsg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Tsg 24'!$P$31:$P$32</c:f>
              <c:numCache>
                <c:formatCode>General</c:formatCode>
                <c:ptCount val="2"/>
                <c:pt idx="0">
                  <c:v>0.88569064324200786</c:v>
                </c:pt>
                <c:pt idx="1">
                  <c:v>5.949465084442709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A6CB-44BF-B948-2DCC5B239A44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band intensity.xlsx]Tsg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Tsg 24'!$Q$31:$Q$32</c:f>
              <c:numCache>
                <c:formatCode>General</c:formatCode>
                <c:ptCount val="2"/>
                <c:pt idx="1">
                  <c:v>0.315876741002410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A6CB-44BF-B948-2DCC5B239A44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band intensity.xlsx]Tsg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Tsg 24'!$R$31:$R$32</c:f>
              <c:numCache>
                <c:formatCode>General</c:formatCode>
                <c:ptCount val="2"/>
                <c:pt idx="1">
                  <c:v>0.700237375006697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A6CB-44BF-B948-2DCC5B239A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3426256"/>
        <c:axId val="453433800"/>
      </c:scatterChart>
      <c:catAx>
        <c:axId val="453426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33800"/>
        <c:crosses val="autoZero"/>
        <c:auto val="1"/>
        <c:lblAlgn val="ctr"/>
        <c:lblOffset val="100"/>
        <c:noMultiLvlLbl val="0"/>
      </c:catAx>
      <c:valAx>
        <c:axId val="4534338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band intensity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262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/>
              <a:t>T-cadherin mRNA</a:t>
            </a:r>
            <a:endParaRPr lang="ja-JP" alt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148-43AC-9DA6-07A63F89B0BD}"/>
              </c:ext>
            </c:extLst>
          </c:dPt>
          <c:errBars>
            <c:errBarType val="plus"/>
            <c:errValType val="cust"/>
            <c:noEndCap val="0"/>
            <c:plus>
              <c:numRef>
                <c:f>'[210614_protocol&amp;result_2800.xlsx]解析2'!$H$12:$H$15</c:f>
                <c:numCache>
                  <c:formatCode>General</c:formatCode>
                  <c:ptCount val="4"/>
                  <c:pt idx="0">
                    <c:v>1.1494011913716833E-2</c:v>
                  </c:pt>
                  <c:pt idx="1">
                    <c:v>4.7331617692552223E-2</c:v>
                  </c:pt>
                  <c:pt idx="2">
                    <c:v>2.1277048293081927E-2</c:v>
                  </c:pt>
                  <c:pt idx="3">
                    <c:v>3.293801810693613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10614_protocol&amp;result_2800.xlsx]解析2'!$B$12:$B$1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'[210614_protocol&amp;result_2800.xlsx]解析2'!$D$12:$D$15</c:f>
              <c:numCache>
                <c:formatCode>General</c:formatCode>
                <c:ptCount val="4"/>
                <c:pt idx="0">
                  <c:v>1</c:v>
                </c:pt>
                <c:pt idx="1">
                  <c:v>0.57579382099713849</c:v>
                </c:pt>
                <c:pt idx="2">
                  <c:v>0.61652982405956325</c:v>
                </c:pt>
                <c:pt idx="3">
                  <c:v>0.434001315062384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148-43AC-9DA6-07A63F89B0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577137512"/>
        <c:axId val="57713784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614_protocol&amp;result_2800.xlsx]解析2'!$B$12:$B$1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210614_protocol&amp;result_2800.xlsx]解析2'!$E$12:$E$15</c:f>
              <c:numCache>
                <c:formatCode>General</c:formatCode>
                <c:ptCount val="4"/>
                <c:pt idx="0">
                  <c:v>0.97696676791667225</c:v>
                </c:pt>
                <c:pt idx="1">
                  <c:v>0.53085192311222662</c:v>
                </c:pt>
                <c:pt idx="2">
                  <c:v>0.58090791576385969</c:v>
                </c:pt>
                <c:pt idx="3">
                  <c:v>0.437204875374447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148-43AC-9DA6-07A63F89B0BD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614_protocol&amp;result_2800.xlsx]解析2'!$B$12:$B$1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210614_protocol&amp;result_2800.xlsx]解析2'!$F$12:$F$15</c:f>
              <c:numCache>
                <c:formatCode>General</c:formatCode>
                <c:ptCount val="4"/>
                <c:pt idx="0">
                  <c:v>0.99749491645589117</c:v>
                </c:pt>
                <c:pt idx="1">
                  <c:v>0.69081982658778296</c:v>
                </c:pt>
                <c:pt idx="2">
                  <c:v>0.60139358917212715</c:v>
                </c:pt>
                <c:pt idx="3">
                  <c:v>0.362582548673395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148-43AC-9DA6-07A63F89B0BD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614_protocol&amp;result_2800.xlsx]解析2'!$B$12:$B$1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210614_protocol&amp;result_2800.xlsx]解析2'!$G$12:$G$15</c:f>
              <c:numCache>
                <c:formatCode>General</c:formatCode>
                <c:ptCount val="4"/>
                <c:pt idx="0">
                  <c:v>1.0255383156274367</c:v>
                </c:pt>
                <c:pt idx="1">
                  <c:v>0.50570971329140568</c:v>
                </c:pt>
                <c:pt idx="2">
                  <c:v>0.6672879672427029</c:v>
                </c:pt>
                <c:pt idx="3">
                  <c:v>0.502216521139310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148-43AC-9DA6-07A63F89B0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7137512"/>
        <c:axId val="577137840"/>
      </c:scatterChart>
      <c:catAx>
        <c:axId val="577137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G132 (μmol/L)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137840"/>
        <c:crosses val="autoZero"/>
        <c:auto val="1"/>
        <c:lblAlgn val="ctr"/>
        <c:lblOffset val="100"/>
        <c:noMultiLvlLbl val="0"/>
      </c:catAx>
      <c:valAx>
        <c:axId val="5771378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i="1" dirty="0"/>
                  <a:t>Cdh13/Rplp0</a:t>
                </a:r>
                <a:r>
                  <a:rPr lang="en-US" dirty="0"/>
                  <a:t> (AU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137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ja-JP" dirty="0" err="1" smtClean="0"/>
              <a:t>exosomal</a:t>
            </a:r>
            <a:r>
              <a:rPr lang="en-US" altLang="ja-JP" dirty="0" smtClean="0"/>
              <a:t> </a:t>
            </a:r>
            <a:r>
              <a:rPr lang="en-US" altLang="ja-JP" dirty="0" err="1" smtClean="0"/>
              <a:t>Syntenin</a:t>
            </a:r>
            <a:endParaRPr lang="en-US" altLang="ja-JP" dirty="0"/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6664960317460318"/>
          <c:y val="0.27468914538635403"/>
          <c:w val="0.67791388888888893"/>
          <c:h val="0.589197351745855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DCA-4A3D-81FD-A1F4ABE607CA}"/>
              </c:ext>
            </c:extLst>
          </c:dPt>
          <c:errBars>
            <c:errBarType val="plus"/>
            <c:errValType val="cust"/>
            <c:noEndCap val="0"/>
            <c:plus>
              <c:numRef>
                <c:f>'[band intensity.xlsx]Tsg 24'!$J$31:$J$32</c:f>
                <c:numCache>
                  <c:formatCode>General</c:formatCode>
                  <c:ptCount val="2"/>
                  <c:pt idx="0">
                    <c:v>7.525875826733526E-2</c:v>
                  </c:pt>
                  <c:pt idx="1">
                    <c:v>5.439307488133936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band intensity.xlsx]Syntenin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cat>
          <c:val>
            <c:numRef>
              <c:f>'[band intensity.xlsx]Syntenin 24'!$L$31:$L$32</c:f>
              <c:numCache>
                <c:formatCode>General</c:formatCode>
                <c:ptCount val="2"/>
                <c:pt idx="0">
                  <c:v>1</c:v>
                </c:pt>
                <c:pt idx="1">
                  <c:v>0.2926831019048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DCA-4A3D-81FD-A1F4ABE607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453426256"/>
        <c:axId val="45343380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band intensity.xlsx]Syntenin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Syntenin 24'!$M$31:$M$32</c:f>
              <c:numCache>
                <c:formatCode>General</c:formatCode>
                <c:ptCount val="2"/>
                <c:pt idx="0">
                  <c:v>1.2907110821376904</c:v>
                </c:pt>
                <c:pt idx="1">
                  <c:v>0.102699030760767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DCA-4A3D-81FD-A1F4ABE607CA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band intensity.xlsx]Syntenin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Syntenin 24'!$N$31:$N$32</c:f>
              <c:numCache>
                <c:formatCode>General</c:formatCode>
                <c:ptCount val="2"/>
                <c:pt idx="0">
                  <c:v>1.4835722661717694</c:v>
                </c:pt>
                <c:pt idx="1">
                  <c:v>0.248035974025719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4DCA-4A3D-81FD-A1F4ABE607CA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band intensity.xlsx]Syntenin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Syntenin 24'!$O$31:$O$32</c:f>
              <c:numCache>
                <c:formatCode>General</c:formatCode>
                <c:ptCount val="2"/>
                <c:pt idx="0">
                  <c:v>0.48880901621532735</c:v>
                </c:pt>
                <c:pt idx="1">
                  <c:v>0.241935894348812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DCA-4A3D-81FD-A1F4ABE607CA}"/>
            </c:ext>
          </c:extLst>
        </c:ser>
        <c:ser>
          <c:idx val="4"/>
          <c:order val="4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band intensity.xlsx]Syntenin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Syntenin 24'!$P$31:$P$32</c:f>
              <c:numCache>
                <c:formatCode>General</c:formatCode>
                <c:ptCount val="2"/>
                <c:pt idx="0">
                  <c:v>0.7369076354752131</c:v>
                </c:pt>
                <c:pt idx="1">
                  <c:v>0.324380937838308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4DCA-4A3D-81FD-A1F4ABE607CA}"/>
            </c:ext>
          </c:extLst>
        </c:ser>
        <c:ser>
          <c:idx val="5"/>
          <c:order val="5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band intensity.xlsx]Syntenin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Syntenin 24'!$Q$31:$Q$32</c:f>
              <c:numCache>
                <c:formatCode>General</c:formatCode>
                <c:ptCount val="2"/>
                <c:pt idx="1">
                  <c:v>0.402248963906556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4DCA-4A3D-81FD-A1F4ABE607CA}"/>
            </c:ext>
          </c:extLst>
        </c:ser>
        <c:ser>
          <c:idx val="6"/>
          <c:order val="6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strRef>
              <c:f>'[band intensity.xlsx]Syntenin 24'!$K$31:$K$32</c:f>
              <c:strCache>
                <c:ptCount val="2"/>
                <c:pt idx="0">
                  <c:v>Ctrl</c:v>
                </c:pt>
                <c:pt idx="1">
                  <c:v>TM</c:v>
                </c:pt>
              </c:strCache>
            </c:strRef>
          </c:xVal>
          <c:yVal>
            <c:numRef>
              <c:f>'[band intensity.xlsx]Syntenin 24'!$R$31:$R$32</c:f>
              <c:numCache>
                <c:formatCode>General</c:formatCode>
                <c:ptCount val="2"/>
                <c:pt idx="1">
                  <c:v>0.436797810549065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4DCA-4A3D-81FD-A1F4ABE607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3426256"/>
        <c:axId val="453433800"/>
      </c:scatterChart>
      <c:catAx>
        <c:axId val="453426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33800"/>
        <c:crosses val="autoZero"/>
        <c:auto val="1"/>
        <c:lblAlgn val="ctr"/>
        <c:lblOffset val="100"/>
        <c:noMultiLvlLbl val="0"/>
      </c:catAx>
      <c:valAx>
        <c:axId val="4534338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band intensity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4534262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100" b="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 err="1"/>
              <a:t>BiP</a:t>
            </a:r>
            <a:r>
              <a:rPr lang="en-US" altLang="ja-JP" sz="1200" dirty="0"/>
              <a:t> mRNA</a:t>
            </a:r>
            <a:endParaRPr lang="ja-JP" alt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3772812499999996"/>
          <c:y val="0.16613481481481482"/>
          <c:w val="0.71817465277777781"/>
          <c:h val="0.61241481481481486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smGrid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B2E-4C5D-85A5-EAAB58F5707F}"/>
              </c:ext>
            </c:extLst>
          </c:dPt>
          <c:errBars>
            <c:errBarType val="plus"/>
            <c:errValType val="cust"/>
            <c:noEndCap val="0"/>
            <c:plus>
              <c:numRef>
                <c:f>'[210614_protocol&amp;result_2800.xlsx]解析2'!$P$3:$P$6</c:f>
                <c:numCache>
                  <c:formatCode>General</c:formatCode>
                  <c:ptCount val="4"/>
                  <c:pt idx="0">
                    <c:v>0.2127149718985783</c:v>
                  </c:pt>
                  <c:pt idx="1">
                    <c:v>8.4689657631374857E-2</c:v>
                  </c:pt>
                  <c:pt idx="2">
                    <c:v>0.18697400835875699</c:v>
                  </c:pt>
                  <c:pt idx="3">
                    <c:v>0.13652018695586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10614_protocol&amp;result_2800.xlsx]解析2'!$B$3:$B$6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'[210614_protocol&amp;result_2800.xlsx]解析2'!$L$3:$L$6</c:f>
              <c:numCache>
                <c:formatCode>General</c:formatCode>
                <c:ptCount val="4"/>
                <c:pt idx="0">
                  <c:v>1</c:v>
                </c:pt>
                <c:pt idx="1">
                  <c:v>2.0394743219089517</c:v>
                </c:pt>
                <c:pt idx="2">
                  <c:v>2.1645758030112847</c:v>
                </c:pt>
                <c:pt idx="3">
                  <c:v>2.0289203253849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B2E-4C5D-85A5-EAAB58F570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577137512"/>
        <c:axId val="57713784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614_protocol&amp;result_2800.xlsx]解析2'!$B$3:$B$6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210614_protocol&amp;result_2800.xlsx]解析2'!$M$3:$M$6</c:f>
              <c:numCache>
                <c:formatCode>General</c:formatCode>
                <c:ptCount val="4"/>
                <c:pt idx="0">
                  <c:v>1.5205049031604341</c:v>
                </c:pt>
                <c:pt idx="1">
                  <c:v>1.9786966718873664</c:v>
                </c:pt>
                <c:pt idx="2">
                  <c:v>2.5749607983506788</c:v>
                </c:pt>
                <c:pt idx="3">
                  <c:v>1.93797568321418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B2E-4C5D-85A5-EAAB58F5707F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614_protocol&amp;result_2800.xlsx]解析2'!$B$3:$B$6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210614_protocol&amp;result_2800.xlsx]解析2'!$N$3:$N$6</c:f>
              <c:numCache>
                <c:formatCode>General</c:formatCode>
                <c:ptCount val="4"/>
                <c:pt idx="0">
                  <c:v>0.76025245158021837</c:v>
                </c:pt>
                <c:pt idx="1">
                  <c:v>1.8980927203698634</c:v>
                </c:pt>
                <c:pt idx="2">
                  <c:v>2.135465319778175</c:v>
                </c:pt>
                <c:pt idx="3">
                  <c:v>1.79570513230010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BB2E-4C5D-85A5-EAAB58F5707F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614_protocol&amp;result_2800.xlsx]解析2'!$B$3:$B$6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210614_protocol&amp;result_2800.xlsx]解析2'!$O$3:$O$6</c:f>
              <c:numCache>
                <c:formatCode>General</c:formatCode>
                <c:ptCount val="4"/>
                <c:pt idx="0">
                  <c:v>0.71924264525934745</c:v>
                </c:pt>
                <c:pt idx="1">
                  <c:v>2.2416335734696249</c:v>
                </c:pt>
                <c:pt idx="2">
                  <c:v>1.7833012909049999</c:v>
                </c:pt>
                <c:pt idx="3">
                  <c:v>2.3530801606406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B2E-4C5D-85A5-EAAB58F570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7137512"/>
        <c:axId val="577137840"/>
      </c:scatterChart>
      <c:catAx>
        <c:axId val="577137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unicamycin </a:t>
                </a:r>
                <a:r>
                  <a:rPr lang="en-US" dirty="0"/>
                  <a:t>(</a:t>
                </a:r>
                <a:r>
                  <a:rPr lang="en-US" dirty="0" err="1"/>
                  <a:t>μmol</a:t>
                </a:r>
                <a:r>
                  <a:rPr lang="en-US" dirty="0"/>
                  <a:t>/L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137840"/>
        <c:crosses val="autoZero"/>
        <c:auto val="1"/>
        <c:lblAlgn val="ctr"/>
        <c:lblOffset val="100"/>
        <c:noMultiLvlLbl val="0"/>
      </c:catAx>
      <c:valAx>
        <c:axId val="5771378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i="1" dirty="0"/>
                  <a:t>Hspa5/Rplp0</a:t>
                </a:r>
                <a:r>
                  <a:rPr lang="en-US" dirty="0"/>
                  <a:t> (AU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137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 err="1"/>
              <a:t>BiP</a:t>
            </a:r>
            <a:r>
              <a:rPr lang="en-US" altLang="ja-JP" sz="1200" dirty="0"/>
              <a:t> mRNA</a:t>
            </a:r>
            <a:endParaRPr lang="ja-JP" alt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9285902777777778"/>
          <c:y val="7.5941111111111112E-2"/>
          <c:w val="0.75863402777777778"/>
          <c:h val="0.679089999999999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AE0-4B85-B10B-DEFDDDB5B912}"/>
              </c:ext>
            </c:extLst>
          </c:dPt>
          <c:errBars>
            <c:errBarType val="plus"/>
            <c:errValType val="cust"/>
            <c:noEndCap val="0"/>
            <c:plus>
              <c:numRef>
                <c:f>'[210614_protocol&amp;result_2800.xlsx]解析2'!$P$12:$P$15</c:f>
                <c:numCache>
                  <c:formatCode>General</c:formatCode>
                  <c:ptCount val="4"/>
                  <c:pt idx="0">
                    <c:v>7.8174686875095795E-2</c:v>
                  </c:pt>
                  <c:pt idx="1">
                    <c:v>0.15724107063327647</c:v>
                  </c:pt>
                  <c:pt idx="2">
                    <c:v>0.29106261037010212</c:v>
                  </c:pt>
                  <c:pt idx="3">
                    <c:v>1.05360586146504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10614_protocol&amp;result_2800.xlsx]解析2'!$B$12:$B$1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cat>
          <c:val>
            <c:numRef>
              <c:f>'[210614_protocol&amp;result_2800.xlsx]解析2'!$L$12:$L$15</c:f>
              <c:numCache>
                <c:formatCode>General</c:formatCode>
                <c:ptCount val="4"/>
                <c:pt idx="0">
                  <c:v>1</c:v>
                </c:pt>
                <c:pt idx="1">
                  <c:v>2.1184779404536216</c:v>
                </c:pt>
                <c:pt idx="2">
                  <c:v>2.5611662211798469</c:v>
                </c:pt>
                <c:pt idx="3">
                  <c:v>4.89757026463331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AE0-4B85-B10B-DEFDDDB5B9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577137512"/>
        <c:axId val="57713784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614_protocol&amp;result_2800.xlsx]解析2'!$B$12:$B$1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210614_protocol&amp;result_2800.xlsx]解析2'!$M$12:$M$15</c:f>
              <c:numCache>
                <c:formatCode>General</c:formatCode>
                <c:ptCount val="4"/>
                <c:pt idx="0">
                  <c:v>0.88314510662524603</c:v>
                </c:pt>
                <c:pt idx="1">
                  <c:v>2.1595375568133597</c:v>
                </c:pt>
                <c:pt idx="2">
                  <c:v>3.2732468508634045</c:v>
                </c:pt>
                <c:pt idx="3">
                  <c:v>3.81246054400270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AE0-4B85-B10B-DEFDDDB5B912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614_protocol&amp;result_2800.xlsx]解析2'!$B$12:$B$1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210614_protocol&amp;result_2800.xlsx]解析2'!$N$12:$N$15</c:f>
              <c:numCache>
                <c:formatCode>General</c:formatCode>
                <c:ptCount val="4"/>
                <c:pt idx="0">
                  <c:v>1.1898027408901612</c:v>
                </c:pt>
                <c:pt idx="1">
                  <c:v>2.4296060512970126</c:v>
                </c:pt>
                <c:pt idx="2">
                  <c:v>2.2356934842869864</c:v>
                </c:pt>
                <c:pt idx="3">
                  <c:v>3.41224776880612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AE0-4B85-B10B-DEFDDDB5B912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614_protocol&amp;result_2800.xlsx]解析2'!$B$12:$B$15</c:f>
              <c:strCache>
                <c:ptCount val="4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0</c:v>
                </c:pt>
              </c:strCache>
            </c:strRef>
          </c:xVal>
          <c:yVal>
            <c:numRef>
              <c:f>'[210614_protocol&amp;result_2800.xlsx]解析2'!$O$12:$O$15</c:f>
              <c:numCache>
                <c:formatCode>General</c:formatCode>
                <c:ptCount val="4"/>
                <c:pt idx="0">
                  <c:v>0.9270521524845925</c:v>
                </c:pt>
                <c:pt idx="1">
                  <c:v>1.7662902132504921</c:v>
                </c:pt>
                <c:pt idx="2">
                  <c:v>2.1745583283891503</c:v>
                </c:pt>
                <c:pt idx="3">
                  <c:v>7.46800248109111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AE0-4B85-B10B-DEFDDDB5B9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7137512"/>
        <c:axId val="577137840"/>
      </c:scatterChart>
      <c:catAx>
        <c:axId val="577137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MG132 (μmol/L)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31192916666666665"/>
              <c:y val="0.883159999999999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137840"/>
        <c:crosses val="autoZero"/>
        <c:auto val="1"/>
        <c:lblAlgn val="ctr"/>
        <c:lblOffset val="100"/>
        <c:noMultiLvlLbl val="0"/>
      </c:catAx>
      <c:valAx>
        <c:axId val="5771378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i="1" dirty="0"/>
                  <a:t>Hspa5</a:t>
                </a:r>
                <a:r>
                  <a:rPr lang="en-US" i="1" baseline="0" dirty="0"/>
                  <a:t>/Rplp0</a:t>
                </a:r>
                <a:r>
                  <a:rPr lang="en-US" baseline="0" dirty="0"/>
                  <a:t> </a:t>
                </a:r>
                <a:r>
                  <a:rPr lang="en-US" dirty="0"/>
                  <a:t>(AU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7137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dirty="0" err="1"/>
              <a:t>BiP</a:t>
            </a:r>
            <a:r>
              <a:rPr lang="en-US" altLang="ja-JP" sz="1200" dirty="0"/>
              <a:t> mRNA</a:t>
            </a:r>
            <a:endParaRPr lang="ja-JP" alt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trellis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9BC-489B-961B-041B982DFEEB}"/>
              </c:ext>
            </c:extLst>
          </c:dPt>
          <c:dPt>
            <c:idx val="1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9BC-489B-961B-041B982DFEEB}"/>
              </c:ext>
            </c:extLst>
          </c:dPt>
          <c:dPt>
            <c:idx val="2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9BC-489B-961B-041B982DFEEB}"/>
              </c:ext>
            </c:extLst>
          </c:dPt>
          <c:dPt>
            <c:idx val="3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 w="1905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9BC-489B-961B-041B982DFEEB}"/>
              </c:ext>
            </c:extLst>
          </c:dPt>
          <c:errBars>
            <c:errBarType val="plus"/>
            <c:errValType val="cust"/>
            <c:noEndCap val="0"/>
            <c:plus>
              <c:numRef>
                <c:f>'[210702_protocol&amp;result_GRP78.xlsx]2100'!$F$17:$F$20</c:f>
                <c:numCache>
                  <c:formatCode>General</c:formatCode>
                  <c:ptCount val="4"/>
                  <c:pt idx="0">
                    <c:v>0.18427370596756487</c:v>
                  </c:pt>
                  <c:pt idx="1">
                    <c:v>0.65224298313270235</c:v>
                  </c:pt>
                  <c:pt idx="2">
                    <c:v>0.39450199131544855</c:v>
                  </c:pt>
                  <c:pt idx="3">
                    <c:v>0.691136523252053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10702_protocol&amp;result_GRP78.xlsx]2100'!$A$17:$A$20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cat>
          <c:val>
            <c:numRef>
              <c:f>'[210702_protocol&amp;result_GRP78.xlsx]2100'!$B$17:$B$20</c:f>
              <c:numCache>
                <c:formatCode>General</c:formatCode>
                <c:ptCount val="4"/>
                <c:pt idx="0">
                  <c:v>1</c:v>
                </c:pt>
                <c:pt idx="1">
                  <c:v>8.6894006862424611</c:v>
                </c:pt>
                <c:pt idx="2">
                  <c:v>8.9397825176359458</c:v>
                </c:pt>
                <c:pt idx="3">
                  <c:v>20.1408447986278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9BC-489B-961B-041B982DFE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774071768"/>
        <c:axId val="774072424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702_protocol&amp;result_GRP78.xlsx]2100'!$A$17:$A$20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xVal>
          <c:yVal>
            <c:numRef>
              <c:f>'[210702_protocol&amp;result_GRP78.xlsx]2100'!$C$17:$C$20</c:f>
              <c:numCache>
                <c:formatCode>General</c:formatCode>
                <c:ptCount val="4"/>
                <c:pt idx="0">
                  <c:v>0.80448603140557762</c:v>
                </c:pt>
                <c:pt idx="1">
                  <c:v>9.4882319347353938</c:v>
                </c:pt>
                <c:pt idx="2">
                  <c:v>8.6107522308643443</c:v>
                </c:pt>
                <c:pt idx="3">
                  <c:v>18.5859338901846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89BC-489B-961B-041B982DFEEB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702_protocol&amp;result_GRP78.xlsx]2100'!$A$17:$A$20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xVal>
          <c:yVal>
            <c:numRef>
              <c:f>'[210702_protocol&amp;result_GRP78.xlsx]2100'!$D$17:$D$20</c:f>
              <c:numCache>
                <c:formatCode>General</c:formatCode>
                <c:ptCount val="4"/>
                <c:pt idx="0">
                  <c:v>1.4500868159364537</c:v>
                </c:pt>
                <c:pt idx="1">
                  <c:v>9.4882319347353938</c:v>
                </c:pt>
                <c:pt idx="2">
                  <c:v>8.3174383991625547</c:v>
                </c:pt>
                <c:pt idx="3">
                  <c:v>20.3384703880775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89BC-489B-961B-041B982DFEEB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xVal>
            <c:strRef>
              <c:f>'[210702_protocol&amp;result_GRP78.xlsx]2100'!$A$17:$A$20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xVal>
          <c:yVal>
            <c:numRef>
              <c:f>'[210702_protocol&amp;result_GRP78.xlsx]2100'!$E$17:$E$20</c:f>
              <c:numCache>
                <c:formatCode>General</c:formatCode>
                <c:ptCount val="4"/>
                <c:pt idx="0">
                  <c:v>0.74542715265796866</c:v>
                </c:pt>
                <c:pt idx="1">
                  <c:v>7.0917381892565992</c:v>
                </c:pt>
                <c:pt idx="2">
                  <c:v>9.8911569228809384</c:v>
                </c:pt>
                <c:pt idx="3">
                  <c:v>21.4981301176213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89BC-489B-961B-041B982DFE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74071768"/>
        <c:axId val="774072424"/>
      </c:scatterChart>
      <c:catAx>
        <c:axId val="7740717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hapsigargin </a:t>
                </a:r>
                <a:r>
                  <a:rPr lang="en-US" dirty="0"/>
                  <a:t>(</a:t>
                </a:r>
                <a:r>
                  <a:rPr lang="en-US" dirty="0" err="1"/>
                  <a:t>μmol</a:t>
                </a:r>
                <a:r>
                  <a:rPr lang="en-US" dirty="0"/>
                  <a:t>/L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4072424"/>
        <c:crosses val="autoZero"/>
        <c:auto val="1"/>
        <c:lblAlgn val="ctr"/>
        <c:lblOffset val="100"/>
        <c:noMultiLvlLbl val="0"/>
      </c:catAx>
      <c:valAx>
        <c:axId val="774072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i="1" dirty="0"/>
                  <a:t>Hspa5/Rplp0</a:t>
                </a:r>
                <a:r>
                  <a:rPr lang="en-US" dirty="0"/>
                  <a:t> (AU)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4071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1200" i="1" dirty="0" smtClean="0"/>
              <a:t>Xbp1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splicing</a:t>
            </a:r>
            <a:endParaRPr lang="ja-JP" alt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trellis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EEB-4438-AABF-490B9A9A706F}"/>
              </c:ext>
            </c:extLst>
          </c:dPt>
          <c:dPt>
            <c:idx val="1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EEB-4438-AABF-490B9A9A706F}"/>
              </c:ext>
            </c:extLst>
          </c:dPt>
          <c:dPt>
            <c:idx val="2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EEB-4438-AABF-490B9A9A706F}"/>
              </c:ext>
            </c:extLst>
          </c:dPt>
          <c:dPt>
            <c:idx val="3"/>
            <c:invertIfNegative val="0"/>
            <c:bubble3D val="0"/>
            <c:spPr>
              <a:pattFill prst="smCheck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EEB-4438-AABF-490B9A9A706F}"/>
              </c:ext>
            </c:extLst>
          </c:dPt>
          <c:errBars>
            <c:errBarType val="plus"/>
            <c:errValType val="cust"/>
            <c:noEndCap val="0"/>
            <c:plus>
              <c:numRef>
                <c:f>[XBP1定量.xlsx]Sheet2!$L$22:$L$25</c:f>
                <c:numCache>
                  <c:formatCode>General</c:formatCode>
                  <c:ptCount val="4"/>
                  <c:pt idx="0">
                    <c:v>0.71521366714056867</c:v>
                  </c:pt>
                  <c:pt idx="1">
                    <c:v>3.6565375368695729</c:v>
                  </c:pt>
                  <c:pt idx="2">
                    <c:v>2.7093736789613345</c:v>
                  </c:pt>
                  <c:pt idx="3">
                    <c:v>2.86763508402238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XBP1定量.xlsx]Sheet2!$G$22:$G$25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cat>
          <c:val>
            <c:numRef>
              <c:f>[XBP1定量.xlsx]Sheet2!$H$22:$H$25</c:f>
              <c:numCache>
                <c:formatCode>General</c:formatCode>
                <c:ptCount val="4"/>
                <c:pt idx="0">
                  <c:v>42.317921738043957</c:v>
                </c:pt>
                <c:pt idx="1">
                  <c:v>33.036113042991282</c:v>
                </c:pt>
                <c:pt idx="2">
                  <c:v>79.866379723058614</c:v>
                </c:pt>
                <c:pt idx="3">
                  <c:v>78.9604223805507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EEB-4438-AABF-490B9A9A70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526063864"/>
        <c:axId val="526059600"/>
      </c:barChart>
      <c:scatterChart>
        <c:scatterStyle val="lineMarker"/>
        <c:varyColors val="0"/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>
                    <a:alpha val="98000"/>
                  </a:schemeClr>
                </a:solidFill>
              </a:ln>
              <a:effectLst/>
            </c:spPr>
          </c:marker>
          <c:xVal>
            <c:strRef>
              <c:f>[XBP1定量.xlsx]Sheet2!$G$22:$G$25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xVal>
          <c:yVal>
            <c:numRef>
              <c:f>[XBP1定量.xlsx]Sheet2!$I$22:$I$25</c:f>
              <c:numCache>
                <c:formatCode>General</c:formatCode>
                <c:ptCount val="4"/>
                <c:pt idx="0">
                  <c:v>42.901667026121885</c:v>
                </c:pt>
                <c:pt idx="1">
                  <c:v>38.544397275736223</c:v>
                </c:pt>
                <c:pt idx="2">
                  <c:v>73.762549183204868</c:v>
                </c:pt>
                <c:pt idx="3">
                  <c:v>81.3571668350798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EEEB-4438-AABF-490B9A9A706F}"/>
            </c:ext>
          </c:extLst>
        </c:ser>
        <c:ser>
          <c:idx val="2"/>
          <c:order val="2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[XBP1定量.xlsx]Sheet2!$G$22:$G$25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xVal>
          <c:yVal>
            <c:numRef>
              <c:f>[XBP1定量.xlsx]Sheet2!$J$22:$J$25</c:f>
              <c:numCache>
                <c:formatCode>General</c:formatCode>
                <c:ptCount val="4"/>
                <c:pt idx="0">
                  <c:v>43.456545068300642</c:v>
                </c:pt>
                <c:pt idx="1">
                  <c:v>36.398367253041982</c:v>
                </c:pt>
                <c:pt idx="2">
                  <c:v>85.174534198096438</c:v>
                </c:pt>
                <c:pt idx="3">
                  <c:v>83.4801531081817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EEEB-4438-AABF-490B9A9A706F}"/>
            </c:ext>
          </c:extLst>
        </c:ser>
        <c:ser>
          <c:idx val="3"/>
          <c:order val="3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strRef>
              <c:f>[XBP1定量.xlsx]Sheet2!$G$22:$G$25</c:f>
              <c:strCache>
                <c:ptCount val="4"/>
                <c:pt idx="0">
                  <c:v>0</c:v>
                </c:pt>
                <c:pt idx="1">
                  <c:v>0.1</c:v>
                </c:pt>
                <c:pt idx="2">
                  <c:v>0.3</c:v>
                </c:pt>
                <c:pt idx="3">
                  <c:v>1</c:v>
                </c:pt>
              </c:strCache>
            </c:strRef>
          </c:xVal>
          <c:yVal>
            <c:numRef>
              <c:f>[XBP1定量.xlsx]Sheet2!$K$22:$K$25</c:f>
              <c:numCache>
                <c:formatCode>General</c:formatCode>
                <c:ptCount val="4"/>
                <c:pt idx="0">
                  <c:v>40.595553119709329</c:v>
                </c:pt>
                <c:pt idx="1">
                  <c:v>24.165574600195644</c:v>
                </c:pt>
                <c:pt idx="2">
                  <c:v>80.662055787874522</c:v>
                </c:pt>
                <c:pt idx="3">
                  <c:v>72.0439471983906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EEEB-4438-AABF-490B9A9A70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6063864"/>
        <c:axId val="526059600"/>
      </c:scatterChart>
      <c:catAx>
        <c:axId val="5260638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dirty="0" err="1"/>
                  <a:t>Thapsigargin</a:t>
                </a:r>
                <a:r>
                  <a:rPr lang="en-US" altLang="ja-JP" dirty="0"/>
                  <a:t> (</a:t>
                </a:r>
                <a:r>
                  <a:rPr lang="en-US" altLang="ja-JP" dirty="0" err="1"/>
                  <a:t>μmol</a:t>
                </a:r>
                <a:r>
                  <a:rPr lang="en-US" altLang="ja-JP" dirty="0"/>
                  <a:t>/L)</a:t>
                </a:r>
                <a:endParaRPr lang="ja-JP" altLang="en-US" dirty="0"/>
              </a:p>
            </c:rich>
          </c:tx>
          <c:layout>
            <c:manualLayout>
              <c:xMode val="edge"/>
              <c:yMode val="edge"/>
              <c:x val="0.26825787037037035"/>
              <c:y val="0.83286172839506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26059600"/>
        <c:crosses val="autoZero"/>
        <c:auto val="1"/>
        <c:lblAlgn val="ctr"/>
        <c:lblOffset val="100"/>
        <c:noMultiLvlLbl val="0"/>
      </c:catAx>
      <c:valAx>
        <c:axId val="526059600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% spliced </a:t>
                </a:r>
                <a:r>
                  <a:rPr lang="en-US" i="1" dirty="0" smtClean="0"/>
                  <a:t>Xbp1 </a:t>
                </a:r>
                <a:r>
                  <a:rPr lang="en-US" dirty="0"/>
                  <a:t>amplicons</a:t>
                </a:r>
                <a:endParaRPr lang="ja-JP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2606386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4958</cdr:x>
      <cdr:y>0.50384</cdr:y>
    </cdr:from>
    <cdr:to>
      <cdr:x>0.60681</cdr:x>
      <cdr:y>0.60106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971086" y="1243378"/>
          <a:ext cx="339615" cy="2399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altLang="ja-JP" sz="11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 dirty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2544</cdr:x>
      <cdr:y>0.43304</cdr:y>
    </cdr:from>
    <cdr:to>
      <cdr:x>0.74211</cdr:x>
      <cdr:y>0.53026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350950" y="1068665"/>
          <a:ext cx="252007" cy="2399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1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 dirty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3422</cdr:x>
      <cdr:y>0.10289</cdr:y>
    </cdr:from>
    <cdr:to>
      <cdr:x>0.96366</cdr:x>
      <cdr:y>0.20011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585923" y="253916"/>
          <a:ext cx="495574" cy="2399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100" b="1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51457</cdr:x>
      <cdr:y>0.23684</cdr:y>
    </cdr:from>
    <cdr:to>
      <cdr:x>0.73304</cdr:x>
      <cdr:y>0.3378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111473" y="479594"/>
          <a:ext cx="471903" cy="2044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559</cdr:x>
      <cdr:y>0.19117</cdr:y>
    </cdr:from>
    <cdr:to>
      <cdr:x>0.82565</cdr:x>
      <cdr:y>0.2825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416751" y="387129"/>
          <a:ext cx="366662" cy="1849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0264</cdr:x>
      <cdr:y>0.16264</cdr:y>
    </cdr:from>
    <cdr:to>
      <cdr:x>0.94388</cdr:x>
      <cdr:y>0.24231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2311593" y="439125"/>
          <a:ext cx="406771" cy="2151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53716</cdr:x>
      <cdr:y>0.19722</cdr:y>
    </cdr:from>
    <cdr:to>
      <cdr:x>0.68551</cdr:x>
      <cdr:y>0.29907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160258" y="399371"/>
          <a:ext cx="320436" cy="2062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6714</cdr:x>
      <cdr:y>0.27506</cdr:y>
    </cdr:from>
    <cdr:to>
      <cdr:x>0.82729</cdr:x>
      <cdr:y>0.37691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441014" y="556997"/>
          <a:ext cx="345927" cy="2062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9106</cdr:x>
      <cdr:y>0.36454</cdr:y>
    </cdr:from>
    <cdr:to>
      <cdr:x>0.97</cdr:x>
      <cdr:y>0.46639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708690" y="738197"/>
          <a:ext cx="386510" cy="2062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.47159</cdr:x>
      <cdr:y>0.45817</cdr:y>
    </cdr:from>
    <cdr:to>
      <cdr:x>0.65876</cdr:x>
      <cdr:y>0.56233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511034" y="903391"/>
          <a:ext cx="599710" cy="2053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6392</cdr:x>
      <cdr:y>0.41179</cdr:y>
    </cdr:from>
    <cdr:to>
      <cdr:x>0.95789</cdr:x>
      <cdr:y>0.48895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2768084" y="811942"/>
          <a:ext cx="301089" cy="1521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21318</cdr:x>
      <cdr:y>0.24301</cdr:y>
    </cdr:from>
    <cdr:to>
      <cdr:x>0.38843</cdr:x>
      <cdr:y>0.41981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683046" y="479150"/>
          <a:ext cx="561517" cy="34860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dirty="0"/>
            <a:t>***</a:t>
          </a:r>
          <a:endParaRPr lang="ja-JP" altLang="en-US" sz="1100" dirty="0"/>
        </a:p>
      </cdr:txBody>
    </cdr:sp>
  </cdr:relSizeAnchor>
  <cdr:relSizeAnchor xmlns:cdr="http://schemas.openxmlformats.org/drawingml/2006/chartDrawing">
    <cdr:from>
      <cdr:x>0.28994</cdr:x>
      <cdr:y>0.23518</cdr:y>
    </cdr:from>
    <cdr:to>
      <cdr:x>0.4646</cdr:x>
      <cdr:y>0.36199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929001" y="463724"/>
          <a:ext cx="559635" cy="2500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dirty="0"/>
            <a:t>***</a:t>
          </a:r>
          <a:endParaRPr lang="ja-JP" altLang="en-US" sz="1100" dirty="0"/>
        </a:p>
      </cdr:txBody>
    </cdr:sp>
  </cdr:relSizeAnchor>
  <cdr:relSizeAnchor xmlns:cdr="http://schemas.openxmlformats.org/drawingml/2006/chartDrawing">
    <cdr:from>
      <cdr:x>0.4646</cdr:x>
      <cdr:y>0.3796</cdr:y>
    </cdr:from>
    <cdr:to>
      <cdr:x>0.60979</cdr:x>
      <cdr:y>0.45429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488636" y="748468"/>
          <a:ext cx="465197" cy="14728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dirty="0"/>
            <a:t>**</a:t>
          </a:r>
          <a:endParaRPr lang="ja-JP" altLang="en-US" sz="1100" dirty="0"/>
        </a:p>
      </cdr:txBody>
    </cdr:sp>
  </cdr:relSizeAnchor>
  <cdr:relSizeAnchor xmlns:cdr="http://schemas.openxmlformats.org/drawingml/2006/chartDrawing">
    <cdr:from>
      <cdr:x>0.87636</cdr:x>
      <cdr:y>0.34256</cdr:y>
    </cdr:from>
    <cdr:to>
      <cdr:x>0.99025</cdr:x>
      <cdr:y>0.45429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2807936" y="675434"/>
          <a:ext cx="364914" cy="2203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dirty="0"/>
            <a:t>**</a:t>
          </a:r>
          <a:endParaRPr lang="ja-JP" altLang="en-US" sz="1100" dirty="0"/>
        </a:p>
      </cdr:txBody>
    </cdr:sp>
  </cdr:relSizeAnchor>
  <cdr:relSizeAnchor xmlns:cdr="http://schemas.openxmlformats.org/drawingml/2006/chartDrawing">
    <cdr:from>
      <cdr:x>0.34439</cdr:x>
      <cdr:y>0.10146</cdr:y>
    </cdr:from>
    <cdr:to>
      <cdr:x>0.49025</cdr:x>
      <cdr:y>0.24066</cdr:y>
    </cdr:to>
    <cdr:sp macro="" textlink="">
      <cdr:nvSpPr>
        <cdr:cNvPr id="6" name="テキスト ボックス 1"/>
        <cdr:cNvSpPr txBox="1"/>
      </cdr:nvSpPr>
      <cdr:spPr>
        <a:xfrm xmlns:a="http://schemas.openxmlformats.org/drawingml/2006/main">
          <a:off x="1103470" y="200055"/>
          <a:ext cx="467332" cy="27445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dirty="0"/>
            <a:t>***</a:t>
          </a:r>
          <a:endParaRPr lang="ja-JP" altLang="en-US" sz="1100" dirty="0"/>
        </a:p>
      </cdr:txBody>
    </cdr:sp>
  </cdr:relSizeAnchor>
  <cdr:relSizeAnchor xmlns:cdr="http://schemas.openxmlformats.org/drawingml/2006/chartDrawing">
    <cdr:from>
      <cdr:x>0.29059</cdr:x>
      <cdr:y>0.20564</cdr:y>
    </cdr:from>
    <cdr:to>
      <cdr:x>0.51364</cdr:x>
      <cdr:y>0.20564</cdr:y>
    </cdr:to>
    <cdr:cxnSp macro="">
      <cdr:nvCxnSpPr>
        <cdr:cNvPr id="8" name="直線コネクタ 7">
          <a:extLst xmlns:a="http://schemas.openxmlformats.org/drawingml/2006/main">
            <a:ext uri="{FF2B5EF4-FFF2-40B4-BE49-F238E27FC236}">
              <a16:creationId xmlns:a16="http://schemas.microsoft.com/office/drawing/2014/main" id="{92767043-68B4-8277-7965-5B0C13E65C92}"/>
            </a:ext>
          </a:extLst>
        </cdr:cNvPr>
        <cdr:cNvCxnSpPr/>
      </cdr:nvCxnSpPr>
      <cdr:spPr>
        <a:xfrm xmlns:a="http://schemas.openxmlformats.org/drawingml/2006/main">
          <a:off x="931072" y="405472"/>
          <a:ext cx="714680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14.xml><?xml version="1.0" encoding="utf-8"?>
<c:userShapes xmlns:c="http://schemas.openxmlformats.org/drawingml/2006/chart">
  <cdr:relSizeAnchor xmlns:cdr="http://schemas.openxmlformats.org/drawingml/2006/chartDrawing">
    <cdr:from>
      <cdr:x>0.89492</cdr:x>
      <cdr:y>0.40063</cdr:y>
    </cdr:from>
    <cdr:to>
      <cdr:x>0.98889</cdr:x>
      <cdr:y>0.47779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4091589" y="1098998"/>
          <a:ext cx="429631" cy="2116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15.xml><?xml version="1.0" encoding="utf-8"?>
<c:userShapes xmlns:c="http://schemas.openxmlformats.org/drawingml/2006/chart">
  <cdr:relSizeAnchor xmlns:cdr="http://schemas.openxmlformats.org/drawingml/2006/chartDrawing">
    <cdr:from>
      <cdr:x>0.89492</cdr:x>
      <cdr:y>0.40063</cdr:y>
    </cdr:from>
    <cdr:to>
      <cdr:x>0.98889</cdr:x>
      <cdr:y>0.47779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4091589" y="1098998"/>
          <a:ext cx="429631" cy="2116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16.xml><?xml version="1.0" encoding="utf-8"?>
<c:userShapes xmlns:c="http://schemas.openxmlformats.org/drawingml/2006/chart">
  <cdr:relSizeAnchor xmlns:cdr="http://schemas.openxmlformats.org/drawingml/2006/chartDrawing">
    <cdr:from>
      <cdr:x>0.90257</cdr:x>
      <cdr:y>0.36698</cdr:y>
    </cdr:from>
    <cdr:to>
      <cdr:x>0.99654</cdr:x>
      <cdr:y>0.44414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4132095" y="1002832"/>
          <a:ext cx="430207" cy="2108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17.xml><?xml version="1.0" encoding="utf-8"?>
<c:userShapes xmlns:c="http://schemas.openxmlformats.org/drawingml/2006/chart">
  <cdr:relSizeAnchor xmlns:cdr="http://schemas.openxmlformats.org/drawingml/2006/chartDrawing">
    <cdr:from>
      <cdr:x>0.8368</cdr:x>
      <cdr:y>0.44213</cdr:y>
    </cdr:from>
    <cdr:to>
      <cdr:x>0.92153</cdr:x>
      <cdr:y>0.53472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3825860" y="1212862"/>
          <a:ext cx="387385" cy="2539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0903</cdr:x>
      <cdr:y>0.22222</cdr:y>
    </cdr:from>
    <cdr:to>
      <cdr:x>0.53681</cdr:x>
      <cdr:y>0.31481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870075" y="609600"/>
          <a:ext cx="584200" cy="254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/>
            <a:t>n.s.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125</cdr:x>
      <cdr:y>0.40741</cdr:y>
    </cdr:from>
    <cdr:to>
      <cdr:x>0.74028</cdr:x>
      <cdr:y>0.5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2800350" y="1117600"/>
          <a:ext cx="584200" cy="254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.s.</a:t>
          </a:r>
          <a:endParaRPr lang="ja-JP" altLang="en-US" sz="1100"/>
        </a:p>
      </cdr:txBody>
    </cdr:sp>
  </cdr:relSizeAnchor>
</c:userShapes>
</file>

<file path=ppt/drawings/drawing18.xml><?xml version="1.0" encoding="utf-8"?>
<c:userShapes xmlns:c="http://schemas.openxmlformats.org/drawingml/2006/chart">
  <cdr:relSizeAnchor xmlns:cdr="http://schemas.openxmlformats.org/drawingml/2006/chartDrawing">
    <cdr:from>
      <cdr:x>0.83611</cdr:x>
      <cdr:y>0.5162</cdr:y>
    </cdr:from>
    <cdr:to>
      <cdr:x>0.92361</cdr:x>
      <cdr:y>0.60417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3822700" y="1416043"/>
          <a:ext cx="400050" cy="2413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0556</cdr:x>
      <cdr:y>0.16667</cdr:y>
    </cdr:from>
    <cdr:to>
      <cdr:x>0.53333</cdr:x>
      <cdr:y>0.25926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854200" y="457200"/>
          <a:ext cx="584200" cy="254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.s.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1111</cdr:x>
      <cdr:y>0.32176</cdr:y>
    </cdr:from>
    <cdr:to>
      <cdr:x>0.73889</cdr:x>
      <cdr:y>0.41435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2794000" y="882650"/>
          <a:ext cx="584200" cy="254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.s.</a:t>
          </a:r>
          <a:endParaRPr lang="ja-JP" altLang="en-US" sz="1100"/>
        </a:p>
      </cdr:txBody>
    </cdr:sp>
  </cdr:relSizeAnchor>
</c:userShapes>
</file>

<file path=ppt/drawings/drawing19.xml><?xml version="1.0" encoding="utf-8"?>
<c:userShapes xmlns:c="http://schemas.openxmlformats.org/drawingml/2006/chart">
  <cdr:relSizeAnchor xmlns:cdr="http://schemas.openxmlformats.org/drawingml/2006/chartDrawing">
    <cdr:from>
      <cdr:x>0.83958</cdr:x>
      <cdr:y>0.33567</cdr:y>
    </cdr:from>
    <cdr:to>
      <cdr:x>0.92431</cdr:x>
      <cdr:y>0.4282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3838560" y="920820"/>
          <a:ext cx="387385" cy="2539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1233</cdr:x>
      <cdr:y>0.12715</cdr:y>
    </cdr:from>
    <cdr:to>
      <cdr:x>0.54011</cdr:x>
      <cdr:y>0.21974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885152" y="348791"/>
          <a:ext cx="584210" cy="2539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2111</cdr:x>
      <cdr:y>0.2005</cdr:y>
    </cdr:from>
    <cdr:to>
      <cdr:x>0.74888</cdr:x>
      <cdr:y>0.2931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2839730" y="550015"/>
          <a:ext cx="584165" cy="2540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60637</cdr:x>
      <cdr:y>0.1445</cdr:y>
    </cdr:from>
    <cdr:to>
      <cdr:x>0.72304</cdr:x>
      <cdr:y>0.24172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746339" y="475449"/>
          <a:ext cx="336010" cy="3198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1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 dirty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3088</cdr:x>
      <cdr:y>0.49467</cdr:y>
    </cdr:from>
    <cdr:to>
      <cdr:x>0.95509</cdr:x>
      <cdr:y>0.59189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578707" y="1220743"/>
          <a:ext cx="484295" cy="2399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100" b="1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1108</cdr:x>
      <cdr:y>0.35985</cdr:y>
    </cdr:from>
    <cdr:to>
      <cdr:x>0.64992</cdr:x>
      <cdr:y>0.45707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887933" y="888043"/>
          <a:ext cx="515894" cy="2399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100" b="1" dirty="0" err="1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0.xml><?xml version="1.0" encoding="utf-8"?>
<c:userShapes xmlns:c="http://schemas.openxmlformats.org/drawingml/2006/chart">
  <cdr:relSizeAnchor xmlns:cdr="http://schemas.openxmlformats.org/drawingml/2006/chartDrawing">
    <cdr:from>
      <cdr:x>0.63194</cdr:x>
      <cdr:y>0.36136</cdr:y>
    </cdr:from>
    <cdr:to>
      <cdr:x>0.68572</cdr:x>
      <cdr:y>0.45164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2889241" y="991291"/>
          <a:ext cx="245866" cy="2476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2971</cdr:x>
      <cdr:y>0.40766</cdr:y>
    </cdr:from>
    <cdr:to>
      <cdr:x>0.90794</cdr:x>
      <cdr:y>0.48032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3793455" y="1118288"/>
          <a:ext cx="357651" cy="1993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1056</cdr:x>
      <cdr:y>0.12465</cdr:y>
    </cdr:from>
    <cdr:to>
      <cdr:x>0.53833</cdr:x>
      <cdr:y>0.21724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877089" y="341937"/>
          <a:ext cx="584165" cy="2539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1.xml><?xml version="1.0" encoding="utf-8"?>
<c:userShapes xmlns:c="http://schemas.openxmlformats.org/drawingml/2006/chart">
  <cdr:relSizeAnchor xmlns:cdr="http://schemas.openxmlformats.org/drawingml/2006/chartDrawing">
    <cdr:from>
      <cdr:x>0.83611</cdr:x>
      <cdr:y>0.5162</cdr:y>
    </cdr:from>
    <cdr:to>
      <cdr:x>0.92361</cdr:x>
      <cdr:y>0.60417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3822700" y="1416043"/>
          <a:ext cx="400050" cy="2413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1955</cdr:x>
      <cdr:y>0.10629</cdr:y>
    </cdr:from>
    <cdr:to>
      <cdr:x>0.54732</cdr:x>
      <cdr:y>0.19888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918196" y="291587"/>
          <a:ext cx="584164" cy="2539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1973</cdr:x>
      <cdr:y>0.37172</cdr:y>
    </cdr:from>
    <cdr:to>
      <cdr:x>0.74751</cdr:x>
      <cdr:y>0.46431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2833400" y="1019713"/>
          <a:ext cx="584211" cy="2539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2.xml><?xml version="1.0" encoding="utf-8"?>
<c:userShapes xmlns:c="http://schemas.openxmlformats.org/drawingml/2006/chart">
  <cdr:relSizeAnchor xmlns:cdr="http://schemas.openxmlformats.org/drawingml/2006/chartDrawing">
    <cdr:from>
      <cdr:x>0.79686</cdr:x>
      <cdr:y>0.5162</cdr:y>
    </cdr:from>
    <cdr:to>
      <cdr:x>0.92361</cdr:x>
      <cdr:y>0.60334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3155557" y="1416040"/>
          <a:ext cx="501939" cy="2390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dirty="0" err="1"/>
            <a:t>n.s</a:t>
          </a:r>
          <a:r>
            <a:rPr lang="en-US" altLang="ja-JP" sz="1100" dirty="0"/>
            <a:t>.</a:t>
          </a:r>
          <a:endParaRPr lang="ja-JP" altLang="en-US" sz="1100" dirty="0"/>
        </a:p>
      </cdr:txBody>
    </cdr:sp>
  </cdr:relSizeAnchor>
  <cdr:relSizeAnchor xmlns:cdr="http://schemas.openxmlformats.org/drawingml/2006/chartDrawing">
    <cdr:from>
      <cdr:x>0.41528</cdr:x>
      <cdr:y>0.29861</cdr:y>
    </cdr:from>
    <cdr:to>
      <cdr:x>0.54305</cdr:x>
      <cdr:y>0.3912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898670" y="819159"/>
          <a:ext cx="584165" cy="2539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.s.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59749</cdr:x>
      <cdr:y>0.48973</cdr:y>
    </cdr:from>
    <cdr:to>
      <cdr:x>0.72527</cdr:x>
      <cdr:y>0.58232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2366057" y="1343416"/>
          <a:ext cx="506009" cy="2539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dirty="0" err="1"/>
            <a:t>n.s</a:t>
          </a:r>
          <a:r>
            <a:rPr lang="en-US" altLang="ja-JP" sz="1100" dirty="0"/>
            <a:t>.</a:t>
          </a:r>
          <a:endParaRPr lang="ja-JP" altLang="en-US" sz="1100" dirty="0"/>
        </a:p>
      </cdr:txBody>
    </cdr:sp>
  </cdr:relSizeAnchor>
</c:userShapes>
</file>

<file path=ppt/drawings/drawing23.xml><?xml version="1.0" encoding="utf-8"?>
<c:userShapes xmlns:c="http://schemas.openxmlformats.org/drawingml/2006/chart">
  <cdr:relSizeAnchor xmlns:cdr="http://schemas.openxmlformats.org/drawingml/2006/chartDrawing">
    <cdr:from>
      <cdr:x>0.39236</cdr:x>
      <cdr:y>0.36343</cdr:y>
    </cdr:from>
    <cdr:to>
      <cdr:x>0.5243</cdr:x>
      <cdr:y>0.44908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793890" y="996949"/>
          <a:ext cx="603230" cy="23495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600" b="1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6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4305</cdr:x>
      <cdr:y>0.33565</cdr:y>
    </cdr:from>
    <cdr:to>
      <cdr:x>0.70347</cdr:x>
      <cdr:y>0.41435</cdr:y>
    </cdr:to>
    <cdr:sp macro="" textlink="">
      <cdr:nvSpPr>
        <cdr:cNvPr id="8" name="テキスト ボックス 1"/>
        <cdr:cNvSpPr txBox="1"/>
      </cdr:nvSpPr>
      <cdr:spPr>
        <a:xfrm xmlns:a="http://schemas.openxmlformats.org/drawingml/2006/main">
          <a:off x="2940036" y="920755"/>
          <a:ext cx="276240" cy="2158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600" b="1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6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0139</cdr:x>
      <cdr:y>0.5162</cdr:y>
    </cdr:from>
    <cdr:to>
      <cdr:x>0.88542</cdr:x>
      <cdr:y>0.59722</cdr:y>
    </cdr:to>
    <cdr:sp macro="" textlink="">
      <cdr:nvSpPr>
        <cdr:cNvPr id="9" name="テキスト ボックス 1"/>
        <cdr:cNvSpPr txBox="1"/>
      </cdr:nvSpPr>
      <cdr:spPr>
        <a:xfrm xmlns:a="http://schemas.openxmlformats.org/drawingml/2006/main">
          <a:off x="3663949" y="1416050"/>
          <a:ext cx="384175" cy="2222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600" b="1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6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4.xml><?xml version="1.0" encoding="utf-8"?>
<c:userShapes xmlns:c="http://schemas.openxmlformats.org/drawingml/2006/chart">
  <cdr:relSizeAnchor xmlns:cdr="http://schemas.openxmlformats.org/drawingml/2006/chartDrawing">
    <cdr:from>
      <cdr:x>0.60466</cdr:x>
      <cdr:y>0.32527</cdr:y>
    </cdr:from>
    <cdr:to>
      <cdr:x>0.69986</cdr:x>
      <cdr:y>0.39785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2764500" y="892290"/>
          <a:ext cx="435255" cy="1991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2484</cdr:x>
      <cdr:y>0.2346</cdr:y>
    </cdr:from>
    <cdr:to>
      <cdr:x>0.92005</cdr:x>
      <cdr:y>0.30718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3771158" y="643563"/>
          <a:ext cx="435300" cy="1991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2726</cdr:x>
      <cdr:y>0.22581</cdr:y>
    </cdr:from>
    <cdr:to>
      <cdr:x>0.85665</cdr:x>
      <cdr:y>0.22581</cdr:y>
    </cdr:to>
    <cdr:cxnSp macro="">
      <cdr:nvCxnSpPr>
        <cdr:cNvPr id="5" name="直線コネクタ 4">
          <a:extLst xmlns:a="http://schemas.openxmlformats.org/drawingml/2006/main">
            <a:ext uri="{FF2B5EF4-FFF2-40B4-BE49-F238E27FC236}">
              <a16:creationId xmlns:a16="http://schemas.microsoft.com/office/drawing/2014/main" id="{42E8E10C-F02C-0A17-9E39-F12ABA43355A}"/>
            </a:ext>
          </a:extLst>
        </cdr:cNvPr>
        <cdr:cNvCxnSpPr/>
      </cdr:nvCxnSpPr>
      <cdr:spPr>
        <a:xfrm xmlns:a="http://schemas.openxmlformats.org/drawingml/2006/main" flipV="1">
          <a:off x="2854698" y="627530"/>
          <a:ext cx="1044000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9654</cdr:x>
      <cdr:y>0.32085</cdr:y>
    </cdr:from>
    <cdr:to>
      <cdr:x>0.49219</cdr:x>
      <cdr:y>0.39249</cdr:y>
    </cdr:to>
    <cdr:sp macro="" textlink="">
      <cdr:nvSpPr>
        <cdr:cNvPr id="7" name="テキスト ボックス 1"/>
        <cdr:cNvSpPr txBox="1"/>
      </cdr:nvSpPr>
      <cdr:spPr>
        <a:xfrm xmlns:a="http://schemas.openxmlformats.org/drawingml/2006/main">
          <a:off x="1812961" y="880158"/>
          <a:ext cx="437311" cy="1965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0556</cdr:x>
      <cdr:y>0.13889</cdr:y>
    </cdr:from>
    <cdr:to>
      <cdr:x>0.80121</cdr:x>
      <cdr:y>0.21053</cdr:y>
    </cdr:to>
    <cdr:sp macro="" textlink="">
      <cdr:nvSpPr>
        <cdr:cNvPr id="8" name="テキスト ボックス 1"/>
        <cdr:cNvSpPr txBox="1"/>
      </cdr:nvSpPr>
      <cdr:spPr>
        <a:xfrm xmlns:a="http://schemas.openxmlformats.org/drawingml/2006/main">
          <a:off x="3225800" y="381000"/>
          <a:ext cx="437311" cy="1965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5.xml><?xml version="1.0" encoding="utf-8"?>
<c:userShapes xmlns:c="http://schemas.openxmlformats.org/drawingml/2006/chart">
  <cdr:relSizeAnchor xmlns:cdr="http://schemas.openxmlformats.org/drawingml/2006/chartDrawing">
    <cdr:from>
      <cdr:x>0.60466</cdr:x>
      <cdr:y>0.32527</cdr:y>
    </cdr:from>
    <cdr:to>
      <cdr:x>0.69986</cdr:x>
      <cdr:y>0.39785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2764500" y="892290"/>
          <a:ext cx="435255" cy="1991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2345</cdr:x>
      <cdr:y>0.21377</cdr:y>
    </cdr:from>
    <cdr:to>
      <cdr:x>0.91866</cdr:x>
      <cdr:y>0.28635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3764818" y="586405"/>
          <a:ext cx="435301" cy="1991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2726</cdr:x>
      <cdr:y>0.22581</cdr:y>
    </cdr:from>
    <cdr:to>
      <cdr:x>0.85665</cdr:x>
      <cdr:y>0.22581</cdr:y>
    </cdr:to>
    <cdr:cxnSp macro="">
      <cdr:nvCxnSpPr>
        <cdr:cNvPr id="5" name="直線コネクタ 4">
          <a:extLst xmlns:a="http://schemas.openxmlformats.org/drawingml/2006/main">
            <a:ext uri="{FF2B5EF4-FFF2-40B4-BE49-F238E27FC236}">
              <a16:creationId xmlns:a16="http://schemas.microsoft.com/office/drawing/2014/main" id="{64C8EA67-FB24-7AED-E90A-62EA8E9ADBC1}"/>
            </a:ext>
          </a:extLst>
        </cdr:cNvPr>
        <cdr:cNvCxnSpPr/>
      </cdr:nvCxnSpPr>
      <cdr:spPr>
        <a:xfrm xmlns:a="http://schemas.openxmlformats.org/drawingml/2006/main" flipV="1">
          <a:off x="2854698" y="627530"/>
          <a:ext cx="1044000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9654</cdr:x>
      <cdr:y>0.32085</cdr:y>
    </cdr:from>
    <cdr:to>
      <cdr:x>0.49219</cdr:x>
      <cdr:y>0.39249</cdr:y>
    </cdr:to>
    <cdr:sp macro="" textlink="">
      <cdr:nvSpPr>
        <cdr:cNvPr id="7" name="テキスト ボックス 1"/>
        <cdr:cNvSpPr txBox="1"/>
      </cdr:nvSpPr>
      <cdr:spPr>
        <a:xfrm xmlns:a="http://schemas.openxmlformats.org/drawingml/2006/main">
          <a:off x="1812961" y="880158"/>
          <a:ext cx="437311" cy="1965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0556</cdr:x>
      <cdr:y>0.13889</cdr:y>
    </cdr:from>
    <cdr:to>
      <cdr:x>0.80121</cdr:x>
      <cdr:y>0.21053</cdr:y>
    </cdr:to>
    <cdr:sp macro="" textlink="">
      <cdr:nvSpPr>
        <cdr:cNvPr id="8" name="テキスト ボックス 1"/>
        <cdr:cNvSpPr txBox="1"/>
      </cdr:nvSpPr>
      <cdr:spPr>
        <a:xfrm xmlns:a="http://schemas.openxmlformats.org/drawingml/2006/main">
          <a:off x="3225800" y="381000"/>
          <a:ext cx="437311" cy="1965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6.xml><?xml version="1.0" encoding="utf-8"?>
<c:userShapes xmlns:c="http://schemas.openxmlformats.org/drawingml/2006/chart">
  <cdr:relSizeAnchor xmlns:cdr="http://schemas.openxmlformats.org/drawingml/2006/chartDrawing">
    <cdr:from>
      <cdr:x>0.61299</cdr:x>
      <cdr:y>0.21184</cdr:y>
    </cdr:from>
    <cdr:to>
      <cdr:x>0.70819</cdr:x>
      <cdr:y>0.28442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2802606" y="581131"/>
          <a:ext cx="435254" cy="1991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2345</cdr:x>
      <cdr:y>0.21377</cdr:y>
    </cdr:from>
    <cdr:to>
      <cdr:x>0.91866</cdr:x>
      <cdr:y>0.28635</cdr:y>
    </cdr:to>
    <cdr:sp macro="" textlink="">
      <cdr:nvSpPr>
        <cdr:cNvPr id="6" name="テキスト ボックス 1"/>
        <cdr:cNvSpPr txBox="1"/>
      </cdr:nvSpPr>
      <cdr:spPr>
        <a:xfrm xmlns:a="http://schemas.openxmlformats.org/drawingml/2006/main">
          <a:off x="3764818" y="586405"/>
          <a:ext cx="435301" cy="1991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2726</cdr:x>
      <cdr:y>0.22581</cdr:y>
    </cdr:from>
    <cdr:to>
      <cdr:x>0.85665</cdr:x>
      <cdr:y>0.22581</cdr:y>
    </cdr:to>
    <cdr:cxnSp macro="">
      <cdr:nvCxnSpPr>
        <cdr:cNvPr id="9" name="直線コネクタ 4">
          <a:extLst xmlns:a="http://schemas.openxmlformats.org/drawingml/2006/main">
            <a:ext uri="{FF2B5EF4-FFF2-40B4-BE49-F238E27FC236}">
              <a16:creationId xmlns:a16="http://schemas.microsoft.com/office/drawing/2014/main" id="{E9589D5A-D151-B4C0-89BF-242650289A7B}"/>
            </a:ext>
          </a:extLst>
        </cdr:cNvPr>
        <cdr:cNvCxnSpPr/>
      </cdr:nvCxnSpPr>
      <cdr:spPr>
        <a:xfrm xmlns:a="http://schemas.openxmlformats.org/drawingml/2006/main" flipV="1">
          <a:off x="2854698" y="627530"/>
          <a:ext cx="1044000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9793</cdr:x>
      <cdr:y>0.24909</cdr:y>
    </cdr:from>
    <cdr:to>
      <cdr:x>0.49358</cdr:x>
      <cdr:y>0.32073</cdr:y>
    </cdr:to>
    <cdr:sp macro="" textlink="">
      <cdr:nvSpPr>
        <cdr:cNvPr id="10" name="テキスト ボックス 1"/>
        <cdr:cNvSpPr txBox="1"/>
      </cdr:nvSpPr>
      <cdr:spPr>
        <a:xfrm xmlns:a="http://schemas.openxmlformats.org/drawingml/2006/main">
          <a:off x="1819331" y="683306"/>
          <a:ext cx="437312" cy="1965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0556</cdr:x>
      <cdr:y>0.13889</cdr:y>
    </cdr:from>
    <cdr:to>
      <cdr:x>0.80121</cdr:x>
      <cdr:y>0.21053</cdr:y>
    </cdr:to>
    <cdr:sp macro="" textlink="">
      <cdr:nvSpPr>
        <cdr:cNvPr id="11" name="テキスト ボックス 1"/>
        <cdr:cNvSpPr txBox="1"/>
      </cdr:nvSpPr>
      <cdr:spPr>
        <a:xfrm xmlns:a="http://schemas.openxmlformats.org/drawingml/2006/main">
          <a:off x="3225800" y="381000"/>
          <a:ext cx="437311" cy="1965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>
              <a:latin typeface="Arial" panose="020B0604020202020204" pitchFamily="34" charset="0"/>
              <a:cs typeface="Arial" panose="020B0604020202020204" pitchFamily="34" charset="0"/>
            </a:rPr>
            <a:t>n.s.</a:t>
          </a:r>
          <a:endParaRPr lang="ja-JP" altLang="en-US" sz="1100" b="1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7.xml><?xml version="1.0" encoding="utf-8"?>
<c:userShapes xmlns:c="http://schemas.openxmlformats.org/drawingml/2006/chart">
  <cdr:relSizeAnchor xmlns:cdr="http://schemas.openxmlformats.org/drawingml/2006/chartDrawing">
    <cdr:from>
      <cdr:x>0.57835</cdr:x>
      <cdr:y>0.13263</cdr:y>
    </cdr:from>
    <cdr:to>
      <cdr:x>0.74797</cdr:x>
      <cdr:y>0.19614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041036" y="334226"/>
          <a:ext cx="305307" cy="1600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7289</cdr:x>
      <cdr:y>0.20706</cdr:y>
    </cdr:from>
    <cdr:to>
      <cdr:x>0.84789</cdr:x>
      <cdr:y>0.20706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939A3ABF-E226-F5FC-AA57-0C744336ECC5}"/>
            </a:ext>
          </a:extLst>
        </cdr:cNvPr>
        <cdr:cNvCxnSpPr/>
      </cdr:nvCxnSpPr>
      <cdr:spPr>
        <a:xfrm xmlns:a="http://schemas.openxmlformats.org/drawingml/2006/main" flipV="1">
          <a:off x="851206" y="521782"/>
          <a:ext cx="675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28.xml><?xml version="1.0" encoding="utf-8"?>
<c:userShapes xmlns:c="http://schemas.openxmlformats.org/drawingml/2006/chart">
  <cdr:relSizeAnchor xmlns:cdr="http://schemas.openxmlformats.org/drawingml/2006/chartDrawing">
    <cdr:from>
      <cdr:x>0.58479</cdr:x>
      <cdr:y>0.14808</cdr:y>
    </cdr:from>
    <cdr:to>
      <cdr:x>0.76125</cdr:x>
      <cdr:y>0.23033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052628" y="373162"/>
          <a:ext cx="317630" cy="2072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7703</cdr:x>
      <cdr:y>0.22218</cdr:y>
    </cdr:from>
    <cdr:to>
      <cdr:x>0.85203</cdr:x>
      <cdr:y>0.22218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939A3ABF-E226-F5FC-AA57-0C744336ECC5}"/>
            </a:ext>
          </a:extLst>
        </cdr:cNvPr>
        <cdr:cNvCxnSpPr/>
      </cdr:nvCxnSpPr>
      <cdr:spPr>
        <a:xfrm xmlns:a="http://schemas.openxmlformats.org/drawingml/2006/main" flipV="1">
          <a:off x="858657" y="559882"/>
          <a:ext cx="675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29.xml><?xml version="1.0" encoding="utf-8"?>
<c:userShapes xmlns:c="http://schemas.openxmlformats.org/drawingml/2006/chart">
  <cdr:relSizeAnchor xmlns:cdr="http://schemas.openxmlformats.org/drawingml/2006/chartDrawing">
    <cdr:from>
      <cdr:x>0.50266</cdr:x>
      <cdr:y>0.10231</cdr:y>
    </cdr:from>
    <cdr:to>
      <cdr:x>0.76994</cdr:x>
      <cdr:y>0.1847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904780" y="257826"/>
          <a:ext cx="481107" cy="2076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4837</cdr:x>
      <cdr:y>0.20202</cdr:y>
    </cdr:from>
    <cdr:to>
      <cdr:x>0.82337</cdr:x>
      <cdr:y>0.20202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939A3ABF-E226-F5FC-AA57-0C744336ECC5}"/>
            </a:ext>
          </a:extLst>
        </cdr:cNvPr>
        <cdr:cNvCxnSpPr/>
      </cdr:nvCxnSpPr>
      <cdr:spPr>
        <a:xfrm xmlns:a="http://schemas.openxmlformats.org/drawingml/2006/main" flipV="1">
          <a:off x="807068" y="509082"/>
          <a:ext cx="675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64542</cdr:x>
      <cdr:y>0.4746</cdr:y>
    </cdr:from>
    <cdr:to>
      <cdr:x>0.78037</cdr:x>
      <cdr:y>0.57628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394112" y="961062"/>
          <a:ext cx="291480" cy="2059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0328</cdr:x>
      <cdr:y>0.52796</cdr:y>
    </cdr:from>
    <cdr:to>
      <cdr:x>0.95558</cdr:x>
      <cdr:y>0.6035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735076" y="1069129"/>
          <a:ext cx="328974" cy="15295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4172</cdr:x>
      <cdr:y>0.2275</cdr:y>
    </cdr:from>
    <cdr:to>
      <cdr:x>0.64256</cdr:x>
      <cdr:y>0.32433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954106" y="460694"/>
          <a:ext cx="433815" cy="1960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0.xml><?xml version="1.0" encoding="utf-8"?>
<c:userShapes xmlns:c="http://schemas.openxmlformats.org/drawingml/2006/chart">
  <cdr:relSizeAnchor xmlns:cdr="http://schemas.openxmlformats.org/drawingml/2006/chartDrawing">
    <cdr:from>
      <cdr:x>0.5</cdr:x>
      <cdr:y>0.13467</cdr:y>
    </cdr:from>
    <cdr:to>
      <cdr:x>0.77122</cdr:x>
      <cdr:y>0.23382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900000" y="339368"/>
          <a:ext cx="488197" cy="2498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5561</cdr:x>
      <cdr:y>0.24233</cdr:y>
    </cdr:from>
    <cdr:to>
      <cdr:x>0.83061</cdr:x>
      <cdr:y>0.24233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939A3ABF-E226-F5FC-AA57-0C744336ECC5}"/>
            </a:ext>
          </a:extLst>
        </cdr:cNvPr>
        <cdr:cNvCxnSpPr/>
      </cdr:nvCxnSpPr>
      <cdr:spPr>
        <a:xfrm xmlns:a="http://schemas.openxmlformats.org/drawingml/2006/main" flipV="1">
          <a:off x="820090" y="610682"/>
          <a:ext cx="675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1.xml><?xml version="1.0" encoding="utf-8"?>
<c:userShapes xmlns:c="http://schemas.openxmlformats.org/drawingml/2006/chart">
  <cdr:relSizeAnchor xmlns:cdr="http://schemas.openxmlformats.org/drawingml/2006/chartDrawing">
    <cdr:from>
      <cdr:x>0.53557</cdr:x>
      <cdr:y>0.17065</cdr:y>
    </cdr:from>
    <cdr:to>
      <cdr:x>0.78957</cdr:x>
      <cdr:y>0.22768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964025" y="430032"/>
          <a:ext cx="457196" cy="1437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5051</cdr:x>
      <cdr:y>0.24743</cdr:y>
    </cdr:from>
    <cdr:to>
      <cdr:x>0.82551</cdr:x>
      <cdr:y>0.24743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939A3ABF-E226-F5FC-AA57-0C744336ECC5}"/>
            </a:ext>
          </a:extLst>
        </cdr:cNvPr>
        <cdr:cNvCxnSpPr/>
      </cdr:nvCxnSpPr>
      <cdr:spPr>
        <a:xfrm xmlns:a="http://schemas.openxmlformats.org/drawingml/2006/main" flipV="1">
          <a:off x="810926" y="623519"/>
          <a:ext cx="675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2.xml><?xml version="1.0" encoding="utf-8"?>
<c:userShapes xmlns:c="http://schemas.openxmlformats.org/drawingml/2006/chart">
  <cdr:relSizeAnchor xmlns:cdr="http://schemas.openxmlformats.org/drawingml/2006/chartDrawing">
    <cdr:from>
      <cdr:x>0.59813</cdr:x>
      <cdr:y>0.1772</cdr:y>
    </cdr:from>
    <cdr:to>
      <cdr:x>0.70925</cdr:x>
      <cdr:y>0.2762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076632" y="446547"/>
          <a:ext cx="200016" cy="2494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6619</cdr:x>
      <cdr:y>0.26531</cdr:y>
    </cdr:from>
    <cdr:to>
      <cdr:x>0.84119</cdr:x>
      <cdr:y>0.26531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939A3ABF-E226-F5FC-AA57-0C744336ECC5}"/>
            </a:ext>
          </a:extLst>
        </cdr:cNvPr>
        <cdr:cNvCxnSpPr/>
      </cdr:nvCxnSpPr>
      <cdr:spPr>
        <a:xfrm xmlns:a="http://schemas.openxmlformats.org/drawingml/2006/main" flipV="1">
          <a:off x="839140" y="668570"/>
          <a:ext cx="675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3.xml><?xml version="1.0" encoding="utf-8"?>
<c:userShapes xmlns:c="http://schemas.openxmlformats.org/drawingml/2006/chart">
  <cdr:relSizeAnchor xmlns:cdr="http://schemas.openxmlformats.org/drawingml/2006/chartDrawing">
    <cdr:from>
      <cdr:x>0.58086</cdr:x>
      <cdr:y>0.17167</cdr:y>
    </cdr:from>
    <cdr:to>
      <cdr:x>0.69198</cdr:x>
      <cdr:y>0.27067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045555" y="432596"/>
          <a:ext cx="200016" cy="2494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6412</cdr:x>
      <cdr:y>0.24635</cdr:y>
    </cdr:from>
    <cdr:to>
      <cdr:x>0.83912</cdr:x>
      <cdr:y>0.24635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939A3ABF-E226-F5FC-AA57-0C744336ECC5}"/>
            </a:ext>
          </a:extLst>
        </cdr:cNvPr>
        <cdr:cNvCxnSpPr/>
      </cdr:nvCxnSpPr>
      <cdr:spPr>
        <a:xfrm xmlns:a="http://schemas.openxmlformats.org/drawingml/2006/main" flipV="1">
          <a:off x="835421" y="620793"/>
          <a:ext cx="675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4.xml><?xml version="1.0" encoding="utf-8"?>
<c:userShapes xmlns:c="http://schemas.openxmlformats.org/drawingml/2006/chart">
  <cdr:relSizeAnchor xmlns:cdr="http://schemas.openxmlformats.org/drawingml/2006/chartDrawing">
    <cdr:from>
      <cdr:x>0.61659</cdr:x>
      <cdr:y>0.15786</cdr:y>
    </cdr:from>
    <cdr:to>
      <cdr:x>0.72771</cdr:x>
      <cdr:y>0.25686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109854" y="397819"/>
          <a:ext cx="200016" cy="2494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7822</cdr:x>
      <cdr:y>0.24857</cdr:y>
    </cdr:from>
    <cdr:to>
      <cdr:x>0.85322</cdr:x>
      <cdr:y>0.24857</cdr:y>
    </cdr:to>
    <cdr:cxnSp macro="">
      <cdr:nvCxnSpPr>
        <cdr:cNvPr id="3" name="直線コネクタ 2">
          <a:extLst xmlns:a="http://schemas.openxmlformats.org/drawingml/2006/main">
            <a:ext uri="{FF2B5EF4-FFF2-40B4-BE49-F238E27FC236}">
              <a16:creationId xmlns:a16="http://schemas.microsoft.com/office/drawing/2014/main" id="{939A3ABF-E226-F5FC-AA57-0C744336ECC5}"/>
            </a:ext>
          </a:extLst>
        </cdr:cNvPr>
        <cdr:cNvCxnSpPr/>
      </cdr:nvCxnSpPr>
      <cdr:spPr>
        <a:xfrm xmlns:a="http://schemas.openxmlformats.org/drawingml/2006/main" flipV="1">
          <a:off x="860796" y="626399"/>
          <a:ext cx="675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5.xml><?xml version="1.0" encoding="utf-8"?>
<c:userShapes xmlns:c="http://schemas.openxmlformats.org/drawingml/2006/chart">
  <cdr:relSizeAnchor xmlns:cdr="http://schemas.openxmlformats.org/drawingml/2006/chartDrawing">
    <cdr:from>
      <cdr:x>0.72292</cdr:x>
      <cdr:y>0.73134</cdr:y>
    </cdr:from>
    <cdr:to>
      <cdr:x>0.92014</cdr:x>
      <cdr:y>0.80171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3305175" y="2178050"/>
          <a:ext cx="901700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/>
            <a:t>p=0.0460</a:t>
          </a:r>
          <a:endParaRPr lang="ja-JP" altLang="en-US" sz="1100"/>
        </a:p>
      </cdr:txBody>
    </cdr:sp>
  </cdr:relSizeAnchor>
</c:userShapes>
</file>

<file path=ppt/drawings/drawing36.xml><?xml version="1.0" encoding="utf-8"?>
<c:userShapes xmlns:c="http://schemas.openxmlformats.org/drawingml/2006/chart">
  <cdr:relSizeAnchor xmlns:cdr="http://schemas.openxmlformats.org/drawingml/2006/chartDrawing">
    <cdr:from>
      <cdr:x>0.53136</cdr:x>
      <cdr:y>0.16702</cdr:y>
    </cdr:from>
    <cdr:to>
      <cdr:x>0.689</cdr:x>
      <cdr:y>0.2799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530317" y="450957"/>
          <a:ext cx="454003" cy="3047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0426</cdr:x>
      <cdr:y>0.26945</cdr:y>
    </cdr:from>
    <cdr:to>
      <cdr:x>0.77926</cdr:x>
      <cdr:y>0.26945</cdr:y>
    </cdr:to>
    <cdr:cxnSp macro="">
      <cdr:nvCxnSpPr>
        <cdr:cNvPr id="4" name="直線コネクタ 3">
          <a:extLst xmlns:a="http://schemas.openxmlformats.org/drawingml/2006/main">
            <a:ext uri="{FF2B5EF4-FFF2-40B4-BE49-F238E27FC236}">
              <a16:creationId xmlns:a16="http://schemas.microsoft.com/office/drawing/2014/main" id="{180791A4-2BA7-F79E-53E5-6F9A3EB70FA4}"/>
            </a:ext>
          </a:extLst>
        </cdr:cNvPr>
        <cdr:cNvCxnSpPr/>
      </cdr:nvCxnSpPr>
      <cdr:spPr>
        <a:xfrm xmlns:a="http://schemas.openxmlformats.org/drawingml/2006/main">
          <a:off x="1164269" y="727518"/>
          <a:ext cx="1080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7.xml><?xml version="1.0" encoding="utf-8"?>
<c:userShapes xmlns:c="http://schemas.openxmlformats.org/drawingml/2006/chart">
  <cdr:relSizeAnchor xmlns:cdr="http://schemas.openxmlformats.org/drawingml/2006/chartDrawing">
    <cdr:from>
      <cdr:x>0.52008</cdr:x>
      <cdr:y>0.16902</cdr:y>
    </cdr:from>
    <cdr:to>
      <cdr:x>0.6689</cdr:x>
      <cdr:y>0.27319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497822" y="456356"/>
          <a:ext cx="428601" cy="2812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dirty="0"/>
            <a:t>.</a:t>
          </a:r>
          <a:endParaRPr lang="ja-JP" altLang="en-US" sz="1100" dirty="0"/>
        </a:p>
      </cdr:txBody>
    </cdr:sp>
  </cdr:relSizeAnchor>
  <cdr:relSizeAnchor xmlns:cdr="http://schemas.openxmlformats.org/drawingml/2006/chartDrawing">
    <cdr:from>
      <cdr:x>0.40309</cdr:x>
      <cdr:y>0.28524</cdr:y>
    </cdr:from>
    <cdr:to>
      <cdr:x>0.77809</cdr:x>
      <cdr:y>0.28524</cdr:y>
    </cdr:to>
    <cdr:cxnSp macro="">
      <cdr:nvCxnSpPr>
        <cdr:cNvPr id="4" name="直線コネクタ 3">
          <a:extLst xmlns:a="http://schemas.openxmlformats.org/drawingml/2006/main">
            <a:ext uri="{FF2B5EF4-FFF2-40B4-BE49-F238E27FC236}">
              <a16:creationId xmlns:a16="http://schemas.microsoft.com/office/drawing/2014/main" id="{04D9EFA2-C17A-443D-ABD7-CE3D00C36126}"/>
            </a:ext>
          </a:extLst>
        </cdr:cNvPr>
        <cdr:cNvCxnSpPr/>
      </cdr:nvCxnSpPr>
      <cdr:spPr>
        <a:xfrm xmlns:a="http://schemas.openxmlformats.org/drawingml/2006/main" flipV="1">
          <a:off x="1160899" y="770150"/>
          <a:ext cx="1080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8.xml><?xml version="1.0" encoding="utf-8"?>
<c:userShapes xmlns:c="http://schemas.openxmlformats.org/drawingml/2006/chart">
  <cdr:relSizeAnchor xmlns:cdr="http://schemas.openxmlformats.org/drawingml/2006/chartDrawing">
    <cdr:from>
      <cdr:x>0.47578</cdr:x>
      <cdr:y>0.13123</cdr:y>
    </cdr:from>
    <cdr:to>
      <cdr:x>0.64225</cdr:x>
      <cdr:y>0.2354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370255" y="354310"/>
          <a:ext cx="479434" cy="2812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7213</cdr:x>
      <cdr:y>0.21927</cdr:y>
    </cdr:from>
    <cdr:to>
      <cdr:x>0.74713</cdr:x>
      <cdr:y>0.21927</cdr:y>
    </cdr:to>
    <cdr:cxnSp macro="">
      <cdr:nvCxnSpPr>
        <cdr:cNvPr id="4" name="直線コネクタ 3">
          <a:extLst xmlns:a="http://schemas.openxmlformats.org/drawingml/2006/main">
            <a:ext uri="{FF2B5EF4-FFF2-40B4-BE49-F238E27FC236}">
              <a16:creationId xmlns:a16="http://schemas.microsoft.com/office/drawing/2014/main" id="{4645A0AE-0981-7174-427C-3764E40A2AFD}"/>
            </a:ext>
          </a:extLst>
        </cdr:cNvPr>
        <cdr:cNvCxnSpPr/>
      </cdr:nvCxnSpPr>
      <cdr:spPr>
        <a:xfrm xmlns:a="http://schemas.openxmlformats.org/drawingml/2006/main" flipV="1">
          <a:off x="1071743" y="592018"/>
          <a:ext cx="1080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9.xml><?xml version="1.0" encoding="utf-8"?>
<c:userShapes xmlns:c="http://schemas.openxmlformats.org/drawingml/2006/chart">
  <cdr:relSizeAnchor xmlns:cdr="http://schemas.openxmlformats.org/drawingml/2006/chartDrawing">
    <cdr:from>
      <cdr:x>0.51472</cdr:x>
      <cdr:y>0.10928</cdr:y>
    </cdr:from>
    <cdr:to>
      <cdr:x>0.67389</cdr:x>
      <cdr:y>0.21345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482394" y="295043"/>
          <a:ext cx="458409" cy="2812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0446</cdr:x>
      <cdr:y>0.21929</cdr:y>
    </cdr:from>
    <cdr:to>
      <cdr:x>0.77946</cdr:x>
      <cdr:y>0.21929</cdr:y>
    </cdr:to>
    <cdr:cxnSp macro="">
      <cdr:nvCxnSpPr>
        <cdr:cNvPr id="4" name="直線コネクタ 3">
          <a:extLst xmlns:a="http://schemas.openxmlformats.org/drawingml/2006/main">
            <a:ext uri="{FF2B5EF4-FFF2-40B4-BE49-F238E27FC236}">
              <a16:creationId xmlns:a16="http://schemas.microsoft.com/office/drawing/2014/main" id="{37958AED-2DA4-B8C5-E781-27B8DA41D66B}"/>
            </a:ext>
          </a:extLst>
        </cdr:cNvPr>
        <cdr:cNvCxnSpPr/>
      </cdr:nvCxnSpPr>
      <cdr:spPr>
        <a:xfrm xmlns:a="http://schemas.openxmlformats.org/drawingml/2006/main" flipH="1" flipV="1">
          <a:off x="1164845" y="592070"/>
          <a:ext cx="1080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45458</cdr:x>
      <cdr:y>0.27362</cdr:y>
    </cdr:from>
    <cdr:to>
      <cdr:x>0.66156</cdr:x>
      <cdr:y>0.37316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981893" y="554081"/>
          <a:ext cx="447082" cy="2015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3935</cdr:x>
      <cdr:y>0.37537</cdr:y>
    </cdr:from>
    <cdr:to>
      <cdr:x>0.74949</cdr:x>
      <cdr:y>0.47491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381004" y="760115"/>
          <a:ext cx="237894" cy="2015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3935</cdr:x>
      <cdr:y>0.22975</cdr:y>
    </cdr:from>
    <cdr:to>
      <cdr:x>1</cdr:x>
      <cdr:y>0.37095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381005" y="465252"/>
          <a:ext cx="778995" cy="2859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</a:p>
        <a:p xmlns:a="http://schemas.openxmlformats.org/drawingml/2006/main">
          <a:pPr algn="ctr"/>
          <a:r>
            <a:rPr lang="en-US" altLang="ja-JP" sz="1000" b="1" dirty="0">
              <a:latin typeface="Arial" panose="020B0604020202020204" pitchFamily="34" charset="0"/>
              <a:cs typeface="Arial" panose="020B0604020202020204" pitchFamily="34" charset="0"/>
            </a:rPr>
            <a:t>(p=0.054)</a:t>
          </a:r>
          <a:endParaRPr lang="ja-JP" altLang="en-US" sz="10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0.xml><?xml version="1.0" encoding="utf-8"?>
<c:userShapes xmlns:c="http://schemas.openxmlformats.org/drawingml/2006/chart">
  <cdr:relSizeAnchor xmlns:cdr="http://schemas.openxmlformats.org/drawingml/2006/chartDrawing">
    <cdr:from>
      <cdr:x>0.72153</cdr:x>
      <cdr:y>0.26852</cdr:y>
    </cdr:from>
    <cdr:to>
      <cdr:x>0.87448</cdr:x>
      <cdr:y>0.37269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2078006" y="725004"/>
          <a:ext cx="440508" cy="2812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1.xml><?xml version="1.0" encoding="utf-8"?>
<c:userShapes xmlns:c="http://schemas.openxmlformats.org/drawingml/2006/chart">
  <cdr:relSizeAnchor xmlns:cdr="http://schemas.openxmlformats.org/drawingml/2006/chartDrawing">
    <cdr:from>
      <cdr:x>0.70128</cdr:x>
      <cdr:y>0.41634</cdr:y>
    </cdr:from>
    <cdr:to>
      <cdr:x>0.86477</cdr:x>
      <cdr:y>0.52051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2019687" y="1124131"/>
          <a:ext cx="470846" cy="2812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2.xml><?xml version="1.0" encoding="utf-8"?>
<c:userShapes xmlns:c="http://schemas.openxmlformats.org/drawingml/2006/chart">
  <cdr:relSizeAnchor xmlns:cdr="http://schemas.openxmlformats.org/drawingml/2006/chartDrawing">
    <cdr:from>
      <cdr:x>0.40851</cdr:x>
      <cdr:y>0.2528</cdr:y>
    </cdr:from>
    <cdr:to>
      <cdr:x>0.83353</cdr:x>
      <cdr:y>0.2528</cdr:y>
    </cdr:to>
    <cdr:cxnSp macro="">
      <cdr:nvCxnSpPr>
        <cdr:cNvPr id="3" name="直線コネクタ 2"/>
        <cdr:cNvCxnSpPr/>
      </cdr:nvCxnSpPr>
      <cdr:spPr>
        <a:xfrm xmlns:a="http://schemas.openxmlformats.org/drawingml/2006/main">
          <a:off x="941207" y="509649"/>
          <a:ext cx="979246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1858</cdr:x>
      <cdr:y>0.12214</cdr:y>
    </cdr:from>
    <cdr:to>
      <cdr:x>0.74243</cdr:x>
      <cdr:y>0.27387</cdr:y>
    </cdr:to>
    <cdr:sp macro="" textlink="">
      <cdr:nvSpPr>
        <cdr:cNvPr id="4" name="テキスト ボックス 3"/>
        <cdr:cNvSpPr txBox="1"/>
      </cdr:nvSpPr>
      <cdr:spPr>
        <a:xfrm xmlns:a="http://schemas.openxmlformats.org/drawingml/2006/main">
          <a:off x="1194816" y="246235"/>
          <a:ext cx="515752" cy="30588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200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200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3.xml><?xml version="1.0" encoding="utf-8"?>
<c:userShapes xmlns:c="http://schemas.openxmlformats.org/drawingml/2006/chart">
  <cdr:relSizeAnchor xmlns:cdr="http://schemas.openxmlformats.org/drawingml/2006/chartDrawing">
    <cdr:from>
      <cdr:x>0.39789</cdr:x>
      <cdr:y>0.3148</cdr:y>
    </cdr:from>
    <cdr:to>
      <cdr:x>0.82309</cdr:x>
      <cdr:y>0.3148</cdr:y>
    </cdr:to>
    <cdr:cxnSp macro="">
      <cdr:nvCxnSpPr>
        <cdr:cNvPr id="2" name="直線コネクタ 1"/>
        <cdr:cNvCxnSpPr/>
      </cdr:nvCxnSpPr>
      <cdr:spPr>
        <a:xfrm xmlns:a="http://schemas.openxmlformats.org/drawingml/2006/main">
          <a:off x="916748" y="634642"/>
          <a:ext cx="979661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259</cdr:x>
      <cdr:y>0.1427</cdr:y>
    </cdr:from>
    <cdr:to>
      <cdr:x>0.69212</cdr:x>
      <cdr:y>0.30305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1266533" y="231166"/>
          <a:ext cx="477600" cy="2597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200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200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4.xml><?xml version="1.0" encoding="utf-8"?>
<c:userShapes xmlns:c="http://schemas.openxmlformats.org/drawingml/2006/chart">
  <cdr:relSizeAnchor xmlns:cdr="http://schemas.openxmlformats.org/drawingml/2006/chartDrawing">
    <cdr:from>
      <cdr:x>0.35764</cdr:x>
      <cdr:y>0.30059</cdr:y>
    </cdr:from>
    <cdr:to>
      <cdr:x>0.78267</cdr:x>
      <cdr:y>0.30059</cdr:y>
    </cdr:to>
    <cdr:cxnSp macro="">
      <cdr:nvCxnSpPr>
        <cdr:cNvPr id="2" name="直線コネクタ 2"/>
        <cdr:cNvCxnSpPr/>
      </cdr:nvCxnSpPr>
      <cdr:spPr>
        <a:xfrm xmlns:a="http://schemas.openxmlformats.org/drawingml/2006/main">
          <a:off x="1103698" y="824586"/>
          <a:ext cx="1311685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12</cdr:x>
      <cdr:y>0.20553</cdr:y>
    </cdr:from>
    <cdr:to>
      <cdr:x>0.66509</cdr:x>
      <cdr:y>0.28655</cdr:y>
    </cdr:to>
    <cdr:sp macro="" textlink="">
      <cdr:nvSpPr>
        <cdr:cNvPr id="5" name="テキスト ボックス 3"/>
        <cdr:cNvSpPr txBox="1"/>
      </cdr:nvSpPr>
      <cdr:spPr>
        <a:xfrm xmlns:a="http://schemas.openxmlformats.org/drawingml/2006/main">
          <a:off x="1290242" y="414349"/>
          <a:ext cx="385783" cy="16333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200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5.xml><?xml version="1.0" encoding="utf-8"?>
<c:userShapes xmlns:c="http://schemas.openxmlformats.org/drawingml/2006/chart">
  <cdr:relSizeAnchor xmlns:cdr="http://schemas.openxmlformats.org/drawingml/2006/chartDrawing">
    <cdr:from>
      <cdr:x>0.34414</cdr:x>
      <cdr:y>0.27268</cdr:y>
    </cdr:from>
    <cdr:to>
      <cdr:x>0.76917</cdr:x>
      <cdr:y>0.27268</cdr:y>
    </cdr:to>
    <cdr:cxnSp macro="">
      <cdr:nvCxnSpPr>
        <cdr:cNvPr id="3" name="直線コネクタ 2"/>
        <cdr:cNvCxnSpPr/>
      </cdr:nvCxnSpPr>
      <cdr:spPr>
        <a:xfrm xmlns:a="http://schemas.openxmlformats.org/drawingml/2006/main">
          <a:off x="991135" y="588980"/>
          <a:ext cx="1224087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4882</cdr:x>
      <cdr:y>0.14776</cdr:y>
    </cdr:from>
    <cdr:to>
      <cdr:x>0.82298</cdr:x>
      <cdr:y>0.26574</cdr:y>
    </cdr:to>
    <cdr:sp macro="" textlink="">
      <cdr:nvSpPr>
        <cdr:cNvPr id="4" name="テキスト ボックス 3"/>
        <cdr:cNvSpPr txBox="1"/>
      </cdr:nvSpPr>
      <cdr:spPr>
        <a:xfrm xmlns:a="http://schemas.openxmlformats.org/drawingml/2006/main">
          <a:off x="803680" y="297887"/>
          <a:ext cx="1092469" cy="2378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200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200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r>
            <a:rPr lang="en-US" altLang="ja-JP" sz="1200" baseline="0" dirty="0">
              <a:latin typeface="Arial" panose="020B0604020202020204" pitchFamily="34" charset="0"/>
              <a:cs typeface="Arial" panose="020B0604020202020204" pitchFamily="34" charset="0"/>
            </a:rPr>
            <a:t> (p=0.13)</a:t>
          </a:r>
        </a:p>
      </cdr:txBody>
    </cdr:sp>
  </cdr:relSizeAnchor>
</c:userShapes>
</file>

<file path=ppt/drawings/drawing46.xml><?xml version="1.0" encoding="utf-8"?>
<c:userShapes xmlns:c="http://schemas.openxmlformats.org/drawingml/2006/chart">
  <cdr:relSizeAnchor xmlns:cdr="http://schemas.openxmlformats.org/drawingml/2006/chartDrawing">
    <cdr:from>
      <cdr:x>0.44536</cdr:x>
      <cdr:y>0.27336</cdr:y>
    </cdr:from>
    <cdr:to>
      <cdr:x>0.87039</cdr:x>
      <cdr:y>0.27336</cdr:y>
    </cdr:to>
    <cdr:cxnSp macro="">
      <cdr:nvCxnSpPr>
        <cdr:cNvPr id="3" name="直線コネクタ 2"/>
        <cdr:cNvCxnSpPr/>
      </cdr:nvCxnSpPr>
      <cdr:spPr>
        <a:xfrm xmlns:a="http://schemas.openxmlformats.org/drawingml/2006/main">
          <a:off x="1122300" y="442838"/>
          <a:ext cx="1071075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8453</cdr:x>
      <cdr:y>0.14975</cdr:y>
    </cdr:from>
    <cdr:to>
      <cdr:x>0.76327</cdr:x>
      <cdr:y>0.26784</cdr:y>
    </cdr:to>
    <cdr:sp macro="" textlink="">
      <cdr:nvSpPr>
        <cdr:cNvPr id="4" name="テキスト ボックス 3"/>
        <cdr:cNvSpPr txBox="1"/>
      </cdr:nvSpPr>
      <cdr:spPr>
        <a:xfrm xmlns:a="http://schemas.openxmlformats.org/drawingml/2006/main">
          <a:off x="1473014" y="242591"/>
          <a:ext cx="450418" cy="1913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200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7.xml><?xml version="1.0" encoding="utf-8"?>
<c:userShapes xmlns:c="http://schemas.openxmlformats.org/drawingml/2006/chart">
  <cdr:relSizeAnchor xmlns:cdr="http://schemas.openxmlformats.org/drawingml/2006/chartDrawing">
    <cdr:from>
      <cdr:x>0.43538</cdr:x>
      <cdr:y>0.26549</cdr:y>
    </cdr:from>
    <cdr:to>
      <cdr:x>0.86041</cdr:x>
      <cdr:y>0.26549</cdr:y>
    </cdr:to>
    <cdr:cxnSp macro="">
      <cdr:nvCxnSpPr>
        <cdr:cNvPr id="3" name="直線コネクタ 2"/>
        <cdr:cNvCxnSpPr/>
      </cdr:nvCxnSpPr>
      <cdr:spPr>
        <a:xfrm xmlns:a="http://schemas.openxmlformats.org/drawingml/2006/main">
          <a:off x="1097167" y="430093"/>
          <a:ext cx="1071075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8693</cdr:x>
      <cdr:y>0.1514</cdr:y>
    </cdr:from>
    <cdr:to>
      <cdr:x>0.74159</cdr:x>
      <cdr:y>0.25601</cdr:y>
    </cdr:to>
    <cdr:sp macro="" textlink="">
      <cdr:nvSpPr>
        <cdr:cNvPr id="4" name="テキスト ボックス 3"/>
        <cdr:cNvSpPr txBox="1"/>
      </cdr:nvSpPr>
      <cdr:spPr>
        <a:xfrm xmlns:a="http://schemas.openxmlformats.org/drawingml/2006/main">
          <a:off x="1479074" y="245265"/>
          <a:ext cx="389726" cy="1694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2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8.xml><?xml version="1.0" encoding="utf-8"?>
<c:userShapes xmlns:c="http://schemas.openxmlformats.org/drawingml/2006/chart">
  <cdr:relSizeAnchor xmlns:cdr="http://schemas.openxmlformats.org/drawingml/2006/chartDrawing">
    <cdr:from>
      <cdr:x>0.40208</cdr:x>
      <cdr:y>0.27923</cdr:y>
    </cdr:from>
    <cdr:to>
      <cdr:x>0.82711</cdr:x>
      <cdr:y>0.27923</cdr:y>
    </cdr:to>
    <cdr:cxnSp macro="">
      <cdr:nvCxnSpPr>
        <cdr:cNvPr id="3" name="直線コネクタ 2"/>
        <cdr:cNvCxnSpPr/>
      </cdr:nvCxnSpPr>
      <cdr:spPr>
        <a:xfrm xmlns:a="http://schemas.openxmlformats.org/drawingml/2006/main">
          <a:off x="1013246" y="662533"/>
          <a:ext cx="1071075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8105</cdr:x>
      <cdr:y>0.19451</cdr:y>
    </cdr:from>
    <cdr:to>
      <cdr:x>0.75204</cdr:x>
      <cdr:y>0.28083</cdr:y>
    </cdr:to>
    <cdr:sp macro="" textlink="">
      <cdr:nvSpPr>
        <cdr:cNvPr id="4" name="テキスト ボックス 3"/>
        <cdr:cNvSpPr txBox="1"/>
      </cdr:nvSpPr>
      <cdr:spPr>
        <a:xfrm xmlns:a="http://schemas.openxmlformats.org/drawingml/2006/main">
          <a:off x="1464257" y="315114"/>
          <a:ext cx="430893" cy="1398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2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4765</cdr:x>
      <cdr:y>0.34084</cdr:y>
    </cdr:from>
    <cdr:to>
      <cdr:x>0.62766</cdr:x>
      <cdr:y>0.43807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029245" y="690202"/>
          <a:ext cx="326506" cy="1968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1793</cdr:x>
      <cdr:y>0.35308</cdr:y>
    </cdr:from>
    <cdr:to>
      <cdr:x>0.79394</cdr:x>
      <cdr:y>0.4503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1334729" y="714987"/>
          <a:ext cx="380188" cy="1968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0684</cdr:x>
      <cdr:y>0.42966</cdr:y>
    </cdr:from>
    <cdr:to>
      <cdr:x>0.97103</cdr:x>
      <cdr:y>0.52688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2323698" y="1160086"/>
          <a:ext cx="472867" cy="26249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44665</cdr:x>
      <cdr:y>0.22303</cdr:y>
    </cdr:from>
    <cdr:to>
      <cdr:x>0.61782</cdr:x>
      <cdr:y>0.32025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964764" y="451636"/>
          <a:ext cx="369722" cy="1968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057</cdr:x>
      <cdr:y>0.20602</cdr:y>
    </cdr:from>
    <cdr:to>
      <cdr:x>0.95275</cdr:x>
      <cdr:y>0.30324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740312" y="417191"/>
          <a:ext cx="317636" cy="1968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3417</cdr:x>
      <cdr:y>0.15265</cdr:y>
    </cdr:from>
    <cdr:to>
      <cdr:x>0.79683</cdr:x>
      <cdr:y>0.24988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369807" y="309116"/>
          <a:ext cx="351348" cy="19689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38008</cdr:x>
      <cdr:y>0.41686</cdr:y>
    </cdr:from>
    <cdr:to>
      <cdr:x>0.57867</cdr:x>
      <cdr:y>0.52102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820969" y="844135"/>
          <a:ext cx="428962" cy="2109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56799</cdr:x>
      <cdr:y>0.32753</cdr:y>
    </cdr:from>
    <cdr:to>
      <cdr:x>0.7961</cdr:x>
      <cdr:y>0.43169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226853" y="663251"/>
          <a:ext cx="492725" cy="2109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8391</cdr:x>
      <cdr:y>0</cdr:y>
    </cdr:from>
    <cdr:to>
      <cdr:x>0.92385</cdr:x>
      <cdr:y>0.10417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693251" y="-5451203"/>
          <a:ext cx="302270" cy="2109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45588</cdr:x>
      <cdr:y>0.39118</cdr:y>
    </cdr:from>
    <cdr:to>
      <cdr:x>0.62347</cdr:x>
      <cdr:y>0.48377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984705" y="792142"/>
          <a:ext cx="361994" cy="1874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1239</cdr:x>
      <cdr:y>0.376</cdr:y>
    </cdr:from>
    <cdr:to>
      <cdr:x>0.78968</cdr:x>
      <cdr:y>0.46894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322753" y="761402"/>
          <a:ext cx="382958" cy="1881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5643</cdr:x>
      <cdr:y>0.15876</cdr:y>
    </cdr:from>
    <cdr:to>
      <cdr:x>0.95587</cdr:x>
      <cdr:y>0.30051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1633890" y="321486"/>
          <a:ext cx="430779" cy="2870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62651</cdr:x>
      <cdr:y>0.16932</cdr:y>
    </cdr:from>
    <cdr:to>
      <cdr:x>0.7883</cdr:x>
      <cdr:y>0.25034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804363" y="457164"/>
          <a:ext cx="465955" cy="2187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80185</cdr:x>
      <cdr:y>0.1784</cdr:y>
    </cdr:from>
    <cdr:to>
      <cdr:x>1</cdr:x>
      <cdr:y>0.30651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1731996" y="361259"/>
          <a:ext cx="428004" cy="2594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***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804</cdr:x>
      <cdr:y>0.33282</cdr:y>
    </cdr:from>
    <cdr:to>
      <cdr:x>0.58442</cdr:x>
      <cdr:y>0.44206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821665" y="673954"/>
          <a:ext cx="440675" cy="2212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b="1" dirty="0" err="1">
              <a:latin typeface="Arial" panose="020B0604020202020204" pitchFamily="34" charset="0"/>
              <a:cs typeface="Arial" panose="020B0604020202020204" pitchFamily="34" charset="0"/>
            </a:rPr>
            <a:t>n.s</a:t>
          </a:r>
          <a:r>
            <a:rPr lang="en-US" altLang="ja-JP" sz="1100" b="1" dirty="0">
              <a:latin typeface="Arial" panose="020B0604020202020204" pitchFamily="34" charset="0"/>
              <a:cs typeface="Arial" panose="020B0604020202020204" pitchFamily="34" charset="0"/>
            </a:rPr>
            <a:t>.</a:t>
          </a:r>
          <a:endParaRPr lang="ja-JP" altLang="en-US" sz="11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8CA94D-74C3-40BC-8E91-76832A85ED10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5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5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F13AAB-F998-43D0-9D6C-C6C23B6396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896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ja-JP" sz="1200" dirty="0"/>
              <a:t>Figure S1. </a:t>
            </a:r>
            <a:r>
              <a:rPr kumimoji="1" lang="en-US" altLang="ja-JP" dirty="0"/>
              <a:t>T-cadherin stable</a:t>
            </a:r>
            <a:r>
              <a:rPr kumimoji="1" lang="en-US" altLang="ja-JP" baseline="0" dirty="0"/>
              <a:t> cell lines were established</a:t>
            </a:r>
            <a:r>
              <a:rPr lang="en-US" altLang="ja-JP" sz="1200" dirty="0"/>
              <a:t>.</a:t>
            </a:r>
          </a:p>
          <a:p>
            <a:pPr marL="228600" indent="-228600">
              <a:buAutoNum type="alphaLcParenBoth"/>
            </a:pPr>
            <a:r>
              <a:rPr kumimoji="1" lang="en-US" altLang="ja-JP" dirty="0"/>
              <a:t> HEK293T T-cadherin stable cell</a:t>
            </a:r>
            <a:r>
              <a:rPr kumimoji="1" lang="en-US" altLang="ja-JP" baseline="0" dirty="0"/>
              <a:t> line (293TT) and </a:t>
            </a:r>
            <a:r>
              <a:rPr kumimoji="1" lang="en-US" altLang="ja-JP" dirty="0"/>
              <a:t>CHO</a:t>
            </a:r>
            <a:r>
              <a:rPr kumimoji="1" lang="en-US" altLang="ja-JP" baseline="0" dirty="0"/>
              <a:t> </a:t>
            </a:r>
            <a:r>
              <a:rPr kumimoji="1" lang="en-US" altLang="ja-JP" dirty="0"/>
              <a:t>T-cadherin stable</a:t>
            </a:r>
            <a:r>
              <a:rPr kumimoji="1" lang="en-US" altLang="ja-JP" baseline="0" dirty="0"/>
              <a:t> cell line (CHO-T) were established. HEK293TT #2 were used for analysis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Both"/>
              <a:tabLst/>
              <a:defRPr/>
            </a:pPr>
            <a:r>
              <a:rPr kumimoji="1" lang="en-US" altLang="ja-JP" sz="1200" baseline="0" dirty="0"/>
              <a:t> CHO-T </a:t>
            </a:r>
            <a:r>
              <a:rPr kumimoji="1" lang="en-US" altLang="ja-JP" baseline="0" dirty="0"/>
              <a:t>were treated with 0.3 </a:t>
            </a:r>
            <a:r>
              <a:rPr kumimoji="1" lang="en-US" altLang="ja-JP" baseline="0" dirty="0" err="1"/>
              <a:t>μmol</a:t>
            </a:r>
            <a:r>
              <a:rPr kumimoji="1" lang="en-US" altLang="ja-JP" baseline="0" dirty="0"/>
              <a:t>/L </a:t>
            </a:r>
            <a:r>
              <a:rPr kumimoji="1" lang="en-US" altLang="ja-JP" baseline="0" dirty="0" err="1"/>
              <a:t>Thapsigargin</a:t>
            </a:r>
            <a:r>
              <a:rPr kumimoji="1" lang="en-US" altLang="ja-JP" baseline="0" dirty="0"/>
              <a:t> (TG), . After 24 h incubation, </a:t>
            </a:r>
            <a:r>
              <a:rPr kumimoji="1" lang="en-US" altLang="ja-JP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hole cell lysates were collected and subjected to western blot(n=3).</a:t>
            </a:r>
          </a:p>
          <a:p>
            <a:pPr marL="228600" indent="-228600">
              <a:buAutoNum type="alphaLcParenBoth"/>
            </a:pPr>
            <a:r>
              <a:rPr lang="en-US" altLang="ja-JP" sz="1200" dirty="0"/>
              <a:t>The sequence of CDH13 and that ofXBP1 which includes</a:t>
            </a:r>
            <a:r>
              <a:rPr lang="en-US" altLang="ja-JP" sz="1200" baseline="0" dirty="0"/>
              <a:t> IRE1α recognition site (red). Complementary sequences are shown in blue text.</a:t>
            </a:r>
            <a:endParaRPr lang="en-US" altLang="ja-JP" sz="1200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F13AAB-F998-43D0-9D6C-C6C23B6396D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0557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/>
              <a:t>Figure S3. </a:t>
            </a:r>
            <a:r>
              <a:rPr kumimoji="1" lang="en-US" altLang="ja-JP" baseline="0" dirty="0"/>
              <a:t>P</a:t>
            </a:r>
            <a:r>
              <a:rPr kumimoji="1" lang="en-US" altLang="ja-JP" dirty="0"/>
              <a:t>harmacological induction of ER stress reduces</a:t>
            </a:r>
            <a:r>
              <a:rPr kumimoji="1" lang="en-US" altLang="ja-JP" baseline="0" dirty="0"/>
              <a:t> exosome secretion from CHO-T</a:t>
            </a:r>
            <a:r>
              <a:rPr lang="en-US" altLang="ja-JP" sz="1200" dirty="0"/>
              <a:t>.</a:t>
            </a:r>
          </a:p>
          <a:p>
            <a:pPr marL="228600" indent="-228600">
              <a:buAutoNum type="alphaLcParenBoth"/>
            </a:pPr>
            <a:r>
              <a:rPr kumimoji="1" lang="en-US" altLang="ja-JP" baseline="0" dirty="0"/>
              <a:t> CHO-T were treated with indicated concentration of </a:t>
            </a:r>
            <a:r>
              <a:rPr kumimoji="1" lang="en-US" altLang="ja-JP" baseline="0" dirty="0" err="1"/>
              <a:t>thapsigargin</a:t>
            </a:r>
            <a:r>
              <a:rPr kumimoji="1" lang="en-US" altLang="ja-JP" baseline="0" dirty="0"/>
              <a:t>  for 24 hours. </a:t>
            </a:r>
            <a:r>
              <a:rPr kumimoji="1" lang="en-US" altLang="ja-JP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ecreted exosomes were purified and proved by antibodies against typical exosome cargos indicated (n=3)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Both"/>
              <a:tabLst/>
              <a:defRPr/>
            </a:pPr>
            <a:r>
              <a:rPr kumimoji="1" lang="en-US" altLang="ja-JP" dirty="0"/>
              <a:t> </a:t>
            </a:r>
            <a:r>
              <a:rPr kumimoji="1" lang="en-US" altLang="ja-JP" baseline="0" dirty="0"/>
              <a:t>CHO-T were treated with indicated concentration of </a:t>
            </a:r>
            <a:r>
              <a:rPr kumimoji="1" lang="en-US" altLang="ja-JP" baseline="0" dirty="0" err="1"/>
              <a:t>tunicamycin</a:t>
            </a:r>
            <a:r>
              <a:rPr kumimoji="1" lang="en-US" altLang="ja-JP" baseline="0" dirty="0"/>
              <a:t> for 24 hours. </a:t>
            </a:r>
            <a:r>
              <a:rPr kumimoji="1" lang="en-US" altLang="ja-JP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ecreted exosomes were purified and proved by antibodies against typical exosome cargos indicated (n=3)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Both"/>
              <a:tabLst/>
              <a:defRPr/>
            </a:pPr>
            <a:r>
              <a:rPr kumimoji="1" lang="en-US" altLang="ja-JP" sz="1200" baseline="0" dirty="0"/>
              <a:t> </a:t>
            </a:r>
            <a:r>
              <a:rPr kumimoji="1" lang="en-US" altLang="ja-JP" baseline="0" dirty="0"/>
              <a:t>CHO-T were treated with indicated concentration of MG-132 for 24 hours. </a:t>
            </a:r>
            <a:r>
              <a:rPr kumimoji="1" lang="en-US" altLang="ja-JP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ecreted exosomes were purified and proved by antibodies against typical exosome cargos indicated (n=3)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Both"/>
              <a:tabLst/>
              <a:defRPr/>
            </a:pPr>
            <a:endParaRPr kumimoji="1" lang="en-US" altLang="ja-JP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F13AAB-F998-43D0-9D6C-C6C23B6396D5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9547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8588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6982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857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123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1004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926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296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1318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2062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351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3057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F57376-0CF6-4023-A368-CD6C08E09F41}" type="datetimeFigureOut">
              <a:rPr kumimoji="1" lang="ja-JP" altLang="en-US" smtClean="0"/>
              <a:t>2023/8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28C7E0-3559-40A7-803A-BAEA2B6FAE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5699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chart" Target="../charts/chart4.xml"/><Relationship Id="rId18" Type="http://schemas.openxmlformats.org/officeDocument/2006/relationships/chart" Target="../charts/chart9.xml"/><Relationship Id="rId3" Type="http://schemas.openxmlformats.org/officeDocument/2006/relationships/image" Target="../media/image1.png"/><Relationship Id="rId21" Type="http://schemas.openxmlformats.org/officeDocument/2006/relationships/chart" Target="../charts/chart12.xml"/><Relationship Id="rId7" Type="http://schemas.openxmlformats.org/officeDocument/2006/relationships/chart" Target="../charts/chart1.xml"/><Relationship Id="rId12" Type="http://schemas.openxmlformats.org/officeDocument/2006/relationships/chart" Target="../charts/chart3.xml"/><Relationship Id="rId17" Type="http://schemas.openxmlformats.org/officeDocument/2006/relationships/chart" Target="../charts/chart8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7.xml"/><Relationship Id="rId20" Type="http://schemas.openxmlformats.org/officeDocument/2006/relationships/chart" Target="../charts/chart1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chart" Target="../charts/chart2.xml"/><Relationship Id="rId24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chart" Target="../charts/chart6.xml"/><Relationship Id="rId23" Type="http://schemas.openxmlformats.org/officeDocument/2006/relationships/image" Target="../media/image8.png"/><Relationship Id="rId10" Type="http://schemas.openxmlformats.org/officeDocument/2006/relationships/image" Target="../media/image7.png"/><Relationship Id="rId19" Type="http://schemas.openxmlformats.org/officeDocument/2006/relationships/chart" Target="../charts/chart10.xml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chart" Target="../charts/chart5.xml"/><Relationship Id="rId22" Type="http://schemas.openxmlformats.org/officeDocument/2006/relationships/chart" Target="../charts/chart13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3" Type="http://schemas.openxmlformats.org/officeDocument/2006/relationships/chart" Target="../charts/chart45.xml"/><Relationship Id="rId7" Type="http://schemas.openxmlformats.org/officeDocument/2006/relationships/image" Target="../media/image41.png"/><Relationship Id="rId12" Type="http://schemas.openxmlformats.org/officeDocument/2006/relationships/chart" Target="../charts/chart50.xml"/><Relationship Id="rId2" Type="http://schemas.openxmlformats.org/officeDocument/2006/relationships/chart" Target="../charts/chart4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png"/><Relationship Id="rId11" Type="http://schemas.openxmlformats.org/officeDocument/2006/relationships/chart" Target="../charts/chart49.xml"/><Relationship Id="rId5" Type="http://schemas.openxmlformats.org/officeDocument/2006/relationships/chart" Target="../charts/chart47.xml"/><Relationship Id="rId10" Type="http://schemas.openxmlformats.org/officeDocument/2006/relationships/chart" Target="../charts/chart48.xml"/><Relationship Id="rId4" Type="http://schemas.openxmlformats.org/officeDocument/2006/relationships/chart" Target="../charts/chart46.xml"/><Relationship Id="rId9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chart" Target="../charts/chart16.xml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chart" Target="../charts/chart18.xml"/><Relationship Id="rId18" Type="http://schemas.openxmlformats.org/officeDocument/2006/relationships/image" Target="../media/image23.png"/><Relationship Id="rId3" Type="http://schemas.openxmlformats.org/officeDocument/2006/relationships/image" Target="../media/image14.png"/><Relationship Id="rId21" Type="http://schemas.openxmlformats.org/officeDocument/2006/relationships/chart" Target="../charts/chart23.xml"/><Relationship Id="rId7" Type="http://schemas.openxmlformats.org/officeDocument/2006/relationships/image" Target="../media/image18.png"/><Relationship Id="rId12" Type="http://schemas.openxmlformats.org/officeDocument/2006/relationships/chart" Target="../charts/chart17.xml"/><Relationship Id="rId17" Type="http://schemas.openxmlformats.org/officeDocument/2006/relationships/chart" Target="../charts/chart22.xml"/><Relationship Id="rId2" Type="http://schemas.openxmlformats.org/officeDocument/2006/relationships/notesSlide" Target="../notesSlides/notesSlide2.xml"/><Relationship Id="rId16" Type="http://schemas.openxmlformats.org/officeDocument/2006/relationships/chart" Target="../charts/chart21.xml"/><Relationship Id="rId20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5" Type="http://schemas.openxmlformats.org/officeDocument/2006/relationships/chart" Target="../charts/chart20.xml"/><Relationship Id="rId10" Type="http://schemas.openxmlformats.org/officeDocument/2006/relationships/image" Target="../media/image21.png"/><Relationship Id="rId19" Type="http://schemas.openxmlformats.org/officeDocument/2006/relationships/image" Target="../media/image24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chart" Target="../charts/chart1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7" Type="http://schemas.openxmlformats.org/officeDocument/2006/relationships/chart" Target="../charts/chart26.xml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5.xml"/><Relationship Id="rId5" Type="http://schemas.openxmlformats.org/officeDocument/2006/relationships/chart" Target="../charts/chart24.xml"/><Relationship Id="rId4" Type="http://schemas.openxmlformats.org/officeDocument/2006/relationships/image" Target="../media/image2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7.xml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4.xml"/><Relationship Id="rId3" Type="http://schemas.openxmlformats.org/officeDocument/2006/relationships/chart" Target="../charts/chart29.xml"/><Relationship Id="rId7" Type="http://schemas.openxmlformats.org/officeDocument/2006/relationships/chart" Target="../charts/chart33.xml"/><Relationship Id="rId2" Type="http://schemas.openxmlformats.org/officeDocument/2006/relationships/chart" Target="../charts/chart28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2.xml"/><Relationship Id="rId5" Type="http://schemas.openxmlformats.org/officeDocument/2006/relationships/chart" Target="../charts/chart31.xml"/><Relationship Id="rId4" Type="http://schemas.openxmlformats.org/officeDocument/2006/relationships/chart" Target="../charts/chart30.xml"/><Relationship Id="rId9" Type="http://schemas.openxmlformats.org/officeDocument/2006/relationships/chart" Target="../charts/chart35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12" Type="http://schemas.openxmlformats.org/officeDocument/2006/relationships/chart" Target="../charts/chart40.xml"/><Relationship Id="rId2" Type="http://schemas.openxmlformats.org/officeDocument/2006/relationships/chart" Target="../charts/chart3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11" Type="http://schemas.openxmlformats.org/officeDocument/2006/relationships/chart" Target="../charts/chart39.xml"/><Relationship Id="rId5" Type="http://schemas.openxmlformats.org/officeDocument/2006/relationships/image" Target="../media/image33.png"/><Relationship Id="rId10" Type="http://schemas.openxmlformats.org/officeDocument/2006/relationships/chart" Target="../charts/chart38.xml"/><Relationship Id="rId4" Type="http://schemas.openxmlformats.org/officeDocument/2006/relationships/image" Target="../media/image32.png"/><Relationship Id="rId9" Type="http://schemas.openxmlformats.org/officeDocument/2006/relationships/chart" Target="../charts/chart3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7" Type="http://schemas.openxmlformats.org/officeDocument/2006/relationships/chart" Target="../charts/chart43.xml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2.xml"/><Relationship Id="rId5" Type="http://schemas.openxmlformats.org/officeDocument/2006/relationships/chart" Target="../charts/chart41.xml"/><Relationship Id="rId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S1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rot="16200000">
            <a:off x="930492" y="290750"/>
            <a:ext cx="1016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K293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1201435" y="265212"/>
            <a:ext cx="1062892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K293T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楕円 29"/>
          <p:cNvSpPr/>
          <p:nvPr/>
        </p:nvSpPr>
        <p:spPr>
          <a:xfrm>
            <a:off x="-718457" y="-3531129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楕円 33"/>
          <p:cNvSpPr/>
          <p:nvPr/>
        </p:nvSpPr>
        <p:spPr>
          <a:xfrm>
            <a:off x="-590554" y="14039632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" r="52288"/>
          <a:stretch/>
        </p:blipFill>
        <p:spPr>
          <a:xfrm>
            <a:off x="1297140" y="950932"/>
            <a:ext cx="540000" cy="37015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0" name="図 9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1" r="51701"/>
          <a:stretch/>
        </p:blipFill>
        <p:spPr>
          <a:xfrm>
            <a:off x="1297139" y="1545488"/>
            <a:ext cx="540000" cy="26517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1" name="テキスト ボックス 10"/>
          <p:cNvSpPr txBox="1"/>
          <p:nvPr/>
        </p:nvSpPr>
        <p:spPr>
          <a:xfrm>
            <a:off x="-7584" y="994636"/>
            <a:ext cx="1287375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B: T-cadheri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-7584" y="1450269"/>
            <a:ext cx="1142624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B: α-tubuli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45000" y="27212"/>
            <a:ext cx="31630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469814" y="68561"/>
            <a:ext cx="31630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946278" y="68561"/>
            <a:ext cx="1375501" cy="61555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HO-T cell</a:t>
            </a:r>
          </a:p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(CHO T-cadherin</a:t>
            </a:r>
          </a:p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expressing cell)</a:t>
            </a:r>
          </a:p>
        </p:txBody>
      </p:sp>
      <p:pic>
        <p:nvPicPr>
          <p:cNvPr id="42" name="図 41"/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774" r="-1"/>
          <a:stretch/>
        </p:blipFill>
        <p:spPr>
          <a:xfrm>
            <a:off x="3782214" y="2087571"/>
            <a:ext cx="1080000" cy="21390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43" name="図 42"/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82214" y="1478350"/>
            <a:ext cx="1080000" cy="25470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4" name="テキスト ボックス 43"/>
          <p:cNvSpPr txBox="1"/>
          <p:nvPr/>
        </p:nvSpPr>
        <p:spPr>
          <a:xfrm>
            <a:off x="2469814" y="1465192"/>
            <a:ext cx="1461052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B: T-cadheri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2469814" y="2054016"/>
            <a:ext cx="1461052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B: α-tubuli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 rot="16200000">
            <a:off x="3516532" y="963978"/>
            <a:ext cx="784814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 rot="16200000">
            <a:off x="3760270" y="963978"/>
            <a:ext cx="784814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 rot="16200000">
            <a:off x="4057941" y="963978"/>
            <a:ext cx="784814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 rot="16200000">
            <a:off x="4338259" y="963978"/>
            <a:ext cx="784814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2" name="グラフ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2606922"/>
              </p:ext>
            </p:extLst>
          </p:nvPr>
        </p:nvGraphicFramePr>
        <p:xfrm>
          <a:off x="5528592" y="27212"/>
          <a:ext cx="2160000" cy="2467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pic>
        <p:nvPicPr>
          <p:cNvPr id="55" name="図 54"/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82214" y="1794372"/>
            <a:ext cx="1080000" cy="23511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6" name="テキスト ボックス 55"/>
          <p:cNvSpPr txBox="1"/>
          <p:nvPr/>
        </p:nvSpPr>
        <p:spPr>
          <a:xfrm>
            <a:off x="2469814" y="1771418"/>
            <a:ext cx="1461052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図 56"/>
          <p:cNvPicPr>
            <a:picLocks noChangeAspect="1"/>
          </p:cNvPicPr>
          <p:nvPr/>
        </p:nvPicPr>
        <p:blipFill rotWithShape="1"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21462" y="2636167"/>
            <a:ext cx="540000" cy="38253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8" name="図 57"/>
          <p:cNvPicPr>
            <a:picLocks noChangeAspect="1"/>
          </p:cNvPicPr>
          <p:nvPr/>
        </p:nvPicPr>
        <p:blipFill rotWithShape="1"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21462" y="3224197"/>
            <a:ext cx="540000" cy="27312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1" name="テキスト ボックス 60"/>
          <p:cNvSpPr txBox="1"/>
          <p:nvPr/>
        </p:nvSpPr>
        <p:spPr>
          <a:xfrm>
            <a:off x="-7584" y="2737364"/>
            <a:ext cx="1287375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B: T-cadheri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-7584" y="3205529"/>
            <a:ext cx="1142624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IB: α-tubuli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 rot="16200000">
            <a:off x="910629" y="1984311"/>
            <a:ext cx="10628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O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 rot="16200000">
            <a:off x="1203395" y="2002400"/>
            <a:ext cx="10628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O-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8" name="グラフ 7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6379746"/>
              </p:ext>
            </p:extLst>
          </p:nvPr>
        </p:nvGraphicFramePr>
        <p:xfrm>
          <a:off x="7430633" y="27212"/>
          <a:ext cx="2160000" cy="2467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10" name="グラフ 10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652750"/>
              </p:ext>
            </p:extLst>
          </p:nvPr>
        </p:nvGraphicFramePr>
        <p:xfrm>
          <a:off x="2879738" y="2819780"/>
          <a:ext cx="2160000" cy="202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11" name="テキスト ボックス 110"/>
          <p:cNvSpPr txBox="1"/>
          <p:nvPr/>
        </p:nvSpPr>
        <p:spPr>
          <a:xfrm>
            <a:off x="2938813" y="2528866"/>
            <a:ext cx="31630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2" name="グラフ 1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0409206"/>
              </p:ext>
            </p:extLst>
          </p:nvPr>
        </p:nvGraphicFramePr>
        <p:xfrm>
          <a:off x="5039738" y="2819780"/>
          <a:ext cx="2160000" cy="202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13" name="グラフ 1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4170012"/>
              </p:ext>
            </p:extLst>
          </p:nvPr>
        </p:nvGraphicFramePr>
        <p:xfrm>
          <a:off x="7199738" y="2819780"/>
          <a:ext cx="2160000" cy="202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14" name="テキスト ボックス 113"/>
          <p:cNvSpPr txBox="1"/>
          <p:nvPr/>
        </p:nvSpPr>
        <p:spPr>
          <a:xfrm>
            <a:off x="3271087" y="2528866"/>
            <a:ext cx="1044000" cy="2769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CHO-T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</a:p>
        </p:txBody>
      </p:sp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7C6C37DF-3480-EDE4-9635-6AF877D539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1919725"/>
              </p:ext>
            </p:extLst>
          </p:nvPr>
        </p:nvGraphicFramePr>
        <p:xfrm>
          <a:off x="2209711" y="4867861"/>
          <a:ext cx="2160000" cy="202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BB507C6C-62F0-5556-730A-550C4B50D9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3280333"/>
              </p:ext>
            </p:extLst>
          </p:nvPr>
        </p:nvGraphicFramePr>
        <p:xfrm>
          <a:off x="4369711" y="4867861"/>
          <a:ext cx="2160000" cy="202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7317F8B5-BCDC-695C-A83F-CBCFF069C4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9032160"/>
              </p:ext>
            </p:extLst>
          </p:nvPr>
        </p:nvGraphicFramePr>
        <p:xfrm>
          <a:off x="49711" y="4867861"/>
          <a:ext cx="2160000" cy="202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C073ED4-C3F1-C6F0-EEA9-44F5D22CCCAB}"/>
              </a:ext>
            </a:extLst>
          </p:cNvPr>
          <p:cNvSpPr txBox="1"/>
          <p:nvPr/>
        </p:nvSpPr>
        <p:spPr>
          <a:xfrm>
            <a:off x="131496" y="4798855"/>
            <a:ext cx="3163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014DDE9-928F-CBD4-E159-DE37063B6E0F}"/>
              </a:ext>
            </a:extLst>
          </p:cNvPr>
          <p:cNvSpPr txBox="1"/>
          <p:nvPr/>
        </p:nvSpPr>
        <p:spPr>
          <a:xfrm>
            <a:off x="131496" y="6837906"/>
            <a:ext cx="3163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7" name="グラフ 46">
            <a:extLst>
              <a:ext uri="{FF2B5EF4-FFF2-40B4-BE49-F238E27FC236}">
                <a16:creationId xmlns:a16="http://schemas.microsoft.com/office/drawing/2014/main" id="{8F53B600-875D-12ED-EAB2-DE89D1DF68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705538"/>
              </p:ext>
            </p:extLst>
          </p:nvPr>
        </p:nvGraphicFramePr>
        <p:xfrm>
          <a:off x="49711" y="6827135"/>
          <a:ext cx="2160000" cy="202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53" name="グラフ 52">
            <a:extLst>
              <a:ext uri="{FF2B5EF4-FFF2-40B4-BE49-F238E27FC236}">
                <a16:creationId xmlns:a16="http://schemas.microsoft.com/office/drawing/2014/main" id="{F38FA1E8-9101-EF62-1C42-E80BF32571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4323699"/>
              </p:ext>
            </p:extLst>
          </p:nvPr>
        </p:nvGraphicFramePr>
        <p:xfrm>
          <a:off x="2209711" y="6827135"/>
          <a:ext cx="2160000" cy="202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54" name="グラフ 53">
            <a:extLst>
              <a:ext uri="{FF2B5EF4-FFF2-40B4-BE49-F238E27FC236}">
                <a16:creationId xmlns:a16="http://schemas.microsoft.com/office/drawing/2014/main" id="{FDCBD85C-2AD8-5654-E228-FC186F559A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8386940"/>
              </p:ext>
            </p:extLst>
          </p:nvPr>
        </p:nvGraphicFramePr>
        <p:xfrm>
          <a:off x="4369711" y="6827135"/>
          <a:ext cx="2160000" cy="202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id="{7AD535CC-7F87-82BE-77ED-657E7188C3FC}"/>
              </a:ext>
            </a:extLst>
          </p:cNvPr>
          <p:cNvGrpSpPr/>
          <p:nvPr/>
        </p:nvGrpSpPr>
        <p:grpSpPr>
          <a:xfrm>
            <a:off x="6389497" y="4861883"/>
            <a:ext cx="3235340" cy="3952045"/>
            <a:chOff x="74963" y="1452106"/>
            <a:chExt cx="3235340" cy="3952045"/>
          </a:xfrm>
        </p:grpSpPr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FC05918A-2646-F8F3-CB18-297AC861D7A9}"/>
                </a:ext>
              </a:extLst>
            </p:cNvPr>
            <p:cNvSpPr txBox="1"/>
            <p:nvPr/>
          </p:nvSpPr>
          <p:spPr>
            <a:xfrm>
              <a:off x="184535" y="1452107"/>
              <a:ext cx="2862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65" name="グラフ 64">
              <a:extLst>
                <a:ext uri="{FF2B5EF4-FFF2-40B4-BE49-F238E27FC236}">
                  <a16:creationId xmlns:a16="http://schemas.microsoft.com/office/drawing/2014/main" id="{16C105CD-FF8E-FF4C-E13C-049B4E8EF80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10845763"/>
                </p:ext>
              </p:extLst>
            </p:nvPr>
          </p:nvGraphicFramePr>
          <p:xfrm>
            <a:off x="74963" y="1674966"/>
            <a:ext cx="3204095" cy="19717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graphicFrame>
          <p:nvGraphicFramePr>
            <p:cNvPr id="66" name="グラフ 65">
              <a:extLst>
                <a:ext uri="{FF2B5EF4-FFF2-40B4-BE49-F238E27FC236}">
                  <a16:creationId xmlns:a16="http://schemas.microsoft.com/office/drawing/2014/main" id="{18DFEB38-9172-0037-9856-1255C2D9FC1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57343376"/>
                </p:ext>
              </p:extLst>
            </p:nvPr>
          </p:nvGraphicFramePr>
          <p:xfrm>
            <a:off x="106208" y="3432400"/>
            <a:ext cx="3204095" cy="19717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2"/>
            </a:graphicData>
          </a:graphic>
        </p:graphicFrame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5D2EB07D-0447-9012-00E0-13E830E5FB83}"/>
                </a:ext>
              </a:extLst>
            </p:cNvPr>
            <p:cNvSpPr txBox="1"/>
            <p:nvPr/>
          </p:nvSpPr>
          <p:spPr>
            <a:xfrm>
              <a:off x="208631" y="3341225"/>
              <a:ext cx="2862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BA660C62-53EC-BFFF-301A-3822FB8A8BD1}"/>
                </a:ext>
              </a:extLst>
            </p:cNvPr>
            <p:cNvSpPr txBox="1"/>
            <p:nvPr/>
          </p:nvSpPr>
          <p:spPr>
            <a:xfrm>
              <a:off x="1040691" y="1452106"/>
              <a:ext cx="1440000" cy="30777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EK293TT cell</a:t>
              </a:r>
            </a:p>
          </p:txBody>
        </p:sp>
      </p:grpSp>
      <p:pic>
        <p:nvPicPr>
          <p:cNvPr id="72" name="図 71">
            <a:extLst>
              <a:ext uri="{FF2B5EF4-FFF2-40B4-BE49-F238E27FC236}">
                <a16:creationId xmlns:a16="http://schemas.microsoft.com/office/drawing/2014/main" id="{D869A504-6E5B-A370-E7B8-E557DE4318BE}"/>
              </a:ext>
            </a:extLst>
          </p:cNvPr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77857" y="9471769"/>
            <a:ext cx="1252964" cy="308836"/>
          </a:xfrm>
          <a:prstGeom prst="rect">
            <a:avLst/>
          </a:prstGeom>
        </p:spPr>
      </p:pic>
      <p:pic>
        <p:nvPicPr>
          <p:cNvPr id="73" name="図 72">
            <a:extLst>
              <a:ext uri="{FF2B5EF4-FFF2-40B4-BE49-F238E27FC236}">
                <a16:creationId xmlns:a16="http://schemas.microsoft.com/office/drawing/2014/main" id="{31414E30-6A3C-2C22-BAB4-9541EFD15CB4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772769" y="9460148"/>
            <a:ext cx="1252964" cy="365973"/>
          </a:xfrm>
          <a:prstGeom prst="rect">
            <a:avLst/>
          </a:prstGeom>
        </p:spPr>
      </p:pic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1402AD6-021C-9B38-5F41-6EE1BD43FC8D}"/>
              </a:ext>
            </a:extLst>
          </p:cNvPr>
          <p:cNvSpPr txBox="1"/>
          <p:nvPr/>
        </p:nvSpPr>
        <p:spPr>
          <a:xfrm>
            <a:off x="7837150" y="9218106"/>
            <a:ext cx="198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A0C6DB34-99E8-181E-3903-D941CC45E27D}"/>
              </a:ext>
            </a:extLst>
          </p:cNvPr>
          <p:cNvSpPr txBox="1"/>
          <p:nvPr/>
        </p:nvSpPr>
        <p:spPr>
          <a:xfrm>
            <a:off x="8121420" y="9218106"/>
            <a:ext cx="198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7E77AE23-E6C1-B439-07A3-244E3D7BDD45}"/>
              </a:ext>
            </a:extLst>
          </p:cNvPr>
          <p:cNvSpPr txBox="1"/>
          <p:nvPr/>
        </p:nvSpPr>
        <p:spPr>
          <a:xfrm>
            <a:off x="8387751" y="9218106"/>
            <a:ext cx="4498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3EF89235-D592-BF27-BF13-43DE3055F909}"/>
              </a:ext>
            </a:extLst>
          </p:cNvPr>
          <p:cNvSpPr txBox="1"/>
          <p:nvPr/>
        </p:nvSpPr>
        <p:spPr>
          <a:xfrm>
            <a:off x="8686428" y="9218106"/>
            <a:ext cx="406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A62EC97B-A5DB-6B81-1F35-ECD252C04780}"/>
              </a:ext>
            </a:extLst>
          </p:cNvPr>
          <p:cNvSpPr txBox="1"/>
          <p:nvPr/>
        </p:nvSpPr>
        <p:spPr>
          <a:xfrm>
            <a:off x="5146245" y="9186476"/>
            <a:ext cx="198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31CE7A1-C935-0CE8-4A4D-D32EBDCF2693}"/>
              </a:ext>
            </a:extLst>
          </p:cNvPr>
          <p:cNvSpPr txBox="1"/>
          <p:nvPr/>
        </p:nvSpPr>
        <p:spPr>
          <a:xfrm>
            <a:off x="5430515" y="9186476"/>
            <a:ext cx="198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BFB23FCE-A8D7-69DF-3ED0-D1B957633A98}"/>
              </a:ext>
            </a:extLst>
          </p:cNvPr>
          <p:cNvSpPr txBox="1"/>
          <p:nvPr/>
        </p:nvSpPr>
        <p:spPr>
          <a:xfrm>
            <a:off x="5696846" y="9186476"/>
            <a:ext cx="4275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DD6F39E-D4F3-A32C-513F-7F2569D551E5}"/>
              </a:ext>
            </a:extLst>
          </p:cNvPr>
          <p:cNvSpPr txBox="1"/>
          <p:nvPr/>
        </p:nvSpPr>
        <p:spPr>
          <a:xfrm>
            <a:off x="5995523" y="9186476"/>
            <a:ext cx="4731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A082B86E-169B-0C6D-4A42-B5EBAC5511D6}"/>
              </a:ext>
            </a:extLst>
          </p:cNvPr>
          <p:cNvCxnSpPr>
            <a:stCxn id="79" idx="0"/>
            <a:endCxn id="82" idx="0"/>
          </p:cNvCxnSpPr>
          <p:nvPr/>
        </p:nvCxnSpPr>
        <p:spPr>
          <a:xfrm>
            <a:off x="5245699" y="9186476"/>
            <a:ext cx="98641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07C3A2FB-A3C8-13FF-A6C8-B80E1D75AAD0}"/>
              </a:ext>
            </a:extLst>
          </p:cNvPr>
          <p:cNvCxnSpPr/>
          <p:nvPr/>
        </p:nvCxnSpPr>
        <p:spPr>
          <a:xfrm>
            <a:off x="7951982" y="9218106"/>
            <a:ext cx="9122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A7313B26-5CBB-ADFE-F4E4-29907FBFD740}"/>
              </a:ext>
            </a:extLst>
          </p:cNvPr>
          <p:cNvSpPr txBox="1"/>
          <p:nvPr/>
        </p:nvSpPr>
        <p:spPr>
          <a:xfrm>
            <a:off x="5376699" y="8943310"/>
            <a:ext cx="716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CA5995C2-D649-E642-789F-543980FF3300}"/>
              </a:ext>
            </a:extLst>
          </p:cNvPr>
          <p:cNvSpPr txBox="1"/>
          <p:nvPr/>
        </p:nvSpPr>
        <p:spPr>
          <a:xfrm>
            <a:off x="8089874" y="8969766"/>
            <a:ext cx="716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B3C877BD-FDD2-98CD-1B1B-6FCE667639F2}"/>
              </a:ext>
            </a:extLst>
          </p:cNvPr>
          <p:cNvSpPr txBox="1"/>
          <p:nvPr/>
        </p:nvSpPr>
        <p:spPr>
          <a:xfrm>
            <a:off x="4483961" y="9183149"/>
            <a:ext cx="973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hour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E1734477-FFE2-BFB3-EEAC-3BF14BF2E44A}"/>
              </a:ext>
            </a:extLst>
          </p:cNvPr>
          <p:cNvSpPr txBox="1"/>
          <p:nvPr/>
        </p:nvSpPr>
        <p:spPr>
          <a:xfrm>
            <a:off x="7143613" y="9200032"/>
            <a:ext cx="973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hour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0245697-A7E2-2FAA-A30A-AC8081C88268}"/>
              </a:ext>
            </a:extLst>
          </p:cNvPr>
          <p:cNvSpPr txBox="1"/>
          <p:nvPr/>
        </p:nvSpPr>
        <p:spPr>
          <a:xfrm>
            <a:off x="215536" y="10021276"/>
            <a:ext cx="9050862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1. ER stress downregulated T-cadherin expressions.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EK293T T-cadherin stable cell line (293TT) and CHO T-cadherin stable cell line (CHO-T).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O-T treated with 0.3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L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Thapsigargi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TG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, Tunicamycin (TM), or MG-132 (MG) for 24 h (n=3).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C,D,E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O-T cells treated with indicated compounds  for 24 hours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n=3).</a:t>
            </a:r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-cadherin mRNA expression.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D,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RNA expression.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E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licing rates of </a:t>
            </a:r>
            <a:r>
              <a:rPr kumimoji="1" lang="en-US" altLang="ja-JP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mplicons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F,G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93TT treated with 3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L tunicamycin for indicated tim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n=3).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F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-cadherin mRNA expression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licing rates of </a:t>
            </a:r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mplicons.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are mean ± SEM. The results of the experiment were tested in two separate trials. One-way analysis of variance with Dunnett’s multiple comparisons. *p &lt; 0.05; **p &lt; 0.01; ***p &lt; 0.001. </a:t>
            </a:r>
          </a:p>
        </p:txBody>
      </p:sp>
      <p:sp>
        <p:nvSpPr>
          <p:cNvPr id="94" name="テキスト ボックス 111"/>
          <p:cNvSpPr txBox="1"/>
          <p:nvPr/>
        </p:nvSpPr>
        <p:spPr>
          <a:xfrm>
            <a:off x="4408861" y="9411989"/>
            <a:ext cx="7740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XBP1u</a:t>
            </a:r>
            <a:r>
              <a:rPr lang="ja-JP" alt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112"/>
          <p:cNvSpPr txBox="1"/>
          <p:nvPr/>
        </p:nvSpPr>
        <p:spPr>
          <a:xfrm>
            <a:off x="4408861" y="9524126"/>
            <a:ext cx="8714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XBP1s</a:t>
            </a:r>
            <a:r>
              <a:rPr lang="ja-JP" alt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線コネクタ 95"/>
          <p:cNvCxnSpPr/>
          <p:nvPr/>
        </p:nvCxnSpPr>
        <p:spPr>
          <a:xfrm flipV="1">
            <a:off x="6329886" y="9763320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テキスト ボックス 74"/>
          <p:cNvSpPr txBox="1"/>
          <p:nvPr/>
        </p:nvSpPr>
        <p:spPr>
          <a:xfrm>
            <a:off x="6433106" y="9640209"/>
            <a:ext cx="5653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76"/>
          <p:cNvSpPr txBox="1"/>
          <p:nvPr/>
        </p:nvSpPr>
        <p:spPr>
          <a:xfrm>
            <a:off x="6438132" y="9328055"/>
            <a:ext cx="6728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111"/>
          <p:cNvSpPr txBox="1"/>
          <p:nvPr/>
        </p:nvSpPr>
        <p:spPr>
          <a:xfrm>
            <a:off x="7109041" y="9451165"/>
            <a:ext cx="7740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XBP1u</a:t>
            </a:r>
            <a:r>
              <a:rPr lang="ja-JP" alt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112"/>
          <p:cNvSpPr txBox="1"/>
          <p:nvPr/>
        </p:nvSpPr>
        <p:spPr>
          <a:xfrm>
            <a:off x="7109041" y="9563302"/>
            <a:ext cx="8714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XBP1s</a:t>
            </a:r>
            <a:r>
              <a:rPr lang="ja-JP" alt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線コネクタ 100"/>
          <p:cNvCxnSpPr/>
          <p:nvPr/>
        </p:nvCxnSpPr>
        <p:spPr>
          <a:xfrm flipV="1">
            <a:off x="9033075" y="9789016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テキスト ボックス 74"/>
          <p:cNvSpPr txBox="1"/>
          <p:nvPr/>
        </p:nvSpPr>
        <p:spPr>
          <a:xfrm>
            <a:off x="9136295" y="9665905"/>
            <a:ext cx="5653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76"/>
          <p:cNvSpPr txBox="1"/>
          <p:nvPr/>
        </p:nvSpPr>
        <p:spPr>
          <a:xfrm>
            <a:off x="9141321" y="9353751"/>
            <a:ext cx="6728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直線コネクタ 103"/>
          <p:cNvCxnSpPr/>
          <p:nvPr/>
        </p:nvCxnSpPr>
        <p:spPr>
          <a:xfrm>
            <a:off x="1856882" y="1196954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/>
          <p:cNvSpPr txBox="1"/>
          <p:nvPr/>
        </p:nvSpPr>
        <p:spPr>
          <a:xfrm>
            <a:off x="2041873" y="1037981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直線コネクタ 105"/>
          <p:cNvCxnSpPr/>
          <p:nvPr/>
        </p:nvCxnSpPr>
        <p:spPr>
          <a:xfrm>
            <a:off x="1856882" y="1685118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テキスト ボックス 106"/>
          <p:cNvSpPr txBox="1"/>
          <p:nvPr/>
        </p:nvSpPr>
        <p:spPr>
          <a:xfrm>
            <a:off x="2041873" y="1526145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2031597" y="674242"/>
            <a:ext cx="784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直線コネクタ 108"/>
          <p:cNvCxnSpPr/>
          <p:nvPr/>
        </p:nvCxnSpPr>
        <p:spPr>
          <a:xfrm>
            <a:off x="1869916" y="2930268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テキスト ボックス 114"/>
          <p:cNvSpPr txBox="1"/>
          <p:nvPr/>
        </p:nvSpPr>
        <p:spPr>
          <a:xfrm>
            <a:off x="2054907" y="2771295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直線コネクタ 115"/>
          <p:cNvCxnSpPr/>
          <p:nvPr/>
        </p:nvCxnSpPr>
        <p:spPr>
          <a:xfrm>
            <a:off x="1869916" y="3418432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テキスト ボックス 116"/>
          <p:cNvSpPr txBox="1"/>
          <p:nvPr/>
        </p:nvSpPr>
        <p:spPr>
          <a:xfrm>
            <a:off x="2054907" y="3259459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2044631" y="2407556"/>
            <a:ext cx="784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線コネクタ 118"/>
          <p:cNvCxnSpPr/>
          <p:nvPr/>
        </p:nvCxnSpPr>
        <p:spPr>
          <a:xfrm>
            <a:off x="4879735" y="1609610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テキスト ボックス 119"/>
          <p:cNvSpPr txBox="1"/>
          <p:nvPr/>
        </p:nvSpPr>
        <p:spPr>
          <a:xfrm>
            <a:off x="5064726" y="1450637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直線コネクタ 120"/>
          <p:cNvCxnSpPr/>
          <p:nvPr/>
        </p:nvCxnSpPr>
        <p:spPr>
          <a:xfrm>
            <a:off x="4879735" y="2211245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テキスト ボックス 121"/>
          <p:cNvSpPr txBox="1"/>
          <p:nvPr/>
        </p:nvSpPr>
        <p:spPr>
          <a:xfrm>
            <a:off x="5064726" y="2052272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4920147" y="1086898"/>
            <a:ext cx="784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線コネクタ 123"/>
          <p:cNvCxnSpPr/>
          <p:nvPr/>
        </p:nvCxnSpPr>
        <p:spPr>
          <a:xfrm>
            <a:off x="4879735" y="1865401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テキスト ボックス 124"/>
          <p:cNvSpPr txBox="1"/>
          <p:nvPr/>
        </p:nvSpPr>
        <p:spPr>
          <a:xfrm>
            <a:off x="5064726" y="1706428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84413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kumimoji="1" lang="en-US" altLang="ja-JP" sz="4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9235193"/>
              </p:ext>
            </p:extLst>
          </p:nvPr>
        </p:nvGraphicFramePr>
        <p:xfrm>
          <a:off x="0" y="497528"/>
          <a:ext cx="2304000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6973594"/>
              </p:ext>
            </p:extLst>
          </p:nvPr>
        </p:nvGraphicFramePr>
        <p:xfrm>
          <a:off x="2304000" y="497528"/>
          <a:ext cx="2304000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83579256"/>
              </p:ext>
            </p:extLst>
          </p:nvPr>
        </p:nvGraphicFramePr>
        <p:xfrm>
          <a:off x="4993200" y="497528"/>
          <a:ext cx="2304000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136622"/>
              </p:ext>
            </p:extLst>
          </p:nvPr>
        </p:nvGraphicFramePr>
        <p:xfrm>
          <a:off x="7297200" y="497528"/>
          <a:ext cx="2304000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テキスト ボックス 8"/>
          <p:cNvSpPr txBox="1"/>
          <p:nvPr/>
        </p:nvSpPr>
        <p:spPr>
          <a:xfrm>
            <a:off x="91955" y="3641347"/>
            <a:ext cx="16071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i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91955" y="4123455"/>
            <a:ext cx="16071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IB: Tsg10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91954" y="4554810"/>
            <a:ext cx="16071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ynten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コネクタ 11"/>
          <p:cNvCxnSpPr/>
          <p:nvPr/>
        </p:nvCxnSpPr>
        <p:spPr>
          <a:xfrm>
            <a:off x="1699104" y="3497278"/>
            <a:ext cx="13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3266418" y="3495674"/>
            <a:ext cx="20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/>
          <p:cNvSpPr txBox="1"/>
          <p:nvPr/>
        </p:nvSpPr>
        <p:spPr>
          <a:xfrm>
            <a:off x="3626418" y="3072770"/>
            <a:ext cx="136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699104" y="3072770"/>
            <a:ext cx="136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1783" t="43615" r="11371" b="27847"/>
          <a:stretch/>
        </p:blipFill>
        <p:spPr>
          <a:xfrm>
            <a:off x="1699103" y="3654155"/>
            <a:ext cx="3600000" cy="32092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1036" t="50940" r="10879" b="15976"/>
          <a:stretch/>
        </p:blipFill>
        <p:spPr>
          <a:xfrm>
            <a:off x="1699104" y="4149878"/>
            <a:ext cx="3600000" cy="38375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" name="図 17"/>
          <p:cNvPicPr>
            <a:picLocks noChangeAspect="1"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50674" t="42011" r="10898" b="43496"/>
          <a:stretch/>
        </p:blipFill>
        <p:spPr>
          <a:xfrm>
            <a:off x="1699103" y="4658413"/>
            <a:ext cx="3600000" cy="17591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aphicFrame>
        <p:nvGraphicFramePr>
          <p:cNvPr id="19" name="グラフ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800994"/>
              </p:ext>
            </p:extLst>
          </p:nvPr>
        </p:nvGraphicFramePr>
        <p:xfrm>
          <a:off x="91954" y="5140732"/>
          <a:ext cx="2520000" cy="2372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0" name="グラフ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3452613"/>
              </p:ext>
            </p:extLst>
          </p:nvPr>
        </p:nvGraphicFramePr>
        <p:xfrm>
          <a:off x="2611954" y="5140732"/>
          <a:ext cx="2520000" cy="2372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1" name="グラフ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6627084"/>
              </p:ext>
            </p:extLst>
          </p:nvPr>
        </p:nvGraphicFramePr>
        <p:xfrm>
          <a:off x="5131954" y="5140732"/>
          <a:ext cx="2520000" cy="2372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cxnSp>
        <p:nvCxnSpPr>
          <p:cNvPr id="22" name="直線コネクタ 21"/>
          <p:cNvCxnSpPr/>
          <p:nvPr/>
        </p:nvCxnSpPr>
        <p:spPr>
          <a:xfrm>
            <a:off x="5319551" y="3893413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5498417" y="3734715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コネクタ 23"/>
          <p:cNvCxnSpPr/>
          <p:nvPr/>
        </p:nvCxnSpPr>
        <p:spPr>
          <a:xfrm>
            <a:off x="5319551" y="4253693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5498417" y="4098668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線コネクタ 25"/>
          <p:cNvCxnSpPr/>
          <p:nvPr/>
        </p:nvCxnSpPr>
        <p:spPr>
          <a:xfrm>
            <a:off x="5319551" y="4658413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5498417" y="4560342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429369" y="3295298"/>
            <a:ext cx="7910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65314" y="3043428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ja-JP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782331" y="84371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ja-JP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65314" y="84371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正方形/長方形 31"/>
          <p:cNvSpPr/>
          <p:nvPr/>
        </p:nvSpPr>
        <p:spPr>
          <a:xfrm>
            <a:off x="-33727" y="7726097"/>
            <a:ext cx="9623462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7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unicamycin treatments in C57BL6/J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ice under fasting condition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ice were challenged with TM(1 μg/g body weight/day)  or vehicle control for 2 days under fasting condition. Serum, total mRNA and tissue lysates, were isolated 4h after second injection (n = 6–7).</a:t>
            </a:r>
          </a:p>
          <a:p>
            <a:r>
              <a:rPr lang="en-US" altLang="ja-JP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,</a:t>
            </a:r>
            <a:r>
              <a:rPr lang="ja-JP" altLang="en-US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ody weight before first treatment and before sacrifice were measured. </a:t>
            </a:r>
            <a:r>
              <a:rPr lang="en-US" altLang="ja-JP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plicing rates of </a:t>
            </a:r>
            <a:r>
              <a:rPr lang="en-US" altLang="ja-JP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mplicons in liver RNA, analyzed by polyacrylamide gel electrophoresis. 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RNA expression in liver, normalized to </a:t>
            </a:r>
            <a:r>
              <a:rPr kumimoji="1"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Rplp0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D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estern blots of exosome markers in the EV fractions from the plasma.</a:t>
            </a:r>
          </a:p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re mean ± SEM. The results of the experiment were tested in two separate trials. one-way analysis of variance with student’s t test. *p &lt; 0.05; **p &lt; 0.01; ***p &lt; 0.001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7207265" y="84371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ja-JP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7234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S2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176027" y="4152917"/>
            <a:ext cx="92833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i="1" dirty="0">
                <a:latin typeface="Courier New" panose="02070309020205020404" pitchFamily="49" charset="0"/>
                <a:cs typeface="Courier New" panose="02070309020205020404" pitchFamily="49" charset="0"/>
              </a:rPr>
              <a:t>Xbp1 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: -GGUCUG</a:t>
            </a:r>
            <a:r>
              <a:rPr lang="en-US" altLang="ja-JP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UGAGU</a:t>
            </a:r>
            <a:r>
              <a:rPr lang="en-US" altLang="ja-JP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ja-JP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CA</a:t>
            </a:r>
            <a:r>
              <a:rPr lang="en-US" altLang="ja-JP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ja-JP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UCAG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ACUACG</a:t>
            </a:r>
            <a:r>
              <a:rPr lang="en-US" altLang="ja-JP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GCACCU</a:t>
            </a:r>
            <a:r>
              <a:rPr lang="en-US" altLang="ja-JP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U</a:t>
            </a:r>
            <a:r>
              <a:rPr lang="en-US" altLang="ja-JP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CA</a:t>
            </a:r>
            <a:r>
              <a:rPr lang="en-US" altLang="ja-JP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ja-JP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UGCA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GGCCC-</a:t>
            </a:r>
            <a:endParaRPr lang="ja-JP" altLang="en-US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176027" y="3790536"/>
            <a:ext cx="74911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i="1" dirty="0">
                <a:latin typeface="Courier New" panose="02070309020205020404" pitchFamily="49" charset="0"/>
                <a:cs typeface="Courier New" panose="02070309020205020404" pitchFamily="49" charset="0"/>
              </a:rPr>
              <a:t>Cdh13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: -AACAUCC</a:t>
            </a:r>
            <a:r>
              <a:rPr lang="en-US" altLang="ja-JP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UCAG</a:t>
            </a:r>
            <a:r>
              <a:rPr lang="en-US" altLang="ja-JP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ja-JP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altLang="ja-JP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US" altLang="ja-JP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UGAC</a:t>
            </a:r>
            <a:r>
              <a:rPr lang="en-US" altLang="ja-JP" b="1" dirty="0">
                <a:latin typeface="Courier New" panose="02070309020205020404" pitchFamily="49" charset="0"/>
                <a:cs typeface="Courier New" panose="02070309020205020404" pitchFamily="49" charset="0"/>
              </a:rPr>
              <a:t>AAGCCAUCUCCUAACAUGUU-</a:t>
            </a:r>
            <a:endParaRPr lang="ja-JP" altLang="en-US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40794" y="506052"/>
            <a:ext cx="3584759" cy="3273836"/>
          </a:xfrm>
          <a:prstGeom prst="rect">
            <a:avLst/>
          </a:prstGeom>
        </p:spPr>
      </p:pic>
      <p:sp>
        <p:nvSpPr>
          <p:cNvPr id="10" name="正方形/長方形 9"/>
          <p:cNvSpPr/>
          <p:nvPr/>
        </p:nvSpPr>
        <p:spPr>
          <a:xfrm>
            <a:off x="17082" y="4707083"/>
            <a:ext cx="96012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2. The sequence of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Cdh13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nd that of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includes consensus IRE1α recognition sites (red). Complementary sequences are shown in blue letter.</a:t>
            </a:r>
          </a:p>
        </p:txBody>
      </p:sp>
    </p:spTree>
    <p:extLst>
      <p:ext uri="{BB962C8B-B14F-4D97-AF65-F5344CB8AC3E}">
        <p14:creationId xmlns:p14="http://schemas.microsoft.com/office/powerpoint/2010/main" val="3014924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32612" y="1533577"/>
            <a:ext cx="2880000" cy="31609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32612" y="2104499"/>
            <a:ext cx="2880000" cy="36990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9" name="図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32612" y="2749646"/>
            <a:ext cx="2880000" cy="32925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0" name="テキスト ボックス 9"/>
          <p:cNvSpPr txBox="1"/>
          <p:nvPr/>
        </p:nvSpPr>
        <p:spPr>
          <a:xfrm>
            <a:off x="125631" y="1506960"/>
            <a:ext cx="1692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Ali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25631" y="2126904"/>
            <a:ext cx="1692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Tsg10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25631" y="2718799"/>
            <a:ext cx="1692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Synten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549208" y="1113414"/>
            <a:ext cx="55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920269" y="1113414"/>
            <a:ext cx="55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193083" y="1113414"/>
            <a:ext cx="55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535470" y="1113414"/>
            <a:ext cx="55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953639" y="1118276"/>
            <a:ext cx="55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324700" y="1118276"/>
            <a:ext cx="55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597514" y="1118276"/>
            <a:ext cx="55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979657" y="1118276"/>
            <a:ext cx="55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549208" y="723203"/>
            <a:ext cx="1334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937074" y="725960"/>
            <a:ext cx="1334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コネクタ 22"/>
          <p:cNvCxnSpPr/>
          <p:nvPr/>
        </p:nvCxnSpPr>
        <p:spPr>
          <a:xfrm>
            <a:off x="1623340" y="1087632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>
            <a:off x="3054552" y="1087632"/>
            <a:ext cx="12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393423" y="1123792"/>
            <a:ext cx="1175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hour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線コネクタ 25"/>
          <p:cNvCxnSpPr/>
          <p:nvPr/>
        </p:nvCxnSpPr>
        <p:spPr>
          <a:xfrm>
            <a:off x="4413154" y="1710847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4598145" y="1551874"/>
            <a:ext cx="578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コネクタ 27"/>
          <p:cNvCxnSpPr/>
          <p:nvPr/>
        </p:nvCxnSpPr>
        <p:spPr>
          <a:xfrm>
            <a:off x="4401566" y="2303994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4586557" y="2145021"/>
            <a:ext cx="578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/>
          <p:cNvCxnSpPr/>
          <p:nvPr/>
        </p:nvCxnSpPr>
        <p:spPr>
          <a:xfrm>
            <a:off x="4401566" y="2753909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/>
          <p:cNvSpPr txBox="1"/>
          <p:nvPr/>
        </p:nvSpPr>
        <p:spPr>
          <a:xfrm>
            <a:off x="4612823" y="2537025"/>
            <a:ext cx="578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/>
          <p:cNvCxnSpPr/>
          <p:nvPr/>
        </p:nvCxnSpPr>
        <p:spPr>
          <a:xfrm>
            <a:off x="4382376" y="3081201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>
            <a:off x="4607670" y="2953050"/>
            <a:ext cx="578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491768" y="1123792"/>
            <a:ext cx="7910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グラフ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6376561"/>
              </p:ext>
            </p:extLst>
          </p:nvPr>
        </p:nvGraphicFramePr>
        <p:xfrm>
          <a:off x="48349" y="336337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1892356"/>
              </p:ext>
            </p:extLst>
          </p:nvPr>
        </p:nvGraphicFramePr>
        <p:xfrm>
          <a:off x="48349" y="610208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9" name="テキスト ボックス 38"/>
          <p:cNvSpPr txBox="1"/>
          <p:nvPr/>
        </p:nvSpPr>
        <p:spPr>
          <a:xfrm>
            <a:off x="266696" y="72168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楕円 39"/>
          <p:cNvSpPr/>
          <p:nvPr/>
        </p:nvSpPr>
        <p:spPr>
          <a:xfrm>
            <a:off x="-718457" y="-3531129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楕円 40"/>
          <p:cNvSpPr/>
          <p:nvPr/>
        </p:nvSpPr>
        <p:spPr>
          <a:xfrm>
            <a:off x="-590554" y="14039632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S3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781393" y="102544"/>
            <a:ext cx="2052000" cy="4001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HEK293TT cell</a:t>
            </a:r>
          </a:p>
        </p:txBody>
      </p:sp>
      <p:graphicFrame>
        <p:nvGraphicFramePr>
          <p:cNvPr id="61" name="グラフ 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152867"/>
              </p:ext>
            </p:extLst>
          </p:nvPr>
        </p:nvGraphicFramePr>
        <p:xfrm>
          <a:off x="48349" y="8886269"/>
          <a:ext cx="4551083" cy="27790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20174958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S3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0671701" y="8500787"/>
            <a:ext cx="71882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3200" dirty="0"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備忘録</a:t>
            </a: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40243" y="1373590"/>
            <a:ext cx="1440000" cy="20326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40243" y="1818353"/>
            <a:ext cx="1440000" cy="22289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40243" y="2297920"/>
            <a:ext cx="1440000" cy="25005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8" name="テキスト ボックス 7"/>
          <p:cNvSpPr txBox="1"/>
          <p:nvPr/>
        </p:nvSpPr>
        <p:spPr>
          <a:xfrm>
            <a:off x="891740" y="1377288"/>
            <a:ext cx="143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Ali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891740" y="1818353"/>
            <a:ext cx="143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Tsg10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891740" y="2283378"/>
            <a:ext cx="143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Synten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340243" y="933004"/>
            <a:ext cx="583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692986" y="933004"/>
            <a:ext cx="583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079123" y="933004"/>
            <a:ext cx="583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.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517532" y="933004"/>
            <a:ext cx="583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780420" y="879030"/>
            <a:ext cx="1611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G (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91794" y="532894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図 21"/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2340243" y="3892804"/>
            <a:ext cx="1440000" cy="31960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3" name="図 22"/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2340243" y="4522302"/>
            <a:ext cx="1440000" cy="25594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4" name="図 23"/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2340243" y="5007988"/>
            <a:ext cx="1440000" cy="36426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5" name="テキスト ボックス 24"/>
          <p:cNvSpPr txBox="1"/>
          <p:nvPr/>
        </p:nvSpPr>
        <p:spPr>
          <a:xfrm>
            <a:off x="286475" y="3499361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図 25"/>
          <p:cNvPicPr>
            <a:picLocks noChangeAspect="1"/>
          </p:cNvPicPr>
          <p:nvPr/>
        </p:nvPicPr>
        <p:blipFill rotWithShape="1"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40243" y="6731463"/>
            <a:ext cx="1440000" cy="33739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7" name="図 26"/>
          <p:cNvPicPr>
            <a:picLocks noChangeAspect="1"/>
          </p:cNvPicPr>
          <p:nvPr/>
        </p:nvPicPr>
        <p:blipFill rotWithShape="1"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40243" y="7350691"/>
            <a:ext cx="1440000" cy="25937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8" name="図 27"/>
          <p:cNvPicPr>
            <a:picLocks noChangeAspect="1"/>
          </p:cNvPicPr>
          <p:nvPr/>
        </p:nvPicPr>
        <p:blipFill rotWithShape="1">
          <a:blip r:embed="rId11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40243" y="7836377"/>
            <a:ext cx="1440000" cy="36672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0" name="テキスト ボックス 39"/>
          <p:cNvSpPr txBox="1"/>
          <p:nvPr/>
        </p:nvSpPr>
        <p:spPr>
          <a:xfrm>
            <a:off x="891740" y="6703972"/>
            <a:ext cx="143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Ali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891740" y="7272037"/>
            <a:ext cx="143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Tsg10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891740" y="7787862"/>
            <a:ext cx="143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Synten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2295979" y="6259688"/>
            <a:ext cx="583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2705872" y="6259688"/>
            <a:ext cx="386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072959" y="6259688"/>
            <a:ext cx="327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3397071" y="6259688"/>
            <a:ext cx="583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780420" y="6246463"/>
            <a:ext cx="1571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G (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891740" y="3918074"/>
            <a:ext cx="143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Alix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891740" y="4435339"/>
            <a:ext cx="143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Tsg10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891740" y="4900364"/>
            <a:ext cx="143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Synten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295979" y="3499190"/>
            <a:ext cx="583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693172" y="3499190"/>
            <a:ext cx="386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085659" y="3499190"/>
            <a:ext cx="307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3384371" y="3499190"/>
            <a:ext cx="5008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804330" y="3512415"/>
            <a:ext cx="15478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M (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280551" y="5887221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8" name="グラフ 5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8227702"/>
              </p:ext>
            </p:extLst>
          </p:nvPr>
        </p:nvGraphicFramePr>
        <p:xfrm>
          <a:off x="11173394" y="2728644"/>
          <a:ext cx="396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59" name="グラフ 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4908488"/>
              </p:ext>
            </p:extLst>
          </p:nvPr>
        </p:nvGraphicFramePr>
        <p:xfrm>
          <a:off x="11167470" y="5407558"/>
          <a:ext cx="396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62" name="グラフ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3796987"/>
              </p:ext>
            </p:extLst>
          </p:nvPr>
        </p:nvGraphicFramePr>
        <p:xfrm>
          <a:off x="4571378" y="331529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63" name="グラフ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8296919"/>
              </p:ext>
            </p:extLst>
          </p:nvPr>
        </p:nvGraphicFramePr>
        <p:xfrm>
          <a:off x="4571378" y="603309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64" name="グラフ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2038076"/>
              </p:ext>
            </p:extLst>
          </p:nvPr>
        </p:nvGraphicFramePr>
        <p:xfrm>
          <a:off x="4571378" y="57209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65" name="グラフ 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2720338"/>
              </p:ext>
            </p:extLst>
          </p:nvPr>
        </p:nvGraphicFramePr>
        <p:xfrm>
          <a:off x="11178713" y="283191"/>
          <a:ext cx="396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66" name="楕円 65"/>
          <p:cNvSpPr/>
          <p:nvPr/>
        </p:nvSpPr>
        <p:spPr>
          <a:xfrm>
            <a:off x="-718457" y="-3531129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7" name="楕円 66"/>
          <p:cNvSpPr/>
          <p:nvPr/>
        </p:nvSpPr>
        <p:spPr>
          <a:xfrm>
            <a:off x="-590554" y="14039632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11420273" y="10301092"/>
            <a:ext cx="6622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solidFill>
                  <a:srgbClr val="0070C0"/>
                </a:solidFill>
              </a:rPr>
              <a:t>Fig3</a:t>
            </a:r>
            <a:r>
              <a:rPr kumimoji="1" lang="ja-JP" altLang="en-US" sz="2400" b="1" dirty="0">
                <a:solidFill>
                  <a:srgbClr val="0070C0"/>
                </a:solidFill>
              </a:rPr>
              <a:t>に対応</a:t>
            </a:r>
            <a:endParaRPr kumimoji="1" lang="en-US" altLang="ja-JP" sz="2400" b="1" dirty="0">
              <a:solidFill>
                <a:srgbClr val="0070C0"/>
              </a:solidFill>
            </a:endParaRPr>
          </a:p>
          <a:p>
            <a:r>
              <a:rPr kumimoji="1" lang="en-US" altLang="ja-JP" sz="2400" b="1" dirty="0">
                <a:solidFill>
                  <a:srgbClr val="FF0000"/>
                </a:solidFill>
              </a:rPr>
              <a:t>RNA</a:t>
            </a:r>
            <a:r>
              <a:rPr kumimoji="1" lang="ja-JP" altLang="en-US" sz="2400" b="1" dirty="0">
                <a:solidFill>
                  <a:srgbClr val="FF0000"/>
                </a:solidFill>
              </a:rPr>
              <a:t>量は減少していないが、回収手技の関係でサンプル間のブレや、取り損ないがある</a:t>
            </a:r>
            <a:endParaRPr kumimoji="1" lang="en-US" altLang="ja-JP" sz="2400" b="1" dirty="0">
              <a:solidFill>
                <a:srgbClr val="FF0000"/>
              </a:solidFill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809116" y="184666"/>
            <a:ext cx="1548000" cy="4001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>
                <a:latin typeface="Arial" panose="020B0604020202020204" pitchFamily="34" charset="0"/>
                <a:cs typeface="Arial" panose="020B0604020202020204" pitchFamily="34" charset="0"/>
              </a:rPr>
              <a:t>CHO-T </a:t>
            </a:r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</a:p>
        </p:txBody>
      </p:sp>
      <p:pic>
        <p:nvPicPr>
          <p:cNvPr id="61" name="図 60"/>
          <p:cNvPicPr>
            <a:picLocks noChangeAspect="1"/>
          </p:cNvPicPr>
          <p:nvPr/>
        </p:nvPicPr>
        <p:blipFill rotWithShape="1">
          <a:blip r:embed="rId1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65659" y="11148459"/>
            <a:ext cx="1440000" cy="31400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9" name="図 68"/>
          <p:cNvPicPr>
            <a:picLocks noChangeAspect="1"/>
          </p:cNvPicPr>
          <p:nvPr/>
        </p:nvPicPr>
        <p:blipFill rotWithShape="1">
          <a:blip r:embed="rId1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65659" y="10627428"/>
            <a:ext cx="1440000" cy="27728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0" name="図 69"/>
          <p:cNvPicPr>
            <a:picLocks noChangeAspect="1"/>
          </p:cNvPicPr>
          <p:nvPr/>
        </p:nvPicPr>
        <p:blipFill rotWithShape="1">
          <a:blip r:embed="rId2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65659" y="10089101"/>
            <a:ext cx="1440000" cy="26018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1" name="テキスト ボックス 70"/>
          <p:cNvSpPr txBox="1"/>
          <p:nvPr/>
        </p:nvSpPr>
        <p:spPr>
          <a:xfrm>
            <a:off x="1516512" y="9401576"/>
            <a:ext cx="66988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</a:p>
          <a:p>
            <a:pPr algn="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4μ8c</a:t>
            </a: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990540" y="10600860"/>
            <a:ext cx="15115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B: Tsg101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990540" y="11112647"/>
            <a:ext cx="15115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Syntenin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990540" y="10056807"/>
            <a:ext cx="15115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Alix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2341124" y="9401576"/>
            <a:ext cx="34050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3118798" y="9401576"/>
            <a:ext cx="34050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2745893" y="9401576"/>
            <a:ext cx="34050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3491703" y="9401576"/>
            <a:ext cx="34050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graphicFrame>
        <p:nvGraphicFramePr>
          <p:cNvPr id="79" name="グラフ 7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0744163"/>
              </p:ext>
            </p:extLst>
          </p:nvPr>
        </p:nvGraphicFramePr>
        <p:xfrm>
          <a:off x="4571378" y="926863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sp>
        <p:nvSpPr>
          <p:cNvPr id="80" name="テキスト ボックス 79"/>
          <p:cNvSpPr txBox="1"/>
          <p:nvPr/>
        </p:nvSpPr>
        <p:spPr>
          <a:xfrm>
            <a:off x="278663" y="8860786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790116" y="8737895"/>
            <a:ext cx="1683166" cy="4001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UV-F2 cell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直線コネクタ 81"/>
          <p:cNvCxnSpPr/>
          <p:nvPr/>
        </p:nvCxnSpPr>
        <p:spPr>
          <a:xfrm>
            <a:off x="3805776" y="1493707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/>
          <p:cNvSpPr txBox="1"/>
          <p:nvPr/>
        </p:nvSpPr>
        <p:spPr>
          <a:xfrm>
            <a:off x="3990767" y="1334734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直線コネクタ 83"/>
          <p:cNvCxnSpPr/>
          <p:nvPr/>
        </p:nvCxnSpPr>
        <p:spPr>
          <a:xfrm>
            <a:off x="3794188" y="1929371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/>
          <p:cNvSpPr txBox="1"/>
          <p:nvPr/>
        </p:nvSpPr>
        <p:spPr>
          <a:xfrm>
            <a:off x="3979179" y="1770398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直線コネクタ 85"/>
          <p:cNvCxnSpPr/>
          <p:nvPr/>
        </p:nvCxnSpPr>
        <p:spPr>
          <a:xfrm>
            <a:off x="3794188" y="2297920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86"/>
          <p:cNvSpPr txBox="1"/>
          <p:nvPr/>
        </p:nvSpPr>
        <p:spPr>
          <a:xfrm>
            <a:off x="4005445" y="2170033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線コネクタ 87"/>
          <p:cNvCxnSpPr/>
          <p:nvPr/>
        </p:nvCxnSpPr>
        <p:spPr>
          <a:xfrm>
            <a:off x="3789035" y="2553393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/>
          <p:cNvSpPr txBox="1"/>
          <p:nvPr/>
        </p:nvSpPr>
        <p:spPr>
          <a:xfrm>
            <a:off x="4000292" y="2381392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3884391" y="906652"/>
            <a:ext cx="656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直線コネクタ 90"/>
          <p:cNvCxnSpPr/>
          <p:nvPr/>
        </p:nvCxnSpPr>
        <p:spPr>
          <a:xfrm>
            <a:off x="3805776" y="4083273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テキスト ボックス 91"/>
          <p:cNvSpPr txBox="1"/>
          <p:nvPr/>
        </p:nvSpPr>
        <p:spPr>
          <a:xfrm>
            <a:off x="3990767" y="3924300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直線コネクタ 92"/>
          <p:cNvCxnSpPr/>
          <p:nvPr/>
        </p:nvCxnSpPr>
        <p:spPr>
          <a:xfrm>
            <a:off x="3794188" y="4674613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テキスト ボックス 93"/>
          <p:cNvSpPr txBox="1"/>
          <p:nvPr/>
        </p:nvSpPr>
        <p:spPr>
          <a:xfrm>
            <a:off x="3979179" y="4515640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直線コネクタ 94"/>
          <p:cNvCxnSpPr/>
          <p:nvPr/>
        </p:nvCxnSpPr>
        <p:spPr>
          <a:xfrm>
            <a:off x="3794188" y="5015220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テキスト ボックス 95"/>
          <p:cNvSpPr txBox="1"/>
          <p:nvPr/>
        </p:nvSpPr>
        <p:spPr>
          <a:xfrm>
            <a:off x="4005445" y="4887333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直線コネクタ 96"/>
          <p:cNvCxnSpPr/>
          <p:nvPr/>
        </p:nvCxnSpPr>
        <p:spPr>
          <a:xfrm>
            <a:off x="3789035" y="5364075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テキスト ボックス 97"/>
          <p:cNvSpPr txBox="1"/>
          <p:nvPr/>
        </p:nvSpPr>
        <p:spPr>
          <a:xfrm>
            <a:off x="4000292" y="5192074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3884391" y="3496218"/>
            <a:ext cx="656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直線コネクタ 99"/>
          <p:cNvCxnSpPr/>
          <p:nvPr/>
        </p:nvCxnSpPr>
        <p:spPr>
          <a:xfrm>
            <a:off x="3803470" y="6891175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100"/>
          <p:cNvSpPr txBox="1"/>
          <p:nvPr/>
        </p:nvSpPr>
        <p:spPr>
          <a:xfrm>
            <a:off x="3988461" y="6732202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線コネクタ 101"/>
          <p:cNvCxnSpPr/>
          <p:nvPr/>
        </p:nvCxnSpPr>
        <p:spPr>
          <a:xfrm>
            <a:off x="3791882" y="7479420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テキスト ボックス 102"/>
          <p:cNvSpPr txBox="1"/>
          <p:nvPr/>
        </p:nvSpPr>
        <p:spPr>
          <a:xfrm>
            <a:off x="3976873" y="7320447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直線コネクタ 103"/>
          <p:cNvCxnSpPr/>
          <p:nvPr/>
        </p:nvCxnSpPr>
        <p:spPr>
          <a:xfrm>
            <a:off x="3791882" y="7846466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/>
          <p:cNvSpPr txBox="1"/>
          <p:nvPr/>
        </p:nvSpPr>
        <p:spPr>
          <a:xfrm>
            <a:off x="4003139" y="7718579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直線コネクタ 105"/>
          <p:cNvCxnSpPr/>
          <p:nvPr/>
        </p:nvCxnSpPr>
        <p:spPr>
          <a:xfrm>
            <a:off x="3786729" y="8187890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テキスト ボックス 106"/>
          <p:cNvSpPr txBox="1"/>
          <p:nvPr/>
        </p:nvSpPr>
        <p:spPr>
          <a:xfrm>
            <a:off x="3997986" y="8015889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882085" y="6304120"/>
            <a:ext cx="656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直線コネクタ 108"/>
          <p:cNvCxnSpPr/>
          <p:nvPr/>
        </p:nvCxnSpPr>
        <p:spPr>
          <a:xfrm>
            <a:off x="3810929" y="10186713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テキスト ボックス 109"/>
          <p:cNvSpPr txBox="1"/>
          <p:nvPr/>
        </p:nvSpPr>
        <p:spPr>
          <a:xfrm>
            <a:off x="3995920" y="10027740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直線コネクタ 110"/>
          <p:cNvCxnSpPr/>
          <p:nvPr/>
        </p:nvCxnSpPr>
        <p:spPr>
          <a:xfrm>
            <a:off x="3799341" y="10773768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テキスト ボックス 111"/>
          <p:cNvSpPr txBox="1"/>
          <p:nvPr/>
        </p:nvSpPr>
        <p:spPr>
          <a:xfrm>
            <a:off x="3984332" y="10614795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直線コネクタ 112"/>
          <p:cNvCxnSpPr/>
          <p:nvPr/>
        </p:nvCxnSpPr>
        <p:spPr>
          <a:xfrm>
            <a:off x="3799341" y="11167807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テキスト ボックス 113"/>
          <p:cNvSpPr txBox="1"/>
          <p:nvPr/>
        </p:nvSpPr>
        <p:spPr>
          <a:xfrm>
            <a:off x="4010598" y="11039920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直線コネクタ 114"/>
          <p:cNvCxnSpPr/>
          <p:nvPr/>
        </p:nvCxnSpPr>
        <p:spPr>
          <a:xfrm>
            <a:off x="3794188" y="11423280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テキスト ボックス 115"/>
          <p:cNvSpPr txBox="1"/>
          <p:nvPr/>
        </p:nvSpPr>
        <p:spPr>
          <a:xfrm>
            <a:off x="4005445" y="11251279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3889544" y="9599658"/>
            <a:ext cx="656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02434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27382" y="2503256"/>
            <a:ext cx="1610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α-tubuli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27382" y="1845005"/>
            <a:ext cx="1610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-cadheri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98304" y="1713950"/>
            <a:ext cx="1440000" cy="5737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98304" y="2597101"/>
            <a:ext cx="1440000" cy="2706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05554" y="3160302"/>
            <a:ext cx="1440000" cy="3264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テキスト ボックス 8"/>
          <p:cNvSpPr txBox="1"/>
          <p:nvPr/>
        </p:nvSpPr>
        <p:spPr>
          <a:xfrm>
            <a:off x="327382" y="3138843"/>
            <a:ext cx="16108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PN</a:t>
            </a:r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8826190"/>
              </p:ext>
            </p:extLst>
          </p:nvPr>
        </p:nvGraphicFramePr>
        <p:xfrm>
          <a:off x="4510957" y="81649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770261" y="188138"/>
            <a:ext cx="4370796" cy="4001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2 T-cadherin overexpressing cell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061991"/>
              </p:ext>
            </p:extLst>
          </p:nvPr>
        </p:nvGraphicFramePr>
        <p:xfrm>
          <a:off x="327382" y="446172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6480237"/>
              </p:ext>
            </p:extLst>
          </p:nvPr>
        </p:nvGraphicFramePr>
        <p:xfrm>
          <a:off x="4899382" y="446172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4" name="テキスト ボックス 13"/>
          <p:cNvSpPr txBox="1"/>
          <p:nvPr/>
        </p:nvSpPr>
        <p:spPr>
          <a:xfrm>
            <a:off x="266696" y="72168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66696" y="3959980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884939" y="3959980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S3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楕円 18"/>
          <p:cNvSpPr/>
          <p:nvPr/>
        </p:nvSpPr>
        <p:spPr>
          <a:xfrm>
            <a:off x="-718457" y="-3531129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楕円 19"/>
          <p:cNvSpPr/>
          <p:nvPr/>
        </p:nvSpPr>
        <p:spPr>
          <a:xfrm>
            <a:off x="-590554" y="14039632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/>
          <p:cNvSpPr/>
          <p:nvPr/>
        </p:nvSpPr>
        <p:spPr>
          <a:xfrm>
            <a:off x="60686" y="7433173"/>
            <a:ext cx="960120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00">
              <a:defRPr/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harmacological induction of ER stress reduced exosome secretio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93TT treated with 3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L tunicamycin for indicated time. The secreted exosomes were purified and proved by antibodies against exosome markers (n=3)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B,C,D, 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HO-T treated with indicated concentration of (A)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Thapsigargin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(B) Tunicamycin, or (C) MG132  for 24 hours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n=3)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E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2 cells treated with 0.3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L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Thapsigargin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TG) and 3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μmo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L 4μ8c for 24 h (n=3)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F,G,H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2 T-cadherin overexpressing cells treated with 100 nmol/L tunicamycin for 48 hours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F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hole cell lysates (n=3)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G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otal RNA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n=3).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H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ll proteins of whole cell (n=3).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are mean ± SEM. The results of the experiment were tested in two separate trials. For (A) , (B), and (C), one-way analysis of variance with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Dunnett’s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multiple comparisons. For (D)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ne-way analysis of variance with Tukey’s multiple comparisons.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*p &lt; 0.05; **p &lt; 0.01; ***p &lt; 0.001. 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 rot="16200000">
            <a:off x="2078224" y="332441"/>
            <a:ext cx="1280160" cy="1491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800"/>
              </a:lnSpc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  <a:p>
            <a:pPr>
              <a:lnSpc>
                <a:spcPts val="2800"/>
              </a:lnSpc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</a:p>
          <a:p>
            <a:pPr>
              <a:lnSpc>
                <a:spcPts val="2800"/>
              </a:lnSpc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PN</a:t>
            </a:r>
          </a:p>
          <a:p>
            <a:pPr>
              <a:lnSpc>
                <a:spcPts val="2800"/>
              </a:lnSpc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PN+TM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/>
          <p:cNvCxnSpPr/>
          <p:nvPr/>
        </p:nvCxnSpPr>
        <p:spPr>
          <a:xfrm>
            <a:off x="3445512" y="2138896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/>
          <p:cNvSpPr txBox="1"/>
          <p:nvPr/>
        </p:nvSpPr>
        <p:spPr>
          <a:xfrm>
            <a:off x="3630503" y="1979923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524127" y="1551841"/>
            <a:ext cx="656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コネクタ 23"/>
          <p:cNvCxnSpPr/>
          <p:nvPr/>
        </p:nvCxnSpPr>
        <p:spPr>
          <a:xfrm>
            <a:off x="3445512" y="2756074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3630503" y="2597101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線コネクタ 27"/>
          <p:cNvCxnSpPr/>
          <p:nvPr/>
        </p:nvCxnSpPr>
        <p:spPr>
          <a:xfrm>
            <a:off x="3445512" y="3246336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3630503" y="3087363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78764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501" t="32430" r="2820" b="56693"/>
          <a:stretch/>
        </p:blipFill>
        <p:spPr>
          <a:xfrm>
            <a:off x="1146295" y="1593942"/>
            <a:ext cx="8398935" cy="550333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0" y="1499776"/>
            <a:ext cx="1337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00 bps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0" y="1812344"/>
            <a:ext cx="1337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00 bps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</a:p>
        </p:txBody>
      </p:sp>
      <p:sp>
        <p:nvSpPr>
          <p:cNvPr id="7" name="楕円 6"/>
          <p:cNvSpPr/>
          <p:nvPr/>
        </p:nvSpPr>
        <p:spPr>
          <a:xfrm>
            <a:off x="-718457" y="-3531129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楕円 7"/>
          <p:cNvSpPr/>
          <p:nvPr/>
        </p:nvSpPr>
        <p:spPr>
          <a:xfrm>
            <a:off x="-590554" y="14039632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1153139" y="736764"/>
            <a:ext cx="1345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 (*1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2118338" y="736764"/>
            <a:ext cx="134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</a:t>
            </a:r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1640879" y="736765"/>
            <a:ext cx="1345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2606079" y="736764"/>
            <a:ext cx="134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</a:t>
            </a:r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rot="16200000">
            <a:off x="3164579" y="736766"/>
            <a:ext cx="1345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4129779" y="736765"/>
            <a:ext cx="134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</a:t>
            </a:r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3652320" y="736766"/>
            <a:ext cx="1345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 rot="16200000">
            <a:off x="4617520" y="736765"/>
            <a:ext cx="134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</a:t>
            </a:r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5075930" y="736764"/>
            <a:ext cx="1345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6041130" y="736763"/>
            <a:ext cx="134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</a:t>
            </a:r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5563671" y="736764"/>
            <a:ext cx="1345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6528871" y="736763"/>
            <a:ext cx="1345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</a:t>
            </a:r>
            <a:r>
              <a:rPr kumimoji="1" lang="en-US" altLang="ja-JP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endParaRPr kumimoji="1" lang="ja-JP" alt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7077374" y="734838"/>
            <a:ext cx="13488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 (*2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 rot="16200000">
            <a:off x="7336775" y="518323"/>
            <a:ext cx="17819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 (*0.5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 rot="16200000">
            <a:off x="7830866" y="518324"/>
            <a:ext cx="1781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 (*0.25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 rot="16200000">
            <a:off x="8352294" y="518324"/>
            <a:ext cx="17819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i Ctrl (*0.125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グラフ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5141451"/>
              </p:ext>
            </p:extLst>
          </p:nvPr>
        </p:nvGraphicFramePr>
        <p:xfrm>
          <a:off x="121569" y="2118934"/>
          <a:ext cx="4752975" cy="285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0" name="テキスト ボックス 29"/>
          <p:cNvSpPr txBox="1"/>
          <p:nvPr/>
        </p:nvSpPr>
        <p:spPr>
          <a:xfrm rot="16200000">
            <a:off x="670539" y="736764"/>
            <a:ext cx="1345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S4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85067" y="532894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4874544" y="2282475"/>
            <a:ext cx="7179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03" name="グループ化 102"/>
          <p:cNvGrpSpPr/>
          <p:nvPr/>
        </p:nvGrpSpPr>
        <p:grpSpPr>
          <a:xfrm>
            <a:off x="5233510" y="2602712"/>
            <a:ext cx="2506962" cy="2371151"/>
            <a:chOff x="263804" y="3284858"/>
            <a:chExt cx="3668588" cy="3449553"/>
          </a:xfrm>
        </p:grpSpPr>
        <p:pic>
          <p:nvPicPr>
            <p:cNvPr id="104" name="図 10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060" y="3508512"/>
              <a:ext cx="3584332" cy="3225899"/>
            </a:xfrm>
            <a:prstGeom prst="rect">
              <a:avLst/>
            </a:prstGeom>
          </p:spPr>
        </p:pic>
        <p:sp>
          <p:nvSpPr>
            <p:cNvPr id="105" name="テキスト ボックス 104"/>
            <p:cNvSpPr txBox="1"/>
            <p:nvPr/>
          </p:nvSpPr>
          <p:spPr>
            <a:xfrm>
              <a:off x="263804" y="3284858"/>
              <a:ext cx="3562761" cy="3805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ifferentially expressed genes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直線矢印コネクタ 105"/>
            <p:cNvCxnSpPr/>
            <p:nvPr/>
          </p:nvCxnSpPr>
          <p:spPr>
            <a:xfrm>
              <a:off x="1143000" y="5702300"/>
              <a:ext cx="636588" cy="37147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テキスト ボックス 106"/>
            <p:cNvSpPr txBox="1"/>
            <p:nvPr/>
          </p:nvSpPr>
          <p:spPr>
            <a:xfrm>
              <a:off x="827397" y="5273557"/>
              <a:ext cx="1505173" cy="6716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Cdh13</a:t>
              </a:r>
            </a:p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(T-cadherin)</a:t>
              </a: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893F231-6C53-D9DF-A1E3-D3E8B3F551FB}"/>
              </a:ext>
            </a:extLst>
          </p:cNvPr>
          <p:cNvSpPr txBox="1"/>
          <p:nvPr/>
        </p:nvSpPr>
        <p:spPr>
          <a:xfrm>
            <a:off x="168990" y="4973863"/>
            <a:ext cx="937624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ja-JP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knockdown in CHO T-cadherin expressing cells (CHO-T)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kumimoji="1" lang="en-US" altLang="ja-JP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expression quantified by polyacrylamide gel electrophoresis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 volcano plot. Data show differentially expressed genes in siXBP1-treated cells compared to negative control siRNA-treated cells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479621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AEF3F23-3069-6026-430D-670BF9126268}"/>
              </a:ext>
            </a:extLst>
          </p:cNvPr>
          <p:cNvSpPr/>
          <p:nvPr/>
        </p:nvSpPr>
        <p:spPr>
          <a:xfrm>
            <a:off x="0" y="6715335"/>
            <a:ext cx="96012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5. Poly (I:C) introduction in UV-F2 cells.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ene expressions normalized to 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Rplp0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. UV-F2 cells were transfected with 0.5 </a:t>
            </a:r>
            <a:r>
              <a:rPr lang="el-GR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g/mL poly (I:C) and incubated for 24 h (n=3).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estern blots of EV fractions from the conditioned media (n=3). 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licing rates of </a:t>
            </a:r>
            <a:r>
              <a:rPr lang="en-US" altLang="ja-JP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mplicons analyzed by polyacrylamide gel electrophoresis.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are mean ± SEM. The results of the experiment were tested in two separate trials. one-way analysis of variance with student’s t test. *p &lt; 0.05; **p &lt; 0.01; ***p &lt; 0.001.</a:t>
            </a:r>
          </a:p>
        </p:txBody>
      </p:sp>
      <p:graphicFrame>
        <p:nvGraphicFramePr>
          <p:cNvPr id="47" name="グラフ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7011109"/>
              </p:ext>
            </p:extLst>
          </p:nvPr>
        </p:nvGraphicFramePr>
        <p:xfrm>
          <a:off x="2004915" y="572872"/>
          <a:ext cx="18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8" name="グラフ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0140794"/>
              </p:ext>
            </p:extLst>
          </p:nvPr>
        </p:nvGraphicFramePr>
        <p:xfrm>
          <a:off x="3795927" y="572872"/>
          <a:ext cx="18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9" name="グラフ 4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9280491"/>
              </p:ext>
            </p:extLst>
          </p:nvPr>
        </p:nvGraphicFramePr>
        <p:xfrm>
          <a:off x="5550145" y="572872"/>
          <a:ext cx="18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0" name="グラフ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1023160"/>
              </p:ext>
            </p:extLst>
          </p:nvPr>
        </p:nvGraphicFramePr>
        <p:xfrm>
          <a:off x="7599606" y="572872"/>
          <a:ext cx="18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1" name="グラフ 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6060534"/>
              </p:ext>
            </p:extLst>
          </p:nvPr>
        </p:nvGraphicFramePr>
        <p:xfrm>
          <a:off x="201004" y="572872"/>
          <a:ext cx="18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52" name="テキスト ボックス 51"/>
          <p:cNvSpPr txBox="1"/>
          <p:nvPr/>
        </p:nvSpPr>
        <p:spPr>
          <a:xfrm>
            <a:off x="561459" y="81819"/>
            <a:ext cx="1618598" cy="4001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UV-F2 cell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3" name="グループ化 52"/>
          <p:cNvGrpSpPr/>
          <p:nvPr/>
        </p:nvGrpSpPr>
        <p:grpSpPr>
          <a:xfrm>
            <a:off x="601499" y="3084320"/>
            <a:ext cx="1438643" cy="369332"/>
            <a:chOff x="385811" y="3075724"/>
            <a:chExt cx="1438643" cy="369332"/>
          </a:xfrm>
        </p:grpSpPr>
        <p:cxnSp>
          <p:nvCxnSpPr>
            <p:cNvPr id="54" name="直線コネクタ 53"/>
            <p:cNvCxnSpPr/>
            <p:nvPr/>
          </p:nvCxnSpPr>
          <p:spPr>
            <a:xfrm>
              <a:off x="565132" y="3082012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テキスト ボックス 54"/>
            <p:cNvSpPr txBox="1"/>
            <p:nvPr/>
          </p:nvSpPr>
          <p:spPr>
            <a:xfrm>
              <a:off x="385811" y="3075724"/>
              <a:ext cx="14386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Poly (I:C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グループ化 55"/>
          <p:cNvGrpSpPr/>
          <p:nvPr/>
        </p:nvGrpSpPr>
        <p:grpSpPr>
          <a:xfrm>
            <a:off x="2339906" y="3065990"/>
            <a:ext cx="1438643" cy="369332"/>
            <a:chOff x="385811" y="3075724"/>
            <a:chExt cx="1438643" cy="369332"/>
          </a:xfrm>
        </p:grpSpPr>
        <p:cxnSp>
          <p:nvCxnSpPr>
            <p:cNvPr id="57" name="直線コネクタ 56"/>
            <p:cNvCxnSpPr/>
            <p:nvPr/>
          </p:nvCxnSpPr>
          <p:spPr>
            <a:xfrm>
              <a:off x="565132" y="3082012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テキスト ボックス 57"/>
            <p:cNvSpPr txBox="1"/>
            <p:nvPr/>
          </p:nvSpPr>
          <p:spPr>
            <a:xfrm>
              <a:off x="385811" y="3075724"/>
              <a:ext cx="14386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Poly (I:C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グループ化 58"/>
          <p:cNvGrpSpPr/>
          <p:nvPr/>
        </p:nvGrpSpPr>
        <p:grpSpPr>
          <a:xfrm>
            <a:off x="5959381" y="3092516"/>
            <a:ext cx="1438643" cy="369332"/>
            <a:chOff x="385811" y="3075724"/>
            <a:chExt cx="1438643" cy="369332"/>
          </a:xfrm>
        </p:grpSpPr>
        <p:cxnSp>
          <p:nvCxnSpPr>
            <p:cNvPr id="60" name="直線コネクタ 59"/>
            <p:cNvCxnSpPr/>
            <p:nvPr/>
          </p:nvCxnSpPr>
          <p:spPr>
            <a:xfrm>
              <a:off x="565132" y="3082012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テキスト ボックス 60"/>
            <p:cNvSpPr txBox="1"/>
            <p:nvPr/>
          </p:nvSpPr>
          <p:spPr>
            <a:xfrm>
              <a:off x="385811" y="3075724"/>
              <a:ext cx="14386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Poly (I:C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2" name="グループ化 61"/>
          <p:cNvGrpSpPr/>
          <p:nvPr/>
        </p:nvGrpSpPr>
        <p:grpSpPr>
          <a:xfrm>
            <a:off x="4070263" y="3092516"/>
            <a:ext cx="1438643" cy="369332"/>
            <a:chOff x="385811" y="3075724"/>
            <a:chExt cx="1438643" cy="369332"/>
          </a:xfrm>
        </p:grpSpPr>
        <p:cxnSp>
          <p:nvCxnSpPr>
            <p:cNvPr id="63" name="直線コネクタ 62"/>
            <p:cNvCxnSpPr/>
            <p:nvPr/>
          </p:nvCxnSpPr>
          <p:spPr>
            <a:xfrm>
              <a:off x="565132" y="3082012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テキスト ボックス 63"/>
            <p:cNvSpPr txBox="1"/>
            <p:nvPr/>
          </p:nvSpPr>
          <p:spPr>
            <a:xfrm>
              <a:off x="385811" y="3075724"/>
              <a:ext cx="14386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Poly (I:C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5" name="テキスト ボックス 64"/>
          <p:cNvSpPr txBox="1"/>
          <p:nvPr/>
        </p:nvSpPr>
        <p:spPr>
          <a:xfrm>
            <a:off x="149255" y="3611556"/>
            <a:ext cx="6368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ja-JP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" name="グループ化 65"/>
          <p:cNvGrpSpPr/>
          <p:nvPr/>
        </p:nvGrpSpPr>
        <p:grpSpPr>
          <a:xfrm>
            <a:off x="2933018" y="6155793"/>
            <a:ext cx="1438643" cy="369332"/>
            <a:chOff x="385811" y="3075724"/>
            <a:chExt cx="1438643" cy="369332"/>
          </a:xfrm>
        </p:grpSpPr>
        <p:cxnSp>
          <p:nvCxnSpPr>
            <p:cNvPr id="67" name="直線コネクタ 66"/>
            <p:cNvCxnSpPr/>
            <p:nvPr/>
          </p:nvCxnSpPr>
          <p:spPr>
            <a:xfrm>
              <a:off x="565132" y="3082012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テキスト ボックス 67"/>
            <p:cNvSpPr txBox="1"/>
            <p:nvPr/>
          </p:nvSpPr>
          <p:spPr>
            <a:xfrm>
              <a:off x="385811" y="3075724"/>
              <a:ext cx="14386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Poly (I:C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9" name="グループ化 68"/>
          <p:cNvGrpSpPr/>
          <p:nvPr/>
        </p:nvGrpSpPr>
        <p:grpSpPr>
          <a:xfrm>
            <a:off x="7978950" y="3121361"/>
            <a:ext cx="1438643" cy="369332"/>
            <a:chOff x="385811" y="3075724"/>
            <a:chExt cx="1438643" cy="369332"/>
          </a:xfrm>
        </p:grpSpPr>
        <p:cxnSp>
          <p:nvCxnSpPr>
            <p:cNvPr id="70" name="直線コネクタ 69"/>
            <p:cNvCxnSpPr/>
            <p:nvPr/>
          </p:nvCxnSpPr>
          <p:spPr>
            <a:xfrm>
              <a:off x="565132" y="3082012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テキスト ボックス 70"/>
            <p:cNvSpPr txBox="1"/>
            <p:nvPr/>
          </p:nvSpPr>
          <p:spPr>
            <a:xfrm>
              <a:off x="385811" y="3075724"/>
              <a:ext cx="14386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Poly (I:C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2" name="テキスト ボックス 71"/>
          <p:cNvSpPr txBox="1"/>
          <p:nvPr/>
        </p:nvSpPr>
        <p:spPr>
          <a:xfrm>
            <a:off x="7291422" y="241485"/>
            <a:ext cx="6368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ja-JP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149255" y="81819"/>
            <a:ext cx="6368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74" name="グラフ 7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2332025"/>
              </p:ext>
            </p:extLst>
          </p:nvPr>
        </p:nvGraphicFramePr>
        <p:xfrm>
          <a:off x="4152944" y="3554190"/>
          <a:ext cx="18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5" name="グラフ 7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3993464"/>
              </p:ext>
            </p:extLst>
          </p:nvPr>
        </p:nvGraphicFramePr>
        <p:xfrm>
          <a:off x="2479419" y="3579070"/>
          <a:ext cx="18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76" name="グラフ 7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564157"/>
              </p:ext>
            </p:extLst>
          </p:nvPr>
        </p:nvGraphicFramePr>
        <p:xfrm>
          <a:off x="691134" y="3613847"/>
          <a:ext cx="180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pSp>
        <p:nvGrpSpPr>
          <p:cNvPr id="77" name="グループ化 76"/>
          <p:cNvGrpSpPr/>
          <p:nvPr/>
        </p:nvGrpSpPr>
        <p:grpSpPr>
          <a:xfrm>
            <a:off x="1170109" y="6155793"/>
            <a:ext cx="1438643" cy="369332"/>
            <a:chOff x="385811" y="3075724"/>
            <a:chExt cx="1438643" cy="369332"/>
          </a:xfrm>
        </p:grpSpPr>
        <p:cxnSp>
          <p:nvCxnSpPr>
            <p:cNvPr id="78" name="直線コネクタ 77"/>
            <p:cNvCxnSpPr/>
            <p:nvPr/>
          </p:nvCxnSpPr>
          <p:spPr>
            <a:xfrm>
              <a:off x="565132" y="3082012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テキスト ボックス 78"/>
            <p:cNvSpPr txBox="1"/>
            <p:nvPr/>
          </p:nvSpPr>
          <p:spPr>
            <a:xfrm>
              <a:off x="385811" y="3075724"/>
              <a:ext cx="14386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Poly (I:C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グループ化 79"/>
          <p:cNvGrpSpPr/>
          <p:nvPr/>
        </p:nvGrpSpPr>
        <p:grpSpPr>
          <a:xfrm>
            <a:off x="4695927" y="6155793"/>
            <a:ext cx="1438643" cy="369332"/>
            <a:chOff x="385811" y="3075724"/>
            <a:chExt cx="1438643" cy="369332"/>
          </a:xfrm>
        </p:grpSpPr>
        <p:cxnSp>
          <p:nvCxnSpPr>
            <p:cNvPr id="81" name="直線コネクタ 80"/>
            <p:cNvCxnSpPr/>
            <p:nvPr/>
          </p:nvCxnSpPr>
          <p:spPr>
            <a:xfrm>
              <a:off x="565132" y="3082012"/>
              <a:ext cx="10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テキスト ボックス 81"/>
            <p:cNvSpPr txBox="1"/>
            <p:nvPr/>
          </p:nvSpPr>
          <p:spPr>
            <a:xfrm>
              <a:off x="385811" y="3075724"/>
              <a:ext cx="14386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Poly (I:C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テキスト ボックス 38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S5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7809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5026831"/>
              </p:ext>
            </p:extLst>
          </p:nvPr>
        </p:nvGraphicFramePr>
        <p:xfrm>
          <a:off x="657357" y="-16035"/>
          <a:ext cx="4572000" cy="2978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90700" y="6772768"/>
            <a:ext cx="1440000" cy="3940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7296" t="41132" r="60010" b="40947"/>
          <a:stretch/>
        </p:blipFill>
        <p:spPr>
          <a:xfrm>
            <a:off x="1790700" y="7379539"/>
            <a:ext cx="1440000" cy="23309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861" t="32939" r="64847" b="46520"/>
          <a:stretch/>
        </p:blipFill>
        <p:spPr>
          <a:xfrm>
            <a:off x="1790700" y="7825307"/>
            <a:ext cx="1440000" cy="30556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8" name="テキスト ボックス 7"/>
          <p:cNvSpPr txBox="1"/>
          <p:nvPr/>
        </p:nvSpPr>
        <p:spPr>
          <a:xfrm>
            <a:off x="1778000" y="6375681"/>
            <a:ext cx="144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--++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0" y="3696660"/>
            <a:ext cx="177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: T-cadher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0" y="4211565"/>
            <a:ext cx="177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0" y="4730967"/>
            <a:ext cx="177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Pan act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778000" y="3299573"/>
            <a:ext cx="144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--++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38833" y="3043428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35620" y="6121338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920" t="49606" r="67773" b="17608"/>
          <a:stretch/>
        </p:blipFill>
        <p:spPr>
          <a:xfrm>
            <a:off x="1783329" y="3676405"/>
            <a:ext cx="1440000" cy="49226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600" t="59389" r="65783" b="26335"/>
          <a:stretch/>
        </p:blipFill>
        <p:spPr>
          <a:xfrm>
            <a:off x="1778000" y="4331076"/>
            <a:ext cx="1440000" cy="211527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9628" t="33230" r="66980" b="45534"/>
          <a:stretch/>
        </p:blipFill>
        <p:spPr>
          <a:xfrm>
            <a:off x="1783329" y="4761247"/>
            <a:ext cx="1440000" cy="32060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aphicFrame>
        <p:nvGraphicFramePr>
          <p:cNvPr id="18" name="グラフ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4194602"/>
              </p:ext>
            </p:extLst>
          </p:nvPr>
        </p:nvGraphicFramePr>
        <p:xfrm>
          <a:off x="3841200" y="2932400"/>
          <a:ext cx="28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9" name="グラフ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8214310"/>
              </p:ext>
            </p:extLst>
          </p:nvPr>
        </p:nvGraphicFramePr>
        <p:xfrm>
          <a:off x="6721200" y="2932400"/>
          <a:ext cx="28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0" name="グラフ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0564842"/>
              </p:ext>
            </p:extLst>
          </p:nvPr>
        </p:nvGraphicFramePr>
        <p:xfrm>
          <a:off x="6721200" y="6121338"/>
          <a:ext cx="28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1" name="グラフ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7472040"/>
              </p:ext>
            </p:extLst>
          </p:nvPr>
        </p:nvGraphicFramePr>
        <p:xfrm>
          <a:off x="3841200" y="6121338"/>
          <a:ext cx="28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22" name="テキスト ボックス 21"/>
          <p:cNvSpPr txBox="1"/>
          <p:nvPr/>
        </p:nvSpPr>
        <p:spPr>
          <a:xfrm>
            <a:off x="772456" y="2999054"/>
            <a:ext cx="917001" cy="4001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>
                <a:latin typeface="Arial" panose="020B0604020202020204" pitchFamily="34" charset="0"/>
                <a:cs typeface="Arial" panose="020B0604020202020204" pitchFamily="34" charset="0"/>
              </a:rPr>
              <a:t>Aorta</a:t>
            </a:r>
            <a:endParaRPr kumimoji="1" lang="en-US" altLang="ja-JP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コネクタ 22"/>
          <p:cNvCxnSpPr/>
          <p:nvPr/>
        </p:nvCxnSpPr>
        <p:spPr>
          <a:xfrm>
            <a:off x="1779358" y="3343786"/>
            <a:ext cx="144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/>
          <p:cNvSpPr txBox="1"/>
          <p:nvPr/>
        </p:nvSpPr>
        <p:spPr>
          <a:xfrm>
            <a:off x="1779357" y="2962115"/>
            <a:ext cx="143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772456" y="6121338"/>
            <a:ext cx="917001" cy="4001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kumimoji="1" lang="en-US" altLang="ja-JP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線コネクタ 25"/>
          <p:cNvCxnSpPr/>
          <p:nvPr/>
        </p:nvCxnSpPr>
        <p:spPr>
          <a:xfrm>
            <a:off x="1778001" y="6360265"/>
            <a:ext cx="144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1778000" y="5978594"/>
            <a:ext cx="143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0" y="6764985"/>
            <a:ext cx="177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T-cadher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0" y="7279890"/>
            <a:ext cx="177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0" y="7799292"/>
            <a:ext cx="177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Pan act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コネクタ 30"/>
          <p:cNvCxnSpPr/>
          <p:nvPr/>
        </p:nvCxnSpPr>
        <p:spPr>
          <a:xfrm>
            <a:off x="7409197" y="8837139"/>
            <a:ext cx="19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/>
          <p:cNvCxnSpPr/>
          <p:nvPr/>
        </p:nvCxnSpPr>
        <p:spPr>
          <a:xfrm>
            <a:off x="4616266" y="8837139"/>
            <a:ext cx="19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>
            <a:off x="4616266" y="5644976"/>
            <a:ext cx="19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/>
          <p:cNvSpPr txBox="1"/>
          <p:nvPr/>
        </p:nvSpPr>
        <p:spPr>
          <a:xfrm>
            <a:off x="4921071" y="5638688"/>
            <a:ext cx="143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直線コネクタ 34"/>
          <p:cNvCxnSpPr/>
          <p:nvPr/>
        </p:nvCxnSpPr>
        <p:spPr>
          <a:xfrm>
            <a:off x="7409197" y="5634180"/>
            <a:ext cx="19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/>
          <p:cNvSpPr txBox="1"/>
          <p:nvPr/>
        </p:nvSpPr>
        <p:spPr>
          <a:xfrm>
            <a:off x="7714002" y="5627892"/>
            <a:ext cx="143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91794" y="84371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kumimoji="1" lang="en-US" altLang="ja-JP" sz="4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4921071" y="8886604"/>
            <a:ext cx="143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7714002" y="8875808"/>
            <a:ext cx="143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楕円 46"/>
          <p:cNvSpPr/>
          <p:nvPr/>
        </p:nvSpPr>
        <p:spPr>
          <a:xfrm>
            <a:off x="-718457" y="-3531129"/>
            <a:ext cx="4370797" cy="13716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1" name="直線コネクタ 40"/>
          <p:cNvCxnSpPr/>
          <p:nvPr/>
        </p:nvCxnSpPr>
        <p:spPr>
          <a:xfrm>
            <a:off x="3241622" y="4091589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/>
          <p:cNvSpPr txBox="1"/>
          <p:nvPr/>
        </p:nvSpPr>
        <p:spPr>
          <a:xfrm>
            <a:off x="3426613" y="3932616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コネクタ 42"/>
          <p:cNvCxnSpPr/>
          <p:nvPr/>
        </p:nvCxnSpPr>
        <p:spPr>
          <a:xfrm>
            <a:off x="3241622" y="4759281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/>
          <p:cNvSpPr txBox="1"/>
          <p:nvPr/>
        </p:nvSpPr>
        <p:spPr>
          <a:xfrm>
            <a:off x="3426613" y="4600308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282034" y="3271761"/>
            <a:ext cx="784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線コネクタ 45"/>
          <p:cNvCxnSpPr/>
          <p:nvPr/>
        </p:nvCxnSpPr>
        <p:spPr>
          <a:xfrm>
            <a:off x="3241622" y="4358497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/>
          <p:cNvSpPr txBox="1"/>
          <p:nvPr/>
        </p:nvSpPr>
        <p:spPr>
          <a:xfrm>
            <a:off x="3426613" y="4199524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線コネクタ 48"/>
          <p:cNvCxnSpPr/>
          <p:nvPr/>
        </p:nvCxnSpPr>
        <p:spPr>
          <a:xfrm>
            <a:off x="3241622" y="5081608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/>
          <p:cNvSpPr txBox="1"/>
          <p:nvPr/>
        </p:nvSpPr>
        <p:spPr>
          <a:xfrm>
            <a:off x="3426613" y="4922635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コネクタ 50"/>
          <p:cNvCxnSpPr/>
          <p:nvPr/>
        </p:nvCxnSpPr>
        <p:spPr>
          <a:xfrm>
            <a:off x="3241622" y="7029801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/>
          <p:cNvSpPr txBox="1"/>
          <p:nvPr/>
        </p:nvSpPr>
        <p:spPr>
          <a:xfrm>
            <a:off x="3426613" y="6870828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線コネクタ 52"/>
          <p:cNvCxnSpPr/>
          <p:nvPr/>
        </p:nvCxnSpPr>
        <p:spPr>
          <a:xfrm>
            <a:off x="3241622" y="7822987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/>
          <p:cNvSpPr txBox="1"/>
          <p:nvPr/>
        </p:nvSpPr>
        <p:spPr>
          <a:xfrm>
            <a:off x="3426613" y="7664014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3282034" y="6209973"/>
            <a:ext cx="784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線コネクタ 55"/>
          <p:cNvCxnSpPr/>
          <p:nvPr/>
        </p:nvCxnSpPr>
        <p:spPr>
          <a:xfrm>
            <a:off x="3241622" y="7375437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/>
          <p:cNvSpPr txBox="1"/>
          <p:nvPr/>
        </p:nvSpPr>
        <p:spPr>
          <a:xfrm>
            <a:off x="3426613" y="7216464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線コネクタ 57"/>
          <p:cNvCxnSpPr/>
          <p:nvPr/>
        </p:nvCxnSpPr>
        <p:spPr>
          <a:xfrm>
            <a:off x="3241622" y="8128490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/>
          <p:cNvSpPr txBox="1"/>
          <p:nvPr/>
        </p:nvSpPr>
        <p:spPr>
          <a:xfrm>
            <a:off x="3426613" y="7969517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79456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7435970" y="12093714"/>
            <a:ext cx="216523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kumimoji="1" lang="en-US" altLang="ja-JP" sz="4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.</a:t>
            </a:r>
            <a:endParaRPr kumimoji="1" lang="ja-JP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617" b="12241"/>
          <a:stretch/>
        </p:blipFill>
        <p:spPr>
          <a:xfrm>
            <a:off x="1771314" y="1407044"/>
            <a:ext cx="1440000" cy="40072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17112" b="-2"/>
          <a:stretch/>
        </p:blipFill>
        <p:spPr>
          <a:xfrm>
            <a:off x="1771314" y="2534151"/>
            <a:ext cx="1440000" cy="18308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170"/>
          <a:stretch/>
        </p:blipFill>
        <p:spPr>
          <a:xfrm>
            <a:off x="1771314" y="2050960"/>
            <a:ext cx="1440000" cy="17908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94842625"/>
              </p:ext>
            </p:extLst>
          </p:nvPr>
        </p:nvGraphicFramePr>
        <p:xfrm>
          <a:off x="3841200" y="269510"/>
          <a:ext cx="28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3302434"/>
              </p:ext>
            </p:extLst>
          </p:nvPr>
        </p:nvGraphicFramePr>
        <p:xfrm>
          <a:off x="6721200" y="269510"/>
          <a:ext cx="288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0" y="1427890"/>
            <a:ext cx="177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T-cadher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0" y="1843658"/>
            <a:ext cx="177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0" y="2363060"/>
            <a:ext cx="177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Pan acti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772456" y="307426"/>
            <a:ext cx="1208744" cy="4001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35619" y="307426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5" name="直線コネクタ 14"/>
          <p:cNvCxnSpPr/>
          <p:nvPr/>
        </p:nvCxnSpPr>
        <p:spPr>
          <a:xfrm>
            <a:off x="4616266" y="2986594"/>
            <a:ext cx="19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/>
          <p:cNvSpPr txBox="1"/>
          <p:nvPr/>
        </p:nvSpPr>
        <p:spPr>
          <a:xfrm>
            <a:off x="4921071" y="2980306"/>
            <a:ext cx="143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コネクタ 16"/>
          <p:cNvCxnSpPr/>
          <p:nvPr/>
        </p:nvCxnSpPr>
        <p:spPr>
          <a:xfrm>
            <a:off x="7409197" y="2975798"/>
            <a:ext cx="19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7714002" y="2969510"/>
            <a:ext cx="143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-33727" y="6051180"/>
            <a:ext cx="962346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6. Tunicamycin treatments in C57BL6/J mice. Mice were challenged with TM(1 μg/g body weight/day)  or vehicle control for 2 days. Serum, total mRNA and tissue lysates, were isolated 4h after second injection (n = 6–7).</a:t>
            </a:r>
          </a:p>
          <a:p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A,</a:t>
            </a:r>
            <a:r>
              <a:rPr lang="ja-JP" alt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ody weights.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otal protein extracts from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orta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otal 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otein extracts from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eart.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D,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otal 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otein extracts from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uscle.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E,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erum exosomes analyzed by NTA (a magnification of Figure 5E).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ata are mean ± SEM. The results of the experiment were tested in two separate trials. one-way analysis of variance with student’s t test. *p &lt; 0.05; **p &lt; 0.01; ***p &lt; 0.001.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772671" y="972878"/>
            <a:ext cx="144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dist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--++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/>
          <p:cNvCxnSpPr/>
          <p:nvPr/>
        </p:nvCxnSpPr>
        <p:spPr>
          <a:xfrm>
            <a:off x="1772672" y="957462"/>
            <a:ext cx="144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/>
          <p:cNvSpPr txBox="1"/>
          <p:nvPr/>
        </p:nvSpPr>
        <p:spPr>
          <a:xfrm>
            <a:off x="1772671" y="575791"/>
            <a:ext cx="14386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29605" y="3082323"/>
            <a:ext cx="4217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25" name="グラフ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325261"/>
              </p:ext>
            </p:extLst>
          </p:nvPr>
        </p:nvGraphicFramePr>
        <p:xfrm>
          <a:off x="199657" y="3186384"/>
          <a:ext cx="456901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34" name="直線コネクタ 33"/>
          <p:cNvCxnSpPr/>
          <p:nvPr/>
        </p:nvCxnSpPr>
        <p:spPr>
          <a:xfrm>
            <a:off x="3223639" y="1670718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/>
          <p:cNvSpPr txBox="1"/>
          <p:nvPr/>
        </p:nvSpPr>
        <p:spPr>
          <a:xfrm>
            <a:off x="3408630" y="1511745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264051" y="850890"/>
            <a:ext cx="7846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線コネクタ 38"/>
          <p:cNvCxnSpPr/>
          <p:nvPr/>
        </p:nvCxnSpPr>
        <p:spPr>
          <a:xfrm>
            <a:off x="3223639" y="2052646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/>
          <p:cNvSpPr txBox="1"/>
          <p:nvPr/>
        </p:nvSpPr>
        <p:spPr>
          <a:xfrm>
            <a:off x="3408630" y="1893673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コネクタ 40"/>
          <p:cNvCxnSpPr/>
          <p:nvPr/>
        </p:nvCxnSpPr>
        <p:spPr>
          <a:xfrm>
            <a:off x="3223639" y="2660737"/>
            <a:ext cx="2187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/>
          <p:cNvSpPr txBox="1"/>
          <p:nvPr/>
        </p:nvSpPr>
        <p:spPr>
          <a:xfrm>
            <a:off x="3408630" y="2501764"/>
            <a:ext cx="5782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0421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25</TotalTime>
  <Words>2023</Words>
  <Application>Microsoft Office PowerPoint</Application>
  <PresentationFormat>A3 297x420 mm</PresentationFormat>
  <Paragraphs>508</Paragraphs>
  <Slides>10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9" baseType="lpstr">
      <vt:lpstr>ＭＳ Ｐゴシック</vt:lpstr>
      <vt:lpstr>Yu Gothic UI</vt:lpstr>
      <vt:lpstr>游ゴシック</vt:lpstr>
      <vt:lpstr>游ゴシック Light</vt:lpstr>
      <vt:lpstr>Arial</vt:lpstr>
      <vt:lpstr>Calibri</vt:lpstr>
      <vt:lpstr>Calibri Light</vt:lpstr>
      <vt:lpstr>Courier New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183083</dc:creator>
  <cp:lastModifiedBy>E183083</cp:lastModifiedBy>
  <cp:revision>513</cp:revision>
  <cp:lastPrinted>2022-01-20T09:03:04Z</cp:lastPrinted>
  <dcterms:created xsi:type="dcterms:W3CDTF">2021-10-27T01:22:27Z</dcterms:created>
  <dcterms:modified xsi:type="dcterms:W3CDTF">2023-08-17T09:32:05Z</dcterms:modified>
</cp:coreProperties>
</file>